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45" r:id="rId2"/>
    <p:sldId id="342" r:id="rId3"/>
    <p:sldId id="343" r:id="rId4"/>
    <p:sldId id="348" r:id="rId5"/>
    <p:sldId id="349" r:id="rId6"/>
    <p:sldId id="350" r:id="rId7"/>
    <p:sldId id="351" r:id="rId8"/>
  </p:sldIdLst>
  <p:sldSz cx="6300788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3208"/>
    <a:srgbClr val="CB190B"/>
    <a:srgbClr val="33CC33"/>
    <a:srgbClr val="C7550F"/>
    <a:srgbClr val="FF3300"/>
    <a:srgbClr val="CC3300"/>
    <a:srgbClr val="FF0000"/>
    <a:srgbClr val="00CC00"/>
    <a:srgbClr val="CC0000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7" autoAdjust="0"/>
    <p:restoredTop sz="94660"/>
  </p:normalViewPr>
  <p:slideViewPr>
    <p:cSldViewPr snapToGrid="0">
      <p:cViewPr varScale="1">
        <p:scale>
          <a:sx n="139" d="100"/>
          <a:sy n="139" d="100"/>
        </p:scale>
        <p:origin x="199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20C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0-28-20%20run%2030C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Bin%20Wang\11-11-20%20run%20(left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C$17:$CC$146</c:f>
              <c:numCache>
                <c:formatCode>0.00</c:formatCode>
                <c:ptCount val="130"/>
                <c:pt idx="0">
                  <c:v>2.7111149999999964</c:v>
                </c:pt>
                <c:pt idx="1">
                  <c:v>6.3441950000000009</c:v>
                </c:pt>
                <c:pt idx="2">
                  <c:v>6.0773799999999989</c:v>
                </c:pt>
                <c:pt idx="3">
                  <c:v>6.2251450000000013</c:v>
                </c:pt>
                <c:pt idx="4">
                  <c:v>6.5327450000000011</c:v>
                </c:pt>
                <c:pt idx="5">
                  <c:v>6.4481799999999989</c:v>
                </c:pt>
                <c:pt idx="6">
                  <c:v>6.2890450000000016</c:v>
                </c:pt>
                <c:pt idx="7">
                  <c:v>6.2258450000000014</c:v>
                </c:pt>
                <c:pt idx="8">
                  <c:v>6.2152750000000001</c:v>
                </c:pt>
                <c:pt idx="9">
                  <c:v>6.2551950000000014</c:v>
                </c:pt>
                <c:pt idx="10">
                  <c:v>6.5666649999999969</c:v>
                </c:pt>
                <c:pt idx="11">
                  <c:v>7.0681549999999991</c:v>
                </c:pt>
                <c:pt idx="12">
                  <c:v>8.2521500000000003</c:v>
                </c:pt>
                <c:pt idx="13">
                  <c:v>10.170354999999999</c:v>
                </c:pt>
                <c:pt idx="14">
                  <c:v>13.219210000000004</c:v>
                </c:pt>
                <c:pt idx="15">
                  <c:v>17.790845000000001</c:v>
                </c:pt>
                <c:pt idx="16">
                  <c:v>24.025475</c:v>
                </c:pt>
                <c:pt idx="17">
                  <c:v>32.40052</c:v>
                </c:pt>
                <c:pt idx="18">
                  <c:v>43.371780000000001</c:v>
                </c:pt>
                <c:pt idx="19">
                  <c:v>55.628744999999995</c:v>
                </c:pt>
                <c:pt idx="20">
                  <c:v>67.081180000000003</c:v>
                </c:pt>
                <c:pt idx="21">
                  <c:v>76.080060000000003</c:v>
                </c:pt>
                <c:pt idx="22">
                  <c:v>81.25851999999999</c:v>
                </c:pt>
                <c:pt idx="23">
                  <c:v>82.185149999999993</c:v>
                </c:pt>
                <c:pt idx="24">
                  <c:v>80.644110000000012</c:v>
                </c:pt>
                <c:pt idx="25">
                  <c:v>77.224955000000008</c:v>
                </c:pt>
                <c:pt idx="26">
                  <c:v>72.694474999999997</c:v>
                </c:pt>
                <c:pt idx="27">
                  <c:v>69.395439999999994</c:v>
                </c:pt>
                <c:pt idx="28">
                  <c:v>64.937644999999989</c:v>
                </c:pt>
                <c:pt idx="29">
                  <c:v>59.859405000000002</c:v>
                </c:pt>
                <c:pt idx="30">
                  <c:v>54.684889999999989</c:v>
                </c:pt>
                <c:pt idx="31">
                  <c:v>50.314064999999999</c:v>
                </c:pt>
                <c:pt idx="32">
                  <c:v>45.163764999999998</c:v>
                </c:pt>
                <c:pt idx="33">
                  <c:v>40.622595000000004</c:v>
                </c:pt>
                <c:pt idx="34">
                  <c:v>37.367750000000001</c:v>
                </c:pt>
                <c:pt idx="35">
                  <c:v>34.446235000000001</c:v>
                </c:pt>
                <c:pt idx="36">
                  <c:v>31.782595000000001</c:v>
                </c:pt>
                <c:pt idx="37">
                  <c:v>29.591985000000005</c:v>
                </c:pt>
                <c:pt idx="38">
                  <c:v>28.118560000000002</c:v>
                </c:pt>
                <c:pt idx="39">
                  <c:v>26.373695000000001</c:v>
                </c:pt>
                <c:pt idx="40">
                  <c:v>24.961704999999998</c:v>
                </c:pt>
                <c:pt idx="41">
                  <c:v>24.810045000000002</c:v>
                </c:pt>
                <c:pt idx="42">
                  <c:v>25.378325</c:v>
                </c:pt>
                <c:pt idx="43">
                  <c:v>26.690950000000001</c:v>
                </c:pt>
                <c:pt idx="44">
                  <c:v>28.615539999999996</c:v>
                </c:pt>
                <c:pt idx="45">
                  <c:v>30.739975000000001</c:v>
                </c:pt>
                <c:pt idx="46">
                  <c:v>33.355110000000003</c:v>
                </c:pt>
                <c:pt idx="47">
                  <c:v>35.896850000000001</c:v>
                </c:pt>
                <c:pt idx="48">
                  <c:v>38.095110000000005</c:v>
                </c:pt>
                <c:pt idx="49">
                  <c:v>39.357804999999999</c:v>
                </c:pt>
                <c:pt idx="50">
                  <c:v>39.776625000000003</c:v>
                </c:pt>
                <c:pt idx="51">
                  <c:v>39.795000000000002</c:v>
                </c:pt>
                <c:pt idx="52">
                  <c:v>39.833469999999998</c:v>
                </c:pt>
                <c:pt idx="53">
                  <c:v>39.13505</c:v>
                </c:pt>
                <c:pt idx="54">
                  <c:v>38.445500000000003</c:v>
                </c:pt>
                <c:pt idx="55">
                  <c:v>37.344564999999996</c:v>
                </c:pt>
                <c:pt idx="56">
                  <c:v>35.930405</c:v>
                </c:pt>
                <c:pt idx="57">
                  <c:v>34.299639999999997</c:v>
                </c:pt>
                <c:pt idx="58">
                  <c:v>32.174469999999999</c:v>
                </c:pt>
                <c:pt idx="59">
                  <c:v>30.634899999999998</c:v>
                </c:pt>
                <c:pt idx="60">
                  <c:v>28.904564999999998</c:v>
                </c:pt>
                <c:pt idx="61">
                  <c:v>26.789279999999998</c:v>
                </c:pt>
                <c:pt idx="62">
                  <c:v>25.670964999999995</c:v>
                </c:pt>
                <c:pt idx="63">
                  <c:v>23.812835000000003</c:v>
                </c:pt>
                <c:pt idx="64">
                  <c:v>22.533674999999999</c:v>
                </c:pt>
                <c:pt idx="65">
                  <c:v>21.817860000000003</c:v>
                </c:pt>
                <c:pt idx="66">
                  <c:v>21.377254999999998</c:v>
                </c:pt>
                <c:pt idx="67">
                  <c:v>20.64415</c:v>
                </c:pt>
                <c:pt idx="68">
                  <c:v>19.872364999999995</c:v>
                </c:pt>
                <c:pt idx="69">
                  <c:v>19.307889999999997</c:v>
                </c:pt>
                <c:pt idx="70">
                  <c:v>19.084705</c:v>
                </c:pt>
                <c:pt idx="71">
                  <c:v>18.962395000000001</c:v>
                </c:pt>
                <c:pt idx="72">
                  <c:v>19.047489999999996</c:v>
                </c:pt>
                <c:pt idx="73">
                  <c:v>19.406845000000001</c:v>
                </c:pt>
                <c:pt idx="74">
                  <c:v>19.193519999999999</c:v>
                </c:pt>
                <c:pt idx="75">
                  <c:v>19.395254999999999</c:v>
                </c:pt>
                <c:pt idx="76">
                  <c:v>19.305660000000003</c:v>
                </c:pt>
                <c:pt idx="77">
                  <c:v>19.273954999999997</c:v>
                </c:pt>
                <c:pt idx="78">
                  <c:v>19.258975</c:v>
                </c:pt>
                <c:pt idx="79">
                  <c:v>18.9373</c:v>
                </c:pt>
                <c:pt idx="80">
                  <c:v>18.655035000000005</c:v>
                </c:pt>
                <c:pt idx="81">
                  <c:v>18.146100000000001</c:v>
                </c:pt>
                <c:pt idx="82">
                  <c:v>17.649435000000004</c:v>
                </c:pt>
                <c:pt idx="83">
                  <c:v>16.601879999999998</c:v>
                </c:pt>
                <c:pt idx="84">
                  <c:v>15.990205</c:v>
                </c:pt>
                <c:pt idx="85">
                  <c:v>15.304339999999996</c:v>
                </c:pt>
                <c:pt idx="86">
                  <c:v>14.904070000000001</c:v>
                </c:pt>
                <c:pt idx="87">
                  <c:v>14.300789999999996</c:v>
                </c:pt>
                <c:pt idx="88">
                  <c:v>14.107610000000003</c:v>
                </c:pt>
                <c:pt idx="89">
                  <c:v>13.75177</c:v>
                </c:pt>
                <c:pt idx="90">
                  <c:v>13.453225</c:v>
                </c:pt>
                <c:pt idx="91">
                  <c:v>13.299314999999996</c:v>
                </c:pt>
                <c:pt idx="92">
                  <c:v>13.101964999999996</c:v>
                </c:pt>
                <c:pt idx="93">
                  <c:v>13.147535000000003</c:v>
                </c:pt>
                <c:pt idx="94">
                  <c:v>12.506520000000002</c:v>
                </c:pt>
                <c:pt idx="95">
                  <c:v>12.340770000000001</c:v>
                </c:pt>
                <c:pt idx="96">
                  <c:v>12.162889999999997</c:v>
                </c:pt>
                <c:pt idx="97">
                  <c:v>12.164325</c:v>
                </c:pt>
                <c:pt idx="98">
                  <c:v>11.891279999999998</c:v>
                </c:pt>
                <c:pt idx="99">
                  <c:v>11.865639999999997</c:v>
                </c:pt>
                <c:pt idx="100">
                  <c:v>11.652135000000003</c:v>
                </c:pt>
                <c:pt idx="101">
                  <c:v>11.520779999999998</c:v>
                </c:pt>
                <c:pt idx="102">
                  <c:v>11.312654999999999</c:v>
                </c:pt>
                <c:pt idx="103">
                  <c:v>11.050800000000001</c:v>
                </c:pt>
                <c:pt idx="104">
                  <c:v>10.964774999999999</c:v>
                </c:pt>
                <c:pt idx="105">
                  <c:v>10.661570000000001</c:v>
                </c:pt>
                <c:pt idx="106">
                  <c:v>10.531439999999996</c:v>
                </c:pt>
                <c:pt idx="107">
                  <c:v>10.510870000000001</c:v>
                </c:pt>
                <c:pt idx="108">
                  <c:v>10.892345000000001</c:v>
                </c:pt>
                <c:pt idx="109">
                  <c:v>10.288604999999999</c:v>
                </c:pt>
                <c:pt idx="110">
                  <c:v>10.246879999999999</c:v>
                </c:pt>
                <c:pt idx="111">
                  <c:v>10.646475000000001</c:v>
                </c:pt>
                <c:pt idx="112">
                  <c:v>10.010689999999997</c:v>
                </c:pt>
                <c:pt idx="113">
                  <c:v>9.8690100000000029</c:v>
                </c:pt>
                <c:pt idx="114">
                  <c:v>9.8603299999999994</c:v>
                </c:pt>
                <c:pt idx="115">
                  <c:v>9.9297600000000035</c:v>
                </c:pt>
                <c:pt idx="116">
                  <c:v>9.9658850000000037</c:v>
                </c:pt>
                <c:pt idx="117">
                  <c:v>9.9563950000000006</c:v>
                </c:pt>
                <c:pt idx="118">
                  <c:v>10.013154999999999</c:v>
                </c:pt>
                <c:pt idx="119">
                  <c:v>10.070870000000001</c:v>
                </c:pt>
                <c:pt idx="120">
                  <c:v>10.143945</c:v>
                </c:pt>
                <c:pt idx="121">
                  <c:v>10.34545</c:v>
                </c:pt>
                <c:pt idx="122">
                  <c:v>10.437489999999997</c:v>
                </c:pt>
                <c:pt idx="123">
                  <c:v>10.686970000000001</c:v>
                </c:pt>
                <c:pt idx="124">
                  <c:v>11.078260000000004</c:v>
                </c:pt>
                <c:pt idx="125">
                  <c:v>10.897039999999997</c:v>
                </c:pt>
                <c:pt idx="126">
                  <c:v>10.956250000000001</c:v>
                </c:pt>
                <c:pt idx="127">
                  <c:v>10.973339999999997</c:v>
                </c:pt>
                <c:pt idx="128">
                  <c:v>10.892489999999997</c:v>
                </c:pt>
                <c:pt idx="129">
                  <c:v>10.7240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17F-4A13-BA30-0E18CB604258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D$17:$CD$146</c:f>
              <c:numCache>
                <c:formatCode>0.00</c:formatCode>
                <c:ptCount val="130"/>
                <c:pt idx="0">
                  <c:v>4.3187149999999965</c:v>
                </c:pt>
                <c:pt idx="1">
                  <c:v>8.0754950000000019</c:v>
                </c:pt>
                <c:pt idx="2">
                  <c:v>7.4872799999999993</c:v>
                </c:pt>
                <c:pt idx="3">
                  <c:v>7.3378450000000015</c:v>
                </c:pt>
                <c:pt idx="4">
                  <c:v>7.5519450000000008</c:v>
                </c:pt>
                <c:pt idx="5">
                  <c:v>7.2281799999999992</c:v>
                </c:pt>
                <c:pt idx="6">
                  <c:v>6.8989450000000012</c:v>
                </c:pt>
                <c:pt idx="7">
                  <c:v>6.6271450000000014</c:v>
                </c:pt>
                <c:pt idx="8">
                  <c:v>6.2665749999999996</c:v>
                </c:pt>
                <c:pt idx="9">
                  <c:v>6.1608950000000009</c:v>
                </c:pt>
                <c:pt idx="10">
                  <c:v>6.2328649999999968</c:v>
                </c:pt>
                <c:pt idx="11">
                  <c:v>6.4423549999999992</c:v>
                </c:pt>
                <c:pt idx="12">
                  <c:v>7.3772500000000001</c:v>
                </c:pt>
                <c:pt idx="13">
                  <c:v>8.9421549999999996</c:v>
                </c:pt>
                <c:pt idx="14">
                  <c:v>11.527410000000003</c:v>
                </c:pt>
                <c:pt idx="15">
                  <c:v>15.774745000000001</c:v>
                </c:pt>
                <c:pt idx="16">
                  <c:v>21.617274999999999</c:v>
                </c:pt>
                <c:pt idx="17">
                  <c:v>29.634120000000003</c:v>
                </c:pt>
                <c:pt idx="18">
                  <c:v>39.804380000000002</c:v>
                </c:pt>
                <c:pt idx="19">
                  <c:v>52.324145000000001</c:v>
                </c:pt>
                <c:pt idx="20">
                  <c:v>63.673080000000006</c:v>
                </c:pt>
                <c:pt idx="21">
                  <c:v>72.833660000000009</c:v>
                </c:pt>
                <c:pt idx="22">
                  <c:v>78.911519999999996</c:v>
                </c:pt>
                <c:pt idx="23">
                  <c:v>81.492249999999999</c:v>
                </c:pt>
                <c:pt idx="24">
                  <c:v>81.040610000000015</c:v>
                </c:pt>
                <c:pt idx="25">
                  <c:v>77.436655000000002</c:v>
                </c:pt>
                <c:pt idx="26">
                  <c:v>74.658974999999998</c:v>
                </c:pt>
                <c:pt idx="27">
                  <c:v>69.642939999999996</c:v>
                </c:pt>
                <c:pt idx="28">
                  <c:v>64.863244999999992</c:v>
                </c:pt>
                <c:pt idx="29">
                  <c:v>59.309205000000006</c:v>
                </c:pt>
                <c:pt idx="30">
                  <c:v>53.488389999999988</c:v>
                </c:pt>
                <c:pt idx="31">
                  <c:v>48.000964999999994</c:v>
                </c:pt>
                <c:pt idx="32">
                  <c:v>43.437764999999999</c:v>
                </c:pt>
                <c:pt idx="33">
                  <c:v>38.674795000000003</c:v>
                </c:pt>
                <c:pt idx="34">
                  <c:v>35.231850000000001</c:v>
                </c:pt>
                <c:pt idx="35">
                  <c:v>31.820335000000004</c:v>
                </c:pt>
                <c:pt idx="36">
                  <c:v>29.422095000000002</c:v>
                </c:pt>
                <c:pt idx="37">
                  <c:v>26.807185000000004</c:v>
                </c:pt>
                <c:pt idx="38">
                  <c:v>24.625860000000003</c:v>
                </c:pt>
                <c:pt idx="39">
                  <c:v>23.093895</c:v>
                </c:pt>
                <c:pt idx="40">
                  <c:v>22.029705</c:v>
                </c:pt>
                <c:pt idx="41">
                  <c:v>21.596344999999999</c:v>
                </c:pt>
                <c:pt idx="42">
                  <c:v>21.724125000000001</c:v>
                </c:pt>
                <c:pt idx="43">
                  <c:v>22.627749999999999</c:v>
                </c:pt>
                <c:pt idx="44">
                  <c:v>23.905339999999995</c:v>
                </c:pt>
                <c:pt idx="45">
                  <c:v>25.916575000000002</c:v>
                </c:pt>
                <c:pt idx="46">
                  <c:v>28.292210000000004</c:v>
                </c:pt>
                <c:pt idx="47">
                  <c:v>30.986249999999998</c:v>
                </c:pt>
                <c:pt idx="48">
                  <c:v>33.168510000000005</c:v>
                </c:pt>
                <c:pt idx="49">
                  <c:v>34.461905000000002</c:v>
                </c:pt>
                <c:pt idx="50">
                  <c:v>35.066524999999999</c:v>
                </c:pt>
                <c:pt idx="51">
                  <c:v>34.720700000000001</c:v>
                </c:pt>
                <c:pt idx="52">
                  <c:v>34.281170000000003</c:v>
                </c:pt>
                <c:pt idx="53">
                  <c:v>33.107050000000001</c:v>
                </c:pt>
                <c:pt idx="54">
                  <c:v>32.172800000000002</c:v>
                </c:pt>
                <c:pt idx="55">
                  <c:v>30.592664999999997</c:v>
                </c:pt>
                <c:pt idx="56">
                  <c:v>29.350704999999998</c:v>
                </c:pt>
                <c:pt idx="57">
                  <c:v>28.268639999999998</c:v>
                </c:pt>
                <c:pt idx="58">
                  <c:v>26.664170000000002</c:v>
                </c:pt>
                <c:pt idx="59">
                  <c:v>24.842500000000001</c:v>
                </c:pt>
                <c:pt idx="60">
                  <c:v>23.436364999999995</c:v>
                </c:pt>
                <c:pt idx="61">
                  <c:v>22.140979999999999</c:v>
                </c:pt>
                <c:pt idx="62">
                  <c:v>20.906764999999996</c:v>
                </c:pt>
                <c:pt idx="63">
                  <c:v>19.886735000000005</c:v>
                </c:pt>
                <c:pt idx="64">
                  <c:v>18.939274999999999</c:v>
                </c:pt>
                <c:pt idx="65">
                  <c:v>18.153660000000002</c:v>
                </c:pt>
                <c:pt idx="66">
                  <c:v>17.571755</c:v>
                </c:pt>
                <c:pt idx="67">
                  <c:v>16.942250000000001</c:v>
                </c:pt>
                <c:pt idx="68">
                  <c:v>16.575964999999997</c:v>
                </c:pt>
                <c:pt idx="69">
                  <c:v>16.338289999999997</c:v>
                </c:pt>
                <c:pt idx="70">
                  <c:v>16.335004999999999</c:v>
                </c:pt>
                <c:pt idx="71">
                  <c:v>16.216695000000001</c:v>
                </c:pt>
                <c:pt idx="72">
                  <c:v>16.500289999999996</c:v>
                </c:pt>
                <c:pt idx="73">
                  <c:v>16.816445000000002</c:v>
                </c:pt>
                <c:pt idx="74">
                  <c:v>17.02732</c:v>
                </c:pt>
                <c:pt idx="75">
                  <c:v>17.423354999999997</c:v>
                </c:pt>
                <c:pt idx="76">
                  <c:v>17.400760000000002</c:v>
                </c:pt>
                <c:pt idx="77">
                  <c:v>17.540855000000001</c:v>
                </c:pt>
                <c:pt idx="78">
                  <c:v>17.444075000000002</c:v>
                </c:pt>
                <c:pt idx="79">
                  <c:v>17.385200000000001</c:v>
                </c:pt>
                <c:pt idx="80">
                  <c:v>17.127335000000002</c:v>
                </c:pt>
                <c:pt idx="81">
                  <c:v>16.922799999999999</c:v>
                </c:pt>
                <c:pt idx="82">
                  <c:v>16.607735000000005</c:v>
                </c:pt>
                <c:pt idx="83">
                  <c:v>16.14208</c:v>
                </c:pt>
                <c:pt idx="84">
                  <c:v>15.719605</c:v>
                </c:pt>
                <c:pt idx="85">
                  <c:v>15.187639999999996</c:v>
                </c:pt>
                <c:pt idx="86">
                  <c:v>14.764470000000001</c:v>
                </c:pt>
                <c:pt idx="87">
                  <c:v>14.158289999999997</c:v>
                </c:pt>
                <c:pt idx="88">
                  <c:v>13.775410000000004</c:v>
                </c:pt>
                <c:pt idx="89">
                  <c:v>13.319970000000001</c:v>
                </c:pt>
                <c:pt idx="90">
                  <c:v>12.652925</c:v>
                </c:pt>
                <c:pt idx="91">
                  <c:v>12.318214999999997</c:v>
                </c:pt>
                <c:pt idx="92">
                  <c:v>11.855564999999997</c:v>
                </c:pt>
                <c:pt idx="93">
                  <c:v>11.611135000000003</c:v>
                </c:pt>
                <c:pt idx="94">
                  <c:v>11.65192</c:v>
                </c:pt>
                <c:pt idx="95">
                  <c:v>11.60467</c:v>
                </c:pt>
                <c:pt idx="96">
                  <c:v>11.705689999999997</c:v>
                </c:pt>
                <c:pt idx="97">
                  <c:v>11.927625000000001</c:v>
                </c:pt>
                <c:pt idx="98">
                  <c:v>11.921379999999999</c:v>
                </c:pt>
                <c:pt idx="99">
                  <c:v>12.101839999999996</c:v>
                </c:pt>
                <c:pt idx="100">
                  <c:v>11.998035000000003</c:v>
                </c:pt>
                <c:pt idx="101">
                  <c:v>12.024179999999999</c:v>
                </c:pt>
                <c:pt idx="102">
                  <c:v>11.996754999999999</c:v>
                </c:pt>
                <c:pt idx="103">
                  <c:v>11.7662</c:v>
                </c:pt>
                <c:pt idx="104">
                  <c:v>11.735575000000001</c:v>
                </c:pt>
                <c:pt idx="105">
                  <c:v>11.530970000000002</c:v>
                </c:pt>
                <c:pt idx="106">
                  <c:v>11.360639999999997</c:v>
                </c:pt>
                <c:pt idx="107">
                  <c:v>11.081470000000001</c:v>
                </c:pt>
                <c:pt idx="108">
                  <c:v>10.727845</c:v>
                </c:pt>
                <c:pt idx="109">
                  <c:v>10.396604999999999</c:v>
                </c:pt>
                <c:pt idx="110">
                  <c:v>9.9716799999999992</c:v>
                </c:pt>
                <c:pt idx="111">
                  <c:v>9.6240749999999995</c:v>
                </c:pt>
                <c:pt idx="112">
                  <c:v>9.321989999999996</c:v>
                </c:pt>
                <c:pt idx="113">
                  <c:v>8.8989100000000043</c:v>
                </c:pt>
                <c:pt idx="114">
                  <c:v>8.4889299999999981</c:v>
                </c:pt>
                <c:pt idx="115">
                  <c:v>8.1981600000000032</c:v>
                </c:pt>
                <c:pt idx="116">
                  <c:v>8.0272850000000027</c:v>
                </c:pt>
                <c:pt idx="117">
                  <c:v>7.7297950000000011</c:v>
                </c:pt>
                <c:pt idx="118">
                  <c:v>7.7117549999999992</c:v>
                </c:pt>
                <c:pt idx="119">
                  <c:v>7.6442700000000015</c:v>
                </c:pt>
                <c:pt idx="120">
                  <c:v>7.7265450000000016</c:v>
                </c:pt>
                <c:pt idx="121">
                  <c:v>7.8128500000000001</c:v>
                </c:pt>
                <c:pt idx="122">
                  <c:v>7.9037899999999963</c:v>
                </c:pt>
                <c:pt idx="123">
                  <c:v>8.0976700000000008</c:v>
                </c:pt>
                <c:pt idx="124">
                  <c:v>8.0896600000000038</c:v>
                </c:pt>
                <c:pt idx="125">
                  <c:v>8.2407399999999971</c:v>
                </c:pt>
                <c:pt idx="126">
                  <c:v>8.27285</c:v>
                </c:pt>
                <c:pt idx="127">
                  <c:v>8.2683399999999967</c:v>
                </c:pt>
                <c:pt idx="128">
                  <c:v>8.201889999999997</c:v>
                </c:pt>
                <c:pt idx="129">
                  <c:v>8.0732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17F-4A13-BA30-0E18CB604258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E$17:$CE$146</c:f>
              <c:numCache>
                <c:formatCode>0.00</c:formatCode>
                <c:ptCount val="130"/>
                <c:pt idx="0">
                  <c:v>3.5236149999999964</c:v>
                </c:pt>
                <c:pt idx="1">
                  <c:v>7.3666950000000009</c:v>
                </c:pt>
                <c:pt idx="2">
                  <c:v>6.6580799999999991</c:v>
                </c:pt>
                <c:pt idx="3">
                  <c:v>6.3620450000000011</c:v>
                </c:pt>
                <c:pt idx="4">
                  <c:v>6.634945000000001</c:v>
                </c:pt>
                <c:pt idx="5">
                  <c:v>6.6051799999999989</c:v>
                </c:pt>
                <c:pt idx="6">
                  <c:v>6.1587450000000015</c:v>
                </c:pt>
                <c:pt idx="7">
                  <c:v>5.8470450000000014</c:v>
                </c:pt>
                <c:pt idx="8">
                  <c:v>5.724075</c:v>
                </c:pt>
                <c:pt idx="9">
                  <c:v>5.7045950000000012</c:v>
                </c:pt>
                <c:pt idx="10">
                  <c:v>5.8409649999999962</c:v>
                </c:pt>
                <c:pt idx="11">
                  <c:v>6.1681549999999987</c:v>
                </c:pt>
                <c:pt idx="12">
                  <c:v>7.3706500000000004</c:v>
                </c:pt>
                <c:pt idx="13">
                  <c:v>9.5147549999999992</c:v>
                </c:pt>
                <c:pt idx="14">
                  <c:v>12.216510000000003</c:v>
                </c:pt>
                <c:pt idx="15">
                  <c:v>16.842845000000001</c:v>
                </c:pt>
                <c:pt idx="16">
                  <c:v>23.214175000000001</c:v>
                </c:pt>
                <c:pt idx="17">
                  <c:v>31.887220000000003</c:v>
                </c:pt>
                <c:pt idx="18">
                  <c:v>42.888579999999997</c:v>
                </c:pt>
                <c:pt idx="19">
                  <c:v>55.832544999999996</c:v>
                </c:pt>
                <c:pt idx="20">
                  <c:v>68.16498</c:v>
                </c:pt>
                <c:pt idx="21">
                  <c:v>77.937060000000002</c:v>
                </c:pt>
                <c:pt idx="22">
                  <c:v>83.872419999999991</c:v>
                </c:pt>
                <c:pt idx="23">
                  <c:v>86.160749999999993</c:v>
                </c:pt>
                <c:pt idx="24">
                  <c:v>84.419810000000012</c:v>
                </c:pt>
                <c:pt idx="25">
                  <c:v>80.980155000000011</c:v>
                </c:pt>
                <c:pt idx="26">
                  <c:v>76.600375</c:v>
                </c:pt>
                <c:pt idx="27">
                  <c:v>72.827839999999995</c:v>
                </c:pt>
                <c:pt idx="28">
                  <c:v>68.634045</c:v>
                </c:pt>
                <c:pt idx="29">
                  <c:v>63.179305000000006</c:v>
                </c:pt>
                <c:pt idx="30">
                  <c:v>57.530689999999993</c:v>
                </c:pt>
                <c:pt idx="31">
                  <c:v>52.057964999999996</c:v>
                </c:pt>
                <c:pt idx="32">
                  <c:v>46.019464999999997</c:v>
                </c:pt>
                <c:pt idx="33">
                  <c:v>40.739595000000001</c:v>
                </c:pt>
                <c:pt idx="34">
                  <c:v>36.465850000000003</c:v>
                </c:pt>
                <c:pt idx="35">
                  <c:v>32.728235000000005</c:v>
                </c:pt>
                <c:pt idx="36">
                  <c:v>29.673295</c:v>
                </c:pt>
                <c:pt idx="37">
                  <c:v>27.329885000000004</c:v>
                </c:pt>
                <c:pt idx="38">
                  <c:v>25.461060000000003</c:v>
                </c:pt>
                <c:pt idx="39">
                  <c:v>24.100195000000003</c:v>
                </c:pt>
                <c:pt idx="40">
                  <c:v>23.194704999999999</c:v>
                </c:pt>
                <c:pt idx="41">
                  <c:v>22.812045000000001</c:v>
                </c:pt>
                <c:pt idx="42">
                  <c:v>23.166824999999999</c:v>
                </c:pt>
                <c:pt idx="43">
                  <c:v>24.222549999999998</c:v>
                </c:pt>
                <c:pt idx="44">
                  <c:v>25.096239999999998</c:v>
                </c:pt>
                <c:pt idx="45">
                  <c:v>26.758875</c:v>
                </c:pt>
                <c:pt idx="46">
                  <c:v>28.935010000000002</c:v>
                </c:pt>
                <c:pt idx="47">
                  <c:v>31.152450000000002</c:v>
                </c:pt>
                <c:pt idx="48">
                  <c:v>33.044610000000006</c:v>
                </c:pt>
                <c:pt idx="49">
                  <c:v>34.043205</c:v>
                </c:pt>
                <c:pt idx="50">
                  <c:v>35.176524999999998</c:v>
                </c:pt>
                <c:pt idx="51">
                  <c:v>35.502400000000002</c:v>
                </c:pt>
                <c:pt idx="52">
                  <c:v>35.676169999999999</c:v>
                </c:pt>
                <c:pt idx="53">
                  <c:v>34.810549999999999</c:v>
                </c:pt>
                <c:pt idx="54">
                  <c:v>34.429299999999998</c:v>
                </c:pt>
                <c:pt idx="55">
                  <c:v>33.595965</c:v>
                </c:pt>
                <c:pt idx="56">
                  <c:v>32.795004999999996</c:v>
                </c:pt>
                <c:pt idx="57">
                  <c:v>31.856539999999995</c:v>
                </c:pt>
                <c:pt idx="58">
                  <c:v>30.44387</c:v>
                </c:pt>
                <c:pt idx="59">
                  <c:v>29.104600000000001</c:v>
                </c:pt>
                <c:pt idx="60">
                  <c:v>27.880264999999998</c:v>
                </c:pt>
                <c:pt idx="61">
                  <c:v>26.947579999999999</c:v>
                </c:pt>
                <c:pt idx="62">
                  <c:v>26.111064999999996</c:v>
                </c:pt>
                <c:pt idx="63">
                  <c:v>25.453835000000005</c:v>
                </c:pt>
                <c:pt idx="64">
                  <c:v>24.819475000000001</c:v>
                </c:pt>
                <c:pt idx="65">
                  <c:v>23.728160000000003</c:v>
                </c:pt>
                <c:pt idx="66">
                  <c:v>23.073954999999998</c:v>
                </c:pt>
                <c:pt idx="67">
                  <c:v>22.568249999999999</c:v>
                </c:pt>
                <c:pt idx="68">
                  <c:v>21.949164999999997</c:v>
                </c:pt>
                <c:pt idx="69">
                  <c:v>21.942589999999996</c:v>
                </c:pt>
                <c:pt idx="70">
                  <c:v>22.008505</c:v>
                </c:pt>
                <c:pt idx="71">
                  <c:v>22.125795</c:v>
                </c:pt>
                <c:pt idx="72">
                  <c:v>22.332089999999997</c:v>
                </c:pt>
                <c:pt idx="73">
                  <c:v>22.557745000000001</c:v>
                </c:pt>
                <c:pt idx="74">
                  <c:v>22.621320000000001</c:v>
                </c:pt>
                <c:pt idx="75">
                  <c:v>22.695854999999998</c:v>
                </c:pt>
                <c:pt idx="76">
                  <c:v>22.298060000000003</c:v>
                </c:pt>
                <c:pt idx="77">
                  <c:v>21.967554999999997</c:v>
                </c:pt>
                <c:pt idx="78">
                  <c:v>21.549975</c:v>
                </c:pt>
                <c:pt idx="79">
                  <c:v>21.062100000000001</c:v>
                </c:pt>
                <c:pt idx="80">
                  <c:v>20.561435000000003</c:v>
                </c:pt>
                <c:pt idx="81">
                  <c:v>19.9282</c:v>
                </c:pt>
                <c:pt idx="82">
                  <c:v>19.284435000000002</c:v>
                </c:pt>
                <c:pt idx="83">
                  <c:v>18.35548</c:v>
                </c:pt>
                <c:pt idx="84">
                  <c:v>17.511004999999997</c:v>
                </c:pt>
                <c:pt idx="85">
                  <c:v>16.623739999999998</c:v>
                </c:pt>
                <c:pt idx="86">
                  <c:v>15.728770000000001</c:v>
                </c:pt>
                <c:pt idx="87">
                  <c:v>14.623489999999997</c:v>
                </c:pt>
                <c:pt idx="88">
                  <c:v>13.664410000000004</c:v>
                </c:pt>
                <c:pt idx="89">
                  <c:v>13.071270000000002</c:v>
                </c:pt>
                <c:pt idx="90">
                  <c:v>13.165825</c:v>
                </c:pt>
                <c:pt idx="91">
                  <c:v>12.351414999999996</c:v>
                </c:pt>
                <c:pt idx="92">
                  <c:v>12.034364999999996</c:v>
                </c:pt>
                <c:pt idx="93">
                  <c:v>12.074735000000004</c:v>
                </c:pt>
                <c:pt idx="94">
                  <c:v>12.165820000000002</c:v>
                </c:pt>
                <c:pt idx="95">
                  <c:v>12.219570000000001</c:v>
                </c:pt>
                <c:pt idx="96">
                  <c:v>12.342089999999997</c:v>
                </c:pt>
                <c:pt idx="97">
                  <c:v>12.243325</c:v>
                </c:pt>
                <c:pt idx="98">
                  <c:v>12.17878</c:v>
                </c:pt>
                <c:pt idx="99">
                  <c:v>12.307639999999996</c:v>
                </c:pt>
                <c:pt idx="100">
                  <c:v>12.092835000000003</c:v>
                </c:pt>
                <c:pt idx="101">
                  <c:v>12.041179999999999</c:v>
                </c:pt>
                <c:pt idx="102">
                  <c:v>11.729054999999999</c:v>
                </c:pt>
                <c:pt idx="103">
                  <c:v>11.470599999999999</c:v>
                </c:pt>
                <c:pt idx="104">
                  <c:v>11.399075</c:v>
                </c:pt>
                <c:pt idx="105">
                  <c:v>11.170670000000001</c:v>
                </c:pt>
                <c:pt idx="106">
                  <c:v>10.848939999999997</c:v>
                </c:pt>
                <c:pt idx="107">
                  <c:v>10.794070000000001</c:v>
                </c:pt>
                <c:pt idx="108">
                  <c:v>10.549345000000001</c:v>
                </c:pt>
                <c:pt idx="109">
                  <c:v>10.411004999999999</c:v>
                </c:pt>
                <c:pt idx="110">
                  <c:v>10.29618</c:v>
                </c:pt>
                <c:pt idx="111">
                  <c:v>10.134575</c:v>
                </c:pt>
                <c:pt idx="112">
                  <c:v>10.075289999999997</c:v>
                </c:pt>
                <c:pt idx="113">
                  <c:v>10.017910000000004</c:v>
                </c:pt>
                <c:pt idx="114">
                  <c:v>10.038629999999999</c:v>
                </c:pt>
                <c:pt idx="115">
                  <c:v>9.8518600000000038</c:v>
                </c:pt>
                <c:pt idx="116">
                  <c:v>9.8006850000000032</c:v>
                </c:pt>
                <c:pt idx="117">
                  <c:v>9.6947950000000009</c:v>
                </c:pt>
                <c:pt idx="118">
                  <c:v>9.5914549999999981</c:v>
                </c:pt>
                <c:pt idx="119">
                  <c:v>9.5185700000000004</c:v>
                </c:pt>
                <c:pt idx="120">
                  <c:v>9.5460450000000012</c:v>
                </c:pt>
                <c:pt idx="121">
                  <c:v>9.4391499999999997</c:v>
                </c:pt>
                <c:pt idx="122">
                  <c:v>9.5253899999999962</c:v>
                </c:pt>
                <c:pt idx="123">
                  <c:v>9.5162700000000005</c:v>
                </c:pt>
                <c:pt idx="124">
                  <c:v>9.5238600000000027</c:v>
                </c:pt>
                <c:pt idx="125">
                  <c:v>9.3750399999999967</c:v>
                </c:pt>
                <c:pt idx="126">
                  <c:v>9.2478499999999997</c:v>
                </c:pt>
                <c:pt idx="127">
                  <c:v>9.1159399999999966</c:v>
                </c:pt>
                <c:pt idx="128">
                  <c:v>8.9958899999999957</c:v>
                </c:pt>
                <c:pt idx="129">
                  <c:v>8.916204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17F-4A13-BA30-0E18CB604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7142912"/>
        <c:axId val="37144448"/>
      </c:lineChart>
      <c:catAx>
        <c:axId val="37142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7144448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7144448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71429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Z$17:$BZ$146</c:f>
              <c:numCache>
                <c:formatCode>0.00</c:formatCode>
                <c:ptCount val="130"/>
                <c:pt idx="0">
                  <c:v>22.919459999999997</c:v>
                </c:pt>
                <c:pt idx="1">
                  <c:v>22.283459999999998</c:v>
                </c:pt>
                <c:pt idx="2">
                  <c:v>20.283620000000003</c:v>
                </c:pt>
                <c:pt idx="3">
                  <c:v>18.917940000000002</c:v>
                </c:pt>
                <c:pt idx="4">
                  <c:v>17.221020000000003</c:v>
                </c:pt>
                <c:pt idx="5">
                  <c:v>15.26038</c:v>
                </c:pt>
                <c:pt idx="6">
                  <c:v>13.614979999999999</c:v>
                </c:pt>
                <c:pt idx="7">
                  <c:v>12.138659999999998</c:v>
                </c:pt>
                <c:pt idx="8">
                  <c:v>11.136040000000003</c:v>
                </c:pt>
                <c:pt idx="9">
                  <c:v>10.415920000000002</c:v>
                </c:pt>
                <c:pt idx="10">
                  <c:v>10.764620000000001</c:v>
                </c:pt>
                <c:pt idx="11">
                  <c:v>11.2887</c:v>
                </c:pt>
                <c:pt idx="12">
                  <c:v>12.988320000000002</c:v>
                </c:pt>
                <c:pt idx="13">
                  <c:v>15.693679999999999</c:v>
                </c:pt>
                <c:pt idx="14">
                  <c:v>19.504659999999998</c:v>
                </c:pt>
                <c:pt idx="15">
                  <c:v>25.719459999999998</c:v>
                </c:pt>
                <c:pt idx="16">
                  <c:v>35.137779999999999</c:v>
                </c:pt>
                <c:pt idx="17">
                  <c:v>47.070740000000001</c:v>
                </c:pt>
                <c:pt idx="18">
                  <c:v>60.561180000000007</c:v>
                </c:pt>
                <c:pt idx="19">
                  <c:v>71.929959999999994</c:v>
                </c:pt>
                <c:pt idx="20">
                  <c:v>78.012119999999996</c:v>
                </c:pt>
                <c:pt idx="21">
                  <c:v>78.117239999999995</c:v>
                </c:pt>
                <c:pt idx="22">
                  <c:v>73.627139999999997</c:v>
                </c:pt>
                <c:pt idx="23">
                  <c:v>68.404560000000004</c:v>
                </c:pt>
                <c:pt idx="24">
                  <c:v>64.787499999999994</c:v>
                </c:pt>
                <c:pt idx="25">
                  <c:v>63.990419999999993</c:v>
                </c:pt>
                <c:pt idx="26">
                  <c:v>63.565919999999998</c:v>
                </c:pt>
                <c:pt idx="27">
                  <c:v>62.011859999999999</c:v>
                </c:pt>
                <c:pt idx="28">
                  <c:v>58.769919999999992</c:v>
                </c:pt>
                <c:pt idx="29">
                  <c:v>53.987659999999998</c:v>
                </c:pt>
                <c:pt idx="30">
                  <c:v>48.340060000000001</c:v>
                </c:pt>
                <c:pt idx="31">
                  <c:v>42.328659999999999</c:v>
                </c:pt>
                <c:pt idx="32">
                  <c:v>36.775799999999997</c:v>
                </c:pt>
                <c:pt idx="33">
                  <c:v>32.504919999999998</c:v>
                </c:pt>
                <c:pt idx="34">
                  <c:v>28.4331</c:v>
                </c:pt>
                <c:pt idx="35">
                  <c:v>25.5853</c:v>
                </c:pt>
                <c:pt idx="36">
                  <c:v>23.581740000000003</c:v>
                </c:pt>
                <c:pt idx="37">
                  <c:v>22.300879999999999</c:v>
                </c:pt>
                <c:pt idx="38">
                  <c:v>22.179359999999999</c:v>
                </c:pt>
                <c:pt idx="39">
                  <c:v>23.735040000000001</c:v>
                </c:pt>
                <c:pt idx="40">
                  <c:v>26.976659999999999</c:v>
                </c:pt>
                <c:pt idx="41">
                  <c:v>31.046459999999996</c:v>
                </c:pt>
                <c:pt idx="42">
                  <c:v>35.748919999999998</c:v>
                </c:pt>
                <c:pt idx="43">
                  <c:v>40.134159999999994</c:v>
                </c:pt>
                <c:pt idx="44">
                  <c:v>42.905320000000003</c:v>
                </c:pt>
                <c:pt idx="45">
                  <c:v>43.86074</c:v>
                </c:pt>
                <c:pt idx="46">
                  <c:v>43.499839999999999</c:v>
                </c:pt>
                <c:pt idx="47">
                  <c:v>42.38494</c:v>
                </c:pt>
                <c:pt idx="48">
                  <c:v>39.467420000000004</c:v>
                </c:pt>
                <c:pt idx="49">
                  <c:v>37.290599999999998</c:v>
                </c:pt>
                <c:pt idx="50">
                  <c:v>35.213239999999999</c:v>
                </c:pt>
                <c:pt idx="51">
                  <c:v>33.616599999999998</c:v>
                </c:pt>
                <c:pt idx="52">
                  <c:v>32.483499999999999</c:v>
                </c:pt>
                <c:pt idx="53">
                  <c:v>30.507840000000002</c:v>
                </c:pt>
                <c:pt idx="54">
                  <c:v>28.75038</c:v>
                </c:pt>
                <c:pt idx="55">
                  <c:v>26.837779999999999</c:v>
                </c:pt>
                <c:pt idx="56">
                  <c:v>25.162659999999999</c:v>
                </c:pt>
                <c:pt idx="57">
                  <c:v>23.437840000000001</c:v>
                </c:pt>
                <c:pt idx="58">
                  <c:v>22.101099999999999</c:v>
                </c:pt>
                <c:pt idx="59">
                  <c:v>21.058759999999996</c:v>
                </c:pt>
                <c:pt idx="60">
                  <c:v>20.2608</c:v>
                </c:pt>
                <c:pt idx="61">
                  <c:v>19.365759999999998</c:v>
                </c:pt>
                <c:pt idx="62">
                  <c:v>18.93872</c:v>
                </c:pt>
                <c:pt idx="63">
                  <c:v>18.664279999999998</c:v>
                </c:pt>
                <c:pt idx="64">
                  <c:v>19.328240000000001</c:v>
                </c:pt>
                <c:pt idx="65">
                  <c:v>20.782420000000002</c:v>
                </c:pt>
                <c:pt idx="66">
                  <c:v>22.889659999999999</c:v>
                </c:pt>
                <c:pt idx="67">
                  <c:v>25.340720000000001</c:v>
                </c:pt>
                <c:pt idx="68">
                  <c:v>27.761500000000002</c:v>
                </c:pt>
                <c:pt idx="69">
                  <c:v>29.685579999999998</c:v>
                </c:pt>
                <c:pt idx="70">
                  <c:v>30.33548</c:v>
                </c:pt>
                <c:pt idx="71">
                  <c:v>30.544240000000002</c:v>
                </c:pt>
                <c:pt idx="72">
                  <c:v>30.194179999999999</c:v>
                </c:pt>
                <c:pt idx="73">
                  <c:v>28.915620000000001</c:v>
                </c:pt>
                <c:pt idx="74">
                  <c:v>27.111520000000002</c:v>
                </c:pt>
                <c:pt idx="75">
                  <c:v>25.191479999999999</c:v>
                </c:pt>
                <c:pt idx="76">
                  <c:v>23.003059999999998</c:v>
                </c:pt>
                <c:pt idx="77">
                  <c:v>21.240379999999998</c:v>
                </c:pt>
                <c:pt idx="78">
                  <c:v>19.413359999999997</c:v>
                </c:pt>
                <c:pt idx="79">
                  <c:v>17.9282</c:v>
                </c:pt>
                <c:pt idx="80">
                  <c:v>16.859220000000001</c:v>
                </c:pt>
                <c:pt idx="81">
                  <c:v>16.300279999999997</c:v>
                </c:pt>
                <c:pt idx="82">
                  <c:v>15.519379999999998</c:v>
                </c:pt>
                <c:pt idx="83">
                  <c:v>14.967979999999999</c:v>
                </c:pt>
                <c:pt idx="84">
                  <c:v>14.654979999999998</c:v>
                </c:pt>
                <c:pt idx="85">
                  <c:v>14.520859999999997</c:v>
                </c:pt>
                <c:pt idx="86">
                  <c:v>14.560040000000003</c:v>
                </c:pt>
                <c:pt idx="87">
                  <c:v>14.5932</c:v>
                </c:pt>
                <c:pt idx="88">
                  <c:v>15.182600000000001</c:v>
                </c:pt>
                <c:pt idx="89">
                  <c:v>15.777859999999997</c:v>
                </c:pt>
                <c:pt idx="90">
                  <c:v>16.738040000000002</c:v>
                </c:pt>
                <c:pt idx="91">
                  <c:v>18.101520000000001</c:v>
                </c:pt>
                <c:pt idx="92">
                  <c:v>19.286640000000002</c:v>
                </c:pt>
                <c:pt idx="93">
                  <c:v>20.595240000000004</c:v>
                </c:pt>
                <c:pt idx="94">
                  <c:v>21.54468</c:v>
                </c:pt>
                <c:pt idx="95">
                  <c:v>21.807920000000003</c:v>
                </c:pt>
                <c:pt idx="96">
                  <c:v>21.549559999999996</c:v>
                </c:pt>
                <c:pt idx="97">
                  <c:v>20.710740000000001</c:v>
                </c:pt>
                <c:pt idx="98">
                  <c:v>19.613320000000002</c:v>
                </c:pt>
                <c:pt idx="99">
                  <c:v>18.215979999999998</c:v>
                </c:pt>
                <c:pt idx="100">
                  <c:v>16.973400000000002</c:v>
                </c:pt>
                <c:pt idx="101">
                  <c:v>15.637240000000002</c:v>
                </c:pt>
                <c:pt idx="102">
                  <c:v>14.271559999999997</c:v>
                </c:pt>
                <c:pt idx="103">
                  <c:v>13.11462</c:v>
                </c:pt>
                <c:pt idx="104">
                  <c:v>12.0944</c:v>
                </c:pt>
                <c:pt idx="105">
                  <c:v>11.214659999999999</c:v>
                </c:pt>
                <c:pt idx="106">
                  <c:v>10.495320000000001</c:v>
                </c:pt>
                <c:pt idx="107">
                  <c:v>10.173779999999999</c:v>
                </c:pt>
                <c:pt idx="108">
                  <c:v>9.7830400000000015</c:v>
                </c:pt>
                <c:pt idx="109">
                  <c:v>9.6417599999999979</c:v>
                </c:pt>
                <c:pt idx="110">
                  <c:v>9.792740000000002</c:v>
                </c:pt>
                <c:pt idx="111">
                  <c:v>10.041579999999998</c:v>
                </c:pt>
                <c:pt idx="112">
                  <c:v>10.421559999999998</c:v>
                </c:pt>
                <c:pt idx="113">
                  <c:v>10.898320000000002</c:v>
                </c:pt>
                <c:pt idx="114">
                  <c:v>11.631959999999998</c:v>
                </c:pt>
                <c:pt idx="115">
                  <c:v>12.475559999999998</c:v>
                </c:pt>
                <c:pt idx="116">
                  <c:v>13.361599999999999</c:v>
                </c:pt>
                <c:pt idx="117">
                  <c:v>14.128640000000003</c:v>
                </c:pt>
                <c:pt idx="118">
                  <c:v>14.810179999999999</c:v>
                </c:pt>
                <c:pt idx="119">
                  <c:v>15.319699999999999</c:v>
                </c:pt>
                <c:pt idx="120">
                  <c:v>15.4192</c:v>
                </c:pt>
                <c:pt idx="121">
                  <c:v>15.419759999999998</c:v>
                </c:pt>
                <c:pt idx="122">
                  <c:v>14.421679999999999</c:v>
                </c:pt>
                <c:pt idx="123">
                  <c:v>13.710599999999999</c:v>
                </c:pt>
                <c:pt idx="124">
                  <c:v>10.891540000000003</c:v>
                </c:pt>
                <c:pt idx="125">
                  <c:v>11.9697</c:v>
                </c:pt>
                <c:pt idx="126">
                  <c:v>11.046520000000001</c:v>
                </c:pt>
                <c:pt idx="127">
                  <c:v>10.2011</c:v>
                </c:pt>
                <c:pt idx="128">
                  <c:v>9.5023</c:v>
                </c:pt>
                <c:pt idx="129">
                  <c:v>8.89114000000000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FC-47A2-992F-F62E0ABB7B83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A$17:$CA$146</c:f>
              <c:numCache>
                <c:formatCode>0.00</c:formatCode>
                <c:ptCount val="130"/>
                <c:pt idx="0">
                  <c:v>53.45626</c:v>
                </c:pt>
                <c:pt idx="1">
                  <c:v>50.352759999999996</c:v>
                </c:pt>
                <c:pt idx="2">
                  <c:v>47.872520000000002</c:v>
                </c:pt>
                <c:pt idx="3">
                  <c:v>44.125340000000001</c:v>
                </c:pt>
                <c:pt idx="4">
                  <c:v>40.045120000000004</c:v>
                </c:pt>
                <c:pt idx="5">
                  <c:v>36.210279999999997</c:v>
                </c:pt>
                <c:pt idx="6">
                  <c:v>32.774979999999999</c:v>
                </c:pt>
                <c:pt idx="7">
                  <c:v>29.342859999999998</c:v>
                </c:pt>
                <c:pt idx="8">
                  <c:v>26.748240000000003</c:v>
                </c:pt>
                <c:pt idx="9">
                  <c:v>24.840220000000002</c:v>
                </c:pt>
                <c:pt idx="10">
                  <c:v>24.040620000000001</c:v>
                </c:pt>
                <c:pt idx="11">
                  <c:v>24.558599999999998</c:v>
                </c:pt>
                <c:pt idx="12">
                  <c:v>26.993220000000001</c:v>
                </c:pt>
                <c:pt idx="13">
                  <c:v>31.720279999999999</c:v>
                </c:pt>
                <c:pt idx="14">
                  <c:v>38.98216</c:v>
                </c:pt>
                <c:pt idx="15">
                  <c:v>48.436959999999999</c:v>
                </c:pt>
                <c:pt idx="16">
                  <c:v>63.643980000000006</c:v>
                </c:pt>
                <c:pt idx="17">
                  <c:v>86.630040000000008</c:v>
                </c:pt>
                <c:pt idx="18">
                  <c:v>112.83098000000001</c:v>
                </c:pt>
                <c:pt idx="19">
                  <c:v>137.58946</c:v>
                </c:pt>
                <c:pt idx="20">
                  <c:v>153.83302</c:v>
                </c:pt>
                <c:pt idx="21">
                  <c:v>158.33983999999998</c:v>
                </c:pt>
                <c:pt idx="22">
                  <c:v>150.82863999999998</c:v>
                </c:pt>
                <c:pt idx="23">
                  <c:v>135.09426000000002</c:v>
                </c:pt>
                <c:pt idx="24">
                  <c:v>119.72920000000001</c:v>
                </c:pt>
                <c:pt idx="25">
                  <c:v>110.22972</c:v>
                </c:pt>
                <c:pt idx="26">
                  <c:v>106.11721999999999</c:v>
                </c:pt>
                <c:pt idx="27">
                  <c:v>103.69136</c:v>
                </c:pt>
                <c:pt idx="28">
                  <c:v>99.112519999999989</c:v>
                </c:pt>
                <c:pt idx="29">
                  <c:v>91.364859999999993</c:v>
                </c:pt>
                <c:pt idx="30">
                  <c:v>81.806960000000004</c:v>
                </c:pt>
                <c:pt idx="31">
                  <c:v>71.492159999999998</c:v>
                </c:pt>
                <c:pt idx="32">
                  <c:v>60.122</c:v>
                </c:pt>
                <c:pt idx="33">
                  <c:v>50.579720000000002</c:v>
                </c:pt>
                <c:pt idx="34">
                  <c:v>42.481900000000003</c:v>
                </c:pt>
                <c:pt idx="35">
                  <c:v>36.964799999999997</c:v>
                </c:pt>
                <c:pt idx="36">
                  <c:v>33.104440000000004</c:v>
                </c:pt>
                <c:pt idx="37">
                  <c:v>31.07978</c:v>
                </c:pt>
                <c:pt idx="38">
                  <c:v>31.843559999999997</c:v>
                </c:pt>
                <c:pt idx="39">
                  <c:v>35.640240000000006</c:v>
                </c:pt>
                <c:pt idx="40">
                  <c:v>41.954159999999995</c:v>
                </c:pt>
                <c:pt idx="41">
                  <c:v>49.872659999999996</c:v>
                </c:pt>
                <c:pt idx="42">
                  <c:v>58.361619999999995</c:v>
                </c:pt>
                <c:pt idx="43">
                  <c:v>66.474360000000004</c:v>
                </c:pt>
                <c:pt idx="44">
                  <c:v>71.539319999999989</c:v>
                </c:pt>
                <c:pt idx="45">
                  <c:v>74.220839999999995</c:v>
                </c:pt>
                <c:pt idx="46">
                  <c:v>73.425939999999997</c:v>
                </c:pt>
                <c:pt idx="47">
                  <c:v>71.876840000000001</c:v>
                </c:pt>
                <c:pt idx="48">
                  <c:v>67.226219999999998</c:v>
                </c:pt>
                <c:pt idx="49">
                  <c:v>62.1629</c:v>
                </c:pt>
                <c:pt idx="50">
                  <c:v>57.611840000000001</c:v>
                </c:pt>
                <c:pt idx="51">
                  <c:v>54.046199999999999</c:v>
                </c:pt>
                <c:pt idx="52">
                  <c:v>50.833199999999998</c:v>
                </c:pt>
                <c:pt idx="53">
                  <c:v>47.74324</c:v>
                </c:pt>
                <c:pt idx="54">
                  <c:v>44.949080000000002</c:v>
                </c:pt>
                <c:pt idx="55">
                  <c:v>42.056379999999997</c:v>
                </c:pt>
                <c:pt idx="56">
                  <c:v>39.290859999999995</c:v>
                </c:pt>
                <c:pt idx="57">
                  <c:v>36.737140000000004</c:v>
                </c:pt>
                <c:pt idx="58">
                  <c:v>34.1053</c:v>
                </c:pt>
                <c:pt idx="59">
                  <c:v>31.795659999999998</c:v>
                </c:pt>
                <c:pt idx="60">
                  <c:v>29.956199999999999</c:v>
                </c:pt>
                <c:pt idx="61">
                  <c:v>28.862359999999999</c:v>
                </c:pt>
                <c:pt idx="62">
                  <c:v>29.010820000000002</c:v>
                </c:pt>
                <c:pt idx="63">
                  <c:v>29.79618</c:v>
                </c:pt>
                <c:pt idx="64">
                  <c:v>31.359140000000004</c:v>
                </c:pt>
                <c:pt idx="65">
                  <c:v>34.255119999999998</c:v>
                </c:pt>
                <c:pt idx="66">
                  <c:v>37.880859999999998</c:v>
                </c:pt>
                <c:pt idx="67">
                  <c:v>41.92962</c:v>
                </c:pt>
                <c:pt idx="68">
                  <c:v>45.425699999999999</c:v>
                </c:pt>
                <c:pt idx="69">
                  <c:v>48.611179999999997</c:v>
                </c:pt>
                <c:pt idx="70">
                  <c:v>50.761879999999998</c:v>
                </c:pt>
                <c:pt idx="71">
                  <c:v>51.159240000000004</c:v>
                </c:pt>
                <c:pt idx="72">
                  <c:v>50.728279999999998</c:v>
                </c:pt>
                <c:pt idx="73">
                  <c:v>48.761119999999998</c:v>
                </c:pt>
                <c:pt idx="74">
                  <c:v>46.025620000000004</c:v>
                </c:pt>
                <c:pt idx="75">
                  <c:v>43.014479999999999</c:v>
                </c:pt>
                <c:pt idx="76">
                  <c:v>39.100259999999999</c:v>
                </c:pt>
                <c:pt idx="77">
                  <c:v>35.471679999999999</c:v>
                </c:pt>
                <c:pt idx="78">
                  <c:v>32.294460000000001</c:v>
                </c:pt>
                <c:pt idx="79">
                  <c:v>29.651900000000001</c:v>
                </c:pt>
                <c:pt idx="80">
                  <c:v>27.57292</c:v>
                </c:pt>
                <c:pt idx="81">
                  <c:v>26.626279999999998</c:v>
                </c:pt>
                <c:pt idx="82">
                  <c:v>25.674879999999998</c:v>
                </c:pt>
                <c:pt idx="83">
                  <c:v>24.984279999999998</c:v>
                </c:pt>
                <c:pt idx="84">
                  <c:v>24.650980000000001</c:v>
                </c:pt>
                <c:pt idx="85">
                  <c:v>24.188059999999997</c:v>
                </c:pt>
                <c:pt idx="86">
                  <c:v>24.224440000000001</c:v>
                </c:pt>
                <c:pt idx="87">
                  <c:v>23.985700000000001</c:v>
                </c:pt>
                <c:pt idx="88">
                  <c:v>24.439699999999998</c:v>
                </c:pt>
                <c:pt idx="89">
                  <c:v>25.435759999999998</c:v>
                </c:pt>
                <c:pt idx="90">
                  <c:v>27.445540000000001</c:v>
                </c:pt>
                <c:pt idx="91">
                  <c:v>30.729620000000001</c:v>
                </c:pt>
                <c:pt idx="92">
                  <c:v>34.180240000000005</c:v>
                </c:pt>
                <c:pt idx="93">
                  <c:v>36.917840000000005</c:v>
                </c:pt>
                <c:pt idx="94">
                  <c:v>37.988880000000002</c:v>
                </c:pt>
                <c:pt idx="95">
                  <c:v>38.655320000000003</c:v>
                </c:pt>
                <c:pt idx="96">
                  <c:v>38.06476</c:v>
                </c:pt>
                <c:pt idx="97">
                  <c:v>36.508340000000004</c:v>
                </c:pt>
                <c:pt idx="98">
                  <c:v>34.603920000000002</c:v>
                </c:pt>
                <c:pt idx="99">
                  <c:v>32.056979999999996</c:v>
                </c:pt>
                <c:pt idx="100">
                  <c:v>29.479099999999999</c:v>
                </c:pt>
                <c:pt idx="101">
                  <c:v>27.170140000000004</c:v>
                </c:pt>
                <c:pt idx="102">
                  <c:v>24.740659999999998</c:v>
                </c:pt>
                <c:pt idx="103">
                  <c:v>22.998920000000002</c:v>
                </c:pt>
                <c:pt idx="104">
                  <c:v>21.499099999999999</c:v>
                </c:pt>
                <c:pt idx="105">
                  <c:v>20.116259999999997</c:v>
                </c:pt>
                <c:pt idx="106">
                  <c:v>18.778420000000001</c:v>
                </c:pt>
                <c:pt idx="107">
                  <c:v>17.789079999999998</c:v>
                </c:pt>
                <c:pt idx="108">
                  <c:v>16.872640000000004</c:v>
                </c:pt>
                <c:pt idx="109">
                  <c:v>16.245759999999997</c:v>
                </c:pt>
                <c:pt idx="110">
                  <c:v>15.764940000000003</c:v>
                </c:pt>
                <c:pt idx="111">
                  <c:v>15.484879999999999</c:v>
                </c:pt>
                <c:pt idx="112">
                  <c:v>15.757659999999998</c:v>
                </c:pt>
                <c:pt idx="113">
                  <c:v>16.456520000000001</c:v>
                </c:pt>
                <c:pt idx="114">
                  <c:v>17.515059999999998</c:v>
                </c:pt>
                <c:pt idx="115">
                  <c:v>19.264359999999996</c:v>
                </c:pt>
                <c:pt idx="116">
                  <c:v>21.317</c:v>
                </c:pt>
                <c:pt idx="117">
                  <c:v>23.274440000000002</c:v>
                </c:pt>
                <c:pt idx="118">
                  <c:v>25.09308</c:v>
                </c:pt>
                <c:pt idx="119">
                  <c:v>26.445900000000002</c:v>
                </c:pt>
                <c:pt idx="120">
                  <c:v>26.965699999999998</c:v>
                </c:pt>
                <c:pt idx="121">
                  <c:v>27.108759999999997</c:v>
                </c:pt>
                <c:pt idx="122">
                  <c:v>26.46508</c:v>
                </c:pt>
                <c:pt idx="123">
                  <c:v>25.308900000000001</c:v>
                </c:pt>
                <c:pt idx="124">
                  <c:v>21.842940000000002</c:v>
                </c:pt>
                <c:pt idx="125">
                  <c:v>21.7881</c:v>
                </c:pt>
                <c:pt idx="126">
                  <c:v>20.069320000000001</c:v>
                </c:pt>
                <c:pt idx="127">
                  <c:v>18.350100000000001</c:v>
                </c:pt>
                <c:pt idx="128">
                  <c:v>16.702300000000001</c:v>
                </c:pt>
                <c:pt idx="129">
                  <c:v>15.32414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FC-47A2-992F-F62E0ABB7B83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B$17:$CB$146</c:f>
              <c:numCache>
                <c:formatCode>0.00</c:formatCode>
                <c:ptCount val="130"/>
                <c:pt idx="0">
                  <c:v>53.955559999999998</c:v>
                </c:pt>
                <c:pt idx="1">
                  <c:v>50.873860000000001</c:v>
                </c:pt>
                <c:pt idx="2">
                  <c:v>46.32152</c:v>
                </c:pt>
                <c:pt idx="3">
                  <c:v>41.486940000000004</c:v>
                </c:pt>
                <c:pt idx="4">
                  <c:v>36.269120000000001</c:v>
                </c:pt>
                <c:pt idx="5">
                  <c:v>31.058579999999999</c:v>
                </c:pt>
                <c:pt idx="6">
                  <c:v>26.318279999999998</c:v>
                </c:pt>
                <c:pt idx="7">
                  <c:v>23.029159999999997</c:v>
                </c:pt>
                <c:pt idx="8">
                  <c:v>20.675040000000003</c:v>
                </c:pt>
                <c:pt idx="9">
                  <c:v>18.991020000000002</c:v>
                </c:pt>
                <c:pt idx="10">
                  <c:v>17.824120000000001</c:v>
                </c:pt>
                <c:pt idx="11">
                  <c:v>17.771100000000001</c:v>
                </c:pt>
                <c:pt idx="12">
                  <c:v>19.029720000000001</c:v>
                </c:pt>
                <c:pt idx="13">
                  <c:v>22.108179999999997</c:v>
                </c:pt>
                <c:pt idx="14">
                  <c:v>27.051559999999998</c:v>
                </c:pt>
                <c:pt idx="15">
                  <c:v>34.786960000000001</c:v>
                </c:pt>
                <c:pt idx="16">
                  <c:v>46.390079999999998</c:v>
                </c:pt>
                <c:pt idx="17">
                  <c:v>63.907240000000002</c:v>
                </c:pt>
                <c:pt idx="18">
                  <c:v>83.438680000000005</c:v>
                </c:pt>
                <c:pt idx="19">
                  <c:v>100.30535999999999</c:v>
                </c:pt>
                <c:pt idx="20">
                  <c:v>110.89312</c:v>
                </c:pt>
                <c:pt idx="21">
                  <c:v>113.98993999999999</c:v>
                </c:pt>
                <c:pt idx="22">
                  <c:v>110.73203999999998</c:v>
                </c:pt>
                <c:pt idx="23">
                  <c:v>102.32346</c:v>
                </c:pt>
                <c:pt idx="24">
                  <c:v>91.391999999999996</c:v>
                </c:pt>
                <c:pt idx="25">
                  <c:v>81.641619999999989</c:v>
                </c:pt>
                <c:pt idx="26">
                  <c:v>73.816719999999989</c:v>
                </c:pt>
                <c:pt idx="27">
                  <c:v>67.857759999999999</c:v>
                </c:pt>
                <c:pt idx="28">
                  <c:v>63.094519999999996</c:v>
                </c:pt>
                <c:pt idx="29">
                  <c:v>57.89226</c:v>
                </c:pt>
                <c:pt idx="30">
                  <c:v>51.956159999999997</c:v>
                </c:pt>
                <c:pt idx="31">
                  <c:v>45.573859999999996</c:v>
                </c:pt>
                <c:pt idx="32">
                  <c:v>38.226999999999997</c:v>
                </c:pt>
                <c:pt idx="33">
                  <c:v>32.513919999999999</c:v>
                </c:pt>
                <c:pt idx="34">
                  <c:v>27.84</c:v>
                </c:pt>
                <c:pt idx="35">
                  <c:v>24.151700000000002</c:v>
                </c:pt>
                <c:pt idx="36">
                  <c:v>21.737440000000003</c:v>
                </c:pt>
                <c:pt idx="37">
                  <c:v>20.719279999999998</c:v>
                </c:pt>
                <c:pt idx="38">
                  <c:v>21.022759999999998</c:v>
                </c:pt>
                <c:pt idx="39">
                  <c:v>22.523640000000004</c:v>
                </c:pt>
                <c:pt idx="40">
                  <c:v>25.456059999999997</c:v>
                </c:pt>
                <c:pt idx="41">
                  <c:v>30.053759999999997</c:v>
                </c:pt>
                <c:pt idx="42">
                  <c:v>36.081119999999999</c:v>
                </c:pt>
                <c:pt idx="43">
                  <c:v>41.81326</c:v>
                </c:pt>
                <c:pt idx="44">
                  <c:v>47.150320000000001</c:v>
                </c:pt>
                <c:pt idx="45">
                  <c:v>50.079039999999999</c:v>
                </c:pt>
                <c:pt idx="46">
                  <c:v>51.198740000000001</c:v>
                </c:pt>
                <c:pt idx="47">
                  <c:v>50.203040000000001</c:v>
                </c:pt>
                <c:pt idx="48">
                  <c:v>47.612720000000003</c:v>
                </c:pt>
                <c:pt idx="49">
                  <c:v>43.854999999999997</c:v>
                </c:pt>
                <c:pt idx="50">
                  <c:v>39.88364</c:v>
                </c:pt>
                <c:pt idx="51">
                  <c:v>36.251600000000003</c:v>
                </c:pt>
                <c:pt idx="52">
                  <c:v>33.174999999999997</c:v>
                </c:pt>
                <c:pt idx="53">
                  <c:v>30.212540000000001</c:v>
                </c:pt>
                <c:pt idx="54">
                  <c:v>27.946179999999998</c:v>
                </c:pt>
                <c:pt idx="55">
                  <c:v>26.184079999999998</c:v>
                </c:pt>
                <c:pt idx="56">
                  <c:v>24.792359999999999</c:v>
                </c:pt>
                <c:pt idx="57">
                  <c:v>23.102640000000001</c:v>
                </c:pt>
                <c:pt idx="58">
                  <c:v>21.5533</c:v>
                </c:pt>
                <c:pt idx="59">
                  <c:v>20.292159999999999</c:v>
                </c:pt>
                <c:pt idx="60">
                  <c:v>18.974599999999999</c:v>
                </c:pt>
                <c:pt idx="61">
                  <c:v>17.945859999999996</c:v>
                </c:pt>
                <c:pt idx="62">
                  <c:v>17.335520000000002</c:v>
                </c:pt>
                <c:pt idx="63">
                  <c:v>17.121279999999999</c:v>
                </c:pt>
                <c:pt idx="64">
                  <c:v>17.310340000000004</c:v>
                </c:pt>
                <c:pt idx="65">
                  <c:v>18.509820000000001</c:v>
                </c:pt>
                <c:pt idx="66">
                  <c:v>20.233259999999998</c:v>
                </c:pt>
                <c:pt idx="67">
                  <c:v>22.28152</c:v>
                </c:pt>
                <c:pt idx="68">
                  <c:v>25.392199999999999</c:v>
                </c:pt>
                <c:pt idx="69">
                  <c:v>27.987880000000001</c:v>
                </c:pt>
                <c:pt idx="70">
                  <c:v>30.363879999999998</c:v>
                </c:pt>
                <c:pt idx="71">
                  <c:v>31.878240000000002</c:v>
                </c:pt>
                <c:pt idx="72">
                  <c:v>32.347879999999996</c:v>
                </c:pt>
                <c:pt idx="73">
                  <c:v>31.869420000000002</c:v>
                </c:pt>
                <c:pt idx="74">
                  <c:v>30.628320000000002</c:v>
                </c:pt>
                <c:pt idx="75">
                  <c:v>28.743779999999997</c:v>
                </c:pt>
                <c:pt idx="76">
                  <c:v>26.539459999999998</c:v>
                </c:pt>
                <c:pt idx="77">
                  <c:v>24.11158</c:v>
                </c:pt>
                <c:pt idx="78">
                  <c:v>21.532159999999998</c:v>
                </c:pt>
                <c:pt idx="79">
                  <c:v>19.028199999999998</c:v>
                </c:pt>
                <c:pt idx="80">
                  <c:v>16.95542</c:v>
                </c:pt>
                <c:pt idx="81">
                  <c:v>15.623479999999999</c:v>
                </c:pt>
                <c:pt idx="82">
                  <c:v>14.796879999999998</c:v>
                </c:pt>
                <c:pt idx="83">
                  <c:v>14.177079999999998</c:v>
                </c:pt>
                <c:pt idx="84">
                  <c:v>13.77638</c:v>
                </c:pt>
                <c:pt idx="85">
                  <c:v>13.675659999999997</c:v>
                </c:pt>
                <c:pt idx="86">
                  <c:v>13.773640000000002</c:v>
                </c:pt>
                <c:pt idx="87">
                  <c:v>14.077400000000001</c:v>
                </c:pt>
                <c:pt idx="88">
                  <c:v>14.567399999999999</c:v>
                </c:pt>
                <c:pt idx="89">
                  <c:v>15.116259999999997</c:v>
                </c:pt>
                <c:pt idx="90">
                  <c:v>15.973840000000003</c:v>
                </c:pt>
                <c:pt idx="91">
                  <c:v>17.17822</c:v>
                </c:pt>
                <c:pt idx="92">
                  <c:v>18.502440000000004</c:v>
                </c:pt>
                <c:pt idx="93">
                  <c:v>20.164840000000002</c:v>
                </c:pt>
                <c:pt idx="94">
                  <c:v>21.908279999999998</c:v>
                </c:pt>
                <c:pt idx="95">
                  <c:v>23.466820000000002</c:v>
                </c:pt>
                <c:pt idx="96">
                  <c:v>24.494659999999996</c:v>
                </c:pt>
                <c:pt idx="97">
                  <c:v>24.894740000000002</c:v>
                </c:pt>
                <c:pt idx="98">
                  <c:v>24.25592</c:v>
                </c:pt>
                <c:pt idx="99">
                  <c:v>23.159579999999998</c:v>
                </c:pt>
                <c:pt idx="100">
                  <c:v>22.017199999999999</c:v>
                </c:pt>
                <c:pt idx="101">
                  <c:v>20.159040000000001</c:v>
                </c:pt>
                <c:pt idx="102">
                  <c:v>17.966859999999997</c:v>
                </c:pt>
                <c:pt idx="103">
                  <c:v>16.191320000000001</c:v>
                </c:pt>
                <c:pt idx="104">
                  <c:v>14.527200000000001</c:v>
                </c:pt>
                <c:pt idx="105">
                  <c:v>13.164059999999997</c:v>
                </c:pt>
                <c:pt idx="106">
                  <c:v>12.264120000000002</c:v>
                </c:pt>
                <c:pt idx="107">
                  <c:v>11.563679999999998</c:v>
                </c:pt>
                <c:pt idx="108">
                  <c:v>11.198240000000002</c:v>
                </c:pt>
                <c:pt idx="109">
                  <c:v>10.923959999999997</c:v>
                </c:pt>
                <c:pt idx="110">
                  <c:v>10.786640000000002</c:v>
                </c:pt>
                <c:pt idx="111">
                  <c:v>10.591379999999999</c:v>
                </c:pt>
                <c:pt idx="112">
                  <c:v>10.763859999999998</c:v>
                </c:pt>
                <c:pt idx="113">
                  <c:v>10.942920000000001</c:v>
                </c:pt>
                <c:pt idx="114">
                  <c:v>11.504459999999998</c:v>
                </c:pt>
                <c:pt idx="115">
                  <c:v>12.279759999999998</c:v>
                </c:pt>
                <c:pt idx="116">
                  <c:v>13.334099999999999</c:v>
                </c:pt>
                <c:pt idx="117">
                  <c:v>14.499040000000003</c:v>
                </c:pt>
                <c:pt idx="118">
                  <c:v>16.026679999999999</c:v>
                </c:pt>
                <c:pt idx="119">
                  <c:v>17.269400000000001</c:v>
                </c:pt>
                <c:pt idx="120">
                  <c:v>18.140799999999999</c:v>
                </c:pt>
                <c:pt idx="121">
                  <c:v>18.532659999999996</c:v>
                </c:pt>
                <c:pt idx="122">
                  <c:v>18.26418</c:v>
                </c:pt>
                <c:pt idx="123">
                  <c:v>18.0123</c:v>
                </c:pt>
                <c:pt idx="124">
                  <c:v>15.135440000000003</c:v>
                </c:pt>
                <c:pt idx="125">
                  <c:v>15.9069</c:v>
                </c:pt>
                <c:pt idx="126">
                  <c:v>14.932820000000001</c:v>
                </c:pt>
                <c:pt idx="127">
                  <c:v>13.6677</c:v>
                </c:pt>
                <c:pt idx="128">
                  <c:v>12.437099999999999</c:v>
                </c:pt>
                <c:pt idx="129">
                  <c:v>11.31874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3FC-47A2-992F-F62E0ABB7B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1746816"/>
        <c:axId val="41748352"/>
      </c:lineChart>
      <c:catAx>
        <c:axId val="41746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1748352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41748352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417468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W$17:$BW$146</c:f>
              <c:numCache>
                <c:formatCode>0.00</c:formatCode>
                <c:ptCount val="130"/>
                <c:pt idx="0">
                  <c:v>190.091455</c:v>
                </c:pt>
                <c:pt idx="1">
                  <c:v>181.007655</c:v>
                </c:pt>
                <c:pt idx="2">
                  <c:v>171.6345225</c:v>
                </c:pt>
                <c:pt idx="3">
                  <c:v>162.003545</c:v>
                </c:pt>
                <c:pt idx="4">
                  <c:v>150.7206975</c:v>
                </c:pt>
                <c:pt idx="5">
                  <c:v>137.17701499999998</c:v>
                </c:pt>
                <c:pt idx="6">
                  <c:v>122.92510249999999</c:v>
                </c:pt>
                <c:pt idx="7">
                  <c:v>108.97626750000001</c:v>
                </c:pt>
                <c:pt idx="8">
                  <c:v>97.226857499999994</c:v>
                </c:pt>
                <c:pt idx="9">
                  <c:v>86.993610000000004</c:v>
                </c:pt>
                <c:pt idx="10">
                  <c:v>79.92734750000001</c:v>
                </c:pt>
                <c:pt idx="11">
                  <c:v>76.556325000000001</c:v>
                </c:pt>
                <c:pt idx="12">
                  <c:v>78.125285000000005</c:v>
                </c:pt>
                <c:pt idx="13">
                  <c:v>80.829789999999988</c:v>
                </c:pt>
                <c:pt idx="14">
                  <c:v>85.590730000000008</c:v>
                </c:pt>
                <c:pt idx="15">
                  <c:v>92.016580000000005</c:v>
                </c:pt>
                <c:pt idx="16">
                  <c:v>101.41266499999999</c:v>
                </c:pt>
                <c:pt idx="17">
                  <c:v>111.2649825</c:v>
                </c:pt>
                <c:pt idx="18">
                  <c:v>122.20867749999999</c:v>
                </c:pt>
                <c:pt idx="19">
                  <c:v>131.46694250000002</c:v>
                </c:pt>
                <c:pt idx="20">
                  <c:v>135.3611975</c:v>
                </c:pt>
                <c:pt idx="21">
                  <c:v>141.1336575</c:v>
                </c:pt>
                <c:pt idx="22">
                  <c:v>146.0002575</c:v>
                </c:pt>
                <c:pt idx="23">
                  <c:v>150.4440175</c:v>
                </c:pt>
                <c:pt idx="24">
                  <c:v>161.60683750000001</c:v>
                </c:pt>
                <c:pt idx="25">
                  <c:v>168.895385</c:v>
                </c:pt>
                <c:pt idx="26">
                  <c:v>172.39471</c:v>
                </c:pt>
                <c:pt idx="27">
                  <c:v>172.60388</c:v>
                </c:pt>
                <c:pt idx="28">
                  <c:v>167.9780475</c:v>
                </c:pt>
                <c:pt idx="29">
                  <c:v>160.57255499999999</c:v>
                </c:pt>
                <c:pt idx="30">
                  <c:v>154.75274250000001</c:v>
                </c:pt>
                <c:pt idx="31">
                  <c:v>151.09990500000001</c:v>
                </c:pt>
                <c:pt idx="32">
                  <c:v>148.75618750000001</c:v>
                </c:pt>
                <c:pt idx="33">
                  <c:v>149.869585</c:v>
                </c:pt>
                <c:pt idx="34">
                  <c:v>149.06344999999999</c:v>
                </c:pt>
                <c:pt idx="35">
                  <c:v>148.637</c:v>
                </c:pt>
                <c:pt idx="36">
                  <c:v>144.45865749999999</c:v>
                </c:pt>
                <c:pt idx="37">
                  <c:v>137.69827749999999</c:v>
                </c:pt>
                <c:pt idx="38">
                  <c:v>132.30233000000001</c:v>
                </c:pt>
                <c:pt idx="39">
                  <c:v>127.84474499999999</c:v>
                </c:pt>
                <c:pt idx="40">
                  <c:v>122.61778000000001</c:v>
                </c:pt>
                <c:pt idx="41">
                  <c:v>118.18386750000001</c:v>
                </c:pt>
                <c:pt idx="42">
                  <c:v>113.68262250000001</c:v>
                </c:pt>
                <c:pt idx="43">
                  <c:v>109.43169250000001</c:v>
                </c:pt>
                <c:pt idx="44">
                  <c:v>105.57266000000001</c:v>
                </c:pt>
                <c:pt idx="45">
                  <c:v>101.966095</c:v>
                </c:pt>
                <c:pt idx="46">
                  <c:v>98.755719999999997</c:v>
                </c:pt>
                <c:pt idx="47">
                  <c:v>97.273757500000002</c:v>
                </c:pt>
                <c:pt idx="48">
                  <c:v>95.172872500000011</c:v>
                </c:pt>
                <c:pt idx="49">
                  <c:v>92.808425</c:v>
                </c:pt>
                <c:pt idx="50">
                  <c:v>90.852807499999997</c:v>
                </c:pt>
                <c:pt idx="51">
                  <c:v>89.042887500000006</c:v>
                </c:pt>
                <c:pt idx="52">
                  <c:v>87.479924999999994</c:v>
                </c:pt>
                <c:pt idx="53">
                  <c:v>86.645057499999993</c:v>
                </c:pt>
                <c:pt idx="54">
                  <c:v>86.223227499999993</c:v>
                </c:pt>
                <c:pt idx="55">
                  <c:v>87.433339999999987</c:v>
                </c:pt>
                <c:pt idx="56">
                  <c:v>88.844542500000003</c:v>
                </c:pt>
                <c:pt idx="57">
                  <c:v>90.063682499999999</c:v>
                </c:pt>
                <c:pt idx="58">
                  <c:v>91.143862499999997</c:v>
                </c:pt>
                <c:pt idx="59">
                  <c:v>91.38244250000001</c:v>
                </c:pt>
                <c:pt idx="60">
                  <c:v>91.181712500000003</c:v>
                </c:pt>
                <c:pt idx="61">
                  <c:v>89.855730000000008</c:v>
                </c:pt>
                <c:pt idx="62">
                  <c:v>87.912860000000009</c:v>
                </c:pt>
                <c:pt idx="63">
                  <c:v>85.742889999999989</c:v>
                </c:pt>
                <c:pt idx="64">
                  <c:v>83.712732500000001</c:v>
                </c:pt>
                <c:pt idx="65">
                  <c:v>81.719722500000003</c:v>
                </c:pt>
                <c:pt idx="66">
                  <c:v>79.636742500000011</c:v>
                </c:pt>
                <c:pt idx="67">
                  <c:v>77.13676000000001</c:v>
                </c:pt>
                <c:pt idx="68">
                  <c:v>75.401462499999994</c:v>
                </c:pt>
                <c:pt idx="69">
                  <c:v>73.601039999999998</c:v>
                </c:pt>
                <c:pt idx="70">
                  <c:v>72.045127499999992</c:v>
                </c:pt>
                <c:pt idx="71">
                  <c:v>70.21087</c:v>
                </c:pt>
                <c:pt idx="72">
                  <c:v>69.546839999999989</c:v>
                </c:pt>
                <c:pt idx="73">
                  <c:v>68.83167250000001</c:v>
                </c:pt>
                <c:pt idx="74">
                  <c:v>68.792785000000009</c:v>
                </c:pt>
                <c:pt idx="75">
                  <c:v>68.571789999999993</c:v>
                </c:pt>
                <c:pt idx="76">
                  <c:v>68.255542500000004</c:v>
                </c:pt>
                <c:pt idx="77">
                  <c:v>67.365589999999997</c:v>
                </c:pt>
                <c:pt idx="78">
                  <c:v>66.588605000000001</c:v>
                </c:pt>
                <c:pt idx="79">
                  <c:v>66.281687500000004</c:v>
                </c:pt>
                <c:pt idx="80">
                  <c:v>66.781697500000007</c:v>
                </c:pt>
                <c:pt idx="81">
                  <c:v>67.415727499999988</c:v>
                </c:pt>
                <c:pt idx="82">
                  <c:v>67.545652499999989</c:v>
                </c:pt>
                <c:pt idx="83">
                  <c:v>67.615264999999994</c:v>
                </c:pt>
                <c:pt idx="84">
                  <c:v>67.076814999999996</c:v>
                </c:pt>
                <c:pt idx="85">
                  <c:v>65.890330000000006</c:v>
                </c:pt>
                <c:pt idx="86">
                  <c:v>64.050069999999991</c:v>
                </c:pt>
                <c:pt idx="87">
                  <c:v>61.570050000000002</c:v>
                </c:pt>
                <c:pt idx="88">
                  <c:v>59.987549999999999</c:v>
                </c:pt>
                <c:pt idx="89">
                  <c:v>58.343017500000002</c:v>
                </c:pt>
                <c:pt idx="90">
                  <c:v>56.226844999999997</c:v>
                </c:pt>
                <c:pt idx="91">
                  <c:v>55.435760000000009</c:v>
                </c:pt>
                <c:pt idx="92">
                  <c:v>54.810207499999997</c:v>
                </c:pt>
                <c:pt idx="93">
                  <c:v>53.876732499999996</c:v>
                </c:pt>
                <c:pt idx="94">
                  <c:v>52.580602499999991</c:v>
                </c:pt>
                <c:pt idx="95">
                  <c:v>51.468572500000001</c:v>
                </c:pt>
                <c:pt idx="96">
                  <c:v>50.519417499999996</c:v>
                </c:pt>
                <c:pt idx="97">
                  <c:v>50.237832500000003</c:v>
                </c:pt>
                <c:pt idx="98">
                  <c:v>49.621810000000004</c:v>
                </c:pt>
                <c:pt idx="99">
                  <c:v>49.059814999999993</c:v>
                </c:pt>
                <c:pt idx="100">
                  <c:v>49.010100000000001</c:v>
                </c:pt>
                <c:pt idx="101">
                  <c:v>48.509070000000001</c:v>
                </c:pt>
                <c:pt idx="102">
                  <c:v>47.850954999999999</c:v>
                </c:pt>
                <c:pt idx="103">
                  <c:v>47.363635000000002</c:v>
                </c:pt>
                <c:pt idx="104">
                  <c:v>47.185787500000004</c:v>
                </c:pt>
                <c:pt idx="105">
                  <c:v>46.866129999999998</c:v>
                </c:pt>
                <c:pt idx="106">
                  <c:v>46.246097500000005</c:v>
                </c:pt>
                <c:pt idx="107">
                  <c:v>44.713864999999998</c:v>
                </c:pt>
                <c:pt idx="108">
                  <c:v>43.003695</c:v>
                </c:pt>
                <c:pt idx="109">
                  <c:v>40.987780000000001</c:v>
                </c:pt>
                <c:pt idx="110">
                  <c:v>39.456807500000004</c:v>
                </c:pt>
                <c:pt idx="111">
                  <c:v>38.706227499999997</c:v>
                </c:pt>
                <c:pt idx="112">
                  <c:v>37.822667500000001</c:v>
                </c:pt>
                <c:pt idx="113">
                  <c:v>37.0871475</c:v>
                </c:pt>
                <c:pt idx="114">
                  <c:v>36.654967499999998</c:v>
                </c:pt>
                <c:pt idx="115">
                  <c:v>36.117042499999997</c:v>
                </c:pt>
                <c:pt idx="116">
                  <c:v>35.4649</c:v>
                </c:pt>
                <c:pt idx="117">
                  <c:v>34.963169999999998</c:v>
                </c:pt>
                <c:pt idx="118">
                  <c:v>35.037864999999996</c:v>
                </c:pt>
                <c:pt idx="119">
                  <c:v>35.246974999999999</c:v>
                </c:pt>
                <c:pt idx="120">
                  <c:v>35.0660375</c:v>
                </c:pt>
                <c:pt idx="121">
                  <c:v>35.189129999999999</c:v>
                </c:pt>
                <c:pt idx="122">
                  <c:v>35.006664999999998</c:v>
                </c:pt>
                <c:pt idx="123">
                  <c:v>34.572024999999996</c:v>
                </c:pt>
                <c:pt idx="124">
                  <c:v>32.268219999999999</c:v>
                </c:pt>
                <c:pt idx="125">
                  <c:v>33.268099999999997</c:v>
                </c:pt>
                <c:pt idx="126">
                  <c:v>32.336485000000003</c:v>
                </c:pt>
                <c:pt idx="127">
                  <c:v>31.362224999999999</c:v>
                </c:pt>
                <c:pt idx="128">
                  <c:v>30.110787500000001</c:v>
                </c:pt>
                <c:pt idx="129">
                  <c:v>29.2055825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E84-4C68-A432-D76F3233C6F2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X$17:$BX$146</c:f>
              <c:numCache>
                <c:formatCode>0.00</c:formatCode>
                <c:ptCount val="130"/>
                <c:pt idx="0">
                  <c:v>150.17515500000002</c:v>
                </c:pt>
                <c:pt idx="1">
                  <c:v>148.32145500000001</c:v>
                </c:pt>
                <c:pt idx="2">
                  <c:v>140.7647225</c:v>
                </c:pt>
                <c:pt idx="3">
                  <c:v>128.29484500000001</c:v>
                </c:pt>
                <c:pt idx="4">
                  <c:v>114.81169750000001</c:v>
                </c:pt>
                <c:pt idx="5">
                  <c:v>102.51911499999999</c:v>
                </c:pt>
                <c:pt idx="6">
                  <c:v>92.531202499999992</c:v>
                </c:pt>
                <c:pt idx="7">
                  <c:v>82.470867500000011</c:v>
                </c:pt>
                <c:pt idx="8">
                  <c:v>72.852857499999999</c:v>
                </c:pt>
                <c:pt idx="9">
                  <c:v>65.116210000000009</c:v>
                </c:pt>
                <c:pt idx="10">
                  <c:v>59.212247500000011</c:v>
                </c:pt>
                <c:pt idx="11">
                  <c:v>55.231724999999997</c:v>
                </c:pt>
                <c:pt idx="12">
                  <c:v>52.721785000000011</c:v>
                </c:pt>
                <c:pt idx="13">
                  <c:v>51.30809</c:v>
                </c:pt>
                <c:pt idx="14">
                  <c:v>51.120629999999998</c:v>
                </c:pt>
                <c:pt idx="15">
                  <c:v>51.452979999999997</c:v>
                </c:pt>
                <c:pt idx="16">
                  <c:v>52.726964999999993</c:v>
                </c:pt>
                <c:pt idx="17">
                  <c:v>54.565582499999998</c:v>
                </c:pt>
                <c:pt idx="18">
                  <c:v>57.386177499999988</c:v>
                </c:pt>
                <c:pt idx="19">
                  <c:v>61.829742500000002</c:v>
                </c:pt>
                <c:pt idx="20">
                  <c:v>68.025497500000014</c:v>
                </c:pt>
                <c:pt idx="21">
                  <c:v>75.600657499999997</c:v>
                </c:pt>
                <c:pt idx="22">
                  <c:v>81.218357499999996</c:v>
                </c:pt>
                <c:pt idx="23">
                  <c:v>84.651517500000011</c:v>
                </c:pt>
                <c:pt idx="24">
                  <c:v>87.147337500000006</c:v>
                </c:pt>
                <c:pt idx="25">
                  <c:v>88.134485000000012</c:v>
                </c:pt>
                <c:pt idx="26">
                  <c:v>90.286710000000014</c:v>
                </c:pt>
                <c:pt idx="27">
                  <c:v>92.951980000000006</c:v>
                </c:pt>
                <c:pt idx="28">
                  <c:v>95.223547500000009</c:v>
                </c:pt>
                <c:pt idx="29">
                  <c:v>97.569355000000002</c:v>
                </c:pt>
                <c:pt idx="30">
                  <c:v>100.5778425</c:v>
                </c:pt>
                <c:pt idx="31">
                  <c:v>102.91150500000001</c:v>
                </c:pt>
                <c:pt idx="32">
                  <c:v>103.2664875</c:v>
                </c:pt>
                <c:pt idx="33">
                  <c:v>105.14548500000001</c:v>
                </c:pt>
                <c:pt idx="34">
                  <c:v>103.04115</c:v>
                </c:pt>
                <c:pt idx="35">
                  <c:v>101.3111</c:v>
                </c:pt>
                <c:pt idx="36">
                  <c:v>98.608957499999988</c:v>
                </c:pt>
                <c:pt idx="37">
                  <c:v>95.081977499999994</c:v>
                </c:pt>
                <c:pt idx="38">
                  <c:v>91.986930000000001</c:v>
                </c:pt>
                <c:pt idx="39">
                  <c:v>88.289644999999993</c:v>
                </c:pt>
                <c:pt idx="40">
                  <c:v>84.942580000000007</c:v>
                </c:pt>
                <c:pt idx="41">
                  <c:v>81.101567500000002</c:v>
                </c:pt>
                <c:pt idx="42">
                  <c:v>77.155322500000011</c:v>
                </c:pt>
                <c:pt idx="43">
                  <c:v>73.434992500000007</c:v>
                </c:pt>
                <c:pt idx="44">
                  <c:v>69.651160000000004</c:v>
                </c:pt>
                <c:pt idx="45">
                  <c:v>65.429694999999995</c:v>
                </c:pt>
                <c:pt idx="46">
                  <c:v>61.669919999999998</c:v>
                </c:pt>
                <c:pt idx="47">
                  <c:v>58.184457499999994</c:v>
                </c:pt>
                <c:pt idx="48">
                  <c:v>55.436372500000012</c:v>
                </c:pt>
                <c:pt idx="49">
                  <c:v>53.397024999999999</c:v>
                </c:pt>
                <c:pt idx="50">
                  <c:v>52.894707499999996</c:v>
                </c:pt>
                <c:pt idx="51">
                  <c:v>51.727487500000002</c:v>
                </c:pt>
                <c:pt idx="52">
                  <c:v>50.562024999999998</c:v>
                </c:pt>
                <c:pt idx="53">
                  <c:v>49.902657500000004</c:v>
                </c:pt>
                <c:pt idx="54">
                  <c:v>49.535127499999994</c:v>
                </c:pt>
                <c:pt idx="55">
                  <c:v>48.877539999999996</c:v>
                </c:pt>
                <c:pt idx="56">
                  <c:v>48.804242500000001</c:v>
                </c:pt>
                <c:pt idx="57">
                  <c:v>48.400882500000002</c:v>
                </c:pt>
                <c:pt idx="58">
                  <c:v>47.922162499999999</c:v>
                </c:pt>
                <c:pt idx="59">
                  <c:v>47.236742499999998</c:v>
                </c:pt>
                <c:pt idx="60">
                  <c:v>46.715512500000003</c:v>
                </c:pt>
                <c:pt idx="61">
                  <c:v>46.415129999999998</c:v>
                </c:pt>
                <c:pt idx="62">
                  <c:v>46.503460000000004</c:v>
                </c:pt>
                <c:pt idx="63">
                  <c:v>46.704789999999996</c:v>
                </c:pt>
                <c:pt idx="64">
                  <c:v>46.866532499999998</c:v>
                </c:pt>
                <c:pt idx="65">
                  <c:v>46.401522500000006</c:v>
                </c:pt>
                <c:pt idx="66">
                  <c:v>45.311942500000001</c:v>
                </c:pt>
                <c:pt idx="67">
                  <c:v>44.045760000000001</c:v>
                </c:pt>
                <c:pt idx="68">
                  <c:v>43.173662499999999</c:v>
                </c:pt>
                <c:pt idx="69">
                  <c:v>42.554739999999995</c:v>
                </c:pt>
                <c:pt idx="70">
                  <c:v>41.597127499999999</c:v>
                </c:pt>
                <c:pt idx="71">
                  <c:v>40.799170000000004</c:v>
                </c:pt>
                <c:pt idx="72">
                  <c:v>40.030639999999998</c:v>
                </c:pt>
                <c:pt idx="73">
                  <c:v>39.301572500000006</c:v>
                </c:pt>
                <c:pt idx="74">
                  <c:v>38.474385000000005</c:v>
                </c:pt>
                <c:pt idx="75">
                  <c:v>37.78369</c:v>
                </c:pt>
                <c:pt idx="76">
                  <c:v>37.319342499999998</c:v>
                </c:pt>
                <c:pt idx="77">
                  <c:v>37.107789999999994</c:v>
                </c:pt>
                <c:pt idx="78">
                  <c:v>37.073304999999998</c:v>
                </c:pt>
                <c:pt idx="79">
                  <c:v>37.158787500000003</c:v>
                </c:pt>
                <c:pt idx="80">
                  <c:v>37.290497500000001</c:v>
                </c:pt>
                <c:pt idx="81">
                  <c:v>37.434927499999993</c:v>
                </c:pt>
                <c:pt idx="82">
                  <c:v>37.552052499999995</c:v>
                </c:pt>
                <c:pt idx="83">
                  <c:v>37.342664999999997</c:v>
                </c:pt>
                <c:pt idx="84">
                  <c:v>37.069614999999999</c:v>
                </c:pt>
                <c:pt idx="85">
                  <c:v>36.434829999999998</c:v>
                </c:pt>
                <c:pt idx="86">
                  <c:v>35.425670000000004</c:v>
                </c:pt>
                <c:pt idx="87">
                  <c:v>34.34205</c:v>
                </c:pt>
                <c:pt idx="88">
                  <c:v>33.202750000000002</c:v>
                </c:pt>
                <c:pt idx="89">
                  <c:v>32.063117499999997</c:v>
                </c:pt>
                <c:pt idx="90">
                  <c:v>30.563745000000001</c:v>
                </c:pt>
                <c:pt idx="91">
                  <c:v>29.593260000000004</c:v>
                </c:pt>
                <c:pt idx="92">
                  <c:v>28.6853075</c:v>
                </c:pt>
                <c:pt idx="93">
                  <c:v>28.062932500000002</c:v>
                </c:pt>
                <c:pt idx="94">
                  <c:v>27.517002499999997</c:v>
                </c:pt>
                <c:pt idx="95">
                  <c:v>27.337472500000004</c:v>
                </c:pt>
                <c:pt idx="96">
                  <c:v>27.533717499999998</c:v>
                </c:pt>
                <c:pt idx="97">
                  <c:v>27.880032500000002</c:v>
                </c:pt>
                <c:pt idx="98">
                  <c:v>28.250810000000005</c:v>
                </c:pt>
                <c:pt idx="99">
                  <c:v>28.464514999999995</c:v>
                </c:pt>
                <c:pt idx="100">
                  <c:v>28.302900000000001</c:v>
                </c:pt>
                <c:pt idx="101">
                  <c:v>27.757070000000002</c:v>
                </c:pt>
                <c:pt idx="102">
                  <c:v>27.246254999999998</c:v>
                </c:pt>
                <c:pt idx="103">
                  <c:v>26.597935000000003</c:v>
                </c:pt>
                <c:pt idx="104">
                  <c:v>26.075787500000001</c:v>
                </c:pt>
                <c:pt idx="105">
                  <c:v>25.86243</c:v>
                </c:pt>
                <c:pt idx="106">
                  <c:v>25.219297500000003</c:v>
                </c:pt>
                <c:pt idx="107">
                  <c:v>24.759564999999995</c:v>
                </c:pt>
                <c:pt idx="108">
                  <c:v>24.366595</c:v>
                </c:pt>
                <c:pt idx="109">
                  <c:v>24.071079999999998</c:v>
                </c:pt>
                <c:pt idx="110">
                  <c:v>24.1320075</c:v>
                </c:pt>
                <c:pt idx="111">
                  <c:v>23.384027499999995</c:v>
                </c:pt>
                <c:pt idx="112">
                  <c:v>22.9514675</c:v>
                </c:pt>
                <c:pt idx="113">
                  <c:v>22.248947500000003</c:v>
                </c:pt>
                <c:pt idx="114">
                  <c:v>21.692667499999999</c:v>
                </c:pt>
                <c:pt idx="115">
                  <c:v>21.255242499999998</c:v>
                </c:pt>
                <c:pt idx="116">
                  <c:v>20.8871</c:v>
                </c:pt>
                <c:pt idx="117">
                  <c:v>20.751170000000002</c:v>
                </c:pt>
                <c:pt idx="118">
                  <c:v>20.514464999999998</c:v>
                </c:pt>
                <c:pt idx="119">
                  <c:v>20.764175000000002</c:v>
                </c:pt>
                <c:pt idx="120">
                  <c:v>20.8983375</c:v>
                </c:pt>
                <c:pt idx="121">
                  <c:v>20.742629999999998</c:v>
                </c:pt>
                <c:pt idx="122">
                  <c:v>20.806464999999996</c:v>
                </c:pt>
                <c:pt idx="123">
                  <c:v>20.829325000000001</c:v>
                </c:pt>
                <c:pt idx="124">
                  <c:v>18.62632</c:v>
                </c:pt>
                <c:pt idx="125">
                  <c:v>20.169</c:v>
                </c:pt>
                <c:pt idx="126">
                  <c:v>19.801285000000004</c:v>
                </c:pt>
                <c:pt idx="127">
                  <c:v>19.387824999999999</c:v>
                </c:pt>
                <c:pt idx="128">
                  <c:v>18.770887500000001</c:v>
                </c:pt>
                <c:pt idx="129">
                  <c:v>18.2990825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E84-4C68-A432-D76F3233C6F2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Y$17:$BY$146</c:f>
              <c:numCache>
                <c:formatCode>0.00</c:formatCode>
                <c:ptCount val="130"/>
                <c:pt idx="0">
                  <c:v>148.18175500000001</c:v>
                </c:pt>
                <c:pt idx="1">
                  <c:v>138.91075499999999</c:v>
                </c:pt>
                <c:pt idx="2">
                  <c:v>131.32682250000002</c:v>
                </c:pt>
                <c:pt idx="3">
                  <c:v>120.632345</c:v>
                </c:pt>
                <c:pt idx="4">
                  <c:v>111.08129750000001</c:v>
                </c:pt>
                <c:pt idx="5">
                  <c:v>99.630614999999992</c:v>
                </c:pt>
                <c:pt idx="6">
                  <c:v>92.189002499999987</c:v>
                </c:pt>
                <c:pt idx="7">
                  <c:v>87.427667499999998</c:v>
                </c:pt>
                <c:pt idx="8">
                  <c:v>82.540357499999999</c:v>
                </c:pt>
                <c:pt idx="9">
                  <c:v>76.520810000000012</c:v>
                </c:pt>
                <c:pt idx="10">
                  <c:v>72.475247500000009</c:v>
                </c:pt>
                <c:pt idx="11">
                  <c:v>68.635024999999999</c:v>
                </c:pt>
                <c:pt idx="12">
                  <c:v>64.355185000000006</c:v>
                </c:pt>
                <c:pt idx="13">
                  <c:v>60.835089999999994</c:v>
                </c:pt>
                <c:pt idx="14">
                  <c:v>58.875730000000004</c:v>
                </c:pt>
                <c:pt idx="15">
                  <c:v>60.377280000000006</c:v>
                </c:pt>
                <c:pt idx="16">
                  <c:v>65.457964999999987</c:v>
                </c:pt>
                <c:pt idx="17">
                  <c:v>73.676682499999998</c:v>
                </c:pt>
                <c:pt idx="18">
                  <c:v>83.317377499999992</c:v>
                </c:pt>
                <c:pt idx="19">
                  <c:v>90.716142500000004</c:v>
                </c:pt>
                <c:pt idx="20">
                  <c:v>94.330697500000014</c:v>
                </c:pt>
                <c:pt idx="21">
                  <c:v>94.559457499999994</c:v>
                </c:pt>
                <c:pt idx="22">
                  <c:v>93.247657499999988</c:v>
                </c:pt>
                <c:pt idx="23">
                  <c:v>96.227117500000006</c:v>
                </c:pt>
                <c:pt idx="24">
                  <c:v>105.00953749999999</c:v>
                </c:pt>
                <c:pt idx="25">
                  <c:v>115.231385</c:v>
                </c:pt>
                <c:pt idx="26">
                  <c:v>120.61331000000001</c:v>
                </c:pt>
                <c:pt idx="27">
                  <c:v>121.20298000000001</c:v>
                </c:pt>
                <c:pt idx="28">
                  <c:v>119.2691475</c:v>
                </c:pt>
                <c:pt idx="29">
                  <c:v>116.71115500000001</c:v>
                </c:pt>
                <c:pt idx="30">
                  <c:v>116.06764250000001</c:v>
                </c:pt>
                <c:pt idx="31">
                  <c:v>115.932005</c:v>
                </c:pt>
                <c:pt idx="32">
                  <c:v>115.61018749999999</c:v>
                </c:pt>
                <c:pt idx="33">
                  <c:v>120.13198500000001</c:v>
                </c:pt>
                <c:pt idx="34">
                  <c:v>121.59305000000001</c:v>
                </c:pt>
                <c:pt idx="35">
                  <c:v>123.3616</c:v>
                </c:pt>
                <c:pt idx="36">
                  <c:v>122.9208575</c:v>
                </c:pt>
                <c:pt idx="37">
                  <c:v>120.56337749999999</c:v>
                </c:pt>
                <c:pt idx="38">
                  <c:v>116.93323000000001</c:v>
                </c:pt>
                <c:pt idx="39">
                  <c:v>112.00544499999999</c:v>
                </c:pt>
                <c:pt idx="40">
                  <c:v>107.04628000000001</c:v>
                </c:pt>
                <c:pt idx="41">
                  <c:v>101.9726675</c:v>
                </c:pt>
                <c:pt idx="42">
                  <c:v>97.887522500000003</c:v>
                </c:pt>
                <c:pt idx="43">
                  <c:v>94.753392500000004</c:v>
                </c:pt>
                <c:pt idx="44">
                  <c:v>91.832760000000007</c:v>
                </c:pt>
                <c:pt idx="45">
                  <c:v>88.913195000000002</c:v>
                </c:pt>
                <c:pt idx="46">
                  <c:v>87.366419999999991</c:v>
                </c:pt>
                <c:pt idx="47">
                  <c:v>84.839157499999999</c:v>
                </c:pt>
                <c:pt idx="48">
                  <c:v>81.570672500000015</c:v>
                </c:pt>
                <c:pt idx="49">
                  <c:v>78.053425000000004</c:v>
                </c:pt>
                <c:pt idx="50">
                  <c:v>73.868407499999989</c:v>
                </c:pt>
                <c:pt idx="51">
                  <c:v>70.811887499999997</c:v>
                </c:pt>
                <c:pt idx="52">
                  <c:v>69.153025</c:v>
                </c:pt>
                <c:pt idx="53">
                  <c:v>69.0870575</c:v>
                </c:pt>
                <c:pt idx="54">
                  <c:v>71.078327499999986</c:v>
                </c:pt>
                <c:pt idx="55">
                  <c:v>72.829639999999998</c:v>
                </c:pt>
                <c:pt idx="56">
                  <c:v>74.929342500000004</c:v>
                </c:pt>
                <c:pt idx="57">
                  <c:v>75.732582499999992</c:v>
                </c:pt>
                <c:pt idx="58">
                  <c:v>75.419162499999999</c:v>
                </c:pt>
                <c:pt idx="59">
                  <c:v>74.537842500000011</c:v>
                </c:pt>
                <c:pt idx="60">
                  <c:v>73.341412500000004</c:v>
                </c:pt>
                <c:pt idx="61">
                  <c:v>72.135730000000009</c:v>
                </c:pt>
                <c:pt idx="62">
                  <c:v>70.927560000000014</c:v>
                </c:pt>
                <c:pt idx="63">
                  <c:v>70.132089999999991</c:v>
                </c:pt>
                <c:pt idx="64">
                  <c:v>69.745132499999997</c:v>
                </c:pt>
                <c:pt idx="65">
                  <c:v>69.692322500000003</c:v>
                </c:pt>
                <c:pt idx="66">
                  <c:v>69.352342500000006</c:v>
                </c:pt>
                <c:pt idx="67">
                  <c:v>68.290560000000013</c:v>
                </c:pt>
                <c:pt idx="68">
                  <c:v>66.752062499999994</c:v>
                </c:pt>
                <c:pt idx="69">
                  <c:v>64.194439999999986</c:v>
                </c:pt>
                <c:pt idx="70">
                  <c:v>61.910827499999989</c:v>
                </c:pt>
                <c:pt idx="71">
                  <c:v>60.065669999999997</c:v>
                </c:pt>
                <c:pt idx="72">
                  <c:v>58.450039999999994</c:v>
                </c:pt>
                <c:pt idx="73">
                  <c:v>57.581572500000007</c:v>
                </c:pt>
                <c:pt idx="74">
                  <c:v>57.133685000000007</c:v>
                </c:pt>
                <c:pt idx="75">
                  <c:v>57.323589999999989</c:v>
                </c:pt>
                <c:pt idx="76">
                  <c:v>57.717642500000004</c:v>
                </c:pt>
                <c:pt idx="77">
                  <c:v>57.994989999999987</c:v>
                </c:pt>
                <c:pt idx="78">
                  <c:v>58.434505000000001</c:v>
                </c:pt>
                <c:pt idx="79">
                  <c:v>58.012387500000003</c:v>
                </c:pt>
                <c:pt idx="80">
                  <c:v>57.317297500000009</c:v>
                </c:pt>
                <c:pt idx="81">
                  <c:v>56.987527499999992</c:v>
                </c:pt>
                <c:pt idx="82">
                  <c:v>56.884052499999989</c:v>
                </c:pt>
                <c:pt idx="83">
                  <c:v>56.913164999999992</c:v>
                </c:pt>
                <c:pt idx="84">
                  <c:v>56.922014999999988</c:v>
                </c:pt>
                <c:pt idx="85">
                  <c:v>56.037130000000005</c:v>
                </c:pt>
                <c:pt idx="86">
                  <c:v>54.707169999999998</c:v>
                </c:pt>
                <c:pt idx="87">
                  <c:v>52.841450000000002</c:v>
                </c:pt>
                <c:pt idx="88">
                  <c:v>50.881549999999997</c:v>
                </c:pt>
                <c:pt idx="89">
                  <c:v>49.181217499999995</c:v>
                </c:pt>
                <c:pt idx="90">
                  <c:v>47.739944999999999</c:v>
                </c:pt>
                <c:pt idx="91">
                  <c:v>47.055260000000004</c:v>
                </c:pt>
                <c:pt idx="92">
                  <c:v>46.143507499999998</c:v>
                </c:pt>
                <c:pt idx="93">
                  <c:v>45.849832499999998</c:v>
                </c:pt>
                <c:pt idx="94">
                  <c:v>45.418502499999995</c:v>
                </c:pt>
                <c:pt idx="95">
                  <c:v>44.5815725</c:v>
                </c:pt>
                <c:pt idx="96">
                  <c:v>43.676617499999999</c:v>
                </c:pt>
                <c:pt idx="97">
                  <c:v>42.918732500000004</c:v>
                </c:pt>
                <c:pt idx="98">
                  <c:v>42.540010000000002</c:v>
                </c:pt>
                <c:pt idx="99">
                  <c:v>42.625214999999997</c:v>
                </c:pt>
                <c:pt idx="100">
                  <c:v>43.354199999999999</c:v>
                </c:pt>
                <c:pt idx="101">
                  <c:v>44.030670000000001</c:v>
                </c:pt>
                <c:pt idx="102">
                  <c:v>45.229754999999997</c:v>
                </c:pt>
                <c:pt idx="103">
                  <c:v>46.168435000000002</c:v>
                </c:pt>
                <c:pt idx="104">
                  <c:v>46.2466875</c:v>
                </c:pt>
                <c:pt idx="105">
                  <c:v>45.161630000000002</c:v>
                </c:pt>
                <c:pt idx="106">
                  <c:v>44.138097500000001</c:v>
                </c:pt>
                <c:pt idx="107">
                  <c:v>42.528264999999998</c:v>
                </c:pt>
                <c:pt idx="108">
                  <c:v>41.109895000000002</c:v>
                </c:pt>
                <c:pt idx="109">
                  <c:v>39.888379999999998</c:v>
                </c:pt>
                <c:pt idx="110">
                  <c:v>38.811107499999999</c:v>
                </c:pt>
                <c:pt idx="111">
                  <c:v>38.226527499999996</c:v>
                </c:pt>
                <c:pt idx="112">
                  <c:v>37.932467500000001</c:v>
                </c:pt>
                <c:pt idx="113">
                  <c:v>37.524247500000001</c:v>
                </c:pt>
                <c:pt idx="114">
                  <c:v>37.159167500000002</c:v>
                </c:pt>
                <c:pt idx="115">
                  <c:v>36.287842499999996</c:v>
                </c:pt>
                <c:pt idx="116">
                  <c:v>35.616700000000002</c:v>
                </c:pt>
                <c:pt idx="117">
                  <c:v>35.097970000000004</c:v>
                </c:pt>
                <c:pt idx="118">
                  <c:v>34.690764999999999</c:v>
                </c:pt>
                <c:pt idx="119">
                  <c:v>34.991374999999998</c:v>
                </c:pt>
                <c:pt idx="120">
                  <c:v>34.800537499999997</c:v>
                </c:pt>
                <c:pt idx="121">
                  <c:v>34.909729999999996</c:v>
                </c:pt>
                <c:pt idx="122">
                  <c:v>34.903664999999997</c:v>
                </c:pt>
                <c:pt idx="123">
                  <c:v>34.651924999999999</c:v>
                </c:pt>
                <c:pt idx="124">
                  <c:v>32.152819999999998</c:v>
                </c:pt>
                <c:pt idx="125">
                  <c:v>33.297800000000002</c:v>
                </c:pt>
                <c:pt idx="126">
                  <c:v>32.567285000000005</c:v>
                </c:pt>
                <c:pt idx="127">
                  <c:v>31.545324999999998</c:v>
                </c:pt>
                <c:pt idx="128">
                  <c:v>30.5470875</c:v>
                </c:pt>
                <c:pt idx="129">
                  <c:v>29.6945825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E84-4C68-A432-D76F3233C6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7432320"/>
        <c:axId val="37848576"/>
      </c:lineChart>
      <c:catAx>
        <c:axId val="37432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784857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784857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7432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814711881993054"/>
          <c:y val="0.12381700254724456"/>
          <c:w val="0.70060152599424208"/>
          <c:h val="0.62560379622752549"/>
        </c:manualLayout>
      </c:layout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T$17:$BT$146</c:f>
              <c:numCache>
                <c:formatCode>0.00</c:formatCode>
                <c:ptCount val="130"/>
                <c:pt idx="0">
                  <c:v>181.243155</c:v>
                </c:pt>
                <c:pt idx="1">
                  <c:v>180.684055</c:v>
                </c:pt>
                <c:pt idx="2">
                  <c:v>184.74792250000002</c:v>
                </c:pt>
                <c:pt idx="3">
                  <c:v>183.19914499999999</c:v>
                </c:pt>
                <c:pt idx="4">
                  <c:v>181.94089750000001</c:v>
                </c:pt>
                <c:pt idx="5">
                  <c:v>181.95521499999998</c:v>
                </c:pt>
                <c:pt idx="6">
                  <c:v>179.6457025</c:v>
                </c:pt>
                <c:pt idx="7">
                  <c:v>172.8432675</c:v>
                </c:pt>
                <c:pt idx="8">
                  <c:v>164.07245749999998</c:v>
                </c:pt>
                <c:pt idx="9">
                  <c:v>159.87231</c:v>
                </c:pt>
                <c:pt idx="10">
                  <c:v>162.64374750000002</c:v>
                </c:pt>
                <c:pt idx="11">
                  <c:v>172.24192500000001</c:v>
                </c:pt>
                <c:pt idx="12">
                  <c:v>187.02598500000002</c:v>
                </c:pt>
                <c:pt idx="13">
                  <c:v>204.26788999999999</c:v>
                </c:pt>
                <c:pt idx="14">
                  <c:v>222.79382999999999</c:v>
                </c:pt>
                <c:pt idx="15">
                  <c:v>233.51587999999998</c:v>
                </c:pt>
                <c:pt idx="16">
                  <c:v>244.393665</c:v>
                </c:pt>
                <c:pt idx="17">
                  <c:v>271.56798250000003</c:v>
                </c:pt>
                <c:pt idx="18">
                  <c:v>313.81847749999997</c:v>
                </c:pt>
                <c:pt idx="19">
                  <c:v>347.7944425</c:v>
                </c:pt>
                <c:pt idx="20">
                  <c:v>358.5314975</c:v>
                </c:pt>
                <c:pt idx="21">
                  <c:v>350.97675750000002</c:v>
                </c:pt>
                <c:pt idx="22">
                  <c:v>336.05055750000002</c:v>
                </c:pt>
                <c:pt idx="23">
                  <c:v>318.44761749999998</c:v>
                </c:pt>
                <c:pt idx="24">
                  <c:v>306.99043749999998</c:v>
                </c:pt>
                <c:pt idx="25">
                  <c:v>294.06478500000003</c:v>
                </c:pt>
                <c:pt idx="26">
                  <c:v>274.26600999999999</c:v>
                </c:pt>
                <c:pt idx="27">
                  <c:v>250.50688</c:v>
                </c:pt>
                <c:pt idx="28">
                  <c:v>226.04854750000001</c:v>
                </c:pt>
                <c:pt idx="29">
                  <c:v>204.28705500000001</c:v>
                </c:pt>
                <c:pt idx="30">
                  <c:v>184.97614250000001</c:v>
                </c:pt>
                <c:pt idx="31">
                  <c:v>166.81600500000002</c:v>
                </c:pt>
                <c:pt idx="32">
                  <c:v>149.52168750000001</c:v>
                </c:pt>
                <c:pt idx="33">
                  <c:v>135.928585</c:v>
                </c:pt>
                <c:pt idx="34">
                  <c:v>122.29535</c:v>
                </c:pt>
                <c:pt idx="35">
                  <c:v>112.0442</c:v>
                </c:pt>
                <c:pt idx="36">
                  <c:v>104.99095749999999</c:v>
                </c:pt>
                <c:pt idx="37">
                  <c:v>100.09927749999999</c:v>
                </c:pt>
                <c:pt idx="38">
                  <c:v>97.525330000000011</c:v>
                </c:pt>
                <c:pt idx="39">
                  <c:v>100.472545</c:v>
                </c:pt>
                <c:pt idx="40">
                  <c:v>107.97288</c:v>
                </c:pt>
                <c:pt idx="41">
                  <c:v>123.2949675</c:v>
                </c:pt>
                <c:pt idx="42">
                  <c:v>143.7962225</c:v>
                </c:pt>
                <c:pt idx="43">
                  <c:v>163.25229250000001</c:v>
                </c:pt>
                <c:pt idx="44">
                  <c:v>184.89546000000001</c:v>
                </c:pt>
                <c:pt idx="45">
                  <c:v>197.36109500000001</c:v>
                </c:pt>
                <c:pt idx="46">
                  <c:v>203.08501999999999</c:v>
                </c:pt>
                <c:pt idx="47">
                  <c:v>203.20005749999999</c:v>
                </c:pt>
                <c:pt idx="48">
                  <c:v>200.22587250000001</c:v>
                </c:pt>
                <c:pt idx="49">
                  <c:v>192.74222499999999</c:v>
                </c:pt>
                <c:pt idx="50">
                  <c:v>182.6460075</c:v>
                </c:pt>
                <c:pt idx="51">
                  <c:v>172.44998749999999</c:v>
                </c:pt>
                <c:pt idx="52">
                  <c:v>161.54672500000001</c:v>
                </c:pt>
                <c:pt idx="53">
                  <c:v>152.33465749999999</c:v>
                </c:pt>
                <c:pt idx="54">
                  <c:v>144.7847275</c:v>
                </c:pt>
                <c:pt idx="55">
                  <c:v>136.29783999999998</c:v>
                </c:pt>
                <c:pt idx="56">
                  <c:v>128.60364250000001</c:v>
                </c:pt>
                <c:pt idx="57">
                  <c:v>121.8448825</c:v>
                </c:pt>
                <c:pt idx="58">
                  <c:v>114.26276249999999</c:v>
                </c:pt>
                <c:pt idx="59">
                  <c:v>106.7229425</c:v>
                </c:pt>
                <c:pt idx="60">
                  <c:v>99.505812500000005</c:v>
                </c:pt>
                <c:pt idx="61">
                  <c:v>92.303530000000009</c:v>
                </c:pt>
                <c:pt idx="62">
                  <c:v>85.794960000000003</c:v>
                </c:pt>
                <c:pt idx="63">
                  <c:v>80.941289999999995</c:v>
                </c:pt>
                <c:pt idx="64">
                  <c:v>78.310532499999994</c:v>
                </c:pt>
                <c:pt idx="65">
                  <c:v>78.65572250000001</c:v>
                </c:pt>
                <c:pt idx="66">
                  <c:v>81.544842500000001</c:v>
                </c:pt>
                <c:pt idx="67">
                  <c:v>85.666660000000007</c:v>
                </c:pt>
                <c:pt idx="68">
                  <c:v>91.293362500000001</c:v>
                </c:pt>
                <c:pt idx="69">
                  <c:v>97.798839999999984</c:v>
                </c:pt>
                <c:pt idx="70">
                  <c:v>102.97612749999999</c:v>
                </c:pt>
                <c:pt idx="71">
                  <c:v>106.50287</c:v>
                </c:pt>
                <c:pt idx="72">
                  <c:v>108.86633999999999</c:v>
                </c:pt>
                <c:pt idx="73">
                  <c:v>110.42827250000001</c:v>
                </c:pt>
                <c:pt idx="74">
                  <c:v>112.60658500000001</c:v>
                </c:pt>
                <c:pt idx="75">
                  <c:v>114.35328999999999</c:v>
                </c:pt>
                <c:pt idx="76">
                  <c:v>114.23974250000001</c:v>
                </c:pt>
                <c:pt idx="77">
                  <c:v>113.99418999999999</c:v>
                </c:pt>
                <c:pt idx="78">
                  <c:v>111.806405</c:v>
                </c:pt>
                <c:pt idx="79">
                  <c:v>107.6846875</c:v>
                </c:pt>
                <c:pt idx="80">
                  <c:v>103.0328975</c:v>
                </c:pt>
                <c:pt idx="81">
                  <c:v>96.965127499999994</c:v>
                </c:pt>
                <c:pt idx="82">
                  <c:v>90.278852499999985</c:v>
                </c:pt>
                <c:pt idx="83">
                  <c:v>83.65366499999999</c:v>
                </c:pt>
                <c:pt idx="84">
                  <c:v>76.295614999999984</c:v>
                </c:pt>
                <c:pt idx="85">
                  <c:v>69.396929999999998</c:v>
                </c:pt>
                <c:pt idx="86">
                  <c:v>63.123869999999997</c:v>
                </c:pt>
                <c:pt idx="87">
                  <c:v>58.366950000000003</c:v>
                </c:pt>
                <c:pt idx="88">
                  <c:v>55.299149999999997</c:v>
                </c:pt>
                <c:pt idx="89">
                  <c:v>52.977217500000002</c:v>
                </c:pt>
                <c:pt idx="90">
                  <c:v>51.753145000000004</c:v>
                </c:pt>
                <c:pt idx="91">
                  <c:v>51.767860000000006</c:v>
                </c:pt>
                <c:pt idx="92">
                  <c:v>52.496907499999992</c:v>
                </c:pt>
                <c:pt idx="93">
                  <c:v>53.827232499999994</c:v>
                </c:pt>
                <c:pt idx="94">
                  <c:v>54.686502499999989</c:v>
                </c:pt>
                <c:pt idx="95">
                  <c:v>55.407372500000008</c:v>
                </c:pt>
                <c:pt idx="96">
                  <c:v>55.984717500000002</c:v>
                </c:pt>
                <c:pt idx="97">
                  <c:v>56.813732499999993</c:v>
                </c:pt>
                <c:pt idx="98">
                  <c:v>57.797210000000007</c:v>
                </c:pt>
                <c:pt idx="99">
                  <c:v>59.175014999999988</c:v>
                </c:pt>
                <c:pt idx="100">
                  <c:v>61.158099999999997</c:v>
                </c:pt>
                <c:pt idx="101">
                  <c:v>63.487069999999996</c:v>
                </c:pt>
                <c:pt idx="102">
                  <c:v>64.603455000000011</c:v>
                </c:pt>
                <c:pt idx="103">
                  <c:v>65.47303500000001</c:v>
                </c:pt>
                <c:pt idx="104">
                  <c:v>66.056687499999995</c:v>
                </c:pt>
                <c:pt idx="105">
                  <c:v>64.254930000000002</c:v>
                </c:pt>
                <c:pt idx="106">
                  <c:v>61.612397500000007</c:v>
                </c:pt>
                <c:pt idx="107">
                  <c:v>58.236964999999991</c:v>
                </c:pt>
                <c:pt idx="108">
                  <c:v>54.968594999999993</c:v>
                </c:pt>
                <c:pt idx="109">
                  <c:v>51.675280000000001</c:v>
                </c:pt>
                <c:pt idx="110">
                  <c:v>48.605807500000004</c:v>
                </c:pt>
                <c:pt idx="111">
                  <c:v>45.656427499999999</c:v>
                </c:pt>
                <c:pt idx="112">
                  <c:v>43.017967499999997</c:v>
                </c:pt>
                <c:pt idx="113">
                  <c:v>40.901247500000004</c:v>
                </c:pt>
                <c:pt idx="114">
                  <c:v>39.558767500000002</c:v>
                </c:pt>
                <c:pt idx="115">
                  <c:v>38.360442499999998</c:v>
                </c:pt>
                <c:pt idx="116">
                  <c:v>37.679400000000001</c:v>
                </c:pt>
                <c:pt idx="117">
                  <c:v>37.289569999999998</c:v>
                </c:pt>
                <c:pt idx="118">
                  <c:v>37.381065</c:v>
                </c:pt>
                <c:pt idx="119">
                  <c:v>37.535375000000002</c:v>
                </c:pt>
                <c:pt idx="120">
                  <c:v>37.095837500000002</c:v>
                </c:pt>
                <c:pt idx="121">
                  <c:v>36.837229999999998</c:v>
                </c:pt>
                <c:pt idx="122">
                  <c:v>36.806764999999999</c:v>
                </c:pt>
                <c:pt idx="123">
                  <c:v>37.005724999999998</c:v>
                </c:pt>
                <c:pt idx="124">
                  <c:v>35.149819999999998</c:v>
                </c:pt>
                <c:pt idx="125">
                  <c:v>37.614100000000001</c:v>
                </c:pt>
                <c:pt idx="126">
                  <c:v>38.501085000000003</c:v>
                </c:pt>
                <c:pt idx="127">
                  <c:v>39.174824999999998</c:v>
                </c:pt>
                <c:pt idx="128">
                  <c:v>38.726587500000001</c:v>
                </c:pt>
                <c:pt idx="129">
                  <c:v>41.04658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F75-4F78-A171-ECF872408D2D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U$17:$BU$146</c:f>
              <c:numCache>
                <c:formatCode>0.00</c:formatCode>
                <c:ptCount val="130"/>
                <c:pt idx="0">
                  <c:v>166.403255</c:v>
                </c:pt>
                <c:pt idx="1">
                  <c:v>142.40355500000001</c:v>
                </c:pt>
                <c:pt idx="2">
                  <c:v>128.32682250000002</c:v>
                </c:pt>
                <c:pt idx="3">
                  <c:v>119.18304499999999</c:v>
                </c:pt>
                <c:pt idx="4">
                  <c:v>115.06829750000001</c:v>
                </c:pt>
                <c:pt idx="5">
                  <c:v>109.395315</c:v>
                </c:pt>
                <c:pt idx="6">
                  <c:v>102.49930249999998</c:v>
                </c:pt>
                <c:pt idx="7">
                  <c:v>98.364167500000008</c:v>
                </c:pt>
                <c:pt idx="8">
                  <c:v>93.112757500000001</c:v>
                </c:pt>
                <c:pt idx="9">
                  <c:v>94.102410000000006</c:v>
                </c:pt>
                <c:pt idx="10">
                  <c:v>97.724647500000003</c:v>
                </c:pt>
                <c:pt idx="11">
                  <c:v>106.694425</c:v>
                </c:pt>
                <c:pt idx="12">
                  <c:v>120.96788500000001</c:v>
                </c:pt>
                <c:pt idx="13">
                  <c:v>137.88609</c:v>
                </c:pt>
                <c:pt idx="14">
                  <c:v>175.70723000000001</c:v>
                </c:pt>
                <c:pt idx="15">
                  <c:v>213.85657999999998</c:v>
                </c:pt>
                <c:pt idx="16">
                  <c:v>261.90866499999998</c:v>
                </c:pt>
                <c:pt idx="17">
                  <c:v>315.74058250000002</c:v>
                </c:pt>
                <c:pt idx="18">
                  <c:v>354.69887749999998</c:v>
                </c:pt>
                <c:pt idx="19">
                  <c:v>379.4699425</c:v>
                </c:pt>
                <c:pt idx="20">
                  <c:v>386.35319750000002</c:v>
                </c:pt>
                <c:pt idx="21">
                  <c:v>377.76205750000003</c:v>
                </c:pt>
                <c:pt idx="22">
                  <c:v>360.86295749999999</c:v>
                </c:pt>
                <c:pt idx="23">
                  <c:v>338.04031749999996</c:v>
                </c:pt>
                <c:pt idx="24">
                  <c:v>316.13703750000002</c:v>
                </c:pt>
                <c:pt idx="25">
                  <c:v>292.91508500000003</c:v>
                </c:pt>
                <c:pt idx="26">
                  <c:v>270.63321000000002</c:v>
                </c:pt>
                <c:pt idx="27">
                  <c:v>250.44367999999997</c:v>
                </c:pt>
                <c:pt idx="28">
                  <c:v>229.7647475</c:v>
                </c:pt>
                <c:pt idx="29">
                  <c:v>206.59905499999999</c:v>
                </c:pt>
                <c:pt idx="30">
                  <c:v>182.59974249999999</c:v>
                </c:pt>
                <c:pt idx="31">
                  <c:v>158.203205</c:v>
                </c:pt>
                <c:pt idx="32">
                  <c:v>134.1565875</c:v>
                </c:pt>
                <c:pt idx="33">
                  <c:v>119.844885</c:v>
                </c:pt>
                <c:pt idx="34">
                  <c:v>109.21795</c:v>
                </c:pt>
                <c:pt idx="35">
                  <c:v>101.32250000000001</c:v>
                </c:pt>
                <c:pt idx="36">
                  <c:v>96.7715575</c:v>
                </c:pt>
                <c:pt idx="37">
                  <c:v>94.746777499999993</c:v>
                </c:pt>
                <c:pt idx="38">
                  <c:v>97.142229999999998</c:v>
                </c:pt>
                <c:pt idx="39">
                  <c:v>105.10554499999999</c:v>
                </c:pt>
                <c:pt idx="40">
                  <c:v>116.22838</c:v>
                </c:pt>
                <c:pt idx="41">
                  <c:v>132.55076750000001</c:v>
                </c:pt>
                <c:pt idx="42">
                  <c:v>150.05182250000001</c:v>
                </c:pt>
                <c:pt idx="43">
                  <c:v>170.55289250000001</c:v>
                </c:pt>
                <c:pt idx="44">
                  <c:v>190.29926</c:v>
                </c:pt>
                <c:pt idx="45">
                  <c:v>201.573395</c:v>
                </c:pt>
                <c:pt idx="46">
                  <c:v>206.84822</c:v>
                </c:pt>
                <c:pt idx="47">
                  <c:v>206.44325749999999</c:v>
                </c:pt>
                <c:pt idx="48">
                  <c:v>201.8213725</c:v>
                </c:pt>
                <c:pt idx="49">
                  <c:v>192.86392499999999</c:v>
                </c:pt>
                <c:pt idx="50">
                  <c:v>182.64030750000001</c:v>
                </c:pt>
                <c:pt idx="51">
                  <c:v>171.97438750000001</c:v>
                </c:pt>
                <c:pt idx="52">
                  <c:v>160.073925</c:v>
                </c:pt>
                <c:pt idx="53">
                  <c:v>148.9281575</c:v>
                </c:pt>
                <c:pt idx="54">
                  <c:v>138.35692749999998</c:v>
                </c:pt>
                <c:pt idx="55">
                  <c:v>128.72134</c:v>
                </c:pt>
                <c:pt idx="56">
                  <c:v>119.3684425</c:v>
                </c:pt>
                <c:pt idx="57">
                  <c:v>110.0457825</c:v>
                </c:pt>
                <c:pt idx="58">
                  <c:v>101.05046249999999</c:v>
                </c:pt>
                <c:pt idx="59">
                  <c:v>92.89314250000001</c:v>
                </c:pt>
                <c:pt idx="60">
                  <c:v>85.324712500000004</c:v>
                </c:pt>
                <c:pt idx="61">
                  <c:v>79.687930000000009</c:v>
                </c:pt>
                <c:pt idx="62">
                  <c:v>75.669660000000007</c:v>
                </c:pt>
                <c:pt idx="63">
                  <c:v>73.893089999999987</c:v>
                </c:pt>
                <c:pt idx="64">
                  <c:v>74.201832499999995</c:v>
                </c:pt>
                <c:pt idx="65">
                  <c:v>75.376022500000005</c:v>
                </c:pt>
                <c:pt idx="66">
                  <c:v>78.648842500000001</c:v>
                </c:pt>
                <c:pt idx="67">
                  <c:v>82.916260000000008</c:v>
                </c:pt>
                <c:pt idx="68">
                  <c:v>88.705462499999996</c:v>
                </c:pt>
                <c:pt idx="69">
                  <c:v>95.252839999999992</c:v>
                </c:pt>
                <c:pt idx="70">
                  <c:v>102.0272275</c:v>
                </c:pt>
                <c:pt idx="71">
                  <c:v>108.81856999999999</c:v>
                </c:pt>
                <c:pt idx="72">
                  <c:v>114.95383999999999</c:v>
                </c:pt>
                <c:pt idx="73">
                  <c:v>119.16687250000001</c:v>
                </c:pt>
                <c:pt idx="74">
                  <c:v>121.44378500000001</c:v>
                </c:pt>
                <c:pt idx="75">
                  <c:v>122.44228999999999</c:v>
                </c:pt>
                <c:pt idx="76">
                  <c:v>121.6061425</c:v>
                </c:pt>
                <c:pt idx="77">
                  <c:v>118.23728999999999</c:v>
                </c:pt>
                <c:pt idx="78">
                  <c:v>114.00070500000001</c:v>
                </c:pt>
                <c:pt idx="79">
                  <c:v>108.7431875</c:v>
                </c:pt>
                <c:pt idx="80">
                  <c:v>102.10449750000001</c:v>
                </c:pt>
                <c:pt idx="81">
                  <c:v>95.051427499999988</c:v>
                </c:pt>
                <c:pt idx="82">
                  <c:v>86.855252499999992</c:v>
                </c:pt>
                <c:pt idx="83">
                  <c:v>78.858364999999992</c:v>
                </c:pt>
                <c:pt idx="84">
                  <c:v>70.873614999999987</c:v>
                </c:pt>
                <c:pt idx="85">
                  <c:v>64.203130000000002</c:v>
                </c:pt>
                <c:pt idx="86">
                  <c:v>58.804069999999996</c:v>
                </c:pt>
                <c:pt idx="87">
                  <c:v>55.13335</c:v>
                </c:pt>
                <c:pt idx="88">
                  <c:v>53.077150000000003</c:v>
                </c:pt>
                <c:pt idx="89">
                  <c:v>51.7584175</c:v>
                </c:pt>
                <c:pt idx="90">
                  <c:v>52.312845000000003</c:v>
                </c:pt>
                <c:pt idx="91">
                  <c:v>53.813060000000007</c:v>
                </c:pt>
                <c:pt idx="92">
                  <c:v>56.084707499999993</c:v>
                </c:pt>
                <c:pt idx="93">
                  <c:v>58.845932499999996</c:v>
                </c:pt>
                <c:pt idx="94">
                  <c:v>60.85070249999999</c:v>
                </c:pt>
                <c:pt idx="95">
                  <c:v>62.281472500000007</c:v>
                </c:pt>
                <c:pt idx="96">
                  <c:v>63.952217500000003</c:v>
                </c:pt>
                <c:pt idx="97">
                  <c:v>65.040132499999999</c:v>
                </c:pt>
                <c:pt idx="98">
                  <c:v>66.48481000000001</c:v>
                </c:pt>
                <c:pt idx="99">
                  <c:v>68.285814999999985</c:v>
                </c:pt>
                <c:pt idx="100">
                  <c:v>71.124300000000005</c:v>
                </c:pt>
                <c:pt idx="101">
                  <c:v>73.235770000000002</c:v>
                </c:pt>
                <c:pt idx="102">
                  <c:v>74.835855000000009</c:v>
                </c:pt>
                <c:pt idx="103">
                  <c:v>75.032135000000011</c:v>
                </c:pt>
                <c:pt idx="104">
                  <c:v>73.298487499999993</c:v>
                </c:pt>
                <c:pt idx="105">
                  <c:v>69.90243000000001</c:v>
                </c:pt>
                <c:pt idx="106">
                  <c:v>65.759697500000016</c:v>
                </c:pt>
                <c:pt idx="107">
                  <c:v>60.702964999999992</c:v>
                </c:pt>
                <c:pt idx="108">
                  <c:v>55.708694999999999</c:v>
                </c:pt>
                <c:pt idx="109">
                  <c:v>51.300179999999997</c:v>
                </c:pt>
                <c:pt idx="110">
                  <c:v>47.022107500000004</c:v>
                </c:pt>
                <c:pt idx="111">
                  <c:v>43.9261275</c:v>
                </c:pt>
                <c:pt idx="112">
                  <c:v>41.787767500000001</c:v>
                </c:pt>
                <c:pt idx="113">
                  <c:v>40.634247500000001</c:v>
                </c:pt>
                <c:pt idx="114">
                  <c:v>40.268167499999997</c:v>
                </c:pt>
                <c:pt idx="115">
                  <c:v>40.2344425</c:v>
                </c:pt>
                <c:pt idx="116">
                  <c:v>39.752699999999997</c:v>
                </c:pt>
                <c:pt idx="117">
                  <c:v>39.161570000000005</c:v>
                </c:pt>
                <c:pt idx="118">
                  <c:v>38.656664999999997</c:v>
                </c:pt>
                <c:pt idx="119">
                  <c:v>38.305574999999997</c:v>
                </c:pt>
                <c:pt idx="120">
                  <c:v>38.205337499999999</c:v>
                </c:pt>
                <c:pt idx="121">
                  <c:v>38.521729999999998</c:v>
                </c:pt>
                <c:pt idx="122">
                  <c:v>39.816064999999995</c:v>
                </c:pt>
                <c:pt idx="123">
                  <c:v>41.682025000000003</c:v>
                </c:pt>
                <c:pt idx="124">
                  <c:v>41.973820000000003</c:v>
                </c:pt>
                <c:pt idx="125">
                  <c:v>45.979399999999998</c:v>
                </c:pt>
                <c:pt idx="126">
                  <c:v>47.480185000000006</c:v>
                </c:pt>
                <c:pt idx="127">
                  <c:v>48.145724999999999</c:v>
                </c:pt>
                <c:pt idx="128">
                  <c:v>47.904087500000003</c:v>
                </c:pt>
                <c:pt idx="129">
                  <c:v>47.4115825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F75-4F78-A171-ECF872408D2D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V$17:$BV$146</c:f>
              <c:numCache>
                <c:formatCode>0.00</c:formatCode>
                <c:ptCount val="130"/>
                <c:pt idx="0">
                  <c:v>165.958055</c:v>
                </c:pt>
                <c:pt idx="1">
                  <c:v>148.411855</c:v>
                </c:pt>
                <c:pt idx="2">
                  <c:v>138.0934225</c:v>
                </c:pt>
                <c:pt idx="3">
                  <c:v>133.85174499999999</c:v>
                </c:pt>
                <c:pt idx="4">
                  <c:v>134.5212975</c:v>
                </c:pt>
                <c:pt idx="5">
                  <c:v>133.89091499999998</c:v>
                </c:pt>
                <c:pt idx="6">
                  <c:v>133.1217025</c:v>
                </c:pt>
                <c:pt idx="7">
                  <c:v>129.54006749999999</c:v>
                </c:pt>
                <c:pt idx="8">
                  <c:v>125.9325575</c:v>
                </c:pt>
                <c:pt idx="9">
                  <c:v>121.31661000000001</c:v>
                </c:pt>
                <c:pt idx="10">
                  <c:v>117.13054750000001</c:v>
                </c:pt>
                <c:pt idx="11">
                  <c:v>116.320025</c:v>
                </c:pt>
                <c:pt idx="12">
                  <c:v>122.98458500000001</c:v>
                </c:pt>
                <c:pt idx="13">
                  <c:v>131.47228999999999</c:v>
                </c:pt>
                <c:pt idx="14">
                  <c:v>152.95152999999999</c:v>
                </c:pt>
                <c:pt idx="15">
                  <c:v>189.39498</c:v>
                </c:pt>
                <c:pt idx="16">
                  <c:v>245.135865</c:v>
                </c:pt>
                <c:pt idx="17">
                  <c:v>299.08908250000002</c:v>
                </c:pt>
                <c:pt idx="18">
                  <c:v>341.36717749999997</c:v>
                </c:pt>
                <c:pt idx="19">
                  <c:v>379.4210425</c:v>
                </c:pt>
                <c:pt idx="20">
                  <c:v>401.22809749999999</c:v>
                </c:pt>
                <c:pt idx="21">
                  <c:v>400.87185750000003</c:v>
                </c:pt>
                <c:pt idx="22">
                  <c:v>392.38975750000003</c:v>
                </c:pt>
                <c:pt idx="23">
                  <c:v>376.38151749999997</c:v>
                </c:pt>
                <c:pt idx="24">
                  <c:v>348.04623750000002</c:v>
                </c:pt>
                <c:pt idx="25">
                  <c:v>315.28038500000002</c:v>
                </c:pt>
                <c:pt idx="26">
                  <c:v>285.96841000000001</c:v>
                </c:pt>
                <c:pt idx="27">
                  <c:v>255.84687999999997</c:v>
                </c:pt>
                <c:pt idx="28">
                  <c:v>225.18154750000002</c:v>
                </c:pt>
                <c:pt idx="29">
                  <c:v>199.040155</c:v>
                </c:pt>
                <c:pt idx="30">
                  <c:v>175.76804250000001</c:v>
                </c:pt>
                <c:pt idx="31">
                  <c:v>155.413105</c:v>
                </c:pt>
                <c:pt idx="32">
                  <c:v>134.20938749999999</c:v>
                </c:pt>
                <c:pt idx="33">
                  <c:v>119.60908500000001</c:v>
                </c:pt>
                <c:pt idx="34">
                  <c:v>107.31715</c:v>
                </c:pt>
                <c:pt idx="35">
                  <c:v>97.919300000000007</c:v>
                </c:pt>
                <c:pt idx="36">
                  <c:v>92.728057499999991</c:v>
                </c:pt>
                <c:pt idx="37">
                  <c:v>90.953777499999987</c:v>
                </c:pt>
                <c:pt idx="38">
                  <c:v>94.830930000000009</c:v>
                </c:pt>
                <c:pt idx="39">
                  <c:v>104.37514499999999</c:v>
                </c:pt>
                <c:pt idx="40">
                  <c:v>116.63098000000001</c:v>
                </c:pt>
                <c:pt idx="41">
                  <c:v>131.87816750000002</c:v>
                </c:pt>
                <c:pt idx="42">
                  <c:v>148.34202250000001</c:v>
                </c:pt>
                <c:pt idx="43">
                  <c:v>164.70269250000001</c:v>
                </c:pt>
                <c:pt idx="44">
                  <c:v>177.86996000000002</c:v>
                </c:pt>
                <c:pt idx="45">
                  <c:v>186.78589499999998</c:v>
                </c:pt>
                <c:pt idx="46">
                  <c:v>190.90392</c:v>
                </c:pt>
                <c:pt idx="47">
                  <c:v>190.6757575</c:v>
                </c:pt>
                <c:pt idx="48">
                  <c:v>186.4961725</c:v>
                </c:pt>
                <c:pt idx="49">
                  <c:v>180.30112500000001</c:v>
                </c:pt>
                <c:pt idx="50">
                  <c:v>172.0632075</c:v>
                </c:pt>
                <c:pt idx="51">
                  <c:v>162.70258749999999</c:v>
                </c:pt>
                <c:pt idx="52">
                  <c:v>154.959925</c:v>
                </c:pt>
                <c:pt idx="53">
                  <c:v>146.6851575</c:v>
                </c:pt>
                <c:pt idx="54">
                  <c:v>137.20522749999998</c:v>
                </c:pt>
                <c:pt idx="55">
                  <c:v>125.43463999999999</c:v>
                </c:pt>
                <c:pt idx="56">
                  <c:v>115.2345425</c:v>
                </c:pt>
                <c:pt idx="57">
                  <c:v>104.76378249999999</c:v>
                </c:pt>
                <c:pt idx="58">
                  <c:v>95.053162499999999</c:v>
                </c:pt>
                <c:pt idx="59">
                  <c:v>87.286742500000003</c:v>
                </c:pt>
                <c:pt idx="60">
                  <c:v>80.955612500000001</c:v>
                </c:pt>
                <c:pt idx="61">
                  <c:v>76.859729999999999</c:v>
                </c:pt>
                <c:pt idx="62">
                  <c:v>74.354060000000004</c:v>
                </c:pt>
                <c:pt idx="63">
                  <c:v>73.023889999999994</c:v>
                </c:pt>
                <c:pt idx="64">
                  <c:v>72.185532499999994</c:v>
                </c:pt>
                <c:pt idx="65">
                  <c:v>73.655822500000014</c:v>
                </c:pt>
                <c:pt idx="66">
                  <c:v>74.809442500000003</c:v>
                </c:pt>
                <c:pt idx="67">
                  <c:v>76.956460000000007</c:v>
                </c:pt>
                <c:pt idx="68">
                  <c:v>80.377162499999997</c:v>
                </c:pt>
                <c:pt idx="69">
                  <c:v>84.285539999999997</c:v>
                </c:pt>
                <c:pt idx="70">
                  <c:v>88.726627499999992</c:v>
                </c:pt>
                <c:pt idx="71">
                  <c:v>93.171469999999999</c:v>
                </c:pt>
                <c:pt idx="72">
                  <c:v>98.124839999999992</c:v>
                </c:pt>
                <c:pt idx="73">
                  <c:v>103.04527250000001</c:v>
                </c:pt>
                <c:pt idx="74">
                  <c:v>106.56838500000001</c:v>
                </c:pt>
                <c:pt idx="75">
                  <c:v>108.18948999999999</c:v>
                </c:pt>
                <c:pt idx="76">
                  <c:v>107.40464250000001</c:v>
                </c:pt>
                <c:pt idx="77">
                  <c:v>104.96959</c:v>
                </c:pt>
                <c:pt idx="78">
                  <c:v>101.018005</c:v>
                </c:pt>
                <c:pt idx="79">
                  <c:v>96.770487500000002</c:v>
                </c:pt>
                <c:pt idx="80">
                  <c:v>90.635597500000003</c:v>
                </c:pt>
                <c:pt idx="81">
                  <c:v>84.917327499999985</c:v>
                </c:pt>
                <c:pt idx="82">
                  <c:v>79.142352499999987</c:v>
                </c:pt>
                <c:pt idx="83">
                  <c:v>73.839764999999986</c:v>
                </c:pt>
                <c:pt idx="84">
                  <c:v>69.590714999999989</c:v>
                </c:pt>
                <c:pt idx="85">
                  <c:v>65.754530000000003</c:v>
                </c:pt>
                <c:pt idx="86">
                  <c:v>63.718369999999993</c:v>
                </c:pt>
                <c:pt idx="87">
                  <c:v>60.467950000000002</c:v>
                </c:pt>
                <c:pt idx="88">
                  <c:v>58.416449999999998</c:v>
                </c:pt>
                <c:pt idx="89">
                  <c:v>56.039317500000003</c:v>
                </c:pt>
                <c:pt idx="90">
                  <c:v>54.173544999999997</c:v>
                </c:pt>
                <c:pt idx="91">
                  <c:v>53.053560000000012</c:v>
                </c:pt>
                <c:pt idx="92">
                  <c:v>51.628507499999998</c:v>
                </c:pt>
                <c:pt idx="93">
                  <c:v>51.613132499999999</c:v>
                </c:pt>
                <c:pt idx="94">
                  <c:v>52.122602499999999</c:v>
                </c:pt>
                <c:pt idx="95">
                  <c:v>53.773272500000012</c:v>
                </c:pt>
                <c:pt idx="96">
                  <c:v>56.114817500000008</c:v>
                </c:pt>
                <c:pt idx="97">
                  <c:v>59.302932499999997</c:v>
                </c:pt>
                <c:pt idx="98">
                  <c:v>62.858410000000006</c:v>
                </c:pt>
                <c:pt idx="99">
                  <c:v>65.650114999999985</c:v>
                </c:pt>
                <c:pt idx="100">
                  <c:v>67.921199999999999</c:v>
                </c:pt>
                <c:pt idx="101">
                  <c:v>69.215669999999989</c:v>
                </c:pt>
                <c:pt idx="102">
                  <c:v>68.888455000000008</c:v>
                </c:pt>
                <c:pt idx="103">
                  <c:v>67.47903500000001</c:v>
                </c:pt>
                <c:pt idx="104">
                  <c:v>65.812987500000006</c:v>
                </c:pt>
                <c:pt idx="105">
                  <c:v>63.160430000000005</c:v>
                </c:pt>
                <c:pt idx="106">
                  <c:v>60.778597500000011</c:v>
                </c:pt>
                <c:pt idx="107">
                  <c:v>58.346864999999994</c:v>
                </c:pt>
                <c:pt idx="108">
                  <c:v>56.154194999999994</c:v>
                </c:pt>
                <c:pt idx="109">
                  <c:v>54.360880000000002</c:v>
                </c:pt>
                <c:pt idx="110">
                  <c:v>52.716107499999993</c:v>
                </c:pt>
                <c:pt idx="111">
                  <c:v>50.906827499999999</c:v>
                </c:pt>
                <c:pt idx="112">
                  <c:v>48.887067500000001</c:v>
                </c:pt>
                <c:pt idx="113">
                  <c:v>46.536747500000004</c:v>
                </c:pt>
                <c:pt idx="114">
                  <c:v>44.298967499999996</c:v>
                </c:pt>
                <c:pt idx="115">
                  <c:v>41.922742499999998</c:v>
                </c:pt>
                <c:pt idx="116">
                  <c:v>40.135899999999999</c:v>
                </c:pt>
                <c:pt idx="117">
                  <c:v>38.41207</c:v>
                </c:pt>
                <c:pt idx="118">
                  <c:v>37.298264999999994</c:v>
                </c:pt>
                <c:pt idx="119">
                  <c:v>36.753774999999997</c:v>
                </c:pt>
                <c:pt idx="120">
                  <c:v>36.773837499999999</c:v>
                </c:pt>
                <c:pt idx="121">
                  <c:v>37.303229999999999</c:v>
                </c:pt>
                <c:pt idx="122">
                  <c:v>38.074664999999996</c:v>
                </c:pt>
                <c:pt idx="123">
                  <c:v>39.212825000000002</c:v>
                </c:pt>
                <c:pt idx="124">
                  <c:v>38.497920000000001</c:v>
                </c:pt>
                <c:pt idx="125">
                  <c:v>41.5944</c:v>
                </c:pt>
                <c:pt idx="126">
                  <c:v>42.366685000000004</c:v>
                </c:pt>
                <c:pt idx="127">
                  <c:v>42.665925000000001</c:v>
                </c:pt>
                <c:pt idx="128">
                  <c:v>42.569687500000001</c:v>
                </c:pt>
                <c:pt idx="129">
                  <c:v>42.7420825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F75-4F78-A171-ECF872408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7100928"/>
        <c:axId val="77102464"/>
      </c:lineChart>
      <c:catAx>
        <c:axId val="77100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710246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7710246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771009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R$17:$CR$146</c:f>
              <c:numCache>
                <c:formatCode>0.00</c:formatCode>
                <c:ptCount val="130"/>
                <c:pt idx="0">
                  <c:v>6.6149149999999963</c:v>
                </c:pt>
                <c:pt idx="1">
                  <c:v>10.197795000000001</c:v>
                </c:pt>
                <c:pt idx="2">
                  <c:v>9.947379999999999</c:v>
                </c:pt>
                <c:pt idx="3">
                  <c:v>9.6431450000000005</c:v>
                </c:pt>
                <c:pt idx="4">
                  <c:v>9.4903450000000014</c:v>
                </c:pt>
                <c:pt idx="5">
                  <c:v>9.5386799999999994</c:v>
                </c:pt>
                <c:pt idx="6">
                  <c:v>9.272845000000002</c:v>
                </c:pt>
                <c:pt idx="7">
                  <c:v>8.827745000000002</c:v>
                </c:pt>
                <c:pt idx="8">
                  <c:v>8.8057750000000006</c:v>
                </c:pt>
                <c:pt idx="9">
                  <c:v>8.9525950000000005</c:v>
                </c:pt>
                <c:pt idx="10">
                  <c:v>9.4125649999999972</c:v>
                </c:pt>
                <c:pt idx="11">
                  <c:v>10.645354999999999</c:v>
                </c:pt>
                <c:pt idx="12">
                  <c:v>13.718450000000001</c:v>
                </c:pt>
                <c:pt idx="13">
                  <c:v>19.874354999999998</c:v>
                </c:pt>
                <c:pt idx="14">
                  <c:v>27.334410000000002</c:v>
                </c:pt>
                <c:pt idx="15">
                  <c:v>37.862545000000004</c:v>
                </c:pt>
                <c:pt idx="16">
                  <c:v>50.632874999999999</c:v>
                </c:pt>
                <c:pt idx="17">
                  <c:v>62.441819999999993</c:v>
                </c:pt>
                <c:pt idx="18">
                  <c:v>67.102879999999999</c:v>
                </c:pt>
                <c:pt idx="19">
                  <c:v>65.26214499999999</c:v>
                </c:pt>
                <c:pt idx="20">
                  <c:v>58.921180000000007</c:v>
                </c:pt>
                <c:pt idx="21">
                  <c:v>54.266860000000008</c:v>
                </c:pt>
                <c:pt idx="22">
                  <c:v>50.844720000000002</c:v>
                </c:pt>
                <c:pt idx="23">
                  <c:v>47.57255</c:v>
                </c:pt>
                <c:pt idx="24">
                  <c:v>44.168810000000001</c:v>
                </c:pt>
                <c:pt idx="25">
                  <c:v>41.023254999999999</c:v>
                </c:pt>
                <c:pt idx="26">
                  <c:v>38.781775000000003</c:v>
                </c:pt>
                <c:pt idx="27">
                  <c:v>36.140239999999999</c:v>
                </c:pt>
                <c:pt idx="28">
                  <c:v>32.790845000000004</c:v>
                </c:pt>
                <c:pt idx="29">
                  <c:v>29.723005000000001</c:v>
                </c:pt>
                <c:pt idx="30">
                  <c:v>26.942889999999995</c:v>
                </c:pt>
                <c:pt idx="31">
                  <c:v>25.145664999999997</c:v>
                </c:pt>
                <c:pt idx="32">
                  <c:v>24.502064999999998</c:v>
                </c:pt>
                <c:pt idx="33">
                  <c:v>25.270195000000001</c:v>
                </c:pt>
                <c:pt idx="34">
                  <c:v>29.382449999999999</c:v>
                </c:pt>
                <c:pt idx="35">
                  <c:v>36.033635000000004</c:v>
                </c:pt>
                <c:pt idx="36">
                  <c:v>44.613795000000003</c:v>
                </c:pt>
                <c:pt idx="37">
                  <c:v>52.667485000000006</c:v>
                </c:pt>
                <c:pt idx="38">
                  <c:v>60.847260000000013</c:v>
                </c:pt>
                <c:pt idx="39">
                  <c:v>67.734994999999998</c:v>
                </c:pt>
                <c:pt idx="40">
                  <c:v>70.501405000000005</c:v>
                </c:pt>
                <c:pt idx="41">
                  <c:v>68.959644999999995</c:v>
                </c:pt>
                <c:pt idx="42">
                  <c:v>64.124925000000005</c:v>
                </c:pt>
                <c:pt idx="43">
                  <c:v>56.083950000000002</c:v>
                </c:pt>
                <c:pt idx="44">
                  <c:v>49.852139999999999</c:v>
                </c:pt>
                <c:pt idx="45">
                  <c:v>44.680174999999998</c:v>
                </c:pt>
                <c:pt idx="46">
                  <c:v>41.190510000000003</c:v>
                </c:pt>
                <c:pt idx="47">
                  <c:v>38.119950000000003</c:v>
                </c:pt>
                <c:pt idx="48">
                  <c:v>35.861210000000007</c:v>
                </c:pt>
                <c:pt idx="49">
                  <c:v>33.823805</c:v>
                </c:pt>
                <c:pt idx="50">
                  <c:v>32.051225000000002</c:v>
                </c:pt>
                <c:pt idx="51">
                  <c:v>30.430800000000001</c:v>
                </c:pt>
                <c:pt idx="52">
                  <c:v>29.645770000000002</c:v>
                </c:pt>
                <c:pt idx="53">
                  <c:v>29.460149999999999</c:v>
                </c:pt>
                <c:pt idx="54">
                  <c:v>29.656600000000001</c:v>
                </c:pt>
                <c:pt idx="55">
                  <c:v>31.094364999999996</c:v>
                </c:pt>
                <c:pt idx="56">
                  <c:v>33.817405000000001</c:v>
                </c:pt>
                <c:pt idx="57">
                  <c:v>37.547839999999994</c:v>
                </c:pt>
                <c:pt idx="58">
                  <c:v>41.90737</c:v>
                </c:pt>
                <c:pt idx="59">
                  <c:v>45.6661</c:v>
                </c:pt>
                <c:pt idx="60">
                  <c:v>48.202565</c:v>
                </c:pt>
                <c:pt idx="61">
                  <c:v>49.362580000000001</c:v>
                </c:pt>
                <c:pt idx="62">
                  <c:v>49.318164999999993</c:v>
                </c:pt>
                <c:pt idx="63">
                  <c:v>47.976035000000003</c:v>
                </c:pt>
                <c:pt idx="64">
                  <c:v>45.833874999999999</c:v>
                </c:pt>
                <c:pt idx="65">
                  <c:v>43.141760000000005</c:v>
                </c:pt>
                <c:pt idx="66">
                  <c:v>40.542954999999999</c:v>
                </c:pt>
                <c:pt idx="67">
                  <c:v>37.484349999999999</c:v>
                </c:pt>
                <c:pt idx="68">
                  <c:v>34.655764999999995</c:v>
                </c:pt>
                <c:pt idx="69">
                  <c:v>31.945589999999996</c:v>
                </c:pt>
                <c:pt idx="70">
                  <c:v>29.881605</c:v>
                </c:pt>
                <c:pt idx="71">
                  <c:v>27.171695</c:v>
                </c:pt>
                <c:pt idx="72">
                  <c:v>24.967489999999998</c:v>
                </c:pt>
                <c:pt idx="73">
                  <c:v>22.980045</c:v>
                </c:pt>
                <c:pt idx="74">
                  <c:v>21.723020000000002</c:v>
                </c:pt>
                <c:pt idx="75">
                  <c:v>21.269254999999998</c:v>
                </c:pt>
                <c:pt idx="76">
                  <c:v>21.339760000000002</c:v>
                </c:pt>
                <c:pt idx="77">
                  <c:v>22.586054999999998</c:v>
                </c:pt>
                <c:pt idx="78">
                  <c:v>24.457775000000002</c:v>
                </c:pt>
                <c:pt idx="79">
                  <c:v>26.856000000000002</c:v>
                </c:pt>
                <c:pt idx="80">
                  <c:v>29.818935000000003</c:v>
                </c:pt>
                <c:pt idx="81">
                  <c:v>32.366300000000003</c:v>
                </c:pt>
                <c:pt idx="82">
                  <c:v>34.406735000000005</c:v>
                </c:pt>
                <c:pt idx="83">
                  <c:v>35.425879999999999</c:v>
                </c:pt>
                <c:pt idx="84">
                  <c:v>35.468204999999998</c:v>
                </c:pt>
                <c:pt idx="85">
                  <c:v>35.495539999999998</c:v>
                </c:pt>
                <c:pt idx="86">
                  <c:v>34.137070000000001</c:v>
                </c:pt>
                <c:pt idx="87">
                  <c:v>32.669089999999997</c:v>
                </c:pt>
                <c:pt idx="88">
                  <c:v>30.797710000000002</c:v>
                </c:pt>
                <c:pt idx="89">
                  <c:v>28.889870000000002</c:v>
                </c:pt>
                <c:pt idx="90">
                  <c:v>27.260325000000002</c:v>
                </c:pt>
                <c:pt idx="91">
                  <c:v>25.687514999999998</c:v>
                </c:pt>
                <c:pt idx="92">
                  <c:v>23.898964999999997</c:v>
                </c:pt>
                <c:pt idx="93">
                  <c:v>22.337335000000003</c:v>
                </c:pt>
                <c:pt idx="94">
                  <c:v>21.120720000000002</c:v>
                </c:pt>
                <c:pt idx="95">
                  <c:v>20.256769999999999</c:v>
                </c:pt>
                <c:pt idx="96">
                  <c:v>19.667789999999997</c:v>
                </c:pt>
                <c:pt idx="97">
                  <c:v>19.606925</c:v>
                </c:pt>
                <c:pt idx="98">
                  <c:v>20.01698</c:v>
                </c:pt>
                <c:pt idx="99">
                  <c:v>20.977039999999995</c:v>
                </c:pt>
                <c:pt idx="100">
                  <c:v>21.999435000000002</c:v>
                </c:pt>
                <c:pt idx="101">
                  <c:v>23.429579999999998</c:v>
                </c:pt>
                <c:pt idx="102">
                  <c:v>24.500954999999998</c:v>
                </c:pt>
                <c:pt idx="103">
                  <c:v>25.4237</c:v>
                </c:pt>
                <c:pt idx="104">
                  <c:v>25.952275</c:v>
                </c:pt>
                <c:pt idx="105">
                  <c:v>25.792470000000002</c:v>
                </c:pt>
                <c:pt idx="106">
                  <c:v>25.180439999999997</c:v>
                </c:pt>
                <c:pt idx="107">
                  <c:v>24.340170000000001</c:v>
                </c:pt>
                <c:pt idx="108">
                  <c:v>23.281045000000002</c:v>
                </c:pt>
                <c:pt idx="109">
                  <c:v>22.599004999999998</c:v>
                </c:pt>
                <c:pt idx="110">
                  <c:v>21.906579999999998</c:v>
                </c:pt>
                <c:pt idx="111">
                  <c:v>20.868175000000001</c:v>
                </c:pt>
                <c:pt idx="112">
                  <c:v>19.731689999999997</c:v>
                </c:pt>
                <c:pt idx="113">
                  <c:v>19.068510000000003</c:v>
                </c:pt>
                <c:pt idx="114">
                  <c:v>18.471629999999998</c:v>
                </c:pt>
                <c:pt idx="115">
                  <c:v>17.988360000000004</c:v>
                </c:pt>
                <c:pt idx="116">
                  <c:v>17.971585000000005</c:v>
                </c:pt>
                <c:pt idx="117">
                  <c:v>18.178295000000002</c:v>
                </c:pt>
                <c:pt idx="118">
                  <c:v>18.740054999999998</c:v>
                </c:pt>
                <c:pt idx="119">
                  <c:v>19.327770000000001</c:v>
                </c:pt>
                <c:pt idx="120">
                  <c:v>20.027445</c:v>
                </c:pt>
                <c:pt idx="121">
                  <c:v>20.551850000000002</c:v>
                </c:pt>
                <c:pt idx="122">
                  <c:v>20.986389999999997</c:v>
                </c:pt>
                <c:pt idx="123">
                  <c:v>21.208770000000001</c:v>
                </c:pt>
                <c:pt idx="124">
                  <c:v>20.947860000000002</c:v>
                </c:pt>
                <c:pt idx="125">
                  <c:v>20.712639999999997</c:v>
                </c:pt>
                <c:pt idx="126">
                  <c:v>20.234649999999998</c:v>
                </c:pt>
                <c:pt idx="127">
                  <c:v>19.331939999999996</c:v>
                </c:pt>
                <c:pt idx="128">
                  <c:v>18.588589999999996</c:v>
                </c:pt>
                <c:pt idx="129">
                  <c:v>17.9651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E95-4A3F-9512-11D1A4677276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S$17:$CS$146</c:f>
              <c:numCache>
                <c:formatCode>0.00</c:formatCode>
                <c:ptCount val="130"/>
                <c:pt idx="0">
                  <c:v>6.1416149999999963</c:v>
                </c:pt>
                <c:pt idx="1">
                  <c:v>9.8987950000000016</c:v>
                </c:pt>
                <c:pt idx="2">
                  <c:v>9.554079999999999</c:v>
                </c:pt>
                <c:pt idx="3">
                  <c:v>8.8718450000000004</c:v>
                </c:pt>
                <c:pt idx="4">
                  <c:v>8.0887450000000012</c:v>
                </c:pt>
                <c:pt idx="5">
                  <c:v>7.6610799999999992</c:v>
                </c:pt>
                <c:pt idx="6">
                  <c:v>7.3806450000000012</c:v>
                </c:pt>
                <c:pt idx="7">
                  <c:v>6.9971450000000015</c:v>
                </c:pt>
                <c:pt idx="8">
                  <c:v>6.7661749999999996</c:v>
                </c:pt>
                <c:pt idx="9">
                  <c:v>6.835395000000001</c:v>
                </c:pt>
                <c:pt idx="10">
                  <c:v>7.4770649999999961</c:v>
                </c:pt>
                <c:pt idx="11">
                  <c:v>8.8279549999999993</c:v>
                </c:pt>
                <c:pt idx="12">
                  <c:v>11.620950000000001</c:v>
                </c:pt>
                <c:pt idx="13">
                  <c:v>15.927754999999999</c:v>
                </c:pt>
                <c:pt idx="14">
                  <c:v>21.436310000000002</c:v>
                </c:pt>
                <c:pt idx="15">
                  <c:v>28.231945</c:v>
                </c:pt>
                <c:pt idx="16">
                  <c:v>35.091475000000003</c:v>
                </c:pt>
                <c:pt idx="17">
                  <c:v>40.128120000000003</c:v>
                </c:pt>
                <c:pt idx="18">
                  <c:v>42.930679999999995</c:v>
                </c:pt>
                <c:pt idx="19">
                  <c:v>45.246545000000005</c:v>
                </c:pt>
                <c:pt idx="20">
                  <c:v>45.982979999999998</c:v>
                </c:pt>
                <c:pt idx="21">
                  <c:v>46.377160000000003</c:v>
                </c:pt>
                <c:pt idx="22">
                  <c:v>46.091520000000003</c:v>
                </c:pt>
                <c:pt idx="23">
                  <c:v>44.359250000000003</c:v>
                </c:pt>
                <c:pt idx="24">
                  <c:v>41.911410000000004</c:v>
                </c:pt>
                <c:pt idx="25">
                  <c:v>41.494254999999995</c:v>
                </c:pt>
                <c:pt idx="26">
                  <c:v>41.109175</c:v>
                </c:pt>
                <c:pt idx="27">
                  <c:v>39.410139999999998</c:v>
                </c:pt>
                <c:pt idx="28">
                  <c:v>35.895144999999999</c:v>
                </c:pt>
                <c:pt idx="29">
                  <c:v>32.437705000000001</c:v>
                </c:pt>
                <c:pt idx="30">
                  <c:v>29.714689999999997</c:v>
                </c:pt>
                <c:pt idx="31">
                  <c:v>27.089064999999998</c:v>
                </c:pt>
                <c:pt idx="32">
                  <c:v>25.139364999999998</c:v>
                </c:pt>
                <c:pt idx="33">
                  <c:v>24.140695000000001</c:v>
                </c:pt>
                <c:pt idx="34">
                  <c:v>25.09375</c:v>
                </c:pt>
                <c:pt idx="35">
                  <c:v>28.191535000000002</c:v>
                </c:pt>
                <c:pt idx="36">
                  <c:v>33.176695000000002</c:v>
                </c:pt>
                <c:pt idx="37">
                  <c:v>38.680185000000002</c:v>
                </c:pt>
                <c:pt idx="38">
                  <c:v>44.534760000000006</c:v>
                </c:pt>
                <c:pt idx="39">
                  <c:v>49.404695000000004</c:v>
                </c:pt>
                <c:pt idx="40">
                  <c:v>51.619104999999998</c:v>
                </c:pt>
                <c:pt idx="41">
                  <c:v>50.363644999999998</c:v>
                </c:pt>
                <c:pt idx="42">
                  <c:v>46.684824999999996</c:v>
                </c:pt>
                <c:pt idx="43">
                  <c:v>43.311149999999998</c:v>
                </c:pt>
                <c:pt idx="44">
                  <c:v>40.045939999999995</c:v>
                </c:pt>
                <c:pt idx="45">
                  <c:v>37.222574999999999</c:v>
                </c:pt>
                <c:pt idx="46">
                  <c:v>35.724510000000002</c:v>
                </c:pt>
                <c:pt idx="47">
                  <c:v>33.949750000000002</c:v>
                </c:pt>
                <c:pt idx="48">
                  <c:v>31.973510000000005</c:v>
                </c:pt>
                <c:pt idx="49">
                  <c:v>29.845704999999999</c:v>
                </c:pt>
                <c:pt idx="50">
                  <c:v>27.559925</c:v>
                </c:pt>
                <c:pt idx="51">
                  <c:v>26.104600000000001</c:v>
                </c:pt>
                <c:pt idx="52">
                  <c:v>24.638070000000003</c:v>
                </c:pt>
                <c:pt idx="53">
                  <c:v>23.748950000000001</c:v>
                </c:pt>
                <c:pt idx="54">
                  <c:v>23.211200000000002</c:v>
                </c:pt>
                <c:pt idx="55">
                  <c:v>23.352964999999998</c:v>
                </c:pt>
                <c:pt idx="56">
                  <c:v>24.185604999999999</c:v>
                </c:pt>
                <c:pt idx="57">
                  <c:v>26.146539999999998</c:v>
                </c:pt>
                <c:pt idx="58">
                  <c:v>28.80097</c:v>
                </c:pt>
                <c:pt idx="59">
                  <c:v>31.68</c:v>
                </c:pt>
                <c:pt idx="60">
                  <c:v>34.034464999999997</c:v>
                </c:pt>
                <c:pt idx="61">
                  <c:v>35.448079999999997</c:v>
                </c:pt>
                <c:pt idx="62">
                  <c:v>36.129964999999999</c:v>
                </c:pt>
                <c:pt idx="63">
                  <c:v>35.724235</c:v>
                </c:pt>
                <c:pt idx="64">
                  <c:v>34.847475000000003</c:v>
                </c:pt>
                <c:pt idx="65">
                  <c:v>33.541360000000005</c:v>
                </c:pt>
                <c:pt idx="66">
                  <c:v>31.822154999999999</c:v>
                </c:pt>
                <c:pt idx="67">
                  <c:v>29.959150000000001</c:v>
                </c:pt>
                <c:pt idx="68">
                  <c:v>27.670164999999997</c:v>
                </c:pt>
                <c:pt idx="69">
                  <c:v>25.627689999999998</c:v>
                </c:pt>
                <c:pt idx="70">
                  <c:v>24.020804999999999</c:v>
                </c:pt>
                <c:pt idx="71">
                  <c:v>22.398695</c:v>
                </c:pt>
                <c:pt idx="72">
                  <c:v>21.064989999999998</c:v>
                </c:pt>
                <c:pt idx="73">
                  <c:v>19.641445000000001</c:v>
                </c:pt>
                <c:pt idx="74">
                  <c:v>18.467120000000001</c:v>
                </c:pt>
                <c:pt idx="75">
                  <c:v>17.966054999999997</c:v>
                </c:pt>
                <c:pt idx="76">
                  <c:v>17.764460000000003</c:v>
                </c:pt>
                <c:pt idx="77">
                  <c:v>18.113454999999998</c:v>
                </c:pt>
                <c:pt idx="78">
                  <c:v>18.900275000000001</c:v>
                </c:pt>
                <c:pt idx="79">
                  <c:v>20.167300000000001</c:v>
                </c:pt>
                <c:pt idx="80">
                  <c:v>21.454335000000004</c:v>
                </c:pt>
                <c:pt idx="81">
                  <c:v>22.8965</c:v>
                </c:pt>
                <c:pt idx="82">
                  <c:v>24.104635000000002</c:v>
                </c:pt>
                <c:pt idx="83">
                  <c:v>24.88758</c:v>
                </c:pt>
                <c:pt idx="84">
                  <c:v>25.183304999999997</c:v>
                </c:pt>
                <c:pt idx="85">
                  <c:v>25.076939999999997</c:v>
                </c:pt>
                <c:pt idx="86">
                  <c:v>24.43487</c:v>
                </c:pt>
                <c:pt idx="87">
                  <c:v>23.395189999999996</c:v>
                </c:pt>
                <c:pt idx="88">
                  <c:v>22.261610000000005</c:v>
                </c:pt>
                <c:pt idx="89">
                  <c:v>21.16807</c:v>
                </c:pt>
                <c:pt idx="90">
                  <c:v>19.945225000000001</c:v>
                </c:pt>
                <c:pt idx="91">
                  <c:v>18.940114999999995</c:v>
                </c:pt>
                <c:pt idx="92">
                  <c:v>17.776064999999996</c:v>
                </c:pt>
                <c:pt idx="93">
                  <c:v>16.907035000000004</c:v>
                </c:pt>
                <c:pt idx="94">
                  <c:v>16.524520000000003</c:v>
                </c:pt>
                <c:pt idx="95">
                  <c:v>16.192970000000003</c:v>
                </c:pt>
                <c:pt idx="96">
                  <c:v>16.178689999999996</c:v>
                </c:pt>
                <c:pt idx="97">
                  <c:v>16.307324999999999</c:v>
                </c:pt>
                <c:pt idx="98">
                  <c:v>16.719079999999998</c:v>
                </c:pt>
                <c:pt idx="99">
                  <c:v>17.412939999999995</c:v>
                </c:pt>
                <c:pt idx="100">
                  <c:v>18.156435000000002</c:v>
                </c:pt>
                <c:pt idx="101">
                  <c:v>18.67698</c:v>
                </c:pt>
                <c:pt idx="102">
                  <c:v>19.341654999999999</c:v>
                </c:pt>
                <c:pt idx="103">
                  <c:v>19.5182</c:v>
                </c:pt>
                <c:pt idx="104">
                  <c:v>19.686875000000001</c:v>
                </c:pt>
                <c:pt idx="105">
                  <c:v>19.395770000000002</c:v>
                </c:pt>
                <c:pt idx="106">
                  <c:v>18.873139999999996</c:v>
                </c:pt>
                <c:pt idx="107">
                  <c:v>18.284970000000001</c:v>
                </c:pt>
                <c:pt idx="108">
                  <c:v>17.507545</c:v>
                </c:pt>
                <c:pt idx="109">
                  <c:v>16.634004999999998</c:v>
                </c:pt>
                <c:pt idx="110">
                  <c:v>15.67198</c:v>
                </c:pt>
                <c:pt idx="111">
                  <c:v>15.718575</c:v>
                </c:pt>
                <c:pt idx="112">
                  <c:v>14.057189999999997</c:v>
                </c:pt>
                <c:pt idx="113">
                  <c:v>13.559410000000003</c:v>
                </c:pt>
                <c:pt idx="114">
                  <c:v>13.709529999999999</c:v>
                </c:pt>
                <c:pt idx="115">
                  <c:v>12.840460000000004</c:v>
                </c:pt>
                <c:pt idx="116">
                  <c:v>12.864585000000003</c:v>
                </c:pt>
                <c:pt idx="117">
                  <c:v>12.843495000000001</c:v>
                </c:pt>
                <c:pt idx="118">
                  <c:v>13.137054999999998</c:v>
                </c:pt>
                <c:pt idx="119">
                  <c:v>13.343470000000002</c:v>
                </c:pt>
                <c:pt idx="120">
                  <c:v>13.861445000000002</c:v>
                </c:pt>
                <c:pt idx="121">
                  <c:v>14.300549999999999</c:v>
                </c:pt>
                <c:pt idx="122">
                  <c:v>14.534689999999996</c:v>
                </c:pt>
                <c:pt idx="123">
                  <c:v>14.773770000000001</c:v>
                </c:pt>
                <c:pt idx="124">
                  <c:v>14.610660000000003</c:v>
                </c:pt>
                <c:pt idx="125">
                  <c:v>14.503039999999997</c:v>
                </c:pt>
                <c:pt idx="126">
                  <c:v>14.11215</c:v>
                </c:pt>
                <c:pt idx="127">
                  <c:v>13.593039999999997</c:v>
                </c:pt>
                <c:pt idx="128">
                  <c:v>13.083189999999997</c:v>
                </c:pt>
                <c:pt idx="129">
                  <c:v>12.6769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E95-4A3F-9512-11D1A4677276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T$17:$CT$146</c:f>
              <c:numCache>
                <c:formatCode>0.00</c:formatCode>
                <c:ptCount val="130"/>
                <c:pt idx="0">
                  <c:v>4.5934149999999967</c:v>
                </c:pt>
                <c:pt idx="1">
                  <c:v>8.4361950000000014</c:v>
                </c:pt>
                <c:pt idx="2">
                  <c:v>8.0876799999999989</c:v>
                </c:pt>
                <c:pt idx="3">
                  <c:v>7.2588450000000009</c:v>
                </c:pt>
                <c:pt idx="4">
                  <c:v>6.6563450000000008</c:v>
                </c:pt>
                <c:pt idx="5">
                  <c:v>6.7403799999999991</c:v>
                </c:pt>
                <c:pt idx="6">
                  <c:v>6.5054450000000008</c:v>
                </c:pt>
                <c:pt idx="7">
                  <c:v>6.0989450000000014</c:v>
                </c:pt>
                <c:pt idx="8">
                  <c:v>5.9284749999999997</c:v>
                </c:pt>
                <c:pt idx="9">
                  <c:v>6.097195000000001</c:v>
                </c:pt>
                <c:pt idx="10">
                  <c:v>6.8000649999999965</c:v>
                </c:pt>
                <c:pt idx="11">
                  <c:v>8.0672549999999994</c:v>
                </c:pt>
                <c:pt idx="12">
                  <c:v>10.70795</c:v>
                </c:pt>
                <c:pt idx="13">
                  <c:v>14.790154999999999</c:v>
                </c:pt>
                <c:pt idx="14">
                  <c:v>20.406810000000004</c:v>
                </c:pt>
                <c:pt idx="15">
                  <c:v>27.190745</c:v>
                </c:pt>
                <c:pt idx="16">
                  <c:v>33.949775000000002</c:v>
                </c:pt>
                <c:pt idx="17">
                  <c:v>38.437620000000003</c:v>
                </c:pt>
                <c:pt idx="18">
                  <c:v>40.32938</c:v>
                </c:pt>
                <c:pt idx="19">
                  <c:v>41.328445000000002</c:v>
                </c:pt>
                <c:pt idx="20">
                  <c:v>42.04298</c:v>
                </c:pt>
                <c:pt idx="21">
                  <c:v>42.632760000000005</c:v>
                </c:pt>
                <c:pt idx="22">
                  <c:v>41.875120000000003</c:v>
                </c:pt>
                <c:pt idx="23">
                  <c:v>40.892449999999997</c:v>
                </c:pt>
                <c:pt idx="24">
                  <c:v>39.276910000000001</c:v>
                </c:pt>
                <c:pt idx="25">
                  <c:v>39.179854999999996</c:v>
                </c:pt>
                <c:pt idx="26">
                  <c:v>38.687775000000002</c:v>
                </c:pt>
                <c:pt idx="27">
                  <c:v>37.03454</c:v>
                </c:pt>
                <c:pt idx="28">
                  <c:v>33.947445000000002</c:v>
                </c:pt>
                <c:pt idx="29">
                  <c:v>30.790604999999999</c:v>
                </c:pt>
                <c:pt idx="30">
                  <c:v>27.963489999999997</c:v>
                </c:pt>
                <c:pt idx="31">
                  <c:v>25.161564999999996</c:v>
                </c:pt>
                <c:pt idx="32">
                  <c:v>23.326164999999996</c:v>
                </c:pt>
                <c:pt idx="33">
                  <c:v>22.649495000000002</c:v>
                </c:pt>
                <c:pt idx="34">
                  <c:v>24.025749999999999</c:v>
                </c:pt>
                <c:pt idx="35">
                  <c:v>27.069635000000005</c:v>
                </c:pt>
                <c:pt idx="36">
                  <c:v>31.615394999999999</c:v>
                </c:pt>
                <c:pt idx="37">
                  <c:v>36.297885000000001</c:v>
                </c:pt>
                <c:pt idx="38">
                  <c:v>40.89376</c:v>
                </c:pt>
                <c:pt idx="39">
                  <c:v>43.855195000000002</c:v>
                </c:pt>
                <c:pt idx="40">
                  <c:v>44.478904999999997</c:v>
                </c:pt>
                <c:pt idx="41">
                  <c:v>43.348545000000001</c:v>
                </c:pt>
                <c:pt idx="42">
                  <c:v>40.835324999999997</c:v>
                </c:pt>
                <c:pt idx="43">
                  <c:v>38.601750000000003</c:v>
                </c:pt>
                <c:pt idx="44">
                  <c:v>36.17324</c:v>
                </c:pt>
                <c:pt idx="45">
                  <c:v>34.290374999999997</c:v>
                </c:pt>
                <c:pt idx="46">
                  <c:v>32.623910000000002</c:v>
                </c:pt>
                <c:pt idx="47">
                  <c:v>30.994350000000001</c:v>
                </c:pt>
                <c:pt idx="48">
                  <c:v>28.937710000000003</c:v>
                </c:pt>
                <c:pt idx="49">
                  <c:v>26.714205</c:v>
                </c:pt>
                <c:pt idx="50">
                  <c:v>24.670425000000002</c:v>
                </c:pt>
                <c:pt idx="51">
                  <c:v>22.643599999999999</c:v>
                </c:pt>
                <c:pt idx="52">
                  <c:v>21.25827</c:v>
                </c:pt>
                <c:pt idx="53">
                  <c:v>20.518750000000001</c:v>
                </c:pt>
                <c:pt idx="54">
                  <c:v>20.432500000000001</c:v>
                </c:pt>
                <c:pt idx="55">
                  <c:v>20.925364999999996</c:v>
                </c:pt>
                <c:pt idx="56">
                  <c:v>22.075505</c:v>
                </c:pt>
                <c:pt idx="57">
                  <c:v>24.128939999999997</c:v>
                </c:pt>
                <c:pt idx="58">
                  <c:v>26.377370000000003</c:v>
                </c:pt>
                <c:pt idx="59">
                  <c:v>28.601800000000001</c:v>
                </c:pt>
                <c:pt idx="60">
                  <c:v>30.326764999999998</c:v>
                </c:pt>
                <c:pt idx="61">
                  <c:v>31.27618</c:v>
                </c:pt>
                <c:pt idx="62">
                  <c:v>31.978964999999995</c:v>
                </c:pt>
                <c:pt idx="63">
                  <c:v>31.967135000000003</c:v>
                </c:pt>
                <c:pt idx="64">
                  <c:v>31.577874999999999</c:v>
                </c:pt>
                <c:pt idx="65">
                  <c:v>30.661360000000002</c:v>
                </c:pt>
                <c:pt idx="66">
                  <c:v>29.770754999999998</c:v>
                </c:pt>
                <c:pt idx="67">
                  <c:v>28.530650000000001</c:v>
                </c:pt>
                <c:pt idx="68">
                  <c:v>27.287664999999997</c:v>
                </c:pt>
                <c:pt idx="69">
                  <c:v>25.907189999999996</c:v>
                </c:pt>
                <c:pt idx="70">
                  <c:v>24.681204999999999</c:v>
                </c:pt>
                <c:pt idx="71">
                  <c:v>23.171995000000003</c:v>
                </c:pt>
                <c:pt idx="72">
                  <c:v>21.827789999999997</c:v>
                </c:pt>
                <c:pt idx="73">
                  <c:v>20.734745</c:v>
                </c:pt>
                <c:pt idx="74">
                  <c:v>19.717120000000001</c:v>
                </c:pt>
                <c:pt idx="75">
                  <c:v>19.134754999999998</c:v>
                </c:pt>
                <c:pt idx="76">
                  <c:v>18.685460000000003</c:v>
                </c:pt>
                <c:pt idx="77">
                  <c:v>18.619254999999999</c:v>
                </c:pt>
                <c:pt idx="78">
                  <c:v>18.945174999999999</c:v>
                </c:pt>
                <c:pt idx="79">
                  <c:v>19.661300000000001</c:v>
                </c:pt>
                <c:pt idx="80">
                  <c:v>20.551235000000002</c:v>
                </c:pt>
                <c:pt idx="81">
                  <c:v>21.4389</c:v>
                </c:pt>
                <c:pt idx="82">
                  <c:v>22.070735000000003</c:v>
                </c:pt>
                <c:pt idx="83">
                  <c:v>22.721879999999999</c:v>
                </c:pt>
                <c:pt idx="84">
                  <c:v>22.834804999999999</c:v>
                </c:pt>
                <c:pt idx="85">
                  <c:v>22.902839999999998</c:v>
                </c:pt>
                <c:pt idx="86">
                  <c:v>22.608170000000001</c:v>
                </c:pt>
                <c:pt idx="87">
                  <c:v>21.643989999999995</c:v>
                </c:pt>
                <c:pt idx="88">
                  <c:v>20.847710000000003</c:v>
                </c:pt>
                <c:pt idx="89">
                  <c:v>19.937270000000002</c:v>
                </c:pt>
                <c:pt idx="90">
                  <c:v>18.891925000000001</c:v>
                </c:pt>
                <c:pt idx="91">
                  <c:v>17.879014999999995</c:v>
                </c:pt>
                <c:pt idx="92">
                  <c:v>16.882964999999995</c:v>
                </c:pt>
                <c:pt idx="93">
                  <c:v>16.083635000000005</c:v>
                </c:pt>
                <c:pt idx="94">
                  <c:v>15.565520000000001</c:v>
                </c:pt>
                <c:pt idx="95">
                  <c:v>15.008870000000002</c:v>
                </c:pt>
                <c:pt idx="96">
                  <c:v>14.656889999999997</c:v>
                </c:pt>
                <c:pt idx="97">
                  <c:v>14.417925</c:v>
                </c:pt>
                <c:pt idx="98">
                  <c:v>14.40598</c:v>
                </c:pt>
                <c:pt idx="99">
                  <c:v>14.702039999999997</c:v>
                </c:pt>
                <c:pt idx="100">
                  <c:v>14.995035000000003</c:v>
                </c:pt>
                <c:pt idx="101">
                  <c:v>15.471779999999999</c:v>
                </c:pt>
                <c:pt idx="102">
                  <c:v>15.861954999999998</c:v>
                </c:pt>
                <c:pt idx="103">
                  <c:v>16.302299999999999</c:v>
                </c:pt>
                <c:pt idx="104">
                  <c:v>16.862874999999999</c:v>
                </c:pt>
                <c:pt idx="105">
                  <c:v>16.759170000000001</c:v>
                </c:pt>
                <c:pt idx="106">
                  <c:v>16.727339999999998</c:v>
                </c:pt>
                <c:pt idx="107">
                  <c:v>16.516070000000003</c:v>
                </c:pt>
                <c:pt idx="108">
                  <c:v>15.945245000000002</c:v>
                </c:pt>
                <c:pt idx="109">
                  <c:v>15.272604999999999</c:v>
                </c:pt>
                <c:pt idx="110">
                  <c:v>14.748779999999998</c:v>
                </c:pt>
                <c:pt idx="111">
                  <c:v>14.061975</c:v>
                </c:pt>
                <c:pt idx="112">
                  <c:v>13.498489999999997</c:v>
                </c:pt>
                <c:pt idx="113">
                  <c:v>13.098710000000004</c:v>
                </c:pt>
                <c:pt idx="114">
                  <c:v>12.631029999999999</c:v>
                </c:pt>
                <c:pt idx="115">
                  <c:v>12.389060000000004</c:v>
                </c:pt>
                <c:pt idx="116">
                  <c:v>12.259385000000004</c:v>
                </c:pt>
                <c:pt idx="117">
                  <c:v>12.322095000000001</c:v>
                </c:pt>
                <c:pt idx="118">
                  <c:v>12.532554999999999</c:v>
                </c:pt>
                <c:pt idx="119">
                  <c:v>12.825370000000001</c:v>
                </c:pt>
                <c:pt idx="120">
                  <c:v>13.373945000000001</c:v>
                </c:pt>
                <c:pt idx="121">
                  <c:v>13.86835</c:v>
                </c:pt>
                <c:pt idx="122">
                  <c:v>14.291589999999996</c:v>
                </c:pt>
                <c:pt idx="123">
                  <c:v>14.71977</c:v>
                </c:pt>
                <c:pt idx="124">
                  <c:v>14.720560000000004</c:v>
                </c:pt>
                <c:pt idx="125">
                  <c:v>14.879139999999996</c:v>
                </c:pt>
                <c:pt idx="126">
                  <c:v>14.56475</c:v>
                </c:pt>
                <c:pt idx="127">
                  <c:v>14.052839999999996</c:v>
                </c:pt>
                <c:pt idx="128">
                  <c:v>13.659189999999997</c:v>
                </c:pt>
                <c:pt idx="129">
                  <c:v>13.0440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E95-4A3F-9512-11D1A46772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5477760"/>
        <c:axId val="75479680"/>
      </c:lineChart>
      <c:catAx>
        <c:axId val="75477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5479680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75479680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75477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R$17:$CR$146</c:f>
              <c:numCache>
                <c:formatCode>0.00</c:formatCode>
                <c:ptCount val="130"/>
                <c:pt idx="0">
                  <c:v>26.309439999999995</c:v>
                </c:pt>
                <c:pt idx="1">
                  <c:v>24.637160000000005</c:v>
                </c:pt>
                <c:pt idx="2">
                  <c:v>17.969275</c:v>
                </c:pt>
                <c:pt idx="3">
                  <c:v>16.184139999999996</c:v>
                </c:pt>
                <c:pt idx="4">
                  <c:v>15.095685000000003</c:v>
                </c:pt>
                <c:pt idx="5">
                  <c:v>14.405799999999999</c:v>
                </c:pt>
                <c:pt idx="6">
                  <c:v>14.586464999999997</c:v>
                </c:pt>
                <c:pt idx="7">
                  <c:v>16.956624999999999</c:v>
                </c:pt>
                <c:pt idx="8">
                  <c:v>21.085539999999998</c:v>
                </c:pt>
                <c:pt idx="9">
                  <c:v>29.604760000000002</c:v>
                </c:pt>
                <c:pt idx="10">
                  <c:v>43.737789999999997</c:v>
                </c:pt>
                <c:pt idx="11">
                  <c:v>61.653255000000001</c:v>
                </c:pt>
                <c:pt idx="12">
                  <c:v>81.748389999999986</c:v>
                </c:pt>
                <c:pt idx="13">
                  <c:v>106.97590500000001</c:v>
                </c:pt>
                <c:pt idx="14">
                  <c:v>133.05181000000002</c:v>
                </c:pt>
                <c:pt idx="15">
                  <c:v>141.289355</c:v>
                </c:pt>
                <c:pt idx="16">
                  <c:v>131.46496000000002</c:v>
                </c:pt>
                <c:pt idx="17">
                  <c:v>115.75246000000001</c:v>
                </c:pt>
                <c:pt idx="18">
                  <c:v>86.958710000000011</c:v>
                </c:pt>
                <c:pt idx="19">
                  <c:v>60.94156000000001</c:v>
                </c:pt>
                <c:pt idx="20">
                  <c:v>44.396370000000005</c:v>
                </c:pt>
                <c:pt idx="21">
                  <c:v>35.184829999999998</c:v>
                </c:pt>
                <c:pt idx="22">
                  <c:v>29.366885000000003</c:v>
                </c:pt>
                <c:pt idx="23">
                  <c:v>25.634605000000001</c:v>
                </c:pt>
                <c:pt idx="24">
                  <c:v>23.021195000000002</c:v>
                </c:pt>
                <c:pt idx="25">
                  <c:v>20.991054999999999</c:v>
                </c:pt>
                <c:pt idx="26">
                  <c:v>19.099610000000002</c:v>
                </c:pt>
                <c:pt idx="27">
                  <c:v>17.817629999999998</c:v>
                </c:pt>
                <c:pt idx="28">
                  <c:v>18.353495000000002</c:v>
                </c:pt>
                <c:pt idx="29">
                  <c:v>22.293520000000001</c:v>
                </c:pt>
                <c:pt idx="30">
                  <c:v>31.613970000000002</c:v>
                </c:pt>
                <c:pt idx="31">
                  <c:v>44.983935000000002</c:v>
                </c:pt>
                <c:pt idx="32">
                  <c:v>59.496260000000007</c:v>
                </c:pt>
                <c:pt idx="33">
                  <c:v>69.642814999999985</c:v>
                </c:pt>
                <c:pt idx="34">
                  <c:v>75.077100000000002</c:v>
                </c:pt>
                <c:pt idx="35">
                  <c:v>76.394814999999994</c:v>
                </c:pt>
                <c:pt idx="36">
                  <c:v>77.231549999999999</c:v>
                </c:pt>
                <c:pt idx="37">
                  <c:v>75.632900000000006</c:v>
                </c:pt>
                <c:pt idx="38">
                  <c:v>70.300394999999995</c:v>
                </c:pt>
                <c:pt idx="39">
                  <c:v>58.250594999999997</c:v>
                </c:pt>
                <c:pt idx="40">
                  <c:v>45.929885000000006</c:v>
                </c:pt>
                <c:pt idx="41">
                  <c:v>33.229539999999993</c:v>
                </c:pt>
                <c:pt idx="42">
                  <c:v>24.3414</c:v>
                </c:pt>
                <c:pt idx="43">
                  <c:v>19.316479999999999</c:v>
                </c:pt>
                <c:pt idx="44">
                  <c:v>16.136395</c:v>
                </c:pt>
                <c:pt idx="45">
                  <c:v>14.779125000000001</c:v>
                </c:pt>
                <c:pt idx="46">
                  <c:v>14.714460000000004</c:v>
                </c:pt>
                <c:pt idx="47">
                  <c:v>15.477064999999996</c:v>
                </c:pt>
                <c:pt idx="48">
                  <c:v>17.037229999999997</c:v>
                </c:pt>
                <c:pt idx="49">
                  <c:v>19.67558</c:v>
                </c:pt>
                <c:pt idx="50">
                  <c:v>23.373329999999999</c:v>
                </c:pt>
                <c:pt idx="51">
                  <c:v>27.914835000000004</c:v>
                </c:pt>
                <c:pt idx="52">
                  <c:v>34.435899999999997</c:v>
                </c:pt>
                <c:pt idx="53">
                  <c:v>43.211069999999999</c:v>
                </c:pt>
                <c:pt idx="54">
                  <c:v>53.274680000000004</c:v>
                </c:pt>
                <c:pt idx="55">
                  <c:v>59.798710000000007</c:v>
                </c:pt>
                <c:pt idx="56">
                  <c:v>56.028314999999992</c:v>
                </c:pt>
                <c:pt idx="57">
                  <c:v>47.205125000000002</c:v>
                </c:pt>
                <c:pt idx="58">
                  <c:v>37.459289999999996</c:v>
                </c:pt>
                <c:pt idx="59">
                  <c:v>28.749625000000002</c:v>
                </c:pt>
                <c:pt idx="60">
                  <c:v>22.408839999999998</c:v>
                </c:pt>
                <c:pt idx="61">
                  <c:v>18.295354999999997</c:v>
                </c:pt>
                <c:pt idx="62">
                  <c:v>16.021899999999999</c:v>
                </c:pt>
                <c:pt idx="63">
                  <c:v>15.184664999999997</c:v>
                </c:pt>
                <c:pt idx="64">
                  <c:v>15.033720000000001</c:v>
                </c:pt>
                <c:pt idx="65">
                  <c:v>15.0221</c:v>
                </c:pt>
                <c:pt idx="66">
                  <c:v>15.076499999999999</c:v>
                </c:pt>
                <c:pt idx="67">
                  <c:v>15.008979999999999</c:v>
                </c:pt>
                <c:pt idx="68">
                  <c:v>15.8788</c:v>
                </c:pt>
                <c:pt idx="69">
                  <c:v>18.075139999999998</c:v>
                </c:pt>
                <c:pt idx="70">
                  <c:v>22.327549999999999</c:v>
                </c:pt>
                <c:pt idx="71">
                  <c:v>28.51238</c:v>
                </c:pt>
                <c:pt idx="72">
                  <c:v>35.263294999999999</c:v>
                </c:pt>
                <c:pt idx="73">
                  <c:v>39.611639999999994</c:v>
                </c:pt>
                <c:pt idx="74">
                  <c:v>39.732905000000002</c:v>
                </c:pt>
                <c:pt idx="75">
                  <c:v>37.044195000000002</c:v>
                </c:pt>
                <c:pt idx="76">
                  <c:v>32.277160000000002</c:v>
                </c:pt>
                <c:pt idx="77">
                  <c:v>27.397495000000003</c:v>
                </c:pt>
                <c:pt idx="78">
                  <c:v>23.276174999999999</c:v>
                </c:pt>
                <c:pt idx="79">
                  <c:v>20.259839999999997</c:v>
                </c:pt>
                <c:pt idx="80">
                  <c:v>17.667389999999997</c:v>
                </c:pt>
                <c:pt idx="81">
                  <c:v>15.795010000000003</c:v>
                </c:pt>
                <c:pt idx="82">
                  <c:v>14.155764999999997</c:v>
                </c:pt>
                <c:pt idx="83">
                  <c:v>12.897349999999999</c:v>
                </c:pt>
                <c:pt idx="84">
                  <c:v>11.886760000000004</c:v>
                </c:pt>
                <c:pt idx="85">
                  <c:v>11.425395000000002</c:v>
                </c:pt>
                <c:pt idx="86">
                  <c:v>11.564160000000003</c:v>
                </c:pt>
                <c:pt idx="87">
                  <c:v>12.885475</c:v>
                </c:pt>
                <c:pt idx="88">
                  <c:v>15.318039999999996</c:v>
                </c:pt>
                <c:pt idx="89">
                  <c:v>18.520775</c:v>
                </c:pt>
                <c:pt idx="90">
                  <c:v>22.462360000000004</c:v>
                </c:pt>
                <c:pt idx="91">
                  <c:v>24.7653</c:v>
                </c:pt>
                <c:pt idx="92">
                  <c:v>25.951164999999996</c:v>
                </c:pt>
                <c:pt idx="93">
                  <c:v>25.713425000000001</c:v>
                </c:pt>
                <c:pt idx="94">
                  <c:v>25.369924999999999</c:v>
                </c:pt>
                <c:pt idx="95">
                  <c:v>24.188874999999999</c:v>
                </c:pt>
                <c:pt idx="96">
                  <c:v>22.806245000000001</c:v>
                </c:pt>
                <c:pt idx="97">
                  <c:v>20.820320000000002</c:v>
                </c:pt>
                <c:pt idx="98">
                  <c:v>18.013045000000002</c:v>
                </c:pt>
                <c:pt idx="99">
                  <c:v>15.687579999999999</c:v>
                </c:pt>
                <c:pt idx="100">
                  <c:v>13.880479999999999</c:v>
                </c:pt>
                <c:pt idx="101">
                  <c:v>12.465020000000001</c:v>
                </c:pt>
                <c:pt idx="102">
                  <c:v>11.652954999999999</c:v>
                </c:pt>
                <c:pt idx="103">
                  <c:v>11.303460000000003</c:v>
                </c:pt>
                <c:pt idx="104">
                  <c:v>11.476345000000002</c:v>
                </c:pt>
                <c:pt idx="105">
                  <c:v>12.222339999999997</c:v>
                </c:pt>
                <c:pt idx="106">
                  <c:v>13.562814999999997</c:v>
                </c:pt>
                <c:pt idx="107">
                  <c:v>15.600295000000001</c:v>
                </c:pt>
                <c:pt idx="108">
                  <c:v>17.929500000000001</c:v>
                </c:pt>
                <c:pt idx="109">
                  <c:v>20.069539999999996</c:v>
                </c:pt>
                <c:pt idx="110">
                  <c:v>21.565914999999997</c:v>
                </c:pt>
                <c:pt idx="111">
                  <c:v>22.019189999999998</c:v>
                </c:pt>
                <c:pt idx="112">
                  <c:v>21.839195</c:v>
                </c:pt>
                <c:pt idx="113">
                  <c:v>21.212860000000003</c:v>
                </c:pt>
                <c:pt idx="114">
                  <c:v>20.06427</c:v>
                </c:pt>
                <c:pt idx="115">
                  <c:v>15.375639999999997</c:v>
                </c:pt>
                <c:pt idx="116">
                  <c:v>13.184029999999998</c:v>
                </c:pt>
                <c:pt idx="117">
                  <c:v>11.303360000000003</c:v>
                </c:pt>
                <c:pt idx="118">
                  <c:v>9.5692200000000014</c:v>
                </c:pt>
                <c:pt idx="119">
                  <c:v>8.3366200000000017</c:v>
                </c:pt>
                <c:pt idx="120">
                  <c:v>7.4358049999999984</c:v>
                </c:pt>
                <c:pt idx="121">
                  <c:v>6.8821399999999961</c:v>
                </c:pt>
                <c:pt idx="122">
                  <c:v>6.7799100000000037</c:v>
                </c:pt>
                <c:pt idx="123">
                  <c:v>7.0416049999999988</c:v>
                </c:pt>
                <c:pt idx="124">
                  <c:v>7.6350450000000007</c:v>
                </c:pt>
                <c:pt idx="125">
                  <c:v>8.2645499999999998</c:v>
                </c:pt>
                <c:pt idx="126">
                  <c:v>8.8888200000000008</c:v>
                </c:pt>
                <c:pt idx="127">
                  <c:v>9.4278850000000034</c:v>
                </c:pt>
                <c:pt idx="128">
                  <c:v>10.145300000000001</c:v>
                </c:pt>
                <c:pt idx="129">
                  <c:v>11.1111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5B6-411A-8E22-C239854C0BDC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S$17:$CS$146</c:f>
              <c:numCache>
                <c:formatCode>0.00</c:formatCode>
                <c:ptCount val="130"/>
                <c:pt idx="0">
                  <c:v>28.889639999999996</c:v>
                </c:pt>
                <c:pt idx="1">
                  <c:v>28.635660000000005</c:v>
                </c:pt>
                <c:pt idx="2">
                  <c:v>21.726175000000001</c:v>
                </c:pt>
                <c:pt idx="3">
                  <c:v>19.112639999999995</c:v>
                </c:pt>
                <c:pt idx="4">
                  <c:v>16.999685000000003</c:v>
                </c:pt>
                <c:pt idx="5">
                  <c:v>15.2981</c:v>
                </c:pt>
                <c:pt idx="6">
                  <c:v>14.704364999999996</c:v>
                </c:pt>
                <c:pt idx="7">
                  <c:v>16.149825</c:v>
                </c:pt>
                <c:pt idx="8">
                  <c:v>20.764539999999997</c:v>
                </c:pt>
                <c:pt idx="9">
                  <c:v>31.719760000000004</c:v>
                </c:pt>
                <c:pt idx="10">
                  <c:v>52.456589999999991</c:v>
                </c:pt>
                <c:pt idx="11">
                  <c:v>78.204355000000007</c:v>
                </c:pt>
                <c:pt idx="12">
                  <c:v>109.10538999999999</c:v>
                </c:pt>
                <c:pt idx="13">
                  <c:v>137.29720499999999</c:v>
                </c:pt>
                <c:pt idx="14">
                  <c:v>154.90111000000002</c:v>
                </c:pt>
                <c:pt idx="15">
                  <c:v>155.458855</c:v>
                </c:pt>
                <c:pt idx="16">
                  <c:v>142.96106</c:v>
                </c:pt>
                <c:pt idx="17">
                  <c:v>126.61366000000001</c:v>
                </c:pt>
                <c:pt idx="18">
                  <c:v>97.510110000000012</c:v>
                </c:pt>
                <c:pt idx="19">
                  <c:v>69.893660000000011</c:v>
                </c:pt>
                <c:pt idx="20">
                  <c:v>51.505670000000002</c:v>
                </c:pt>
                <c:pt idx="21">
                  <c:v>39.269329999999997</c:v>
                </c:pt>
                <c:pt idx="22">
                  <c:v>31.197985000000003</c:v>
                </c:pt>
                <c:pt idx="23">
                  <c:v>26.818704999999998</c:v>
                </c:pt>
                <c:pt idx="24">
                  <c:v>23.832895000000001</c:v>
                </c:pt>
                <c:pt idx="25">
                  <c:v>21.681854999999999</c:v>
                </c:pt>
                <c:pt idx="26">
                  <c:v>19.795010000000005</c:v>
                </c:pt>
                <c:pt idx="27">
                  <c:v>18.988630000000001</c:v>
                </c:pt>
                <c:pt idx="28">
                  <c:v>20.247995</c:v>
                </c:pt>
                <c:pt idx="29">
                  <c:v>23.45092</c:v>
                </c:pt>
                <c:pt idx="30">
                  <c:v>30.219270000000002</c:v>
                </c:pt>
                <c:pt idx="31">
                  <c:v>40.543035000000003</c:v>
                </c:pt>
                <c:pt idx="32">
                  <c:v>51.750660000000003</c:v>
                </c:pt>
                <c:pt idx="33">
                  <c:v>63.231914999999994</c:v>
                </c:pt>
                <c:pt idx="34">
                  <c:v>74.891599999999997</c:v>
                </c:pt>
                <c:pt idx="35">
                  <c:v>85.767714999999995</c:v>
                </c:pt>
                <c:pt idx="36">
                  <c:v>90.292950000000005</c:v>
                </c:pt>
                <c:pt idx="37">
                  <c:v>83.957800000000006</c:v>
                </c:pt>
                <c:pt idx="38">
                  <c:v>70.718094999999991</c:v>
                </c:pt>
                <c:pt idx="39">
                  <c:v>54.823594999999997</c:v>
                </c:pt>
                <c:pt idx="40">
                  <c:v>41.124285</c:v>
                </c:pt>
                <c:pt idx="41">
                  <c:v>28.573039999999995</c:v>
                </c:pt>
                <c:pt idx="42">
                  <c:v>20.860600000000002</c:v>
                </c:pt>
                <c:pt idx="43">
                  <c:v>17.464079999999999</c:v>
                </c:pt>
                <c:pt idx="44">
                  <c:v>16.029795</c:v>
                </c:pt>
                <c:pt idx="45">
                  <c:v>15.691125</c:v>
                </c:pt>
                <c:pt idx="46">
                  <c:v>15.803460000000003</c:v>
                </c:pt>
                <c:pt idx="47">
                  <c:v>16.424364999999998</c:v>
                </c:pt>
                <c:pt idx="48">
                  <c:v>18.202729999999999</c:v>
                </c:pt>
                <c:pt idx="49">
                  <c:v>20.777079999999998</c:v>
                </c:pt>
                <c:pt idx="50">
                  <c:v>24.686329999999998</c:v>
                </c:pt>
                <c:pt idx="51">
                  <c:v>29.826135000000004</c:v>
                </c:pt>
                <c:pt idx="52">
                  <c:v>36.540599999999998</c:v>
                </c:pt>
                <c:pt idx="53">
                  <c:v>43.95637</c:v>
                </c:pt>
                <c:pt idx="54">
                  <c:v>51.026379999999996</c:v>
                </c:pt>
                <c:pt idx="55">
                  <c:v>54.808610000000009</c:v>
                </c:pt>
                <c:pt idx="56">
                  <c:v>52.391614999999994</c:v>
                </c:pt>
                <c:pt idx="57">
                  <c:v>45.527225000000001</c:v>
                </c:pt>
                <c:pt idx="58">
                  <c:v>37.591589999999997</c:v>
                </c:pt>
                <c:pt idx="59">
                  <c:v>30.400725000000001</c:v>
                </c:pt>
                <c:pt idx="60">
                  <c:v>24.630339999999997</c:v>
                </c:pt>
                <c:pt idx="61">
                  <c:v>20.691354999999998</c:v>
                </c:pt>
                <c:pt idx="62">
                  <c:v>18.2532</c:v>
                </c:pt>
                <c:pt idx="63">
                  <c:v>16.626164999999997</c:v>
                </c:pt>
                <c:pt idx="64">
                  <c:v>15.914720000000001</c:v>
                </c:pt>
                <c:pt idx="65">
                  <c:v>15.696199999999999</c:v>
                </c:pt>
                <c:pt idx="66">
                  <c:v>15.9459</c:v>
                </c:pt>
                <c:pt idx="67">
                  <c:v>16.26688</c:v>
                </c:pt>
                <c:pt idx="68">
                  <c:v>17.6403</c:v>
                </c:pt>
                <c:pt idx="69">
                  <c:v>20.230039999999995</c:v>
                </c:pt>
                <c:pt idx="70">
                  <c:v>24.517949999999999</c:v>
                </c:pt>
                <c:pt idx="71">
                  <c:v>29.964179999999999</c:v>
                </c:pt>
                <c:pt idx="72">
                  <c:v>35.571294999999999</c:v>
                </c:pt>
                <c:pt idx="73">
                  <c:v>41.060839999999999</c:v>
                </c:pt>
                <c:pt idx="74">
                  <c:v>43.021904999999997</c:v>
                </c:pt>
                <c:pt idx="75">
                  <c:v>41.091095000000003</c:v>
                </c:pt>
                <c:pt idx="76">
                  <c:v>36.855560000000004</c:v>
                </c:pt>
                <c:pt idx="77">
                  <c:v>31.080295</c:v>
                </c:pt>
                <c:pt idx="78">
                  <c:v>25.514575000000001</c:v>
                </c:pt>
                <c:pt idx="79">
                  <c:v>21.214039999999997</c:v>
                </c:pt>
                <c:pt idx="80">
                  <c:v>17.776289999999996</c:v>
                </c:pt>
                <c:pt idx="81">
                  <c:v>15.464810000000003</c:v>
                </c:pt>
                <c:pt idx="82">
                  <c:v>14.048164999999997</c:v>
                </c:pt>
                <c:pt idx="83">
                  <c:v>13.139150000000001</c:v>
                </c:pt>
                <c:pt idx="84">
                  <c:v>12.554660000000004</c:v>
                </c:pt>
                <c:pt idx="85">
                  <c:v>12.388295000000001</c:v>
                </c:pt>
                <c:pt idx="86">
                  <c:v>12.675960000000003</c:v>
                </c:pt>
                <c:pt idx="87">
                  <c:v>13.582775</c:v>
                </c:pt>
                <c:pt idx="88">
                  <c:v>15.567739999999997</c:v>
                </c:pt>
                <c:pt idx="89">
                  <c:v>18.174275000000002</c:v>
                </c:pt>
                <c:pt idx="90">
                  <c:v>21.664860000000004</c:v>
                </c:pt>
                <c:pt idx="91">
                  <c:v>24.378</c:v>
                </c:pt>
                <c:pt idx="92">
                  <c:v>27.123764999999995</c:v>
                </c:pt>
                <c:pt idx="93">
                  <c:v>28.357225</c:v>
                </c:pt>
                <c:pt idx="94">
                  <c:v>28.134924999999999</c:v>
                </c:pt>
                <c:pt idx="95">
                  <c:v>25.947675</c:v>
                </c:pt>
                <c:pt idx="96">
                  <c:v>22.833545000000001</c:v>
                </c:pt>
                <c:pt idx="97">
                  <c:v>19.686820000000001</c:v>
                </c:pt>
                <c:pt idx="98">
                  <c:v>17.028345000000002</c:v>
                </c:pt>
                <c:pt idx="99">
                  <c:v>15.148879999999998</c:v>
                </c:pt>
                <c:pt idx="100">
                  <c:v>13.772779999999999</c:v>
                </c:pt>
                <c:pt idx="101">
                  <c:v>13.019020000000001</c:v>
                </c:pt>
                <c:pt idx="102">
                  <c:v>12.596754999999998</c:v>
                </c:pt>
                <c:pt idx="103">
                  <c:v>12.611560000000004</c:v>
                </c:pt>
                <c:pt idx="104">
                  <c:v>12.871445000000001</c:v>
                </c:pt>
                <c:pt idx="105">
                  <c:v>13.671039999999996</c:v>
                </c:pt>
                <c:pt idx="106">
                  <c:v>14.882614999999996</c:v>
                </c:pt>
                <c:pt idx="107">
                  <c:v>16.585395000000002</c:v>
                </c:pt>
                <c:pt idx="108">
                  <c:v>18.8142</c:v>
                </c:pt>
                <c:pt idx="109">
                  <c:v>20.927239999999998</c:v>
                </c:pt>
                <c:pt idx="110">
                  <c:v>22.462314999999997</c:v>
                </c:pt>
                <c:pt idx="111">
                  <c:v>23.108989999999995</c:v>
                </c:pt>
                <c:pt idx="112">
                  <c:v>23.062495000000002</c:v>
                </c:pt>
                <c:pt idx="113">
                  <c:v>21.922060000000002</c:v>
                </c:pt>
                <c:pt idx="114">
                  <c:v>20.056170000000002</c:v>
                </c:pt>
                <c:pt idx="115">
                  <c:v>14.809939999999996</c:v>
                </c:pt>
                <c:pt idx="116">
                  <c:v>12.627329999999999</c:v>
                </c:pt>
                <c:pt idx="117">
                  <c:v>10.947060000000004</c:v>
                </c:pt>
                <c:pt idx="118">
                  <c:v>9.346820000000001</c:v>
                </c:pt>
                <c:pt idx="119">
                  <c:v>8.3855200000000014</c:v>
                </c:pt>
                <c:pt idx="120">
                  <c:v>7.8486049999999992</c:v>
                </c:pt>
                <c:pt idx="121">
                  <c:v>7.3779399999999962</c:v>
                </c:pt>
                <c:pt idx="122">
                  <c:v>7.2628100000000035</c:v>
                </c:pt>
                <c:pt idx="123">
                  <c:v>7.4990049999999986</c:v>
                </c:pt>
                <c:pt idx="124">
                  <c:v>8.1335450000000016</c:v>
                </c:pt>
                <c:pt idx="125">
                  <c:v>8.7222500000000007</c:v>
                </c:pt>
                <c:pt idx="126">
                  <c:v>9.6672200000000004</c:v>
                </c:pt>
                <c:pt idx="127">
                  <c:v>10.654985000000003</c:v>
                </c:pt>
                <c:pt idx="128">
                  <c:v>11.8203</c:v>
                </c:pt>
                <c:pt idx="129">
                  <c:v>12.7192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5B6-411A-8E22-C239854C0BDC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T$17:$CT$146</c:f>
              <c:numCache>
                <c:formatCode>0.00</c:formatCode>
                <c:ptCount val="130"/>
                <c:pt idx="0">
                  <c:v>40.174439999999997</c:v>
                </c:pt>
                <c:pt idx="1">
                  <c:v>40.788760000000003</c:v>
                </c:pt>
                <c:pt idx="2">
                  <c:v>28.869375000000002</c:v>
                </c:pt>
                <c:pt idx="3">
                  <c:v>23.926139999999997</c:v>
                </c:pt>
                <c:pt idx="4">
                  <c:v>20.713685000000005</c:v>
                </c:pt>
                <c:pt idx="5">
                  <c:v>18.7254</c:v>
                </c:pt>
                <c:pt idx="6">
                  <c:v>18.192464999999995</c:v>
                </c:pt>
                <c:pt idx="7">
                  <c:v>21.281725000000002</c:v>
                </c:pt>
                <c:pt idx="8">
                  <c:v>30.726039999999998</c:v>
                </c:pt>
                <c:pt idx="9">
                  <c:v>46.363860000000003</c:v>
                </c:pt>
                <c:pt idx="10">
                  <c:v>69.045389999999998</c:v>
                </c:pt>
                <c:pt idx="11">
                  <c:v>98.974855000000005</c:v>
                </c:pt>
                <c:pt idx="12">
                  <c:v>122.01778999999999</c:v>
                </c:pt>
                <c:pt idx="13">
                  <c:v>136.646705</c:v>
                </c:pt>
                <c:pt idx="14">
                  <c:v>144.13401000000002</c:v>
                </c:pt>
                <c:pt idx="15">
                  <c:v>145.28115500000001</c:v>
                </c:pt>
                <c:pt idx="16">
                  <c:v>134.58826000000002</c:v>
                </c:pt>
                <c:pt idx="17">
                  <c:v>118.83956000000001</c:v>
                </c:pt>
                <c:pt idx="18">
                  <c:v>89.219310000000007</c:v>
                </c:pt>
                <c:pt idx="19">
                  <c:v>64.234960000000015</c:v>
                </c:pt>
                <c:pt idx="20">
                  <c:v>47.808970000000002</c:v>
                </c:pt>
                <c:pt idx="21">
                  <c:v>36.786830000000002</c:v>
                </c:pt>
                <c:pt idx="22">
                  <c:v>30.541185000000002</c:v>
                </c:pt>
                <c:pt idx="23">
                  <c:v>27.721605</c:v>
                </c:pt>
                <c:pt idx="24">
                  <c:v>26.443695000000002</c:v>
                </c:pt>
                <c:pt idx="25">
                  <c:v>26.633654999999997</c:v>
                </c:pt>
                <c:pt idx="26">
                  <c:v>26.633010000000002</c:v>
                </c:pt>
                <c:pt idx="27">
                  <c:v>26.908629999999999</c:v>
                </c:pt>
                <c:pt idx="28">
                  <c:v>28.578795</c:v>
                </c:pt>
                <c:pt idx="29">
                  <c:v>32.648319999999998</c:v>
                </c:pt>
                <c:pt idx="30">
                  <c:v>39.80397</c:v>
                </c:pt>
                <c:pt idx="31">
                  <c:v>50.560635000000005</c:v>
                </c:pt>
                <c:pt idx="32">
                  <c:v>64.955060000000003</c:v>
                </c:pt>
                <c:pt idx="33">
                  <c:v>82.183914999999985</c:v>
                </c:pt>
                <c:pt idx="34">
                  <c:v>97.484399999999994</c:v>
                </c:pt>
                <c:pt idx="35">
                  <c:v>101.306715</c:v>
                </c:pt>
                <c:pt idx="36">
                  <c:v>95.232950000000002</c:v>
                </c:pt>
                <c:pt idx="37">
                  <c:v>82.649699999999996</c:v>
                </c:pt>
                <c:pt idx="38">
                  <c:v>67.340795</c:v>
                </c:pt>
                <c:pt idx="39">
                  <c:v>52.910394999999994</c:v>
                </c:pt>
                <c:pt idx="40">
                  <c:v>42.336885000000002</c:v>
                </c:pt>
                <c:pt idx="41">
                  <c:v>33.986439999999995</c:v>
                </c:pt>
                <c:pt idx="42">
                  <c:v>29.0337</c:v>
                </c:pt>
                <c:pt idx="43">
                  <c:v>26.450679999999998</c:v>
                </c:pt>
                <c:pt idx="44">
                  <c:v>24.777195000000003</c:v>
                </c:pt>
                <c:pt idx="45">
                  <c:v>23.440725</c:v>
                </c:pt>
                <c:pt idx="46">
                  <c:v>22.728160000000003</c:v>
                </c:pt>
                <c:pt idx="47">
                  <c:v>22.876964999999995</c:v>
                </c:pt>
                <c:pt idx="48">
                  <c:v>24.486729999999998</c:v>
                </c:pt>
                <c:pt idx="49">
                  <c:v>28.55988</c:v>
                </c:pt>
                <c:pt idx="50">
                  <c:v>35.143129999999999</c:v>
                </c:pt>
                <c:pt idx="51">
                  <c:v>43.525835000000001</c:v>
                </c:pt>
                <c:pt idx="52">
                  <c:v>51.775500000000001</c:v>
                </c:pt>
                <c:pt idx="53">
                  <c:v>58.913769999999992</c:v>
                </c:pt>
                <c:pt idx="54">
                  <c:v>63.304380000000002</c:v>
                </c:pt>
                <c:pt idx="55">
                  <c:v>64.131810000000016</c:v>
                </c:pt>
                <c:pt idx="56">
                  <c:v>60.224214999999994</c:v>
                </c:pt>
                <c:pt idx="57">
                  <c:v>52.240025000000003</c:v>
                </c:pt>
                <c:pt idx="58">
                  <c:v>42.833189999999995</c:v>
                </c:pt>
                <c:pt idx="59">
                  <c:v>34.744325000000003</c:v>
                </c:pt>
                <c:pt idx="60">
                  <c:v>28.575939999999996</c:v>
                </c:pt>
                <c:pt idx="61">
                  <c:v>24.479054999999999</c:v>
                </c:pt>
                <c:pt idx="62">
                  <c:v>21.491099999999999</c:v>
                </c:pt>
                <c:pt idx="63">
                  <c:v>19.727364999999995</c:v>
                </c:pt>
                <c:pt idx="64">
                  <c:v>18.648020000000002</c:v>
                </c:pt>
                <c:pt idx="65">
                  <c:v>18.529800000000002</c:v>
                </c:pt>
                <c:pt idx="66">
                  <c:v>19.261099999999999</c:v>
                </c:pt>
                <c:pt idx="67">
                  <c:v>20.412979999999997</c:v>
                </c:pt>
                <c:pt idx="68">
                  <c:v>22.928699999999999</c:v>
                </c:pt>
                <c:pt idx="69">
                  <c:v>26.682739999999995</c:v>
                </c:pt>
                <c:pt idx="70">
                  <c:v>31.290949999999999</c:v>
                </c:pt>
                <c:pt idx="71">
                  <c:v>36.232680000000002</c:v>
                </c:pt>
                <c:pt idx="72">
                  <c:v>40.736094999999999</c:v>
                </c:pt>
                <c:pt idx="73">
                  <c:v>44.764539999999997</c:v>
                </c:pt>
                <c:pt idx="74">
                  <c:v>45.825804999999995</c:v>
                </c:pt>
                <c:pt idx="75">
                  <c:v>43.548994999999998</c:v>
                </c:pt>
                <c:pt idx="76">
                  <c:v>38.706660000000007</c:v>
                </c:pt>
                <c:pt idx="77">
                  <c:v>32.906095000000001</c:v>
                </c:pt>
                <c:pt idx="78">
                  <c:v>28.645375000000001</c:v>
                </c:pt>
                <c:pt idx="79">
                  <c:v>23.609639999999995</c:v>
                </c:pt>
                <c:pt idx="80">
                  <c:v>20.600389999999997</c:v>
                </c:pt>
                <c:pt idx="81">
                  <c:v>18.651010000000003</c:v>
                </c:pt>
                <c:pt idx="82">
                  <c:v>17.535064999999996</c:v>
                </c:pt>
                <c:pt idx="83">
                  <c:v>16.768450000000001</c:v>
                </c:pt>
                <c:pt idx="84">
                  <c:v>16.395760000000003</c:v>
                </c:pt>
                <c:pt idx="85">
                  <c:v>16.592195</c:v>
                </c:pt>
                <c:pt idx="86">
                  <c:v>17.417160000000003</c:v>
                </c:pt>
                <c:pt idx="87">
                  <c:v>19.191875</c:v>
                </c:pt>
                <c:pt idx="88">
                  <c:v>22.010339999999996</c:v>
                </c:pt>
                <c:pt idx="89">
                  <c:v>25.619675000000001</c:v>
                </c:pt>
                <c:pt idx="90">
                  <c:v>29.503560000000004</c:v>
                </c:pt>
                <c:pt idx="91">
                  <c:v>32.011699999999998</c:v>
                </c:pt>
                <c:pt idx="92">
                  <c:v>33.630764999999997</c:v>
                </c:pt>
                <c:pt idx="93">
                  <c:v>33.552225</c:v>
                </c:pt>
                <c:pt idx="94">
                  <c:v>32.149225000000001</c:v>
                </c:pt>
                <c:pt idx="95">
                  <c:v>29.125675000000001</c:v>
                </c:pt>
                <c:pt idx="96">
                  <c:v>25.847645</c:v>
                </c:pt>
                <c:pt idx="97">
                  <c:v>22.85022</c:v>
                </c:pt>
                <c:pt idx="98">
                  <c:v>20.222045000000001</c:v>
                </c:pt>
                <c:pt idx="99">
                  <c:v>18.115579999999998</c:v>
                </c:pt>
                <c:pt idx="100">
                  <c:v>16.646079999999998</c:v>
                </c:pt>
                <c:pt idx="101">
                  <c:v>15.473220000000001</c:v>
                </c:pt>
                <c:pt idx="102">
                  <c:v>14.547154999999998</c:v>
                </c:pt>
                <c:pt idx="103">
                  <c:v>13.818760000000003</c:v>
                </c:pt>
                <c:pt idx="104">
                  <c:v>13.547045000000001</c:v>
                </c:pt>
                <c:pt idx="105">
                  <c:v>14.008339999999997</c:v>
                </c:pt>
                <c:pt idx="106">
                  <c:v>15.218014999999996</c:v>
                </c:pt>
                <c:pt idx="107">
                  <c:v>17.004795000000001</c:v>
                </c:pt>
                <c:pt idx="108">
                  <c:v>19.232099999999999</c:v>
                </c:pt>
                <c:pt idx="109">
                  <c:v>21.270639999999997</c:v>
                </c:pt>
                <c:pt idx="110">
                  <c:v>22.863414999999996</c:v>
                </c:pt>
                <c:pt idx="111">
                  <c:v>23.169089999999997</c:v>
                </c:pt>
                <c:pt idx="112">
                  <c:v>22.860095000000001</c:v>
                </c:pt>
                <c:pt idx="113">
                  <c:v>21.630060000000004</c:v>
                </c:pt>
                <c:pt idx="114">
                  <c:v>19.83867</c:v>
                </c:pt>
                <c:pt idx="115">
                  <c:v>15.594939999999996</c:v>
                </c:pt>
                <c:pt idx="116">
                  <c:v>13.838329999999999</c:v>
                </c:pt>
                <c:pt idx="117">
                  <c:v>12.317360000000004</c:v>
                </c:pt>
                <c:pt idx="118">
                  <c:v>10.970420000000001</c:v>
                </c:pt>
                <c:pt idx="119">
                  <c:v>10.183420000000002</c:v>
                </c:pt>
                <c:pt idx="120">
                  <c:v>9.5764049999999994</c:v>
                </c:pt>
                <c:pt idx="121">
                  <c:v>9.1774399999999972</c:v>
                </c:pt>
                <c:pt idx="122">
                  <c:v>9.0049100000000042</c:v>
                </c:pt>
                <c:pt idx="123">
                  <c:v>9.1720049999999986</c:v>
                </c:pt>
                <c:pt idx="124">
                  <c:v>9.7615450000000017</c:v>
                </c:pt>
                <c:pt idx="125">
                  <c:v>10.83785</c:v>
                </c:pt>
                <c:pt idx="126">
                  <c:v>11.980720000000002</c:v>
                </c:pt>
                <c:pt idx="127">
                  <c:v>13.092985000000004</c:v>
                </c:pt>
                <c:pt idx="128">
                  <c:v>14.2348</c:v>
                </c:pt>
                <c:pt idx="129">
                  <c:v>14.8986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5B6-411A-8E22-C239854C0B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7015296"/>
        <c:axId val="77037568"/>
      </c:lineChart>
      <c:catAx>
        <c:axId val="77015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7037568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77037568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770152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R$17:$CR$146</c:f>
              <c:numCache>
                <c:formatCode>0.00</c:formatCode>
                <c:ptCount val="130"/>
                <c:pt idx="0">
                  <c:v>20.031089999999995</c:v>
                </c:pt>
                <c:pt idx="1">
                  <c:v>22.496489999999998</c:v>
                </c:pt>
                <c:pt idx="2">
                  <c:v>21.264354999999998</c:v>
                </c:pt>
                <c:pt idx="3">
                  <c:v>20.118910000000003</c:v>
                </c:pt>
                <c:pt idx="4">
                  <c:v>18.758904999999999</c:v>
                </c:pt>
                <c:pt idx="5">
                  <c:v>17.167870000000001</c:v>
                </c:pt>
                <c:pt idx="6">
                  <c:v>15.851295</c:v>
                </c:pt>
                <c:pt idx="7">
                  <c:v>15.646164999999996</c:v>
                </c:pt>
                <c:pt idx="8">
                  <c:v>16.106585000000003</c:v>
                </c:pt>
                <c:pt idx="9">
                  <c:v>17.713279999999997</c:v>
                </c:pt>
                <c:pt idx="10">
                  <c:v>20.057604999999999</c:v>
                </c:pt>
                <c:pt idx="11">
                  <c:v>23.503550000000001</c:v>
                </c:pt>
                <c:pt idx="12">
                  <c:v>32.03633</c:v>
                </c:pt>
                <c:pt idx="13">
                  <c:v>46.923220000000001</c:v>
                </c:pt>
                <c:pt idx="14">
                  <c:v>69.193439999999995</c:v>
                </c:pt>
                <c:pt idx="15">
                  <c:v>98.026139999999984</c:v>
                </c:pt>
                <c:pt idx="16">
                  <c:v>124.98097</c:v>
                </c:pt>
                <c:pt idx="17">
                  <c:v>138.673135</c:v>
                </c:pt>
                <c:pt idx="18">
                  <c:v>131.79934499999999</c:v>
                </c:pt>
                <c:pt idx="19">
                  <c:v>108.12211499999999</c:v>
                </c:pt>
                <c:pt idx="20">
                  <c:v>88.207005000000009</c:v>
                </c:pt>
                <c:pt idx="21">
                  <c:v>76.853085000000007</c:v>
                </c:pt>
                <c:pt idx="22">
                  <c:v>73.302185000000009</c:v>
                </c:pt>
                <c:pt idx="23">
                  <c:v>71.981464999999986</c:v>
                </c:pt>
                <c:pt idx="24">
                  <c:v>68.512524999999997</c:v>
                </c:pt>
                <c:pt idx="25">
                  <c:v>64.15373000000001</c:v>
                </c:pt>
                <c:pt idx="26">
                  <c:v>57.349380000000004</c:v>
                </c:pt>
                <c:pt idx="27">
                  <c:v>49.299539999999993</c:v>
                </c:pt>
                <c:pt idx="28">
                  <c:v>41.548204999999996</c:v>
                </c:pt>
                <c:pt idx="29">
                  <c:v>34.66789</c:v>
                </c:pt>
                <c:pt idx="30">
                  <c:v>30.154914999999995</c:v>
                </c:pt>
                <c:pt idx="31">
                  <c:v>28.817789999999995</c:v>
                </c:pt>
                <c:pt idx="32">
                  <c:v>30.512025000000001</c:v>
                </c:pt>
                <c:pt idx="33">
                  <c:v>36.712629999999997</c:v>
                </c:pt>
                <c:pt idx="34">
                  <c:v>44.520800000000001</c:v>
                </c:pt>
                <c:pt idx="35">
                  <c:v>58.804699999999997</c:v>
                </c:pt>
                <c:pt idx="36">
                  <c:v>75.354385000000008</c:v>
                </c:pt>
                <c:pt idx="37">
                  <c:v>89.091844999999992</c:v>
                </c:pt>
                <c:pt idx="38">
                  <c:v>97.05843999999999</c:v>
                </c:pt>
                <c:pt idx="39">
                  <c:v>95.023010000000014</c:v>
                </c:pt>
                <c:pt idx="40">
                  <c:v>85.864639999999994</c:v>
                </c:pt>
                <c:pt idx="41">
                  <c:v>73.618864999999985</c:v>
                </c:pt>
                <c:pt idx="42">
                  <c:v>59.210355000000007</c:v>
                </c:pt>
                <c:pt idx="43">
                  <c:v>46.953914999999995</c:v>
                </c:pt>
                <c:pt idx="44">
                  <c:v>40.137180000000001</c:v>
                </c:pt>
                <c:pt idx="45">
                  <c:v>36.993810000000003</c:v>
                </c:pt>
                <c:pt idx="46">
                  <c:v>35.32526</c:v>
                </c:pt>
                <c:pt idx="47">
                  <c:v>34.086785000000006</c:v>
                </c:pt>
                <c:pt idx="48">
                  <c:v>31.437954999999999</c:v>
                </c:pt>
                <c:pt idx="49">
                  <c:v>28.515149999999998</c:v>
                </c:pt>
                <c:pt idx="50">
                  <c:v>25.786085000000003</c:v>
                </c:pt>
                <c:pt idx="51">
                  <c:v>23.669325000000001</c:v>
                </c:pt>
                <c:pt idx="52">
                  <c:v>22.300350000000002</c:v>
                </c:pt>
                <c:pt idx="53">
                  <c:v>22.247185000000002</c:v>
                </c:pt>
                <c:pt idx="54">
                  <c:v>23.540145000000003</c:v>
                </c:pt>
                <c:pt idx="55">
                  <c:v>26.13542</c:v>
                </c:pt>
                <c:pt idx="56">
                  <c:v>29.743114999999996</c:v>
                </c:pt>
                <c:pt idx="57">
                  <c:v>34.850135000000002</c:v>
                </c:pt>
                <c:pt idx="58">
                  <c:v>39.548074999999997</c:v>
                </c:pt>
                <c:pt idx="59">
                  <c:v>43.301614999999998</c:v>
                </c:pt>
                <c:pt idx="60">
                  <c:v>45.286175</c:v>
                </c:pt>
                <c:pt idx="61">
                  <c:v>44.922839999999994</c:v>
                </c:pt>
                <c:pt idx="62">
                  <c:v>42.231780000000001</c:v>
                </c:pt>
                <c:pt idx="63">
                  <c:v>38.241720000000001</c:v>
                </c:pt>
                <c:pt idx="64">
                  <c:v>33.623535000000004</c:v>
                </c:pt>
                <c:pt idx="65">
                  <c:v>28.550055</c:v>
                </c:pt>
                <c:pt idx="66">
                  <c:v>23.485514999999996</c:v>
                </c:pt>
                <c:pt idx="67">
                  <c:v>19.88458</c:v>
                </c:pt>
                <c:pt idx="68">
                  <c:v>17.642575000000001</c:v>
                </c:pt>
                <c:pt idx="69">
                  <c:v>16.533520000000003</c:v>
                </c:pt>
                <c:pt idx="70">
                  <c:v>15.812145000000001</c:v>
                </c:pt>
                <c:pt idx="71">
                  <c:v>15.449660000000003</c:v>
                </c:pt>
                <c:pt idx="72">
                  <c:v>15.580020000000001</c:v>
                </c:pt>
                <c:pt idx="73">
                  <c:v>16.168955</c:v>
                </c:pt>
                <c:pt idx="74">
                  <c:v>17.543029999999998</c:v>
                </c:pt>
                <c:pt idx="75">
                  <c:v>19.650220000000001</c:v>
                </c:pt>
                <c:pt idx="76">
                  <c:v>21.991214999999997</c:v>
                </c:pt>
                <c:pt idx="77">
                  <c:v>24.160320000000002</c:v>
                </c:pt>
                <c:pt idx="78">
                  <c:v>26.046789999999998</c:v>
                </c:pt>
                <c:pt idx="79">
                  <c:v>27.877424999999999</c:v>
                </c:pt>
                <c:pt idx="80">
                  <c:v>32.041705</c:v>
                </c:pt>
                <c:pt idx="81">
                  <c:v>29.953245000000003</c:v>
                </c:pt>
                <c:pt idx="82">
                  <c:v>29.426895000000002</c:v>
                </c:pt>
                <c:pt idx="83">
                  <c:v>27.80387</c:v>
                </c:pt>
                <c:pt idx="84">
                  <c:v>25.505870000000002</c:v>
                </c:pt>
                <c:pt idx="85">
                  <c:v>23.081539999999997</c:v>
                </c:pt>
                <c:pt idx="86">
                  <c:v>20.514060000000004</c:v>
                </c:pt>
                <c:pt idx="87">
                  <c:v>17.8279</c:v>
                </c:pt>
                <c:pt idx="88">
                  <c:v>15.2286</c:v>
                </c:pt>
                <c:pt idx="89">
                  <c:v>12.944364999999996</c:v>
                </c:pt>
                <c:pt idx="90">
                  <c:v>11.269510000000004</c:v>
                </c:pt>
                <c:pt idx="91">
                  <c:v>10.44708</c:v>
                </c:pt>
                <c:pt idx="92">
                  <c:v>10.139985000000003</c:v>
                </c:pt>
                <c:pt idx="93">
                  <c:v>10.614235000000004</c:v>
                </c:pt>
                <c:pt idx="94">
                  <c:v>11.683795000000002</c:v>
                </c:pt>
                <c:pt idx="95">
                  <c:v>13.621954999999998</c:v>
                </c:pt>
                <c:pt idx="96">
                  <c:v>16.328364999999998</c:v>
                </c:pt>
                <c:pt idx="97">
                  <c:v>19.060735000000005</c:v>
                </c:pt>
                <c:pt idx="98">
                  <c:v>21.540879999999998</c:v>
                </c:pt>
                <c:pt idx="99">
                  <c:v>23.004770000000001</c:v>
                </c:pt>
                <c:pt idx="100">
                  <c:v>23.9329</c:v>
                </c:pt>
                <c:pt idx="101">
                  <c:v>23.899860000000004</c:v>
                </c:pt>
                <c:pt idx="102">
                  <c:v>23.118489999999998</c:v>
                </c:pt>
                <c:pt idx="103">
                  <c:v>21.722429999999999</c:v>
                </c:pt>
                <c:pt idx="104">
                  <c:v>20.200524999999999</c:v>
                </c:pt>
                <c:pt idx="105">
                  <c:v>18.330939999999998</c:v>
                </c:pt>
                <c:pt idx="106">
                  <c:v>16.637705</c:v>
                </c:pt>
                <c:pt idx="107">
                  <c:v>15.112170000000001</c:v>
                </c:pt>
                <c:pt idx="108">
                  <c:v>13.625210000000003</c:v>
                </c:pt>
                <c:pt idx="109">
                  <c:v>12.604739999999996</c:v>
                </c:pt>
                <c:pt idx="110">
                  <c:v>11.507285000000003</c:v>
                </c:pt>
                <c:pt idx="111">
                  <c:v>10.680845000000001</c:v>
                </c:pt>
                <c:pt idx="112">
                  <c:v>9.9169649999999958</c:v>
                </c:pt>
                <c:pt idx="113">
                  <c:v>9.4171049999999994</c:v>
                </c:pt>
                <c:pt idx="114">
                  <c:v>9.4315649999999973</c:v>
                </c:pt>
                <c:pt idx="115">
                  <c:v>9.7522149999999961</c:v>
                </c:pt>
                <c:pt idx="116">
                  <c:v>10.5785</c:v>
                </c:pt>
                <c:pt idx="117">
                  <c:v>11.860660000000003</c:v>
                </c:pt>
                <c:pt idx="118">
                  <c:v>13.66107</c:v>
                </c:pt>
                <c:pt idx="119">
                  <c:v>15.81255</c:v>
                </c:pt>
                <c:pt idx="120">
                  <c:v>17.455024999999999</c:v>
                </c:pt>
                <c:pt idx="121">
                  <c:v>18.542239999999996</c:v>
                </c:pt>
                <c:pt idx="122">
                  <c:v>18.52317</c:v>
                </c:pt>
                <c:pt idx="123">
                  <c:v>17.627050000000001</c:v>
                </c:pt>
                <c:pt idx="124">
                  <c:v>14.481760000000003</c:v>
                </c:pt>
                <c:pt idx="125">
                  <c:v>14.7346</c:v>
                </c:pt>
                <c:pt idx="126">
                  <c:v>12.96613</c:v>
                </c:pt>
                <c:pt idx="127">
                  <c:v>11.65715</c:v>
                </c:pt>
                <c:pt idx="128">
                  <c:v>10.440925</c:v>
                </c:pt>
                <c:pt idx="129">
                  <c:v>9.41453500000000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914-4730-818C-2CA628D2D1D6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S$17:$CS$146</c:f>
              <c:numCache>
                <c:formatCode>0.00</c:formatCode>
                <c:ptCount val="130"/>
                <c:pt idx="0">
                  <c:v>20.686789999999995</c:v>
                </c:pt>
                <c:pt idx="1">
                  <c:v>22.303789999999996</c:v>
                </c:pt>
                <c:pt idx="2">
                  <c:v>20.077254999999997</c:v>
                </c:pt>
                <c:pt idx="3">
                  <c:v>18.335610000000003</c:v>
                </c:pt>
                <c:pt idx="4">
                  <c:v>16.996704999999999</c:v>
                </c:pt>
                <c:pt idx="5">
                  <c:v>16.16337</c:v>
                </c:pt>
                <c:pt idx="6">
                  <c:v>15.695895000000002</c:v>
                </c:pt>
                <c:pt idx="7">
                  <c:v>15.876964999999997</c:v>
                </c:pt>
                <c:pt idx="8">
                  <c:v>16.714285000000004</c:v>
                </c:pt>
                <c:pt idx="9">
                  <c:v>18.601379999999999</c:v>
                </c:pt>
                <c:pt idx="10">
                  <c:v>23.059404999999998</c:v>
                </c:pt>
                <c:pt idx="11">
                  <c:v>32.812449999999998</c:v>
                </c:pt>
                <c:pt idx="12">
                  <c:v>49.041530000000002</c:v>
                </c:pt>
                <c:pt idx="13">
                  <c:v>71.636919999999989</c:v>
                </c:pt>
                <c:pt idx="14">
                  <c:v>99.368139999999997</c:v>
                </c:pt>
                <c:pt idx="15">
                  <c:v>126.70934</c:v>
                </c:pt>
                <c:pt idx="16">
                  <c:v>145.43136999999999</c:v>
                </c:pt>
                <c:pt idx="17">
                  <c:v>149.67713500000002</c:v>
                </c:pt>
                <c:pt idx="18">
                  <c:v>141.073745</c:v>
                </c:pt>
                <c:pt idx="19">
                  <c:v>124.75751499999998</c:v>
                </c:pt>
                <c:pt idx="20">
                  <c:v>108.915605</c:v>
                </c:pt>
                <c:pt idx="21">
                  <c:v>96.896985000000015</c:v>
                </c:pt>
                <c:pt idx="22">
                  <c:v>88.975485000000006</c:v>
                </c:pt>
                <c:pt idx="23">
                  <c:v>83.183064999999985</c:v>
                </c:pt>
                <c:pt idx="24">
                  <c:v>76.622425000000007</c:v>
                </c:pt>
                <c:pt idx="25">
                  <c:v>68.520330000000001</c:v>
                </c:pt>
                <c:pt idx="26">
                  <c:v>59.667980000000007</c:v>
                </c:pt>
                <c:pt idx="27">
                  <c:v>51.030939999999994</c:v>
                </c:pt>
                <c:pt idx="28">
                  <c:v>43.297404999999998</c:v>
                </c:pt>
                <c:pt idx="29">
                  <c:v>37.831889999999994</c:v>
                </c:pt>
                <c:pt idx="30">
                  <c:v>36.223115</c:v>
                </c:pt>
                <c:pt idx="31">
                  <c:v>38.488689999999998</c:v>
                </c:pt>
                <c:pt idx="32">
                  <c:v>43.870024999999998</c:v>
                </c:pt>
                <c:pt idx="33">
                  <c:v>51.856830000000002</c:v>
                </c:pt>
                <c:pt idx="34">
                  <c:v>61.472000000000001</c:v>
                </c:pt>
                <c:pt idx="35">
                  <c:v>73.614999999999995</c:v>
                </c:pt>
                <c:pt idx="36">
                  <c:v>87.406585000000007</c:v>
                </c:pt>
                <c:pt idx="37">
                  <c:v>99.056444999999997</c:v>
                </c:pt>
                <c:pt idx="38">
                  <c:v>104.58013999999999</c:v>
                </c:pt>
                <c:pt idx="39">
                  <c:v>103.10501000000001</c:v>
                </c:pt>
                <c:pt idx="40">
                  <c:v>93.500139999999988</c:v>
                </c:pt>
                <c:pt idx="41">
                  <c:v>81.114964999999984</c:v>
                </c:pt>
                <c:pt idx="42">
                  <c:v>66.42535500000001</c:v>
                </c:pt>
                <c:pt idx="43">
                  <c:v>53.246414999999992</c:v>
                </c:pt>
                <c:pt idx="44">
                  <c:v>44.371079999999999</c:v>
                </c:pt>
                <c:pt idx="45">
                  <c:v>38.548210000000005</c:v>
                </c:pt>
                <c:pt idx="46">
                  <c:v>34.988960000000006</c:v>
                </c:pt>
                <c:pt idx="47">
                  <c:v>32.247685000000004</c:v>
                </c:pt>
                <c:pt idx="48">
                  <c:v>30.208955</c:v>
                </c:pt>
                <c:pt idx="49">
                  <c:v>28.315850000000001</c:v>
                </c:pt>
                <c:pt idx="50">
                  <c:v>26.656085000000004</c:v>
                </c:pt>
                <c:pt idx="51">
                  <c:v>26.186025000000001</c:v>
                </c:pt>
                <c:pt idx="52">
                  <c:v>27.351150000000001</c:v>
                </c:pt>
                <c:pt idx="53">
                  <c:v>30.276085000000002</c:v>
                </c:pt>
                <c:pt idx="54">
                  <c:v>34.139045000000003</c:v>
                </c:pt>
                <c:pt idx="55">
                  <c:v>38.64922</c:v>
                </c:pt>
                <c:pt idx="56">
                  <c:v>44.464914999999998</c:v>
                </c:pt>
                <c:pt idx="57">
                  <c:v>51.238735000000005</c:v>
                </c:pt>
                <c:pt idx="58">
                  <c:v>58.294074999999999</c:v>
                </c:pt>
                <c:pt idx="59">
                  <c:v>63.242614999999994</c:v>
                </c:pt>
                <c:pt idx="60">
                  <c:v>64.835674999999995</c:v>
                </c:pt>
                <c:pt idx="61">
                  <c:v>63.466339999999988</c:v>
                </c:pt>
                <c:pt idx="62">
                  <c:v>59.371880000000004</c:v>
                </c:pt>
                <c:pt idx="63">
                  <c:v>53.385819999999995</c:v>
                </c:pt>
                <c:pt idx="64">
                  <c:v>46.331835000000005</c:v>
                </c:pt>
                <c:pt idx="65">
                  <c:v>38.879354999999997</c:v>
                </c:pt>
                <c:pt idx="66">
                  <c:v>31.627414999999996</c:v>
                </c:pt>
                <c:pt idx="67">
                  <c:v>26.552479999999999</c:v>
                </c:pt>
                <c:pt idx="68">
                  <c:v>23.245175</c:v>
                </c:pt>
                <c:pt idx="69">
                  <c:v>21.508420000000001</c:v>
                </c:pt>
                <c:pt idx="70">
                  <c:v>20.636145000000003</c:v>
                </c:pt>
                <c:pt idx="71">
                  <c:v>20.158160000000002</c:v>
                </c:pt>
                <c:pt idx="72">
                  <c:v>20.366720000000001</c:v>
                </c:pt>
                <c:pt idx="73">
                  <c:v>21.374955</c:v>
                </c:pt>
                <c:pt idx="74">
                  <c:v>23.889129999999998</c:v>
                </c:pt>
                <c:pt idx="75">
                  <c:v>26.908620000000003</c:v>
                </c:pt>
                <c:pt idx="76">
                  <c:v>30.247514999999996</c:v>
                </c:pt>
                <c:pt idx="77">
                  <c:v>33.193420000000003</c:v>
                </c:pt>
                <c:pt idx="78">
                  <c:v>36.553689999999996</c:v>
                </c:pt>
                <c:pt idx="79">
                  <c:v>39.304324999999999</c:v>
                </c:pt>
                <c:pt idx="80">
                  <c:v>41.740404999999996</c:v>
                </c:pt>
                <c:pt idx="81">
                  <c:v>43.474445000000003</c:v>
                </c:pt>
                <c:pt idx="82">
                  <c:v>43.236995</c:v>
                </c:pt>
                <c:pt idx="83">
                  <c:v>40.746670000000002</c:v>
                </c:pt>
                <c:pt idx="84">
                  <c:v>36.97457</c:v>
                </c:pt>
                <c:pt idx="85">
                  <c:v>32.597239999999999</c:v>
                </c:pt>
                <c:pt idx="86">
                  <c:v>28.483360000000005</c:v>
                </c:pt>
                <c:pt idx="87">
                  <c:v>24.2759</c:v>
                </c:pt>
                <c:pt idx="88">
                  <c:v>20.316800000000001</c:v>
                </c:pt>
                <c:pt idx="89">
                  <c:v>17.134864999999998</c:v>
                </c:pt>
                <c:pt idx="90">
                  <c:v>15.149310000000003</c:v>
                </c:pt>
                <c:pt idx="91">
                  <c:v>14.181379999999999</c:v>
                </c:pt>
                <c:pt idx="92">
                  <c:v>13.868085000000004</c:v>
                </c:pt>
                <c:pt idx="93">
                  <c:v>14.436835000000004</c:v>
                </c:pt>
                <c:pt idx="94">
                  <c:v>15.518195</c:v>
                </c:pt>
                <c:pt idx="95">
                  <c:v>17.555754999999998</c:v>
                </c:pt>
                <c:pt idx="96">
                  <c:v>20.283564999999996</c:v>
                </c:pt>
                <c:pt idx="97">
                  <c:v>23.606735000000004</c:v>
                </c:pt>
                <c:pt idx="98">
                  <c:v>26.676379999999998</c:v>
                </c:pt>
                <c:pt idx="99">
                  <c:v>29.46247</c:v>
                </c:pt>
                <c:pt idx="100">
                  <c:v>31.721399999999999</c:v>
                </c:pt>
                <c:pt idx="101">
                  <c:v>32.838160000000002</c:v>
                </c:pt>
                <c:pt idx="102">
                  <c:v>32.782789999999999</c:v>
                </c:pt>
                <c:pt idx="103">
                  <c:v>31.52393</c:v>
                </c:pt>
                <c:pt idx="104">
                  <c:v>28.726125</c:v>
                </c:pt>
                <c:pt idx="105">
                  <c:v>25.665839999999996</c:v>
                </c:pt>
                <c:pt idx="106">
                  <c:v>22.315404999999998</c:v>
                </c:pt>
                <c:pt idx="107">
                  <c:v>19.32077</c:v>
                </c:pt>
                <c:pt idx="108">
                  <c:v>16.796810000000004</c:v>
                </c:pt>
                <c:pt idx="109">
                  <c:v>14.770839999999996</c:v>
                </c:pt>
                <c:pt idx="110">
                  <c:v>13.247785000000004</c:v>
                </c:pt>
                <c:pt idx="111">
                  <c:v>12.051945000000002</c:v>
                </c:pt>
                <c:pt idx="112">
                  <c:v>11.115864999999996</c:v>
                </c:pt>
                <c:pt idx="113">
                  <c:v>10.681104999999999</c:v>
                </c:pt>
                <c:pt idx="114">
                  <c:v>10.514464999999996</c:v>
                </c:pt>
                <c:pt idx="115">
                  <c:v>10.845214999999996</c:v>
                </c:pt>
                <c:pt idx="116">
                  <c:v>11.731999999999999</c:v>
                </c:pt>
                <c:pt idx="117">
                  <c:v>13.151860000000003</c:v>
                </c:pt>
                <c:pt idx="118">
                  <c:v>15.057970000000001</c:v>
                </c:pt>
                <c:pt idx="119">
                  <c:v>17.23845</c:v>
                </c:pt>
                <c:pt idx="120">
                  <c:v>19.225124999999998</c:v>
                </c:pt>
                <c:pt idx="121">
                  <c:v>20.357839999999996</c:v>
                </c:pt>
                <c:pt idx="122">
                  <c:v>20.78837</c:v>
                </c:pt>
                <c:pt idx="123">
                  <c:v>20.488050000000001</c:v>
                </c:pt>
                <c:pt idx="124">
                  <c:v>17.549360000000004</c:v>
                </c:pt>
                <c:pt idx="125">
                  <c:v>17.9482</c:v>
                </c:pt>
                <c:pt idx="126">
                  <c:v>16.097729999999999</c:v>
                </c:pt>
                <c:pt idx="127">
                  <c:v>14.52905</c:v>
                </c:pt>
                <c:pt idx="128">
                  <c:v>12.870725</c:v>
                </c:pt>
                <c:pt idx="129">
                  <c:v>11.610635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914-4730-818C-2CA628D2D1D6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T$17:$CT$146</c:f>
              <c:numCache>
                <c:formatCode>0.00</c:formatCode>
                <c:ptCount val="130"/>
                <c:pt idx="0">
                  <c:v>28.610689999999998</c:v>
                </c:pt>
                <c:pt idx="1">
                  <c:v>28.895689999999995</c:v>
                </c:pt>
                <c:pt idx="2">
                  <c:v>26.050355</c:v>
                </c:pt>
                <c:pt idx="3">
                  <c:v>23.446610000000003</c:v>
                </c:pt>
                <c:pt idx="4">
                  <c:v>21.823705</c:v>
                </c:pt>
                <c:pt idx="5">
                  <c:v>20.46367</c:v>
                </c:pt>
                <c:pt idx="6">
                  <c:v>19.796794999999999</c:v>
                </c:pt>
                <c:pt idx="7">
                  <c:v>19.151364999999995</c:v>
                </c:pt>
                <c:pt idx="8">
                  <c:v>19.320285000000002</c:v>
                </c:pt>
                <c:pt idx="9">
                  <c:v>21.289479999999998</c:v>
                </c:pt>
                <c:pt idx="10">
                  <c:v>27.006705</c:v>
                </c:pt>
                <c:pt idx="11">
                  <c:v>37.330249999999999</c:v>
                </c:pt>
                <c:pt idx="12">
                  <c:v>52.398130000000002</c:v>
                </c:pt>
                <c:pt idx="13">
                  <c:v>72.344519999999989</c:v>
                </c:pt>
                <c:pt idx="14">
                  <c:v>97.010839999999988</c:v>
                </c:pt>
                <c:pt idx="15">
                  <c:v>126.96834</c:v>
                </c:pt>
                <c:pt idx="16">
                  <c:v>154.50246999999999</c:v>
                </c:pt>
                <c:pt idx="17">
                  <c:v>170.302435</c:v>
                </c:pt>
                <c:pt idx="18">
                  <c:v>170.07514499999999</c:v>
                </c:pt>
                <c:pt idx="19">
                  <c:v>152.22581499999998</c:v>
                </c:pt>
                <c:pt idx="20">
                  <c:v>123.51860500000001</c:v>
                </c:pt>
                <c:pt idx="21">
                  <c:v>99.681285000000003</c:v>
                </c:pt>
                <c:pt idx="22">
                  <c:v>85.930585000000008</c:v>
                </c:pt>
                <c:pt idx="23">
                  <c:v>78.844564999999989</c:v>
                </c:pt>
                <c:pt idx="24">
                  <c:v>74.266125000000002</c:v>
                </c:pt>
                <c:pt idx="25">
                  <c:v>69.26803000000001</c:v>
                </c:pt>
                <c:pt idx="26">
                  <c:v>62.602680000000007</c:v>
                </c:pt>
                <c:pt idx="27">
                  <c:v>54.076339999999988</c:v>
                </c:pt>
                <c:pt idx="28">
                  <c:v>45.782004999999998</c:v>
                </c:pt>
                <c:pt idx="29">
                  <c:v>39.024089999999994</c:v>
                </c:pt>
                <c:pt idx="30">
                  <c:v>35.157514999999997</c:v>
                </c:pt>
                <c:pt idx="31">
                  <c:v>35.105789999999999</c:v>
                </c:pt>
                <c:pt idx="32">
                  <c:v>38.937925</c:v>
                </c:pt>
                <c:pt idx="33">
                  <c:v>45.894030000000001</c:v>
                </c:pt>
                <c:pt idx="34">
                  <c:v>54.267000000000003</c:v>
                </c:pt>
                <c:pt idx="35">
                  <c:v>68.652500000000003</c:v>
                </c:pt>
                <c:pt idx="36">
                  <c:v>83.624985000000009</c:v>
                </c:pt>
                <c:pt idx="37">
                  <c:v>96.566544999999991</c:v>
                </c:pt>
                <c:pt idx="38">
                  <c:v>103.47944</c:v>
                </c:pt>
                <c:pt idx="39">
                  <c:v>103.58521</c:v>
                </c:pt>
                <c:pt idx="40">
                  <c:v>95.993139999999997</c:v>
                </c:pt>
                <c:pt idx="41">
                  <c:v>84.739364999999992</c:v>
                </c:pt>
                <c:pt idx="42">
                  <c:v>71.224455000000006</c:v>
                </c:pt>
                <c:pt idx="43">
                  <c:v>58.861814999999993</c:v>
                </c:pt>
                <c:pt idx="44">
                  <c:v>49.21998</c:v>
                </c:pt>
                <c:pt idx="45">
                  <c:v>43.363610000000001</c:v>
                </c:pt>
                <c:pt idx="46">
                  <c:v>39.371460000000006</c:v>
                </c:pt>
                <c:pt idx="47">
                  <c:v>37.474185000000006</c:v>
                </c:pt>
                <c:pt idx="48">
                  <c:v>35.599354999999996</c:v>
                </c:pt>
                <c:pt idx="49">
                  <c:v>32.475250000000003</c:v>
                </c:pt>
                <c:pt idx="50">
                  <c:v>29.413585000000005</c:v>
                </c:pt>
                <c:pt idx="51">
                  <c:v>27.182424999999999</c:v>
                </c:pt>
                <c:pt idx="52">
                  <c:v>26.294350000000001</c:v>
                </c:pt>
                <c:pt idx="53">
                  <c:v>27.438585000000003</c:v>
                </c:pt>
                <c:pt idx="54">
                  <c:v>30.155045000000001</c:v>
                </c:pt>
                <c:pt idx="55">
                  <c:v>34.11392</c:v>
                </c:pt>
                <c:pt idx="56">
                  <c:v>39.492914999999996</c:v>
                </c:pt>
                <c:pt idx="57">
                  <c:v>46.841835000000003</c:v>
                </c:pt>
                <c:pt idx="58">
                  <c:v>54.012574999999998</c:v>
                </c:pt>
                <c:pt idx="59">
                  <c:v>59.64041499999999</c:v>
                </c:pt>
                <c:pt idx="60">
                  <c:v>61.645775</c:v>
                </c:pt>
                <c:pt idx="61">
                  <c:v>59.849939999999989</c:v>
                </c:pt>
                <c:pt idx="62">
                  <c:v>55.212480000000006</c:v>
                </c:pt>
                <c:pt idx="63">
                  <c:v>49.006019999999999</c:v>
                </c:pt>
                <c:pt idx="64">
                  <c:v>42.223035000000003</c:v>
                </c:pt>
                <c:pt idx="65">
                  <c:v>35.390855000000002</c:v>
                </c:pt>
                <c:pt idx="66">
                  <c:v>29.447114999999997</c:v>
                </c:pt>
                <c:pt idx="67">
                  <c:v>25.25178</c:v>
                </c:pt>
                <c:pt idx="68">
                  <c:v>22.534475</c:v>
                </c:pt>
                <c:pt idx="69">
                  <c:v>20.955120000000001</c:v>
                </c:pt>
                <c:pt idx="70">
                  <c:v>19.741845000000001</c:v>
                </c:pt>
                <c:pt idx="71">
                  <c:v>18.933160000000004</c:v>
                </c:pt>
                <c:pt idx="72">
                  <c:v>18.582520000000002</c:v>
                </c:pt>
                <c:pt idx="73">
                  <c:v>19.068254999999997</c:v>
                </c:pt>
                <c:pt idx="74">
                  <c:v>20.592229999999997</c:v>
                </c:pt>
                <c:pt idx="75">
                  <c:v>23.15232</c:v>
                </c:pt>
                <c:pt idx="76">
                  <c:v>26.588214999999998</c:v>
                </c:pt>
                <c:pt idx="77">
                  <c:v>30.336220000000001</c:v>
                </c:pt>
                <c:pt idx="78">
                  <c:v>34.165789999999994</c:v>
                </c:pt>
                <c:pt idx="79">
                  <c:v>38.279425000000003</c:v>
                </c:pt>
                <c:pt idx="80">
                  <c:v>41.289204999999995</c:v>
                </c:pt>
                <c:pt idx="81">
                  <c:v>43.294845000000002</c:v>
                </c:pt>
                <c:pt idx="82">
                  <c:v>42.973395000000004</c:v>
                </c:pt>
                <c:pt idx="83">
                  <c:v>40.263069999999999</c:v>
                </c:pt>
                <c:pt idx="84">
                  <c:v>35.884070000000001</c:v>
                </c:pt>
                <c:pt idx="85">
                  <c:v>30.900539999999996</c:v>
                </c:pt>
                <c:pt idx="86">
                  <c:v>26.696760000000005</c:v>
                </c:pt>
                <c:pt idx="87">
                  <c:v>22.691600000000001</c:v>
                </c:pt>
                <c:pt idx="88">
                  <c:v>19.3203</c:v>
                </c:pt>
                <c:pt idx="89">
                  <c:v>16.414064999999997</c:v>
                </c:pt>
                <c:pt idx="90">
                  <c:v>14.346810000000003</c:v>
                </c:pt>
                <c:pt idx="91">
                  <c:v>13.145879999999998</c:v>
                </c:pt>
                <c:pt idx="92">
                  <c:v>12.413985000000004</c:v>
                </c:pt>
                <c:pt idx="93">
                  <c:v>12.384335000000004</c:v>
                </c:pt>
                <c:pt idx="94">
                  <c:v>13.049195000000001</c:v>
                </c:pt>
                <c:pt idx="95">
                  <c:v>14.608355</c:v>
                </c:pt>
                <c:pt idx="96">
                  <c:v>17.126464999999996</c:v>
                </c:pt>
                <c:pt idx="97">
                  <c:v>20.322035000000003</c:v>
                </c:pt>
                <c:pt idx="98">
                  <c:v>23.832279999999997</c:v>
                </c:pt>
                <c:pt idx="99">
                  <c:v>27.441470000000002</c:v>
                </c:pt>
                <c:pt idx="100">
                  <c:v>30.5899</c:v>
                </c:pt>
                <c:pt idx="101">
                  <c:v>32.86186</c:v>
                </c:pt>
                <c:pt idx="102">
                  <c:v>33.676089999999995</c:v>
                </c:pt>
                <c:pt idx="103">
                  <c:v>32.796230000000001</c:v>
                </c:pt>
                <c:pt idx="104">
                  <c:v>30.441324999999999</c:v>
                </c:pt>
                <c:pt idx="105">
                  <c:v>27.017439999999997</c:v>
                </c:pt>
                <c:pt idx="106">
                  <c:v>23.178604999999997</c:v>
                </c:pt>
                <c:pt idx="107">
                  <c:v>19.791070000000001</c:v>
                </c:pt>
                <c:pt idx="108">
                  <c:v>16.874610000000004</c:v>
                </c:pt>
                <c:pt idx="109">
                  <c:v>14.661239999999996</c:v>
                </c:pt>
                <c:pt idx="110">
                  <c:v>12.769785000000004</c:v>
                </c:pt>
                <c:pt idx="111">
                  <c:v>11.404145000000002</c:v>
                </c:pt>
                <c:pt idx="112">
                  <c:v>10.643464999999997</c:v>
                </c:pt>
                <c:pt idx="113">
                  <c:v>10.196404999999999</c:v>
                </c:pt>
                <c:pt idx="114">
                  <c:v>10.386564999999997</c:v>
                </c:pt>
                <c:pt idx="115">
                  <c:v>11.066714999999997</c:v>
                </c:pt>
                <c:pt idx="116">
                  <c:v>12.394399999999999</c:v>
                </c:pt>
                <c:pt idx="117">
                  <c:v>14.090060000000003</c:v>
                </c:pt>
                <c:pt idx="118">
                  <c:v>16.364570000000001</c:v>
                </c:pt>
                <c:pt idx="119">
                  <c:v>18.640149999999998</c:v>
                </c:pt>
                <c:pt idx="120">
                  <c:v>20.726925000000001</c:v>
                </c:pt>
                <c:pt idx="121">
                  <c:v>22.411339999999996</c:v>
                </c:pt>
                <c:pt idx="122">
                  <c:v>23.41827</c:v>
                </c:pt>
                <c:pt idx="123">
                  <c:v>23.270949999999999</c:v>
                </c:pt>
                <c:pt idx="124">
                  <c:v>20.372760000000003</c:v>
                </c:pt>
                <c:pt idx="125">
                  <c:v>20.453600000000002</c:v>
                </c:pt>
                <c:pt idx="126">
                  <c:v>18.160729999999997</c:v>
                </c:pt>
                <c:pt idx="127">
                  <c:v>15.897550000000001</c:v>
                </c:pt>
                <c:pt idx="128">
                  <c:v>13.995825</c:v>
                </c:pt>
                <c:pt idx="129">
                  <c:v>12.186235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914-4730-818C-2CA628D2D1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7175040"/>
        <c:axId val="77210752"/>
      </c:lineChart>
      <c:catAx>
        <c:axId val="77175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7210752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77210752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771750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O$17:$CO$146</c:f>
              <c:numCache>
                <c:formatCode>0.00</c:formatCode>
                <c:ptCount val="130"/>
                <c:pt idx="0">
                  <c:v>10.333214999999997</c:v>
                </c:pt>
                <c:pt idx="1">
                  <c:v>15.124895</c:v>
                </c:pt>
                <c:pt idx="2">
                  <c:v>15.800279999999999</c:v>
                </c:pt>
                <c:pt idx="3">
                  <c:v>15.988845000000001</c:v>
                </c:pt>
                <c:pt idx="4">
                  <c:v>15.954445000000002</c:v>
                </c:pt>
                <c:pt idx="5">
                  <c:v>16.007579999999997</c:v>
                </c:pt>
                <c:pt idx="6">
                  <c:v>16.705445000000001</c:v>
                </c:pt>
                <c:pt idx="7">
                  <c:v>18.366245000000003</c:v>
                </c:pt>
                <c:pt idx="8">
                  <c:v>21.795275</c:v>
                </c:pt>
                <c:pt idx="9">
                  <c:v>28.485795</c:v>
                </c:pt>
                <c:pt idx="10">
                  <c:v>38.953664999999994</c:v>
                </c:pt>
                <c:pt idx="11">
                  <c:v>52.503855000000001</c:v>
                </c:pt>
                <c:pt idx="12">
                  <c:v>69.524450000000002</c:v>
                </c:pt>
                <c:pt idx="13">
                  <c:v>88.407755000000009</c:v>
                </c:pt>
                <c:pt idx="14">
                  <c:v>104.80791000000001</c:v>
                </c:pt>
                <c:pt idx="15">
                  <c:v>111.39954499999999</c:v>
                </c:pt>
                <c:pt idx="16">
                  <c:v>109.371375</c:v>
                </c:pt>
                <c:pt idx="17">
                  <c:v>101.92041999999999</c:v>
                </c:pt>
                <c:pt idx="18">
                  <c:v>93.135080000000002</c:v>
                </c:pt>
                <c:pt idx="19">
                  <c:v>85.172844999999995</c:v>
                </c:pt>
                <c:pt idx="20">
                  <c:v>78.967579999999998</c:v>
                </c:pt>
                <c:pt idx="21">
                  <c:v>73.411260000000013</c:v>
                </c:pt>
                <c:pt idx="22">
                  <c:v>69.640819999999991</c:v>
                </c:pt>
                <c:pt idx="23">
                  <c:v>66.559150000000002</c:v>
                </c:pt>
                <c:pt idx="24">
                  <c:v>65.559110000000004</c:v>
                </c:pt>
                <c:pt idx="25">
                  <c:v>67.521255000000011</c:v>
                </c:pt>
                <c:pt idx="26">
                  <c:v>72.771574999999999</c:v>
                </c:pt>
                <c:pt idx="27">
                  <c:v>79.85593999999999</c:v>
                </c:pt>
                <c:pt idx="28">
                  <c:v>85.425545</c:v>
                </c:pt>
                <c:pt idx="29">
                  <c:v>89.427205000000001</c:v>
                </c:pt>
                <c:pt idx="30">
                  <c:v>91.748289999999997</c:v>
                </c:pt>
                <c:pt idx="31">
                  <c:v>90.361464999999995</c:v>
                </c:pt>
                <c:pt idx="32">
                  <c:v>86.787264999999991</c:v>
                </c:pt>
                <c:pt idx="33">
                  <c:v>81.070295000000002</c:v>
                </c:pt>
                <c:pt idx="34">
                  <c:v>74.61345</c:v>
                </c:pt>
                <c:pt idx="35">
                  <c:v>68.598235000000003</c:v>
                </c:pt>
                <c:pt idx="36">
                  <c:v>64.892494999999997</c:v>
                </c:pt>
                <c:pt idx="37">
                  <c:v>62.865185000000011</c:v>
                </c:pt>
                <c:pt idx="38">
                  <c:v>63.339160000000007</c:v>
                </c:pt>
                <c:pt idx="39">
                  <c:v>65.103794999999991</c:v>
                </c:pt>
                <c:pt idx="40">
                  <c:v>67.555805000000007</c:v>
                </c:pt>
                <c:pt idx="41">
                  <c:v>70.457744999999989</c:v>
                </c:pt>
                <c:pt idx="42">
                  <c:v>72.519324999999995</c:v>
                </c:pt>
                <c:pt idx="43">
                  <c:v>72.141549999999995</c:v>
                </c:pt>
                <c:pt idx="44">
                  <c:v>69.525439999999989</c:v>
                </c:pt>
                <c:pt idx="45">
                  <c:v>66.509474999999995</c:v>
                </c:pt>
                <c:pt idx="46">
                  <c:v>63.240010000000012</c:v>
                </c:pt>
                <c:pt idx="47">
                  <c:v>60.336550000000003</c:v>
                </c:pt>
                <c:pt idx="48">
                  <c:v>58.943810000000006</c:v>
                </c:pt>
                <c:pt idx="49">
                  <c:v>58.831205000000004</c:v>
                </c:pt>
                <c:pt idx="50">
                  <c:v>59.939324999999997</c:v>
                </c:pt>
                <c:pt idx="51">
                  <c:v>62.430300000000003</c:v>
                </c:pt>
                <c:pt idx="52">
                  <c:v>65.12697</c:v>
                </c:pt>
                <c:pt idx="53">
                  <c:v>67.099950000000007</c:v>
                </c:pt>
                <c:pt idx="54">
                  <c:v>68.102599999999995</c:v>
                </c:pt>
                <c:pt idx="55">
                  <c:v>68.019764999999992</c:v>
                </c:pt>
                <c:pt idx="56">
                  <c:v>67.214105000000004</c:v>
                </c:pt>
                <c:pt idx="57">
                  <c:v>66.906839999999988</c:v>
                </c:pt>
                <c:pt idx="58">
                  <c:v>65.685670000000002</c:v>
                </c:pt>
                <c:pt idx="59">
                  <c:v>63.779499999999999</c:v>
                </c:pt>
                <c:pt idx="60">
                  <c:v>61.762664999999991</c:v>
                </c:pt>
                <c:pt idx="61">
                  <c:v>59.864180000000005</c:v>
                </c:pt>
                <c:pt idx="62">
                  <c:v>58.207864999999991</c:v>
                </c:pt>
                <c:pt idx="63">
                  <c:v>57.437635000000007</c:v>
                </c:pt>
                <c:pt idx="64">
                  <c:v>56.839475</c:v>
                </c:pt>
                <c:pt idx="65">
                  <c:v>56.687260000000009</c:v>
                </c:pt>
                <c:pt idx="66">
                  <c:v>56.543755000000004</c:v>
                </c:pt>
                <c:pt idx="67">
                  <c:v>56.260350000000003</c:v>
                </c:pt>
                <c:pt idx="68">
                  <c:v>55.672864999999987</c:v>
                </c:pt>
                <c:pt idx="69">
                  <c:v>54.971189999999993</c:v>
                </c:pt>
                <c:pt idx="70">
                  <c:v>54.426505000000006</c:v>
                </c:pt>
                <c:pt idx="71">
                  <c:v>53.415194999999997</c:v>
                </c:pt>
                <c:pt idx="72">
                  <c:v>52.329389999999997</c:v>
                </c:pt>
                <c:pt idx="73">
                  <c:v>51.415545000000002</c:v>
                </c:pt>
                <c:pt idx="74">
                  <c:v>50.71922</c:v>
                </c:pt>
                <c:pt idx="75">
                  <c:v>50.499955</c:v>
                </c:pt>
                <c:pt idx="76">
                  <c:v>50.017460000000007</c:v>
                </c:pt>
                <c:pt idx="77">
                  <c:v>49.933554999999998</c:v>
                </c:pt>
                <c:pt idx="78">
                  <c:v>49.747475000000001</c:v>
                </c:pt>
                <c:pt idx="79">
                  <c:v>49.5199</c:v>
                </c:pt>
                <c:pt idx="80">
                  <c:v>49.658035000000005</c:v>
                </c:pt>
                <c:pt idx="81">
                  <c:v>49.333599999999997</c:v>
                </c:pt>
                <c:pt idx="82">
                  <c:v>48.872335000000007</c:v>
                </c:pt>
                <c:pt idx="83">
                  <c:v>48.625880000000002</c:v>
                </c:pt>
                <c:pt idx="84">
                  <c:v>48.170204999999996</c:v>
                </c:pt>
                <c:pt idx="85">
                  <c:v>48.233839999999994</c:v>
                </c:pt>
                <c:pt idx="86">
                  <c:v>47.492670000000004</c:v>
                </c:pt>
                <c:pt idx="87">
                  <c:v>46.588789999999996</c:v>
                </c:pt>
                <c:pt idx="88">
                  <c:v>46.12791</c:v>
                </c:pt>
                <c:pt idx="89">
                  <c:v>45.285470000000004</c:v>
                </c:pt>
                <c:pt idx="90">
                  <c:v>44.575324999999999</c:v>
                </c:pt>
                <c:pt idx="91">
                  <c:v>43.809114999999998</c:v>
                </c:pt>
                <c:pt idx="92">
                  <c:v>42.260964999999999</c:v>
                </c:pt>
                <c:pt idx="93">
                  <c:v>41.514835000000005</c:v>
                </c:pt>
                <c:pt idx="94">
                  <c:v>40.479120000000002</c:v>
                </c:pt>
                <c:pt idx="95">
                  <c:v>39.539169999999999</c:v>
                </c:pt>
                <c:pt idx="96">
                  <c:v>38.457789999999996</c:v>
                </c:pt>
                <c:pt idx="97">
                  <c:v>37.671025</c:v>
                </c:pt>
                <c:pt idx="98">
                  <c:v>36.748080000000002</c:v>
                </c:pt>
                <c:pt idx="99">
                  <c:v>36.036339999999996</c:v>
                </c:pt>
                <c:pt idx="100">
                  <c:v>34.729435000000002</c:v>
                </c:pt>
                <c:pt idx="101">
                  <c:v>34.104480000000002</c:v>
                </c:pt>
                <c:pt idx="102">
                  <c:v>33.195855000000002</c:v>
                </c:pt>
                <c:pt idx="103">
                  <c:v>32.494399999999999</c:v>
                </c:pt>
                <c:pt idx="104">
                  <c:v>32.006675000000001</c:v>
                </c:pt>
                <c:pt idx="105">
                  <c:v>31.38137</c:v>
                </c:pt>
                <c:pt idx="106">
                  <c:v>30.926139999999997</c:v>
                </c:pt>
                <c:pt idx="107">
                  <c:v>30.383470000000003</c:v>
                </c:pt>
                <c:pt idx="108">
                  <c:v>29.943645</c:v>
                </c:pt>
                <c:pt idx="109">
                  <c:v>29.685105</c:v>
                </c:pt>
                <c:pt idx="110">
                  <c:v>29.342979999999997</c:v>
                </c:pt>
                <c:pt idx="111">
                  <c:v>28.993475</c:v>
                </c:pt>
                <c:pt idx="112">
                  <c:v>28.506989999999998</c:v>
                </c:pt>
                <c:pt idx="113">
                  <c:v>28.325310000000002</c:v>
                </c:pt>
                <c:pt idx="114">
                  <c:v>28.004429999999999</c:v>
                </c:pt>
                <c:pt idx="115">
                  <c:v>27.685360000000003</c:v>
                </c:pt>
                <c:pt idx="116">
                  <c:v>27.476285000000004</c:v>
                </c:pt>
                <c:pt idx="117">
                  <c:v>27.052995000000003</c:v>
                </c:pt>
                <c:pt idx="118">
                  <c:v>26.935454999999997</c:v>
                </c:pt>
                <c:pt idx="119">
                  <c:v>26.84357</c:v>
                </c:pt>
                <c:pt idx="120">
                  <c:v>27.036745</c:v>
                </c:pt>
                <c:pt idx="121">
                  <c:v>27.112950000000001</c:v>
                </c:pt>
                <c:pt idx="122">
                  <c:v>27.256089999999997</c:v>
                </c:pt>
                <c:pt idx="123">
                  <c:v>27.08907</c:v>
                </c:pt>
                <c:pt idx="124">
                  <c:v>26.685860000000005</c:v>
                </c:pt>
                <c:pt idx="125">
                  <c:v>26.543639999999996</c:v>
                </c:pt>
                <c:pt idx="126">
                  <c:v>26.281649999999999</c:v>
                </c:pt>
                <c:pt idx="127">
                  <c:v>25.996739999999996</c:v>
                </c:pt>
                <c:pt idx="128">
                  <c:v>26.001289999999997</c:v>
                </c:pt>
                <c:pt idx="129">
                  <c:v>25.9614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02-4434-A054-9BB399624084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P$17:$CP$146</c:f>
              <c:numCache>
                <c:formatCode>0.00</c:formatCode>
                <c:ptCount val="130"/>
                <c:pt idx="0">
                  <c:v>7.4412149999999961</c:v>
                </c:pt>
                <c:pt idx="1">
                  <c:v>12.649395000000002</c:v>
                </c:pt>
                <c:pt idx="2">
                  <c:v>13.240179999999999</c:v>
                </c:pt>
                <c:pt idx="3">
                  <c:v>13.720445000000002</c:v>
                </c:pt>
                <c:pt idx="4">
                  <c:v>13.618545000000001</c:v>
                </c:pt>
                <c:pt idx="5">
                  <c:v>13.904079999999999</c:v>
                </c:pt>
                <c:pt idx="6">
                  <c:v>14.340545000000001</c:v>
                </c:pt>
                <c:pt idx="7">
                  <c:v>15.430645000000002</c:v>
                </c:pt>
                <c:pt idx="8">
                  <c:v>17.612275</c:v>
                </c:pt>
                <c:pt idx="9">
                  <c:v>21.572095000000001</c:v>
                </c:pt>
                <c:pt idx="10">
                  <c:v>28.492664999999995</c:v>
                </c:pt>
                <c:pt idx="11">
                  <c:v>37.912354999999998</c:v>
                </c:pt>
                <c:pt idx="12">
                  <c:v>49.601649999999999</c:v>
                </c:pt>
                <c:pt idx="13">
                  <c:v>62.947655000000005</c:v>
                </c:pt>
                <c:pt idx="14">
                  <c:v>76.161710000000014</c:v>
                </c:pt>
                <c:pt idx="15">
                  <c:v>84.304144999999991</c:v>
                </c:pt>
                <c:pt idx="16">
                  <c:v>85.103475000000003</c:v>
                </c:pt>
                <c:pt idx="17">
                  <c:v>79.296120000000002</c:v>
                </c:pt>
                <c:pt idx="18">
                  <c:v>71.966380000000001</c:v>
                </c:pt>
                <c:pt idx="19">
                  <c:v>66.356444999999994</c:v>
                </c:pt>
                <c:pt idx="20">
                  <c:v>63.118780000000008</c:v>
                </c:pt>
                <c:pt idx="21">
                  <c:v>60.011960000000009</c:v>
                </c:pt>
                <c:pt idx="22">
                  <c:v>57.971419999999995</c:v>
                </c:pt>
                <c:pt idx="23">
                  <c:v>55.827150000000003</c:v>
                </c:pt>
                <c:pt idx="24">
                  <c:v>53.513610000000007</c:v>
                </c:pt>
                <c:pt idx="25">
                  <c:v>53.470855000000007</c:v>
                </c:pt>
                <c:pt idx="26">
                  <c:v>55.515675000000002</c:v>
                </c:pt>
                <c:pt idx="27">
                  <c:v>59.190739999999991</c:v>
                </c:pt>
                <c:pt idx="28">
                  <c:v>62.572144999999992</c:v>
                </c:pt>
                <c:pt idx="29">
                  <c:v>65.028005000000007</c:v>
                </c:pt>
                <c:pt idx="30">
                  <c:v>65.545489999999987</c:v>
                </c:pt>
                <c:pt idx="31">
                  <c:v>65.298964999999995</c:v>
                </c:pt>
                <c:pt idx="32">
                  <c:v>63.646964999999987</c:v>
                </c:pt>
                <c:pt idx="33">
                  <c:v>59.919294999999998</c:v>
                </c:pt>
                <c:pt idx="34">
                  <c:v>56.557049999999997</c:v>
                </c:pt>
                <c:pt idx="35">
                  <c:v>52.828035000000007</c:v>
                </c:pt>
                <c:pt idx="36">
                  <c:v>49.824894999999998</c:v>
                </c:pt>
                <c:pt idx="37">
                  <c:v>48.505385000000004</c:v>
                </c:pt>
                <c:pt idx="38">
                  <c:v>48.330560000000006</c:v>
                </c:pt>
                <c:pt idx="39">
                  <c:v>49.890295000000002</c:v>
                </c:pt>
                <c:pt idx="40">
                  <c:v>51.836504999999995</c:v>
                </c:pt>
                <c:pt idx="41">
                  <c:v>53.926044999999995</c:v>
                </c:pt>
                <c:pt idx="42">
                  <c:v>54.944825000000002</c:v>
                </c:pt>
                <c:pt idx="43">
                  <c:v>55.674250000000001</c:v>
                </c:pt>
                <c:pt idx="44">
                  <c:v>55.582539999999987</c:v>
                </c:pt>
                <c:pt idx="45">
                  <c:v>54.101275000000001</c:v>
                </c:pt>
                <c:pt idx="46">
                  <c:v>52.180910000000004</c:v>
                </c:pt>
                <c:pt idx="47">
                  <c:v>50.498649999999998</c:v>
                </c:pt>
                <c:pt idx="48">
                  <c:v>48.519310000000004</c:v>
                </c:pt>
                <c:pt idx="49">
                  <c:v>47.544505000000001</c:v>
                </c:pt>
                <c:pt idx="50">
                  <c:v>47.170524999999998</c:v>
                </c:pt>
                <c:pt idx="51">
                  <c:v>47.903500000000001</c:v>
                </c:pt>
                <c:pt idx="52">
                  <c:v>49.682270000000003</c:v>
                </c:pt>
                <c:pt idx="53">
                  <c:v>51.388750000000002</c:v>
                </c:pt>
                <c:pt idx="54">
                  <c:v>52.920400000000001</c:v>
                </c:pt>
                <c:pt idx="55">
                  <c:v>54.084164999999992</c:v>
                </c:pt>
                <c:pt idx="56">
                  <c:v>55.170305000000006</c:v>
                </c:pt>
                <c:pt idx="57">
                  <c:v>55.159739999999992</c:v>
                </c:pt>
                <c:pt idx="58">
                  <c:v>54.815669999999997</c:v>
                </c:pt>
                <c:pt idx="59">
                  <c:v>54.269799999999996</c:v>
                </c:pt>
                <c:pt idx="60">
                  <c:v>53.361364999999992</c:v>
                </c:pt>
                <c:pt idx="61">
                  <c:v>52.09178</c:v>
                </c:pt>
                <c:pt idx="62">
                  <c:v>50.448564999999995</c:v>
                </c:pt>
                <c:pt idx="63">
                  <c:v>48.925035000000001</c:v>
                </c:pt>
                <c:pt idx="64">
                  <c:v>47.892975</c:v>
                </c:pt>
                <c:pt idx="65">
                  <c:v>47.041060000000002</c:v>
                </c:pt>
                <c:pt idx="66">
                  <c:v>46.637554999999999</c:v>
                </c:pt>
                <c:pt idx="67">
                  <c:v>46.819949999999999</c:v>
                </c:pt>
                <c:pt idx="68">
                  <c:v>46.387764999999995</c:v>
                </c:pt>
                <c:pt idx="69">
                  <c:v>45.985889999999998</c:v>
                </c:pt>
                <c:pt idx="70">
                  <c:v>45.892404999999997</c:v>
                </c:pt>
                <c:pt idx="71">
                  <c:v>45.498195000000003</c:v>
                </c:pt>
                <c:pt idx="72">
                  <c:v>44.865689999999994</c:v>
                </c:pt>
                <c:pt idx="73">
                  <c:v>44.164645</c:v>
                </c:pt>
                <c:pt idx="74">
                  <c:v>43.554120000000005</c:v>
                </c:pt>
                <c:pt idx="75">
                  <c:v>43.357954999999997</c:v>
                </c:pt>
                <c:pt idx="76">
                  <c:v>43.151360000000004</c:v>
                </c:pt>
                <c:pt idx="77">
                  <c:v>42.763154999999998</c:v>
                </c:pt>
                <c:pt idx="78">
                  <c:v>43.113574999999997</c:v>
                </c:pt>
                <c:pt idx="79">
                  <c:v>42.523000000000003</c:v>
                </c:pt>
                <c:pt idx="80">
                  <c:v>42.487535000000001</c:v>
                </c:pt>
                <c:pt idx="81">
                  <c:v>42.561700000000002</c:v>
                </c:pt>
                <c:pt idx="82">
                  <c:v>41.876435000000001</c:v>
                </c:pt>
                <c:pt idx="83">
                  <c:v>41.410679999999999</c:v>
                </c:pt>
                <c:pt idx="84">
                  <c:v>40.913004999999998</c:v>
                </c:pt>
                <c:pt idx="85">
                  <c:v>40.800439999999995</c:v>
                </c:pt>
                <c:pt idx="86">
                  <c:v>40.099170000000001</c:v>
                </c:pt>
                <c:pt idx="87">
                  <c:v>39.130289999999995</c:v>
                </c:pt>
                <c:pt idx="88">
                  <c:v>38.888710000000003</c:v>
                </c:pt>
                <c:pt idx="89">
                  <c:v>38.23807</c:v>
                </c:pt>
                <c:pt idx="90">
                  <c:v>37.763325000000002</c:v>
                </c:pt>
                <c:pt idx="91">
                  <c:v>37.169914999999996</c:v>
                </c:pt>
                <c:pt idx="92">
                  <c:v>36.337864999999994</c:v>
                </c:pt>
                <c:pt idx="93">
                  <c:v>35.792135000000002</c:v>
                </c:pt>
                <c:pt idx="94">
                  <c:v>35.216720000000002</c:v>
                </c:pt>
                <c:pt idx="95">
                  <c:v>34.404470000000003</c:v>
                </c:pt>
                <c:pt idx="96">
                  <c:v>33.637089999999993</c:v>
                </c:pt>
                <c:pt idx="97">
                  <c:v>32.778025</c:v>
                </c:pt>
                <c:pt idx="98">
                  <c:v>32.113680000000002</c:v>
                </c:pt>
                <c:pt idx="99">
                  <c:v>31.466339999999995</c:v>
                </c:pt>
                <c:pt idx="100">
                  <c:v>30.663735000000003</c:v>
                </c:pt>
                <c:pt idx="101">
                  <c:v>30.070180000000001</c:v>
                </c:pt>
                <c:pt idx="102">
                  <c:v>29.653454999999997</c:v>
                </c:pt>
                <c:pt idx="103">
                  <c:v>29.116099999999999</c:v>
                </c:pt>
                <c:pt idx="104">
                  <c:v>28.752575</c:v>
                </c:pt>
                <c:pt idx="105">
                  <c:v>28.63607</c:v>
                </c:pt>
                <c:pt idx="106">
                  <c:v>28.348739999999996</c:v>
                </c:pt>
                <c:pt idx="107">
                  <c:v>28.19097</c:v>
                </c:pt>
                <c:pt idx="108">
                  <c:v>27.979745000000001</c:v>
                </c:pt>
                <c:pt idx="109">
                  <c:v>28.047504999999997</c:v>
                </c:pt>
                <c:pt idx="110">
                  <c:v>27.831379999999999</c:v>
                </c:pt>
                <c:pt idx="111">
                  <c:v>27.572575000000001</c:v>
                </c:pt>
                <c:pt idx="112">
                  <c:v>26.892889999999998</c:v>
                </c:pt>
                <c:pt idx="113">
                  <c:v>26.883710000000004</c:v>
                </c:pt>
                <c:pt idx="114">
                  <c:v>26.835529999999999</c:v>
                </c:pt>
                <c:pt idx="115">
                  <c:v>26.548860000000005</c:v>
                </c:pt>
                <c:pt idx="116">
                  <c:v>26.624085000000004</c:v>
                </c:pt>
                <c:pt idx="117">
                  <c:v>26.231695000000002</c:v>
                </c:pt>
                <c:pt idx="118">
                  <c:v>26.112555</c:v>
                </c:pt>
                <c:pt idx="119">
                  <c:v>25.846870000000003</c:v>
                </c:pt>
                <c:pt idx="120">
                  <c:v>25.695245</c:v>
                </c:pt>
                <c:pt idx="121">
                  <c:v>25.420249999999999</c:v>
                </c:pt>
                <c:pt idx="122">
                  <c:v>25.193489999999997</c:v>
                </c:pt>
                <c:pt idx="123">
                  <c:v>25.176170000000003</c:v>
                </c:pt>
                <c:pt idx="124">
                  <c:v>24.869060000000005</c:v>
                </c:pt>
                <c:pt idx="125">
                  <c:v>24.545739999999995</c:v>
                </c:pt>
                <c:pt idx="126">
                  <c:v>24.450050000000001</c:v>
                </c:pt>
                <c:pt idx="127">
                  <c:v>24.009039999999995</c:v>
                </c:pt>
                <c:pt idx="128">
                  <c:v>23.837989999999998</c:v>
                </c:pt>
                <c:pt idx="129">
                  <c:v>23.629904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02-4434-A054-9BB399624084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Q$17:$CQ$146</c:f>
              <c:numCache>
                <c:formatCode>0.00</c:formatCode>
                <c:ptCount val="130"/>
                <c:pt idx="0">
                  <c:v>8.3958149999999971</c:v>
                </c:pt>
                <c:pt idx="1">
                  <c:v>12.991495</c:v>
                </c:pt>
                <c:pt idx="2">
                  <c:v>13.34728</c:v>
                </c:pt>
                <c:pt idx="3">
                  <c:v>13.596845000000002</c:v>
                </c:pt>
                <c:pt idx="4">
                  <c:v>13.638145000000002</c:v>
                </c:pt>
                <c:pt idx="5">
                  <c:v>14.011779999999998</c:v>
                </c:pt>
                <c:pt idx="6">
                  <c:v>14.980445000000001</c:v>
                </c:pt>
                <c:pt idx="7">
                  <c:v>16.990045000000002</c:v>
                </c:pt>
                <c:pt idx="8">
                  <c:v>20.350774999999999</c:v>
                </c:pt>
                <c:pt idx="9">
                  <c:v>26.416195000000002</c:v>
                </c:pt>
                <c:pt idx="10">
                  <c:v>35.826864999999998</c:v>
                </c:pt>
                <c:pt idx="11">
                  <c:v>48.121254999999998</c:v>
                </c:pt>
                <c:pt idx="12">
                  <c:v>63.934849999999997</c:v>
                </c:pt>
                <c:pt idx="13">
                  <c:v>81.069055000000006</c:v>
                </c:pt>
                <c:pt idx="14">
                  <c:v>94.990310000000008</c:v>
                </c:pt>
                <c:pt idx="15">
                  <c:v>100.486345</c:v>
                </c:pt>
                <c:pt idx="16">
                  <c:v>99.395574999999994</c:v>
                </c:pt>
                <c:pt idx="17">
                  <c:v>93.032820000000001</c:v>
                </c:pt>
                <c:pt idx="18">
                  <c:v>86.115480000000005</c:v>
                </c:pt>
                <c:pt idx="19">
                  <c:v>80.968044999999989</c:v>
                </c:pt>
                <c:pt idx="20">
                  <c:v>77.557280000000006</c:v>
                </c:pt>
                <c:pt idx="21">
                  <c:v>72.584060000000008</c:v>
                </c:pt>
                <c:pt idx="22">
                  <c:v>68.99351999999999</c:v>
                </c:pt>
                <c:pt idx="23">
                  <c:v>66.701750000000004</c:v>
                </c:pt>
                <c:pt idx="24">
                  <c:v>66.659910000000011</c:v>
                </c:pt>
                <c:pt idx="25">
                  <c:v>68.742955000000009</c:v>
                </c:pt>
                <c:pt idx="26">
                  <c:v>74.088975000000005</c:v>
                </c:pt>
                <c:pt idx="27">
                  <c:v>80.834039999999987</c:v>
                </c:pt>
                <c:pt idx="28">
                  <c:v>85.62944499999999</c:v>
                </c:pt>
                <c:pt idx="29">
                  <c:v>89.360505000000003</c:v>
                </c:pt>
                <c:pt idx="30">
                  <c:v>91.493189999999984</c:v>
                </c:pt>
                <c:pt idx="31">
                  <c:v>90.491464999999991</c:v>
                </c:pt>
                <c:pt idx="32">
                  <c:v>87.101164999999995</c:v>
                </c:pt>
                <c:pt idx="33">
                  <c:v>80.862195</c:v>
                </c:pt>
                <c:pt idx="34">
                  <c:v>75.437349999999995</c:v>
                </c:pt>
                <c:pt idx="35">
                  <c:v>70.912935000000004</c:v>
                </c:pt>
                <c:pt idx="36">
                  <c:v>68.21719499999999</c:v>
                </c:pt>
                <c:pt idx="37">
                  <c:v>67.01498500000001</c:v>
                </c:pt>
                <c:pt idx="38">
                  <c:v>67.507260000000002</c:v>
                </c:pt>
                <c:pt idx="39">
                  <c:v>68.682194999999993</c:v>
                </c:pt>
                <c:pt idx="40">
                  <c:v>71.760604999999998</c:v>
                </c:pt>
                <c:pt idx="41">
                  <c:v>75.67054499999999</c:v>
                </c:pt>
                <c:pt idx="42">
                  <c:v>77.489125000000001</c:v>
                </c:pt>
                <c:pt idx="43">
                  <c:v>77.832149999999999</c:v>
                </c:pt>
                <c:pt idx="44">
                  <c:v>76.987539999999996</c:v>
                </c:pt>
                <c:pt idx="45">
                  <c:v>75.290075000000002</c:v>
                </c:pt>
                <c:pt idx="46">
                  <c:v>73.428910000000016</c:v>
                </c:pt>
                <c:pt idx="47">
                  <c:v>71.503649999999993</c:v>
                </c:pt>
                <c:pt idx="48">
                  <c:v>69.835510000000014</c:v>
                </c:pt>
                <c:pt idx="49">
                  <c:v>69.216205000000002</c:v>
                </c:pt>
                <c:pt idx="50">
                  <c:v>68.939425</c:v>
                </c:pt>
                <c:pt idx="51">
                  <c:v>69.879800000000003</c:v>
                </c:pt>
                <c:pt idx="52">
                  <c:v>71.603369999999998</c:v>
                </c:pt>
                <c:pt idx="53">
                  <c:v>72.523150000000001</c:v>
                </c:pt>
                <c:pt idx="54">
                  <c:v>72.773200000000003</c:v>
                </c:pt>
                <c:pt idx="55">
                  <c:v>72.322664999999986</c:v>
                </c:pt>
                <c:pt idx="56">
                  <c:v>70.938305</c:v>
                </c:pt>
                <c:pt idx="57">
                  <c:v>69.326339999999988</c:v>
                </c:pt>
                <c:pt idx="58">
                  <c:v>66.711469999999991</c:v>
                </c:pt>
                <c:pt idx="59">
                  <c:v>64.251000000000005</c:v>
                </c:pt>
                <c:pt idx="60">
                  <c:v>61.809164999999993</c:v>
                </c:pt>
                <c:pt idx="61">
                  <c:v>59.792980000000007</c:v>
                </c:pt>
                <c:pt idx="62">
                  <c:v>58.548564999999989</c:v>
                </c:pt>
                <c:pt idx="63">
                  <c:v>57.939535000000006</c:v>
                </c:pt>
                <c:pt idx="64">
                  <c:v>57.944474999999997</c:v>
                </c:pt>
                <c:pt idx="65">
                  <c:v>58.131560000000007</c:v>
                </c:pt>
                <c:pt idx="66">
                  <c:v>57.792655000000003</c:v>
                </c:pt>
                <c:pt idx="67">
                  <c:v>57.525950000000002</c:v>
                </c:pt>
                <c:pt idx="68">
                  <c:v>56.659764999999993</c:v>
                </c:pt>
                <c:pt idx="69">
                  <c:v>55.668689999999991</c:v>
                </c:pt>
                <c:pt idx="70">
                  <c:v>54.643505000000005</c:v>
                </c:pt>
                <c:pt idx="71">
                  <c:v>53.611194999999995</c:v>
                </c:pt>
                <c:pt idx="72">
                  <c:v>52.64938999999999</c:v>
                </c:pt>
                <c:pt idx="73">
                  <c:v>51.346145</c:v>
                </c:pt>
                <c:pt idx="74">
                  <c:v>50.44332</c:v>
                </c:pt>
                <c:pt idx="75">
                  <c:v>49.455154999999998</c:v>
                </c:pt>
                <c:pt idx="76">
                  <c:v>48.284960000000005</c:v>
                </c:pt>
                <c:pt idx="77">
                  <c:v>47.801755</c:v>
                </c:pt>
                <c:pt idx="78">
                  <c:v>46.992575000000002</c:v>
                </c:pt>
                <c:pt idx="79">
                  <c:v>46.257899999999999</c:v>
                </c:pt>
                <c:pt idx="80">
                  <c:v>45.538135000000004</c:v>
                </c:pt>
                <c:pt idx="81">
                  <c:v>44.540999999999997</c:v>
                </c:pt>
                <c:pt idx="82">
                  <c:v>44.063735000000001</c:v>
                </c:pt>
                <c:pt idx="83">
                  <c:v>42.949680000000001</c:v>
                </c:pt>
                <c:pt idx="84">
                  <c:v>41.843105000000001</c:v>
                </c:pt>
                <c:pt idx="85">
                  <c:v>40.873639999999995</c:v>
                </c:pt>
                <c:pt idx="86">
                  <c:v>40.008070000000004</c:v>
                </c:pt>
                <c:pt idx="87">
                  <c:v>38.731689999999993</c:v>
                </c:pt>
                <c:pt idx="88">
                  <c:v>37.877310000000001</c:v>
                </c:pt>
                <c:pt idx="89">
                  <c:v>37.306670000000004</c:v>
                </c:pt>
                <c:pt idx="90">
                  <c:v>36.820925000000003</c:v>
                </c:pt>
                <c:pt idx="91">
                  <c:v>36.366314999999993</c:v>
                </c:pt>
                <c:pt idx="92">
                  <c:v>35.285564999999998</c:v>
                </c:pt>
                <c:pt idx="93">
                  <c:v>34.912235000000003</c:v>
                </c:pt>
                <c:pt idx="94">
                  <c:v>34.617620000000002</c:v>
                </c:pt>
                <c:pt idx="95">
                  <c:v>33.865369999999999</c:v>
                </c:pt>
                <c:pt idx="96">
                  <c:v>33.308889999999998</c:v>
                </c:pt>
                <c:pt idx="97">
                  <c:v>33.019024999999999</c:v>
                </c:pt>
                <c:pt idx="98">
                  <c:v>32.811579999999999</c:v>
                </c:pt>
                <c:pt idx="99">
                  <c:v>32.783539999999995</c:v>
                </c:pt>
                <c:pt idx="100">
                  <c:v>32.445835000000002</c:v>
                </c:pt>
                <c:pt idx="101">
                  <c:v>32.184179999999998</c:v>
                </c:pt>
                <c:pt idx="102">
                  <c:v>31.833655</c:v>
                </c:pt>
                <c:pt idx="103">
                  <c:v>31.640499999999999</c:v>
                </c:pt>
                <c:pt idx="104">
                  <c:v>31.659175000000001</c:v>
                </c:pt>
                <c:pt idx="105">
                  <c:v>31.32677</c:v>
                </c:pt>
                <c:pt idx="106">
                  <c:v>31.105039999999995</c:v>
                </c:pt>
                <c:pt idx="107">
                  <c:v>31.02617</c:v>
                </c:pt>
                <c:pt idx="108">
                  <c:v>30.500045</c:v>
                </c:pt>
                <c:pt idx="109">
                  <c:v>30.373304999999998</c:v>
                </c:pt>
                <c:pt idx="110">
                  <c:v>30.20748</c:v>
                </c:pt>
                <c:pt idx="111">
                  <c:v>29.839075000000001</c:v>
                </c:pt>
                <c:pt idx="112">
                  <c:v>29.598089999999996</c:v>
                </c:pt>
                <c:pt idx="113">
                  <c:v>29.326310000000003</c:v>
                </c:pt>
                <c:pt idx="114">
                  <c:v>28.94183</c:v>
                </c:pt>
                <c:pt idx="115">
                  <c:v>28.525960000000005</c:v>
                </c:pt>
                <c:pt idx="116">
                  <c:v>28.228385000000003</c:v>
                </c:pt>
                <c:pt idx="117">
                  <c:v>27.930395000000001</c:v>
                </c:pt>
                <c:pt idx="118">
                  <c:v>27.762255</c:v>
                </c:pt>
                <c:pt idx="119">
                  <c:v>27.30097</c:v>
                </c:pt>
                <c:pt idx="120">
                  <c:v>27.114644999999999</c:v>
                </c:pt>
                <c:pt idx="121">
                  <c:v>26.69735</c:v>
                </c:pt>
                <c:pt idx="122">
                  <c:v>26.598689999999998</c:v>
                </c:pt>
                <c:pt idx="123">
                  <c:v>26.213370000000001</c:v>
                </c:pt>
                <c:pt idx="124">
                  <c:v>25.705060000000003</c:v>
                </c:pt>
                <c:pt idx="125">
                  <c:v>25.571939999999998</c:v>
                </c:pt>
                <c:pt idx="126">
                  <c:v>25.461549999999999</c:v>
                </c:pt>
                <c:pt idx="127">
                  <c:v>24.996439999999996</c:v>
                </c:pt>
                <c:pt idx="128">
                  <c:v>24.726189999999995</c:v>
                </c:pt>
                <c:pt idx="129">
                  <c:v>24.3230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902-4434-A054-9BB3996240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639744"/>
        <c:axId val="64641280"/>
      </c:lineChart>
      <c:catAx>
        <c:axId val="64639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641280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641280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6397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L$17:$CL$146</c:f>
              <c:numCache>
                <c:formatCode>0.00</c:formatCode>
                <c:ptCount val="130"/>
                <c:pt idx="0">
                  <c:v>13.759414999999997</c:v>
                </c:pt>
                <c:pt idx="1">
                  <c:v>18.383295</c:v>
                </c:pt>
                <c:pt idx="2">
                  <c:v>20.091279999999998</c:v>
                </c:pt>
                <c:pt idx="3">
                  <c:v>20.797845000000002</c:v>
                </c:pt>
                <c:pt idx="4">
                  <c:v>20.302545000000002</c:v>
                </c:pt>
                <c:pt idx="5">
                  <c:v>19.952279999999998</c:v>
                </c:pt>
                <c:pt idx="6">
                  <c:v>19.776945000000001</c:v>
                </c:pt>
                <c:pt idx="7">
                  <c:v>19.949945</c:v>
                </c:pt>
                <c:pt idx="8">
                  <c:v>21.224274999999999</c:v>
                </c:pt>
                <c:pt idx="9">
                  <c:v>23.335395000000002</c:v>
                </c:pt>
                <c:pt idx="10">
                  <c:v>26.668764999999997</c:v>
                </c:pt>
                <c:pt idx="11">
                  <c:v>32.582954999999998</c:v>
                </c:pt>
                <c:pt idx="12">
                  <c:v>40.347749999999998</c:v>
                </c:pt>
                <c:pt idx="13">
                  <c:v>50.015355</c:v>
                </c:pt>
                <c:pt idx="14">
                  <c:v>61.684610000000006</c:v>
                </c:pt>
                <c:pt idx="15">
                  <c:v>75.083844999999997</c:v>
                </c:pt>
                <c:pt idx="16">
                  <c:v>87.538775000000001</c:v>
                </c:pt>
                <c:pt idx="17">
                  <c:v>96.952419999999989</c:v>
                </c:pt>
                <c:pt idx="18">
                  <c:v>102.79258</c:v>
                </c:pt>
                <c:pt idx="19">
                  <c:v>104.83964499999999</c:v>
                </c:pt>
                <c:pt idx="20">
                  <c:v>104.37978000000001</c:v>
                </c:pt>
                <c:pt idx="21">
                  <c:v>101.14456000000001</c:v>
                </c:pt>
                <c:pt idx="22">
                  <c:v>97.475020000000001</c:v>
                </c:pt>
                <c:pt idx="23">
                  <c:v>92.768349999999998</c:v>
                </c:pt>
                <c:pt idx="24">
                  <c:v>87.343510000000009</c:v>
                </c:pt>
                <c:pt idx="25">
                  <c:v>81.828455000000005</c:v>
                </c:pt>
                <c:pt idx="26">
                  <c:v>75.386274999999998</c:v>
                </c:pt>
                <c:pt idx="27">
                  <c:v>69.839739999999992</c:v>
                </c:pt>
                <c:pt idx="28">
                  <c:v>64.211844999999997</c:v>
                </c:pt>
                <c:pt idx="29">
                  <c:v>58.825105000000008</c:v>
                </c:pt>
                <c:pt idx="30">
                  <c:v>53.874589999999991</c:v>
                </c:pt>
                <c:pt idx="31">
                  <c:v>50.450864999999993</c:v>
                </c:pt>
                <c:pt idx="32">
                  <c:v>48.437664999999996</c:v>
                </c:pt>
                <c:pt idx="33">
                  <c:v>48.012095000000002</c:v>
                </c:pt>
                <c:pt idx="34">
                  <c:v>49.829949999999997</c:v>
                </c:pt>
                <c:pt idx="35">
                  <c:v>51.815135000000005</c:v>
                </c:pt>
                <c:pt idx="36">
                  <c:v>55.069794999999992</c:v>
                </c:pt>
                <c:pt idx="37">
                  <c:v>58.321185000000007</c:v>
                </c:pt>
                <c:pt idx="38">
                  <c:v>62.001960000000011</c:v>
                </c:pt>
                <c:pt idx="39">
                  <c:v>64.419794999999993</c:v>
                </c:pt>
                <c:pt idx="40">
                  <c:v>65.649304999999998</c:v>
                </c:pt>
                <c:pt idx="41">
                  <c:v>65.368844999999993</c:v>
                </c:pt>
                <c:pt idx="42">
                  <c:v>63.451425</c:v>
                </c:pt>
                <c:pt idx="43">
                  <c:v>59.824950000000001</c:v>
                </c:pt>
                <c:pt idx="44">
                  <c:v>56.644539999999992</c:v>
                </c:pt>
                <c:pt idx="45">
                  <c:v>53.521174999999999</c:v>
                </c:pt>
                <c:pt idx="46">
                  <c:v>50.929310000000001</c:v>
                </c:pt>
                <c:pt idx="47">
                  <c:v>48.625250000000001</c:v>
                </c:pt>
                <c:pt idx="48">
                  <c:v>45.999410000000005</c:v>
                </c:pt>
                <c:pt idx="49">
                  <c:v>43.243904999999998</c:v>
                </c:pt>
                <c:pt idx="50">
                  <c:v>40.521324999999997</c:v>
                </c:pt>
                <c:pt idx="51">
                  <c:v>38.332000000000001</c:v>
                </c:pt>
                <c:pt idx="52">
                  <c:v>37.12097</c:v>
                </c:pt>
                <c:pt idx="53">
                  <c:v>36.310650000000003</c:v>
                </c:pt>
                <c:pt idx="54">
                  <c:v>36.341299999999997</c:v>
                </c:pt>
                <c:pt idx="55">
                  <c:v>36.939764999999994</c:v>
                </c:pt>
                <c:pt idx="56">
                  <c:v>38.203604999999996</c:v>
                </c:pt>
                <c:pt idx="57">
                  <c:v>39.869139999999994</c:v>
                </c:pt>
                <c:pt idx="58">
                  <c:v>41.042970000000004</c:v>
                </c:pt>
                <c:pt idx="59">
                  <c:v>42.111199999999997</c:v>
                </c:pt>
                <c:pt idx="60">
                  <c:v>43.087364999999998</c:v>
                </c:pt>
                <c:pt idx="61">
                  <c:v>43.536479999999997</c:v>
                </c:pt>
                <c:pt idx="62">
                  <c:v>42.994064999999999</c:v>
                </c:pt>
                <c:pt idx="63">
                  <c:v>42.265335</c:v>
                </c:pt>
                <c:pt idx="64">
                  <c:v>40.873575000000002</c:v>
                </c:pt>
                <c:pt idx="65">
                  <c:v>39.669560000000004</c:v>
                </c:pt>
                <c:pt idx="66">
                  <c:v>38.280854999999995</c:v>
                </c:pt>
                <c:pt idx="67">
                  <c:v>36.804450000000003</c:v>
                </c:pt>
                <c:pt idx="68">
                  <c:v>35.648164999999999</c:v>
                </c:pt>
                <c:pt idx="69">
                  <c:v>34.121889999999993</c:v>
                </c:pt>
                <c:pt idx="70">
                  <c:v>33.222304999999999</c:v>
                </c:pt>
                <c:pt idx="71">
                  <c:v>32.423695000000002</c:v>
                </c:pt>
                <c:pt idx="72">
                  <c:v>31.337289999999996</c:v>
                </c:pt>
                <c:pt idx="73">
                  <c:v>30.747145</c:v>
                </c:pt>
                <c:pt idx="74">
                  <c:v>30.63852</c:v>
                </c:pt>
                <c:pt idx="75">
                  <c:v>30.755354999999998</c:v>
                </c:pt>
                <c:pt idx="76">
                  <c:v>30.986360000000005</c:v>
                </c:pt>
                <c:pt idx="77">
                  <c:v>31.785055</c:v>
                </c:pt>
                <c:pt idx="78">
                  <c:v>31.757275</c:v>
                </c:pt>
                <c:pt idx="79">
                  <c:v>32.204799999999999</c:v>
                </c:pt>
                <c:pt idx="80">
                  <c:v>32.973935000000004</c:v>
                </c:pt>
                <c:pt idx="81">
                  <c:v>33.710599999999999</c:v>
                </c:pt>
                <c:pt idx="82">
                  <c:v>34.158735</c:v>
                </c:pt>
                <c:pt idx="83">
                  <c:v>34.234679999999997</c:v>
                </c:pt>
                <c:pt idx="84">
                  <c:v>34.221305000000001</c:v>
                </c:pt>
                <c:pt idx="85">
                  <c:v>34.145039999999995</c:v>
                </c:pt>
                <c:pt idx="86">
                  <c:v>33.471969999999999</c:v>
                </c:pt>
                <c:pt idx="87">
                  <c:v>32.770389999999999</c:v>
                </c:pt>
                <c:pt idx="88">
                  <c:v>31.863010000000003</c:v>
                </c:pt>
                <c:pt idx="89">
                  <c:v>30.62227</c:v>
                </c:pt>
                <c:pt idx="90">
                  <c:v>29.724225000000001</c:v>
                </c:pt>
                <c:pt idx="91">
                  <c:v>28.643614999999997</c:v>
                </c:pt>
                <c:pt idx="92">
                  <c:v>27.666964999999998</c:v>
                </c:pt>
                <c:pt idx="93">
                  <c:v>26.596235000000004</c:v>
                </c:pt>
                <c:pt idx="94">
                  <c:v>26.019220000000001</c:v>
                </c:pt>
                <c:pt idx="95">
                  <c:v>25.439170000000001</c:v>
                </c:pt>
                <c:pt idx="96">
                  <c:v>24.750989999999998</c:v>
                </c:pt>
                <c:pt idx="97">
                  <c:v>24.564225</c:v>
                </c:pt>
                <c:pt idx="98">
                  <c:v>24.440479999999997</c:v>
                </c:pt>
                <c:pt idx="99">
                  <c:v>25.027939999999997</c:v>
                </c:pt>
                <c:pt idx="100">
                  <c:v>25.183035000000004</c:v>
                </c:pt>
                <c:pt idx="101">
                  <c:v>25.729279999999999</c:v>
                </c:pt>
                <c:pt idx="102">
                  <c:v>26.119254999999999</c:v>
                </c:pt>
                <c:pt idx="103">
                  <c:v>26.1508</c:v>
                </c:pt>
                <c:pt idx="104">
                  <c:v>26.677275000000002</c:v>
                </c:pt>
                <c:pt idx="105">
                  <c:v>26.215170000000001</c:v>
                </c:pt>
                <c:pt idx="106">
                  <c:v>25.841839999999998</c:v>
                </c:pt>
                <c:pt idx="107">
                  <c:v>25.564070000000001</c:v>
                </c:pt>
                <c:pt idx="108">
                  <c:v>24.720145000000002</c:v>
                </c:pt>
                <c:pt idx="109">
                  <c:v>24.153504999999999</c:v>
                </c:pt>
                <c:pt idx="110">
                  <c:v>23.493479999999998</c:v>
                </c:pt>
                <c:pt idx="111">
                  <c:v>22.676175000000001</c:v>
                </c:pt>
                <c:pt idx="112">
                  <c:v>21.883389999999995</c:v>
                </c:pt>
                <c:pt idx="113">
                  <c:v>21.370710000000003</c:v>
                </c:pt>
                <c:pt idx="114">
                  <c:v>20.854029999999998</c:v>
                </c:pt>
                <c:pt idx="115">
                  <c:v>20.352360000000004</c:v>
                </c:pt>
                <c:pt idx="116">
                  <c:v>20.030785000000005</c:v>
                </c:pt>
                <c:pt idx="117">
                  <c:v>19.678295000000002</c:v>
                </c:pt>
                <c:pt idx="118">
                  <c:v>19.686454999999999</c:v>
                </c:pt>
                <c:pt idx="119">
                  <c:v>19.662269999999999</c:v>
                </c:pt>
                <c:pt idx="120">
                  <c:v>19.618345000000001</c:v>
                </c:pt>
                <c:pt idx="121">
                  <c:v>19.641449999999999</c:v>
                </c:pt>
                <c:pt idx="122">
                  <c:v>19.471789999999995</c:v>
                </c:pt>
                <c:pt idx="123">
                  <c:v>19.647870000000001</c:v>
                </c:pt>
                <c:pt idx="124">
                  <c:v>19.200760000000002</c:v>
                </c:pt>
                <c:pt idx="125">
                  <c:v>18.939639999999997</c:v>
                </c:pt>
                <c:pt idx="126">
                  <c:v>18.693650000000002</c:v>
                </c:pt>
                <c:pt idx="127">
                  <c:v>18.314539999999997</c:v>
                </c:pt>
                <c:pt idx="128">
                  <c:v>17.941189999999995</c:v>
                </c:pt>
                <c:pt idx="129">
                  <c:v>17.512604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0B1-41C2-B868-DBBF7B0CD828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M$17:$CM$146</c:f>
              <c:numCache>
                <c:formatCode>0.00</c:formatCode>
                <c:ptCount val="130"/>
                <c:pt idx="0">
                  <c:v>16.234414999999995</c:v>
                </c:pt>
                <c:pt idx="1">
                  <c:v>20.149995000000001</c:v>
                </c:pt>
                <c:pt idx="2">
                  <c:v>20.859079999999999</c:v>
                </c:pt>
                <c:pt idx="3">
                  <c:v>20.746845</c:v>
                </c:pt>
                <c:pt idx="4">
                  <c:v>19.823345</c:v>
                </c:pt>
                <c:pt idx="5">
                  <c:v>19.54888</c:v>
                </c:pt>
                <c:pt idx="6">
                  <c:v>20.686245</c:v>
                </c:pt>
                <c:pt idx="7">
                  <c:v>23.280345000000001</c:v>
                </c:pt>
                <c:pt idx="8">
                  <c:v>27.417574999999999</c:v>
                </c:pt>
                <c:pt idx="9">
                  <c:v>33.084495000000004</c:v>
                </c:pt>
                <c:pt idx="10">
                  <c:v>39.911064999999994</c:v>
                </c:pt>
                <c:pt idx="11">
                  <c:v>48.878954999999998</c:v>
                </c:pt>
                <c:pt idx="12">
                  <c:v>59.90605</c:v>
                </c:pt>
                <c:pt idx="13">
                  <c:v>72.72715500000001</c:v>
                </c:pt>
                <c:pt idx="14">
                  <c:v>87.720410000000015</c:v>
                </c:pt>
                <c:pt idx="15">
                  <c:v>102.426445</c:v>
                </c:pt>
                <c:pt idx="16">
                  <c:v>114.96487500000001</c:v>
                </c:pt>
                <c:pt idx="17">
                  <c:v>121.49451999999999</c:v>
                </c:pt>
                <c:pt idx="18">
                  <c:v>124.25368</c:v>
                </c:pt>
                <c:pt idx="19">
                  <c:v>123.918245</c:v>
                </c:pt>
                <c:pt idx="20">
                  <c:v>120.08228000000001</c:v>
                </c:pt>
                <c:pt idx="21">
                  <c:v>116.65766000000001</c:v>
                </c:pt>
                <c:pt idx="22">
                  <c:v>112.67971999999999</c:v>
                </c:pt>
                <c:pt idx="23">
                  <c:v>109.73745</c:v>
                </c:pt>
                <c:pt idx="24">
                  <c:v>103.16961000000001</c:v>
                </c:pt>
                <c:pt idx="25">
                  <c:v>96.030355</c:v>
                </c:pt>
                <c:pt idx="26">
                  <c:v>87.969875000000002</c:v>
                </c:pt>
                <c:pt idx="27">
                  <c:v>80.52033999999999</c:v>
                </c:pt>
                <c:pt idx="28">
                  <c:v>73.994744999999995</c:v>
                </c:pt>
                <c:pt idx="29">
                  <c:v>68.333005</c:v>
                </c:pt>
                <c:pt idx="30">
                  <c:v>63.698489999999993</c:v>
                </c:pt>
                <c:pt idx="31">
                  <c:v>60.367664999999988</c:v>
                </c:pt>
                <c:pt idx="32">
                  <c:v>58.921364999999987</c:v>
                </c:pt>
                <c:pt idx="33">
                  <c:v>59.373594999999995</c:v>
                </c:pt>
                <c:pt idx="34">
                  <c:v>62.023949999999999</c:v>
                </c:pt>
                <c:pt idx="35">
                  <c:v>65.076035000000005</c:v>
                </c:pt>
                <c:pt idx="36">
                  <c:v>68.44879499999999</c:v>
                </c:pt>
                <c:pt idx="37">
                  <c:v>70.909585000000007</c:v>
                </c:pt>
                <c:pt idx="38">
                  <c:v>73.239860000000007</c:v>
                </c:pt>
                <c:pt idx="39">
                  <c:v>73.25189499999999</c:v>
                </c:pt>
                <c:pt idx="40">
                  <c:v>72.121904999999998</c:v>
                </c:pt>
                <c:pt idx="41">
                  <c:v>70.447044999999989</c:v>
                </c:pt>
                <c:pt idx="42">
                  <c:v>67.567724999999996</c:v>
                </c:pt>
                <c:pt idx="43">
                  <c:v>64.771649999999994</c:v>
                </c:pt>
                <c:pt idx="44">
                  <c:v>61.197439999999993</c:v>
                </c:pt>
                <c:pt idx="45">
                  <c:v>58.165675</c:v>
                </c:pt>
                <c:pt idx="46">
                  <c:v>55.067510000000013</c:v>
                </c:pt>
                <c:pt idx="47">
                  <c:v>52.277549999999998</c:v>
                </c:pt>
                <c:pt idx="48">
                  <c:v>48.908410000000003</c:v>
                </c:pt>
                <c:pt idx="49">
                  <c:v>46.221505000000001</c:v>
                </c:pt>
                <c:pt idx="50">
                  <c:v>43.194324999999999</c:v>
                </c:pt>
                <c:pt idx="51">
                  <c:v>41.095100000000002</c:v>
                </c:pt>
                <c:pt idx="52">
                  <c:v>39.68927</c:v>
                </c:pt>
                <c:pt idx="53">
                  <c:v>39.330950000000001</c:v>
                </c:pt>
                <c:pt idx="54">
                  <c:v>39.462400000000002</c:v>
                </c:pt>
                <c:pt idx="55">
                  <c:v>40.813664999999993</c:v>
                </c:pt>
                <c:pt idx="56">
                  <c:v>42.666204999999998</c:v>
                </c:pt>
                <c:pt idx="57">
                  <c:v>44.958839999999995</c:v>
                </c:pt>
                <c:pt idx="58">
                  <c:v>46.201070000000001</c:v>
                </c:pt>
                <c:pt idx="59">
                  <c:v>47.252899999999997</c:v>
                </c:pt>
                <c:pt idx="60">
                  <c:v>47.321264999999997</c:v>
                </c:pt>
                <c:pt idx="61">
                  <c:v>46.644979999999997</c:v>
                </c:pt>
                <c:pt idx="62">
                  <c:v>45.932264999999994</c:v>
                </c:pt>
                <c:pt idx="63">
                  <c:v>44.646835000000003</c:v>
                </c:pt>
                <c:pt idx="64">
                  <c:v>43.226875</c:v>
                </c:pt>
                <c:pt idx="65">
                  <c:v>41.958160000000007</c:v>
                </c:pt>
                <c:pt idx="66">
                  <c:v>40.409554999999997</c:v>
                </c:pt>
                <c:pt idx="67">
                  <c:v>39.046250000000001</c:v>
                </c:pt>
                <c:pt idx="68">
                  <c:v>37.996164999999998</c:v>
                </c:pt>
                <c:pt idx="69">
                  <c:v>36.545789999999997</c:v>
                </c:pt>
                <c:pt idx="70">
                  <c:v>35.638104999999996</c:v>
                </c:pt>
                <c:pt idx="71">
                  <c:v>34.733795000000001</c:v>
                </c:pt>
                <c:pt idx="72">
                  <c:v>34.096889999999995</c:v>
                </c:pt>
                <c:pt idx="73">
                  <c:v>33.427244999999999</c:v>
                </c:pt>
                <c:pt idx="74">
                  <c:v>32.896720000000002</c:v>
                </c:pt>
                <c:pt idx="75">
                  <c:v>32.642854999999997</c:v>
                </c:pt>
                <c:pt idx="76">
                  <c:v>32.324260000000002</c:v>
                </c:pt>
                <c:pt idx="77">
                  <c:v>32.564155</c:v>
                </c:pt>
                <c:pt idx="78">
                  <c:v>32.648474999999998</c:v>
                </c:pt>
                <c:pt idx="79">
                  <c:v>33.187100000000001</c:v>
                </c:pt>
                <c:pt idx="80">
                  <c:v>33.626735000000004</c:v>
                </c:pt>
                <c:pt idx="81">
                  <c:v>34.306399999999996</c:v>
                </c:pt>
                <c:pt idx="82">
                  <c:v>34.685935000000001</c:v>
                </c:pt>
                <c:pt idx="83">
                  <c:v>34.680880000000002</c:v>
                </c:pt>
                <c:pt idx="84">
                  <c:v>34.420105</c:v>
                </c:pt>
                <c:pt idx="85">
                  <c:v>34.338739999999994</c:v>
                </c:pt>
                <c:pt idx="86">
                  <c:v>33.398670000000003</c:v>
                </c:pt>
                <c:pt idx="87">
                  <c:v>32.186689999999999</c:v>
                </c:pt>
                <c:pt idx="88">
                  <c:v>31.300610000000002</c:v>
                </c:pt>
                <c:pt idx="89">
                  <c:v>30.13907</c:v>
                </c:pt>
                <c:pt idx="90">
                  <c:v>29.445724999999999</c:v>
                </c:pt>
                <c:pt idx="91">
                  <c:v>28.560614999999995</c:v>
                </c:pt>
                <c:pt idx="92">
                  <c:v>27.563464999999997</c:v>
                </c:pt>
                <c:pt idx="93">
                  <c:v>26.879835000000003</c:v>
                </c:pt>
                <c:pt idx="94">
                  <c:v>26.47972</c:v>
                </c:pt>
                <c:pt idx="95">
                  <c:v>26.002370000000003</c:v>
                </c:pt>
                <c:pt idx="96">
                  <c:v>25.540389999999995</c:v>
                </c:pt>
                <c:pt idx="97">
                  <c:v>25.683624999999999</c:v>
                </c:pt>
                <c:pt idx="98">
                  <c:v>25.753979999999999</c:v>
                </c:pt>
                <c:pt idx="99">
                  <c:v>26.112939999999998</c:v>
                </c:pt>
                <c:pt idx="100">
                  <c:v>26.257435000000005</c:v>
                </c:pt>
                <c:pt idx="101">
                  <c:v>26.29618</c:v>
                </c:pt>
                <c:pt idx="102">
                  <c:v>26.121755</c:v>
                </c:pt>
                <c:pt idx="103">
                  <c:v>25.8932</c:v>
                </c:pt>
                <c:pt idx="104">
                  <c:v>25.783075</c:v>
                </c:pt>
                <c:pt idx="105">
                  <c:v>25.316270000000003</c:v>
                </c:pt>
                <c:pt idx="106">
                  <c:v>24.641639999999995</c:v>
                </c:pt>
                <c:pt idx="107">
                  <c:v>24.088070000000002</c:v>
                </c:pt>
                <c:pt idx="108">
                  <c:v>23.181345</c:v>
                </c:pt>
                <c:pt idx="109">
                  <c:v>22.616104999999997</c:v>
                </c:pt>
                <c:pt idx="110">
                  <c:v>21.929179999999999</c:v>
                </c:pt>
                <c:pt idx="111">
                  <c:v>21.599374999999998</c:v>
                </c:pt>
                <c:pt idx="112">
                  <c:v>20.942389999999996</c:v>
                </c:pt>
                <c:pt idx="113">
                  <c:v>20.650110000000005</c:v>
                </c:pt>
                <c:pt idx="114">
                  <c:v>20.227229999999999</c:v>
                </c:pt>
                <c:pt idx="115">
                  <c:v>20.119760000000003</c:v>
                </c:pt>
                <c:pt idx="116">
                  <c:v>20.189285000000005</c:v>
                </c:pt>
                <c:pt idx="117">
                  <c:v>20.089695000000003</c:v>
                </c:pt>
                <c:pt idx="118">
                  <c:v>20.159855</c:v>
                </c:pt>
                <c:pt idx="119">
                  <c:v>20.37397</c:v>
                </c:pt>
                <c:pt idx="120">
                  <c:v>20.348645000000001</c:v>
                </c:pt>
                <c:pt idx="121">
                  <c:v>20.467549999999999</c:v>
                </c:pt>
                <c:pt idx="122">
                  <c:v>20.368489999999998</c:v>
                </c:pt>
                <c:pt idx="123">
                  <c:v>20.493570000000002</c:v>
                </c:pt>
                <c:pt idx="124">
                  <c:v>20.135760000000005</c:v>
                </c:pt>
                <c:pt idx="125">
                  <c:v>19.949439999999996</c:v>
                </c:pt>
                <c:pt idx="126">
                  <c:v>19.651050000000001</c:v>
                </c:pt>
                <c:pt idx="127">
                  <c:v>19.286039999999996</c:v>
                </c:pt>
                <c:pt idx="128">
                  <c:v>18.886189999999996</c:v>
                </c:pt>
                <c:pt idx="129">
                  <c:v>18.4301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0B1-41C2-B868-DBBF7B0CD828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N$17:$CN$146</c:f>
              <c:numCache>
                <c:formatCode>0.00</c:formatCode>
                <c:ptCount val="130"/>
                <c:pt idx="0">
                  <c:v>16.714714999999998</c:v>
                </c:pt>
                <c:pt idx="1">
                  <c:v>21.174295000000001</c:v>
                </c:pt>
                <c:pt idx="2">
                  <c:v>21.25508</c:v>
                </c:pt>
                <c:pt idx="3">
                  <c:v>20.716045000000001</c:v>
                </c:pt>
                <c:pt idx="4">
                  <c:v>20.009745000000002</c:v>
                </c:pt>
                <c:pt idx="5">
                  <c:v>19.414179999999998</c:v>
                </c:pt>
                <c:pt idx="6">
                  <c:v>18.977845000000002</c:v>
                </c:pt>
                <c:pt idx="7">
                  <c:v>18.846945000000002</c:v>
                </c:pt>
                <c:pt idx="8">
                  <c:v>19.138774999999999</c:v>
                </c:pt>
                <c:pt idx="9">
                  <c:v>20.225095</c:v>
                </c:pt>
                <c:pt idx="10">
                  <c:v>22.353764999999996</c:v>
                </c:pt>
                <c:pt idx="11">
                  <c:v>26.269955</c:v>
                </c:pt>
                <c:pt idx="12">
                  <c:v>32.094650000000001</c:v>
                </c:pt>
                <c:pt idx="13">
                  <c:v>39.846854999999998</c:v>
                </c:pt>
                <c:pt idx="14">
                  <c:v>49.912910000000004</c:v>
                </c:pt>
                <c:pt idx="15">
                  <c:v>61.275344999999994</c:v>
                </c:pt>
                <c:pt idx="16">
                  <c:v>73.964974999999995</c:v>
                </c:pt>
                <c:pt idx="17">
                  <c:v>84.948920000000001</c:v>
                </c:pt>
                <c:pt idx="18">
                  <c:v>91.84308</c:v>
                </c:pt>
                <c:pt idx="19">
                  <c:v>95.048445000000001</c:v>
                </c:pt>
                <c:pt idx="20">
                  <c:v>94.61948000000001</c:v>
                </c:pt>
                <c:pt idx="21">
                  <c:v>92.374060000000014</c:v>
                </c:pt>
                <c:pt idx="22">
                  <c:v>88.41561999999999</c:v>
                </c:pt>
                <c:pt idx="23">
                  <c:v>83.938550000000006</c:v>
                </c:pt>
                <c:pt idx="24">
                  <c:v>78.455510000000004</c:v>
                </c:pt>
                <c:pt idx="25">
                  <c:v>72.90865500000001</c:v>
                </c:pt>
                <c:pt idx="26">
                  <c:v>67.882075</c:v>
                </c:pt>
                <c:pt idx="27">
                  <c:v>63.048339999999989</c:v>
                </c:pt>
                <c:pt idx="28">
                  <c:v>57.579344999999996</c:v>
                </c:pt>
                <c:pt idx="29">
                  <c:v>52.814305000000004</c:v>
                </c:pt>
                <c:pt idx="30">
                  <c:v>48.531189999999995</c:v>
                </c:pt>
                <c:pt idx="31">
                  <c:v>44.797964999999998</c:v>
                </c:pt>
                <c:pt idx="32">
                  <c:v>42.227264999999996</c:v>
                </c:pt>
                <c:pt idx="33">
                  <c:v>41.004595000000002</c:v>
                </c:pt>
                <c:pt idx="34">
                  <c:v>41.704749999999997</c:v>
                </c:pt>
                <c:pt idx="35">
                  <c:v>43.410335000000003</c:v>
                </c:pt>
                <c:pt idx="36">
                  <c:v>47.061295000000001</c:v>
                </c:pt>
                <c:pt idx="37">
                  <c:v>50.226685000000003</c:v>
                </c:pt>
                <c:pt idx="38">
                  <c:v>53.054460000000006</c:v>
                </c:pt>
                <c:pt idx="39">
                  <c:v>55.205494999999992</c:v>
                </c:pt>
                <c:pt idx="40">
                  <c:v>57.741705000000003</c:v>
                </c:pt>
                <c:pt idx="41">
                  <c:v>60.623744999999992</c:v>
                </c:pt>
                <c:pt idx="42">
                  <c:v>61.665824999999998</c:v>
                </c:pt>
                <c:pt idx="43">
                  <c:v>60.801850000000002</c:v>
                </c:pt>
                <c:pt idx="44">
                  <c:v>58.720639999999989</c:v>
                </c:pt>
                <c:pt idx="45">
                  <c:v>56.257874999999999</c:v>
                </c:pt>
                <c:pt idx="46">
                  <c:v>53.272110000000012</c:v>
                </c:pt>
                <c:pt idx="47">
                  <c:v>50.846249999999998</c:v>
                </c:pt>
                <c:pt idx="48">
                  <c:v>48.408410000000003</c:v>
                </c:pt>
                <c:pt idx="49">
                  <c:v>45.682904999999998</c:v>
                </c:pt>
                <c:pt idx="50">
                  <c:v>42.939324999999997</c:v>
                </c:pt>
                <c:pt idx="51">
                  <c:v>41.173200000000001</c:v>
                </c:pt>
                <c:pt idx="52">
                  <c:v>39.570270000000001</c:v>
                </c:pt>
                <c:pt idx="53">
                  <c:v>38.775149999999996</c:v>
                </c:pt>
                <c:pt idx="54">
                  <c:v>38.938400000000001</c:v>
                </c:pt>
                <c:pt idx="55">
                  <c:v>39.855764999999998</c:v>
                </c:pt>
                <c:pt idx="56">
                  <c:v>41.694904999999999</c:v>
                </c:pt>
                <c:pt idx="57">
                  <c:v>43.891639999999995</c:v>
                </c:pt>
                <c:pt idx="58">
                  <c:v>46.422370000000001</c:v>
                </c:pt>
                <c:pt idx="59">
                  <c:v>48.330500000000001</c:v>
                </c:pt>
                <c:pt idx="60">
                  <c:v>50.015764999999995</c:v>
                </c:pt>
                <c:pt idx="61">
                  <c:v>51.509979999999999</c:v>
                </c:pt>
                <c:pt idx="62">
                  <c:v>51.716664999999999</c:v>
                </c:pt>
                <c:pt idx="63">
                  <c:v>51.121235000000006</c:v>
                </c:pt>
                <c:pt idx="64">
                  <c:v>49.433275000000002</c:v>
                </c:pt>
                <c:pt idx="65">
                  <c:v>47.541460000000001</c:v>
                </c:pt>
                <c:pt idx="66">
                  <c:v>45.777854999999995</c:v>
                </c:pt>
                <c:pt idx="67">
                  <c:v>43.517249999999997</c:v>
                </c:pt>
                <c:pt idx="68">
                  <c:v>42.810964999999996</c:v>
                </c:pt>
                <c:pt idx="69">
                  <c:v>39.261589999999998</c:v>
                </c:pt>
                <c:pt idx="70">
                  <c:v>38.238005000000001</c:v>
                </c:pt>
                <c:pt idx="71">
                  <c:v>36.466095000000003</c:v>
                </c:pt>
                <c:pt idx="72">
                  <c:v>35.459089999999996</c:v>
                </c:pt>
                <c:pt idx="73">
                  <c:v>34.807545000000005</c:v>
                </c:pt>
                <c:pt idx="74">
                  <c:v>34.990120000000005</c:v>
                </c:pt>
                <c:pt idx="75">
                  <c:v>35.305954999999997</c:v>
                </c:pt>
                <c:pt idx="76">
                  <c:v>35.686860000000003</c:v>
                </c:pt>
                <c:pt idx="77">
                  <c:v>36.091555</c:v>
                </c:pt>
                <c:pt idx="78">
                  <c:v>36.930475000000001</c:v>
                </c:pt>
                <c:pt idx="79">
                  <c:v>37.847700000000003</c:v>
                </c:pt>
                <c:pt idx="80">
                  <c:v>38.974935000000002</c:v>
                </c:pt>
                <c:pt idx="81">
                  <c:v>39.770200000000003</c:v>
                </c:pt>
                <c:pt idx="82">
                  <c:v>40.491035000000004</c:v>
                </c:pt>
                <c:pt idx="83">
                  <c:v>40.711680000000001</c:v>
                </c:pt>
                <c:pt idx="84">
                  <c:v>40.154004999999998</c:v>
                </c:pt>
                <c:pt idx="85">
                  <c:v>40.287139999999994</c:v>
                </c:pt>
                <c:pt idx="86">
                  <c:v>39.924570000000003</c:v>
                </c:pt>
                <c:pt idx="87">
                  <c:v>38.900989999999993</c:v>
                </c:pt>
                <c:pt idx="88">
                  <c:v>38.295110000000001</c:v>
                </c:pt>
                <c:pt idx="89">
                  <c:v>37.641870000000004</c:v>
                </c:pt>
                <c:pt idx="90">
                  <c:v>36.915525000000002</c:v>
                </c:pt>
                <c:pt idx="91">
                  <c:v>36.066014999999993</c:v>
                </c:pt>
                <c:pt idx="92">
                  <c:v>35.168965</c:v>
                </c:pt>
                <c:pt idx="93">
                  <c:v>34.626035000000002</c:v>
                </c:pt>
                <c:pt idx="94">
                  <c:v>33.811019999999999</c:v>
                </c:pt>
                <c:pt idx="95">
                  <c:v>33.361170000000001</c:v>
                </c:pt>
                <c:pt idx="96">
                  <c:v>33.245989999999999</c:v>
                </c:pt>
                <c:pt idx="97">
                  <c:v>33.081724999999999</c:v>
                </c:pt>
                <c:pt idx="98">
                  <c:v>32.848379999999999</c:v>
                </c:pt>
                <c:pt idx="99">
                  <c:v>32.824539999999999</c:v>
                </c:pt>
                <c:pt idx="100">
                  <c:v>32.481835000000004</c:v>
                </c:pt>
                <c:pt idx="101">
                  <c:v>32.082679999999996</c:v>
                </c:pt>
                <c:pt idx="102">
                  <c:v>31.669654999999999</c:v>
                </c:pt>
                <c:pt idx="103">
                  <c:v>31.103999999999999</c:v>
                </c:pt>
                <c:pt idx="104">
                  <c:v>30.651875</c:v>
                </c:pt>
                <c:pt idx="105">
                  <c:v>29.948869999999999</c:v>
                </c:pt>
                <c:pt idx="106">
                  <c:v>29.174439999999997</c:v>
                </c:pt>
                <c:pt idx="107">
                  <c:v>28.548670000000001</c:v>
                </c:pt>
                <c:pt idx="108">
                  <c:v>27.835545</c:v>
                </c:pt>
                <c:pt idx="109">
                  <c:v>27.013904999999998</c:v>
                </c:pt>
                <c:pt idx="110">
                  <c:v>26.40268</c:v>
                </c:pt>
                <c:pt idx="111">
                  <c:v>25.853974999999998</c:v>
                </c:pt>
                <c:pt idx="112">
                  <c:v>25.564689999999995</c:v>
                </c:pt>
                <c:pt idx="113">
                  <c:v>25.176310000000004</c:v>
                </c:pt>
                <c:pt idx="114">
                  <c:v>24.766629999999999</c:v>
                </c:pt>
                <c:pt idx="115">
                  <c:v>24.681760000000004</c:v>
                </c:pt>
                <c:pt idx="116">
                  <c:v>24.855185000000002</c:v>
                </c:pt>
                <c:pt idx="117">
                  <c:v>24.794695000000001</c:v>
                </c:pt>
                <c:pt idx="118">
                  <c:v>25.009954999999998</c:v>
                </c:pt>
                <c:pt idx="119">
                  <c:v>25.250870000000003</c:v>
                </c:pt>
                <c:pt idx="120">
                  <c:v>25.493245000000002</c:v>
                </c:pt>
                <c:pt idx="121">
                  <c:v>25.527950000000001</c:v>
                </c:pt>
                <c:pt idx="122">
                  <c:v>25.686089999999997</c:v>
                </c:pt>
                <c:pt idx="123">
                  <c:v>25.868370000000002</c:v>
                </c:pt>
                <c:pt idx="124">
                  <c:v>25.749160000000003</c:v>
                </c:pt>
                <c:pt idx="125">
                  <c:v>25.566639999999996</c:v>
                </c:pt>
                <c:pt idx="126">
                  <c:v>25.222149999999999</c:v>
                </c:pt>
                <c:pt idx="127">
                  <c:v>24.945539999999998</c:v>
                </c:pt>
                <c:pt idx="128">
                  <c:v>24.552089999999996</c:v>
                </c:pt>
                <c:pt idx="129">
                  <c:v>24.0098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0B1-41C2-B868-DBBF7B0CD8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662528"/>
        <c:axId val="64668416"/>
      </c:lineChart>
      <c:catAx>
        <c:axId val="64662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66841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66841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662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I$17:$CI$146</c:f>
              <c:numCache>
                <c:formatCode>0.00</c:formatCode>
                <c:ptCount val="130"/>
                <c:pt idx="0">
                  <c:v>40.799014999999997</c:v>
                </c:pt>
                <c:pt idx="1">
                  <c:v>45.106295000000003</c:v>
                </c:pt>
                <c:pt idx="2">
                  <c:v>44.899180000000001</c:v>
                </c:pt>
                <c:pt idx="3">
                  <c:v>44.559545</c:v>
                </c:pt>
                <c:pt idx="4">
                  <c:v>43.689444999999999</c:v>
                </c:pt>
                <c:pt idx="5">
                  <c:v>41.910379999999996</c:v>
                </c:pt>
                <c:pt idx="6">
                  <c:v>39.730544999999999</c:v>
                </c:pt>
                <c:pt idx="7">
                  <c:v>37.131945000000002</c:v>
                </c:pt>
                <c:pt idx="8">
                  <c:v>35.047874999999998</c:v>
                </c:pt>
                <c:pt idx="9">
                  <c:v>32.884495000000001</c:v>
                </c:pt>
                <c:pt idx="10">
                  <c:v>31.456464999999998</c:v>
                </c:pt>
                <c:pt idx="11">
                  <c:v>30.724854999999998</c:v>
                </c:pt>
                <c:pt idx="12">
                  <c:v>32.207650000000001</c:v>
                </c:pt>
                <c:pt idx="13">
                  <c:v>33.978854999999996</c:v>
                </c:pt>
                <c:pt idx="14">
                  <c:v>39.258710000000001</c:v>
                </c:pt>
                <c:pt idx="15">
                  <c:v>46.490845</c:v>
                </c:pt>
                <c:pt idx="16">
                  <c:v>56.447375000000001</c:v>
                </c:pt>
                <c:pt idx="17">
                  <c:v>67.716920000000002</c:v>
                </c:pt>
                <c:pt idx="18">
                  <c:v>80.926580000000001</c:v>
                </c:pt>
                <c:pt idx="19">
                  <c:v>95.519644999999997</c:v>
                </c:pt>
                <c:pt idx="20">
                  <c:v>110.99088</c:v>
                </c:pt>
                <c:pt idx="21">
                  <c:v>123.29676000000001</c:v>
                </c:pt>
                <c:pt idx="22">
                  <c:v>130.33572000000001</c:v>
                </c:pt>
                <c:pt idx="23">
                  <c:v>134.09475</c:v>
                </c:pt>
                <c:pt idx="24">
                  <c:v>132.09001000000001</c:v>
                </c:pt>
                <c:pt idx="25">
                  <c:v>128.42745500000001</c:v>
                </c:pt>
                <c:pt idx="26">
                  <c:v>122.61767500000001</c:v>
                </c:pt>
                <c:pt idx="27">
                  <c:v>116.80653999999998</c:v>
                </c:pt>
                <c:pt idx="28">
                  <c:v>110.826245</c:v>
                </c:pt>
                <c:pt idx="29">
                  <c:v>105.139505</c:v>
                </c:pt>
                <c:pt idx="30">
                  <c:v>99.51218999999999</c:v>
                </c:pt>
                <c:pt idx="31">
                  <c:v>94.369564999999994</c:v>
                </c:pt>
                <c:pt idx="32">
                  <c:v>90.539564999999996</c:v>
                </c:pt>
                <c:pt idx="33">
                  <c:v>86.567394999999991</c:v>
                </c:pt>
                <c:pt idx="34">
                  <c:v>82.492750000000001</c:v>
                </c:pt>
                <c:pt idx="35">
                  <c:v>79.258335000000002</c:v>
                </c:pt>
                <c:pt idx="36">
                  <c:v>77.176895000000002</c:v>
                </c:pt>
                <c:pt idx="37">
                  <c:v>74.901285000000016</c:v>
                </c:pt>
                <c:pt idx="38">
                  <c:v>73.417660000000012</c:v>
                </c:pt>
                <c:pt idx="39">
                  <c:v>72.314594999999997</c:v>
                </c:pt>
                <c:pt idx="40">
                  <c:v>70.558605</c:v>
                </c:pt>
                <c:pt idx="41">
                  <c:v>70.551344999999998</c:v>
                </c:pt>
                <c:pt idx="42">
                  <c:v>71.922224999999997</c:v>
                </c:pt>
                <c:pt idx="43">
                  <c:v>74.194850000000002</c:v>
                </c:pt>
                <c:pt idx="44">
                  <c:v>75.566539999999989</c:v>
                </c:pt>
                <c:pt idx="45">
                  <c:v>77.050674999999998</c:v>
                </c:pt>
                <c:pt idx="46">
                  <c:v>79.296410000000009</c:v>
                </c:pt>
                <c:pt idx="47">
                  <c:v>81.326149999999998</c:v>
                </c:pt>
                <c:pt idx="48">
                  <c:v>82.95271000000001</c:v>
                </c:pt>
                <c:pt idx="49">
                  <c:v>85.018304999999998</c:v>
                </c:pt>
                <c:pt idx="50">
                  <c:v>85.566824999999994</c:v>
                </c:pt>
                <c:pt idx="51">
                  <c:v>85.067700000000002</c:v>
                </c:pt>
                <c:pt idx="52">
                  <c:v>84.079070000000002</c:v>
                </c:pt>
                <c:pt idx="53">
                  <c:v>82.089550000000003</c:v>
                </c:pt>
                <c:pt idx="54">
                  <c:v>80.2196</c:v>
                </c:pt>
                <c:pt idx="55">
                  <c:v>78.63956499999999</c:v>
                </c:pt>
                <c:pt idx="56">
                  <c:v>76.809905000000001</c:v>
                </c:pt>
                <c:pt idx="57">
                  <c:v>74.179939999999988</c:v>
                </c:pt>
                <c:pt idx="58">
                  <c:v>71.483969999999999</c:v>
                </c:pt>
                <c:pt idx="59">
                  <c:v>69.165400000000005</c:v>
                </c:pt>
                <c:pt idx="60">
                  <c:v>66.662964999999986</c:v>
                </c:pt>
                <c:pt idx="61">
                  <c:v>65.134979999999999</c:v>
                </c:pt>
                <c:pt idx="62">
                  <c:v>63.846564999999991</c:v>
                </c:pt>
                <c:pt idx="63">
                  <c:v>63.086735000000012</c:v>
                </c:pt>
                <c:pt idx="64">
                  <c:v>62.250374999999998</c:v>
                </c:pt>
                <c:pt idx="65">
                  <c:v>62.188160000000011</c:v>
                </c:pt>
                <c:pt idx="66">
                  <c:v>62.740255000000005</c:v>
                </c:pt>
                <c:pt idx="67">
                  <c:v>63.131549999999997</c:v>
                </c:pt>
                <c:pt idx="68">
                  <c:v>63.944364999999991</c:v>
                </c:pt>
                <c:pt idx="69">
                  <c:v>64.414889999999986</c:v>
                </c:pt>
                <c:pt idx="70">
                  <c:v>65.19930500000001</c:v>
                </c:pt>
                <c:pt idx="71">
                  <c:v>65.403795000000002</c:v>
                </c:pt>
                <c:pt idx="72">
                  <c:v>65.695789999999988</c:v>
                </c:pt>
                <c:pt idx="73">
                  <c:v>65.588944999999995</c:v>
                </c:pt>
                <c:pt idx="74">
                  <c:v>64.907519999999991</c:v>
                </c:pt>
                <c:pt idx="75">
                  <c:v>64.79135500000001</c:v>
                </c:pt>
                <c:pt idx="76">
                  <c:v>63.519160000000007</c:v>
                </c:pt>
                <c:pt idx="77">
                  <c:v>62.132255000000008</c:v>
                </c:pt>
                <c:pt idx="78">
                  <c:v>60.644674999999999</c:v>
                </c:pt>
                <c:pt idx="79">
                  <c:v>59.283299999999997</c:v>
                </c:pt>
                <c:pt idx="80">
                  <c:v>58.042835000000011</c:v>
                </c:pt>
                <c:pt idx="81">
                  <c:v>56.620199999999997</c:v>
                </c:pt>
                <c:pt idx="82">
                  <c:v>55.228535000000008</c:v>
                </c:pt>
                <c:pt idx="83">
                  <c:v>53.678980000000003</c:v>
                </c:pt>
                <c:pt idx="84">
                  <c:v>52.705605000000006</c:v>
                </c:pt>
                <c:pt idx="85">
                  <c:v>51.791239999999995</c:v>
                </c:pt>
                <c:pt idx="86">
                  <c:v>51.059069999999998</c:v>
                </c:pt>
                <c:pt idx="87">
                  <c:v>50.338989999999995</c:v>
                </c:pt>
                <c:pt idx="88">
                  <c:v>50.414710000000007</c:v>
                </c:pt>
                <c:pt idx="89">
                  <c:v>49.700569999999999</c:v>
                </c:pt>
                <c:pt idx="90">
                  <c:v>49.619925000000002</c:v>
                </c:pt>
                <c:pt idx="91">
                  <c:v>49.747515</c:v>
                </c:pt>
                <c:pt idx="92">
                  <c:v>49.741564999999994</c:v>
                </c:pt>
                <c:pt idx="93">
                  <c:v>49.686335000000007</c:v>
                </c:pt>
                <c:pt idx="94">
                  <c:v>49.964120000000001</c:v>
                </c:pt>
                <c:pt idx="95">
                  <c:v>50.249270000000003</c:v>
                </c:pt>
                <c:pt idx="96">
                  <c:v>49.682389999999998</c:v>
                </c:pt>
                <c:pt idx="97">
                  <c:v>49.905124999999998</c:v>
                </c:pt>
                <c:pt idx="98">
                  <c:v>49.363979999999998</c:v>
                </c:pt>
                <c:pt idx="99">
                  <c:v>48.597839999999998</c:v>
                </c:pt>
                <c:pt idx="100">
                  <c:v>47.533035000000005</c:v>
                </c:pt>
                <c:pt idx="101">
                  <c:v>47.024879999999996</c:v>
                </c:pt>
                <c:pt idx="102">
                  <c:v>45.774355</c:v>
                </c:pt>
                <c:pt idx="103">
                  <c:v>44.7044</c:v>
                </c:pt>
                <c:pt idx="104">
                  <c:v>44.430075000000002</c:v>
                </c:pt>
                <c:pt idx="105">
                  <c:v>43.174469999999999</c:v>
                </c:pt>
                <c:pt idx="106">
                  <c:v>42.267739999999996</c:v>
                </c:pt>
                <c:pt idx="107">
                  <c:v>41.687870000000004</c:v>
                </c:pt>
                <c:pt idx="108">
                  <c:v>41.133745000000005</c:v>
                </c:pt>
                <c:pt idx="109">
                  <c:v>40.431905</c:v>
                </c:pt>
                <c:pt idx="110">
                  <c:v>40.440779999999997</c:v>
                </c:pt>
                <c:pt idx="111">
                  <c:v>40.146374999999999</c:v>
                </c:pt>
                <c:pt idx="112">
                  <c:v>39.764989999999997</c:v>
                </c:pt>
                <c:pt idx="113">
                  <c:v>39.759510000000006</c:v>
                </c:pt>
                <c:pt idx="114">
                  <c:v>39.812429999999999</c:v>
                </c:pt>
                <c:pt idx="115">
                  <c:v>40.020660000000007</c:v>
                </c:pt>
                <c:pt idx="116">
                  <c:v>40.356885000000005</c:v>
                </c:pt>
                <c:pt idx="117">
                  <c:v>39.999195</c:v>
                </c:pt>
                <c:pt idx="118">
                  <c:v>39.838054999999997</c:v>
                </c:pt>
                <c:pt idx="119">
                  <c:v>39.77787</c:v>
                </c:pt>
                <c:pt idx="120">
                  <c:v>39.527545000000003</c:v>
                </c:pt>
                <c:pt idx="121">
                  <c:v>39.262450000000001</c:v>
                </c:pt>
                <c:pt idx="122">
                  <c:v>38.970389999999995</c:v>
                </c:pt>
                <c:pt idx="123">
                  <c:v>39.112169999999999</c:v>
                </c:pt>
                <c:pt idx="124">
                  <c:v>37.891860000000001</c:v>
                </c:pt>
                <c:pt idx="125">
                  <c:v>37.562339999999999</c:v>
                </c:pt>
                <c:pt idx="126">
                  <c:v>36.895249999999997</c:v>
                </c:pt>
                <c:pt idx="127">
                  <c:v>36.547539999999998</c:v>
                </c:pt>
                <c:pt idx="128">
                  <c:v>36.271989999999995</c:v>
                </c:pt>
                <c:pt idx="129">
                  <c:v>35.7422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D49-439F-B561-03FE5C4B2F31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J$17:$CJ$146</c:f>
              <c:numCache>
                <c:formatCode>0.00</c:formatCode>
                <c:ptCount val="130"/>
                <c:pt idx="0">
                  <c:v>39.613914999999999</c:v>
                </c:pt>
                <c:pt idx="1">
                  <c:v>44.342395000000003</c:v>
                </c:pt>
                <c:pt idx="2">
                  <c:v>43.957479999999997</c:v>
                </c:pt>
                <c:pt idx="3">
                  <c:v>42.635845000000003</c:v>
                </c:pt>
                <c:pt idx="4">
                  <c:v>40.000245</c:v>
                </c:pt>
                <c:pt idx="5">
                  <c:v>36.528280000000002</c:v>
                </c:pt>
                <c:pt idx="6">
                  <c:v>33.202145000000002</c:v>
                </c:pt>
                <c:pt idx="7">
                  <c:v>30.034645000000001</c:v>
                </c:pt>
                <c:pt idx="8">
                  <c:v>27.575074999999998</c:v>
                </c:pt>
                <c:pt idx="9">
                  <c:v>25.480795000000001</c:v>
                </c:pt>
                <c:pt idx="10">
                  <c:v>24.019564999999997</c:v>
                </c:pt>
                <c:pt idx="11">
                  <c:v>23.164254999999997</c:v>
                </c:pt>
                <c:pt idx="12">
                  <c:v>23.556450000000002</c:v>
                </c:pt>
                <c:pt idx="13">
                  <c:v>26.465954999999997</c:v>
                </c:pt>
                <c:pt idx="14">
                  <c:v>31.908210000000004</c:v>
                </c:pt>
                <c:pt idx="15">
                  <c:v>41.151845000000002</c:v>
                </c:pt>
                <c:pt idx="16">
                  <c:v>52.773575000000001</c:v>
                </c:pt>
                <c:pt idx="17">
                  <c:v>66.706819999999993</c:v>
                </c:pt>
                <c:pt idx="18">
                  <c:v>83.263580000000005</c:v>
                </c:pt>
                <c:pt idx="19">
                  <c:v>102.16764499999999</c:v>
                </c:pt>
                <c:pt idx="20">
                  <c:v>122.37828</c:v>
                </c:pt>
                <c:pt idx="21">
                  <c:v>136.78366</c:v>
                </c:pt>
                <c:pt idx="22">
                  <c:v>146.35712000000001</c:v>
                </c:pt>
                <c:pt idx="23">
                  <c:v>149.16295</c:v>
                </c:pt>
                <c:pt idx="24">
                  <c:v>145.10501000000002</c:v>
                </c:pt>
                <c:pt idx="25">
                  <c:v>137.62515500000001</c:v>
                </c:pt>
                <c:pt idx="26">
                  <c:v>129.659875</c:v>
                </c:pt>
                <c:pt idx="27">
                  <c:v>120.87024</c:v>
                </c:pt>
                <c:pt idx="28">
                  <c:v>113.21774499999999</c:v>
                </c:pt>
                <c:pt idx="29">
                  <c:v>105.40000500000001</c:v>
                </c:pt>
                <c:pt idx="30">
                  <c:v>98.530689999999993</c:v>
                </c:pt>
                <c:pt idx="31">
                  <c:v>92.108164999999985</c:v>
                </c:pt>
                <c:pt idx="32">
                  <c:v>86.444264999999987</c:v>
                </c:pt>
                <c:pt idx="33">
                  <c:v>81.155294999999995</c:v>
                </c:pt>
                <c:pt idx="34">
                  <c:v>77.206050000000005</c:v>
                </c:pt>
                <c:pt idx="35">
                  <c:v>73.426835000000011</c:v>
                </c:pt>
                <c:pt idx="36">
                  <c:v>69.768294999999995</c:v>
                </c:pt>
                <c:pt idx="37">
                  <c:v>66.233885000000015</c:v>
                </c:pt>
                <c:pt idx="38">
                  <c:v>63.506460000000011</c:v>
                </c:pt>
                <c:pt idx="39">
                  <c:v>60.637194999999998</c:v>
                </c:pt>
                <c:pt idx="40">
                  <c:v>58.874905000000005</c:v>
                </c:pt>
                <c:pt idx="41">
                  <c:v>58.262344999999996</c:v>
                </c:pt>
                <c:pt idx="42">
                  <c:v>59.147525000000002</c:v>
                </c:pt>
                <c:pt idx="43">
                  <c:v>59.806249999999999</c:v>
                </c:pt>
                <c:pt idx="44">
                  <c:v>61.651139999999991</c:v>
                </c:pt>
                <c:pt idx="45">
                  <c:v>63.709674999999997</c:v>
                </c:pt>
                <c:pt idx="46">
                  <c:v>66.599310000000003</c:v>
                </c:pt>
                <c:pt idx="47">
                  <c:v>69.934749999999994</c:v>
                </c:pt>
                <c:pt idx="48">
                  <c:v>72.222510000000014</c:v>
                </c:pt>
                <c:pt idx="49">
                  <c:v>73.789005000000003</c:v>
                </c:pt>
                <c:pt idx="50">
                  <c:v>75.163525000000007</c:v>
                </c:pt>
                <c:pt idx="51">
                  <c:v>74.250600000000006</c:v>
                </c:pt>
                <c:pt idx="52">
                  <c:v>73.123170000000002</c:v>
                </c:pt>
                <c:pt idx="53">
                  <c:v>71.428049999999999</c:v>
                </c:pt>
                <c:pt idx="54">
                  <c:v>70.069299999999998</c:v>
                </c:pt>
                <c:pt idx="55">
                  <c:v>68.081964999999997</c:v>
                </c:pt>
                <c:pt idx="56">
                  <c:v>66.203305</c:v>
                </c:pt>
                <c:pt idx="57">
                  <c:v>63.959439999999994</c:v>
                </c:pt>
                <c:pt idx="58">
                  <c:v>61.780769999999997</c:v>
                </c:pt>
                <c:pt idx="59">
                  <c:v>60.214700000000001</c:v>
                </c:pt>
                <c:pt idx="60">
                  <c:v>58.646464999999992</c:v>
                </c:pt>
                <c:pt idx="61">
                  <c:v>57.610380000000006</c:v>
                </c:pt>
                <c:pt idx="62">
                  <c:v>56.848564999999994</c:v>
                </c:pt>
                <c:pt idx="63">
                  <c:v>56.36643500000001</c:v>
                </c:pt>
                <c:pt idx="64">
                  <c:v>56.216875000000002</c:v>
                </c:pt>
                <c:pt idx="65">
                  <c:v>56.138160000000006</c:v>
                </c:pt>
                <c:pt idx="66">
                  <c:v>56.471255000000006</c:v>
                </c:pt>
                <c:pt idx="67">
                  <c:v>56.856549999999999</c:v>
                </c:pt>
                <c:pt idx="68">
                  <c:v>57.409164999999987</c:v>
                </c:pt>
                <c:pt idx="69">
                  <c:v>57.914789999999989</c:v>
                </c:pt>
                <c:pt idx="70">
                  <c:v>58.146405000000001</c:v>
                </c:pt>
                <c:pt idx="71">
                  <c:v>57.924094999999994</c:v>
                </c:pt>
                <c:pt idx="72">
                  <c:v>58.095789999999994</c:v>
                </c:pt>
                <c:pt idx="73">
                  <c:v>57.534544999999994</c:v>
                </c:pt>
                <c:pt idx="74">
                  <c:v>57.087119999999999</c:v>
                </c:pt>
                <c:pt idx="75">
                  <c:v>56.600655000000003</c:v>
                </c:pt>
                <c:pt idx="76">
                  <c:v>55.716160000000009</c:v>
                </c:pt>
                <c:pt idx="77">
                  <c:v>54.709655000000005</c:v>
                </c:pt>
                <c:pt idx="78">
                  <c:v>53.601975000000003</c:v>
                </c:pt>
                <c:pt idx="79">
                  <c:v>52.182499999999997</c:v>
                </c:pt>
                <c:pt idx="80">
                  <c:v>50.787935000000004</c:v>
                </c:pt>
                <c:pt idx="81">
                  <c:v>49.543100000000003</c:v>
                </c:pt>
                <c:pt idx="82">
                  <c:v>48.319435000000006</c:v>
                </c:pt>
                <c:pt idx="83">
                  <c:v>47.050179999999997</c:v>
                </c:pt>
                <c:pt idx="84">
                  <c:v>46.038705</c:v>
                </c:pt>
                <c:pt idx="85">
                  <c:v>45.455539999999999</c:v>
                </c:pt>
                <c:pt idx="86">
                  <c:v>44.98807</c:v>
                </c:pt>
                <c:pt idx="87">
                  <c:v>44.133989999999997</c:v>
                </c:pt>
                <c:pt idx="88">
                  <c:v>43.919110000000003</c:v>
                </c:pt>
                <c:pt idx="89">
                  <c:v>43.805170000000004</c:v>
                </c:pt>
                <c:pt idx="90">
                  <c:v>43.935124999999999</c:v>
                </c:pt>
                <c:pt idx="91">
                  <c:v>44.079814999999996</c:v>
                </c:pt>
                <c:pt idx="92">
                  <c:v>43.670564999999996</c:v>
                </c:pt>
                <c:pt idx="93">
                  <c:v>44.012035000000004</c:v>
                </c:pt>
                <c:pt idx="94">
                  <c:v>43.633319999999998</c:v>
                </c:pt>
                <c:pt idx="95">
                  <c:v>43.117170000000002</c:v>
                </c:pt>
                <c:pt idx="96">
                  <c:v>42.356989999999996</c:v>
                </c:pt>
                <c:pt idx="97">
                  <c:v>41.893725000000003</c:v>
                </c:pt>
                <c:pt idx="98">
                  <c:v>40.908679999999997</c:v>
                </c:pt>
                <c:pt idx="99">
                  <c:v>40.219639999999998</c:v>
                </c:pt>
                <c:pt idx="100">
                  <c:v>39.027335000000001</c:v>
                </c:pt>
                <c:pt idx="101">
                  <c:v>38.790079999999996</c:v>
                </c:pt>
                <c:pt idx="102">
                  <c:v>36.908254999999997</c:v>
                </c:pt>
                <c:pt idx="103">
                  <c:v>35.886000000000003</c:v>
                </c:pt>
                <c:pt idx="104">
                  <c:v>35.428175000000003</c:v>
                </c:pt>
                <c:pt idx="105">
                  <c:v>34.698970000000003</c:v>
                </c:pt>
                <c:pt idx="106">
                  <c:v>34.109939999999995</c:v>
                </c:pt>
                <c:pt idx="107">
                  <c:v>34.011569999999999</c:v>
                </c:pt>
                <c:pt idx="108">
                  <c:v>33.925145000000001</c:v>
                </c:pt>
                <c:pt idx="109">
                  <c:v>34.039204999999995</c:v>
                </c:pt>
                <c:pt idx="110">
                  <c:v>34.311079999999997</c:v>
                </c:pt>
                <c:pt idx="111">
                  <c:v>34.648874999999997</c:v>
                </c:pt>
                <c:pt idx="112">
                  <c:v>34.669489999999996</c:v>
                </c:pt>
                <c:pt idx="113">
                  <c:v>35.096610000000005</c:v>
                </c:pt>
                <c:pt idx="114">
                  <c:v>35.27993</c:v>
                </c:pt>
                <c:pt idx="115">
                  <c:v>35.207260000000005</c:v>
                </c:pt>
                <c:pt idx="116">
                  <c:v>35.127985000000002</c:v>
                </c:pt>
                <c:pt idx="117">
                  <c:v>34.829095000000002</c:v>
                </c:pt>
                <c:pt idx="118">
                  <c:v>34.508854999999997</c:v>
                </c:pt>
                <c:pt idx="119">
                  <c:v>33.97457</c:v>
                </c:pt>
                <c:pt idx="120">
                  <c:v>33.940345000000001</c:v>
                </c:pt>
                <c:pt idx="121">
                  <c:v>33.449249999999999</c:v>
                </c:pt>
                <c:pt idx="122">
                  <c:v>32.990989999999996</c:v>
                </c:pt>
                <c:pt idx="123">
                  <c:v>32.910470000000004</c:v>
                </c:pt>
                <c:pt idx="124">
                  <c:v>32.17116</c:v>
                </c:pt>
                <c:pt idx="125">
                  <c:v>31.635539999999995</c:v>
                </c:pt>
                <c:pt idx="126">
                  <c:v>31.50215</c:v>
                </c:pt>
                <c:pt idx="127">
                  <c:v>31.215739999999997</c:v>
                </c:pt>
                <c:pt idx="128">
                  <c:v>31.237289999999998</c:v>
                </c:pt>
                <c:pt idx="129">
                  <c:v>31.0624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D49-439F-B561-03FE5C4B2F31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K$17:$CK$146</c:f>
              <c:numCache>
                <c:formatCode>0.00</c:formatCode>
                <c:ptCount val="130"/>
                <c:pt idx="0">
                  <c:v>37.468114999999997</c:v>
                </c:pt>
                <c:pt idx="1">
                  <c:v>42.437595000000002</c:v>
                </c:pt>
                <c:pt idx="2">
                  <c:v>43.221679999999999</c:v>
                </c:pt>
                <c:pt idx="3">
                  <c:v>43.134844999999999</c:v>
                </c:pt>
                <c:pt idx="4">
                  <c:v>41.508544999999998</c:v>
                </c:pt>
                <c:pt idx="5">
                  <c:v>39.664079999999998</c:v>
                </c:pt>
                <c:pt idx="6">
                  <c:v>37.543244999999999</c:v>
                </c:pt>
                <c:pt idx="7">
                  <c:v>35.472745000000003</c:v>
                </c:pt>
                <c:pt idx="8">
                  <c:v>33.266475</c:v>
                </c:pt>
                <c:pt idx="9">
                  <c:v>31.065295000000003</c:v>
                </c:pt>
                <c:pt idx="10">
                  <c:v>29.198864999999998</c:v>
                </c:pt>
                <c:pt idx="11">
                  <c:v>27.568954999999999</c:v>
                </c:pt>
                <c:pt idx="12">
                  <c:v>27.221150000000002</c:v>
                </c:pt>
                <c:pt idx="13">
                  <c:v>28.453254999999999</c:v>
                </c:pt>
                <c:pt idx="14">
                  <c:v>32.022010000000002</c:v>
                </c:pt>
                <c:pt idx="15">
                  <c:v>37.855145</c:v>
                </c:pt>
                <c:pt idx="16">
                  <c:v>45.358274999999999</c:v>
                </c:pt>
                <c:pt idx="17">
                  <c:v>54.267919999999997</c:v>
                </c:pt>
                <c:pt idx="18">
                  <c:v>65.640480000000011</c:v>
                </c:pt>
                <c:pt idx="19">
                  <c:v>79.24974499999999</c:v>
                </c:pt>
                <c:pt idx="20">
                  <c:v>92.367580000000004</c:v>
                </c:pt>
                <c:pt idx="21">
                  <c:v>102.91556000000001</c:v>
                </c:pt>
                <c:pt idx="22">
                  <c:v>108.65652</c:v>
                </c:pt>
                <c:pt idx="23">
                  <c:v>111.26795</c:v>
                </c:pt>
                <c:pt idx="24">
                  <c:v>110.05231000000001</c:v>
                </c:pt>
                <c:pt idx="25">
                  <c:v>107.589955</c:v>
                </c:pt>
                <c:pt idx="26">
                  <c:v>102.919275</c:v>
                </c:pt>
                <c:pt idx="27">
                  <c:v>97.684239999999988</c:v>
                </c:pt>
                <c:pt idx="28">
                  <c:v>93.678344999999993</c:v>
                </c:pt>
                <c:pt idx="29">
                  <c:v>86.636005000000011</c:v>
                </c:pt>
                <c:pt idx="30">
                  <c:v>80.986989999999992</c:v>
                </c:pt>
                <c:pt idx="31">
                  <c:v>75.458964999999992</c:v>
                </c:pt>
                <c:pt idx="32">
                  <c:v>71.018364999999989</c:v>
                </c:pt>
                <c:pt idx="33">
                  <c:v>66.822794999999999</c:v>
                </c:pt>
                <c:pt idx="34">
                  <c:v>63.416150000000002</c:v>
                </c:pt>
                <c:pt idx="35">
                  <c:v>60.106635000000011</c:v>
                </c:pt>
                <c:pt idx="36">
                  <c:v>57.598394999999996</c:v>
                </c:pt>
                <c:pt idx="37">
                  <c:v>56.423785000000009</c:v>
                </c:pt>
                <c:pt idx="38">
                  <c:v>54.027060000000006</c:v>
                </c:pt>
                <c:pt idx="39">
                  <c:v>54.287094999999994</c:v>
                </c:pt>
                <c:pt idx="40">
                  <c:v>54.840105000000001</c:v>
                </c:pt>
                <c:pt idx="41">
                  <c:v>55.688644999999994</c:v>
                </c:pt>
                <c:pt idx="42">
                  <c:v>56.816625000000002</c:v>
                </c:pt>
                <c:pt idx="43">
                  <c:v>57.999450000000003</c:v>
                </c:pt>
                <c:pt idx="44">
                  <c:v>60.372739999999993</c:v>
                </c:pt>
                <c:pt idx="45">
                  <c:v>62.247275000000002</c:v>
                </c:pt>
                <c:pt idx="46">
                  <c:v>63.679910000000007</c:v>
                </c:pt>
                <c:pt idx="47">
                  <c:v>65.402950000000004</c:v>
                </c:pt>
                <c:pt idx="48">
                  <c:v>66.163710000000009</c:v>
                </c:pt>
                <c:pt idx="49">
                  <c:v>65.662205</c:v>
                </c:pt>
                <c:pt idx="50">
                  <c:v>64.624724999999998</c:v>
                </c:pt>
                <c:pt idx="51">
                  <c:v>63.004899999999999</c:v>
                </c:pt>
                <c:pt idx="52">
                  <c:v>61.102669999999996</c:v>
                </c:pt>
                <c:pt idx="53">
                  <c:v>59.27675</c:v>
                </c:pt>
                <c:pt idx="54">
                  <c:v>57.331800000000001</c:v>
                </c:pt>
                <c:pt idx="55">
                  <c:v>54.61986499999999</c:v>
                </c:pt>
                <c:pt idx="56">
                  <c:v>53.028705000000002</c:v>
                </c:pt>
                <c:pt idx="57">
                  <c:v>52.060239999999993</c:v>
                </c:pt>
                <c:pt idx="58">
                  <c:v>51.639470000000003</c:v>
                </c:pt>
                <c:pt idx="59">
                  <c:v>51.701999999999998</c:v>
                </c:pt>
                <c:pt idx="60">
                  <c:v>51.705664999999996</c:v>
                </c:pt>
                <c:pt idx="61">
                  <c:v>52.058779999999999</c:v>
                </c:pt>
                <c:pt idx="62">
                  <c:v>51.863164999999995</c:v>
                </c:pt>
                <c:pt idx="63">
                  <c:v>51.525135000000006</c:v>
                </c:pt>
                <c:pt idx="64">
                  <c:v>51.134974999999997</c:v>
                </c:pt>
                <c:pt idx="65">
                  <c:v>50.663360000000004</c:v>
                </c:pt>
                <c:pt idx="66">
                  <c:v>50.393554999999999</c:v>
                </c:pt>
                <c:pt idx="67">
                  <c:v>50.268549999999998</c:v>
                </c:pt>
                <c:pt idx="68">
                  <c:v>50.055764999999994</c:v>
                </c:pt>
                <c:pt idx="69">
                  <c:v>49.686589999999995</c:v>
                </c:pt>
                <c:pt idx="70">
                  <c:v>49.498104999999995</c:v>
                </c:pt>
                <c:pt idx="71">
                  <c:v>48.824195000000003</c:v>
                </c:pt>
                <c:pt idx="72">
                  <c:v>48.418589999999995</c:v>
                </c:pt>
                <c:pt idx="73">
                  <c:v>47.729345000000002</c:v>
                </c:pt>
                <c:pt idx="74">
                  <c:v>47.070520000000002</c:v>
                </c:pt>
                <c:pt idx="75">
                  <c:v>47.132255000000001</c:v>
                </c:pt>
                <c:pt idx="76">
                  <c:v>46.293560000000006</c:v>
                </c:pt>
                <c:pt idx="77">
                  <c:v>45.668554999999998</c:v>
                </c:pt>
                <c:pt idx="78">
                  <c:v>45.308875</c:v>
                </c:pt>
                <c:pt idx="79">
                  <c:v>45.145499999999998</c:v>
                </c:pt>
                <c:pt idx="80">
                  <c:v>44.864735000000003</c:v>
                </c:pt>
                <c:pt idx="81">
                  <c:v>44.3949</c:v>
                </c:pt>
                <c:pt idx="82">
                  <c:v>43.953135000000003</c:v>
                </c:pt>
                <c:pt idx="83">
                  <c:v>43.227679999999999</c:v>
                </c:pt>
                <c:pt idx="84">
                  <c:v>42.277104999999999</c:v>
                </c:pt>
                <c:pt idx="85">
                  <c:v>41.811339999999994</c:v>
                </c:pt>
                <c:pt idx="86">
                  <c:v>40.798670000000001</c:v>
                </c:pt>
                <c:pt idx="87">
                  <c:v>39.836089999999999</c:v>
                </c:pt>
                <c:pt idx="88">
                  <c:v>38.944310000000002</c:v>
                </c:pt>
                <c:pt idx="89">
                  <c:v>38.201270000000001</c:v>
                </c:pt>
                <c:pt idx="90">
                  <c:v>37.879624999999997</c:v>
                </c:pt>
                <c:pt idx="91">
                  <c:v>37.631614999999996</c:v>
                </c:pt>
                <c:pt idx="92">
                  <c:v>37.180664999999998</c:v>
                </c:pt>
                <c:pt idx="93">
                  <c:v>37.375235000000004</c:v>
                </c:pt>
                <c:pt idx="94">
                  <c:v>38.00582</c:v>
                </c:pt>
                <c:pt idx="95">
                  <c:v>38.326770000000003</c:v>
                </c:pt>
                <c:pt idx="96">
                  <c:v>38.106189999999998</c:v>
                </c:pt>
                <c:pt idx="97">
                  <c:v>38.512925000000003</c:v>
                </c:pt>
                <c:pt idx="98">
                  <c:v>38.267879999999998</c:v>
                </c:pt>
                <c:pt idx="99">
                  <c:v>37.902839999999998</c:v>
                </c:pt>
                <c:pt idx="100">
                  <c:v>37.222335000000001</c:v>
                </c:pt>
                <c:pt idx="101">
                  <c:v>36.582180000000001</c:v>
                </c:pt>
                <c:pt idx="102">
                  <c:v>35.888354999999997</c:v>
                </c:pt>
                <c:pt idx="103">
                  <c:v>35.032400000000003</c:v>
                </c:pt>
                <c:pt idx="104">
                  <c:v>34.645074999999999</c:v>
                </c:pt>
                <c:pt idx="105">
                  <c:v>33.648470000000003</c:v>
                </c:pt>
                <c:pt idx="106">
                  <c:v>32.975239999999999</c:v>
                </c:pt>
                <c:pt idx="107">
                  <c:v>32.271570000000004</c:v>
                </c:pt>
                <c:pt idx="108">
                  <c:v>31.503645000000002</c:v>
                </c:pt>
                <c:pt idx="109">
                  <c:v>31.043804999999999</c:v>
                </c:pt>
                <c:pt idx="110">
                  <c:v>30.89508</c:v>
                </c:pt>
                <c:pt idx="111">
                  <c:v>30.612874999999999</c:v>
                </c:pt>
                <c:pt idx="112">
                  <c:v>30.439589999999995</c:v>
                </c:pt>
                <c:pt idx="113">
                  <c:v>30.485010000000003</c:v>
                </c:pt>
                <c:pt idx="114">
                  <c:v>30.182029999999997</c:v>
                </c:pt>
                <c:pt idx="115">
                  <c:v>30.069360000000003</c:v>
                </c:pt>
                <c:pt idx="116">
                  <c:v>30.043985000000003</c:v>
                </c:pt>
                <c:pt idx="117">
                  <c:v>29.817995</c:v>
                </c:pt>
                <c:pt idx="118">
                  <c:v>29.749955</c:v>
                </c:pt>
                <c:pt idx="119">
                  <c:v>29.655370000000001</c:v>
                </c:pt>
                <c:pt idx="120">
                  <c:v>29.425445</c:v>
                </c:pt>
                <c:pt idx="121">
                  <c:v>29.159749999999999</c:v>
                </c:pt>
                <c:pt idx="122">
                  <c:v>29.139089999999996</c:v>
                </c:pt>
                <c:pt idx="123">
                  <c:v>28.897670000000002</c:v>
                </c:pt>
                <c:pt idx="124">
                  <c:v>28.542860000000005</c:v>
                </c:pt>
                <c:pt idx="125">
                  <c:v>28.051739999999995</c:v>
                </c:pt>
                <c:pt idx="126">
                  <c:v>27.70035</c:v>
                </c:pt>
                <c:pt idx="127">
                  <c:v>27.155239999999996</c:v>
                </c:pt>
                <c:pt idx="128">
                  <c:v>26.897489999999998</c:v>
                </c:pt>
                <c:pt idx="129">
                  <c:v>26.4886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D49-439F-B561-03FE5C4B2F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750528"/>
        <c:axId val="65752064"/>
      </c:lineChart>
      <c:catAx>
        <c:axId val="65750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575206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575206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5750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F$17:$CF$146</c:f>
              <c:numCache>
                <c:formatCode>0.00</c:formatCode>
                <c:ptCount val="130"/>
                <c:pt idx="0">
                  <c:v>94.594214999999991</c:v>
                </c:pt>
                <c:pt idx="1">
                  <c:v>97.205694999999992</c:v>
                </c:pt>
                <c:pt idx="2">
                  <c:v>98.746480000000005</c:v>
                </c:pt>
                <c:pt idx="3">
                  <c:v>95.82764499999999</c:v>
                </c:pt>
                <c:pt idx="4">
                  <c:v>89.32594499999999</c:v>
                </c:pt>
                <c:pt idx="5">
                  <c:v>84.159580000000005</c:v>
                </c:pt>
                <c:pt idx="6">
                  <c:v>80.211444999999998</c:v>
                </c:pt>
                <c:pt idx="7">
                  <c:v>75.496944999999997</c:v>
                </c:pt>
                <c:pt idx="8">
                  <c:v>72.367575000000002</c:v>
                </c:pt>
                <c:pt idx="9">
                  <c:v>70.441395</c:v>
                </c:pt>
                <c:pt idx="10">
                  <c:v>68.395164999999992</c:v>
                </c:pt>
                <c:pt idx="11">
                  <c:v>66.307254999999998</c:v>
                </c:pt>
                <c:pt idx="12">
                  <c:v>63.969149999999999</c:v>
                </c:pt>
                <c:pt idx="13">
                  <c:v>61.293055000000003</c:v>
                </c:pt>
                <c:pt idx="14">
                  <c:v>59.459510000000009</c:v>
                </c:pt>
                <c:pt idx="15">
                  <c:v>56.815244999999997</c:v>
                </c:pt>
                <c:pt idx="16">
                  <c:v>53.291375000000002</c:v>
                </c:pt>
                <c:pt idx="17">
                  <c:v>49.934220000000003</c:v>
                </c:pt>
                <c:pt idx="18">
                  <c:v>47.36468</c:v>
                </c:pt>
                <c:pt idx="19">
                  <c:v>45.113145000000003</c:v>
                </c:pt>
                <c:pt idx="20">
                  <c:v>42.946179999999998</c:v>
                </c:pt>
                <c:pt idx="21">
                  <c:v>41.056660000000001</c:v>
                </c:pt>
                <c:pt idx="22">
                  <c:v>40.059620000000002</c:v>
                </c:pt>
                <c:pt idx="23">
                  <c:v>39.529649999999997</c:v>
                </c:pt>
                <c:pt idx="24">
                  <c:v>39.900410000000001</c:v>
                </c:pt>
                <c:pt idx="25">
                  <c:v>40.920155000000001</c:v>
                </c:pt>
                <c:pt idx="26">
                  <c:v>42.049574999999997</c:v>
                </c:pt>
                <c:pt idx="27">
                  <c:v>44.148339999999997</c:v>
                </c:pt>
                <c:pt idx="28">
                  <c:v>46.194445000000002</c:v>
                </c:pt>
                <c:pt idx="29">
                  <c:v>48.241605</c:v>
                </c:pt>
                <c:pt idx="30">
                  <c:v>49.944889999999994</c:v>
                </c:pt>
                <c:pt idx="31">
                  <c:v>52.414164999999997</c:v>
                </c:pt>
                <c:pt idx="32">
                  <c:v>55.009064999999993</c:v>
                </c:pt>
                <c:pt idx="33">
                  <c:v>57.648794999999993</c:v>
                </c:pt>
                <c:pt idx="34">
                  <c:v>60.980649999999997</c:v>
                </c:pt>
                <c:pt idx="35">
                  <c:v>64.528735000000012</c:v>
                </c:pt>
                <c:pt idx="36">
                  <c:v>68.429594999999992</c:v>
                </c:pt>
                <c:pt idx="37">
                  <c:v>71.160285000000016</c:v>
                </c:pt>
                <c:pt idx="38">
                  <c:v>73.721560000000011</c:v>
                </c:pt>
                <c:pt idx="39">
                  <c:v>75.987894999999995</c:v>
                </c:pt>
                <c:pt idx="40">
                  <c:v>77.654505</c:v>
                </c:pt>
                <c:pt idx="41">
                  <c:v>78.969144999999997</c:v>
                </c:pt>
                <c:pt idx="42">
                  <c:v>79.742324999999994</c:v>
                </c:pt>
                <c:pt idx="43">
                  <c:v>80.608949999999993</c:v>
                </c:pt>
                <c:pt idx="44">
                  <c:v>81.267139999999998</c:v>
                </c:pt>
                <c:pt idx="45">
                  <c:v>82.319775000000007</c:v>
                </c:pt>
                <c:pt idx="46">
                  <c:v>81.876310000000004</c:v>
                </c:pt>
                <c:pt idx="47">
                  <c:v>81.595950000000002</c:v>
                </c:pt>
                <c:pt idx="48">
                  <c:v>80.698710000000005</c:v>
                </c:pt>
                <c:pt idx="49">
                  <c:v>78.684205000000006</c:v>
                </c:pt>
                <c:pt idx="50">
                  <c:v>76.874724999999998</c:v>
                </c:pt>
                <c:pt idx="51">
                  <c:v>75.263599999999997</c:v>
                </c:pt>
                <c:pt idx="52">
                  <c:v>72.796369999999996</c:v>
                </c:pt>
                <c:pt idx="53">
                  <c:v>71.219549999999998</c:v>
                </c:pt>
                <c:pt idx="54">
                  <c:v>69.203999999999994</c:v>
                </c:pt>
                <c:pt idx="55">
                  <c:v>67.358764999999991</c:v>
                </c:pt>
                <c:pt idx="56">
                  <c:v>65.469405000000009</c:v>
                </c:pt>
                <c:pt idx="57">
                  <c:v>64.241439999999997</c:v>
                </c:pt>
                <c:pt idx="58">
                  <c:v>63.348369999999996</c:v>
                </c:pt>
                <c:pt idx="59">
                  <c:v>62.071300000000001</c:v>
                </c:pt>
                <c:pt idx="60">
                  <c:v>60.820964999999994</c:v>
                </c:pt>
                <c:pt idx="61">
                  <c:v>59.564480000000003</c:v>
                </c:pt>
                <c:pt idx="62">
                  <c:v>58.149564999999988</c:v>
                </c:pt>
                <c:pt idx="63">
                  <c:v>55.771335000000008</c:v>
                </c:pt>
                <c:pt idx="64">
                  <c:v>53.131374999999998</c:v>
                </c:pt>
                <c:pt idx="65">
                  <c:v>50.430260000000004</c:v>
                </c:pt>
                <c:pt idx="66">
                  <c:v>48.352154999999996</c:v>
                </c:pt>
                <c:pt idx="67">
                  <c:v>46.262749999999997</c:v>
                </c:pt>
                <c:pt idx="68">
                  <c:v>44.363864999999997</c:v>
                </c:pt>
                <c:pt idx="69">
                  <c:v>42.578889999999994</c:v>
                </c:pt>
                <c:pt idx="70">
                  <c:v>41.406205</c:v>
                </c:pt>
                <c:pt idx="71">
                  <c:v>40.155895000000001</c:v>
                </c:pt>
                <c:pt idx="72">
                  <c:v>39.356989999999996</c:v>
                </c:pt>
                <c:pt idx="73">
                  <c:v>38.735045</c:v>
                </c:pt>
                <c:pt idx="74">
                  <c:v>39.190719999999999</c:v>
                </c:pt>
                <c:pt idx="75">
                  <c:v>39.886755000000001</c:v>
                </c:pt>
                <c:pt idx="76">
                  <c:v>39.808160000000001</c:v>
                </c:pt>
                <c:pt idx="77">
                  <c:v>39.553354999999996</c:v>
                </c:pt>
                <c:pt idx="78">
                  <c:v>39.346375000000002</c:v>
                </c:pt>
                <c:pt idx="79">
                  <c:v>38.774700000000003</c:v>
                </c:pt>
                <c:pt idx="80">
                  <c:v>37.934335000000004</c:v>
                </c:pt>
                <c:pt idx="81">
                  <c:v>37.252800000000001</c:v>
                </c:pt>
                <c:pt idx="82">
                  <c:v>36.604435000000002</c:v>
                </c:pt>
                <c:pt idx="83">
                  <c:v>35.877980000000001</c:v>
                </c:pt>
                <c:pt idx="84">
                  <c:v>35.147705000000002</c:v>
                </c:pt>
                <c:pt idx="85">
                  <c:v>35.638739999999999</c:v>
                </c:pt>
                <c:pt idx="86">
                  <c:v>34.50947</c:v>
                </c:pt>
                <c:pt idx="87">
                  <c:v>34.430989999999994</c:v>
                </c:pt>
                <c:pt idx="88">
                  <c:v>34.309910000000002</c:v>
                </c:pt>
                <c:pt idx="89">
                  <c:v>34.644870000000004</c:v>
                </c:pt>
                <c:pt idx="90">
                  <c:v>35.181725</c:v>
                </c:pt>
                <c:pt idx="91">
                  <c:v>35.510114999999999</c:v>
                </c:pt>
                <c:pt idx="92">
                  <c:v>35.571565</c:v>
                </c:pt>
                <c:pt idx="93">
                  <c:v>35.269835</c:v>
                </c:pt>
                <c:pt idx="94">
                  <c:v>34.862520000000004</c:v>
                </c:pt>
                <c:pt idx="95">
                  <c:v>34.816569999999999</c:v>
                </c:pt>
                <c:pt idx="96">
                  <c:v>34.210289999999993</c:v>
                </c:pt>
                <c:pt idx="97">
                  <c:v>33.426924999999997</c:v>
                </c:pt>
                <c:pt idx="98">
                  <c:v>32.625779999999999</c:v>
                </c:pt>
                <c:pt idx="99">
                  <c:v>32.010239999999996</c:v>
                </c:pt>
                <c:pt idx="100">
                  <c:v>31.294235000000004</c:v>
                </c:pt>
                <c:pt idx="101">
                  <c:v>30.897579999999998</c:v>
                </c:pt>
                <c:pt idx="102">
                  <c:v>30.265854999999998</c:v>
                </c:pt>
                <c:pt idx="103">
                  <c:v>29.972799999999999</c:v>
                </c:pt>
                <c:pt idx="104">
                  <c:v>29.846274999999999</c:v>
                </c:pt>
                <c:pt idx="105">
                  <c:v>29.550070000000002</c:v>
                </c:pt>
                <c:pt idx="106">
                  <c:v>29.195739999999997</c:v>
                </c:pt>
                <c:pt idx="107">
                  <c:v>29.159470000000002</c:v>
                </c:pt>
                <c:pt idx="108">
                  <c:v>29.143845000000002</c:v>
                </c:pt>
                <c:pt idx="109">
                  <c:v>28.776204999999997</c:v>
                </c:pt>
                <c:pt idx="110">
                  <c:v>28.587579999999999</c:v>
                </c:pt>
                <c:pt idx="111">
                  <c:v>28.098375000000001</c:v>
                </c:pt>
                <c:pt idx="112">
                  <c:v>27.557489999999998</c:v>
                </c:pt>
                <c:pt idx="113">
                  <c:v>27.042510000000004</c:v>
                </c:pt>
                <c:pt idx="114">
                  <c:v>26.405829999999998</c:v>
                </c:pt>
                <c:pt idx="115">
                  <c:v>25.658360000000002</c:v>
                </c:pt>
                <c:pt idx="116">
                  <c:v>25.228485000000003</c:v>
                </c:pt>
                <c:pt idx="117">
                  <c:v>24.442495000000001</c:v>
                </c:pt>
                <c:pt idx="118">
                  <c:v>24.144354999999997</c:v>
                </c:pt>
                <c:pt idx="119">
                  <c:v>23.489570000000001</c:v>
                </c:pt>
                <c:pt idx="120">
                  <c:v>22.893045000000001</c:v>
                </c:pt>
                <c:pt idx="121">
                  <c:v>22.40645</c:v>
                </c:pt>
                <c:pt idx="122">
                  <c:v>21.826289999999997</c:v>
                </c:pt>
                <c:pt idx="123">
                  <c:v>21.526670000000003</c:v>
                </c:pt>
                <c:pt idx="124">
                  <c:v>21.176760000000005</c:v>
                </c:pt>
                <c:pt idx="125">
                  <c:v>20.995939999999997</c:v>
                </c:pt>
                <c:pt idx="126">
                  <c:v>20.826450000000001</c:v>
                </c:pt>
                <c:pt idx="127">
                  <c:v>20.530839999999998</c:v>
                </c:pt>
                <c:pt idx="128">
                  <c:v>20.337689999999995</c:v>
                </c:pt>
                <c:pt idx="129">
                  <c:v>20.180204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EFD-45D7-92C5-21BF46F8D958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G$17:$CG$146</c:f>
              <c:numCache>
                <c:formatCode>0.00</c:formatCode>
                <c:ptCount val="130"/>
                <c:pt idx="0">
                  <c:v>83.373614999999987</c:v>
                </c:pt>
                <c:pt idx="1">
                  <c:v>87.920194999999993</c:v>
                </c:pt>
                <c:pt idx="2">
                  <c:v>87.395380000000003</c:v>
                </c:pt>
                <c:pt idx="3">
                  <c:v>86.767844999999994</c:v>
                </c:pt>
                <c:pt idx="4">
                  <c:v>86.153544999999994</c:v>
                </c:pt>
                <c:pt idx="5">
                  <c:v>83.371679999999998</c:v>
                </c:pt>
                <c:pt idx="6">
                  <c:v>80.338544999999996</c:v>
                </c:pt>
                <c:pt idx="7">
                  <c:v>76.758844999999994</c:v>
                </c:pt>
                <c:pt idx="8">
                  <c:v>73.054474999999996</c:v>
                </c:pt>
                <c:pt idx="9">
                  <c:v>69.374294999999989</c:v>
                </c:pt>
                <c:pt idx="10">
                  <c:v>66.585764999999995</c:v>
                </c:pt>
                <c:pt idx="11">
                  <c:v>63.443655000000007</c:v>
                </c:pt>
                <c:pt idx="12">
                  <c:v>60.524749999999997</c:v>
                </c:pt>
                <c:pt idx="13">
                  <c:v>57.833355000000005</c:v>
                </c:pt>
                <c:pt idx="14">
                  <c:v>55.391410000000008</c:v>
                </c:pt>
                <c:pt idx="15">
                  <c:v>52.955944999999993</c:v>
                </c:pt>
                <c:pt idx="16">
                  <c:v>50.556674999999998</c:v>
                </c:pt>
                <c:pt idx="17">
                  <c:v>48.131320000000002</c:v>
                </c:pt>
                <c:pt idx="18">
                  <c:v>45.737780000000001</c:v>
                </c:pt>
                <c:pt idx="19">
                  <c:v>43.249745000000004</c:v>
                </c:pt>
                <c:pt idx="20">
                  <c:v>40.374279999999999</c:v>
                </c:pt>
                <c:pt idx="21">
                  <c:v>37.860860000000002</c:v>
                </c:pt>
                <c:pt idx="22">
                  <c:v>35.559519999999999</c:v>
                </c:pt>
                <c:pt idx="23">
                  <c:v>34.238549999999996</c:v>
                </c:pt>
                <c:pt idx="24">
                  <c:v>33.120710000000003</c:v>
                </c:pt>
                <c:pt idx="25">
                  <c:v>32.258254999999998</c:v>
                </c:pt>
                <c:pt idx="26">
                  <c:v>31.986474999999999</c:v>
                </c:pt>
                <c:pt idx="27">
                  <c:v>32.468139999999998</c:v>
                </c:pt>
                <c:pt idx="28">
                  <c:v>33.228045000000002</c:v>
                </c:pt>
                <c:pt idx="29">
                  <c:v>34.827204999999999</c:v>
                </c:pt>
                <c:pt idx="30">
                  <c:v>36.989089999999997</c:v>
                </c:pt>
                <c:pt idx="31">
                  <c:v>39.461164999999994</c:v>
                </c:pt>
                <c:pt idx="32">
                  <c:v>42.130964999999996</c:v>
                </c:pt>
                <c:pt idx="33">
                  <c:v>44.507395000000002</c:v>
                </c:pt>
                <c:pt idx="34">
                  <c:v>47.248249999999999</c:v>
                </c:pt>
                <c:pt idx="35">
                  <c:v>49.559935000000003</c:v>
                </c:pt>
                <c:pt idx="36">
                  <c:v>51.000495000000001</c:v>
                </c:pt>
                <c:pt idx="37">
                  <c:v>51.089385</c:v>
                </c:pt>
                <c:pt idx="38">
                  <c:v>52.266160000000006</c:v>
                </c:pt>
                <c:pt idx="39">
                  <c:v>54.051594999999992</c:v>
                </c:pt>
                <c:pt idx="40">
                  <c:v>56.242505000000001</c:v>
                </c:pt>
                <c:pt idx="41">
                  <c:v>58.240544999999997</c:v>
                </c:pt>
                <c:pt idx="42">
                  <c:v>60.357424999999999</c:v>
                </c:pt>
                <c:pt idx="43">
                  <c:v>61.944049999999997</c:v>
                </c:pt>
                <c:pt idx="44">
                  <c:v>63.97323999999999</c:v>
                </c:pt>
                <c:pt idx="45">
                  <c:v>64.377475000000004</c:v>
                </c:pt>
                <c:pt idx="46">
                  <c:v>64.870410000000007</c:v>
                </c:pt>
                <c:pt idx="47">
                  <c:v>65.569249999999997</c:v>
                </c:pt>
                <c:pt idx="48">
                  <c:v>65.73011000000001</c:v>
                </c:pt>
                <c:pt idx="49">
                  <c:v>67.492005000000006</c:v>
                </c:pt>
                <c:pt idx="50">
                  <c:v>65.472525000000005</c:v>
                </c:pt>
                <c:pt idx="51">
                  <c:v>63.636200000000002</c:v>
                </c:pt>
                <c:pt idx="52">
                  <c:v>62.908669999999994</c:v>
                </c:pt>
                <c:pt idx="53">
                  <c:v>61.91675</c:v>
                </c:pt>
                <c:pt idx="54">
                  <c:v>60.411799999999999</c:v>
                </c:pt>
                <c:pt idx="55">
                  <c:v>58.753264999999992</c:v>
                </c:pt>
                <c:pt idx="56">
                  <c:v>57.065705000000001</c:v>
                </c:pt>
                <c:pt idx="57">
                  <c:v>55.706939999999989</c:v>
                </c:pt>
                <c:pt idx="58">
                  <c:v>54.019269999999999</c:v>
                </c:pt>
                <c:pt idx="59">
                  <c:v>52.657800000000002</c:v>
                </c:pt>
                <c:pt idx="60">
                  <c:v>51.515664999999998</c:v>
                </c:pt>
                <c:pt idx="61">
                  <c:v>50.533679999999997</c:v>
                </c:pt>
                <c:pt idx="62">
                  <c:v>49.319964999999996</c:v>
                </c:pt>
                <c:pt idx="63">
                  <c:v>48.268135000000001</c:v>
                </c:pt>
                <c:pt idx="64">
                  <c:v>47.351775000000004</c:v>
                </c:pt>
                <c:pt idx="65">
                  <c:v>46.326860000000003</c:v>
                </c:pt>
                <c:pt idx="66">
                  <c:v>45.389555000000001</c:v>
                </c:pt>
                <c:pt idx="67">
                  <c:v>44.450150000000001</c:v>
                </c:pt>
                <c:pt idx="68">
                  <c:v>43.594164999999997</c:v>
                </c:pt>
                <c:pt idx="69">
                  <c:v>42.62829</c:v>
                </c:pt>
                <c:pt idx="70">
                  <c:v>42.030904999999997</c:v>
                </c:pt>
                <c:pt idx="71">
                  <c:v>40.779395000000001</c:v>
                </c:pt>
                <c:pt idx="72">
                  <c:v>39.282989999999998</c:v>
                </c:pt>
                <c:pt idx="73">
                  <c:v>38.570745000000002</c:v>
                </c:pt>
                <c:pt idx="74">
                  <c:v>37.930720000000001</c:v>
                </c:pt>
                <c:pt idx="75">
                  <c:v>37.796054999999996</c:v>
                </c:pt>
                <c:pt idx="76">
                  <c:v>37.404560000000004</c:v>
                </c:pt>
                <c:pt idx="77">
                  <c:v>37.390254999999996</c:v>
                </c:pt>
                <c:pt idx="78">
                  <c:v>37.241974999999996</c:v>
                </c:pt>
                <c:pt idx="79">
                  <c:v>37.003500000000003</c:v>
                </c:pt>
                <c:pt idx="80">
                  <c:v>36.886635000000005</c:v>
                </c:pt>
                <c:pt idx="81">
                  <c:v>36.777099999999997</c:v>
                </c:pt>
                <c:pt idx="82">
                  <c:v>36.571035000000002</c:v>
                </c:pt>
                <c:pt idx="83">
                  <c:v>36.224379999999996</c:v>
                </c:pt>
                <c:pt idx="84">
                  <c:v>36.432105</c:v>
                </c:pt>
                <c:pt idx="85">
                  <c:v>36.591939999999994</c:v>
                </c:pt>
                <c:pt idx="86">
                  <c:v>36.078070000000004</c:v>
                </c:pt>
                <c:pt idx="87">
                  <c:v>35.591089999999994</c:v>
                </c:pt>
                <c:pt idx="88">
                  <c:v>35.209210000000006</c:v>
                </c:pt>
                <c:pt idx="89">
                  <c:v>34.881170000000004</c:v>
                </c:pt>
                <c:pt idx="90">
                  <c:v>34.898724999999999</c:v>
                </c:pt>
                <c:pt idx="91">
                  <c:v>34.651714999999996</c:v>
                </c:pt>
                <c:pt idx="92">
                  <c:v>34.750264999999999</c:v>
                </c:pt>
                <c:pt idx="93">
                  <c:v>34.883335000000002</c:v>
                </c:pt>
                <c:pt idx="94">
                  <c:v>34.98312</c:v>
                </c:pt>
                <c:pt idx="95">
                  <c:v>34.735570000000003</c:v>
                </c:pt>
                <c:pt idx="96">
                  <c:v>34.326789999999995</c:v>
                </c:pt>
                <c:pt idx="97">
                  <c:v>33.701425</c:v>
                </c:pt>
                <c:pt idx="98">
                  <c:v>32.96378</c:v>
                </c:pt>
                <c:pt idx="99">
                  <c:v>31.942939999999997</c:v>
                </c:pt>
                <c:pt idx="100">
                  <c:v>31.332835000000003</c:v>
                </c:pt>
                <c:pt idx="101">
                  <c:v>30.771879999999999</c:v>
                </c:pt>
                <c:pt idx="102">
                  <c:v>30.408655</c:v>
                </c:pt>
                <c:pt idx="103">
                  <c:v>29.750699999999998</c:v>
                </c:pt>
                <c:pt idx="104">
                  <c:v>29.362974999999999</c:v>
                </c:pt>
                <c:pt idx="105">
                  <c:v>29.065770000000001</c:v>
                </c:pt>
                <c:pt idx="106">
                  <c:v>28.779539999999997</c:v>
                </c:pt>
                <c:pt idx="107">
                  <c:v>28.92407</c:v>
                </c:pt>
                <c:pt idx="108">
                  <c:v>28.699345000000001</c:v>
                </c:pt>
                <c:pt idx="109">
                  <c:v>28.751904999999997</c:v>
                </c:pt>
                <c:pt idx="110">
                  <c:v>28.82518</c:v>
                </c:pt>
                <c:pt idx="111">
                  <c:v>29.060874999999999</c:v>
                </c:pt>
                <c:pt idx="112">
                  <c:v>28.402089999999998</c:v>
                </c:pt>
                <c:pt idx="113">
                  <c:v>28.065910000000002</c:v>
                </c:pt>
                <c:pt idx="114">
                  <c:v>27.905329999999999</c:v>
                </c:pt>
                <c:pt idx="115">
                  <c:v>27.506360000000004</c:v>
                </c:pt>
                <c:pt idx="116">
                  <c:v>27.005885000000003</c:v>
                </c:pt>
                <c:pt idx="117">
                  <c:v>26.638294999999999</c:v>
                </c:pt>
                <c:pt idx="118">
                  <c:v>26.444354999999998</c:v>
                </c:pt>
                <c:pt idx="119">
                  <c:v>26.309570000000001</c:v>
                </c:pt>
                <c:pt idx="120">
                  <c:v>26.196845</c:v>
                </c:pt>
                <c:pt idx="121">
                  <c:v>25.94435</c:v>
                </c:pt>
                <c:pt idx="122">
                  <c:v>25.920289999999998</c:v>
                </c:pt>
                <c:pt idx="123">
                  <c:v>25.905470000000001</c:v>
                </c:pt>
                <c:pt idx="124">
                  <c:v>25.690060000000003</c:v>
                </c:pt>
                <c:pt idx="125">
                  <c:v>25.081539999999997</c:v>
                </c:pt>
                <c:pt idx="126">
                  <c:v>24.98105</c:v>
                </c:pt>
                <c:pt idx="127">
                  <c:v>24.882439999999995</c:v>
                </c:pt>
                <c:pt idx="128">
                  <c:v>24.355589999999996</c:v>
                </c:pt>
                <c:pt idx="129">
                  <c:v>24.0681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EFD-45D7-92C5-21BF46F8D958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H$17:$CH$146</c:f>
              <c:numCache>
                <c:formatCode>0.00</c:formatCode>
                <c:ptCount val="130"/>
                <c:pt idx="0">
                  <c:v>88.639314999999996</c:v>
                </c:pt>
                <c:pt idx="1">
                  <c:v>93.706894999999989</c:v>
                </c:pt>
                <c:pt idx="2">
                  <c:v>93.056580000000011</c:v>
                </c:pt>
                <c:pt idx="3">
                  <c:v>93.373044999999991</c:v>
                </c:pt>
                <c:pt idx="4">
                  <c:v>93.658644999999993</c:v>
                </c:pt>
                <c:pt idx="5">
                  <c:v>91.173880000000011</c:v>
                </c:pt>
                <c:pt idx="6">
                  <c:v>89.17354499999999</c:v>
                </c:pt>
                <c:pt idx="7">
                  <c:v>86.635644999999997</c:v>
                </c:pt>
                <c:pt idx="8">
                  <c:v>82.998575000000002</c:v>
                </c:pt>
                <c:pt idx="9">
                  <c:v>78.93939499999999</c:v>
                </c:pt>
                <c:pt idx="10">
                  <c:v>75.245464999999996</c:v>
                </c:pt>
                <c:pt idx="11">
                  <c:v>71.114155000000011</c:v>
                </c:pt>
                <c:pt idx="12">
                  <c:v>67.541650000000004</c:v>
                </c:pt>
                <c:pt idx="13">
                  <c:v>63.320355000000006</c:v>
                </c:pt>
                <c:pt idx="14">
                  <c:v>59.246610000000011</c:v>
                </c:pt>
                <c:pt idx="15">
                  <c:v>55.341744999999996</c:v>
                </c:pt>
                <c:pt idx="16">
                  <c:v>51.467574999999997</c:v>
                </c:pt>
                <c:pt idx="17">
                  <c:v>47.965119999999999</c:v>
                </c:pt>
                <c:pt idx="18">
                  <c:v>45.009879999999995</c:v>
                </c:pt>
                <c:pt idx="19">
                  <c:v>42.289845</c:v>
                </c:pt>
                <c:pt idx="20">
                  <c:v>39.890779999999999</c:v>
                </c:pt>
                <c:pt idx="21">
                  <c:v>37.888560000000005</c:v>
                </c:pt>
                <c:pt idx="22">
                  <c:v>36.149520000000003</c:v>
                </c:pt>
                <c:pt idx="23">
                  <c:v>34.882150000000003</c:v>
                </c:pt>
                <c:pt idx="24">
                  <c:v>34.290310000000005</c:v>
                </c:pt>
                <c:pt idx="25">
                  <c:v>34.323655000000002</c:v>
                </c:pt>
                <c:pt idx="26">
                  <c:v>33.983775000000001</c:v>
                </c:pt>
                <c:pt idx="27">
                  <c:v>35.000239999999998</c:v>
                </c:pt>
                <c:pt idx="28">
                  <c:v>36.528345000000002</c:v>
                </c:pt>
                <c:pt idx="29">
                  <c:v>38.795105</c:v>
                </c:pt>
                <c:pt idx="30">
                  <c:v>41.397389999999994</c:v>
                </c:pt>
                <c:pt idx="31">
                  <c:v>44.306864999999995</c:v>
                </c:pt>
                <c:pt idx="32">
                  <c:v>48.012065</c:v>
                </c:pt>
                <c:pt idx="33">
                  <c:v>50.848295</c:v>
                </c:pt>
                <c:pt idx="34">
                  <c:v>53.994349999999997</c:v>
                </c:pt>
                <c:pt idx="35">
                  <c:v>57.150535000000012</c:v>
                </c:pt>
                <c:pt idx="36">
                  <c:v>60.952394999999996</c:v>
                </c:pt>
                <c:pt idx="37">
                  <c:v>62.909185000000008</c:v>
                </c:pt>
                <c:pt idx="38">
                  <c:v>64.78616000000001</c:v>
                </c:pt>
                <c:pt idx="39">
                  <c:v>65.815294999999992</c:v>
                </c:pt>
                <c:pt idx="40">
                  <c:v>66.058104999999998</c:v>
                </c:pt>
                <c:pt idx="41">
                  <c:v>65.928444999999996</c:v>
                </c:pt>
                <c:pt idx="42">
                  <c:v>65.561025000000001</c:v>
                </c:pt>
                <c:pt idx="43">
                  <c:v>64.939350000000005</c:v>
                </c:pt>
                <c:pt idx="44">
                  <c:v>64.945239999999984</c:v>
                </c:pt>
                <c:pt idx="45">
                  <c:v>65.903774999999996</c:v>
                </c:pt>
                <c:pt idx="46">
                  <c:v>67.197010000000006</c:v>
                </c:pt>
                <c:pt idx="47">
                  <c:v>68.543850000000006</c:v>
                </c:pt>
                <c:pt idx="48">
                  <c:v>68.799710000000005</c:v>
                </c:pt>
                <c:pt idx="49">
                  <c:v>69.307805000000002</c:v>
                </c:pt>
                <c:pt idx="50">
                  <c:v>68.840125</c:v>
                </c:pt>
                <c:pt idx="51">
                  <c:v>67.722099999999998</c:v>
                </c:pt>
                <c:pt idx="52">
                  <c:v>66.772769999999994</c:v>
                </c:pt>
                <c:pt idx="53">
                  <c:v>65.801950000000005</c:v>
                </c:pt>
                <c:pt idx="54">
                  <c:v>64.084299999999999</c:v>
                </c:pt>
                <c:pt idx="55">
                  <c:v>62.079564999999988</c:v>
                </c:pt>
                <c:pt idx="56">
                  <c:v>60.196805000000005</c:v>
                </c:pt>
                <c:pt idx="57">
                  <c:v>58.294439999999987</c:v>
                </c:pt>
                <c:pt idx="58">
                  <c:v>56.198769999999996</c:v>
                </c:pt>
                <c:pt idx="59">
                  <c:v>54.6524</c:v>
                </c:pt>
                <c:pt idx="60">
                  <c:v>53.210064999999993</c:v>
                </c:pt>
                <c:pt idx="61">
                  <c:v>51.921979999999998</c:v>
                </c:pt>
                <c:pt idx="62">
                  <c:v>51.085564999999995</c:v>
                </c:pt>
                <c:pt idx="63">
                  <c:v>50.330135000000006</c:v>
                </c:pt>
                <c:pt idx="64">
                  <c:v>49.842874999999999</c:v>
                </c:pt>
                <c:pt idx="65">
                  <c:v>48.93506</c:v>
                </c:pt>
                <c:pt idx="66">
                  <c:v>47.963355</c:v>
                </c:pt>
                <c:pt idx="67">
                  <c:v>47.121749999999999</c:v>
                </c:pt>
                <c:pt idx="68">
                  <c:v>46.761864999999993</c:v>
                </c:pt>
                <c:pt idx="69">
                  <c:v>46.102589999999999</c:v>
                </c:pt>
                <c:pt idx="70">
                  <c:v>45.432304999999999</c:v>
                </c:pt>
                <c:pt idx="71">
                  <c:v>45.203695000000003</c:v>
                </c:pt>
                <c:pt idx="72">
                  <c:v>44.523489999999995</c:v>
                </c:pt>
                <c:pt idx="73">
                  <c:v>43.792345000000005</c:v>
                </c:pt>
                <c:pt idx="74">
                  <c:v>43.538319999999999</c:v>
                </c:pt>
                <c:pt idx="75">
                  <c:v>43.678455</c:v>
                </c:pt>
                <c:pt idx="76">
                  <c:v>43.672260000000001</c:v>
                </c:pt>
                <c:pt idx="77">
                  <c:v>44.796655000000001</c:v>
                </c:pt>
                <c:pt idx="78">
                  <c:v>43.668774999999997</c:v>
                </c:pt>
                <c:pt idx="79">
                  <c:v>44.154299999999999</c:v>
                </c:pt>
                <c:pt idx="80">
                  <c:v>44.768435000000004</c:v>
                </c:pt>
                <c:pt idx="81">
                  <c:v>44.964199999999998</c:v>
                </c:pt>
                <c:pt idx="82">
                  <c:v>45.367035000000001</c:v>
                </c:pt>
                <c:pt idx="83">
                  <c:v>45.413080000000001</c:v>
                </c:pt>
                <c:pt idx="84">
                  <c:v>45.387304999999998</c:v>
                </c:pt>
                <c:pt idx="85">
                  <c:v>45.53904</c:v>
                </c:pt>
                <c:pt idx="86">
                  <c:v>45.236170000000001</c:v>
                </c:pt>
                <c:pt idx="87">
                  <c:v>45.509089999999993</c:v>
                </c:pt>
                <c:pt idx="88">
                  <c:v>44.508110000000002</c:v>
                </c:pt>
                <c:pt idx="89">
                  <c:v>44.017969999999998</c:v>
                </c:pt>
                <c:pt idx="90">
                  <c:v>43.640524999999997</c:v>
                </c:pt>
                <c:pt idx="91">
                  <c:v>43.554714999999995</c:v>
                </c:pt>
                <c:pt idx="92">
                  <c:v>43.109264999999994</c:v>
                </c:pt>
                <c:pt idx="93">
                  <c:v>42.874135000000003</c:v>
                </c:pt>
                <c:pt idx="94">
                  <c:v>42.539520000000003</c:v>
                </c:pt>
                <c:pt idx="95">
                  <c:v>41.967570000000002</c:v>
                </c:pt>
                <c:pt idx="96">
                  <c:v>41.181389999999993</c:v>
                </c:pt>
                <c:pt idx="97">
                  <c:v>40.532325</c:v>
                </c:pt>
                <c:pt idx="98">
                  <c:v>39.843379999999996</c:v>
                </c:pt>
                <c:pt idx="99">
                  <c:v>39.629439999999995</c:v>
                </c:pt>
                <c:pt idx="100">
                  <c:v>39.276335000000003</c:v>
                </c:pt>
                <c:pt idx="101">
                  <c:v>38.992280000000001</c:v>
                </c:pt>
                <c:pt idx="102">
                  <c:v>38.418455000000002</c:v>
                </c:pt>
                <c:pt idx="103">
                  <c:v>37.683100000000003</c:v>
                </c:pt>
                <c:pt idx="104">
                  <c:v>37.217075000000001</c:v>
                </c:pt>
                <c:pt idx="105">
                  <c:v>36.313369999999999</c:v>
                </c:pt>
                <c:pt idx="106">
                  <c:v>35.630439999999993</c:v>
                </c:pt>
                <c:pt idx="107">
                  <c:v>35.002070000000003</c:v>
                </c:pt>
                <c:pt idx="108">
                  <c:v>34.593344999999999</c:v>
                </c:pt>
                <c:pt idx="109">
                  <c:v>34.010304999999995</c:v>
                </c:pt>
                <c:pt idx="110">
                  <c:v>33.683779999999999</c:v>
                </c:pt>
                <c:pt idx="111">
                  <c:v>33.353875000000002</c:v>
                </c:pt>
                <c:pt idx="112">
                  <c:v>32.795989999999996</c:v>
                </c:pt>
                <c:pt idx="113">
                  <c:v>32.611910000000002</c:v>
                </c:pt>
                <c:pt idx="114">
                  <c:v>32.641529999999996</c:v>
                </c:pt>
                <c:pt idx="115">
                  <c:v>32.29316</c:v>
                </c:pt>
                <c:pt idx="116">
                  <c:v>32.151785000000004</c:v>
                </c:pt>
                <c:pt idx="117">
                  <c:v>31.711695000000002</c:v>
                </c:pt>
                <c:pt idx="118">
                  <c:v>31.263555</c:v>
                </c:pt>
                <c:pt idx="119">
                  <c:v>30.927570000000003</c:v>
                </c:pt>
                <c:pt idx="120">
                  <c:v>30.887845000000002</c:v>
                </c:pt>
                <c:pt idx="121">
                  <c:v>30.62585</c:v>
                </c:pt>
                <c:pt idx="122">
                  <c:v>30.703489999999995</c:v>
                </c:pt>
                <c:pt idx="123">
                  <c:v>30.59357</c:v>
                </c:pt>
                <c:pt idx="124">
                  <c:v>30.325060000000004</c:v>
                </c:pt>
                <c:pt idx="125">
                  <c:v>30.064339999999998</c:v>
                </c:pt>
                <c:pt idx="126">
                  <c:v>29.743649999999999</c:v>
                </c:pt>
                <c:pt idx="127">
                  <c:v>29.389039999999998</c:v>
                </c:pt>
                <c:pt idx="128">
                  <c:v>29.072489999999995</c:v>
                </c:pt>
                <c:pt idx="129">
                  <c:v>28.7970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EFD-45D7-92C5-21BF46F8D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781760"/>
        <c:axId val="65783296"/>
      </c:lineChart>
      <c:catAx>
        <c:axId val="65781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578329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578329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5781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Z$17:$BZ$146</c:f>
              <c:numCache>
                <c:formatCode>0.00</c:formatCode>
                <c:ptCount val="130"/>
                <c:pt idx="0">
                  <c:v>13.118514999999997</c:v>
                </c:pt>
                <c:pt idx="1">
                  <c:v>16.881595000000001</c:v>
                </c:pt>
                <c:pt idx="2">
                  <c:v>16.470879999999998</c:v>
                </c:pt>
                <c:pt idx="3">
                  <c:v>14.985845000000001</c:v>
                </c:pt>
                <c:pt idx="4">
                  <c:v>13.571645000000002</c:v>
                </c:pt>
                <c:pt idx="5">
                  <c:v>12.130279999999999</c:v>
                </c:pt>
                <c:pt idx="6">
                  <c:v>11.271145000000001</c:v>
                </c:pt>
                <c:pt idx="7">
                  <c:v>10.775745000000001</c:v>
                </c:pt>
                <c:pt idx="8">
                  <c:v>9.8740749999999995</c:v>
                </c:pt>
                <c:pt idx="9">
                  <c:v>9.402095000000001</c:v>
                </c:pt>
                <c:pt idx="10">
                  <c:v>9.4623649999999966</c:v>
                </c:pt>
                <c:pt idx="11">
                  <c:v>10.171654999999999</c:v>
                </c:pt>
                <c:pt idx="12">
                  <c:v>12.575749999999999</c:v>
                </c:pt>
                <c:pt idx="13">
                  <c:v>17.702154999999998</c:v>
                </c:pt>
                <c:pt idx="14">
                  <c:v>24.165910000000004</c:v>
                </c:pt>
                <c:pt idx="15">
                  <c:v>32.439045</c:v>
                </c:pt>
                <c:pt idx="16">
                  <c:v>44.469974999999998</c:v>
                </c:pt>
                <c:pt idx="17">
                  <c:v>59.827719999999992</c:v>
                </c:pt>
                <c:pt idx="18">
                  <c:v>78.390680000000003</c:v>
                </c:pt>
                <c:pt idx="19">
                  <c:v>96.335645</c:v>
                </c:pt>
                <c:pt idx="20">
                  <c:v>110.71158</c:v>
                </c:pt>
                <c:pt idx="21">
                  <c:v>117.74876</c:v>
                </c:pt>
                <c:pt idx="22">
                  <c:v>118.54772</c:v>
                </c:pt>
                <c:pt idx="23">
                  <c:v>115.46684999999999</c:v>
                </c:pt>
                <c:pt idx="24">
                  <c:v>108.44551000000001</c:v>
                </c:pt>
                <c:pt idx="25">
                  <c:v>100.029455</c:v>
                </c:pt>
                <c:pt idx="26">
                  <c:v>90.717574999999997</c:v>
                </c:pt>
                <c:pt idx="27">
                  <c:v>82.730639999999994</c:v>
                </c:pt>
                <c:pt idx="28">
                  <c:v>75.435845</c:v>
                </c:pt>
                <c:pt idx="29">
                  <c:v>70.515105000000005</c:v>
                </c:pt>
                <c:pt idx="30">
                  <c:v>66.441289999999995</c:v>
                </c:pt>
                <c:pt idx="31">
                  <c:v>62.648264999999988</c:v>
                </c:pt>
                <c:pt idx="32">
                  <c:v>59.276364999999991</c:v>
                </c:pt>
                <c:pt idx="33">
                  <c:v>54.798094999999996</c:v>
                </c:pt>
                <c:pt idx="34">
                  <c:v>50.521349999999998</c:v>
                </c:pt>
                <c:pt idx="35">
                  <c:v>46.692335000000007</c:v>
                </c:pt>
                <c:pt idx="36">
                  <c:v>44.040995000000002</c:v>
                </c:pt>
                <c:pt idx="37">
                  <c:v>42.894685000000003</c:v>
                </c:pt>
                <c:pt idx="38">
                  <c:v>43.596060000000001</c:v>
                </c:pt>
                <c:pt idx="39">
                  <c:v>45.374994999999998</c:v>
                </c:pt>
                <c:pt idx="40">
                  <c:v>48.689504999999997</c:v>
                </c:pt>
                <c:pt idx="41">
                  <c:v>52.827844999999996</c:v>
                </c:pt>
                <c:pt idx="42">
                  <c:v>57.959225000000004</c:v>
                </c:pt>
                <c:pt idx="43">
                  <c:v>63.06185</c:v>
                </c:pt>
                <c:pt idx="44">
                  <c:v>66.717139999999986</c:v>
                </c:pt>
                <c:pt idx="45">
                  <c:v>66.791274999999999</c:v>
                </c:pt>
                <c:pt idx="46">
                  <c:v>66.306010000000015</c:v>
                </c:pt>
                <c:pt idx="47">
                  <c:v>65.70805</c:v>
                </c:pt>
                <c:pt idx="48">
                  <c:v>64.786710000000014</c:v>
                </c:pt>
                <c:pt idx="49">
                  <c:v>63.868905000000005</c:v>
                </c:pt>
                <c:pt idx="50">
                  <c:v>62.709724999999999</c:v>
                </c:pt>
                <c:pt idx="51">
                  <c:v>61.340299999999999</c:v>
                </c:pt>
                <c:pt idx="52">
                  <c:v>60.069669999999995</c:v>
                </c:pt>
                <c:pt idx="53">
                  <c:v>57.478949999999998</c:v>
                </c:pt>
                <c:pt idx="54">
                  <c:v>54.881799999999998</c:v>
                </c:pt>
                <c:pt idx="55">
                  <c:v>51.940864999999995</c:v>
                </c:pt>
                <c:pt idx="56">
                  <c:v>49.120505000000001</c:v>
                </c:pt>
                <c:pt idx="57">
                  <c:v>46.731339999999996</c:v>
                </c:pt>
                <c:pt idx="58">
                  <c:v>44.223170000000003</c:v>
                </c:pt>
                <c:pt idx="59">
                  <c:v>41.953899999999997</c:v>
                </c:pt>
                <c:pt idx="60">
                  <c:v>39.889264999999995</c:v>
                </c:pt>
                <c:pt idx="61">
                  <c:v>38.403779999999998</c:v>
                </c:pt>
                <c:pt idx="62">
                  <c:v>37.786465</c:v>
                </c:pt>
                <c:pt idx="63">
                  <c:v>37.780135000000001</c:v>
                </c:pt>
                <c:pt idx="64">
                  <c:v>38.522874999999999</c:v>
                </c:pt>
                <c:pt idx="65">
                  <c:v>39.362960000000001</c:v>
                </c:pt>
                <c:pt idx="66">
                  <c:v>40.125054999999996</c:v>
                </c:pt>
                <c:pt idx="67">
                  <c:v>40.879449999999999</c:v>
                </c:pt>
                <c:pt idx="68">
                  <c:v>41.262864999999998</c:v>
                </c:pt>
                <c:pt idx="69">
                  <c:v>41.864389999999993</c:v>
                </c:pt>
                <c:pt idx="70">
                  <c:v>43.175305000000002</c:v>
                </c:pt>
                <c:pt idx="71">
                  <c:v>44.130195000000001</c:v>
                </c:pt>
                <c:pt idx="72">
                  <c:v>44.894689999999997</c:v>
                </c:pt>
                <c:pt idx="73">
                  <c:v>45.169245000000004</c:v>
                </c:pt>
                <c:pt idx="74">
                  <c:v>45.25882</c:v>
                </c:pt>
                <c:pt idx="75">
                  <c:v>45.179454999999997</c:v>
                </c:pt>
                <c:pt idx="76">
                  <c:v>44.220960000000005</c:v>
                </c:pt>
                <c:pt idx="77">
                  <c:v>42.749755</c:v>
                </c:pt>
                <c:pt idx="78">
                  <c:v>41.012475000000002</c:v>
                </c:pt>
                <c:pt idx="79">
                  <c:v>39.358800000000002</c:v>
                </c:pt>
                <c:pt idx="80">
                  <c:v>37.620435000000001</c:v>
                </c:pt>
                <c:pt idx="81">
                  <c:v>35.832599999999999</c:v>
                </c:pt>
                <c:pt idx="82">
                  <c:v>34.235835000000002</c:v>
                </c:pt>
                <c:pt idx="83">
                  <c:v>32.532080000000001</c:v>
                </c:pt>
                <c:pt idx="84">
                  <c:v>30.951805</c:v>
                </c:pt>
                <c:pt idx="85">
                  <c:v>30.277539999999995</c:v>
                </c:pt>
                <c:pt idx="86">
                  <c:v>29.58877</c:v>
                </c:pt>
                <c:pt idx="87">
                  <c:v>29.043389999999995</c:v>
                </c:pt>
                <c:pt idx="88">
                  <c:v>29.055710000000005</c:v>
                </c:pt>
                <c:pt idx="89">
                  <c:v>29.16527</c:v>
                </c:pt>
                <c:pt idx="90">
                  <c:v>30.011624999999999</c:v>
                </c:pt>
                <c:pt idx="91">
                  <c:v>31.036214999999995</c:v>
                </c:pt>
                <c:pt idx="92">
                  <c:v>31.914064999999997</c:v>
                </c:pt>
                <c:pt idx="93">
                  <c:v>33.131135</c:v>
                </c:pt>
                <c:pt idx="94">
                  <c:v>34.07452</c:v>
                </c:pt>
                <c:pt idx="95">
                  <c:v>34.926169999999999</c:v>
                </c:pt>
                <c:pt idx="96">
                  <c:v>35.144089999999998</c:v>
                </c:pt>
                <c:pt idx="97">
                  <c:v>35.165525000000002</c:v>
                </c:pt>
                <c:pt idx="98">
                  <c:v>34.619979999999998</c:v>
                </c:pt>
                <c:pt idx="99">
                  <c:v>33.984539999999996</c:v>
                </c:pt>
                <c:pt idx="100">
                  <c:v>32.732835000000001</c:v>
                </c:pt>
                <c:pt idx="101">
                  <c:v>31.603479999999998</c:v>
                </c:pt>
                <c:pt idx="102">
                  <c:v>30.349055</c:v>
                </c:pt>
                <c:pt idx="103">
                  <c:v>28.978000000000002</c:v>
                </c:pt>
                <c:pt idx="104">
                  <c:v>27.832374999999999</c:v>
                </c:pt>
                <c:pt idx="105">
                  <c:v>26.31277</c:v>
                </c:pt>
                <c:pt idx="106">
                  <c:v>24.866539999999997</c:v>
                </c:pt>
                <c:pt idx="107">
                  <c:v>23.825670000000002</c:v>
                </c:pt>
                <c:pt idx="108">
                  <c:v>22.585045000000001</c:v>
                </c:pt>
                <c:pt idx="109">
                  <c:v>21.842305</c:v>
                </c:pt>
                <c:pt idx="110">
                  <c:v>21.05808</c:v>
                </c:pt>
                <c:pt idx="111">
                  <c:v>20.501075</c:v>
                </c:pt>
                <c:pt idx="112">
                  <c:v>20.354889999999997</c:v>
                </c:pt>
                <c:pt idx="113">
                  <c:v>20.901910000000004</c:v>
                </c:pt>
                <c:pt idx="114">
                  <c:v>21.665429999999997</c:v>
                </c:pt>
                <c:pt idx="115">
                  <c:v>22.598660000000002</c:v>
                </c:pt>
                <c:pt idx="116">
                  <c:v>23.897585000000003</c:v>
                </c:pt>
                <c:pt idx="117">
                  <c:v>24.923195</c:v>
                </c:pt>
                <c:pt idx="118">
                  <c:v>26.220654999999997</c:v>
                </c:pt>
                <c:pt idx="119">
                  <c:v>27.184470000000001</c:v>
                </c:pt>
                <c:pt idx="120">
                  <c:v>27.856445000000001</c:v>
                </c:pt>
                <c:pt idx="121">
                  <c:v>28.086849999999998</c:v>
                </c:pt>
                <c:pt idx="122">
                  <c:v>28.017689999999998</c:v>
                </c:pt>
                <c:pt idx="123">
                  <c:v>27.652470000000001</c:v>
                </c:pt>
                <c:pt idx="124">
                  <c:v>26.897760000000005</c:v>
                </c:pt>
                <c:pt idx="125">
                  <c:v>25.878739999999997</c:v>
                </c:pt>
                <c:pt idx="126">
                  <c:v>24.876249999999999</c:v>
                </c:pt>
                <c:pt idx="127">
                  <c:v>23.673539999999996</c:v>
                </c:pt>
                <c:pt idx="128">
                  <c:v>22.457989999999995</c:v>
                </c:pt>
                <c:pt idx="129">
                  <c:v>21.3995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8FB-43D0-9A49-B51B0FA99D7F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A$17:$CA$146</c:f>
              <c:numCache>
                <c:formatCode>0.00</c:formatCode>
                <c:ptCount val="130"/>
                <c:pt idx="0">
                  <c:v>12.585014999999997</c:v>
                </c:pt>
                <c:pt idx="1">
                  <c:v>16.429695000000002</c:v>
                </c:pt>
                <c:pt idx="2">
                  <c:v>16.828879999999998</c:v>
                </c:pt>
                <c:pt idx="3">
                  <c:v>16.138545000000001</c:v>
                </c:pt>
                <c:pt idx="4">
                  <c:v>14.964145000000002</c:v>
                </c:pt>
                <c:pt idx="5">
                  <c:v>13.224479999999998</c:v>
                </c:pt>
                <c:pt idx="6">
                  <c:v>12.686545000000001</c:v>
                </c:pt>
                <c:pt idx="7">
                  <c:v>12.039645000000002</c:v>
                </c:pt>
                <c:pt idx="8">
                  <c:v>11.426075000000001</c:v>
                </c:pt>
                <c:pt idx="9">
                  <c:v>10.721795000000002</c:v>
                </c:pt>
                <c:pt idx="10">
                  <c:v>10.221864999999996</c:v>
                </c:pt>
                <c:pt idx="11">
                  <c:v>10.280555</c:v>
                </c:pt>
                <c:pt idx="12">
                  <c:v>11.77805</c:v>
                </c:pt>
                <c:pt idx="13">
                  <c:v>15.781854999999998</c:v>
                </c:pt>
                <c:pt idx="14">
                  <c:v>23.492010000000004</c:v>
                </c:pt>
                <c:pt idx="15">
                  <c:v>32.287845000000004</c:v>
                </c:pt>
                <c:pt idx="16">
                  <c:v>44.653075000000001</c:v>
                </c:pt>
                <c:pt idx="17">
                  <c:v>61.351719999999993</c:v>
                </c:pt>
                <c:pt idx="18">
                  <c:v>82.092280000000002</c:v>
                </c:pt>
                <c:pt idx="19">
                  <c:v>101.97284499999999</c:v>
                </c:pt>
                <c:pt idx="20">
                  <c:v>118.13118</c:v>
                </c:pt>
                <c:pt idx="21">
                  <c:v>125.53656000000001</c:v>
                </c:pt>
                <c:pt idx="22">
                  <c:v>124.97492</c:v>
                </c:pt>
                <c:pt idx="23">
                  <c:v>119.63634999999999</c:v>
                </c:pt>
                <c:pt idx="24">
                  <c:v>110.64781000000001</c:v>
                </c:pt>
                <c:pt idx="25">
                  <c:v>101.538555</c:v>
                </c:pt>
                <c:pt idx="26">
                  <c:v>93.043774999999997</c:v>
                </c:pt>
                <c:pt idx="27">
                  <c:v>84.250339999999994</c:v>
                </c:pt>
                <c:pt idx="28">
                  <c:v>77.454444999999993</c:v>
                </c:pt>
                <c:pt idx="29">
                  <c:v>71.076205000000002</c:v>
                </c:pt>
                <c:pt idx="30">
                  <c:v>65.289989999999989</c:v>
                </c:pt>
                <c:pt idx="31">
                  <c:v>60.068764999999992</c:v>
                </c:pt>
                <c:pt idx="32">
                  <c:v>55.772364999999994</c:v>
                </c:pt>
                <c:pt idx="33">
                  <c:v>51.378695</c:v>
                </c:pt>
                <c:pt idx="34">
                  <c:v>48.294350000000001</c:v>
                </c:pt>
                <c:pt idx="35">
                  <c:v>44.912435000000002</c:v>
                </c:pt>
                <c:pt idx="36">
                  <c:v>42.626694999999998</c:v>
                </c:pt>
                <c:pt idx="37">
                  <c:v>41.287985000000006</c:v>
                </c:pt>
                <c:pt idx="38">
                  <c:v>41.171660000000003</c:v>
                </c:pt>
                <c:pt idx="39">
                  <c:v>41.587895000000003</c:v>
                </c:pt>
                <c:pt idx="40">
                  <c:v>43.497504999999997</c:v>
                </c:pt>
                <c:pt idx="41">
                  <c:v>46.573945000000002</c:v>
                </c:pt>
                <c:pt idx="42">
                  <c:v>50.343224999999997</c:v>
                </c:pt>
                <c:pt idx="43">
                  <c:v>53.616349999999997</c:v>
                </c:pt>
                <c:pt idx="44">
                  <c:v>55.743239999999993</c:v>
                </c:pt>
                <c:pt idx="45">
                  <c:v>57.478774999999999</c:v>
                </c:pt>
                <c:pt idx="46">
                  <c:v>59.692910000000012</c:v>
                </c:pt>
                <c:pt idx="47">
                  <c:v>62.192450000000001</c:v>
                </c:pt>
                <c:pt idx="48">
                  <c:v>64.10851000000001</c:v>
                </c:pt>
                <c:pt idx="49">
                  <c:v>65.159305000000003</c:v>
                </c:pt>
                <c:pt idx="50">
                  <c:v>64.754625000000004</c:v>
                </c:pt>
                <c:pt idx="51">
                  <c:v>63.546399999999998</c:v>
                </c:pt>
                <c:pt idx="52">
                  <c:v>61.922769999999993</c:v>
                </c:pt>
                <c:pt idx="53">
                  <c:v>59.280149999999999</c:v>
                </c:pt>
                <c:pt idx="54">
                  <c:v>56.139800000000001</c:v>
                </c:pt>
                <c:pt idx="55">
                  <c:v>53.239164999999993</c:v>
                </c:pt>
                <c:pt idx="56">
                  <c:v>50.117004999999999</c:v>
                </c:pt>
                <c:pt idx="57">
                  <c:v>47.121839999999999</c:v>
                </c:pt>
                <c:pt idx="58">
                  <c:v>44.03537</c:v>
                </c:pt>
                <c:pt idx="59">
                  <c:v>41.246899999999997</c:v>
                </c:pt>
                <c:pt idx="60">
                  <c:v>38.427264999999998</c:v>
                </c:pt>
                <c:pt idx="61">
                  <c:v>36.094279999999998</c:v>
                </c:pt>
                <c:pt idx="62">
                  <c:v>34.594764999999995</c:v>
                </c:pt>
                <c:pt idx="63">
                  <c:v>33.723135000000006</c:v>
                </c:pt>
                <c:pt idx="64">
                  <c:v>34.067475000000002</c:v>
                </c:pt>
                <c:pt idx="65">
                  <c:v>35.318160000000006</c:v>
                </c:pt>
                <c:pt idx="66">
                  <c:v>37.369254999999995</c:v>
                </c:pt>
                <c:pt idx="67">
                  <c:v>39.334650000000003</c:v>
                </c:pt>
                <c:pt idx="68">
                  <c:v>40.138364999999993</c:v>
                </c:pt>
                <c:pt idx="69">
                  <c:v>40.459289999999996</c:v>
                </c:pt>
                <c:pt idx="70">
                  <c:v>41.341304999999998</c:v>
                </c:pt>
                <c:pt idx="71">
                  <c:v>41.920095000000003</c:v>
                </c:pt>
                <c:pt idx="72">
                  <c:v>42.752889999999994</c:v>
                </c:pt>
                <c:pt idx="73">
                  <c:v>42.906545000000001</c:v>
                </c:pt>
                <c:pt idx="74">
                  <c:v>43.030419999999999</c:v>
                </c:pt>
                <c:pt idx="75">
                  <c:v>42.674754999999998</c:v>
                </c:pt>
                <c:pt idx="76">
                  <c:v>41.624660000000006</c:v>
                </c:pt>
                <c:pt idx="77">
                  <c:v>40.191155000000002</c:v>
                </c:pt>
                <c:pt idx="78">
                  <c:v>38.694474999999997</c:v>
                </c:pt>
                <c:pt idx="79">
                  <c:v>36.820700000000002</c:v>
                </c:pt>
                <c:pt idx="80">
                  <c:v>34.907435000000007</c:v>
                </c:pt>
                <c:pt idx="81">
                  <c:v>32.7697</c:v>
                </c:pt>
                <c:pt idx="82">
                  <c:v>30.684135000000005</c:v>
                </c:pt>
                <c:pt idx="83">
                  <c:v>28.50948</c:v>
                </c:pt>
                <c:pt idx="84">
                  <c:v>26.635904999999998</c:v>
                </c:pt>
                <c:pt idx="85">
                  <c:v>25.092839999999995</c:v>
                </c:pt>
                <c:pt idx="86">
                  <c:v>24.019870000000001</c:v>
                </c:pt>
                <c:pt idx="87">
                  <c:v>23.037489999999998</c:v>
                </c:pt>
                <c:pt idx="88">
                  <c:v>23.055210000000002</c:v>
                </c:pt>
                <c:pt idx="89">
                  <c:v>23.666170000000001</c:v>
                </c:pt>
                <c:pt idx="90">
                  <c:v>24.565825</c:v>
                </c:pt>
                <c:pt idx="91">
                  <c:v>25.654814999999996</c:v>
                </c:pt>
                <c:pt idx="92">
                  <c:v>26.630164999999998</c:v>
                </c:pt>
                <c:pt idx="93">
                  <c:v>28.050635000000003</c:v>
                </c:pt>
                <c:pt idx="94">
                  <c:v>29.381420000000002</c:v>
                </c:pt>
                <c:pt idx="95">
                  <c:v>30.458770000000001</c:v>
                </c:pt>
                <c:pt idx="96">
                  <c:v>31.202989999999996</c:v>
                </c:pt>
                <c:pt idx="97">
                  <c:v>31.674925000000002</c:v>
                </c:pt>
                <c:pt idx="98">
                  <c:v>31.409179999999999</c:v>
                </c:pt>
                <c:pt idx="99">
                  <c:v>31.173439999999996</c:v>
                </c:pt>
                <c:pt idx="100">
                  <c:v>30.147935000000004</c:v>
                </c:pt>
                <c:pt idx="101">
                  <c:v>29.508679999999998</c:v>
                </c:pt>
                <c:pt idx="102">
                  <c:v>28.569154999999999</c:v>
                </c:pt>
                <c:pt idx="103">
                  <c:v>27.381699999999999</c:v>
                </c:pt>
                <c:pt idx="104">
                  <c:v>26.215975</c:v>
                </c:pt>
                <c:pt idx="105">
                  <c:v>24.82047</c:v>
                </c:pt>
                <c:pt idx="106">
                  <c:v>23.420839999999995</c:v>
                </c:pt>
                <c:pt idx="107">
                  <c:v>22.37087</c:v>
                </c:pt>
                <c:pt idx="108">
                  <c:v>20.923345000000001</c:v>
                </c:pt>
                <c:pt idx="109">
                  <c:v>19.915505</c:v>
                </c:pt>
                <c:pt idx="110">
                  <c:v>19.05058</c:v>
                </c:pt>
                <c:pt idx="111">
                  <c:v>18.523575000000001</c:v>
                </c:pt>
                <c:pt idx="112">
                  <c:v>18.101689999999998</c:v>
                </c:pt>
                <c:pt idx="113">
                  <c:v>18.180810000000005</c:v>
                </c:pt>
                <c:pt idx="114">
                  <c:v>18.51463</c:v>
                </c:pt>
                <c:pt idx="115">
                  <c:v>19.263860000000005</c:v>
                </c:pt>
                <c:pt idx="116">
                  <c:v>20.180385000000005</c:v>
                </c:pt>
                <c:pt idx="117">
                  <c:v>21.155095000000003</c:v>
                </c:pt>
                <c:pt idx="118">
                  <c:v>22.462954999999997</c:v>
                </c:pt>
                <c:pt idx="119">
                  <c:v>23.635670000000001</c:v>
                </c:pt>
                <c:pt idx="120">
                  <c:v>24.565645</c:v>
                </c:pt>
                <c:pt idx="121">
                  <c:v>24.91245</c:v>
                </c:pt>
                <c:pt idx="122">
                  <c:v>25.382889999999996</c:v>
                </c:pt>
                <c:pt idx="123">
                  <c:v>25.34967</c:v>
                </c:pt>
                <c:pt idx="124">
                  <c:v>24.920860000000005</c:v>
                </c:pt>
                <c:pt idx="125">
                  <c:v>24.720539999999996</c:v>
                </c:pt>
                <c:pt idx="126">
                  <c:v>24.067450000000001</c:v>
                </c:pt>
                <c:pt idx="127">
                  <c:v>23.215839999999996</c:v>
                </c:pt>
                <c:pt idx="128">
                  <c:v>22.452389999999998</c:v>
                </c:pt>
                <c:pt idx="129">
                  <c:v>21.5377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FB-43D0-9A49-B51B0FA99D7F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B$17:$CB$146</c:f>
              <c:numCache>
                <c:formatCode>0.00</c:formatCode>
                <c:ptCount val="130"/>
                <c:pt idx="0">
                  <c:v>12.266814999999996</c:v>
                </c:pt>
                <c:pt idx="1">
                  <c:v>15.715095000000002</c:v>
                </c:pt>
                <c:pt idx="2">
                  <c:v>15.64448</c:v>
                </c:pt>
                <c:pt idx="3">
                  <c:v>15.470045000000001</c:v>
                </c:pt>
                <c:pt idx="4">
                  <c:v>14.297745000000001</c:v>
                </c:pt>
                <c:pt idx="5">
                  <c:v>13.254979999999998</c:v>
                </c:pt>
                <c:pt idx="6">
                  <c:v>12.640145</c:v>
                </c:pt>
                <c:pt idx="7">
                  <c:v>12.133645000000001</c:v>
                </c:pt>
                <c:pt idx="8">
                  <c:v>11.948475</c:v>
                </c:pt>
                <c:pt idx="9">
                  <c:v>11.661495</c:v>
                </c:pt>
                <c:pt idx="10">
                  <c:v>11.840364999999997</c:v>
                </c:pt>
                <c:pt idx="11">
                  <c:v>12.816654999999999</c:v>
                </c:pt>
                <c:pt idx="12">
                  <c:v>15.443049999999999</c:v>
                </c:pt>
                <c:pt idx="13">
                  <c:v>20.885555</c:v>
                </c:pt>
                <c:pt idx="14">
                  <c:v>29.564910000000005</c:v>
                </c:pt>
                <c:pt idx="15">
                  <c:v>40.040044999999999</c:v>
                </c:pt>
                <c:pt idx="16">
                  <c:v>53.973475000000001</c:v>
                </c:pt>
                <c:pt idx="17">
                  <c:v>72.024919999999995</c:v>
                </c:pt>
                <c:pt idx="18">
                  <c:v>94.259680000000003</c:v>
                </c:pt>
                <c:pt idx="19">
                  <c:v>112.89874499999999</c:v>
                </c:pt>
                <c:pt idx="20">
                  <c:v>127.79388</c:v>
                </c:pt>
                <c:pt idx="21">
                  <c:v>133.00016000000002</c:v>
                </c:pt>
                <c:pt idx="22">
                  <c:v>132.15001999999998</c:v>
                </c:pt>
                <c:pt idx="23">
                  <c:v>128.07355000000001</c:v>
                </c:pt>
                <c:pt idx="24">
                  <c:v>119.89571000000001</c:v>
                </c:pt>
                <c:pt idx="25">
                  <c:v>111.058255</c:v>
                </c:pt>
                <c:pt idx="26">
                  <c:v>101.335475</c:v>
                </c:pt>
                <c:pt idx="27">
                  <c:v>94.065739999999991</c:v>
                </c:pt>
                <c:pt idx="28">
                  <c:v>86.688644999999994</c:v>
                </c:pt>
                <c:pt idx="29">
                  <c:v>80.896005000000002</c:v>
                </c:pt>
                <c:pt idx="30">
                  <c:v>74.722089999999994</c:v>
                </c:pt>
                <c:pt idx="31">
                  <c:v>68.06206499999999</c:v>
                </c:pt>
                <c:pt idx="32">
                  <c:v>62.791364999999992</c:v>
                </c:pt>
                <c:pt idx="33">
                  <c:v>57.868694999999995</c:v>
                </c:pt>
                <c:pt idx="34">
                  <c:v>54.290349999999997</c:v>
                </c:pt>
                <c:pt idx="35">
                  <c:v>51.672435</c:v>
                </c:pt>
                <c:pt idx="36">
                  <c:v>50.825895000000003</c:v>
                </c:pt>
                <c:pt idx="37">
                  <c:v>50.538485000000001</c:v>
                </c:pt>
                <c:pt idx="38">
                  <c:v>51.492660000000001</c:v>
                </c:pt>
                <c:pt idx="39">
                  <c:v>52.827994999999994</c:v>
                </c:pt>
                <c:pt idx="40">
                  <c:v>56.305405000000007</c:v>
                </c:pt>
                <c:pt idx="41">
                  <c:v>61.759144999999997</c:v>
                </c:pt>
                <c:pt idx="42">
                  <c:v>66.928725</c:v>
                </c:pt>
                <c:pt idx="43">
                  <c:v>70.656850000000006</c:v>
                </c:pt>
                <c:pt idx="44">
                  <c:v>72.612239999999986</c:v>
                </c:pt>
                <c:pt idx="45">
                  <c:v>74.434674999999999</c:v>
                </c:pt>
                <c:pt idx="46">
                  <c:v>76.148610000000005</c:v>
                </c:pt>
                <c:pt idx="47">
                  <c:v>77.841750000000005</c:v>
                </c:pt>
                <c:pt idx="48">
                  <c:v>78.154610000000005</c:v>
                </c:pt>
                <c:pt idx="49">
                  <c:v>77.644805000000005</c:v>
                </c:pt>
                <c:pt idx="50">
                  <c:v>76.074124999999995</c:v>
                </c:pt>
                <c:pt idx="51">
                  <c:v>73.719700000000003</c:v>
                </c:pt>
                <c:pt idx="52">
                  <c:v>71.413069999999991</c:v>
                </c:pt>
                <c:pt idx="53">
                  <c:v>68.261949999999999</c:v>
                </c:pt>
                <c:pt idx="54">
                  <c:v>64.897900000000007</c:v>
                </c:pt>
                <c:pt idx="55">
                  <c:v>61.609564999999989</c:v>
                </c:pt>
                <c:pt idx="56">
                  <c:v>57.466805000000008</c:v>
                </c:pt>
                <c:pt idx="57">
                  <c:v>54.028639999999989</c:v>
                </c:pt>
                <c:pt idx="58">
                  <c:v>50.206670000000003</c:v>
                </c:pt>
                <c:pt idx="59">
                  <c:v>46.422499999999999</c:v>
                </c:pt>
                <c:pt idx="60">
                  <c:v>42.845464999999997</c:v>
                </c:pt>
                <c:pt idx="61">
                  <c:v>39.456379999999996</c:v>
                </c:pt>
                <c:pt idx="62">
                  <c:v>36.863864999999997</c:v>
                </c:pt>
                <c:pt idx="63">
                  <c:v>35.659735000000005</c:v>
                </c:pt>
                <c:pt idx="64">
                  <c:v>35.794175000000003</c:v>
                </c:pt>
                <c:pt idx="65">
                  <c:v>38.084060000000001</c:v>
                </c:pt>
                <c:pt idx="66">
                  <c:v>41.952354999999997</c:v>
                </c:pt>
                <c:pt idx="67">
                  <c:v>46.282350000000001</c:v>
                </c:pt>
                <c:pt idx="68">
                  <c:v>49.252064999999995</c:v>
                </c:pt>
                <c:pt idx="69">
                  <c:v>50.217189999999995</c:v>
                </c:pt>
                <c:pt idx="70">
                  <c:v>50.702604999999998</c:v>
                </c:pt>
                <c:pt idx="71">
                  <c:v>50.822895000000003</c:v>
                </c:pt>
                <c:pt idx="72">
                  <c:v>51.023689999999995</c:v>
                </c:pt>
                <c:pt idx="73">
                  <c:v>50.287244999999999</c:v>
                </c:pt>
                <c:pt idx="74">
                  <c:v>49.268120000000003</c:v>
                </c:pt>
                <c:pt idx="75">
                  <c:v>47.705455000000001</c:v>
                </c:pt>
                <c:pt idx="76">
                  <c:v>46.066560000000003</c:v>
                </c:pt>
                <c:pt idx="77">
                  <c:v>43.969654999999996</c:v>
                </c:pt>
                <c:pt idx="78">
                  <c:v>41.644075000000001</c:v>
                </c:pt>
                <c:pt idx="79">
                  <c:v>39.36</c:v>
                </c:pt>
                <c:pt idx="80">
                  <c:v>38.060935000000001</c:v>
                </c:pt>
                <c:pt idx="81">
                  <c:v>34.694899999999997</c:v>
                </c:pt>
                <c:pt idx="82">
                  <c:v>32.674335000000006</c:v>
                </c:pt>
                <c:pt idx="83">
                  <c:v>29.977979999999999</c:v>
                </c:pt>
                <c:pt idx="84">
                  <c:v>28.136904999999999</c:v>
                </c:pt>
                <c:pt idx="85">
                  <c:v>26.923139999999997</c:v>
                </c:pt>
                <c:pt idx="86">
                  <c:v>26.119070000000001</c:v>
                </c:pt>
                <c:pt idx="87">
                  <c:v>25.507789999999996</c:v>
                </c:pt>
                <c:pt idx="88">
                  <c:v>25.672310000000003</c:v>
                </c:pt>
                <c:pt idx="89">
                  <c:v>26.286770000000001</c:v>
                </c:pt>
                <c:pt idx="90">
                  <c:v>27.550924999999999</c:v>
                </c:pt>
                <c:pt idx="91">
                  <c:v>29.109214999999995</c:v>
                </c:pt>
                <c:pt idx="92">
                  <c:v>30.499464999999997</c:v>
                </c:pt>
                <c:pt idx="93">
                  <c:v>32.402835000000003</c:v>
                </c:pt>
                <c:pt idx="94">
                  <c:v>34.027120000000004</c:v>
                </c:pt>
                <c:pt idx="95">
                  <c:v>35.568770000000001</c:v>
                </c:pt>
                <c:pt idx="96">
                  <c:v>36.299789999999994</c:v>
                </c:pt>
                <c:pt idx="97">
                  <c:v>36.566524999999999</c:v>
                </c:pt>
                <c:pt idx="98">
                  <c:v>36.56288</c:v>
                </c:pt>
                <c:pt idx="99">
                  <c:v>36.22354</c:v>
                </c:pt>
                <c:pt idx="100">
                  <c:v>35.118135000000002</c:v>
                </c:pt>
                <c:pt idx="101">
                  <c:v>33.950679999999998</c:v>
                </c:pt>
                <c:pt idx="102">
                  <c:v>32.745654999999999</c:v>
                </c:pt>
                <c:pt idx="103">
                  <c:v>31.313199999999998</c:v>
                </c:pt>
                <c:pt idx="104">
                  <c:v>30.115575</c:v>
                </c:pt>
                <c:pt idx="105">
                  <c:v>28.192270000000001</c:v>
                </c:pt>
                <c:pt idx="106">
                  <c:v>26.561139999999998</c:v>
                </c:pt>
                <c:pt idx="107">
                  <c:v>24.86037</c:v>
                </c:pt>
                <c:pt idx="108">
                  <c:v>23.353645</c:v>
                </c:pt>
                <c:pt idx="109">
                  <c:v>21.968404999999997</c:v>
                </c:pt>
                <c:pt idx="110">
                  <c:v>20.972079999999998</c:v>
                </c:pt>
                <c:pt idx="111">
                  <c:v>20.250174999999999</c:v>
                </c:pt>
                <c:pt idx="112">
                  <c:v>19.912689999999998</c:v>
                </c:pt>
                <c:pt idx="113">
                  <c:v>20.074110000000005</c:v>
                </c:pt>
                <c:pt idx="114">
                  <c:v>20.835829999999998</c:v>
                </c:pt>
                <c:pt idx="115">
                  <c:v>21.996760000000002</c:v>
                </c:pt>
                <c:pt idx="116">
                  <c:v>23.714285000000004</c:v>
                </c:pt>
                <c:pt idx="117">
                  <c:v>25.419595000000001</c:v>
                </c:pt>
                <c:pt idx="118">
                  <c:v>27.240555000000001</c:v>
                </c:pt>
                <c:pt idx="119">
                  <c:v>28.894470000000002</c:v>
                </c:pt>
                <c:pt idx="120">
                  <c:v>30.218345000000003</c:v>
                </c:pt>
                <c:pt idx="121">
                  <c:v>30.878050000000002</c:v>
                </c:pt>
                <c:pt idx="122">
                  <c:v>31.446789999999996</c:v>
                </c:pt>
                <c:pt idx="123">
                  <c:v>31.62717</c:v>
                </c:pt>
                <c:pt idx="124">
                  <c:v>30.887860000000003</c:v>
                </c:pt>
                <c:pt idx="125">
                  <c:v>30.330639999999995</c:v>
                </c:pt>
                <c:pt idx="126">
                  <c:v>29.54975</c:v>
                </c:pt>
                <c:pt idx="127">
                  <c:v>28.270539999999997</c:v>
                </c:pt>
                <c:pt idx="128">
                  <c:v>26.955289999999998</c:v>
                </c:pt>
                <c:pt idx="129">
                  <c:v>25.5453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8FB-43D0-9A49-B51B0FA99D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318656"/>
        <c:axId val="63328640"/>
      </c:lineChart>
      <c:catAx>
        <c:axId val="63318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3328640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3328640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33186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O$17:$CO$146</c:f>
              <c:numCache>
                <c:formatCode>0.00</c:formatCode>
                <c:ptCount val="130"/>
                <c:pt idx="0">
                  <c:v>49.370739999999998</c:v>
                </c:pt>
                <c:pt idx="1">
                  <c:v>47.811960000000006</c:v>
                </c:pt>
                <c:pt idx="2">
                  <c:v>36.557074999999998</c:v>
                </c:pt>
                <c:pt idx="3">
                  <c:v>33.123039999999996</c:v>
                </c:pt>
                <c:pt idx="4">
                  <c:v>28.116185000000005</c:v>
                </c:pt>
                <c:pt idx="5">
                  <c:v>26.655200000000001</c:v>
                </c:pt>
                <c:pt idx="6">
                  <c:v>30.109464999999997</c:v>
                </c:pt>
                <c:pt idx="7">
                  <c:v>43.203625000000002</c:v>
                </c:pt>
                <c:pt idx="8">
                  <c:v>69.957739999999987</c:v>
                </c:pt>
                <c:pt idx="9">
                  <c:v>115.49846000000001</c:v>
                </c:pt>
                <c:pt idx="10">
                  <c:v>165.27858999999998</c:v>
                </c:pt>
                <c:pt idx="11">
                  <c:v>197.04825500000001</c:v>
                </c:pt>
                <c:pt idx="12">
                  <c:v>202.92798999999999</c:v>
                </c:pt>
                <c:pt idx="13">
                  <c:v>192.82720499999999</c:v>
                </c:pt>
                <c:pt idx="14">
                  <c:v>169.54361</c:v>
                </c:pt>
                <c:pt idx="15">
                  <c:v>141.27675500000001</c:v>
                </c:pt>
                <c:pt idx="16">
                  <c:v>114.63356</c:v>
                </c:pt>
                <c:pt idx="17">
                  <c:v>96.48566000000001</c:v>
                </c:pt>
                <c:pt idx="18">
                  <c:v>75.153310000000005</c:v>
                </c:pt>
                <c:pt idx="19">
                  <c:v>61.009160000000008</c:v>
                </c:pt>
                <c:pt idx="20">
                  <c:v>50.755070000000003</c:v>
                </c:pt>
                <c:pt idx="21">
                  <c:v>44.957830000000001</c:v>
                </c:pt>
                <c:pt idx="22">
                  <c:v>45.604485000000004</c:v>
                </c:pt>
                <c:pt idx="23">
                  <c:v>52.577705000000002</c:v>
                </c:pt>
                <c:pt idx="24">
                  <c:v>66.529294999999991</c:v>
                </c:pt>
                <c:pt idx="25">
                  <c:v>85.39495500000001</c:v>
                </c:pt>
                <c:pt idx="26">
                  <c:v>106.92981</c:v>
                </c:pt>
                <c:pt idx="27">
                  <c:v>121.07933</c:v>
                </c:pt>
                <c:pt idx="28">
                  <c:v>129.922695</c:v>
                </c:pt>
                <c:pt idx="29">
                  <c:v>127.09092</c:v>
                </c:pt>
                <c:pt idx="30">
                  <c:v>114.54576999999999</c:v>
                </c:pt>
                <c:pt idx="31">
                  <c:v>98.721535000000003</c:v>
                </c:pt>
                <c:pt idx="32">
                  <c:v>82.235960000000006</c:v>
                </c:pt>
                <c:pt idx="33">
                  <c:v>67.750614999999996</c:v>
                </c:pt>
                <c:pt idx="34">
                  <c:v>56.233400000000003</c:v>
                </c:pt>
                <c:pt idx="35">
                  <c:v>49.424814999999995</c:v>
                </c:pt>
                <c:pt idx="36">
                  <c:v>46.107149999999997</c:v>
                </c:pt>
                <c:pt idx="37">
                  <c:v>46.566200000000002</c:v>
                </c:pt>
                <c:pt idx="38">
                  <c:v>51.584895000000003</c:v>
                </c:pt>
                <c:pt idx="39">
                  <c:v>60.598294999999993</c:v>
                </c:pt>
                <c:pt idx="40">
                  <c:v>72.017585000000011</c:v>
                </c:pt>
                <c:pt idx="41">
                  <c:v>81.656539999999993</c:v>
                </c:pt>
                <c:pt idx="42">
                  <c:v>90.561400000000006</c:v>
                </c:pt>
                <c:pt idx="43">
                  <c:v>98.684580000000011</c:v>
                </c:pt>
                <c:pt idx="44">
                  <c:v>98.86489499999999</c:v>
                </c:pt>
                <c:pt idx="45">
                  <c:v>91.598224999999999</c:v>
                </c:pt>
                <c:pt idx="46">
                  <c:v>81.649960000000007</c:v>
                </c:pt>
                <c:pt idx="47">
                  <c:v>70.846864999999994</c:v>
                </c:pt>
                <c:pt idx="48">
                  <c:v>61.575630000000004</c:v>
                </c:pt>
                <c:pt idx="49">
                  <c:v>53.185680000000005</c:v>
                </c:pt>
                <c:pt idx="50">
                  <c:v>48.643630000000002</c:v>
                </c:pt>
                <c:pt idx="51">
                  <c:v>46.078635000000006</c:v>
                </c:pt>
                <c:pt idx="52">
                  <c:v>46.005600000000001</c:v>
                </c:pt>
                <c:pt idx="53">
                  <c:v>47.527070000000002</c:v>
                </c:pt>
                <c:pt idx="54">
                  <c:v>51.691780000000001</c:v>
                </c:pt>
                <c:pt idx="55">
                  <c:v>57.553710000000009</c:v>
                </c:pt>
                <c:pt idx="56">
                  <c:v>64.200114999999997</c:v>
                </c:pt>
                <c:pt idx="57">
                  <c:v>70.666025000000005</c:v>
                </c:pt>
                <c:pt idx="58">
                  <c:v>78.070689999999985</c:v>
                </c:pt>
                <c:pt idx="59">
                  <c:v>82.339124999999996</c:v>
                </c:pt>
                <c:pt idx="60">
                  <c:v>78.519339999999985</c:v>
                </c:pt>
                <c:pt idx="61">
                  <c:v>71.090955000000008</c:v>
                </c:pt>
                <c:pt idx="62">
                  <c:v>62.784300000000002</c:v>
                </c:pt>
                <c:pt idx="63">
                  <c:v>55.086564999999993</c:v>
                </c:pt>
                <c:pt idx="64">
                  <c:v>48.462119999999999</c:v>
                </c:pt>
                <c:pt idx="65">
                  <c:v>43.712200000000003</c:v>
                </c:pt>
                <c:pt idx="66">
                  <c:v>41.701000000000001</c:v>
                </c:pt>
                <c:pt idx="67">
                  <c:v>40.882280000000002</c:v>
                </c:pt>
                <c:pt idx="68">
                  <c:v>42.194099999999999</c:v>
                </c:pt>
                <c:pt idx="69">
                  <c:v>45.566739999999996</c:v>
                </c:pt>
                <c:pt idx="70">
                  <c:v>51.028950000000002</c:v>
                </c:pt>
                <c:pt idx="71">
                  <c:v>57.951780000000007</c:v>
                </c:pt>
                <c:pt idx="72">
                  <c:v>62.968394999999994</c:v>
                </c:pt>
                <c:pt idx="73">
                  <c:v>64.110939999999985</c:v>
                </c:pt>
                <c:pt idx="74">
                  <c:v>62.702105000000003</c:v>
                </c:pt>
                <c:pt idx="75">
                  <c:v>59.710194999999999</c:v>
                </c:pt>
                <c:pt idx="76">
                  <c:v>55.177160000000008</c:v>
                </c:pt>
                <c:pt idx="77">
                  <c:v>50.640095000000002</c:v>
                </c:pt>
                <c:pt idx="78">
                  <c:v>46.635674999999999</c:v>
                </c:pt>
                <c:pt idx="79">
                  <c:v>42.917439999999999</c:v>
                </c:pt>
                <c:pt idx="80">
                  <c:v>39.784489999999998</c:v>
                </c:pt>
                <c:pt idx="81">
                  <c:v>38.043010000000002</c:v>
                </c:pt>
                <c:pt idx="82">
                  <c:v>37.973364999999994</c:v>
                </c:pt>
                <c:pt idx="83">
                  <c:v>38.809750000000001</c:v>
                </c:pt>
                <c:pt idx="84">
                  <c:v>40.852560000000004</c:v>
                </c:pt>
                <c:pt idx="85">
                  <c:v>43.891795000000002</c:v>
                </c:pt>
                <c:pt idx="86">
                  <c:v>46.989160000000005</c:v>
                </c:pt>
                <c:pt idx="87">
                  <c:v>49.976775000000004</c:v>
                </c:pt>
                <c:pt idx="88">
                  <c:v>51.440739999999998</c:v>
                </c:pt>
                <c:pt idx="89">
                  <c:v>52.059874999999998</c:v>
                </c:pt>
                <c:pt idx="90">
                  <c:v>50.312160000000006</c:v>
                </c:pt>
                <c:pt idx="91">
                  <c:v>46.3354</c:v>
                </c:pt>
                <c:pt idx="92">
                  <c:v>42.542665</c:v>
                </c:pt>
                <c:pt idx="93">
                  <c:v>39.146725000000004</c:v>
                </c:pt>
                <c:pt idx="94">
                  <c:v>36.642724999999999</c:v>
                </c:pt>
                <c:pt idx="95">
                  <c:v>34.544874999999998</c:v>
                </c:pt>
                <c:pt idx="96">
                  <c:v>33.071645000000004</c:v>
                </c:pt>
                <c:pt idx="97">
                  <c:v>32.74682</c:v>
                </c:pt>
                <c:pt idx="98">
                  <c:v>33.062445000000004</c:v>
                </c:pt>
                <c:pt idx="99">
                  <c:v>34.567779999999999</c:v>
                </c:pt>
                <c:pt idx="100">
                  <c:v>36.920180000000002</c:v>
                </c:pt>
                <c:pt idx="101">
                  <c:v>39.48612</c:v>
                </c:pt>
                <c:pt idx="102">
                  <c:v>41.512454999999996</c:v>
                </c:pt>
                <c:pt idx="103">
                  <c:v>42.539760000000001</c:v>
                </c:pt>
                <c:pt idx="104">
                  <c:v>42.300045000000004</c:v>
                </c:pt>
                <c:pt idx="105">
                  <c:v>40.898739999999997</c:v>
                </c:pt>
                <c:pt idx="106">
                  <c:v>39.409814999999995</c:v>
                </c:pt>
                <c:pt idx="107">
                  <c:v>37.569895000000002</c:v>
                </c:pt>
                <c:pt idx="108">
                  <c:v>35.959299999999999</c:v>
                </c:pt>
                <c:pt idx="109">
                  <c:v>34.357939999999999</c:v>
                </c:pt>
                <c:pt idx="110">
                  <c:v>32.849714999999996</c:v>
                </c:pt>
                <c:pt idx="111">
                  <c:v>31.569389999999995</c:v>
                </c:pt>
                <c:pt idx="112">
                  <c:v>30.534995000000002</c:v>
                </c:pt>
                <c:pt idx="113">
                  <c:v>29.324460000000002</c:v>
                </c:pt>
                <c:pt idx="114">
                  <c:v>28.789570000000001</c:v>
                </c:pt>
                <c:pt idx="115">
                  <c:v>24.662839999999996</c:v>
                </c:pt>
                <c:pt idx="116">
                  <c:v>24.378529999999998</c:v>
                </c:pt>
                <c:pt idx="117">
                  <c:v>24.470660000000002</c:v>
                </c:pt>
                <c:pt idx="118">
                  <c:v>24.48432</c:v>
                </c:pt>
                <c:pt idx="119">
                  <c:v>24.436620000000001</c:v>
                </c:pt>
                <c:pt idx="120">
                  <c:v>23.866904999999999</c:v>
                </c:pt>
                <c:pt idx="121">
                  <c:v>22.545639999999995</c:v>
                </c:pt>
                <c:pt idx="122">
                  <c:v>20.694510000000005</c:v>
                </c:pt>
                <c:pt idx="123">
                  <c:v>19.090805</c:v>
                </c:pt>
                <c:pt idx="124">
                  <c:v>17.438745000000001</c:v>
                </c:pt>
                <c:pt idx="125">
                  <c:v>16.215050000000002</c:v>
                </c:pt>
                <c:pt idx="126">
                  <c:v>15.353020000000001</c:v>
                </c:pt>
                <c:pt idx="127">
                  <c:v>14.754585000000004</c:v>
                </c:pt>
                <c:pt idx="128">
                  <c:v>14.903</c:v>
                </c:pt>
                <c:pt idx="129">
                  <c:v>15.3499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730-4B9B-B397-DEEBED0C1CBA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P$17:$CP$146</c:f>
              <c:numCache>
                <c:formatCode>0.00</c:formatCode>
                <c:ptCount val="130"/>
                <c:pt idx="0">
                  <c:v>60.390139999999988</c:v>
                </c:pt>
                <c:pt idx="1">
                  <c:v>60.286660000000012</c:v>
                </c:pt>
                <c:pt idx="2">
                  <c:v>48.868675000000003</c:v>
                </c:pt>
                <c:pt idx="3">
                  <c:v>44.245439999999995</c:v>
                </c:pt>
                <c:pt idx="4">
                  <c:v>41.259485000000005</c:v>
                </c:pt>
                <c:pt idx="5">
                  <c:v>40.0214</c:v>
                </c:pt>
                <c:pt idx="6">
                  <c:v>41.560064999999994</c:v>
                </c:pt>
                <c:pt idx="7">
                  <c:v>50.632024999999999</c:v>
                </c:pt>
                <c:pt idx="8">
                  <c:v>71.166139999999984</c:v>
                </c:pt>
                <c:pt idx="9">
                  <c:v>101.55976000000001</c:v>
                </c:pt>
                <c:pt idx="10">
                  <c:v>132.73029</c:v>
                </c:pt>
                <c:pt idx="11">
                  <c:v>162.25805500000001</c:v>
                </c:pt>
                <c:pt idx="12">
                  <c:v>193.77049</c:v>
                </c:pt>
                <c:pt idx="13">
                  <c:v>208.99300500000001</c:v>
                </c:pt>
                <c:pt idx="14">
                  <c:v>196.88441</c:v>
                </c:pt>
                <c:pt idx="15">
                  <c:v>165.23235500000001</c:v>
                </c:pt>
                <c:pt idx="16">
                  <c:v>129.83766</c:v>
                </c:pt>
                <c:pt idx="17">
                  <c:v>109.07906000000001</c:v>
                </c:pt>
                <c:pt idx="18">
                  <c:v>87.967110000000005</c:v>
                </c:pt>
                <c:pt idx="19">
                  <c:v>73.676460000000006</c:v>
                </c:pt>
                <c:pt idx="20">
                  <c:v>65.764769999999999</c:v>
                </c:pt>
                <c:pt idx="21">
                  <c:v>60.434030000000007</c:v>
                </c:pt>
                <c:pt idx="22">
                  <c:v>56.184485000000009</c:v>
                </c:pt>
                <c:pt idx="23">
                  <c:v>58.900405000000006</c:v>
                </c:pt>
                <c:pt idx="24">
                  <c:v>65.195295000000002</c:v>
                </c:pt>
                <c:pt idx="25">
                  <c:v>75.395655000000005</c:v>
                </c:pt>
                <c:pt idx="26">
                  <c:v>87.105810000000005</c:v>
                </c:pt>
                <c:pt idx="27">
                  <c:v>101.23653</c:v>
                </c:pt>
                <c:pt idx="28">
                  <c:v>114.14919499999999</c:v>
                </c:pt>
                <c:pt idx="29">
                  <c:v>117.23092</c:v>
                </c:pt>
                <c:pt idx="30">
                  <c:v>110.62806999999999</c:v>
                </c:pt>
                <c:pt idx="31">
                  <c:v>99.803335000000004</c:v>
                </c:pt>
                <c:pt idx="32">
                  <c:v>87.63636000000001</c:v>
                </c:pt>
                <c:pt idx="33">
                  <c:v>74.622114999999994</c:v>
                </c:pt>
                <c:pt idx="34">
                  <c:v>63.171100000000003</c:v>
                </c:pt>
                <c:pt idx="35">
                  <c:v>54.908514999999994</c:v>
                </c:pt>
                <c:pt idx="36">
                  <c:v>50.04815</c:v>
                </c:pt>
                <c:pt idx="37">
                  <c:v>48.020299999999999</c:v>
                </c:pt>
                <c:pt idx="38">
                  <c:v>49.440395000000002</c:v>
                </c:pt>
                <c:pt idx="39">
                  <c:v>52.174395000000004</c:v>
                </c:pt>
                <c:pt idx="40">
                  <c:v>57.23288500000001</c:v>
                </c:pt>
                <c:pt idx="41">
                  <c:v>61.091339999999988</c:v>
                </c:pt>
                <c:pt idx="42">
                  <c:v>65.557900000000004</c:v>
                </c:pt>
                <c:pt idx="43">
                  <c:v>71.893680000000003</c:v>
                </c:pt>
                <c:pt idx="44">
                  <c:v>75.582894999999994</c:v>
                </c:pt>
                <c:pt idx="45">
                  <c:v>74.821224999999998</c:v>
                </c:pt>
                <c:pt idx="46">
                  <c:v>70.439560000000014</c:v>
                </c:pt>
                <c:pt idx="47">
                  <c:v>63.701864999999991</c:v>
                </c:pt>
                <c:pt idx="48">
                  <c:v>56.194430000000004</c:v>
                </c:pt>
                <c:pt idx="49">
                  <c:v>49.954679999999996</c:v>
                </c:pt>
                <c:pt idx="50">
                  <c:v>44.779029999999999</c:v>
                </c:pt>
                <c:pt idx="51">
                  <c:v>41.665035000000003</c:v>
                </c:pt>
                <c:pt idx="52">
                  <c:v>40.2742</c:v>
                </c:pt>
                <c:pt idx="53">
                  <c:v>40.653469999999999</c:v>
                </c:pt>
                <c:pt idx="54">
                  <c:v>43.279980000000002</c:v>
                </c:pt>
                <c:pt idx="55">
                  <c:v>47.477710000000002</c:v>
                </c:pt>
                <c:pt idx="56">
                  <c:v>51.933214999999997</c:v>
                </c:pt>
                <c:pt idx="57">
                  <c:v>56.564725000000003</c:v>
                </c:pt>
                <c:pt idx="58">
                  <c:v>60.825689999999987</c:v>
                </c:pt>
                <c:pt idx="59">
                  <c:v>61.357424999999999</c:v>
                </c:pt>
                <c:pt idx="60">
                  <c:v>59.646539999999987</c:v>
                </c:pt>
                <c:pt idx="61">
                  <c:v>55.685755000000007</c:v>
                </c:pt>
                <c:pt idx="62">
                  <c:v>50.694400000000002</c:v>
                </c:pt>
                <c:pt idx="63">
                  <c:v>45.991964999999993</c:v>
                </c:pt>
                <c:pt idx="64">
                  <c:v>42.097120000000004</c:v>
                </c:pt>
                <c:pt idx="65">
                  <c:v>39.051900000000003</c:v>
                </c:pt>
                <c:pt idx="66">
                  <c:v>37.796700000000001</c:v>
                </c:pt>
                <c:pt idx="67">
                  <c:v>36.85848</c:v>
                </c:pt>
                <c:pt idx="68">
                  <c:v>37.384999999999998</c:v>
                </c:pt>
                <c:pt idx="69">
                  <c:v>38.745039999999996</c:v>
                </c:pt>
                <c:pt idx="70">
                  <c:v>41.48845</c:v>
                </c:pt>
                <c:pt idx="71">
                  <c:v>44.728180000000002</c:v>
                </c:pt>
                <c:pt idx="72">
                  <c:v>48.324995000000001</c:v>
                </c:pt>
                <c:pt idx="73">
                  <c:v>51.043139999999994</c:v>
                </c:pt>
                <c:pt idx="74">
                  <c:v>52.361804999999997</c:v>
                </c:pt>
                <c:pt idx="75">
                  <c:v>51.269995000000002</c:v>
                </c:pt>
                <c:pt idx="76">
                  <c:v>47.400460000000002</c:v>
                </c:pt>
                <c:pt idx="77">
                  <c:v>42.874594999999999</c:v>
                </c:pt>
                <c:pt idx="78">
                  <c:v>38.658475000000003</c:v>
                </c:pt>
                <c:pt idx="79">
                  <c:v>35.488339999999994</c:v>
                </c:pt>
                <c:pt idx="80">
                  <c:v>33.259689999999999</c:v>
                </c:pt>
                <c:pt idx="81">
                  <c:v>31.868010000000002</c:v>
                </c:pt>
                <c:pt idx="82">
                  <c:v>32.016764999999999</c:v>
                </c:pt>
                <c:pt idx="83">
                  <c:v>33.151850000000003</c:v>
                </c:pt>
                <c:pt idx="84">
                  <c:v>35.484060000000007</c:v>
                </c:pt>
                <c:pt idx="85">
                  <c:v>37.964195000000004</c:v>
                </c:pt>
                <c:pt idx="86">
                  <c:v>40.782160000000005</c:v>
                </c:pt>
                <c:pt idx="87">
                  <c:v>41.837874999999997</c:v>
                </c:pt>
                <c:pt idx="88">
                  <c:v>41.922539999999998</c:v>
                </c:pt>
                <c:pt idx="89">
                  <c:v>41.763075000000001</c:v>
                </c:pt>
                <c:pt idx="90">
                  <c:v>40.512960000000007</c:v>
                </c:pt>
                <c:pt idx="91">
                  <c:v>37.2971</c:v>
                </c:pt>
                <c:pt idx="92">
                  <c:v>34.714664999999997</c:v>
                </c:pt>
                <c:pt idx="93">
                  <c:v>31.840724999999999</c:v>
                </c:pt>
                <c:pt idx="94">
                  <c:v>29.568024999999999</c:v>
                </c:pt>
                <c:pt idx="95">
                  <c:v>27.983975000000001</c:v>
                </c:pt>
                <c:pt idx="96">
                  <c:v>27.121345000000002</c:v>
                </c:pt>
                <c:pt idx="97">
                  <c:v>27.18252</c:v>
                </c:pt>
                <c:pt idx="98">
                  <c:v>28.108245</c:v>
                </c:pt>
                <c:pt idx="99">
                  <c:v>29.727879999999999</c:v>
                </c:pt>
                <c:pt idx="100">
                  <c:v>31.66038</c:v>
                </c:pt>
                <c:pt idx="101">
                  <c:v>33.135220000000004</c:v>
                </c:pt>
                <c:pt idx="102">
                  <c:v>33.764654999999998</c:v>
                </c:pt>
                <c:pt idx="103">
                  <c:v>33.467960000000005</c:v>
                </c:pt>
                <c:pt idx="104">
                  <c:v>32.559345</c:v>
                </c:pt>
                <c:pt idx="105">
                  <c:v>30.526939999999996</c:v>
                </c:pt>
                <c:pt idx="106">
                  <c:v>28.520514999999996</c:v>
                </c:pt>
                <c:pt idx="107">
                  <c:v>26.362795000000002</c:v>
                </c:pt>
                <c:pt idx="108">
                  <c:v>24.6617</c:v>
                </c:pt>
                <c:pt idx="109">
                  <c:v>22.792639999999995</c:v>
                </c:pt>
                <c:pt idx="110">
                  <c:v>21.486814999999996</c:v>
                </c:pt>
                <c:pt idx="111">
                  <c:v>20.783389999999997</c:v>
                </c:pt>
                <c:pt idx="112">
                  <c:v>20.260295000000003</c:v>
                </c:pt>
                <c:pt idx="113">
                  <c:v>20.412760000000002</c:v>
                </c:pt>
                <c:pt idx="114">
                  <c:v>20.827070000000003</c:v>
                </c:pt>
                <c:pt idx="115">
                  <c:v>19.032939999999996</c:v>
                </c:pt>
                <c:pt idx="116">
                  <c:v>19.614829999999998</c:v>
                </c:pt>
                <c:pt idx="117">
                  <c:v>20.365760000000005</c:v>
                </c:pt>
                <c:pt idx="118">
                  <c:v>20.369720000000001</c:v>
                </c:pt>
                <c:pt idx="119">
                  <c:v>19.434920000000002</c:v>
                </c:pt>
                <c:pt idx="120">
                  <c:v>18.479505</c:v>
                </c:pt>
                <c:pt idx="121">
                  <c:v>17.217139999999997</c:v>
                </c:pt>
                <c:pt idx="122">
                  <c:v>16.161010000000005</c:v>
                </c:pt>
                <c:pt idx="123">
                  <c:v>15.487304999999999</c:v>
                </c:pt>
                <c:pt idx="124">
                  <c:v>14.725345000000001</c:v>
                </c:pt>
                <c:pt idx="125">
                  <c:v>14.22785</c:v>
                </c:pt>
                <c:pt idx="126">
                  <c:v>13.806820000000002</c:v>
                </c:pt>
                <c:pt idx="127">
                  <c:v>13.447085000000003</c:v>
                </c:pt>
                <c:pt idx="128">
                  <c:v>13.377700000000001</c:v>
                </c:pt>
                <c:pt idx="129">
                  <c:v>13.5256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730-4B9B-B397-DEEBED0C1CBA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Q$17:$CQ$146</c:f>
              <c:numCache>
                <c:formatCode>0.00</c:formatCode>
                <c:ptCount val="130"/>
                <c:pt idx="0">
                  <c:v>51.680239999999998</c:v>
                </c:pt>
                <c:pt idx="1">
                  <c:v>49.189360000000001</c:v>
                </c:pt>
                <c:pt idx="2">
                  <c:v>37.460275000000003</c:v>
                </c:pt>
                <c:pt idx="3">
                  <c:v>32.276139999999998</c:v>
                </c:pt>
                <c:pt idx="4">
                  <c:v>27.082385000000002</c:v>
                </c:pt>
                <c:pt idx="5">
                  <c:v>24.229099999999999</c:v>
                </c:pt>
                <c:pt idx="6">
                  <c:v>25.943164999999997</c:v>
                </c:pt>
                <c:pt idx="7">
                  <c:v>36.813025000000003</c:v>
                </c:pt>
                <c:pt idx="8">
                  <c:v>61.94583999999999</c:v>
                </c:pt>
                <c:pt idx="9">
                  <c:v>95.131960000000007</c:v>
                </c:pt>
                <c:pt idx="10">
                  <c:v>123.57578999999998</c:v>
                </c:pt>
                <c:pt idx="11">
                  <c:v>147.53315499999999</c:v>
                </c:pt>
                <c:pt idx="12">
                  <c:v>175.29989</c:v>
                </c:pt>
                <c:pt idx="13">
                  <c:v>194.24820500000001</c:v>
                </c:pt>
                <c:pt idx="14">
                  <c:v>191.38671000000002</c:v>
                </c:pt>
                <c:pt idx="15">
                  <c:v>163.03385500000002</c:v>
                </c:pt>
                <c:pt idx="16">
                  <c:v>127.64296000000002</c:v>
                </c:pt>
                <c:pt idx="17">
                  <c:v>102.98956000000001</c:v>
                </c:pt>
                <c:pt idx="18">
                  <c:v>77.591010000000011</c:v>
                </c:pt>
                <c:pt idx="19">
                  <c:v>62.286960000000008</c:v>
                </c:pt>
                <c:pt idx="20">
                  <c:v>54.407869999999996</c:v>
                </c:pt>
                <c:pt idx="21">
                  <c:v>49.306429999999999</c:v>
                </c:pt>
                <c:pt idx="22">
                  <c:v>46.133085000000001</c:v>
                </c:pt>
                <c:pt idx="23">
                  <c:v>46.868704999999999</c:v>
                </c:pt>
                <c:pt idx="24">
                  <c:v>52.414695000000002</c:v>
                </c:pt>
                <c:pt idx="25">
                  <c:v>63.368255000000005</c:v>
                </c:pt>
                <c:pt idx="26">
                  <c:v>80.120710000000003</c:v>
                </c:pt>
                <c:pt idx="27">
                  <c:v>99.013130000000004</c:v>
                </c:pt>
                <c:pt idx="28">
                  <c:v>118.312895</c:v>
                </c:pt>
                <c:pt idx="29">
                  <c:v>123.14702</c:v>
                </c:pt>
                <c:pt idx="30">
                  <c:v>116.46767</c:v>
                </c:pt>
                <c:pt idx="31">
                  <c:v>104.33573500000001</c:v>
                </c:pt>
                <c:pt idx="32">
                  <c:v>91.059960000000004</c:v>
                </c:pt>
                <c:pt idx="33">
                  <c:v>77.811414999999997</c:v>
                </c:pt>
                <c:pt idx="34">
                  <c:v>65.613600000000005</c:v>
                </c:pt>
                <c:pt idx="35">
                  <c:v>55.87071499999999</c:v>
                </c:pt>
                <c:pt idx="36">
                  <c:v>48.906550000000003</c:v>
                </c:pt>
                <c:pt idx="37">
                  <c:v>44.686599999999999</c:v>
                </c:pt>
                <c:pt idx="38">
                  <c:v>43.210895000000001</c:v>
                </c:pt>
                <c:pt idx="39">
                  <c:v>45.553094999999999</c:v>
                </c:pt>
                <c:pt idx="40">
                  <c:v>52.478685000000006</c:v>
                </c:pt>
                <c:pt idx="41">
                  <c:v>59.785439999999994</c:v>
                </c:pt>
                <c:pt idx="42">
                  <c:v>69.994200000000006</c:v>
                </c:pt>
                <c:pt idx="43">
                  <c:v>80.856080000000006</c:v>
                </c:pt>
                <c:pt idx="44">
                  <c:v>83.425894999999997</c:v>
                </c:pt>
                <c:pt idx="45">
                  <c:v>80.304625000000001</c:v>
                </c:pt>
                <c:pt idx="46">
                  <c:v>74.289060000000006</c:v>
                </c:pt>
                <c:pt idx="47">
                  <c:v>66.957364999999996</c:v>
                </c:pt>
                <c:pt idx="48">
                  <c:v>59.419630000000005</c:v>
                </c:pt>
                <c:pt idx="49">
                  <c:v>52.266680000000001</c:v>
                </c:pt>
                <c:pt idx="50">
                  <c:v>45.989829999999998</c:v>
                </c:pt>
                <c:pt idx="51">
                  <c:v>41.344835000000003</c:v>
                </c:pt>
                <c:pt idx="52">
                  <c:v>38.1541</c:v>
                </c:pt>
                <c:pt idx="53">
                  <c:v>37.542270000000002</c:v>
                </c:pt>
                <c:pt idx="54">
                  <c:v>40.233979999999995</c:v>
                </c:pt>
                <c:pt idx="55">
                  <c:v>45.204210000000003</c:v>
                </c:pt>
                <c:pt idx="56">
                  <c:v>52.049414999999996</c:v>
                </c:pt>
                <c:pt idx="57">
                  <c:v>58.875324999999997</c:v>
                </c:pt>
                <c:pt idx="58">
                  <c:v>62.421489999999991</c:v>
                </c:pt>
                <c:pt idx="59">
                  <c:v>62.786625000000001</c:v>
                </c:pt>
                <c:pt idx="60">
                  <c:v>60.01263999999999</c:v>
                </c:pt>
                <c:pt idx="61">
                  <c:v>56.705555000000004</c:v>
                </c:pt>
                <c:pt idx="62">
                  <c:v>52.552100000000003</c:v>
                </c:pt>
                <c:pt idx="63">
                  <c:v>48.011964999999996</c:v>
                </c:pt>
                <c:pt idx="64">
                  <c:v>43.182720000000003</c:v>
                </c:pt>
                <c:pt idx="65">
                  <c:v>39.182499999999997</c:v>
                </c:pt>
                <c:pt idx="66">
                  <c:v>35.991999999999997</c:v>
                </c:pt>
                <c:pt idx="67">
                  <c:v>33.728679999999997</c:v>
                </c:pt>
                <c:pt idx="68">
                  <c:v>33.241100000000003</c:v>
                </c:pt>
                <c:pt idx="69">
                  <c:v>34.035139999999998</c:v>
                </c:pt>
                <c:pt idx="70">
                  <c:v>37.63805</c:v>
                </c:pt>
                <c:pt idx="71">
                  <c:v>42.643979999999999</c:v>
                </c:pt>
                <c:pt idx="72">
                  <c:v>48.062995000000001</c:v>
                </c:pt>
                <c:pt idx="73">
                  <c:v>51.329739999999994</c:v>
                </c:pt>
                <c:pt idx="74">
                  <c:v>52.170405000000002</c:v>
                </c:pt>
                <c:pt idx="75">
                  <c:v>50.502895000000002</c:v>
                </c:pt>
                <c:pt idx="76">
                  <c:v>46.849060000000001</c:v>
                </c:pt>
                <c:pt idx="77">
                  <c:v>43.289695000000002</c:v>
                </c:pt>
                <c:pt idx="78">
                  <c:v>40.540975000000003</c:v>
                </c:pt>
                <c:pt idx="79">
                  <c:v>37.876239999999996</c:v>
                </c:pt>
                <c:pt idx="80">
                  <c:v>35.063689999999994</c:v>
                </c:pt>
                <c:pt idx="81">
                  <c:v>33.104010000000002</c:v>
                </c:pt>
                <c:pt idx="82">
                  <c:v>32.238964999999993</c:v>
                </c:pt>
                <c:pt idx="83">
                  <c:v>32.174050000000001</c:v>
                </c:pt>
                <c:pt idx="84">
                  <c:v>33.161960000000001</c:v>
                </c:pt>
                <c:pt idx="85">
                  <c:v>35.817095000000002</c:v>
                </c:pt>
                <c:pt idx="86">
                  <c:v>39.123060000000002</c:v>
                </c:pt>
                <c:pt idx="87">
                  <c:v>42.453575000000001</c:v>
                </c:pt>
                <c:pt idx="88">
                  <c:v>44.712539999999997</c:v>
                </c:pt>
                <c:pt idx="89">
                  <c:v>44.756075000000003</c:v>
                </c:pt>
                <c:pt idx="90">
                  <c:v>43.175060000000002</c:v>
                </c:pt>
                <c:pt idx="91">
                  <c:v>39.837699999999998</c:v>
                </c:pt>
                <c:pt idx="92">
                  <c:v>37.902564999999996</c:v>
                </c:pt>
                <c:pt idx="93">
                  <c:v>36.174424999999999</c:v>
                </c:pt>
                <c:pt idx="94">
                  <c:v>34.376925</c:v>
                </c:pt>
                <c:pt idx="95">
                  <c:v>33.238174999999998</c:v>
                </c:pt>
                <c:pt idx="96">
                  <c:v>32.581245000000003</c:v>
                </c:pt>
                <c:pt idx="97">
                  <c:v>31.97362</c:v>
                </c:pt>
                <c:pt idx="98">
                  <c:v>31.972145000000001</c:v>
                </c:pt>
                <c:pt idx="99">
                  <c:v>32.488680000000002</c:v>
                </c:pt>
                <c:pt idx="100">
                  <c:v>33.528480000000002</c:v>
                </c:pt>
                <c:pt idx="101">
                  <c:v>34.829520000000002</c:v>
                </c:pt>
                <c:pt idx="102">
                  <c:v>36.298454999999997</c:v>
                </c:pt>
                <c:pt idx="103">
                  <c:v>38.781760000000006</c:v>
                </c:pt>
                <c:pt idx="104">
                  <c:v>40.628745000000002</c:v>
                </c:pt>
                <c:pt idx="105">
                  <c:v>41.304639999999999</c:v>
                </c:pt>
                <c:pt idx="106">
                  <c:v>39.874714999999995</c:v>
                </c:pt>
                <c:pt idx="107">
                  <c:v>37.477595000000001</c:v>
                </c:pt>
                <c:pt idx="108">
                  <c:v>35.078600000000002</c:v>
                </c:pt>
                <c:pt idx="109">
                  <c:v>32.872739999999993</c:v>
                </c:pt>
                <c:pt idx="110">
                  <c:v>30.060014999999996</c:v>
                </c:pt>
                <c:pt idx="111">
                  <c:v>28.636589999999998</c:v>
                </c:pt>
                <c:pt idx="112">
                  <c:v>27.773095000000001</c:v>
                </c:pt>
                <c:pt idx="113">
                  <c:v>27.416360000000005</c:v>
                </c:pt>
                <c:pt idx="114">
                  <c:v>27.494970000000002</c:v>
                </c:pt>
                <c:pt idx="115">
                  <c:v>23.607539999999997</c:v>
                </c:pt>
                <c:pt idx="116">
                  <c:v>23.187929999999998</c:v>
                </c:pt>
                <c:pt idx="117">
                  <c:v>22.629560000000005</c:v>
                </c:pt>
                <c:pt idx="118">
                  <c:v>21.97832</c:v>
                </c:pt>
                <c:pt idx="119">
                  <c:v>21.374020000000002</c:v>
                </c:pt>
                <c:pt idx="120">
                  <c:v>21.191305</c:v>
                </c:pt>
                <c:pt idx="121">
                  <c:v>20.726539999999996</c:v>
                </c:pt>
                <c:pt idx="122">
                  <c:v>19.715910000000004</c:v>
                </c:pt>
                <c:pt idx="123">
                  <c:v>18.616405</c:v>
                </c:pt>
                <c:pt idx="124">
                  <c:v>17.402145000000001</c:v>
                </c:pt>
                <c:pt idx="125">
                  <c:v>16.36985</c:v>
                </c:pt>
                <c:pt idx="126">
                  <c:v>15.214220000000001</c:v>
                </c:pt>
                <c:pt idx="127">
                  <c:v>14.397385000000003</c:v>
                </c:pt>
                <c:pt idx="128">
                  <c:v>14.2142</c:v>
                </c:pt>
                <c:pt idx="129">
                  <c:v>14.4646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730-4B9B-B397-DEEBED0C1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926848"/>
        <c:axId val="66932736"/>
      </c:lineChart>
      <c:catAx>
        <c:axId val="66926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693273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693273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6926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L$17:$CL$146</c:f>
              <c:numCache>
                <c:formatCode>0.00</c:formatCode>
                <c:ptCount val="130"/>
                <c:pt idx="0">
                  <c:v>26.993439999999996</c:v>
                </c:pt>
                <c:pt idx="1">
                  <c:v>27.304060000000003</c:v>
                </c:pt>
                <c:pt idx="2">
                  <c:v>21.463075</c:v>
                </c:pt>
                <c:pt idx="3">
                  <c:v>18.939439999999998</c:v>
                </c:pt>
                <c:pt idx="4">
                  <c:v>16.784285000000004</c:v>
                </c:pt>
                <c:pt idx="5">
                  <c:v>15.2918</c:v>
                </c:pt>
                <c:pt idx="6">
                  <c:v>14.197064999999997</c:v>
                </c:pt>
                <c:pt idx="7">
                  <c:v>14.362125000000001</c:v>
                </c:pt>
                <c:pt idx="8">
                  <c:v>15.399839999999996</c:v>
                </c:pt>
                <c:pt idx="9">
                  <c:v>18.155660000000005</c:v>
                </c:pt>
                <c:pt idx="10">
                  <c:v>22.843889999999998</c:v>
                </c:pt>
                <c:pt idx="11">
                  <c:v>31.347355</c:v>
                </c:pt>
                <c:pt idx="12">
                  <c:v>40.967589999999994</c:v>
                </c:pt>
                <c:pt idx="13">
                  <c:v>52.975505000000005</c:v>
                </c:pt>
                <c:pt idx="14">
                  <c:v>63.001810000000006</c:v>
                </c:pt>
                <c:pt idx="15">
                  <c:v>71.539755</c:v>
                </c:pt>
                <c:pt idx="16">
                  <c:v>77.133260000000007</c:v>
                </c:pt>
                <c:pt idx="17">
                  <c:v>83.366360000000014</c:v>
                </c:pt>
                <c:pt idx="18">
                  <c:v>80.268710000000013</c:v>
                </c:pt>
                <c:pt idx="19">
                  <c:v>73.314660000000003</c:v>
                </c:pt>
                <c:pt idx="20">
                  <c:v>63.542569999999998</c:v>
                </c:pt>
                <c:pt idx="21">
                  <c:v>54.699230000000007</c:v>
                </c:pt>
                <c:pt idx="22">
                  <c:v>46.418285000000004</c:v>
                </c:pt>
                <c:pt idx="23">
                  <c:v>39.562404999999998</c:v>
                </c:pt>
                <c:pt idx="24">
                  <c:v>35.142495000000004</c:v>
                </c:pt>
                <c:pt idx="25">
                  <c:v>30.668754999999997</c:v>
                </c:pt>
                <c:pt idx="26">
                  <c:v>27.341010000000004</c:v>
                </c:pt>
                <c:pt idx="27">
                  <c:v>25.280529999999999</c:v>
                </c:pt>
                <c:pt idx="28">
                  <c:v>23.710495000000002</c:v>
                </c:pt>
                <c:pt idx="29">
                  <c:v>22.401620000000001</c:v>
                </c:pt>
                <c:pt idx="30">
                  <c:v>21.769070000000003</c:v>
                </c:pt>
                <c:pt idx="31">
                  <c:v>22.662035000000003</c:v>
                </c:pt>
                <c:pt idx="32">
                  <c:v>25.476460000000003</c:v>
                </c:pt>
                <c:pt idx="33">
                  <c:v>29.750014999999998</c:v>
                </c:pt>
                <c:pt idx="34">
                  <c:v>35.667900000000003</c:v>
                </c:pt>
                <c:pt idx="35">
                  <c:v>41.831814999999999</c:v>
                </c:pt>
                <c:pt idx="36">
                  <c:v>42.565350000000002</c:v>
                </c:pt>
                <c:pt idx="37">
                  <c:v>44.174700000000001</c:v>
                </c:pt>
                <c:pt idx="38">
                  <c:v>45.249195</c:v>
                </c:pt>
                <c:pt idx="39">
                  <c:v>46.394095</c:v>
                </c:pt>
                <c:pt idx="40">
                  <c:v>46.991385000000001</c:v>
                </c:pt>
                <c:pt idx="41">
                  <c:v>45.750139999999995</c:v>
                </c:pt>
                <c:pt idx="42">
                  <c:v>43.701000000000001</c:v>
                </c:pt>
                <c:pt idx="43">
                  <c:v>40.056779999999996</c:v>
                </c:pt>
                <c:pt idx="44">
                  <c:v>34.971094999999998</c:v>
                </c:pt>
                <c:pt idx="45">
                  <c:v>29.577024999999999</c:v>
                </c:pt>
                <c:pt idx="46">
                  <c:v>25.196160000000003</c:v>
                </c:pt>
                <c:pt idx="47">
                  <c:v>21.985464999999998</c:v>
                </c:pt>
                <c:pt idx="48">
                  <c:v>19.94933</c:v>
                </c:pt>
                <c:pt idx="49">
                  <c:v>19.513579999999997</c:v>
                </c:pt>
                <c:pt idx="50">
                  <c:v>20.257829999999998</c:v>
                </c:pt>
                <c:pt idx="51">
                  <c:v>21.620735000000003</c:v>
                </c:pt>
                <c:pt idx="52">
                  <c:v>22.635999999999999</c:v>
                </c:pt>
                <c:pt idx="53">
                  <c:v>23.386570000000003</c:v>
                </c:pt>
                <c:pt idx="54">
                  <c:v>24.004179999999998</c:v>
                </c:pt>
                <c:pt idx="55">
                  <c:v>25.339510000000004</c:v>
                </c:pt>
                <c:pt idx="56">
                  <c:v>26.379314999999995</c:v>
                </c:pt>
                <c:pt idx="57">
                  <c:v>28.387225000000001</c:v>
                </c:pt>
                <c:pt idx="58">
                  <c:v>31.348789999999997</c:v>
                </c:pt>
                <c:pt idx="59">
                  <c:v>34.366925000000002</c:v>
                </c:pt>
                <c:pt idx="60">
                  <c:v>34.666939999999997</c:v>
                </c:pt>
                <c:pt idx="61">
                  <c:v>32.282454999999999</c:v>
                </c:pt>
                <c:pt idx="62">
                  <c:v>28.6218</c:v>
                </c:pt>
                <c:pt idx="63">
                  <c:v>25.031464999999997</c:v>
                </c:pt>
                <c:pt idx="64">
                  <c:v>21.939120000000003</c:v>
                </c:pt>
                <c:pt idx="65">
                  <c:v>20.142399999999999</c:v>
                </c:pt>
                <c:pt idx="66">
                  <c:v>19.307200000000002</c:v>
                </c:pt>
                <c:pt idx="67">
                  <c:v>18.455079999999999</c:v>
                </c:pt>
                <c:pt idx="68">
                  <c:v>18.442599999999999</c:v>
                </c:pt>
                <c:pt idx="69">
                  <c:v>17.920039999999997</c:v>
                </c:pt>
                <c:pt idx="70">
                  <c:v>17.098849999999999</c:v>
                </c:pt>
                <c:pt idx="71">
                  <c:v>16.29618</c:v>
                </c:pt>
                <c:pt idx="72">
                  <c:v>15.949195000000001</c:v>
                </c:pt>
                <c:pt idx="73">
                  <c:v>16.181339999999995</c:v>
                </c:pt>
                <c:pt idx="74">
                  <c:v>16.476305</c:v>
                </c:pt>
                <c:pt idx="75">
                  <c:v>17.516195</c:v>
                </c:pt>
                <c:pt idx="76">
                  <c:v>18.945860000000003</c:v>
                </c:pt>
                <c:pt idx="77">
                  <c:v>20.083595000000003</c:v>
                </c:pt>
                <c:pt idx="78">
                  <c:v>20.703975</c:v>
                </c:pt>
                <c:pt idx="79">
                  <c:v>20.467939999999995</c:v>
                </c:pt>
                <c:pt idx="80">
                  <c:v>19.232889999999998</c:v>
                </c:pt>
                <c:pt idx="81">
                  <c:v>17.847710000000003</c:v>
                </c:pt>
                <c:pt idx="82">
                  <c:v>16.579364999999996</c:v>
                </c:pt>
                <c:pt idx="83">
                  <c:v>15.715249999999999</c:v>
                </c:pt>
                <c:pt idx="84">
                  <c:v>15.140760000000004</c:v>
                </c:pt>
                <c:pt idx="85">
                  <c:v>15.021195000000001</c:v>
                </c:pt>
                <c:pt idx="86">
                  <c:v>14.747360000000004</c:v>
                </c:pt>
                <c:pt idx="87">
                  <c:v>14.032275</c:v>
                </c:pt>
                <c:pt idx="88">
                  <c:v>13.420439999999996</c:v>
                </c:pt>
                <c:pt idx="89">
                  <c:v>12.591475000000001</c:v>
                </c:pt>
                <c:pt idx="90">
                  <c:v>12.076460000000003</c:v>
                </c:pt>
                <c:pt idx="91">
                  <c:v>11.7036</c:v>
                </c:pt>
                <c:pt idx="92">
                  <c:v>11.853364999999997</c:v>
                </c:pt>
                <c:pt idx="93">
                  <c:v>12.497325</c:v>
                </c:pt>
                <c:pt idx="94">
                  <c:v>13.226324999999999</c:v>
                </c:pt>
                <c:pt idx="95">
                  <c:v>13.945774999999999</c:v>
                </c:pt>
                <c:pt idx="96">
                  <c:v>14.607445000000002</c:v>
                </c:pt>
                <c:pt idx="97">
                  <c:v>14.736020000000002</c:v>
                </c:pt>
                <c:pt idx="98">
                  <c:v>14.633745000000001</c:v>
                </c:pt>
                <c:pt idx="99">
                  <c:v>14.412279999999999</c:v>
                </c:pt>
                <c:pt idx="100">
                  <c:v>14.370379999999999</c:v>
                </c:pt>
                <c:pt idx="101">
                  <c:v>14.69082</c:v>
                </c:pt>
                <c:pt idx="102">
                  <c:v>15.142954999999999</c:v>
                </c:pt>
                <c:pt idx="103">
                  <c:v>15.583760000000003</c:v>
                </c:pt>
                <c:pt idx="104">
                  <c:v>15.759545000000001</c:v>
                </c:pt>
                <c:pt idx="105">
                  <c:v>15.685439999999996</c:v>
                </c:pt>
                <c:pt idx="106">
                  <c:v>15.138414999999997</c:v>
                </c:pt>
                <c:pt idx="107">
                  <c:v>14.609295000000001</c:v>
                </c:pt>
                <c:pt idx="108">
                  <c:v>13.5984</c:v>
                </c:pt>
                <c:pt idx="109">
                  <c:v>12.762639999999996</c:v>
                </c:pt>
                <c:pt idx="110">
                  <c:v>12.188514999999997</c:v>
                </c:pt>
                <c:pt idx="111">
                  <c:v>11.841489999999997</c:v>
                </c:pt>
                <c:pt idx="112">
                  <c:v>11.602495000000001</c:v>
                </c:pt>
                <c:pt idx="113">
                  <c:v>11.264360000000003</c:v>
                </c:pt>
                <c:pt idx="114">
                  <c:v>10.917570000000001</c:v>
                </c:pt>
                <c:pt idx="115">
                  <c:v>9.5991399999999967</c:v>
                </c:pt>
                <c:pt idx="116">
                  <c:v>9.043829999999998</c:v>
                </c:pt>
                <c:pt idx="117">
                  <c:v>8.629660000000003</c:v>
                </c:pt>
                <c:pt idx="118">
                  <c:v>8.3664200000000015</c:v>
                </c:pt>
                <c:pt idx="119">
                  <c:v>8.229020000000002</c:v>
                </c:pt>
                <c:pt idx="120">
                  <c:v>8.5845049999999983</c:v>
                </c:pt>
                <c:pt idx="121">
                  <c:v>8.5461399999999959</c:v>
                </c:pt>
                <c:pt idx="122">
                  <c:v>8.2738100000000028</c:v>
                </c:pt>
                <c:pt idx="123">
                  <c:v>7.7855049999999988</c:v>
                </c:pt>
                <c:pt idx="124">
                  <c:v>7.3465450000000008</c:v>
                </c:pt>
                <c:pt idx="125">
                  <c:v>6.74925</c:v>
                </c:pt>
                <c:pt idx="126">
                  <c:v>6.2144200000000014</c:v>
                </c:pt>
                <c:pt idx="127">
                  <c:v>5.8671850000000036</c:v>
                </c:pt>
                <c:pt idx="128">
                  <c:v>5.8087</c:v>
                </c:pt>
                <c:pt idx="129">
                  <c:v>5.88850499999999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82-462E-A506-BC11699A70F7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M$17:$CM$146</c:f>
              <c:numCache>
                <c:formatCode>0.00</c:formatCode>
                <c:ptCount val="130"/>
                <c:pt idx="0">
                  <c:v>31.926239999999996</c:v>
                </c:pt>
                <c:pt idx="1">
                  <c:v>31.783660000000005</c:v>
                </c:pt>
                <c:pt idx="2">
                  <c:v>26.843775000000001</c:v>
                </c:pt>
                <c:pt idx="3">
                  <c:v>25.039439999999995</c:v>
                </c:pt>
                <c:pt idx="4">
                  <c:v>23.241385000000005</c:v>
                </c:pt>
                <c:pt idx="5">
                  <c:v>21.878399999999999</c:v>
                </c:pt>
                <c:pt idx="6">
                  <c:v>21.524564999999996</c:v>
                </c:pt>
                <c:pt idx="7">
                  <c:v>21.002925000000001</c:v>
                </c:pt>
                <c:pt idx="8">
                  <c:v>20.073539999999998</c:v>
                </c:pt>
                <c:pt idx="9">
                  <c:v>19.195560000000004</c:v>
                </c:pt>
                <c:pt idx="10">
                  <c:v>20.255989999999997</c:v>
                </c:pt>
                <c:pt idx="11">
                  <c:v>24.994754999999998</c:v>
                </c:pt>
                <c:pt idx="12">
                  <c:v>32.993589999999998</c:v>
                </c:pt>
                <c:pt idx="13">
                  <c:v>44.022604999999999</c:v>
                </c:pt>
                <c:pt idx="14">
                  <c:v>57.262510000000006</c:v>
                </c:pt>
                <c:pt idx="15">
                  <c:v>69.987255000000005</c:v>
                </c:pt>
                <c:pt idx="16">
                  <c:v>79.150660000000016</c:v>
                </c:pt>
                <c:pt idx="17">
                  <c:v>87.883860000000013</c:v>
                </c:pt>
                <c:pt idx="18">
                  <c:v>86.619810000000015</c:v>
                </c:pt>
                <c:pt idx="19">
                  <c:v>81.296660000000003</c:v>
                </c:pt>
                <c:pt idx="20">
                  <c:v>72.587369999999993</c:v>
                </c:pt>
                <c:pt idx="21">
                  <c:v>64.915630000000007</c:v>
                </c:pt>
                <c:pt idx="22">
                  <c:v>55.836785000000006</c:v>
                </c:pt>
                <c:pt idx="23">
                  <c:v>48.351005000000001</c:v>
                </c:pt>
                <c:pt idx="24">
                  <c:v>43.106195</c:v>
                </c:pt>
                <c:pt idx="25">
                  <c:v>39.305754999999998</c:v>
                </c:pt>
                <c:pt idx="26">
                  <c:v>35.718210000000006</c:v>
                </c:pt>
                <c:pt idx="27">
                  <c:v>32.240229999999997</c:v>
                </c:pt>
                <c:pt idx="28">
                  <c:v>29.378195000000002</c:v>
                </c:pt>
                <c:pt idx="29">
                  <c:v>26.771720000000002</c:v>
                </c:pt>
                <c:pt idx="30">
                  <c:v>24.874970000000001</c:v>
                </c:pt>
                <c:pt idx="31">
                  <c:v>24.783435000000004</c:v>
                </c:pt>
                <c:pt idx="32">
                  <c:v>27.501160000000002</c:v>
                </c:pt>
                <c:pt idx="33">
                  <c:v>33.436715</c:v>
                </c:pt>
                <c:pt idx="34">
                  <c:v>41.127699999999997</c:v>
                </c:pt>
                <c:pt idx="35">
                  <c:v>47.183014999999997</c:v>
                </c:pt>
                <c:pt idx="36">
                  <c:v>50.929349999999999</c:v>
                </c:pt>
                <c:pt idx="37">
                  <c:v>53.025799999999997</c:v>
                </c:pt>
                <c:pt idx="38">
                  <c:v>52.622594999999997</c:v>
                </c:pt>
                <c:pt idx="39">
                  <c:v>51.659295</c:v>
                </c:pt>
                <c:pt idx="40">
                  <c:v>50.409185000000001</c:v>
                </c:pt>
                <c:pt idx="41">
                  <c:v>48.276939999999996</c:v>
                </c:pt>
                <c:pt idx="42">
                  <c:v>45.910299999999999</c:v>
                </c:pt>
                <c:pt idx="43">
                  <c:v>42.818680000000001</c:v>
                </c:pt>
                <c:pt idx="44">
                  <c:v>38.927395000000004</c:v>
                </c:pt>
                <c:pt idx="45">
                  <c:v>35.209024999999997</c:v>
                </c:pt>
                <c:pt idx="46">
                  <c:v>32.054560000000002</c:v>
                </c:pt>
                <c:pt idx="47">
                  <c:v>28.826064999999996</c:v>
                </c:pt>
                <c:pt idx="48">
                  <c:v>25.867729999999998</c:v>
                </c:pt>
                <c:pt idx="49">
                  <c:v>24.97458</c:v>
                </c:pt>
                <c:pt idx="50">
                  <c:v>25.423629999999999</c:v>
                </c:pt>
                <c:pt idx="51">
                  <c:v>27.619335000000003</c:v>
                </c:pt>
                <c:pt idx="52">
                  <c:v>28.739799999999999</c:v>
                </c:pt>
                <c:pt idx="53">
                  <c:v>28.995270000000001</c:v>
                </c:pt>
                <c:pt idx="54">
                  <c:v>28.709579999999999</c:v>
                </c:pt>
                <c:pt idx="55">
                  <c:v>29.074310000000004</c:v>
                </c:pt>
                <c:pt idx="56">
                  <c:v>30.141714999999998</c:v>
                </c:pt>
                <c:pt idx="57">
                  <c:v>31.032125000000001</c:v>
                </c:pt>
                <c:pt idx="58">
                  <c:v>31.810889999999997</c:v>
                </c:pt>
                <c:pt idx="59">
                  <c:v>32.873525000000001</c:v>
                </c:pt>
                <c:pt idx="60">
                  <c:v>33.783239999999999</c:v>
                </c:pt>
                <c:pt idx="61">
                  <c:v>34.979354999999998</c:v>
                </c:pt>
                <c:pt idx="62">
                  <c:v>34.464199999999998</c:v>
                </c:pt>
                <c:pt idx="63">
                  <c:v>32.859464999999993</c:v>
                </c:pt>
                <c:pt idx="64">
                  <c:v>30.239520000000002</c:v>
                </c:pt>
                <c:pt idx="65">
                  <c:v>27.705500000000001</c:v>
                </c:pt>
                <c:pt idx="66">
                  <c:v>26.239699999999999</c:v>
                </c:pt>
                <c:pt idx="67">
                  <c:v>24.11628</c:v>
                </c:pt>
                <c:pt idx="68">
                  <c:v>22.421700000000001</c:v>
                </c:pt>
                <c:pt idx="69">
                  <c:v>21.458339999999996</c:v>
                </c:pt>
                <c:pt idx="70">
                  <c:v>21.365549999999999</c:v>
                </c:pt>
                <c:pt idx="71">
                  <c:v>21.874979999999997</c:v>
                </c:pt>
                <c:pt idx="72">
                  <c:v>22.834295000000001</c:v>
                </c:pt>
                <c:pt idx="73">
                  <c:v>23.612639999999995</c:v>
                </c:pt>
                <c:pt idx="74">
                  <c:v>24.051404999999999</c:v>
                </c:pt>
                <c:pt idx="75">
                  <c:v>23.653595000000003</c:v>
                </c:pt>
                <c:pt idx="76">
                  <c:v>23.264360000000003</c:v>
                </c:pt>
                <c:pt idx="77">
                  <c:v>23.248395000000002</c:v>
                </c:pt>
                <c:pt idx="78">
                  <c:v>23.130775</c:v>
                </c:pt>
                <c:pt idx="79">
                  <c:v>23.747639999999997</c:v>
                </c:pt>
                <c:pt idx="80">
                  <c:v>24.537189999999995</c:v>
                </c:pt>
                <c:pt idx="81">
                  <c:v>24.990610000000004</c:v>
                </c:pt>
                <c:pt idx="82">
                  <c:v>25.062364999999996</c:v>
                </c:pt>
                <c:pt idx="83">
                  <c:v>24.023150000000001</c:v>
                </c:pt>
                <c:pt idx="84">
                  <c:v>21.971760000000003</c:v>
                </c:pt>
                <c:pt idx="85">
                  <c:v>20.371895000000002</c:v>
                </c:pt>
                <c:pt idx="86">
                  <c:v>18.858760000000004</c:v>
                </c:pt>
                <c:pt idx="87">
                  <c:v>17.552775</c:v>
                </c:pt>
                <c:pt idx="88">
                  <c:v>16.400039999999997</c:v>
                </c:pt>
                <c:pt idx="89">
                  <c:v>15.609175</c:v>
                </c:pt>
                <c:pt idx="90">
                  <c:v>15.242960000000004</c:v>
                </c:pt>
                <c:pt idx="91">
                  <c:v>14.9132</c:v>
                </c:pt>
                <c:pt idx="92">
                  <c:v>15.208664999999996</c:v>
                </c:pt>
                <c:pt idx="93">
                  <c:v>15.525425</c:v>
                </c:pt>
                <c:pt idx="94">
                  <c:v>15.755324999999999</c:v>
                </c:pt>
                <c:pt idx="95">
                  <c:v>15.631774999999999</c:v>
                </c:pt>
                <c:pt idx="96">
                  <c:v>15.566445000000002</c:v>
                </c:pt>
                <c:pt idx="97">
                  <c:v>15.183320000000002</c:v>
                </c:pt>
                <c:pt idx="98">
                  <c:v>14.920645</c:v>
                </c:pt>
                <c:pt idx="99">
                  <c:v>14.82208</c:v>
                </c:pt>
                <c:pt idx="100">
                  <c:v>14.682279999999999</c:v>
                </c:pt>
                <c:pt idx="101">
                  <c:v>14.686420000000002</c:v>
                </c:pt>
                <c:pt idx="102">
                  <c:v>14.598455</c:v>
                </c:pt>
                <c:pt idx="103">
                  <c:v>14.108060000000004</c:v>
                </c:pt>
                <c:pt idx="104">
                  <c:v>13.870145000000001</c:v>
                </c:pt>
                <c:pt idx="105">
                  <c:v>13.583139999999997</c:v>
                </c:pt>
                <c:pt idx="106">
                  <c:v>13.218814999999996</c:v>
                </c:pt>
                <c:pt idx="107">
                  <c:v>12.801995000000002</c:v>
                </c:pt>
                <c:pt idx="108">
                  <c:v>12.6942</c:v>
                </c:pt>
                <c:pt idx="109">
                  <c:v>12.451539999999996</c:v>
                </c:pt>
                <c:pt idx="110">
                  <c:v>12.466514999999996</c:v>
                </c:pt>
                <c:pt idx="111">
                  <c:v>12.174789999999996</c:v>
                </c:pt>
                <c:pt idx="112">
                  <c:v>12.042195000000001</c:v>
                </c:pt>
                <c:pt idx="113">
                  <c:v>11.525760000000004</c:v>
                </c:pt>
                <c:pt idx="114">
                  <c:v>11.089070000000001</c:v>
                </c:pt>
                <c:pt idx="115">
                  <c:v>9.6088399999999972</c:v>
                </c:pt>
                <c:pt idx="116">
                  <c:v>9.1349299999999989</c:v>
                </c:pt>
                <c:pt idx="117">
                  <c:v>8.8894600000000032</c:v>
                </c:pt>
                <c:pt idx="118">
                  <c:v>8.4664200000000012</c:v>
                </c:pt>
                <c:pt idx="119">
                  <c:v>8.186020000000001</c:v>
                </c:pt>
                <c:pt idx="120">
                  <c:v>7.9109049999999987</c:v>
                </c:pt>
                <c:pt idx="121">
                  <c:v>7.6658399999999967</c:v>
                </c:pt>
                <c:pt idx="122">
                  <c:v>7.4319100000000038</c:v>
                </c:pt>
                <c:pt idx="123">
                  <c:v>7.2052049999999985</c:v>
                </c:pt>
                <c:pt idx="124">
                  <c:v>6.9282450000000013</c:v>
                </c:pt>
                <c:pt idx="125">
                  <c:v>6.67075</c:v>
                </c:pt>
                <c:pt idx="126">
                  <c:v>6.3213200000000009</c:v>
                </c:pt>
                <c:pt idx="127">
                  <c:v>5.9698850000000032</c:v>
                </c:pt>
                <c:pt idx="128">
                  <c:v>5.8281000000000001</c:v>
                </c:pt>
                <c:pt idx="129">
                  <c:v>5.65150499999999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82-462E-A506-BC11699A70F7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N$17:$CN$146</c:f>
              <c:numCache>
                <c:formatCode>0.00</c:formatCode>
                <c:ptCount val="130"/>
                <c:pt idx="0">
                  <c:v>28.528939999999995</c:v>
                </c:pt>
                <c:pt idx="1">
                  <c:v>28.630860000000002</c:v>
                </c:pt>
                <c:pt idx="2">
                  <c:v>22.178175</c:v>
                </c:pt>
                <c:pt idx="3">
                  <c:v>20.078039999999998</c:v>
                </c:pt>
                <c:pt idx="4">
                  <c:v>18.067685000000004</c:v>
                </c:pt>
                <c:pt idx="5">
                  <c:v>16.046199999999999</c:v>
                </c:pt>
                <c:pt idx="6">
                  <c:v>15.152364999999996</c:v>
                </c:pt>
                <c:pt idx="7">
                  <c:v>16.362925000000001</c:v>
                </c:pt>
                <c:pt idx="8">
                  <c:v>19.907739999999997</c:v>
                </c:pt>
                <c:pt idx="9">
                  <c:v>25.997160000000004</c:v>
                </c:pt>
                <c:pt idx="10">
                  <c:v>35.142289999999996</c:v>
                </c:pt>
                <c:pt idx="11">
                  <c:v>47.319755000000001</c:v>
                </c:pt>
                <c:pt idx="12">
                  <c:v>58.667189999999991</c:v>
                </c:pt>
                <c:pt idx="13">
                  <c:v>69.440305000000009</c:v>
                </c:pt>
                <c:pt idx="14">
                  <c:v>80.55971000000001</c:v>
                </c:pt>
                <c:pt idx="15">
                  <c:v>95.327955000000003</c:v>
                </c:pt>
                <c:pt idx="16">
                  <c:v>110.80526</c:v>
                </c:pt>
                <c:pt idx="17">
                  <c:v>128.14126000000002</c:v>
                </c:pt>
                <c:pt idx="18">
                  <c:v>121.36911000000001</c:v>
                </c:pt>
                <c:pt idx="19">
                  <c:v>103.11896000000002</c:v>
                </c:pt>
                <c:pt idx="20">
                  <c:v>82.490569999999991</c:v>
                </c:pt>
                <c:pt idx="21">
                  <c:v>63.920730000000006</c:v>
                </c:pt>
                <c:pt idx="22">
                  <c:v>50.983485000000002</c:v>
                </c:pt>
                <c:pt idx="23">
                  <c:v>42.213504999999998</c:v>
                </c:pt>
                <c:pt idx="24">
                  <c:v>35.697395</c:v>
                </c:pt>
                <c:pt idx="25">
                  <c:v>30.692954999999998</c:v>
                </c:pt>
                <c:pt idx="26">
                  <c:v>27.172010000000004</c:v>
                </c:pt>
                <c:pt idx="27">
                  <c:v>24.570629999999998</c:v>
                </c:pt>
                <c:pt idx="28">
                  <c:v>23.183495000000001</c:v>
                </c:pt>
                <c:pt idx="29">
                  <c:v>22.976020000000002</c:v>
                </c:pt>
                <c:pt idx="30">
                  <c:v>24.666270000000001</c:v>
                </c:pt>
                <c:pt idx="31">
                  <c:v>28.280235000000005</c:v>
                </c:pt>
                <c:pt idx="32">
                  <c:v>33.484860000000005</c:v>
                </c:pt>
                <c:pt idx="33">
                  <c:v>39.484014999999999</c:v>
                </c:pt>
                <c:pt idx="34">
                  <c:v>45.915500000000002</c:v>
                </c:pt>
                <c:pt idx="35">
                  <c:v>52.161014999999999</c:v>
                </c:pt>
                <c:pt idx="36">
                  <c:v>57.420749999999998</c:v>
                </c:pt>
                <c:pt idx="37">
                  <c:v>62.727699999999999</c:v>
                </c:pt>
                <c:pt idx="38">
                  <c:v>67.688994999999991</c:v>
                </c:pt>
                <c:pt idx="39">
                  <c:v>69.055295000000001</c:v>
                </c:pt>
                <c:pt idx="40">
                  <c:v>66.790485000000004</c:v>
                </c:pt>
                <c:pt idx="41">
                  <c:v>57.740639999999992</c:v>
                </c:pt>
                <c:pt idx="42">
                  <c:v>47.782499999999999</c:v>
                </c:pt>
                <c:pt idx="43">
                  <c:v>40.088479999999997</c:v>
                </c:pt>
                <c:pt idx="44">
                  <c:v>33.088995000000004</c:v>
                </c:pt>
                <c:pt idx="45">
                  <c:v>28.582425000000001</c:v>
                </c:pt>
                <c:pt idx="46">
                  <c:v>25.452460000000002</c:v>
                </c:pt>
                <c:pt idx="47">
                  <c:v>23.681264999999996</c:v>
                </c:pt>
                <c:pt idx="48">
                  <c:v>22.87473</c:v>
                </c:pt>
                <c:pt idx="49">
                  <c:v>22.870079999999998</c:v>
                </c:pt>
                <c:pt idx="50">
                  <c:v>22.887029999999999</c:v>
                </c:pt>
                <c:pt idx="51">
                  <c:v>22.992135000000005</c:v>
                </c:pt>
                <c:pt idx="52">
                  <c:v>23.992799999999999</c:v>
                </c:pt>
                <c:pt idx="53">
                  <c:v>26.116970000000002</c:v>
                </c:pt>
                <c:pt idx="54">
                  <c:v>30.115679999999998</c:v>
                </c:pt>
                <c:pt idx="55">
                  <c:v>35.196310000000004</c:v>
                </c:pt>
                <c:pt idx="56">
                  <c:v>40.692715</c:v>
                </c:pt>
                <c:pt idx="57">
                  <c:v>42.960825</c:v>
                </c:pt>
                <c:pt idx="58">
                  <c:v>43.272489999999998</c:v>
                </c:pt>
                <c:pt idx="59">
                  <c:v>42.599125000000001</c:v>
                </c:pt>
                <c:pt idx="60">
                  <c:v>42.561139999999995</c:v>
                </c:pt>
                <c:pt idx="61">
                  <c:v>42.448754999999998</c:v>
                </c:pt>
                <c:pt idx="62">
                  <c:v>39.691800000000001</c:v>
                </c:pt>
                <c:pt idx="63">
                  <c:v>35.971164999999999</c:v>
                </c:pt>
                <c:pt idx="64">
                  <c:v>31.305120000000002</c:v>
                </c:pt>
                <c:pt idx="65">
                  <c:v>27.795100000000001</c:v>
                </c:pt>
                <c:pt idx="66">
                  <c:v>24.980699999999999</c:v>
                </c:pt>
                <c:pt idx="67">
                  <c:v>22.35248</c:v>
                </c:pt>
                <c:pt idx="68">
                  <c:v>21.1997</c:v>
                </c:pt>
                <c:pt idx="69">
                  <c:v>20.909039999999997</c:v>
                </c:pt>
                <c:pt idx="70">
                  <c:v>21.093450000000001</c:v>
                </c:pt>
                <c:pt idx="71">
                  <c:v>21.558779999999999</c:v>
                </c:pt>
                <c:pt idx="72">
                  <c:v>22.688095000000001</c:v>
                </c:pt>
                <c:pt idx="73">
                  <c:v>24.099439999999998</c:v>
                </c:pt>
                <c:pt idx="74">
                  <c:v>25.650005</c:v>
                </c:pt>
                <c:pt idx="75">
                  <c:v>27.481795000000002</c:v>
                </c:pt>
                <c:pt idx="76">
                  <c:v>28.808660000000003</c:v>
                </c:pt>
                <c:pt idx="77">
                  <c:v>30.237095</c:v>
                </c:pt>
                <c:pt idx="78">
                  <c:v>31.675075</c:v>
                </c:pt>
                <c:pt idx="79">
                  <c:v>32.576139999999995</c:v>
                </c:pt>
                <c:pt idx="80">
                  <c:v>32.302389999999995</c:v>
                </c:pt>
                <c:pt idx="81">
                  <c:v>31.692610000000002</c:v>
                </c:pt>
                <c:pt idx="82">
                  <c:v>30.465264999999995</c:v>
                </c:pt>
                <c:pt idx="83">
                  <c:v>28.773949999999999</c:v>
                </c:pt>
                <c:pt idx="84">
                  <c:v>26.487360000000002</c:v>
                </c:pt>
                <c:pt idx="85">
                  <c:v>24.862495000000003</c:v>
                </c:pt>
                <c:pt idx="86">
                  <c:v>23.328860000000002</c:v>
                </c:pt>
                <c:pt idx="87">
                  <c:v>21.855775000000001</c:v>
                </c:pt>
                <c:pt idx="88">
                  <c:v>20.881039999999995</c:v>
                </c:pt>
                <c:pt idx="89">
                  <c:v>20.300975000000001</c:v>
                </c:pt>
                <c:pt idx="90">
                  <c:v>20.181260000000002</c:v>
                </c:pt>
                <c:pt idx="91">
                  <c:v>20.263300000000001</c:v>
                </c:pt>
                <c:pt idx="92">
                  <c:v>20.591664999999995</c:v>
                </c:pt>
                <c:pt idx="93">
                  <c:v>21.517225</c:v>
                </c:pt>
                <c:pt idx="94">
                  <c:v>22.570824999999999</c:v>
                </c:pt>
                <c:pt idx="95">
                  <c:v>23.470475</c:v>
                </c:pt>
                <c:pt idx="96">
                  <c:v>24.741645000000002</c:v>
                </c:pt>
                <c:pt idx="97">
                  <c:v>25.709320000000002</c:v>
                </c:pt>
                <c:pt idx="98">
                  <c:v>26.141745</c:v>
                </c:pt>
                <c:pt idx="99">
                  <c:v>26.64348</c:v>
                </c:pt>
                <c:pt idx="100">
                  <c:v>26.282879999999999</c:v>
                </c:pt>
                <c:pt idx="101">
                  <c:v>25.635920000000002</c:v>
                </c:pt>
                <c:pt idx="102">
                  <c:v>25.432354999999998</c:v>
                </c:pt>
                <c:pt idx="103">
                  <c:v>25.301860000000005</c:v>
                </c:pt>
                <c:pt idx="104">
                  <c:v>24.906945</c:v>
                </c:pt>
                <c:pt idx="105">
                  <c:v>24.064639999999997</c:v>
                </c:pt>
                <c:pt idx="106">
                  <c:v>22.813614999999995</c:v>
                </c:pt>
                <c:pt idx="107">
                  <c:v>21.522895000000002</c:v>
                </c:pt>
                <c:pt idx="108">
                  <c:v>20.111599999999999</c:v>
                </c:pt>
                <c:pt idx="109">
                  <c:v>18.903639999999996</c:v>
                </c:pt>
                <c:pt idx="110">
                  <c:v>18.155114999999995</c:v>
                </c:pt>
                <c:pt idx="111">
                  <c:v>17.888189999999998</c:v>
                </c:pt>
                <c:pt idx="112">
                  <c:v>17.723795000000003</c:v>
                </c:pt>
                <c:pt idx="113">
                  <c:v>17.524160000000002</c:v>
                </c:pt>
                <c:pt idx="114">
                  <c:v>16.896370000000001</c:v>
                </c:pt>
                <c:pt idx="115">
                  <c:v>14.673939999999996</c:v>
                </c:pt>
                <c:pt idx="116">
                  <c:v>14.086029999999999</c:v>
                </c:pt>
                <c:pt idx="117">
                  <c:v>13.948260000000003</c:v>
                </c:pt>
                <c:pt idx="118">
                  <c:v>14.120820000000002</c:v>
                </c:pt>
                <c:pt idx="119">
                  <c:v>14.443020000000001</c:v>
                </c:pt>
                <c:pt idx="120">
                  <c:v>14.412304999999998</c:v>
                </c:pt>
                <c:pt idx="121">
                  <c:v>13.816139999999997</c:v>
                </c:pt>
                <c:pt idx="122">
                  <c:v>12.910910000000003</c:v>
                </c:pt>
                <c:pt idx="123">
                  <c:v>12.123204999999999</c:v>
                </c:pt>
                <c:pt idx="124">
                  <c:v>11.221745</c:v>
                </c:pt>
                <c:pt idx="125">
                  <c:v>10.56855</c:v>
                </c:pt>
                <c:pt idx="126">
                  <c:v>10.081520000000001</c:v>
                </c:pt>
                <c:pt idx="127">
                  <c:v>9.701685000000003</c:v>
                </c:pt>
                <c:pt idx="128">
                  <c:v>9.6623000000000001</c:v>
                </c:pt>
                <c:pt idx="129">
                  <c:v>9.316404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082-462E-A506-BC11699A70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949888"/>
        <c:axId val="66951424"/>
      </c:lineChart>
      <c:catAx>
        <c:axId val="66949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695142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695142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69498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I$17:$CI$146</c:f>
              <c:numCache>
                <c:formatCode>0.00</c:formatCode>
                <c:ptCount val="130"/>
                <c:pt idx="0">
                  <c:v>171.42074</c:v>
                </c:pt>
                <c:pt idx="1">
                  <c:v>138.42716000000001</c:v>
                </c:pt>
                <c:pt idx="2">
                  <c:v>97.949475000000007</c:v>
                </c:pt>
                <c:pt idx="3">
                  <c:v>88.705639999999988</c:v>
                </c:pt>
                <c:pt idx="4">
                  <c:v>79.474285000000009</c:v>
                </c:pt>
                <c:pt idx="5">
                  <c:v>71.8155</c:v>
                </c:pt>
                <c:pt idx="6">
                  <c:v>67.535764999999984</c:v>
                </c:pt>
                <c:pt idx="7">
                  <c:v>68.097724999999997</c:v>
                </c:pt>
                <c:pt idx="8">
                  <c:v>71.701439999999991</c:v>
                </c:pt>
                <c:pt idx="9">
                  <c:v>79.828160000000011</c:v>
                </c:pt>
                <c:pt idx="10">
                  <c:v>90.233589999999992</c:v>
                </c:pt>
                <c:pt idx="11">
                  <c:v>107.541855</c:v>
                </c:pt>
                <c:pt idx="12">
                  <c:v>129.65298999999999</c:v>
                </c:pt>
                <c:pt idx="13">
                  <c:v>151.430305</c:v>
                </c:pt>
                <c:pt idx="14">
                  <c:v>167.49211</c:v>
                </c:pt>
                <c:pt idx="15">
                  <c:v>171.955355</c:v>
                </c:pt>
                <c:pt idx="16">
                  <c:v>164.39446000000001</c:v>
                </c:pt>
                <c:pt idx="17">
                  <c:v>167.04776000000001</c:v>
                </c:pt>
                <c:pt idx="18">
                  <c:v>152.58711</c:v>
                </c:pt>
                <c:pt idx="19">
                  <c:v>137.48906000000002</c:v>
                </c:pt>
                <c:pt idx="20">
                  <c:v>126.28327</c:v>
                </c:pt>
                <c:pt idx="21">
                  <c:v>118.13053000000001</c:v>
                </c:pt>
                <c:pt idx="22">
                  <c:v>108.30708500000001</c:v>
                </c:pt>
                <c:pt idx="23">
                  <c:v>98.606504999999999</c:v>
                </c:pt>
                <c:pt idx="24">
                  <c:v>89.617694999999998</c:v>
                </c:pt>
                <c:pt idx="25">
                  <c:v>82.594255000000004</c:v>
                </c:pt>
                <c:pt idx="26">
                  <c:v>77.322110000000009</c:v>
                </c:pt>
                <c:pt idx="27">
                  <c:v>74.599630000000005</c:v>
                </c:pt>
                <c:pt idx="28">
                  <c:v>75.015495000000001</c:v>
                </c:pt>
                <c:pt idx="29">
                  <c:v>79.821820000000002</c:v>
                </c:pt>
                <c:pt idx="30">
                  <c:v>88.508669999999995</c:v>
                </c:pt>
                <c:pt idx="31">
                  <c:v>97.243335000000016</c:v>
                </c:pt>
                <c:pt idx="32">
                  <c:v>104.01606000000001</c:v>
                </c:pt>
                <c:pt idx="33">
                  <c:v>104.53931499999999</c:v>
                </c:pt>
                <c:pt idx="34">
                  <c:v>99.546300000000002</c:v>
                </c:pt>
                <c:pt idx="35">
                  <c:v>92.814314999999993</c:v>
                </c:pt>
                <c:pt idx="36">
                  <c:v>86.698250000000002</c:v>
                </c:pt>
                <c:pt idx="37">
                  <c:v>82.143199999999993</c:v>
                </c:pt>
                <c:pt idx="38">
                  <c:v>79.550195000000002</c:v>
                </c:pt>
                <c:pt idx="39">
                  <c:v>77.937694999999991</c:v>
                </c:pt>
                <c:pt idx="40">
                  <c:v>77.393485000000013</c:v>
                </c:pt>
                <c:pt idx="41">
                  <c:v>70.165539999999993</c:v>
                </c:pt>
                <c:pt idx="42">
                  <c:v>63.43</c:v>
                </c:pt>
                <c:pt idx="43">
                  <c:v>60.244480000000003</c:v>
                </c:pt>
                <c:pt idx="44">
                  <c:v>57.819194999999993</c:v>
                </c:pt>
                <c:pt idx="45">
                  <c:v>56.967125000000003</c:v>
                </c:pt>
                <c:pt idx="46">
                  <c:v>57.131660000000011</c:v>
                </c:pt>
                <c:pt idx="47">
                  <c:v>58.717564999999993</c:v>
                </c:pt>
                <c:pt idx="48">
                  <c:v>60.199130000000004</c:v>
                </c:pt>
                <c:pt idx="49">
                  <c:v>60.954780000000007</c:v>
                </c:pt>
                <c:pt idx="50">
                  <c:v>60.664830000000002</c:v>
                </c:pt>
                <c:pt idx="51">
                  <c:v>60.053335000000011</c:v>
                </c:pt>
                <c:pt idx="52">
                  <c:v>59.4251</c:v>
                </c:pt>
                <c:pt idx="53">
                  <c:v>58.761369999999992</c:v>
                </c:pt>
                <c:pt idx="54">
                  <c:v>58.128280000000004</c:v>
                </c:pt>
                <c:pt idx="55">
                  <c:v>57.694910000000007</c:v>
                </c:pt>
                <c:pt idx="56">
                  <c:v>56.70611499999999</c:v>
                </c:pt>
                <c:pt idx="57">
                  <c:v>55.181624999999997</c:v>
                </c:pt>
                <c:pt idx="58">
                  <c:v>53.666989999999991</c:v>
                </c:pt>
                <c:pt idx="59">
                  <c:v>52.045425000000002</c:v>
                </c:pt>
                <c:pt idx="60">
                  <c:v>50.803539999999998</c:v>
                </c:pt>
                <c:pt idx="61">
                  <c:v>50.490355000000001</c:v>
                </c:pt>
                <c:pt idx="62">
                  <c:v>50.478900000000003</c:v>
                </c:pt>
                <c:pt idx="63">
                  <c:v>50.312365</c:v>
                </c:pt>
                <c:pt idx="64">
                  <c:v>49.889720000000004</c:v>
                </c:pt>
                <c:pt idx="65">
                  <c:v>49.9726</c:v>
                </c:pt>
                <c:pt idx="66">
                  <c:v>50.028399999999998</c:v>
                </c:pt>
                <c:pt idx="67">
                  <c:v>49.084780000000002</c:v>
                </c:pt>
                <c:pt idx="68">
                  <c:v>49.8048</c:v>
                </c:pt>
                <c:pt idx="69">
                  <c:v>50.587339999999998</c:v>
                </c:pt>
                <c:pt idx="70">
                  <c:v>51.955150000000003</c:v>
                </c:pt>
                <c:pt idx="71">
                  <c:v>52.414879999999997</c:v>
                </c:pt>
                <c:pt idx="72">
                  <c:v>51.142094999999998</c:v>
                </c:pt>
                <c:pt idx="73">
                  <c:v>49.078439999999993</c:v>
                </c:pt>
                <c:pt idx="74">
                  <c:v>46.643904999999997</c:v>
                </c:pt>
                <c:pt idx="75">
                  <c:v>45.382395000000002</c:v>
                </c:pt>
                <c:pt idx="76">
                  <c:v>45.139760000000003</c:v>
                </c:pt>
                <c:pt idx="77">
                  <c:v>45.178094999999999</c:v>
                </c:pt>
                <c:pt idx="78">
                  <c:v>45.998275</c:v>
                </c:pt>
                <c:pt idx="79">
                  <c:v>46.670339999999996</c:v>
                </c:pt>
                <c:pt idx="80">
                  <c:v>45.796289999999999</c:v>
                </c:pt>
                <c:pt idx="81">
                  <c:v>43.767910000000001</c:v>
                </c:pt>
                <c:pt idx="82">
                  <c:v>42.212564999999998</c:v>
                </c:pt>
                <c:pt idx="83">
                  <c:v>41.295549999999999</c:v>
                </c:pt>
                <c:pt idx="84">
                  <c:v>40.196860000000001</c:v>
                </c:pt>
                <c:pt idx="85">
                  <c:v>40.287894999999999</c:v>
                </c:pt>
                <c:pt idx="86">
                  <c:v>42.656360000000006</c:v>
                </c:pt>
                <c:pt idx="87">
                  <c:v>43.443674999999999</c:v>
                </c:pt>
                <c:pt idx="88">
                  <c:v>43.160939999999997</c:v>
                </c:pt>
                <c:pt idx="89">
                  <c:v>41.575775</c:v>
                </c:pt>
                <c:pt idx="90">
                  <c:v>40.101960000000005</c:v>
                </c:pt>
                <c:pt idx="91">
                  <c:v>37.263300000000001</c:v>
                </c:pt>
                <c:pt idx="92">
                  <c:v>36.224964999999997</c:v>
                </c:pt>
                <c:pt idx="93">
                  <c:v>35.753824999999999</c:v>
                </c:pt>
                <c:pt idx="94">
                  <c:v>35.942824999999999</c:v>
                </c:pt>
                <c:pt idx="95">
                  <c:v>36.636775</c:v>
                </c:pt>
                <c:pt idx="96">
                  <c:v>38.235345000000002</c:v>
                </c:pt>
                <c:pt idx="97">
                  <c:v>39.010719999999999</c:v>
                </c:pt>
                <c:pt idx="98">
                  <c:v>39.443645000000004</c:v>
                </c:pt>
                <c:pt idx="99">
                  <c:v>39.05348</c:v>
                </c:pt>
                <c:pt idx="100">
                  <c:v>37.249479999999998</c:v>
                </c:pt>
                <c:pt idx="101">
                  <c:v>35.477519999999998</c:v>
                </c:pt>
                <c:pt idx="102">
                  <c:v>33.595354999999998</c:v>
                </c:pt>
                <c:pt idx="103">
                  <c:v>31.910860000000003</c:v>
                </c:pt>
                <c:pt idx="104">
                  <c:v>30.366845000000001</c:v>
                </c:pt>
                <c:pt idx="105">
                  <c:v>28.815739999999998</c:v>
                </c:pt>
                <c:pt idx="106">
                  <c:v>27.804814999999998</c:v>
                </c:pt>
                <c:pt idx="107">
                  <c:v>27.519195</c:v>
                </c:pt>
                <c:pt idx="108">
                  <c:v>27.7425</c:v>
                </c:pt>
                <c:pt idx="109">
                  <c:v>27.756139999999995</c:v>
                </c:pt>
                <c:pt idx="110">
                  <c:v>27.424614999999996</c:v>
                </c:pt>
                <c:pt idx="111">
                  <c:v>26.630689999999998</c:v>
                </c:pt>
                <c:pt idx="112">
                  <c:v>25.504295000000003</c:v>
                </c:pt>
                <c:pt idx="113">
                  <c:v>24.053460000000005</c:v>
                </c:pt>
                <c:pt idx="114">
                  <c:v>22.902370000000001</c:v>
                </c:pt>
                <c:pt idx="115">
                  <c:v>18.813339999999997</c:v>
                </c:pt>
                <c:pt idx="116">
                  <c:v>17.933329999999998</c:v>
                </c:pt>
                <c:pt idx="117">
                  <c:v>17.451860000000003</c:v>
                </c:pt>
                <c:pt idx="118">
                  <c:v>17.63822</c:v>
                </c:pt>
                <c:pt idx="119">
                  <c:v>17.92482</c:v>
                </c:pt>
                <c:pt idx="120">
                  <c:v>18.397205</c:v>
                </c:pt>
                <c:pt idx="121">
                  <c:v>18.045939999999998</c:v>
                </c:pt>
                <c:pt idx="122">
                  <c:v>17.485410000000005</c:v>
                </c:pt>
                <c:pt idx="123">
                  <c:v>16.951004999999999</c:v>
                </c:pt>
                <c:pt idx="124">
                  <c:v>16.409245000000002</c:v>
                </c:pt>
                <c:pt idx="125">
                  <c:v>15.731450000000001</c:v>
                </c:pt>
                <c:pt idx="126">
                  <c:v>15.155720000000001</c:v>
                </c:pt>
                <c:pt idx="127">
                  <c:v>14.760985000000003</c:v>
                </c:pt>
                <c:pt idx="128">
                  <c:v>15.269</c:v>
                </c:pt>
                <c:pt idx="129">
                  <c:v>15.5753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D7A-4531-A963-DFA7271C65E6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J$17:$CJ$146</c:f>
              <c:numCache>
                <c:formatCode>0.00</c:formatCode>
                <c:ptCount val="130"/>
                <c:pt idx="0">
                  <c:v>150.60623999999999</c:v>
                </c:pt>
                <c:pt idx="1">
                  <c:v>115.63826</c:v>
                </c:pt>
                <c:pt idx="2">
                  <c:v>72.521474999999995</c:v>
                </c:pt>
                <c:pt idx="3">
                  <c:v>60.679839999999992</c:v>
                </c:pt>
                <c:pt idx="4">
                  <c:v>56.552485000000011</c:v>
                </c:pt>
                <c:pt idx="5">
                  <c:v>55.278399999999998</c:v>
                </c:pt>
                <c:pt idx="6">
                  <c:v>54.274064999999993</c:v>
                </c:pt>
                <c:pt idx="7">
                  <c:v>56.679524999999998</c:v>
                </c:pt>
                <c:pt idx="8">
                  <c:v>61.508639999999993</c:v>
                </c:pt>
                <c:pt idx="9">
                  <c:v>67.117060000000009</c:v>
                </c:pt>
                <c:pt idx="10">
                  <c:v>73.127289999999988</c:v>
                </c:pt>
                <c:pt idx="11">
                  <c:v>83.749755000000007</c:v>
                </c:pt>
                <c:pt idx="12">
                  <c:v>101.47998999999999</c:v>
                </c:pt>
                <c:pt idx="13">
                  <c:v>127.191705</c:v>
                </c:pt>
                <c:pt idx="14">
                  <c:v>156.58821</c:v>
                </c:pt>
                <c:pt idx="15">
                  <c:v>171.14845500000001</c:v>
                </c:pt>
                <c:pt idx="16">
                  <c:v>166.98976000000002</c:v>
                </c:pt>
                <c:pt idx="17">
                  <c:v>162.99676000000002</c:v>
                </c:pt>
                <c:pt idx="18">
                  <c:v>140.86161000000001</c:v>
                </c:pt>
                <c:pt idx="19">
                  <c:v>123.26046000000001</c:v>
                </c:pt>
                <c:pt idx="20">
                  <c:v>113.20926999999999</c:v>
                </c:pt>
                <c:pt idx="21">
                  <c:v>103.92803000000001</c:v>
                </c:pt>
                <c:pt idx="22">
                  <c:v>95.267585000000011</c:v>
                </c:pt>
                <c:pt idx="23">
                  <c:v>85.525305000000003</c:v>
                </c:pt>
                <c:pt idx="24">
                  <c:v>75.566194999999993</c:v>
                </c:pt>
                <c:pt idx="25">
                  <c:v>68.134055000000004</c:v>
                </c:pt>
                <c:pt idx="26">
                  <c:v>65.642810000000011</c:v>
                </c:pt>
                <c:pt idx="27">
                  <c:v>66.668630000000007</c:v>
                </c:pt>
                <c:pt idx="28">
                  <c:v>71.768495000000001</c:v>
                </c:pt>
                <c:pt idx="29">
                  <c:v>78.338119999999989</c:v>
                </c:pt>
                <c:pt idx="30">
                  <c:v>83.284269999999992</c:v>
                </c:pt>
                <c:pt idx="31">
                  <c:v>85.278135000000006</c:v>
                </c:pt>
                <c:pt idx="32">
                  <c:v>86.027460000000005</c:v>
                </c:pt>
                <c:pt idx="33">
                  <c:v>87.485714999999985</c:v>
                </c:pt>
                <c:pt idx="34">
                  <c:v>89.593100000000007</c:v>
                </c:pt>
                <c:pt idx="35">
                  <c:v>92.369414999999989</c:v>
                </c:pt>
                <c:pt idx="36">
                  <c:v>93.861649999999997</c:v>
                </c:pt>
                <c:pt idx="37">
                  <c:v>91.853399999999993</c:v>
                </c:pt>
                <c:pt idx="38">
                  <c:v>86.124794999999992</c:v>
                </c:pt>
                <c:pt idx="39">
                  <c:v>79.170294999999996</c:v>
                </c:pt>
                <c:pt idx="40">
                  <c:v>72.625785000000008</c:v>
                </c:pt>
                <c:pt idx="41">
                  <c:v>63.990739999999988</c:v>
                </c:pt>
                <c:pt idx="42">
                  <c:v>57.459699999999998</c:v>
                </c:pt>
                <c:pt idx="43">
                  <c:v>56.159380000000006</c:v>
                </c:pt>
                <c:pt idx="44">
                  <c:v>56.256294999999994</c:v>
                </c:pt>
                <c:pt idx="45">
                  <c:v>56.217224999999999</c:v>
                </c:pt>
                <c:pt idx="46">
                  <c:v>56.474560000000011</c:v>
                </c:pt>
                <c:pt idx="47">
                  <c:v>58.24786499999999</c:v>
                </c:pt>
                <c:pt idx="48">
                  <c:v>60.637230000000002</c:v>
                </c:pt>
                <c:pt idx="49">
                  <c:v>64.63148000000001</c:v>
                </c:pt>
                <c:pt idx="50">
                  <c:v>66.382230000000007</c:v>
                </c:pt>
                <c:pt idx="51">
                  <c:v>65.673835000000011</c:v>
                </c:pt>
                <c:pt idx="52">
                  <c:v>63.464199999999998</c:v>
                </c:pt>
                <c:pt idx="53">
                  <c:v>61.081069999999997</c:v>
                </c:pt>
                <c:pt idx="54">
                  <c:v>60.594180000000001</c:v>
                </c:pt>
                <c:pt idx="55">
                  <c:v>60.917110000000008</c:v>
                </c:pt>
                <c:pt idx="56">
                  <c:v>61.67101499999999</c:v>
                </c:pt>
                <c:pt idx="57">
                  <c:v>62.458224999999999</c:v>
                </c:pt>
                <c:pt idx="58">
                  <c:v>62.114589999999993</c:v>
                </c:pt>
                <c:pt idx="59">
                  <c:v>59.534424999999999</c:v>
                </c:pt>
                <c:pt idx="60">
                  <c:v>56.602039999999988</c:v>
                </c:pt>
                <c:pt idx="61">
                  <c:v>54.563655000000004</c:v>
                </c:pt>
                <c:pt idx="62">
                  <c:v>54.804200000000002</c:v>
                </c:pt>
                <c:pt idx="63">
                  <c:v>56.478064999999994</c:v>
                </c:pt>
                <c:pt idx="64">
                  <c:v>57.413419999999995</c:v>
                </c:pt>
                <c:pt idx="65">
                  <c:v>59.096400000000003</c:v>
                </c:pt>
                <c:pt idx="66">
                  <c:v>59.523499999999999</c:v>
                </c:pt>
                <c:pt idx="67">
                  <c:v>57.604380000000006</c:v>
                </c:pt>
                <c:pt idx="68">
                  <c:v>56.449199999999998</c:v>
                </c:pt>
                <c:pt idx="69">
                  <c:v>56.790639999999989</c:v>
                </c:pt>
                <c:pt idx="70">
                  <c:v>57.857950000000002</c:v>
                </c:pt>
                <c:pt idx="71">
                  <c:v>59.093980000000002</c:v>
                </c:pt>
                <c:pt idx="72">
                  <c:v>60.404394999999994</c:v>
                </c:pt>
                <c:pt idx="73">
                  <c:v>60.180939999999993</c:v>
                </c:pt>
                <c:pt idx="74">
                  <c:v>58.263805000000005</c:v>
                </c:pt>
                <c:pt idx="75">
                  <c:v>56.381794999999997</c:v>
                </c:pt>
                <c:pt idx="76">
                  <c:v>54.887560000000008</c:v>
                </c:pt>
                <c:pt idx="77">
                  <c:v>54.440094999999992</c:v>
                </c:pt>
                <c:pt idx="78">
                  <c:v>55.331575000000001</c:v>
                </c:pt>
                <c:pt idx="79">
                  <c:v>55.438939999999988</c:v>
                </c:pt>
                <c:pt idx="80">
                  <c:v>55.217989999999993</c:v>
                </c:pt>
                <c:pt idx="81">
                  <c:v>53.972210000000011</c:v>
                </c:pt>
                <c:pt idx="82">
                  <c:v>52.725664999999992</c:v>
                </c:pt>
                <c:pt idx="83">
                  <c:v>50.953850000000003</c:v>
                </c:pt>
                <c:pt idx="84">
                  <c:v>49.820460000000004</c:v>
                </c:pt>
                <c:pt idx="85">
                  <c:v>50.091995000000004</c:v>
                </c:pt>
                <c:pt idx="86">
                  <c:v>51.946260000000002</c:v>
                </c:pt>
                <c:pt idx="87">
                  <c:v>55.294575000000002</c:v>
                </c:pt>
                <c:pt idx="88">
                  <c:v>57.155639999999991</c:v>
                </c:pt>
                <c:pt idx="89">
                  <c:v>56.713774999999998</c:v>
                </c:pt>
                <c:pt idx="90">
                  <c:v>54.237660000000012</c:v>
                </c:pt>
                <c:pt idx="91">
                  <c:v>50.2316</c:v>
                </c:pt>
                <c:pt idx="92">
                  <c:v>48.924564999999994</c:v>
                </c:pt>
                <c:pt idx="93">
                  <c:v>48.931424999999997</c:v>
                </c:pt>
                <c:pt idx="94">
                  <c:v>49.669224999999997</c:v>
                </c:pt>
                <c:pt idx="95">
                  <c:v>50.116475000000001</c:v>
                </c:pt>
                <c:pt idx="96">
                  <c:v>50.064345000000003</c:v>
                </c:pt>
                <c:pt idx="97">
                  <c:v>48.76952</c:v>
                </c:pt>
                <c:pt idx="98">
                  <c:v>47.373044999999998</c:v>
                </c:pt>
                <c:pt idx="99">
                  <c:v>45.589379999999998</c:v>
                </c:pt>
                <c:pt idx="100">
                  <c:v>45.06718</c:v>
                </c:pt>
                <c:pt idx="101">
                  <c:v>45.135220000000004</c:v>
                </c:pt>
                <c:pt idx="102">
                  <c:v>45.613154999999999</c:v>
                </c:pt>
                <c:pt idx="103">
                  <c:v>46.529760000000003</c:v>
                </c:pt>
                <c:pt idx="104">
                  <c:v>47.461244999999998</c:v>
                </c:pt>
                <c:pt idx="105">
                  <c:v>47.800339999999998</c:v>
                </c:pt>
                <c:pt idx="106">
                  <c:v>47.701915</c:v>
                </c:pt>
                <c:pt idx="107">
                  <c:v>47.031495</c:v>
                </c:pt>
                <c:pt idx="108">
                  <c:v>45.355899999999998</c:v>
                </c:pt>
                <c:pt idx="109">
                  <c:v>43.798439999999999</c:v>
                </c:pt>
                <c:pt idx="110">
                  <c:v>42.624314999999996</c:v>
                </c:pt>
                <c:pt idx="111">
                  <c:v>42.218089999999997</c:v>
                </c:pt>
                <c:pt idx="112">
                  <c:v>41.768194999999999</c:v>
                </c:pt>
                <c:pt idx="113">
                  <c:v>41.039960000000001</c:v>
                </c:pt>
                <c:pt idx="114">
                  <c:v>39.84057</c:v>
                </c:pt>
                <c:pt idx="115">
                  <c:v>32.079339999999995</c:v>
                </c:pt>
                <c:pt idx="116">
                  <c:v>30.082229999999999</c:v>
                </c:pt>
                <c:pt idx="117">
                  <c:v>28.572960000000002</c:v>
                </c:pt>
                <c:pt idx="118">
                  <c:v>27.49352</c:v>
                </c:pt>
                <c:pt idx="119">
                  <c:v>26.45092</c:v>
                </c:pt>
                <c:pt idx="120">
                  <c:v>26.376204999999999</c:v>
                </c:pt>
                <c:pt idx="121">
                  <c:v>26.353939999999998</c:v>
                </c:pt>
                <c:pt idx="122">
                  <c:v>25.806210000000004</c:v>
                </c:pt>
                <c:pt idx="123">
                  <c:v>25.708304999999999</c:v>
                </c:pt>
                <c:pt idx="124">
                  <c:v>25.267145000000003</c:v>
                </c:pt>
                <c:pt idx="125">
                  <c:v>24.50245</c:v>
                </c:pt>
                <c:pt idx="126">
                  <c:v>23.612920000000003</c:v>
                </c:pt>
                <c:pt idx="127">
                  <c:v>22.762685000000005</c:v>
                </c:pt>
                <c:pt idx="128">
                  <c:v>22.475000000000001</c:v>
                </c:pt>
                <c:pt idx="129">
                  <c:v>22.1077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D7A-4531-A963-DFA7271C65E6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K$17:$CK$146</c:f>
              <c:numCache>
                <c:formatCode>0.00</c:formatCode>
                <c:ptCount val="130"/>
                <c:pt idx="0">
                  <c:v>144.14323999999999</c:v>
                </c:pt>
                <c:pt idx="1">
                  <c:v>120.93636000000001</c:v>
                </c:pt>
                <c:pt idx="2">
                  <c:v>82.398375000000001</c:v>
                </c:pt>
                <c:pt idx="3">
                  <c:v>71.585739999999987</c:v>
                </c:pt>
                <c:pt idx="4">
                  <c:v>64.99228500000001</c:v>
                </c:pt>
                <c:pt idx="5">
                  <c:v>60.609699999999997</c:v>
                </c:pt>
                <c:pt idx="6">
                  <c:v>57.37286499999999</c:v>
                </c:pt>
                <c:pt idx="7">
                  <c:v>54.781424999999999</c:v>
                </c:pt>
                <c:pt idx="8">
                  <c:v>54.780039999999993</c:v>
                </c:pt>
                <c:pt idx="9">
                  <c:v>60.581360000000011</c:v>
                </c:pt>
                <c:pt idx="10">
                  <c:v>68.907089999999997</c:v>
                </c:pt>
                <c:pt idx="11">
                  <c:v>84.170655000000011</c:v>
                </c:pt>
                <c:pt idx="12">
                  <c:v>102.60968999999999</c:v>
                </c:pt>
                <c:pt idx="13">
                  <c:v>121.937905</c:v>
                </c:pt>
                <c:pt idx="14">
                  <c:v>137.78521000000001</c:v>
                </c:pt>
                <c:pt idx="15">
                  <c:v>145.31805500000002</c:v>
                </c:pt>
                <c:pt idx="16">
                  <c:v>145.10856000000001</c:v>
                </c:pt>
                <c:pt idx="17">
                  <c:v>150.05036000000001</c:v>
                </c:pt>
                <c:pt idx="18">
                  <c:v>139.26011</c:v>
                </c:pt>
                <c:pt idx="19">
                  <c:v>122.66746000000001</c:v>
                </c:pt>
                <c:pt idx="20">
                  <c:v>106.05086999999999</c:v>
                </c:pt>
                <c:pt idx="21">
                  <c:v>93.325230000000005</c:v>
                </c:pt>
                <c:pt idx="22">
                  <c:v>82.511485000000008</c:v>
                </c:pt>
                <c:pt idx="23">
                  <c:v>74.728305000000006</c:v>
                </c:pt>
                <c:pt idx="24">
                  <c:v>68.351394999999997</c:v>
                </c:pt>
                <c:pt idx="25">
                  <c:v>63.259155000000007</c:v>
                </c:pt>
                <c:pt idx="26">
                  <c:v>60.519210000000008</c:v>
                </c:pt>
                <c:pt idx="27">
                  <c:v>59.434930000000001</c:v>
                </c:pt>
                <c:pt idx="28">
                  <c:v>61.099294999999998</c:v>
                </c:pt>
                <c:pt idx="29">
                  <c:v>66.046819999999997</c:v>
                </c:pt>
                <c:pt idx="30">
                  <c:v>72.588769999999997</c:v>
                </c:pt>
                <c:pt idx="31">
                  <c:v>80.102835000000013</c:v>
                </c:pt>
                <c:pt idx="32">
                  <c:v>85.62906000000001</c:v>
                </c:pt>
                <c:pt idx="33">
                  <c:v>87.991514999999993</c:v>
                </c:pt>
                <c:pt idx="34">
                  <c:v>85.267399999999995</c:v>
                </c:pt>
                <c:pt idx="35">
                  <c:v>80.029914999999988</c:v>
                </c:pt>
                <c:pt idx="36">
                  <c:v>74.594449999999995</c:v>
                </c:pt>
                <c:pt idx="37">
                  <c:v>70.315299999999993</c:v>
                </c:pt>
                <c:pt idx="38">
                  <c:v>68.083294999999993</c:v>
                </c:pt>
                <c:pt idx="39">
                  <c:v>66.96249499999999</c:v>
                </c:pt>
                <c:pt idx="40">
                  <c:v>65.384685000000005</c:v>
                </c:pt>
                <c:pt idx="41">
                  <c:v>59.212439999999994</c:v>
                </c:pt>
                <c:pt idx="42">
                  <c:v>52.165100000000002</c:v>
                </c:pt>
                <c:pt idx="43">
                  <c:v>48.917079999999999</c:v>
                </c:pt>
                <c:pt idx="44">
                  <c:v>46.187395000000002</c:v>
                </c:pt>
                <c:pt idx="45">
                  <c:v>44.208125000000003</c:v>
                </c:pt>
                <c:pt idx="46">
                  <c:v>44.24906</c:v>
                </c:pt>
                <c:pt idx="47">
                  <c:v>46.505364999999998</c:v>
                </c:pt>
                <c:pt idx="48">
                  <c:v>50.942029999999995</c:v>
                </c:pt>
                <c:pt idx="49">
                  <c:v>54.550980000000003</c:v>
                </c:pt>
                <c:pt idx="50">
                  <c:v>55.096630000000005</c:v>
                </c:pt>
                <c:pt idx="51">
                  <c:v>53.410235000000007</c:v>
                </c:pt>
                <c:pt idx="52">
                  <c:v>50.674500000000002</c:v>
                </c:pt>
                <c:pt idx="53">
                  <c:v>48.394570000000002</c:v>
                </c:pt>
                <c:pt idx="54">
                  <c:v>46.971179999999997</c:v>
                </c:pt>
                <c:pt idx="55">
                  <c:v>46.087210000000006</c:v>
                </c:pt>
                <c:pt idx="56">
                  <c:v>46.132414999999995</c:v>
                </c:pt>
                <c:pt idx="57">
                  <c:v>47.451425</c:v>
                </c:pt>
                <c:pt idx="58">
                  <c:v>48.27769</c:v>
                </c:pt>
                <c:pt idx="59">
                  <c:v>47.674624999999999</c:v>
                </c:pt>
                <c:pt idx="60">
                  <c:v>45.554939999999995</c:v>
                </c:pt>
                <c:pt idx="61">
                  <c:v>43.707054999999997</c:v>
                </c:pt>
                <c:pt idx="62">
                  <c:v>41.514200000000002</c:v>
                </c:pt>
                <c:pt idx="63">
                  <c:v>40.897064999999998</c:v>
                </c:pt>
                <c:pt idx="64">
                  <c:v>41.305419999999998</c:v>
                </c:pt>
                <c:pt idx="65">
                  <c:v>43.761499999999998</c:v>
                </c:pt>
                <c:pt idx="66">
                  <c:v>47.649700000000003</c:v>
                </c:pt>
                <c:pt idx="67">
                  <c:v>49.353380000000001</c:v>
                </c:pt>
                <c:pt idx="68">
                  <c:v>49.654899999999998</c:v>
                </c:pt>
                <c:pt idx="69">
                  <c:v>47.113839999999996</c:v>
                </c:pt>
                <c:pt idx="70">
                  <c:v>44.671250000000001</c:v>
                </c:pt>
                <c:pt idx="71">
                  <c:v>42.698279999999997</c:v>
                </c:pt>
                <c:pt idx="72">
                  <c:v>41.285695000000004</c:v>
                </c:pt>
                <c:pt idx="73">
                  <c:v>40.800139999999999</c:v>
                </c:pt>
                <c:pt idx="74">
                  <c:v>40.798805000000002</c:v>
                </c:pt>
                <c:pt idx="75">
                  <c:v>41.450794999999999</c:v>
                </c:pt>
                <c:pt idx="76">
                  <c:v>41.614360000000005</c:v>
                </c:pt>
                <c:pt idx="77">
                  <c:v>41.975394999999999</c:v>
                </c:pt>
                <c:pt idx="78">
                  <c:v>41.852674999999998</c:v>
                </c:pt>
                <c:pt idx="79">
                  <c:v>41.641639999999995</c:v>
                </c:pt>
                <c:pt idx="80">
                  <c:v>40.846089999999997</c:v>
                </c:pt>
                <c:pt idx="81">
                  <c:v>39.764510000000001</c:v>
                </c:pt>
                <c:pt idx="82">
                  <c:v>39.066364999999998</c:v>
                </c:pt>
                <c:pt idx="83">
                  <c:v>38.610050000000001</c:v>
                </c:pt>
                <c:pt idx="84">
                  <c:v>38.072160000000004</c:v>
                </c:pt>
                <c:pt idx="85">
                  <c:v>38.423394999999999</c:v>
                </c:pt>
                <c:pt idx="86">
                  <c:v>39.428360000000005</c:v>
                </c:pt>
                <c:pt idx="87">
                  <c:v>40.761175000000001</c:v>
                </c:pt>
                <c:pt idx="88">
                  <c:v>41.241339999999994</c:v>
                </c:pt>
                <c:pt idx="89">
                  <c:v>41.166274999999999</c:v>
                </c:pt>
                <c:pt idx="90">
                  <c:v>40.161460000000005</c:v>
                </c:pt>
                <c:pt idx="91">
                  <c:v>37.2941</c:v>
                </c:pt>
                <c:pt idx="92">
                  <c:v>35.789465</c:v>
                </c:pt>
                <c:pt idx="93">
                  <c:v>34.594425000000001</c:v>
                </c:pt>
                <c:pt idx="94">
                  <c:v>34.365825000000001</c:v>
                </c:pt>
                <c:pt idx="95">
                  <c:v>35.062474999999999</c:v>
                </c:pt>
                <c:pt idx="96">
                  <c:v>36.133544999999998</c:v>
                </c:pt>
                <c:pt idx="97">
                  <c:v>37.563520000000004</c:v>
                </c:pt>
                <c:pt idx="98">
                  <c:v>37.545345000000005</c:v>
                </c:pt>
                <c:pt idx="99">
                  <c:v>36.84948</c:v>
                </c:pt>
                <c:pt idx="100">
                  <c:v>35.449179999999998</c:v>
                </c:pt>
                <c:pt idx="101">
                  <c:v>34.306220000000003</c:v>
                </c:pt>
                <c:pt idx="102">
                  <c:v>33.465154999999996</c:v>
                </c:pt>
                <c:pt idx="103">
                  <c:v>33.441660000000006</c:v>
                </c:pt>
                <c:pt idx="104">
                  <c:v>33.708244999999998</c:v>
                </c:pt>
                <c:pt idx="105">
                  <c:v>34.226439999999997</c:v>
                </c:pt>
                <c:pt idx="106">
                  <c:v>34.778514999999999</c:v>
                </c:pt>
                <c:pt idx="107">
                  <c:v>34.955095</c:v>
                </c:pt>
                <c:pt idx="108">
                  <c:v>35.192500000000003</c:v>
                </c:pt>
                <c:pt idx="109">
                  <c:v>35.071739999999998</c:v>
                </c:pt>
                <c:pt idx="110">
                  <c:v>35.299214999999997</c:v>
                </c:pt>
                <c:pt idx="111">
                  <c:v>35.967589999999994</c:v>
                </c:pt>
                <c:pt idx="112">
                  <c:v>35.900295</c:v>
                </c:pt>
                <c:pt idx="113">
                  <c:v>35.687760000000004</c:v>
                </c:pt>
                <c:pt idx="114">
                  <c:v>35.04927</c:v>
                </c:pt>
                <c:pt idx="115">
                  <c:v>27.334539999999997</c:v>
                </c:pt>
                <c:pt idx="116">
                  <c:v>25.89723</c:v>
                </c:pt>
                <c:pt idx="117">
                  <c:v>24.207360000000005</c:v>
                </c:pt>
                <c:pt idx="118">
                  <c:v>22.488020000000002</c:v>
                </c:pt>
                <c:pt idx="119">
                  <c:v>21.300620000000002</c:v>
                </c:pt>
                <c:pt idx="120">
                  <c:v>20.684104999999999</c:v>
                </c:pt>
                <c:pt idx="121">
                  <c:v>20.451639999999998</c:v>
                </c:pt>
                <c:pt idx="122">
                  <c:v>19.791910000000005</c:v>
                </c:pt>
                <c:pt idx="123">
                  <c:v>19.290205</c:v>
                </c:pt>
                <c:pt idx="124">
                  <c:v>18.847845</c:v>
                </c:pt>
                <c:pt idx="125">
                  <c:v>17.986450000000001</c:v>
                </c:pt>
                <c:pt idx="126">
                  <c:v>17.106120000000001</c:v>
                </c:pt>
                <c:pt idx="127">
                  <c:v>16.457385000000002</c:v>
                </c:pt>
                <c:pt idx="128">
                  <c:v>16.209399999999999</c:v>
                </c:pt>
                <c:pt idx="129">
                  <c:v>16.2414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D7A-4531-A963-DFA7271C65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980864"/>
        <c:axId val="66986752"/>
      </c:lineChart>
      <c:catAx>
        <c:axId val="66980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6986752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6986752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69808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F$17:$CF$146</c:f>
              <c:numCache>
                <c:formatCode>0.00</c:formatCode>
                <c:ptCount val="130"/>
                <c:pt idx="0">
                  <c:v>586.57464000000004</c:v>
                </c:pt>
                <c:pt idx="1">
                  <c:v>516.61555999999996</c:v>
                </c:pt>
                <c:pt idx="2">
                  <c:v>386.15247499999998</c:v>
                </c:pt>
                <c:pt idx="3">
                  <c:v>349.85944000000001</c:v>
                </c:pt>
                <c:pt idx="4">
                  <c:v>312.88638500000002</c:v>
                </c:pt>
                <c:pt idx="5">
                  <c:v>279.91539999999998</c:v>
                </c:pt>
                <c:pt idx="6">
                  <c:v>251.13616499999998</c:v>
                </c:pt>
                <c:pt idx="7">
                  <c:v>230.76592500000001</c:v>
                </c:pt>
                <c:pt idx="8">
                  <c:v>213.14463999999998</c:v>
                </c:pt>
                <c:pt idx="9">
                  <c:v>201.39416</c:v>
                </c:pt>
                <c:pt idx="10">
                  <c:v>188.73979</c:v>
                </c:pt>
                <c:pt idx="11">
                  <c:v>179.757555</c:v>
                </c:pt>
                <c:pt idx="12">
                  <c:v>172.56779</c:v>
                </c:pt>
                <c:pt idx="13">
                  <c:v>170.54340500000001</c:v>
                </c:pt>
                <c:pt idx="14">
                  <c:v>170.48581000000001</c:v>
                </c:pt>
                <c:pt idx="15">
                  <c:v>173.694455</c:v>
                </c:pt>
                <c:pt idx="16">
                  <c:v>179.91566</c:v>
                </c:pt>
                <c:pt idx="17">
                  <c:v>197.00646</c:v>
                </c:pt>
                <c:pt idx="18">
                  <c:v>189.84271000000001</c:v>
                </c:pt>
                <c:pt idx="19">
                  <c:v>179.37366</c:v>
                </c:pt>
                <c:pt idx="20">
                  <c:v>169.58556999999999</c:v>
                </c:pt>
                <c:pt idx="21">
                  <c:v>163.47462999999999</c:v>
                </c:pt>
                <c:pt idx="22">
                  <c:v>166.55858500000002</c:v>
                </c:pt>
                <c:pt idx="23">
                  <c:v>175.38460499999999</c:v>
                </c:pt>
                <c:pt idx="24">
                  <c:v>179.34439499999999</c:v>
                </c:pt>
                <c:pt idx="25">
                  <c:v>177.57065500000002</c:v>
                </c:pt>
                <c:pt idx="26">
                  <c:v>170.89831000000001</c:v>
                </c:pt>
                <c:pt idx="27">
                  <c:v>162.42603</c:v>
                </c:pt>
                <c:pt idx="28">
                  <c:v>156.71129500000001</c:v>
                </c:pt>
                <c:pt idx="29">
                  <c:v>154.73661999999999</c:v>
                </c:pt>
                <c:pt idx="30">
                  <c:v>157.63037</c:v>
                </c:pt>
                <c:pt idx="31">
                  <c:v>158.99223500000002</c:v>
                </c:pt>
                <c:pt idx="32">
                  <c:v>159.65786</c:v>
                </c:pt>
                <c:pt idx="33">
                  <c:v>157.67621499999998</c:v>
                </c:pt>
                <c:pt idx="34">
                  <c:v>152.7107</c:v>
                </c:pt>
                <c:pt idx="35">
                  <c:v>146.43711499999998</c:v>
                </c:pt>
                <c:pt idx="36">
                  <c:v>141.29825</c:v>
                </c:pt>
                <c:pt idx="37">
                  <c:v>135.69980000000001</c:v>
                </c:pt>
                <c:pt idx="38">
                  <c:v>134.03339499999998</c:v>
                </c:pt>
                <c:pt idx="39">
                  <c:v>135.92389499999999</c:v>
                </c:pt>
                <c:pt idx="40">
                  <c:v>138.61078500000002</c:v>
                </c:pt>
                <c:pt idx="41">
                  <c:v>130.86913999999999</c:v>
                </c:pt>
                <c:pt idx="42">
                  <c:v>121.904</c:v>
                </c:pt>
                <c:pt idx="43">
                  <c:v>116.80598000000001</c:v>
                </c:pt>
                <c:pt idx="44">
                  <c:v>111.461995</c:v>
                </c:pt>
                <c:pt idx="45">
                  <c:v>106.724825</c:v>
                </c:pt>
                <c:pt idx="46">
                  <c:v>105.03426</c:v>
                </c:pt>
                <c:pt idx="47">
                  <c:v>105.96916499999999</c:v>
                </c:pt>
                <c:pt idx="48">
                  <c:v>105.47033</c:v>
                </c:pt>
                <c:pt idx="49">
                  <c:v>103.86638000000001</c:v>
                </c:pt>
                <c:pt idx="50">
                  <c:v>101.51143</c:v>
                </c:pt>
                <c:pt idx="51">
                  <c:v>98.907835000000006</c:v>
                </c:pt>
                <c:pt idx="52">
                  <c:v>97.690399999999997</c:v>
                </c:pt>
                <c:pt idx="53">
                  <c:v>97.046569999999988</c:v>
                </c:pt>
                <c:pt idx="54">
                  <c:v>96.546880000000002</c:v>
                </c:pt>
                <c:pt idx="55">
                  <c:v>95.357610000000008</c:v>
                </c:pt>
                <c:pt idx="56">
                  <c:v>93.736014999999995</c:v>
                </c:pt>
                <c:pt idx="57">
                  <c:v>91.826425</c:v>
                </c:pt>
                <c:pt idx="58">
                  <c:v>89.876589999999993</c:v>
                </c:pt>
                <c:pt idx="59">
                  <c:v>88.494124999999997</c:v>
                </c:pt>
                <c:pt idx="60">
                  <c:v>88.127839999999992</c:v>
                </c:pt>
                <c:pt idx="61">
                  <c:v>86.949955000000003</c:v>
                </c:pt>
                <c:pt idx="62">
                  <c:v>85.723299999999995</c:v>
                </c:pt>
                <c:pt idx="63">
                  <c:v>85.40326499999999</c:v>
                </c:pt>
                <c:pt idx="64">
                  <c:v>85.291719999999998</c:v>
                </c:pt>
                <c:pt idx="65">
                  <c:v>86.124799999999993</c:v>
                </c:pt>
                <c:pt idx="66">
                  <c:v>85.284700000000001</c:v>
                </c:pt>
                <c:pt idx="67">
                  <c:v>81.71378</c:v>
                </c:pt>
                <c:pt idx="68">
                  <c:v>79.4773</c:v>
                </c:pt>
                <c:pt idx="69">
                  <c:v>77.684639999999987</c:v>
                </c:pt>
                <c:pt idx="70">
                  <c:v>76.955749999999995</c:v>
                </c:pt>
                <c:pt idx="71">
                  <c:v>76.867380000000011</c:v>
                </c:pt>
                <c:pt idx="72">
                  <c:v>77.407595000000001</c:v>
                </c:pt>
                <c:pt idx="73">
                  <c:v>77.814439999999991</c:v>
                </c:pt>
                <c:pt idx="74">
                  <c:v>77.051005000000004</c:v>
                </c:pt>
                <c:pt idx="75">
                  <c:v>75.314494999999994</c:v>
                </c:pt>
                <c:pt idx="76">
                  <c:v>72.748960000000011</c:v>
                </c:pt>
                <c:pt idx="77">
                  <c:v>70.607594999999989</c:v>
                </c:pt>
                <c:pt idx="78">
                  <c:v>68.532674999999998</c:v>
                </c:pt>
                <c:pt idx="79">
                  <c:v>68.099239999999995</c:v>
                </c:pt>
                <c:pt idx="80">
                  <c:v>69.165489999999991</c:v>
                </c:pt>
                <c:pt idx="81">
                  <c:v>69.19371000000001</c:v>
                </c:pt>
                <c:pt idx="82">
                  <c:v>68.943564999999992</c:v>
                </c:pt>
                <c:pt idx="83">
                  <c:v>67.383349999999993</c:v>
                </c:pt>
                <c:pt idx="84">
                  <c:v>65.323460000000011</c:v>
                </c:pt>
                <c:pt idx="85">
                  <c:v>63.130994999999999</c:v>
                </c:pt>
                <c:pt idx="86">
                  <c:v>61.672260000000009</c:v>
                </c:pt>
                <c:pt idx="87">
                  <c:v>61.233775000000001</c:v>
                </c:pt>
                <c:pt idx="88">
                  <c:v>61.395439999999994</c:v>
                </c:pt>
                <c:pt idx="89">
                  <c:v>62.591074999999996</c:v>
                </c:pt>
                <c:pt idx="90">
                  <c:v>62.769160000000007</c:v>
                </c:pt>
                <c:pt idx="91">
                  <c:v>60.378399999999999</c:v>
                </c:pt>
                <c:pt idx="92">
                  <c:v>59.421564999999994</c:v>
                </c:pt>
                <c:pt idx="93">
                  <c:v>58.165125000000003</c:v>
                </c:pt>
                <c:pt idx="94">
                  <c:v>56.890025000000001</c:v>
                </c:pt>
                <c:pt idx="95">
                  <c:v>56.099474999999998</c:v>
                </c:pt>
                <c:pt idx="96">
                  <c:v>55.570144999999997</c:v>
                </c:pt>
                <c:pt idx="97">
                  <c:v>55.746119999999998</c:v>
                </c:pt>
                <c:pt idx="98">
                  <c:v>55.835644999999992</c:v>
                </c:pt>
                <c:pt idx="99">
                  <c:v>55.475980000000007</c:v>
                </c:pt>
                <c:pt idx="100">
                  <c:v>55.040780000000005</c:v>
                </c:pt>
                <c:pt idx="101">
                  <c:v>54.148019999999995</c:v>
                </c:pt>
                <c:pt idx="102">
                  <c:v>53.475455000000004</c:v>
                </c:pt>
                <c:pt idx="103">
                  <c:v>52.221960000000003</c:v>
                </c:pt>
                <c:pt idx="104">
                  <c:v>51.400645000000004</c:v>
                </c:pt>
                <c:pt idx="105">
                  <c:v>51.277839999999998</c:v>
                </c:pt>
                <c:pt idx="106">
                  <c:v>50.974815</c:v>
                </c:pt>
                <c:pt idx="107">
                  <c:v>50.863595000000004</c:v>
                </c:pt>
                <c:pt idx="108">
                  <c:v>50.822800000000001</c:v>
                </c:pt>
                <c:pt idx="109">
                  <c:v>50.835239999999999</c:v>
                </c:pt>
                <c:pt idx="110">
                  <c:v>51.414114999999995</c:v>
                </c:pt>
                <c:pt idx="111">
                  <c:v>51.323389999999996</c:v>
                </c:pt>
                <c:pt idx="112">
                  <c:v>50.091394999999999</c:v>
                </c:pt>
                <c:pt idx="113">
                  <c:v>48.556460000000001</c:v>
                </c:pt>
                <c:pt idx="114">
                  <c:v>46.353569999999998</c:v>
                </c:pt>
                <c:pt idx="115">
                  <c:v>39.173139999999997</c:v>
                </c:pt>
                <c:pt idx="116">
                  <c:v>37.842929999999996</c:v>
                </c:pt>
                <c:pt idx="117">
                  <c:v>36.625060000000005</c:v>
                </c:pt>
                <c:pt idx="118">
                  <c:v>35.342120000000001</c:v>
                </c:pt>
                <c:pt idx="119">
                  <c:v>33.927219999999998</c:v>
                </c:pt>
                <c:pt idx="120">
                  <c:v>32.868204999999996</c:v>
                </c:pt>
                <c:pt idx="121">
                  <c:v>31.707639999999998</c:v>
                </c:pt>
                <c:pt idx="122">
                  <c:v>30.953710000000004</c:v>
                </c:pt>
                <c:pt idx="123">
                  <c:v>30.935704999999999</c:v>
                </c:pt>
                <c:pt idx="124">
                  <c:v>31.048445000000001</c:v>
                </c:pt>
                <c:pt idx="125">
                  <c:v>30.619949999999999</c:v>
                </c:pt>
                <c:pt idx="126">
                  <c:v>29.57752</c:v>
                </c:pt>
                <c:pt idx="127">
                  <c:v>28.284185000000004</c:v>
                </c:pt>
                <c:pt idx="128">
                  <c:v>27.301400000000001</c:v>
                </c:pt>
                <c:pt idx="129">
                  <c:v>26.6814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690-419A-8026-4C0E56CF5EAA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G$17:$CG$146</c:f>
              <c:numCache>
                <c:formatCode>0.00</c:formatCode>
                <c:ptCount val="130"/>
                <c:pt idx="0">
                  <c:v>591.39134000000001</c:v>
                </c:pt>
                <c:pt idx="1">
                  <c:v>522.14395999999999</c:v>
                </c:pt>
                <c:pt idx="2">
                  <c:v>390.965575</c:v>
                </c:pt>
                <c:pt idx="3">
                  <c:v>358.92753999999996</c:v>
                </c:pt>
                <c:pt idx="4">
                  <c:v>328.13518500000004</c:v>
                </c:pt>
                <c:pt idx="5">
                  <c:v>298.27719999999999</c:v>
                </c:pt>
                <c:pt idx="6">
                  <c:v>269.47116499999998</c:v>
                </c:pt>
                <c:pt idx="7">
                  <c:v>246.33002500000001</c:v>
                </c:pt>
                <c:pt idx="8">
                  <c:v>228.50933999999998</c:v>
                </c:pt>
                <c:pt idx="9">
                  <c:v>215.37386000000001</c:v>
                </c:pt>
                <c:pt idx="10">
                  <c:v>210.33479</c:v>
                </c:pt>
                <c:pt idx="11">
                  <c:v>211.91965499999998</c:v>
                </c:pt>
                <c:pt idx="12">
                  <c:v>212.63838999999999</c:v>
                </c:pt>
                <c:pt idx="13">
                  <c:v>214.68560499999998</c:v>
                </c:pt>
                <c:pt idx="14">
                  <c:v>208.32261</c:v>
                </c:pt>
                <c:pt idx="15">
                  <c:v>194.737055</c:v>
                </c:pt>
                <c:pt idx="16">
                  <c:v>183.51706000000001</c:v>
                </c:pt>
                <c:pt idx="17">
                  <c:v>190.99556000000001</c:v>
                </c:pt>
                <c:pt idx="18">
                  <c:v>185.88401000000002</c:v>
                </c:pt>
                <c:pt idx="19">
                  <c:v>189.29026000000002</c:v>
                </c:pt>
                <c:pt idx="20">
                  <c:v>192.88297</c:v>
                </c:pt>
                <c:pt idx="21">
                  <c:v>191.22423000000001</c:v>
                </c:pt>
                <c:pt idx="22">
                  <c:v>185.08908500000001</c:v>
                </c:pt>
                <c:pt idx="23">
                  <c:v>177.013105</c:v>
                </c:pt>
                <c:pt idx="24">
                  <c:v>170.64919499999999</c:v>
                </c:pt>
                <c:pt idx="25">
                  <c:v>170.58165500000001</c:v>
                </c:pt>
                <c:pt idx="26">
                  <c:v>179.61401000000001</c:v>
                </c:pt>
                <c:pt idx="27">
                  <c:v>187.28632999999999</c:v>
                </c:pt>
                <c:pt idx="28">
                  <c:v>188.59399500000001</c:v>
                </c:pt>
                <c:pt idx="29">
                  <c:v>183.33292</c:v>
                </c:pt>
                <c:pt idx="30">
                  <c:v>173.83837</c:v>
                </c:pt>
                <c:pt idx="31">
                  <c:v>161.92173500000001</c:v>
                </c:pt>
                <c:pt idx="32">
                  <c:v>152.18686</c:v>
                </c:pt>
                <c:pt idx="33">
                  <c:v>148.53641499999998</c:v>
                </c:pt>
                <c:pt idx="34">
                  <c:v>152.74340000000001</c:v>
                </c:pt>
                <c:pt idx="35">
                  <c:v>161.57171499999998</c:v>
                </c:pt>
                <c:pt idx="36">
                  <c:v>166.68995000000001</c:v>
                </c:pt>
                <c:pt idx="37">
                  <c:v>166.49959999999999</c:v>
                </c:pt>
                <c:pt idx="38">
                  <c:v>161.43419499999999</c:v>
                </c:pt>
                <c:pt idx="39">
                  <c:v>152.936295</c:v>
                </c:pt>
                <c:pt idx="40">
                  <c:v>143.96148500000001</c:v>
                </c:pt>
                <c:pt idx="41">
                  <c:v>130.22984</c:v>
                </c:pt>
                <c:pt idx="42">
                  <c:v>121.8788</c:v>
                </c:pt>
                <c:pt idx="43">
                  <c:v>123.50948000000001</c:v>
                </c:pt>
                <c:pt idx="44">
                  <c:v>126.618995</c:v>
                </c:pt>
                <c:pt idx="45">
                  <c:v>129.50002499999999</c:v>
                </c:pt>
                <c:pt idx="46">
                  <c:v>129.71116000000001</c:v>
                </c:pt>
                <c:pt idx="47">
                  <c:v>126.22886499999998</c:v>
                </c:pt>
                <c:pt idx="48">
                  <c:v>121.36603000000001</c:v>
                </c:pt>
                <c:pt idx="49">
                  <c:v>115.86388000000001</c:v>
                </c:pt>
                <c:pt idx="50">
                  <c:v>111.88813</c:v>
                </c:pt>
                <c:pt idx="51">
                  <c:v>111.30193500000001</c:v>
                </c:pt>
                <c:pt idx="52">
                  <c:v>111.5642</c:v>
                </c:pt>
                <c:pt idx="53">
                  <c:v>112.21266999999999</c:v>
                </c:pt>
                <c:pt idx="54">
                  <c:v>112.05638</c:v>
                </c:pt>
                <c:pt idx="55">
                  <c:v>109.89831000000001</c:v>
                </c:pt>
                <c:pt idx="56">
                  <c:v>106.41251499999998</c:v>
                </c:pt>
                <c:pt idx="57">
                  <c:v>104.718125</c:v>
                </c:pt>
                <c:pt idx="58">
                  <c:v>101.02418999999999</c:v>
                </c:pt>
                <c:pt idx="59">
                  <c:v>99.252525000000006</c:v>
                </c:pt>
                <c:pt idx="60">
                  <c:v>98.037839999999989</c:v>
                </c:pt>
                <c:pt idx="61">
                  <c:v>95.462254999999999</c:v>
                </c:pt>
                <c:pt idx="62">
                  <c:v>93.609099999999998</c:v>
                </c:pt>
                <c:pt idx="63">
                  <c:v>92.060264999999987</c:v>
                </c:pt>
                <c:pt idx="64">
                  <c:v>90.69601999999999</c:v>
                </c:pt>
                <c:pt idx="65">
                  <c:v>91.871200000000002</c:v>
                </c:pt>
                <c:pt idx="66">
                  <c:v>94.846500000000006</c:v>
                </c:pt>
                <c:pt idx="67">
                  <c:v>95.139480000000006</c:v>
                </c:pt>
                <c:pt idx="68">
                  <c:v>94.243600000000001</c:v>
                </c:pt>
                <c:pt idx="69">
                  <c:v>90.946439999999996</c:v>
                </c:pt>
                <c:pt idx="70">
                  <c:v>88.090350000000001</c:v>
                </c:pt>
                <c:pt idx="71">
                  <c:v>85.988780000000006</c:v>
                </c:pt>
                <c:pt idx="72">
                  <c:v>84.905094999999989</c:v>
                </c:pt>
                <c:pt idx="73">
                  <c:v>85.982039999999984</c:v>
                </c:pt>
                <c:pt idx="74">
                  <c:v>87.867204999999998</c:v>
                </c:pt>
                <c:pt idx="75">
                  <c:v>86.847794999999991</c:v>
                </c:pt>
                <c:pt idx="76">
                  <c:v>84.593860000000006</c:v>
                </c:pt>
                <c:pt idx="77">
                  <c:v>81.979495</c:v>
                </c:pt>
                <c:pt idx="78">
                  <c:v>79.891975000000002</c:v>
                </c:pt>
                <c:pt idx="79">
                  <c:v>78.491339999999994</c:v>
                </c:pt>
                <c:pt idx="80">
                  <c:v>77.146289999999993</c:v>
                </c:pt>
                <c:pt idx="81">
                  <c:v>77.232010000000002</c:v>
                </c:pt>
                <c:pt idx="82">
                  <c:v>78.481764999999996</c:v>
                </c:pt>
                <c:pt idx="83">
                  <c:v>79.953850000000003</c:v>
                </c:pt>
                <c:pt idx="84">
                  <c:v>78.31786000000001</c:v>
                </c:pt>
                <c:pt idx="85">
                  <c:v>75.320194999999998</c:v>
                </c:pt>
                <c:pt idx="86">
                  <c:v>72.587860000000006</c:v>
                </c:pt>
                <c:pt idx="87">
                  <c:v>71.239175000000003</c:v>
                </c:pt>
                <c:pt idx="88">
                  <c:v>69.822339999999997</c:v>
                </c:pt>
                <c:pt idx="89">
                  <c:v>69.111675000000005</c:v>
                </c:pt>
                <c:pt idx="90">
                  <c:v>68.78916000000001</c:v>
                </c:pt>
                <c:pt idx="91">
                  <c:v>66.717100000000002</c:v>
                </c:pt>
                <c:pt idx="92">
                  <c:v>65.864764999999991</c:v>
                </c:pt>
                <c:pt idx="93">
                  <c:v>65.161024999999995</c:v>
                </c:pt>
                <c:pt idx="94">
                  <c:v>65.806524999999993</c:v>
                </c:pt>
                <c:pt idx="95">
                  <c:v>67.185575</c:v>
                </c:pt>
                <c:pt idx="96">
                  <c:v>67.845244999999991</c:v>
                </c:pt>
                <c:pt idx="97">
                  <c:v>67.213819999999998</c:v>
                </c:pt>
                <c:pt idx="98">
                  <c:v>65.555644999999998</c:v>
                </c:pt>
                <c:pt idx="99">
                  <c:v>63.795880000000004</c:v>
                </c:pt>
                <c:pt idx="100">
                  <c:v>61.887580000000007</c:v>
                </c:pt>
                <c:pt idx="101">
                  <c:v>61.131119999999996</c:v>
                </c:pt>
                <c:pt idx="102">
                  <c:v>60.936955000000005</c:v>
                </c:pt>
                <c:pt idx="103">
                  <c:v>60.292660000000012</c:v>
                </c:pt>
                <c:pt idx="104">
                  <c:v>59.451744999999995</c:v>
                </c:pt>
                <c:pt idx="105">
                  <c:v>59.779839999999993</c:v>
                </c:pt>
                <c:pt idx="106">
                  <c:v>60.251614999999994</c:v>
                </c:pt>
                <c:pt idx="107">
                  <c:v>60.096494999999997</c:v>
                </c:pt>
                <c:pt idx="108">
                  <c:v>60.192700000000002</c:v>
                </c:pt>
                <c:pt idx="109">
                  <c:v>59.604739999999993</c:v>
                </c:pt>
                <c:pt idx="110">
                  <c:v>59.116714999999992</c:v>
                </c:pt>
                <c:pt idx="111">
                  <c:v>58.09738999999999</c:v>
                </c:pt>
                <c:pt idx="112">
                  <c:v>57.353494999999995</c:v>
                </c:pt>
                <c:pt idx="113">
                  <c:v>57.212860000000006</c:v>
                </c:pt>
                <c:pt idx="114">
                  <c:v>56.697269999999996</c:v>
                </c:pt>
                <c:pt idx="115">
                  <c:v>48.288939999999997</c:v>
                </c:pt>
                <c:pt idx="116">
                  <c:v>46.788930000000001</c:v>
                </c:pt>
                <c:pt idx="117">
                  <c:v>45.494160000000001</c:v>
                </c:pt>
                <c:pt idx="118">
                  <c:v>44.395720000000004</c:v>
                </c:pt>
                <c:pt idx="119">
                  <c:v>42.525320000000001</c:v>
                </c:pt>
                <c:pt idx="120">
                  <c:v>41.158904999999997</c:v>
                </c:pt>
                <c:pt idx="121">
                  <c:v>39.909139999999994</c:v>
                </c:pt>
                <c:pt idx="122">
                  <c:v>38.221510000000002</c:v>
                </c:pt>
                <c:pt idx="123">
                  <c:v>37.691904999999998</c:v>
                </c:pt>
                <c:pt idx="124">
                  <c:v>36.845345000000002</c:v>
                </c:pt>
                <c:pt idx="125">
                  <c:v>35.964950000000002</c:v>
                </c:pt>
                <c:pt idx="126">
                  <c:v>34.926320000000004</c:v>
                </c:pt>
                <c:pt idx="127">
                  <c:v>34.601885000000003</c:v>
                </c:pt>
                <c:pt idx="128">
                  <c:v>34.489400000000003</c:v>
                </c:pt>
                <c:pt idx="129">
                  <c:v>33.703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690-419A-8026-4C0E56CF5EAA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H$17:$CH$146</c:f>
              <c:numCache>
                <c:formatCode>0.00</c:formatCode>
                <c:ptCount val="130"/>
                <c:pt idx="0">
                  <c:v>585.64624000000003</c:v>
                </c:pt>
                <c:pt idx="1">
                  <c:v>505.66175999999996</c:v>
                </c:pt>
                <c:pt idx="2">
                  <c:v>365.55817500000001</c:v>
                </c:pt>
                <c:pt idx="3">
                  <c:v>335.28764000000001</c:v>
                </c:pt>
                <c:pt idx="4">
                  <c:v>297.66518500000001</c:v>
                </c:pt>
                <c:pt idx="5">
                  <c:v>253.1155</c:v>
                </c:pt>
                <c:pt idx="6">
                  <c:v>218.813165</c:v>
                </c:pt>
                <c:pt idx="7">
                  <c:v>201.90892500000001</c:v>
                </c:pt>
                <c:pt idx="8">
                  <c:v>194.65073999999998</c:v>
                </c:pt>
                <c:pt idx="9">
                  <c:v>194.49516</c:v>
                </c:pt>
                <c:pt idx="10">
                  <c:v>192.38988999999998</c:v>
                </c:pt>
                <c:pt idx="11">
                  <c:v>191.475955</c:v>
                </c:pt>
                <c:pt idx="12">
                  <c:v>179.66998999999998</c:v>
                </c:pt>
                <c:pt idx="13">
                  <c:v>164.98220499999999</c:v>
                </c:pt>
                <c:pt idx="14">
                  <c:v>154.13161000000002</c:v>
                </c:pt>
                <c:pt idx="15">
                  <c:v>147.70585500000001</c:v>
                </c:pt>
                <c:pt idx="16">
                  <c:v>153.80556000000001</c:v>
                </c:pt>
                <c:pt idx="17">
                  <c:v>181.05636000000001</c:v>
                </c:pt>
                <c:pt idx="18">
                  <c:v>191.12911</c:v>
                </c:pt>
                <c:pt idx="19">
                  <c:v>191.33416</c:v>
                </c:pt>
                <c:pt idx="20">
                  <c:v>182.91856999999999</c:v>
                </c:pt>
                <c:pt idx="21">
                  <c:v>168.73842999999999</c:v>
                </c:pt>
                <c:pt idx="22">
                  <c:v>157.55348500000002</c:v>
                </c:pt>
                <c:pt idx="23">
                  <c:v>154.66350500000001</c:v>
                </c:pt>
                <c:pt idx="24">
                  <c:v>161.52489499999999</c:v>
                </c:pt>
                <c:pt idx="25">
                  <c:v>171.97025500000001</c:v>
                </c:pt>
                <c:pt idx="26">
                  <c:v>177.80781000000002</c:v>
                </c:pt>
                <c:pt idx="27">
                  <c:v>175.88493</c:v>
                </c:pt>
                <c:pt idx="28">
                  <c:v>169.20909499999999</c:v>
                </c:pt>
                <c:pt idx="29">
                  <c:v>158.51061999999999</c:v>
                </c:pt>
                <c:pt idx="30">
                  <c:v>151.32667000000001</c:v>
                </c:pt>
                <c:pt idx="31">
                  <c:v>149.05553500000002</c:v>
                </c:pt>
                <c:pt idx="32">
                  <c:v>151.29676000000001</c:v>
                </c:pt>
                <c:pt idx="33">
                  <c:v>157.27321499999999</c:v>
                </c:pt>
                <c:pt idx="34">
                  <c:v>159.62700000000001</c:v>
                </c:pt>
                <c:pt idx="35">
                  <c:v>159.34411499999999</c:v>
                </c:pt>
                <c:pt idx="36">
                  <c:v>154.48724999999999</c:v>
                </c:pt>
                <c:pt idx="37">
                  <c:v>147.1978</c:v>
                </c:pt>
                <c:pt idx="38">
                  <c:v>140.59349499999999</c:v>
                </c:pt>
                <c:pt idx="39">
                  <c:v>136.88939500000001</c:v>
                </c:pt>
                <c:pt idx="40">
                  <c:v>135.801985</c:v>
                </c:pt>
                <c:pt idx="41">
                  <c:v>130.02014</c:v>
                </c:pt>
                <c:pt idx="42">
                  <c:v>124.9823</c:v>
                </c:pt>
                <c:pt idx="43">
                  <c:v>122.65368000000001</c:v>
                </c:pt>
                <c:pt idx="44">
                  <c:v>119.891595</c:v>
                </c:pt>
                <c:pt idx="45">
                  <c:v>115.735625</c:v>
                </c:pt>
                <c:pt idx="46">
                  <c:v>112.61866000000001</c:v>
                </c:pt>
                <c:pt idx="47">
                  <c:v>112.29886499999999</c:v>
                </c:pt>
                <c:pt idx="48">
                  <c:v>111.54463</c:v>
                </c:pt>
                <c:pt idx="49">
                  <c:v>109.60748000000001</c:v>
                </c:pt>
                <c:pt idx="50">
                  <c:v>107.25233</c:v>
                </c:pt>
                <c:pt idx="51">
                  <c:v>103.25563500000001</c:v>
                </c:pt>
                <c:pt idx="52">
                  <c:v>98.805499999999995</c:v>
                </c:pt>
                <c:pt idx="53">
                  <c:v>96.911569999999998</c:v>
                </c:pt>
                <c:pt idx="54">
                  <c:v>96.424880000000002</c:v>
                </c:pt>
                <c:pt idx="55">
                  <c:v>99.391210000000015</c:v>
                </c:pt>
                <c:pt idx="56">
                  <c:v>103.39321499999998</c:v>
                </c:pt>
                <c:pt idx="57">
                  <c:v>102.143925</c:v>
                </c:pt>
                <c:pt idx="58">
                  <c:v>98.644989999999993</c:v>
                </c:pt>
                <c:pt idx="59">
                  <c:v>95.140424999999993</c:v>
                </c:pt>
                <c:pt idx="60">
                  <c:v>91.091639999999984</c:v>
                </c:pt>
                <c:pt idx="61">
                  <c:v>88.448655000000002</c:v>
                </c:pt>
                <c:pt idx="62">
                  <c:v>86.176599999999993</c:v>
                </c:pt>
                <c:pt idx="63">
                  <c:v>84.770164999999992</c:v>
                </c:pt>
                <c:pt idx="64">
                  <c:v>83.580719999999999</c:v>
                </c:pt>
                <c:pt idx="65">
                  <c:v>83.522999999999996</c:v>
                </c:pt>
                <c:pt idx="66">
                  <c:v>83.863799999999998</c:v>
                </c:pt>
                <c:pt idx="67">
                  <c:v>82.539280000000005</c:v>
                </c:pt>
                <c:pt idx="68">
                  <c:v>82.466300000000004</c:v>
                </c:pt>
                <c:pt idx="69">
                  <c:v>81.945639999999997</c:v>
                </c:pt>
                <c:pt idx="70">
                  <c:v>80.818049999999999</c:v>
                </c:pt>
                <c:pt idx="71">
                  <c:v>79.16028</c:v>
                </c:pt>
                <c:pt idx="72">
                  <c:v>77.938494999999989</c:v>
                </c:pt>
                <c:pt idx="73">
                  <c:v>76.275539999999992</c:v>
                </c:pt>
                <c:pt idx="74">
                  <c:v>75.060305</c:v>
                </c:pt>
                <c:pt idx="75">
                  <c:v>74.219894999999994</c:v>
                </c:pt>
                <c:pt idx="76">
                  <c:v>73.552060000000012</c:v>
                </c:pt>
                <c:pt idx="77">
                  <c:v>72.488495</c:v>
                </c:pt>
                <c:pt idx="78">
                  <c:v>72.374174999999994</c:v>
                </c:pt>
                <c:pt idx="79">
                  <c:v>70.967139999999986</c:v>
                </c:pt>
                <c:pt idx="80">
                  <c:v>69.229289999999992</c:v>
                </c:pt>
                <c:pt idx="81">
                  <c:v>67.535210000000006</c:v>
                </c:pt>
                <c:pt idx="82">
                  <c:v>67.071264999999997</c:v>
                </c:pt>
                <c:pt idx="83">
                  <c:v>66.897450000000006</c:v>
                </c:pt>
                <c:pt idx="84">
                  <c:v>66.133160000000004</c:v>
                </c:pt>
                <c:pt idx="85">
                  <c:v>65.528894999999991</c:v>
                </c:pt>
                <c:pt idx="86">
                  <c:v>64.770260000000007</c:v>
                </c:pt>
                <c:pt idx="87">
                  <c:v>63.984175</c:v>
                </c:pt>
                <c:pt idx="88">
                  <c:v>62.941939999999988</c:v>
                </c:pt>
                <c:pt idx="89">
                  <c:v>61.938775</c:v>
                </c:pt>
                <c:pt idx="90">
                  <c:v>61.35916000000001</c:v>
                </c:pt>
                <c:pt idx="91">
                  <c:v>58.907200000000003</c:v>
                </c:pt>
                <c:pt idx="92">
                  <c:v>59.122364999999988</c:v>
                </c:pt>
                <c:pt idx="93">
                  <c:v>59.907125000000001</c:v>
                </c:pt>
                <c:pt idx="94">
                  <c:v>59.907325</c:v>
                </c:pt>
                <c:pt idx="95">
                  <c:v>59.270775</c:v>
                </c:pt>
                <c:pt idx="96">
                  <c:v>57.932144999999998</c:v>
                </c:pt>
                <c:pt idx="97">
                  <c:v>57.070719999999994</c:v>
                </c:pt>
                <c:pt idx="98">
                  <c:v>56.189144999999996</c:v>
                </c:pt>
                <c:pt idx="99">
                  <c:v>55.576480000000004</c:v>
                </c:pt>
                <c:pt idx="100">
                  <c:v>55.368280000000006</c:v>
                </c:pt>
                <c:pt idx="101">
                  <c:v>55.196719999999992</c:v>
                </c:pt>
                <c:pt idx="102">
                  <c:v>54.786655000000003</c:v>
                </c:pt>
                <c:pt idx="103">
                  <c:v>54.472560000000009</c:v>
                </c:pt>
                <c:pt idx="104">
                  <c:v>53.904244999999996</c:v>
                </c:pt>
                <c:pt idx="105">
                  <c:v>54.35593999999999</c:v>
                </c:pt>
                <c:pt idx="106">
                  <c:v>55.606514999999987</c:v>
                </c:pt>
                <c:pt idx="107">
                  <c:v>57.977994999999993</c:v>
                </c:pt>
                <c:pt idx="108">
                  <c:v>56.788600000000002</c:v>
                </c:pt>
                <c:pt idx="109">
                  <c:v>57.10293999999999</c:v>
                </c:pt>
                <c:pt idx="110">
                  <c:v>57.040614999999988</c:v>
                </c:pt>
                <c:pt idx="111">
                  <c:v>56.067189999999989</c:v>
                </c:pt>
                <c:pt idx="112">
                  <c:v>53.998494999999998</c:v>
                </c:pt>
                <c:pt idx="113">
                  <c:v>52.312960000000004</c:v>
                </c:pt>
                <c:pt idx="114">
                  <c:v>51.043669999999999</c:v>
                </c:pt>
                <c:pt idx="115">
                  <c:v>43.651339999999998</c:v>
                </c:pt>
                <c:pt idx="116">
                  <c:v>42.315529999999995</c:v>
                </c:pt>
                <c:pt idx="117">
                  <c:v>41.37856</c:v>
                </c:pt>
                <c:pt idx="118">
                  <c:v>39.652920000000002</c:v>
                </c:pt>
                <c:pt idx="119">
                  <c:v>37.92962</c:v>
                </c:pt>
                <c:pt idx="120">
                  <c:v>36.290905000000002</c:v>
                </c:pt>
                <c:pt idx="121">
                  <c:v>34.587139999999998</c:v>
                </c:pt>
                <c:pt idx="122">
                  <c:v>33.023110000000003</c:v>
                </c:pt>
                <c:pt idx="123">
                  <c:v>32.237805000000002</c:v>
                </c:pt>
                <c:pt idx="124">
                  <c:v>31.782845000000002</c:v>
                </c:pt>
                <c:pt idx="125">
                  <c:v>31.05735</c:v>
                </c:pt>
                <c:pt idx="126">
                  <c:v>30.47082</c:v>
                </c:pt>
                <c:pt idx="127">
                  <c:v>29.452285000000003</c:v>
                </c:pt>
                <c:pt idx="128">
                  <c:v>28.546600000000002</c:v>
                </c:pt>
                <c:pt idx="129">
                  <c:v>28.1047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690-419A-8026-4C0E56CF5E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7003904"/>
        <c:axId val="67005440"/>
      </c:lineChart>
      <c:catAx>
        <c:axId val="67003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7005440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7005440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70039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O$17:$CO$146</c:f>
              <c:numCache>
                <c:formatCode>0.00</c:formatCode>
                <c:ptCount val="130"/>
                <c:pt idx="0">
                  <c:v>43.935389999999998</c:v>
                </c:pt>
                <c:pt idx="1">
                  <c:v>46.742389999999993</c:v>
                </c:pt>
                <c:pt idx="2">
                  <c:v>44.898454999999998</c:v>
                </c:pt>
                <c:pt idx="3">
                  <c:v>42.469110000000001</c:v>
                </c:pt>
                <c:pt idx="4">
                  <c:v>38.936504999999997</c:v>
                </c:pt>
                <c:pt idx="5">
                  <c:v>36.743670000000002</c:v>
                </c:pt>
                <c:pt idx="6">
                  <c:v>37.176695000000002</c:v>
                </c:pt>
                <c:pt idx="7">
                  <c:v>37.988764999999994</c:v>
                </c:pt>
                <c:pt idx="8">
                  <c:v>42.020485000000001</c:v>
                </c:pt>
                <c:pt idx="9">
                  <c:v>52.718680000000006</c:v>
                </c:pt>
                <c:pt idx="10">
                  <c:v>79.894805000000005</c:v>
                </c:pt>
                <c:pt idx="11">
                  <c:v>118.37405</c:v>
                </c:pt>
                <c:pt idx="12">
                  <c:v>167.48492999999999</c:v>
                </c:pt>
                <c:pt idx="13">
                  <c:v>211.84302000000002</c:v>
                </c:pt>
                <c:pt idx="14">
                  <c:v>235.50574</c:v>
                </c:pt>
                <c:pt idx="15">
                  <c:v>230.77473999999998</c:v>
                </c:pt>
                <c:pt idx="16">
                  <c:v>207.21576999999999</c:v>
                </c:pt>
                <c:pt idx="17">
                  <c:v>182.050535</c:v>
                </c:pt>
                <c:pt idx="18">
                  <c:v>165.002745</c:v>
                </c:pt>
                <c:pt idx="19">
                  <c:v>155.327415</c:v>
                </c:pt>
                <c:pt idx="20">
                  <c:v>146.05920499999999</c:v>
                </c:pt>
                <c:pt idx="21">
                  <c:v>137.07058500000002</c:v>
                </c:pt>
                <c:pt idx="22">
                  <c:v>128.721385</c:v>
                </c:pt>
                <c:pt idx="23">
                  <c:v>121.19136499999999</c:v>
                </c:pt>
                <c:pt idx="24">
                  <c:v>121.23752500000001</c:v>
                </c:pt>
                <c:pt idx="25">
                  <c:v>128.12323000000001</c:v>
                </c:pt>
                <c:pt idx="26">
                  <c:v>141.96468000000002</c:v>
                </c:pt>
                <c:pt idx="27">
                  <c:v>153.70694</c:v>
                </c:pt>
                <c:pt idx="28">
                  <c:v>164.967905</c:v>
                </c:pt>
                <c:pt idx="29">
                  <c:v>180.58548999999999</c:v>
                </c:pt>
                <c:pt idx="30">
                  <c:v>192.75761499999999</c:v>
                </c:pt>
                <c:pt idx="31">
                  <c:v>187.40038999999999</c:v>
                </c:pt>
                <c:pt idx="32">
                  <c:v>169.935225</c:v>
                </c:pt>
                <c:pt idx="33">
                  <c:v>150.02593000000002</c:v>
                </c:pt>
                <c:pt idx="34">
                  <c:v>127.6587</c:v>
                </c:pt>
                <c:pt idx="35">
                  <c:v>108.1566</c:v>
                </c:pt>
                <c:pt idx="36">
                  <c:v>90.953785000000011</c:v>
                </c:pt>
                <c:pt idx="37">
                  <c:v>79.237344999999991</c:v>
                </c:pt>
                <c:pt idx="38">
                  <c:v>75.704439999999991</c:v>
                </c:pt>
                <c:pt idx="39">
                  <c:v>79.245210000000014</c:v>
                </c:pt>
                <c:pt idx="40">
                  <c:v>90.938939999999988</c:v>
                </c:pt>
                <c:pt idx="41">
                  <c:v>107.67886499999999</c:v>
                </c:pt>
                <c:pt idx="42">
                  <c:v>125.06875500000001</c:v>
                </c:pt>
                <c:pt idx="43">
                  <c:v>141.155215</c:v>
                </c:pt>
                <c:pt idx="44">
                  <c:v>146.99217999999999</c:v>
                </c:pt>
                <c:pt idx="45">
                  <c:v>147.20281</c:v>
                </c:pt>
                <c:pt idx="46">
                  <c:v>143.36626000000001</c:v>
                </c:pt>
                <c:pt idx="47">
                  <c:v>136.639285</c:v>
                </c:pt>
                <c:pt idx="48">
                  <c:v>125.05195500000001</c:v>
                </c:pt>
                <c:pt idx="49">
                  <c:v>112.03555</c:v>
                </c:pt>
                <c:pt idx="50">
                  <c:v>100.509185</c:v>
                </c:pt>
                <c:pt idx="51">
                  <c:v>91.288825000000003</c:v>
                </c:pt>
                <c:pt idx="52">
                  <c:v>85.615549999999999</c:v>
                </c:pt>
                <c:pt idx="53">
                  <c:v>82.957985000000008</c:v>
                </c:pt>
                <c:pt idx="54">
                  <c:v>81.954744999999988</c:v>
                </c:pt>
                <c:pt idx="55">
                  <c:v>85.58502</c:v>
                </c:pt>
                <c:pt idx="56">
                  <c:v>93.754114999999985</c:v>
                </c:pt>
                <c:pt idx="57">
                  <c:v>104.13603500000001</c:v>
                </c:pt>
                <c:pt idx="58">
                  <c:v>114.698375</c:v>
                </c:pt>
                <c:pt idx="59">
                  <c:v>124.14601499999999</c:v>
                </c:pt>
                <c:pt idx="60">
                  <c:v>132.37417500000001</c:v>
                </c:pt>
                <c:pt idx="61">
                  <c:v>133.22824</c:v>
                </c:pt>
                <c:pt idx="62">
                  <c:v>128.14228</c:v>
                </c:pt>
                <c:pt idx="63">
                  <c:v>120.80322</c:v>
                </c:pt>
                <c:pt idx="64">
                  <c:v>109.43653500000001</c:v>
                </c:pt>
                <c:pt idx="65">
                  <c:v>97.88425500000001</c:v>
                </c:pt>
                <c:pt idx="66">
                  <c:v>87.590814999999992</c:v>
                </c:pt>
                <c:pt idx="67">
                  <c:v>79.506979999999999</c:v>
                </c:pt>
                <c:pt idx="68">
                  <c:v>75.508075000000005</c:v>
                </c:pt>
                <c:pt idx="69">
                  <c:v>74.681719999999999</c:v>
                </c:pt>
                <c:pt idx="70">
                  <c:v>76.867244999999997</c:v>
                </c:pt>
                <c:pt idx="71">
                  <c:v>82.07726000000001</c:v>
                </c:pt>
                <c:pt idx="72">
                  <c:v>89.725519999999989</c:v>
                </c:pt>
                <c:pt idx="73">
                  <c:v>98.078555000000009</c:v>
                </c:pt>
                <c:pt idx="74">
                  <c:v>105.60563</c:v>
                </c:pt>
                <c:pt idx="75">
                  <c:v>110.68602</c:v>
                </c:pt>
                <c:pt idx="76">
                  <c:v>112.50741499999999</c:v>
                </c:pt>
                <c:pt idx="77">
                  <c:v>112.10672</c:v>
                </c:pt>
                <c:pt idx="78">
                  <c:v>108.64868999999999</c:v>
                </c:pt>
                <c:pt idx="79">
                  <c:v>102.44182499999999</c:v>
                </c:pt>
                <c:pt idx="80">
                  <c:v>94.530705000000012</c:v>
                </c:pt>
                <c:pt idx="81">
                  <c:v>86.861144999999993</c:v>
                </c:pt>
                <c:pt idx="82">
                  <c:v>79.807994999999991</c:v>
                </c:pt>
                <c:pt idx="83">
                  <c:v>74.255369999999999</c:v>
                </c:pt>
                <c:pt idx="84">
                  <c:v>71.361969999999999</c:v>
                </c:pt>
                <c:pt idx="85">
                  <c:v>70.726539999999986</c:v>
                </c:pt>
                <c:pt idx="86">
                  <c:v>73.472960000000015</c:v>
                </c:pt>
                <c:pt idx="87">
                  <c:v>76.871300000000005</c:v>
                </c:pt>
                <c:pt idx="88">
                  <c:v>82.918800000000005</c:v>
                </c:pt>
                <c:pt idx="89">
                  <c:v>88.977164999999985</c:v>
                </c:pt>
                <c:pt idx="90">
                  <c:v>92.246810000000011</c:v>
                </c:pt>
                <c:pt idx="91">
                  <c:v>92.363680000000002</c:v>
                </c:pt>
                <c:pt idx="92">
                  <c:v>89.709885000000014</c:v>
                </c:pt>
                <c:pt idx="93">
                  <c:v>84.947735000000009</c:v>
                </c:pt>
                <c:pt idx="94">
                  <c:v>78.852694999999997</c:v>
                </c:pt>
                <c:pt idx="95">
                  <c:v>72.572955000000007</c:v>
                </c:pt>
                <c:pt idx="96">
                  <c:v>67.157464999999988</c:v>
                </c:pt>
                <c:pt idx="97">
                  <c:v>62.41073500000001</c:v>
                </c:pt>
                <c:pt idx="98">
                  <c:v>59.667880000000004</c:v>
                </c:pt>
                <c:pt idx="99">
                  <c:v>58.513769999999994</c:v>
                </c:pt>
                <c:pt idx="100">
                  <c:v>59.512300000000003</c:v>
                </c:pt>
                <c:pt idx="101">
                  <c:v>61.76326000000001</c:v>
                </c:pt>
                <c:pt idx="102">
                  <c:v>65.82898999999999</c:v>
                </c:pt>
                <c:pt idx="103">
                  <c:v>69.142330000000001</c:v>
                </c:pt>
                <c:pt idx="104">
                  <c:v>72.216025000000002</c:v>
                </c:pt>
                <c:pt idx="105">
                  <c:v>73.839839999999995</c:v>
                </c:pt>
                <c:pt idx="106">
                  <c:v>74.33500500000001</c:v>
                </c:pt>
                <c:pt idx="107">
                  <c:v>72.217169999999996</c:v>
                </c:pt>
                <c:pt idx="108">
                  <c:v>69.055510000000012</c:v>
                </c:pt>
                <c:pt idx="109">
                  <c:v>64.837639999999993</c:v>
                </c:pt>
                <c:pt idx="110">
                  <c:v>60.204485000000012</c:v>
                </c:pt>
                <c:pt idx="111">
                  <c:v>55.891944999999993</c:v>
                </c:pt>
                <c:pt idx="112">
                  <c:v>52.456164999999991</c:v>
                </c:pt>
                <c:pt idx="113">
                  <c:v>50.437604999999998</c:v>
                </c:pt>
                <c:pt idx="114">
                  <c:v>49.950764999999997</c:v>
                </c:pt>
                <c:pt idx="115">
                  <c:v>50.645314999999997</c:v>
                </c:pt>
                <c:pt idx="116">
                  <c:v>52.851700000000001</c:v>
                </c:pt>
                <c:pt idx="117">
                  <c:v>55.344460000000012</c:v>
                </c:pt>
                <c:pt idx="118">
                  <c:v>57.533369999999998</c:v>
                </c:pt>
                <c:pt idx="119">
                  <c:v>58.892049999999998</c:v>
                </c:pt>
                <c:pt idx="120">
                  <c:v>58.800424999999997</c:v>
                </c:pt>
                <c:pt idx="121">
                  <c:v>57.780439999999992</c:v>
                </c:pt>
                <c:pt idx="122">
                  <c:v>55.958969999999994</c:v>
                </c:pt>
                <c:pt idx="123">
                  <c:v>53.133249999999997</c:v>
                </c:pt>
                <c:pt idx="124">
                  <c:v>48.160960000000003</c:v>
                </c:pt>
                <c:pt idx="125">
                  <c:v>46.618899999999996</c:v>
                </c:pt>
                <c:pt idx="126">
                  <c:v>43.922730000000001</c:v>
                </c:pt>
                <c:pt idx="127">
                  <c:v>41.892150000000001</c:v>
                </c:pt>
                <c:pt idx="128">
                  <c:v>40.532724999999999</c:v>
                </c:pt>
                <c:pt idx="129">
                  <c:v>40.291435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816-4E76-B990-3136AA94A77E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P$17:$CP$146</c:f>
              <c:numCache>
                <c:formatCode>0.00</c:formatCode>
                <c:ptCount val="130"/>
                <c:pt idx="0">
                  <c:v>33.399389999999997</c:v>
                </c:pt>
                <c:pt idx="1">
                  <c:v>37.950589999999998</c:v>
                </c:pt>
                <c:pt idx="2">
                  <c:v>38.520854999999997</c:v>
                </c:pt>
                <c:pt idx="3">
                  <c:v>39.19191</c:v>
                </c:pt>
                <c:pt idx="4">
                  <c:v>39.671804999999999</c:v>
                </c:pt>
                <c:pt idx="5">
                  <c:v>39.313569999999999</c:v>
                </c:pt>
                <c:pt idx="6">
                  <c:v>37.022095</c:v>
                </c:pt>
                <c:pt idx="7">
                  <c:v>35.909464999999997</c:v>
                </c:pt>
                <c:pt idx="8">
                  <c:v>38.168985000000006</c:v>
                </c:pt>
                <c:pt idx="9">
                  <c:v>47.987879999999997</c:v>
                </c:pt>
                <c:pt idx="10">
                  <c:v>66.227204999999998</c:v>
                </c:pt>
                <c:pt idx="11">
                  <c:v>97.212450000000004</c:v>
                </c:pt>
                <c:pt idx="12">
                  <c:v>143.40452999999999</c:v>
                </c:pt>
                <c:pt idx="13">
                  <c:v>184.29401999999999</c:v>
                </c:pt>
                <c:pt idx="14">
                  <c:v>205.54764</c:v>
                </c:pt>
                <c:pt idx="15">
                  <c:v>207.81804</c:v>
                </c:pt>
                <c:pt idx="16">
                  <c:v>195.95106999999999</c:v>
                </c:pt>
                <c:pt idx="17">
                  <c:v>178.70343500000001</c:v>
                </c:pt>
                <c:pt idx="18">
                  <c:v>162.46954499999998</c:v>
                </c:pt>
                <c:pt idx="19">
                  <c:v>148.989215</c:v>
                </c:pt>
                <c:pt idx="20">
                  <c:v>136.920005</c:v>
                </c:pt>
                <c:pt idx="21">
                  <c:v>125.27428500000001</c:v>
                </c:pt>
                <c:pt idx="22">
                  <c:v>116.721985</c:v>
                </c:pt>
                <c:pt idx="23">
                  <c:v>113.04586499999999</c:v>
                </c:pt>
                <c:pt idx="24">
                  <c:v>119.091325</c:v>
                </c:pt>
                <c:pt idx="25">
                  <c:v>130.17693</c:v>
                </c:pt>
                <c:pt idx="26">
                  <c:v>145.46917999999999</c:v>
                </c:pt>
                <c:pt idx="27">
                  <c:v>162.97363999999999</c:v>
                </c:pt>
                <c:pt idx="28">
                  <c:v>178.00240500000001</c:v>
                </c:pt>
                <c:pt idx="29">
                  <c:v>189.15089</c:v>
                </c:pt>
                <c:pt idx="30">
                  <c:v>191.30481499999999</c:v>
                </c:pt>
                <c:pt idx="31">
                  <c:v>182.72308999999998</c:v>
                </c:pt>
                <c:pt idx="32">
                  <c:v>166.00752499999999</c:v>
                </c:pt>
                <c:pt idx="33">
                  <c:v>145.74083000000002</c:v>
                </c:pt>
                <c:pt idx="34">
                  <c:v>124.8061</c:v>
                </c:pt>
                <c:pt idx="35">
                  <c:v>104.9271</c:v>
                </c:pt>
                <c:pt idx="36">
                  <c:v>89.453085000000016</c:v>
                </c:pt>
                <c:pt idx="37">
                  <c:v>79.379345000000001</c:v>
                </c:pt>
                <c:pt idx="38">
                  <c:v>74.13033999999999</c:v>
                </c:pt>
                <c:pt idx="39">
                  <c:v>75.279610000000005</c:v>
                </c:pt>
                <c:pt idx="40">
                  <c:v>80.780139999999989</c:v>
                </c:pt>
                <c:pt idx="41">
                  <c:v>90.331664999999987</c:v>
                </c:pt>
                <c:pt idx="42">
                  <c:v>101.00225500000001</c:v>
                </c:pt>
                <c:pt idx="43">
                  <c:v>106.57191499999999</c:v>
                </c:pt>
                <c:pt idx="44">
                  <c:v>106.73718000000001</c:v>
                </c:pt>
                <c:pt idx="45">
                  <c:v>100.17951000000001</c:v>
                </c:pt>
                <c:pt idx="46">
                  <c:v>91.911860000000004</c:v>
                </c:pt>
                <c:pt idx="47">
                  <c:v>82.162585000000007</c:v>
                </c:pt>
                <c:pt idx="48">
                  <c:v>73.416055</c:v>
                </c:pt>
                <c:pt idx="49">
                  <c:v>65.945750000000004</c:v>
                </c:pt>
                <c:pt idx="50">
                  <c:v>60.056685000000009</c:v>
                </c:pt>
                <c:pt idx="51">
                  <c:v>55.766824999999997</c:v>
                </c:pt>
                <c:pt idx="52">
                  <c:v>53.360050000000001</c:v>
                </c:pt>
                <c:pt idx="53">
                  <c:v>53.288185000000013</c:v>
                </c:pt>
                <c:pt idx="54">
                  <c:v>55.226144999999995</c:v>
                </c:pt>
                <c:pt idx="55">
                  <c:v>58.899119999999996</c:v>
                </c:pt>
                <c:pt idx="56">
                  <c:v>63.09481499999999</c:v>
                </c:pt>
                <c:pt idx="57">
                  <c:v>66.842635000000016</c:v>
                </c:pt>
                <c:pt idx="58">
                  <c:v>68.426374999999993</c:v>
                </c:pt>
                <c:pt idx="59">
                  <c:v>67.246414999999985</c:v>
                </c:pt>
                <c:pt idx="60">
                  <c:v>64.494974999999997</c:v>
                </c:pt>
                <c:pt idx="61">
                  <c:v>60.46103999999999</c:v>
                </c:pt>
                <c:pt idx="62">
                  <c:v>53.809580000000004</c:v>
                </c:pt>
                <c:pt idx="63">
                  <c:v>47.295819999999999</c:v>
                </c:pt>
                <c:pt idx="64">
                  <c:v>42.428635000000007</c:v>
                </c:pt>
                <c:pt idx="65">
                  <c:v>39.378954999999998</c:v>
                </c:pt>
                <c:pt idx="66">
                  <c:v>37.504614999999994</c:v>
                </c:pt>
                <c:pt idx="67">
                  <c:v>36.492080000000001</c:v>
                </c:pt>
                <c:pt idx="68">
                  <c:v>36.497475000000001</c:v>
                </c:pt>
                <c:pt idx="69">
                  <c:v>37.362220000000001</c:v>
                </c:pt>
                <c:pt idx="70">
                  <c:v>39.131745000000002</c:v>
                </c:pt>
                <c:pt idx="71">
                  <c:v>41.062260000000002</c:v>
                </c:pt>
                <c:pt idx="72">
                  <c:v>41.776319999999998</c:v>
                </c:pt>
                <c:pt idx="73">
                  <c:v>41.372554999999998</c:v>
                </c:pt>
                <c:pt idx="74">
                  <c:v>39.713830000000002</c:v>
                </c:pt>
                <c:pt idx="75">
                  <c:v>37.374119999999998</c:v>
                </c:pt>
                <c:pt idx="76">
                  <c:v>35.442614999999996</c:v>
                </c:pt>
                <c:pt idx="77">
                  <c:v>32.827820000000003</c:v>
                </c:pt>
                <c:pt idx="78">
                  <c:v>30.475489999999997</c:v>
                </c:pt>
                <c:pt idx="79">
                  <c:v>28.704425000000001</c:v>
                </c:pt>
                <c:pt idx="80">
                  <c:v>27.376804999999997</c:v>
                </c:pt>
                <c:pt idx="81">
                  <c:v>26.551945</c:v>
                </c:pt>
                <c:pt idx="82">
                  <c:v>26.183495000000001</c:v>
                </c:pt>
                <c:pt idx="83">
                  <c:v>26.753770000000003</c:v>
                </c:pt>
                <c:pt idx="84">
                  <c:v>28.000870000000003</c:v>
                </c:pt>
                <c:pt idx="85">
                  <c:v>29.266639999999995</c:v>
                </c:pt>
                <c:pt idx="86">
                  <c:v>30.435360000000003</c:v>
                </c:pt>
                <c:pt idx="87">
                  <c:v>30.595300000000002</c:v>
                </c:pt>
                <c:pt idx="88">
                  <c:v>30.432300000000001</c:v>
                </c:pt>
                <c:pt idx="89">
                  <c:v>29.283464999999996</c:v>
                </c:pt>
                <c:pt idx="90">
                  <c:v>27.501210000000004</c:v>
                </c:pt>
                <c:pt idx="91">
                  <c:v>26.704979999999999</c:v>
                </c:pt>
                <c:pt idx="92">
                  <c:v>25.336185000000004</c:v>
                </c:pt>
                <c:pt idx="93">
                  <c:v>24.261535000000002</c:v>
                </c:pt>
                <c:pt idx="94">
                  <c:v>23.384695000000001</c:v>
                </c:pt>
                <c:pt idx="95">
                  <c:v>22.668854999999997</c:v>
                </c:pt>
                <c:pt idx="96">
                  <c:v>22.266364999999997</c:v>
                </c:pt>
                <c:pt idx="97">
                  <c:v>22.099735000000003</c:v>
                </c:pt>
                <c:pt idx="98">
                  <c:v>22.238579999999999</c:v>
                </c:pt>
                <c:pt idx="99">
                  <c:v>22.66187</c:v>
                </c:pt>
                <c:pt idx="100">
                  <c:v>23.105499999999999</c:v>
                </c:pt>
                <c:pt idx="101">
                  <c:v>23.570760000000003</c:v>
                </c:pt>
                <c:pt idx="102">
                  <c:v>23.738389999999995</c:v>
                </c:pt>
                <c:pt idx="103">
                  <c:v>23.657029999999999</c:v>
                </c:pt>
                <c:pt idx="104">
                  <c:v>23.817924999999999</c:v>
                </c:pt>
                <c:pt idx="105">
                  <c:v>24.003139999999995</c:v>
                </c:pt>
                <c:pt idx="106">
                  <c:v>23.678204999999998</c:v>
                </c:pt>
                <c:pt idx="107">
                  <c:v>22.936070000000001</c:v>
                </c:pt>
                <c:pt idx="108">
                  <c:v>22.958510000000004</c:v>
                </c:pt>
                <c:pt idx="109">
                  <c:v>22.736639999999998</c:v>
                </c:pt>
                <c:pt idx="110">
                  <c:v>22.342585000000003</c:v>
                </c:pt>
                <c:pt idx="111">
                  <c:v>21.904045</c:v>
                </c:pt>
                <c:pt idx="112">
                  <c:v>21.476664999999997</c:v>
                </c:pt>
                <c:pt idx="113">
                  <c:v>21.168904999999999</c:v>
                </c:pt>
                <c:pt idx="114">
                  <c:v>21.032664999999998</c:v>
                </c:pt>
                <c:pt idx="115">
                  <c:v>21.287314999999996</c:v>
                </c:pt>
                <c:pt idx="116">
                  <c:v>21.2896</c:v>
                </c:pt>
                <c:pt idx="117">
                  <c:v>20.663960000000003</c:v>
                </c:pt>
                <c:pt idx="118">
                  <c:v>21.245370000000001</c:v>
                </c:pt>
                <c:pt idx="119">
                  <c:v>21.004950000000001</c:v>
                </c:pt>
                <c:pt idx="120">
                  <c:v>21.099525</c:v>
                </c:pt>
                <c:pt idx="121">
                  <c:v>20.570139999999995</c:v>
                </c:pt>
                <c:pt idx="122">
                  <c:v>20.592670000000002</c:v>
                </c:pt>
                <c:pt idx="123">
                  <c:v>20.169049999999999</c:v>
                </c:pt>
                <c:pt idx="124">
                  <c:v>17.872960000000003</c:v>
                </c:pt>
                <c:pt idx="125">
                  <c:v>19.621700000000001</c:v>
                </c:pt>
                <c:pt idx="126">
                  <c:v>19.425529999999998</c:v>
                </c:pt>
                <c:pt idx="127">
                  <c:v>19.23245</c:v>
                </c:pt>
                <c:pt idx="128">
                  <c:v>18.673725000000001</c:v>
                </c:pt>
                <c:pt idx="129">
                  <c:v>18.797935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16-4E76-B990-3136AA94A77E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Q$17:$CQ$146</c:f>
              <c:numCache>
                <c:formatCode>0.00</c:formatCode>
                <c:ptCount val="130"/>
                <c:pt idx="0">
                  <c:v>39.670089999999995</c:v>
                </c:pt>
                <c:pt idx="1">
                  <c:v>41.226189999999995</c:v>
                </c:pt>
                <c:pt idx="2">
                  <c:v>40.179155000000002</c:v>
                </c:pt>
                <c:pt idx="3">
                  <c:v>40.898910000000001</c:v>
                </c:pt>
                <c:pt idx="4">
                  <c:v>43.878704999999997</c:v>
                </c:pt>
                <c:pt idx="5">
                  <c:v>47.007570000000001</c:v>
                </c:pt>
                <c:pt idx="6">
                  <c:v>49.236995</c:v>
                </c:pt>
                <c:pt idx="7">
                  <c:v>52.176264999999994</c:v>
                </c:pt>
                <c:pt idx="8">
                  <c:v>58.408585000000009</c:v>
                </c:pt>
                <c:pt idx="9">
                  <c:v>75.837980000000002</c:v>
                </c:pt>
                <c:pt idx="10">
                  <c:v>106.14880500000001</c:v>
                </c:pt>
                <c:pt idx="11">
                  <c:v>153.85634999999999</c:v>
                </c:pt>
                <c:pt idx="12">
                  <c:v>210.69682999999998</c:v>
                </c:pt>
                <c:pt idx="13">
                  <c:v>255.56802000000002</c:v>
                </c:pt>
                <c:pt idx="14">
                  <c:v>279.41244</c:v>
                </c:pt>
                <c:pt idx="15">
                  <c:v>280.42993999999999</c:v>
                </c:pt>
                <c:pt idx="16">
                  <c:v>265.41786999999999</c:v>
                </c:pt>
                <c:pt idx="17">
                  <c:v>239.291935</c:v>
                </c:pt>
                <c:pt idx="18">
                  <c:v>215.34494500000002</c:v>
                </c:pt>
                <c:pt idx="19">
                  <c:v>202.330915</c:v>
                </c:pt>
                <c:pt idx="20">
                  <c:v>194.80900500000001</c:v>
                </c:pt>
                <c:pt idx="21">
                  <c:v>181.387485</c:v>
                </c:pt>
                <c:pt idx="22">
                  <c:v>167.60608500000001</c:v>
                </c:pt>
                <c:pt idx="23">
                  <c:v>158.93676499999998</c:v>
                </c:pt>
                <c:pt idx="24">
                  <c:v>158.91162499999999</c:v>
                </c:pt>
                <c:pt idx="25">
                  <c:v>166.96522999999999</c:v>
                </c:pt>
                <c:pt idx="26">
                  <c:v>179.29178000000002</c:v>
                </c:pt>
                <c:pt idx="27">
                  <c:v>195.58643999999998</c:v>
                </c:pt>
                <c:pt idx="28">
                  <c:v>212.38030499999999</c:v>
                </c:pt>
                <c:pt idx="29">
                  <c:v>223.78328999999999</c:v>
                </c:pt>
                <c:pt idx="30">
                  <c:v>234.80721499999999</c:v>
                </c:pt>
                <c:pt idx="31">
                  <c:v>235.51039</c:v>
                </c:pt>
                <c:pt idx="32">
                  <c:v>227.56062499999999</c:v>
                </c:pt>
                <c:pt idx="33">
                  <c:v>218.13522999999998</c:v>
                </c:pt>
                <c:pt idx="34">
                  <c:v>198.47190000000001</c:v>
                </c:pt>
                <c:pt idx="35">
                  <c:v>174.16839999999999</c:v>
                </c:pt>
                <c:pt idx="36">
                  <c:v>149.60108500000001</c:v>
                </c:pt>
                <c:pt idx="37">
                  <c:v>129.14524499999999</c:v>
                </c:pt>
                <c:pt idx="38">
                  <c:v>115.95683999999999</c:v>
                </c:pt>
                <c:pt idx="39">
                  <c:v>110.28421000000002</c:v>
                </c:pt>
                <c:pt idx="40">
                  <c:v>112.26093999999999</c:v>
                </c:pt>
                <c:pt idx="41">
                  <c:v>124.154765</c:v>
                </c:pt>
                <c:pt idx="42">
                  <c:v>140.79495500000002</c:v>
                </c:pt>
                <c:pt idx="43">
                  <c:v>150.40461499999998</c:v>
                </c:pt>
                <c:pt idx="44">
                  <c:v>151.25198</c:v>
                </c:pt>
                <c:pt idx="45">
                  <c:v>144.14501000000001</c:v>
                </c:pt>
                <c:pt idx="46">
                  <c:v>133.58586</c:v>
                </c:pt>
                <c:pt idx="47">
                  <c:v>120.61128500000001</c:v>
                </c:pt>
                <c:pt idx="48">
                  <c:v>107.56485500000001</c:v>
                </c:pt>
                <c:pt idx="49">
                  <c:v>93.74915</c:v>
                </c:pt>
                <c:pt idx="50">
                  <c:v>81.253485000000012</c:v>
                </c:pt>
                <c:pt idx="51">
                  <c:v>71.087225000000004</c:v>
                </c:pt>
                <c:pt idx="52">
                  <c:v>64.032150000000001</c:v>
                </c:pt>
                <c:pt idx="53">
                  <c:v>60.185885000000006</c:v>
                </c:pt>
                <c:pt idx="54">
                  <c:v>59.847444999999993</c:v>
                </c:pt>
                <c:pt idx="55">
                  <c:v>62.302219999999998</c:v>
                </c:pt>
                <c:pt idx="56">
                  <c:v>67.371014999999986</c:v>
                </c:pt>
                <c:pt idx="57">
                  <c:v>73.115035000000006</c:v>
                </c:pt>
                <c:pt idx="58">
                  <c:v>76.063474999999997</c:v>
                </c:pt>
                <c:pt idx="59">
                  <c:v>76.129114999999985</c:v>
                </c:pt>
                <c:pt idx="60">
                  <c:v>73.293075000000002</c:v>
                </c:pt>
                <c:pt idx="61">
                  <c:v>68.992339999999984</c:v>
                </c:pt>
                <c:pt idx="62">
                  <c:v>63.599180000000004</c:v>
                </c:pt>
                <c:pt idx="63">
                  <c:v>57.032119999999992</c:v>
                </c:pt>
                <c:pt idx="64">
                  <c:v>50.361135000000004</c:v>
                </c:pt>
                <c:pt idx="65">
                  <c:v>43.255355000000002</c:v>
                </c:pt>
                <c:pt idx="66">
                  <c:v>37.067715</c:v>
                </c:pt>
                <c:pt idx="67">
                  <c:v>33.149979999999999</c:v>
                </c:pt>
                <c:pt idx="68">
                  <c:v>30.911474999999999</c:v>
                </c:pt>
                <c:pt idx="69">
                  <c:v>29.711020000000001</c:v>
                </c:pt>
                <c:pt idx="70">
                  <c:v>29.608445</c:v>
                </c:pt>
                <c:pt idx="71">
                  <c:v>30.893360000000005</c:v>
                </c:pt>
                <c:pt idx="72">
                  <c:v>33.300020000000004</c:v>
                </c:pt>
                <c:pt idx="73">
                  <c:v>36.020154999999995</c:v>
                </c:pt>
                <c:pt idx="74">
                  <c:v>37.402630000000002</c:v>
                </c:pt>
                <c:pt idx="75">
                  <c:v>37.087620000000001</c:v>
                </c:pt>
                <c:pt idx="76">
                  <c:v>35.204014999999998</c:v>
                </c:pt>
                <c:pt idx="77">
                  <c:v>32.835819999999998</c:v>
                </c:pt>
                <c:pt idx="78">
                  <c:v>30.158789999999996</c:v>
                </c:pt>
                <c:pt idx="79">
                  <c:v>27.569524999999999</c:v>
                </c:pt>
                <c:pt idx="80">
                  <c:v>24.940404999999998</c:v>
                </c:pt>
                <c:pt idx="81">
                  <c:v>22.969245000000001</c:v>
                </c:pt>
                <c:pt idx="82">
                  <c:v>21.300895000000001</c:v>
                </c:pt>
                <c:pt idx="83">
                  <c:v>20.04147</c:v>
                </c:pt>
                <c:pt idx="84">
                  <c:v>19.35567</c:v>
                </c:pt>
                <c:pt idx="85">
                  <c:v>18.958039999999997</c:v>
                </c:pt>
                <c:pt idx="86">
                  <c:v>18.956460000000003</c:v>
                </c:pt>
                <c:pt idx="87">
                  <c:v>19.538799999999998</c:v>
                </c:pt>
                <c:pt idx="88">
                  <c:v>20.2837</c:v>
                </c:pt>
                <c:pt idx="89">
                  <c:v>20.820164999999996</c:v>
                </c:pt>
                <c:pt idx="90">
                  <c:v>20.869110000000003</c:v>
                </c:pt>
                <c:pt idx="91">
                  <c:v>20.43028</c:v>
                </c:pt>
                <c:pt idx="92">
                  <c:v>19.566485000000004</c:v>
                </c:pt>
                <c:pt idx="93">
                  <c:v>18.654335000000003</c:v>
                </c:pt>
                <c:pt idx="94">
                  <c:v>17.514895000000003</c:v>
                </c:pt>
                <c:pt idx="95">
                  <c:v>16.659454999999998</c:v>
                </c:pt>
                <c:pt idx="96">
                  <c:v>15.996464999999997</c:v>
                </c:pt>
                <c:pt idx="97">
                  <c:v>15.327635000000004</c:v>
                </c:pt>
                <c:pt idx="98">
                  <c:v>14.90668</c:v>
                </c:pt>
                <c:pt idx="99">
                  <c:v>14.764270000000002</c:v>
                </c:pt>
                <c:pt idx="100">
                  <c:v>14.907500000000001</c:v>
                </c:pt>
                <c:pt idx="101">
                  <c:v>15.119660000000003</c:v>
                </c:pt>
                <c:pt idx="102">
                  <c:v>15.250889999999997</c:v>
                </c:pt>
                <c:pt idx="103">
                  <c:v>15.559329999999999</c:v>
                </c:pt>
                <c:pt idx="104">
                  <c:v>15.792925</c:v>
                </c:pt>
                <c:pt idx="105">
                  <c:v>15.692639999999997</c:v>
                </c:pt>
                <c:pt idx="106">
                  <c:v>15.441804999999999</c:v>
                </c:pt>
                <c:pt idx="107">
                  <c:v>15.043170000000002</c:v>
                </c:pt>
                <c:pt idx="108">
                  <c:v>14.475010000000003</c:v>
                </c:pt>
                <c:pt idx="109">
                  <c:v>14.004839999999996</c:v>
                </c:pt>
                <c:pt idx="110">
                  <c:v>13.459685000000004</c:v>
                </c:pt>
                <c:pt idx="111">
                  <c:v>12.991545</c:v>
                </c:pt>
                <c:pt idx="112">
                  <c:v>12.652764999999997</c:v>
                </c:pt>
                <c:pt idx="113">
                  <c:v>12.455804999999998</c:v>
                </c:pt>
                <c:pt idx="114">
                  <c:v>12.391264999999997</c:v>
                </c:pt>
                <c:pt idx="115">
                  <c:v>12.486814999999996</c:v>
                </c:pt>
                <c:pt idx="116">
                  <c:v>12.517200000000001</c:v>
                </c:pt>
                <c:pt idx="117">
                  <c:v>12.609460000000004</c:v>
                </c:pt>
                <c:pt idx="118">
                  <c:v>12.697970000000002</c:v>
                </c:pt>
                <c:pt idx="119">
                  <c:v>12.76905</c:v>
                </c:pt>
                <c:pt idx="120">
                  <c:v>12.661225</c:v>
                </c:pt>
                <c:pt idx="121">
                  <c:v>12.510839999999996</c:v>
                </c:pt>
                <c:pt idx="122">
                  <c:v>12.346970000000001</c:v>
                </c:pt>
                <c:pt idx="123">
                  <c:v>12.026450000000001</c:v>
                </c:pt>
                <c:pt idx="124">
                  <c:v>9.7858600000000031</c:v>
                </c:pt>
                <c:pt idx="125">
                  <c:v>11.3757</c:v>
                </c:pt>
                <c:pt idx="126">
                  <c:v>11.151329999999998</c:v>
                </c:pt>
                <c:pt idx="127">
                  <c:v>10.98555</c:v>
                </c:pt>
                <c:pt idx="128">
                  <c:v>10.824225</c:v>
                </c:pt>
                <c:pt idx="129">
                  <c:v>10.738635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816-4E76-B990-3136AA94A7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048128"/>
        <c:axId val="38049664"/>
      </c:lineChart>
      <c:catAx>
        <c:axId val="38048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804966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804966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80481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L$17:$CL$146</c:f>
              <c:numCache>
                <c:formatCode>0.00</c:formatCode>
                <c:ptCount val="130"/>
                <c:pt idx="0">
                  <c:v>34.290689999999998</c:v>
                </c:pt>
                <c:pt idx="1">
                  <c:v>38.07649</c:v>
                </c:pt>
                <c:pt idx="2">
                  <c:v>38.225054999999998</c:v>
                </c:pt>
                <c:pt idx="3">
                  <c:v>37.88091</c:v>
                </c:pt>
                <c:pt idx="4">
                  <c:v>37.006605</c:v>
                </c:pt>
                <c:pt idx="5">
                  <c:v>35.04327</c:v>
                </c:pt>
                <c:pt idx="6">
                  <c:v>32.789495000000002</c:v>
                </c:pt>
                <c:pt idx="7">
                  <c:v>31.143664999999995</c:v>
                </c:pt>
                <c:pt idx="8">
                  <c:v>30.095185000000004</c:v>
                </c:pt>
                <c:pt idx="9">
                  <c:v>31.111279999999997</c:v>
                </c:pt>
                <c:pt idx="10">
                  <c:v>36.029604999999997</c:v>
                </c:pt>
                <c:pt idx="11">
                  <c:v>47.477150000000002</c:v>
                </c:pt>
                <c:pt idx="12">
                  <c:v>66.437930000000009</c:v>
                </c:pt>
                <c:pt idx="13">
                  <c:v>90.364219999999989</c:v>
                </c:pt>
                <c:pt idx="14">
                  <c:v>122.21843999999999</c:v>
                </c:pt>
                <c:pt idx="15">
                  <c:v>152.96133999999998</c:v>
                </c:pt>
                <c:pt idx="16">
                  <c:v>176.83016999999998</c:v>
                </c:pt>
                <c:pt idx="17">
                  <c:v>194.28033500000001</c:v>
                </c:pt>
                <c:pt idx="18">
                  <c:v>202.30354499999999</c:v>
                </c:pt>
                <c:pt idx="19">
                  <c:v>201.56901499999998</c:v>
                </c:pt>
                <c:pt idx="20">
                  <c:v>192.18660500000001</c:v>
                </c:pt>
                <c:pt idx="21">
                  <c:v>173.73148500000002</c:v>
                </c:pt>
                <c:pt idx="22">
                  <c:v>152.10648500000002</c:v>
                </c:pt>
                <c:pt idx="23">
                  <c:v>129.27326499999998</c:v>
                </c:pt>
                <c:pt idx="24">
                  <c:v>112.102825</c:v>
                </c:pt>
                <c:pt idx="25">
                  <c:v>98.603430000000003</c:v>
                </c:pt>
                <c:pt idx="26">
                  <c:v>88.170079999999999</c:v>
                </c:pt>
                <c:pt idx="27">
                  <c:v>78.513939999999991</c:v>
                </c:pt>
                <c:pt idx="28">
                  <c:v>69.386505</c:v>
                </c:pt>
                <c:pt idx="29">
                  <c:v>60.23478999999999</c:v>
                </c:pt>
                <c:pt idx="30">
                  <c:v>54.424614999999989</c:v>
                </c:pt>
                <c:pt idx="31">
                  <c:v>51.433189999999996</c:v>
                </c:pt>
                <c:pt idx="32">
                  <c:v>50.001424999999998</c:v>
                </c:pt>
                <c:pt idx="33">
                  <c:v>52.447530000000008</c:v>
                </c:pt>
                <c:pt idx="34">
                  <c:v>56.762300000000003</c:v>
                </c:pt>
                <c:pt idx="35">
                  <c:v>66.8279</c:v>
                </c:pt>
                <c:pt idx="36">
                  <c:v>85.403285000000011</c:v>
                </c:pt>
                <c:pt idx="37">
                  <c:v>106.202445</c:v>
                </c:pt>
                <c:pt idx="38">
                  <c:v>127.93664</c:v>
                </c:pt>
                <c:pt idx="39">
                  <c:v>141.68251000000001</c:v>
                </c:pt>
                <c:pt idx="40">
                  <c:v>147.16163999999998</c:v>
                </c:pt>
                <c:pt idx="41">
                  <c:v>142.625765</c:v>
                </c:pt>
                <c:pt idx="42">
                  <c:v>131.70175499999999</c:v>
                </c:pt>
                <c:pt idx="43">
                  <c:v>117.41861499999999</c:v>
                </c:pt>
                <c:pt idx="44">
                  <c:v>103.40368000000001</c:v>
                </c:pt>
                <c:pt idx="45">
                  <c:v>90.746610000000004</c:v>
                </c:pt>
                <c:pt idx="46">
                  <c:v>79.667660000000012</c:v>
                </c:pt>
                <c:pt idx="47">
                  <c:v>71.767085000000009</c:v>
                </c:pt>
                <c:pt idx="48">
                  <c:v>65.121255000000005</c:v>
                </c:pt>
                <c:pt idx="49">
                  <c:v>59.340649999999997</c:v>
                </c:pt>
                <c:pt idx="50">
                  <c:v>55.729685000000011</c:v>
                </c:pt>
                <c:pt idx="51">
                  <c:v>52.518025000000002</c:v>
                </c:pt>
                <c:pt idx="52">
                  <c:v>49.93235</c:v>
                </c:pt>
                <c:pt idx="53">
                  <c:v>48.373785000000005</c:v>
                </c:pt>
                <c:pt idx="54">
                  <c:v>48.170445000000001</c:v>
                </c:pt>
                <c:pt idx="55">
                  <c:v>49.458019999999998</c:v>
                </c:pt>
                <c:pt idx="56">
                  <c:v>53.86301499999999</c:v>
                </c:pt>
                <c:pt idx="57">
                  <c:v>61.055735000000013</c:v>
                </c:pt>
                <c:pt idx="58">
                  <c:v>70.572275000000005</c:v>
                </c:pt>
                <c:pt idx="59">
                  <c:v>83.060914999999994</c:v>
                </c:pt>
                <c:pt idx="60">
                  <c:v>95.900075000000001</c:v>
                </c:pt>
                <c:pt idx="61">
                  <c:v>103.72573999999999</c:v>
                </c:pt>
                <c:pt idx="62">
                  <c:v>107.28948000000001</c:v>
                </c:pt>
                <c:pt idx="63">
                  <c:v>107.38321999999999</c:v>
                </c:pt>
                <c:pt idx="64">
                  <c:v>102.944135</c:v>
                </c:pt>
                <c:pt idx="65">
                  <c:v>96.011054999999999</c:v>
                </c:pt>
                <c:pt idx="66">
                  <c:v>87.627614999999992</c:v>
                </c:pt>
                <c:pt idx="67">
                  <c:v>77.321380000000005</c:v>
                </c:pt>
                <c:pt idx="68">
                  <c:v>68.556674999999998</c:v>
                </c:pt>
                <c:pt idx="69">
                  <c:v>60.718319999999999</c:v>
                </c:pt>
                <c:pt idx="70">
                  <c:v>54.320044999999993</c:v>
                </c:pt>
                <c:pt idx="71">
                  <c:v>49.334860000000006</c:v>
                </c:pt>
                <c:pt idx="72">
                  <c:v>45.65802</c:v>
                </c:pt>
                <c:pt idx="73">
                  <c:v>43.108354999999996</c:v>
                </c:pt>
                <c:pt idx="74">
                  <c:v>41.971130000000002</c:v>
                </c:pt>
                <c:pt idx="75">
                  <c:v>41.55762</c:v>
                </c:pt>
                <c:pt idx="76">
                  <c:v>42.717514999999999</c:v>
                </c:pt>
                <c:pt idx="77">
                  <c:v>44.852820000000001</c:v>
                </c:pt>
                <c:pt idx="78">
                  <c:v>48.92259</c:v>
                </c:pt>
                <c:pt idx="79">
                  <c:v>53.387625</c:v>
                </c:pt>
                <c:pt idx="80">
                  <c:v>59.592005000000007</c:v>
                </c:pt>
                <c:pt idx="81">
                  <c:v>66.438144999999992</c:v>
                </c:pt>
                <c:pt idx="82">
                  <c:v>73.799594999999997</c:v>
                </c:pt>
                <c:pt idx="83">
                  <c:v>78.791969999999992</c:v>
                </c:pt>
                <c:pt idx="84">
                  <c:v>81.320769999999996</c:v>
                </c:pt>
                <c:pt idx="85">
                  <c:v>80.130039999999994</c:v>
                </c:pt>
                <c:pt idx="86">
                  <c:v>76.09866000000001</c:v>
                </c:pt>
                <c:pt idx="87">
                  <c:v>70.085599999999999</c:v>
                </c:pt>
                <c:pt idx="88">
                  <c:v>62.790300000000002</c:v>
                </c:pt>
                <c:pt idx="89">
                  <c:v>54.692364999999988</c:v>
                </c:pt>
                <c:pt idx="90">
                  <c:v>46.744910000000004</c:v>
                </c:pt>
                <c:pt idx="91">
                  <c:v>39.67268</c:v>
                </c:pt>
                <c:pt idx="92">
                  <c:v>33.398585000000004</c:v>
                </c:pt>
                <c:pt idx="93">
                  <c:v>29.011335000000003</c:v>
                </c:pt>
                <c:pt idx="94">
                  <c:v>26.207495000000002</c:v>
                </c:pt>
                <c:pt idx="95">
                  <c:v>24.780054999999997</c:v>
                </c:pt>
                <c:pt idx="96">
                  <c:v>25.299064999999995</c:v>
                </c:pt>
                <c:pt idx="97">
                  <c:v>27.240935000000004</c:v>
                </c:pt>
                <c:pt idx="98">
                  <c:v>30.81428</c:v>
                </c:pt>
                <c:pt idx="99">
                  <c:v>35.67127</c:v>
                </c:pt>
                <c:pt idx="100">
                  <c:v>41.518700000000003</c:v>
                </c:pt>
                <c:pt idx="101">
                  <c:v>46.96096</c:v>
                </c:pt>
                <c:pt idx="102">
                  <c:v>52.570089999999993</c:v>
                </c:pt>
                <c:pt idx="103">
                  <c:v>57.252130000000008</c:v>
                </c:pt>
                <c:pt idx="104">
                  <c:v>59.911225000000002</c:v>
                </c:pt>
                <c:pt idx="105">
                  <c:v>60.800039999999989</c:v>
                </c:pt>
                <c:pt idx="106">
                  <c:v>59.360305000000004</c:v>
                </c:pt>
                <c:pt idx="107">
                  <c:v>56.309669999999997</c:v>
                </c:pt>
                <c:pt idx="108">
                  <c:v>51.831910000000001</c:v>
                </c:pt>
                <c:pt idx="109">
                  <c:v>46.859439999999999</c:v>
                </c:pt>
                <c:pt idx="110">
                  <c:v>41.276385000000005</c:v>
                </c:pt>
                <c:pt idx="111">
                  <c:v>36.028444999999998</c:v>
                </c:pt>
                <c:pt idx="112">
                  <c:v>31.184064999999997</c:v>
                </c:pt>
                <c:pt idx="113">
                  <c:v>27.028804999999998</c:v>
                </c:pt>
                <c:pt idx="114">
                  <c:v>24.021364999999996</c:v>
                </c:pt>
                <c:pt idx="115">
                  <c:v>21.767214999999997</c:v>
                </c:pt>
                <c:pt idx="116">
                  <c:v>20.1721</c:v>
                </c:pt>
                <c:pt idx="117">
                  <c:v>19.536760000000005</c:v>
                </c:pt>
                <c:pt idx="118">
                  <c:v>19.70147</c:v>
                </c:pt>
                <c:pt idx="119">
                  <c:v>20.989650000000001</c:v>
                </c:pt>
                <c:pt idx="120">
                  <c:v>23.126525000000001</c:v>
                </c:pt>
                <c:pt idx="121">
                  <c:v>26.362739999999995</c:v>
                </c:pt>
                <c:pt idx="122">
                  <c:v>30.17747</c:v>
                </c:pt>
                <c:pt idx="123">
                  <c:v>33.458449999999999</c:v>
                </c:pt>
                <c:pt idx="124">
                  <c:v>33.552860000000003</c:v>
                </c:pt>
                <c:pt idx="125">
                  <c:v>36.505400000000002</c:v>
                </c:pt>
                <c:pt idx="126">
                  <c:v>36.761629999999997</c:v>
                </c:pt>
                <c:pt idx="127">
                  <c:v>36.058549999999997</c:v>
                </c:pt>
                <c:pt idx="128">
                  <c:v>34.572825000000002</c:v>
                </c:pt>
                <c:pt idx="129">
                  <c:v>32.321635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CC-4425-B812-3AF14AF1E815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M$17:$CM$146</c:f>
              <c:numCache>
                <c:formatCode>0.00</c:formatCode>
                <c:ptCount val="130"/>
                <c:pt idx="0">
                  <c:v>31.889989999999997</c:v>
                </c:pt>
                <c:pt idx="1">
                  <c:v>33.682489999999994</c:v>
                </c:pt>
                <c:pt idx="2">
                  <c:v>34.291554999999995</c:v>
                </c:pt>
                <c:pt idx="3">
                  <c:v>31.637210000000003</c:v>
                </c:pt>
                <c:pt idx="4">
                  <c:v>28.393304999999998</c:v>
                </c:pt>
                <c:pt idx="5">
                  <c:v>26.551670000000001</c:v>
                </c:pt>
                <c:pt idx="6">
                  <c:v>24.546794999999999</c:v>
                </c:pt>
                <c:pt idx="7">
                  <c:v>21.542264999999997</c:v>
                </c:pt>
                <c:pt idx="8">
                  <c:v>19.748985000000005</c:v>
                </c:pt>
                <c:pt idx="9">
                  <c:v>19.839679999999998</c:v>
                </c:pt>
                <c:pt idx="10">
                  <c:v>23.512404999999998</c:v>
                </c:pt>
                <c:pt idx="11">
                  <c:v>31.995850000000001</c:v>
                </c:pt>
                <c:pt idx="12">
                  <c:v>44.724429999999998</c:v>
                </c:pt>
                <c:pt idx="13">
                  <c:v>62.062019999999997</c:v>
                </c:pt>
                <c:pt idx="14">
                  <c:v>84.104339999999993</c:v>
                </c:pt>
                <c:pt idx="15">
                  <c:v>110.09074</c:v>
                </c:pt>
                <c:pt idx="16">
                  <c:v>135.56856999999999</c:v>
                </c:pt>
                <c:pt idx="17">
                  <c:v>153.036835</c:v>
                </c:pt>
                <c:pt idx="18">
                  <c:v>161.33344499999998</c:v>
                </c:pt>
                <c:pt idx="19">
                  <c:v>157.15971499999998</c:v>
                </c:pt>
                <c:pt idx="20">
                  <c:v>140.33640500000001</c:v>
                </c:pt>
                <c:pt idx="21">
                  <c:v>118.35398500000001</c:v>
                </c:pt>
                <c:pt idx="22">
                  <c:v>100.61528500000001</c:v>
                </c:pt>
                <c:pt idx="23">
                  <c:v>87.831164999999984</c:v>
                </c:pt>
                <c:pt idx="24">
                  <c:v>80.566625000000002</c:v>
                </c:pt>
                <c:pt idx="25">
                  <c:v>75.564430000000002</c:v>
                </c:pt>
                <c:pt idx="26">
                  <c:v>70.350880000000004</c:v>
                </c:pt>
                <c:pt idx="27">
                  <c:v>63.665639999999989</c:v>
                </c:pt>
                <c:pt idx="28">
                  <c:v>55.834105000000008</c:v>
                </c:pt>
                <c:pt idx="29">
                  <c:v>48.199889999999996</c:v>
                </c:pt>
                <c:pt idx="30">
                  <c:v>40.778214999999996</c:v>
                </c:pt>
                <c:pt idx="31">
                  <c:v>35.639989999999997</c:v>
                </c:pt>
                <c:pt idx="32">
                  <c:v>32.598925000000001</c:v>
                </c:pt>
                <c:pt idx="33">
                  <c:v>32.205930000000002</c:v>
                </c:pt>
                <c:pt idx="34">
                  <c:v>35.558100000000003</c:v>
                </c:pt>
                <c:pt idx="35">
                  <c:v>43.277700000000003</c:v>
                </c:pt>
                <c:pt idx="36">
                  <c:v>53.937685000000009</c:v>
                </c:pt>
                <c:pt idx="37">
                  <c:v>64.288544999999999</c:v>
                </c:pt>
                <c:pt idx="38">
                  <c:v>74.621039999999994</c:v>
                </c:pt>
                <c:pt idx="39">
                  <c:v>82.624210000000005</c:v>
                </c:pt>
                <c:pt idx="40">
                  <c:v>84.58923999999999</c:v>
                </c:pt>
                <c:pt idx="41">
                  <c:v>80.91736499999999</c:v>
                </c:pt>
                <c:pt idx="42">
                  <c:v>74.387354999999999</c:v>
                </c:pt>
                <c:pt idx="43">
                  <c:v>66.469514999999987</c:v>
                </c:pt>
                <c:pt idx="44">
                  <c:v>59.617880000000007</c:v>
                </c:pt>
                <c:pt idx="45">
                  <c:v>54.056210000000007</c:v>
                </c:pt>
                <c:pt idx="46">
                  <c:v>49.263260000000002</c:v>
                </c:pt>
                <c:pt idx="47">
                  <c:v>46.233385000000006</c:v>
                </c:pt>
                <c:pt idx="48">
                  <c:v>43.164054999999998</c:v>
                </c:pt>
                <c:pt idx="49">
                  <c:v>40.243549999999999</c:v>
                </c:pt>
                <c:pt idx="50">
                  <c:v>36.837485000000001</c:v>
                </c:pt>
                <c:pt idx="51">
                  <c:v>34.145024999999997</c:v>
                </c:pt>
                <c:pt idx="52">
                  <c:v>31.284849999999999</c:v>
                </c:pt>
                <c:pt idx="53">
                  <c:v>29.420885000000002</c:v>
                </c:pt>
                <c:pt idx="54">
                  <c:v>28.446645</c:v>
                </c:pt>
                <c:pt idx="55">
                  <c:v>28.931319999999999</c:v>
                </c:pt>
                <c:pt idx="56">
                  <c:v>30.336914999999998</c:v>
                </c:pt>
                <c:pt idx="57">
                  <c:v>33.136335000000003</c:v>
                </c:pt>
                <c:pt idx="58">
                  <c:v>36.568174999999997</c:v>
                </c:pt>
                <c:pt idx="59">
                  <c:v>40.628814999999996</c:v>
                </c:pt>
                <c:pt idx="60">
                  <c:v>43.682575</c:v>
                </c:pt>
                <c:pt idx="61">
                  <c:v>45.683439999999997</c:v>
                </c:pt>
                <c:pt idx="62">
                  <c:v>46.545279999999998</c:v>
                </c:pt>
                <c:pt idx="63">
                  <c:v>45.614020000000004</c:v>
                </c:pt>
                <c:pt idx="64">
                  <c:v>44.101935000000005</c:v>
                </c:pt>
                <c:pt idx="65">
                  <c:v>41.741054999999996</c:v>
                </c:pt>
                <c:pt idx="66">
                  <c:v>39.034914999999998</c:v>
                </c:pt>
                <c:pt idx="67">
                  <c:v>36.005279999999999</c:v>
                </c:pt>
                <c:pt idx="68">
                  <c:v>33.144075000000001</c:v>
                </c:pt>
                <c:pt idx="69">
                  <c:v>30.694020000000002</c:v>
                </c:pt>
                <c:pt idx="70">
                  <c:v>28.656145000000002</c:v>
                </c:pt>
                <c:pt idx="71">
                  <c:v>26.964160000000003</c:v>
                </c:pt>
                <c:pt idx="72">
                  <c:v>25.600519999999999</c:v>
                </c:pt>
                <c:pt idx="73">
                  <c:v>24.459954999999997</c:v>
                </c:pt>
                <c:pt idx="74">
                  <c:v>23.65353</c:v>
                </c:pt>
                <c:pt idx="75">
                  <c:v>23.150020000000001</c:v>
                </c:pt>
                <c:pt idx="76">
                  <c:v>22.983214999999998</c:v>
                </c:pt>
                <c:pt idx="77">
                  <c:v>23.190920000000002</c:v>
                </c:pt>
                <c:pt idx="78">
                  <c:v>24.020889999999998</c:v>
                </c:pt>
                <c:pt idx="79">
                  <c:v>25.550625</c:v>
                </c:pt>
                <c:pt idx="80">
                  <c:v>27.214305</c:v>
                </c:pt>
                <c:pt idx="81">
                  <c:v>29.382345000000001</c:v>
                </c:pt>
                <c:pt idx="82">
                  <c:v>31.140795000000001</c:v>
                </c:pt>
                <c:pt idx="83">
                  <c:v>32.626469999999998</c:v>
                </c:pt>
                <c:pt idx="84">
                  <c:v>33.021370000000005</c:v>
                </c:pt>
                <c:pt idx="85">
                  <c:v>32.887439999999998</c:v>
                </c:pt>
                <c:pt idx="86">
                  <c:v>31.853360000000002</c:v>
                </c:pt>
                <c:pt idx="87">
                  <c:v>30.280200000000001</c:v>
                </c:pt>
                <c:pt idx="88">
                  <c:v>28.2029</c:v>
                </c:pt>
                <c:pt idx="89">
                  <c:v>25.988964999999997</c:v>
                </c:pt>
                <c:pt idx="90">
                  <c:v>23.762810000000002</c:v>
                </c:pt>
                <c:pt idx="91">
                  <c:v>21.617379999999997</c:v>
                </c:pt>
                <c:pt idx="92">
                  <c:v>20.076185000000002</c:v>
                </c:pt>
                <c:pt idx="93">
                  <c:v>19.115535000000005</c:v>
                </c:pt>
                <c:pt idx="94">
                  <c:v>17.690795000000001</c:v>
                </c:pt>
                <c:pt idx="95">
                  <c:v>16.983954999999998</c:v>
                </c:pt>
                <c:pt idx="96">
                  <c:v>16.742464999999996</c:v>
                </c:pt>
                <c:pt idx="97">
                  <c:v>16.821035000000002</c:v>
                </c:pt>
                <c:pt idx="98">
                  <c:v>17.304079999999999</c:v>
                </c:pt>
                <c:pt idx="99">
                  <c:v>18.075970000000002</c:v>
                </c:pt>
                <c:pt idx="100">
                  <c:v>18.976500000000001</c:v>
                </c:pt>
                <c:pt idx="101">
                  <c:v>20.148860000000003</c:v>
                </c:pt>
                <c:pt idx="102">
                  <c:v>21.143689999999996</c:v>
                </c:pt>
                <c:pt idx="103">
                  <c:v>22.240729999999999</c:v>
                </c:pt>
                <c:pt idx="104">
                  <c:v>22.977025000000001</c:v>
                </c:pt>
                <c:pt idx="105">
                  <c:v>23.616739999999997</c:v>
                </c:pt>
                <c:pt idx="106">
                  <c:v>26.121604999999999</c:v>
                </c:pt>
                <c:pt idx="107">
                  <c:v>23.691970000000001</c:v>
                </c:pt>
                <c:pt idx="108">
                  <c:v>23.125110000000003</c:v>
                </c:pt>
                <c:pt idx="109">
                  <c:v>22.249439999999996</c:v>
                </c:pt>
                <c:pt idx="110">
                  <c:v>20.846485000000005</c:v>
                </c:pt>
                <c:pt idx="111">
                  <c:v>19.522545000000001</c:v>
                </c:pt>
                <c:pt idx="112">
                  <c:v>17.897264999999997</c:v>
                </c:pt>
                <c:pt idx="113">
                  <c:v>16.348105</c:v>
                </c:pt>
                <c:pt idx="114">
                  <c:v>15.142864999999997</c:v>
                </c:pt>
                <c:pt idx="115">
                  <c:v>13.876314999999996</c:v>
                </c:pt>
                <c:pt idx="116">
                  <c:v>13.171799999999999</c:v>
                </c:pt>
                <c:pt idx="117">
                  <c:v>12.506160000000003</c:v>
                </c:pt>
                <c:pt idx="118">
                  <c:v>12.268170000000001</c:v>
                </c:pt>
                <c:pt idx="119">
                  <c:v>12.56645</c:v>
                </c:pt>
                <c:pt idx="120">
                  <c:v>13.010524999999999</c:v>
                </c:pt>
                <c:pt idx="121">
                  <c:v>13.682639999999996</c:v>
                </c:pt>
                <c:pt idx="122">
                  <c:v>14.823570000000002</c:v>
                </c:pt>
                <c:pt idx="123">
                  <c:v>15.666550000000001</c:v>
                </c:pt>
                <c:pt idx="124">
                  <c:v>14.636360000000003</c:v>
                </c:pt>
                <c:pt idx="125">
                  <c:v>17.0792</c:v>
                </c:pt>
                <c:pt idx="126">
                  <c:v>17.474229999999999</c:v>
                </c:pt>
                <c:pt idx="127">
                  <c:v>17.497949999999999</c:v>
                </c:pt>
                <c:pt idx="128">
                  <c:v>17.328025</c:v>
                </c:pt>
                <c:pt idx="129">
                  <c:v>16.855335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CC-4425-B812-3AF14AF1E815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N$17:$CN$146</c:f>
              <c:numCache>
                <c:formatCode>0.00</c:formatCode>
                <c:ptCount val="130"/>
                <c:pt idx="0">
                  <c:v>26.798689999999997</c:v>
                </c:pt>
                <c:pt idx="1">
                  <c:v>31.213189999999997</c:v>
                </c:pt>
                <c:pt idx="2">
                  <c:v>32.101154999999999</c:v>
                </c:pt>
                <c:pt idx="3">
                  <c:v>29.862710000000003</c:v>
                </c:pt>
                <c:pt idx="4">
                  <c:v>26.340805</c:v>
                </c:pt>
                <c:pt idx="5">
                  <c:v>24.46097</c:v>
                </c:pt>
                <c:pt idx="6">
                  <c:v>23.190895000000001</c:v>
                </c:pt>
                <c:pt idx="7">
                  <c:v>20.865164999999998</c:v>
                </c:pt>
                <c:pt idx="8">
                  <c:v>18.475285000000003</c:v>
                </c:pt>
                <c:pt idx="9">
                  <c:v>17.68468</c:v>
                </c:pt>
                <c:pt idx="10">
                  <c:v>19.217704999999999</c:v>
                </c:pt>
                <c:pt idx="11">
                  <c:v>23.12415</c:v>
                </c:pt>
                <c:pt idx="12">
                  <c:v>31.04213</c:v>
                </c:pt>
                <c:pt idx="13">
                  <c:v>43.02122</c:v>
                </c:pt>
                <c:pt idx="14">
                  <c:v>62.82233999999999</c:v>
                </c:pt>
                <c:pt idx="15">
                  <c:v>90.020639999999986</c:v>
                </c:pt>
                <c:pt idx="16">
                  <c:v>117.95126999999999</c:v>
                </c:pt>
                <c:pt idx="17">
                  <c:v>140.42953500000002</c:v>
                </c:pt>
                <c:pt idx="18">
                  <c:v>153.695145</c:v>
                </c:pt>
                <c:pt idx="19">
                  <c:v>159.352115</c:v>
                </c:pt>
                <c:pt idx="20">
                  <c:v>157.724705</c:v>
                </c:pt>
                <c:pt idx="21">
                  <c:v>148.94888500000002</c:v>
                </c:pt>
                <c:pt idx="22">
                  <c:v>137.21308500000001</c:v>
                </c:pt>
                <c:pt idx="23">
                  <c:v>125.30236499999999</c:v>
                </c:pt>
                <c:pt idx="24">
                  <c:v>115.155125</c:v>
                </c:pt>
                <c:pt idx="25">
                  <c:v>105.67293000000001</c:v>
                </c:pt>
                <c:pt idx="26">
                  <c:v>97.36948000000001</c:v>
                </c:pt>
                <c:pt idx="27">
                  <c:v>88.251639999999995</c:v>
                </c:pt>
                <c:pt idx="28">
                  <c:v>79.937705000000008</c:v>
                </c:pt>
                <c:pt idx="29">
                  <c:v>72.23178999999999</c:v>
                </c:pt>
                <c:pt idx="30">
                  <c:v>66.433314999999993</c:v>
                </c:pt>
                <c:pt idx="31">
                  <c:v>63.528589999999994</c:v>
                </c:pt>
                <c:pt idx="32">
                  <c:v>63.001224999999998</c:v>
                </c:pt>
                <c:pt idx="33">
                  <c:v>67.730429999999998</c:v>
                </c:pt>
                <c:pt idx="34">
                  <c:v>76.888300000000001</c:v>
                </c:pt>
                <c:pt idx="35">
                  <c:v>89.569199999999995</c:v>
                </c:pt>
                <c:pt idx="36">
                  <c:v>103.09518500000001</c:v>
                </c:pt>
                <c:pt idx="37">
                  <c:v>114.871645</c:v>
                </c:pt>
                <c:pt idx="38">
                  <c:v>123.55743999999999</c:v>
                </c:pt>
                <c:pt idx="39">
                  <c:v>126.44131000000002</c:v>
                </c:pt>
                <c:pt idx="40">
                  <c:v>123.27173999999999</c:v>
                </c:pt>
                <c:pt idx="41">
                  <c:v>115.071265</c:v>
                </c:pt>
                <c:pt idx="42">
                  <c:v>104.92605500000001</c:v>
                </c:pt>
                <c:pt idx="43">
                  <c:v>93.38911499999999</c:v>
                </c:pt>
                <c:pt idx="44">
                  <c:v>81.934280000000001</c:v>
                </c:pt>
                <c:pt idx="45">
                  <c:v>71.342310000000012</c:v>
                </c:pt>
                <c:pt idx="46">
                  <c:v>62.345960000000012</c:v>
                </c:pt>
                <c:pt idx="47">
                  <c:v>55.01478500000001</c:v>
                </c:pt>
                <c:pt idx="48">
                  <c:v>48.678455</c:v>
                </c:pt>
                <c:pt idx="49">
                  <c:v>44.104149999999997</c:v>
                </c:pt>
                <c:pt idx="50">
                  <c:v>40.797285000000002</c:v>
                </c:pt>
                <c:pt idx="51">
                  <c:v>38.428325000000001</c:v>
                </c:pt>
                <c:pt idx="52">
                  <c:v>36.844250000000002</c:v>
                </c:pt>
                <c:pt idx="53">
                  <c:v>36.536685000000006</c:v>
                </c:pt>
                <c:pt idx="54">
                  <c:v>37.714945</c:v>
                </c:pt>
                <c:pt idx="55">
                  <c:v>40.33222</c:v>
                </c:pt>
                <c:pt idx="56">
                  <c:v>44.051015</c:v>
                </c:pt>
                <c:pt idx="57">
                  <c:v>48.263235000000002</c:v>
                </c:pt>
                <c:pt idx="58">
                  <c:v>52.218074999999999</c:v>
                </c:pt>
                <c:pt idx="59">
                  <c:v>54.901214999999993</c:v>
                </c:pt>
                <c:pt idx="60">
                  <c:v>56.090674999999997</c:v>
                </c:pt>
                <c:pt idx="61">
                  <c:v>55.423639999999992</c:v>
                </c:pt>
                <c:pt idx="62">
                  <c:v>53.121180000000003</c:v>
                </c:pt>
                <c:pt idx="63">
                  <c:v>49.283619999999999</c:v>
                </c:pt>
                <c:pt idx="64">
                  <c:v>45.552435000000003</c:v>
                </c:pt>
                <c:pt idx="65">
                  <c:v>40.929254999999998</c:v>
                </c:pt>
                <c:pt idx="66">
                  <c:v>36.754714999999997</c:v>
                </c:pt>
                <c:pt idx="67">
                  <c:v>32.718679999999999</c:v>
                </c:pt>
                <c:pt idx="68">
                  <c:v>29.634174999999999</c:v>
                </c:pt>
                <c:pt idx="69">
                  <c:v>26.808520000000001</c:v>
                </c:pt>
                <c:pt idx="70">
                  <c:v>24.588445</c:v>
                </c:pt>
                <c:pt idx="71">
                  <c:v>23.110360000000004</c:v>
                </c:pt>
                <c:pt idx="72">
                  <c:v>22.089220000000001</c:v>
                </c:pt>
                <c:pt idx="73">
                  <c:v>21.643854999999999</c:v>
                </c:pt>
                <c:pt idx="74">
                  <c:v>21.77533</c:v>
                </c:pt>
                <c:pt idx="75">
                  <c:v>22.477220000000003</c:v>
                </c:pt>
                <c:pt idx="76">
                  <c:v>23.659414999999996</c:v>
                </c:pt>
                <c:pt idx="77">
                  <c:v>25.468620000000001</c:v>
                </c:pt>
                <c:pt idx="78">
                  <c:v>27.034189999999995</c:v>
                </c:pt>
                <c:pt idx="79">
                  <c:v>28.833925000000001</c:v>
                </c:pt>
                <c:pt idx="80">
                  <c:v>29.437904999999997</c:v>
                </c:pt>
                <c:pt idx="81">
                  <c:v>30.158245000000001</c:v>
                </c:pt>
                <c:pt idx="82">
                  <c:v>29.840395000000001</c:v>
                </c:pt>
                <c:pt idx="83">
                  <c:v>29.128970000000002</c:v>
                </c:pt>
                <c:pt idx="84">
                  <c:v>27.915570000000002</c:v>
                </c:pt>
                <c:pt idx="85">
                  <c:v>26.504039999999996</c:v>
                </c:pt>
                <c:pt idx="86">
                  <c:v>24.858660000000004</c:v>
                </c:pt>
                <c:pt idx="87">
                  <c:v>23.179400000000001</c:v>
                </c:pt>
                <c:pt idx="88">
                  <c:v>21.174299999999999</c:v>
                </c:pt>
                <c:pt idx="89">
                  <c:v>19.581864999999997</c:v>
                </c:pt>
                <c:pt idx="90">
                  <c:v>18.450410000000005</c:v>
                </c:pt>
                <c:pt idx="91">
                  <c:v>17.54468</c:v>
                </c:pt>
                <c:pt idx="92">
                  <c:v>16.640485000000002</c:v>
                </c:pt>
                <c:pt idx="93">
                  <c:v>16.051035000000002</c:v>
                </c:pt>
                <c:pt idx="94">
                  <c:v>15.520695000000002</c:v>
                </c:pt>
                <c:pt idx="95">
                  <c:v>15.290455</c:v>
                </c:pt>
                <c:pt idx="96">
                  <c:v>15.327464999999997</c:v>
                </c:pt>
                <c:pt idx="97">
                  <c:v>15.572635000000004</c:v>
                </c:pt>
                <c:pt idx="98">
                  <c:v>16.056179999999998</c:v>
                </c:pt>
                <c:pt idx="99">
                  <c:v>16.821670000000001</c:v>
                </c:pt>
                <c:pt idx="100">
                  <c:v>17.675599999999999</c:v>
                </c:pt>
                <c:pt idx="101">
                  <c:v>18.081260000000004</c:v>
                </c:pt>
                <c:pt idx="102">
                  <c:v>18.597289999999997</c:v>
                </c:pt>
                <c:pt idx="103">
                  <c:v>18.78303</c:v>
                </c:pt>
                <c:pt idx="104">
                  <c:v>18.610424999999999</c:v>
                </c:pt>
                <c:pt idx="105">
                  <c:v>18.396539999999998</c:v>
                </c:pt>
                <c:pt idx="106">
                  <c:v>17.810105</c:v>
                </c:pt>
                <c:pt idx="107">
                  <c:v>17.245070000000002</c:v>
                </c:pt>
                <c:pt idx="108">
                  <c:v>16.373310000000004</c:v>
                </c:pt>
                <c:pt idx="109">
                  <c:v>15.616639999999997</c:v>
                </c:pt>
                <c:pt idx="110">
                  <c:v>15.114885000000003</c:v>
                </c:pt>
                <c:pt idx="111">
                  <c:v>14.371345000000002</c:v>
                </c:pt>
                <c:pt idx="112">
                  <c:v>13.807664999999997</c:v>
                </c:pt>
                <c:pt idx="113">
                  <c:v>13.437504999999998</c:v>
                </c:pt>
                <c:pt idx="114">
                  <c:v>13.210264999999996</c:v>
                </c:pt>
                <c:pt idx="115">
                  <c:v>12.974714999999996</c:v>
                </c:pt>
                <c:pt idx="116">
                  <c:v>12.429500000000001</c:v>
                </c:pt>
                <c:pt idx="117">
                  <c:v>12.596560000000004</c:v>
                </c:pt>
                <c:pt idx="118">
                  <c:v>12.110570000000001</c:v>
                </c:pt>
                <c:pt idx="119">
                  <c:v>12.66245</c:v>
                </c:pt>
                <c:pt idx="120">
                  <c:v>12.608124999999999</c:v>
                </c:pt>
                <c:pt idx="121">
                  <c:v>12.492639999999996</c:v>
                </c:pt>
                <c:pt idx="122">
                  <c:v>13.168470000000001</c:v>
                </c:pt>
                <c:pt idx="123">
                  <c:v>12.41925</c:v>
                </c:pt>
                <c:pt idx="124">
                  <c:v>11.142660000000003</c:v>
                </c:pt>
                <c:pt idx="125">
                  <c:v>13.0419</c:v>
                </c:pt>
                <c:pt idx="126">
                  <c:v>12.846029999999999</c:v>
                </c:pt>
                <c:pt idx="127">
                  <c:v>13.467549999999999</c:v>
                </c:pt>
                <c:pt idx="128">
                  <c:v>12.225524999999999</c:v>
                </c:pt>
                <c:pt idx="129">
                  <c:v>11.975735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BCC-4425-B812-3AF14AF1E8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620544"/>
        <c:axId val="38626432"/>
      </c:lineChart>
      <c:catAx>
        <c:axId val="38620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8626432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8626432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86205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I$17:$CI$146</c:f>
              <c:numCache>
                <c:formatCode>0.00</c:formatCode>
                <c:ptCount val="130"/>
                <c:pt idx="0">
                  <c:v>87.845359999999999</c:v>
                </c:pt>
                <c:pt idx="1">
                  <c:v>88.005859999999998</c:v>
                </c:pt>
                <c:pt idx="2">
                  <c:v>87.10642</c:v>
                </c:pt>
                <c:pt idx="3">
                  <c:v>85.805140000000009</c:v>
                </c:pt>
                <c:pt idx="4">
                  <c:v>85.309619999999995</c:v>
                </c:pt>
                <c:pt idx="5">
                  <c:v>82.165580000000006</c:v>
                </c:pt>
                <c:pt idx="6">
                  <c:v>76.25048000000001</c:v>
                </c:pt>
                <c:pt idx="7">
                  <c:v>69.089959999999991</c:v>
                </c:pt>
                <c:pt idx="8">
                  <c:v>62.882240000000003</c:v>
                </c:pt>
                <c:pt idx="9">
                  <c:v>59.323519999999995</c:v>
                </c:pt>
                <c:pt idx="10">
                  <c:v>59.271119999999996</c:v>
                </c:pt>
                <c:pt idx="11">
                  <c:v>65.053299999999993</c:v>
                </c:pt>
                <c:pt idx="12">
                  <c:v>75.925419999999988</c:v>
                </c:pt>
                <c:pt idx="13">
                  <c:v>91.486180000000004</c:v>
                </c:pt>
                <c:pt idx="14">
                  <c:v>109.52206000000001</c:v>
                </c:pt>
                <c:pt idx="15">
                  <c:v>128.62946000000002</c:v>
                </c:pt>
                <c:pt idx="16">
                  <c:v>151.04277999999999</c:v>
                </c:pt>
                <c:pt idx="17">
                  <c:v>182.03263999999999</c:v>
                </c:pt>
                <c:pt idx="18">
                  <c:v>208.06028000000001</c:v>
                </c:pt>
                <c:pt idx="19">
                  <c:v>224.59356</c:v>
                </c:pt>
                <c:pt idx="20">
                  <c:v>226.80022000000002</c:v>
                </c:pt>
                <c:pt idx="21">
                  <c:v>215.58104</c:v>
                </c:pt>
                <c:pt idx="22">
                  <c:v>194.85324</c:v>
                </c:pt>
                <c:pt idx="23">
                  <c:v>168.63676000000001</c:v>
                </c:pt>
                <c:pt idx="24">
                  <c:v>144.78</c:v>
                </c:pt>
                <c:pt idx="25">
                  <c:v>129.96042</c:v>
                </c:pt>
                <c:pt idx="26">
                  <c:v>118.37572</c:v>
                </c:pt>
                <c:pt idx="27">
                  <c:v>106.66616</c:v>
                </c:pt>
                <c:pt idx="28">
                  <c:v>96.216119999999989</c:v>
                </c:pt>
                <c:pt idx="29">
                  <c:v>88.341359999999995</c:v>
                </c:pt>
                <c:pt idx="30">
                  <c:v>82.148060000000001</c:v>
                </c:pt>
                <c:pt idx="31">
                  <c:v>76.207459999999998</c:v>
                </c:pt>
                <c:pt idx="32">
                  <c:v>72.262699999999995</c:v>
                </c:pt>
                <c:pt idx="33">
                  <c:v>72.152119999999996</c:v>
                </c:pt>
                <c:pt idx="34">
                  <c:v>74.6023</c:v>
                </c:pt>
                <c:pt idx="35">
                  <c:v>78.103300000000004</c:v>
                </c:pt>
                <c:pt idx="36">
                  <c:v>82.819839999999999</c:v>
                </c:pt>
                <c:pt idx="37">
                  <c:v>91.154380000000003</c:v>
                </c:pt>
                <c:pt idx="38">
                  <c:v>103.14695999999999</c:v>
                </c:pt>
                <c:pt idx="39">
                  <c:v>115.88493999999999</c:v>
                </c:pt>
                <c:pt idx="40">
                  <c:v>128.05596</c:v>
                </c:pt>
                <c:pt idx="41">
                  <c:v>137.88996</c:v>
                </c:pt>
                <c:pt idx="42">
                  <c:v>140.76401999999999</c:v>
                </c:pt>
                <c:pt idx="43">
                  <c:v>137.27496000000002</c:v>
                </c:pt>
                <c:pt idx="44">
                  <c:v>131.01641999999998</c:v>
                </c:pt>
                <c:pt idx="45">
                  <c:v>122.73833999999999</c:v>
                </c:pt>
                <c:pt idx="46">
                  <c:v>111.14703999999999</c:v>
                </c:pt>
                <c:pt idx="47">
                  <c:v>101.87784000000001</c:v>
                </c:pt>
                <c:pt idx="48">
                  <c:v>95.187119999999993</c:v>
                </c:pt>
                <c:pt idx="49">
                  <c:v>88.769400000000005</c:v>
                </c:pt>
                <c:pt idx="50">
                  <c:v>84.343640000000008</c:v>
                </c:pt>
                <c:pt idx="51">
                  <c:v>82.605400000000003</c:v>
                </c:pt>
                <c:pt idx="52">
                  <c:v>81.598200000000006</c:v>
                </c:pt>
                <c:pt idx="53">
                  <c:v>79.942140000000009</c:v>
                </c:pt>
                <c:pt idx="54">
                  <c:v>78.174680000000009</c:v>
                </c:pt>
                <c:pt idx="55">
                  <c:v>78.63018000000001</c:v>
                </c:pt>
                <c:pt idx="56">
                  <c:v>80.241060000000004</c:v>
                </c:pt>
                <c:pt idx="57">
                  <c:v>81.051739999999995</c:v>
                </c:pt>
                <c:pt idx="58">
                  <c:v>82.354200000000006</c:v>
                </c:pt>
                <c:pt idx="59">
                  <c:v>84.215260000000001</c:v>
                </c:pt>
                <c:pt idx="60">
                  <c:v>86.4465</c:v>
                </c:pt>
                <c:pt idx="61">
                  <c:v>88.40446</c:v>
                </c:pt>
                <c:pt idx="62">
                  <c:v>89.815419999999989</c:v>
                </c:pt>
                <c:pt idx="63">
                  <c:v>92.301380000000009</c:v>
                </c:pt>
                <c:pt idx="64">
                  <c:v>94.784940000000006</c:v>
                </c:pt>
                <c:pt idx="65">
                  <c:v>95.90052</c:v>
                </c:pt>
                <c:pt idx="66">
                  <c:v>95.553359999999998</c:v>
                </c:pt>
                <c:pt idx="67">
                  <c:v>92.928219999999996</c:v>
                </c:pt>
                <c:pt idx="68">
                  <c:v>88.737799999999993</c:v>
                </c:pt>
                <c:pt idx="69">
                  <c:v>83.879580000000004</c:v>
                </c:pt>
                <c:pt idx="70">
                  <c:v>78.054580000000001</c:v>
                </c:pt>
                <c:pt idx="71">
                  <c:v>72.604640000000003</c:v>
                </c:pt>
                <c:pt idx="72">
                  <c:v>68.249480000000005</c:v>
                </c:pt>
                <c:pt idx="73">
                  <c:v>64.990919999999988</c:v>
                </c:pt>
                <c:pt idx="74">
                  <c:v>62.361619999999995</c:v>
                </c:pt>
                <c:pt idx="75">
                  <c:v>61.370080000000002</c:v>
                </c:pt>
                <c:pt idx="76">
                  <c:v>61.180659999999996</c:v>
                </c:pt>
                <c:pt idx="77">
                  <c:v>62.527080000000005</c:v>
                </c:pt>
                <c:pt idx="78">
                  <c:v>64.713359999999994</c:v>
                </c:pt>
                <c:pt idx="79">
                  <c:v>67.4071</c:v>
                </c:pt>
                <c:pt idx="80">
                  <c:v>70.68262</c:v>
                </c:pt>
                <c:pt idx="81">
                  <c:v>73.195779999999999</c:v>
                </c:pt>
                <c:pt idx="82">
                  <c:v>74.098280000000003</c:v>
                </c:pt>
                <c:pt idx="83">
                  <c:v>73.656480000000002</c:v>
                </c:pt>
                <c:pt idx="84">
                  <c:v>71.835180000000008</c:v>
                </c:pt>
                <c:pt idx="85">
                  <c:v>69.214460000000003</c:v>
                </c:pt>
                <c:pt idx="86">
                  <c:v>66.689940000000007</c:v>
                </c:pt>
                <c:pt idx="87">
                  <c:v>64.293599999999998</c:v>
                </c:pt>
                <c:pt idx="88">
                  <c:v>62.2485</c:v>
                </c:pt>
                <c:pt idx="89">
                  <c:v>61.164859999999997</c:v>
                </c:pt>
                <c:pt idx="90">
                  <c:v>59.86524</c:v>
                </c:pt>
                <c:pt idx="91">
                  <c:v>59.511519999999997</c:v>
                </c:pt>
                <c:pt idx="92">
                  <c:v>58.516440000000003</c:v>
                </c:pt>
                <c:pt idx="93">
                  <c:v>57.411840000000005</c:v>
                </c:pt>
                <c:pt idx="94">
                  <c:v>55.524980000000006</c:v>
                </c:pt>
                <c:pt idx="95">
                  <c:v>53.903419999999997</c:v>
                </c:pt>
                <c:pt idx="96">
                  <c:v>52.202860000000001</c:v>
                </c:pt>
                <c:pt idx="97">
                  <c:v>51.079039999999999</c:v>
                </c:pt>
                <c:pt idx="98">
                  <c:v>50.35322</c:v>
                </c:pt>
                <c:pt idx="99">
                  <c:v>50.64038</c:v>
                </c:pt>
                <c:pt idx="100">
                  <c:v>51.898000000000003</c:v>
                </c:pt>
                <c:pt idx="101">
                  <c:v>52.841140000000003</c:v>
                </c:pt>
                <c:pt idx="102">
                  <c:v>53.155259999999998</c:v>
                </c:pt>
                <c:pt idx="103">
                  <c:v>52.961519999999993</c:v>
                </c:pt>
                <c:pt idx="104">
                  <c:v>52.1965</c:v>
                </c:pt>
                <c:pt idx="105">
                  <c:v>50.737659999999998</c:v>
                </c:pt>
                <c:pt idx="106">
                  <c:v>48.723420000000004</c:v>
                </c:pt>
                <c:pt idx="107">
                  <c:v>46.734279999999998</c:v>
                </c:pt>
                <c:pt idx="108">
                  <c:v>44.430240000000005</c:v>
                </c:pt>
                <c:pt idx="109">
                  <c:v>42.992459999999994</c:v>
                </c:pt>
                <c:pt idx="110">
                  <c:v>41.915640000000003</c:v>
                </c:pt>
                <c:pt idx="111">
                  <c:v>41.843179999999997</c:v>
                </c:pt>
                <c:pt idx="112">
                  <c:v>41.997859999999996</c:v>
                </c:pt>
                <c:pt idx="113">
                  <c:v>42.730920000000005</c:v>
                </c:pt>
                <c:pt idx="114">
                  <c:v>43.352759999999996</c:v>
                </c:pt>
                <c:pt idx="115">
                  <c:v>43.351259999999996</c:v>
                </c:pt>
                <c:pt idx="116">
                  <c:v>42.867400000000004</c:v>
                </c:pt>
                <c:pt idx="117">
                  <c:v>41.791940000000004</c:v>
                </c:pt>
                <c:pt idx="118">
                  <c:v>40.269979999999997</c:v>
                </c:pt>
                <c:pt idx="119">
                  <c:v>38.476199999999999</c:v>
                </c:pt>
                <c:pt idx="120">
                  <c:v>36.839500000000001</c:v>
                </c:pt>
                <c:pt idx="121">
                  <c:v>35.556959999999997</c:v>
                </c:pt>
                <c:pt idx="122">
                  <c:v>34.050779999999996</c:v>
                </c:pt>
                <c:pt idx="123">
                  <c:v>33.473100000000002</c:v>
                </c:pt>
                <c:pt idx="124">
                  <c:v>31.456440000000001</c:v>
                </c:pt>
                <c:pt idx="125">
                  <c:v>33.742199999999997</c:v>
                </c:pt>
                <c:pt idx="126">
                  <c:v>34.692520000000002</c:v>
                </c:pt>
                <c:pt idx="127">
                  <c:v>35.887799999999999</c:v>
                </c:pt>
                <c:pt idx="128">
                  <c:v>36.557600000000001</c:v>
                </c:pt>
                <c:pt idx="129">
                  <c:v>36.38224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B6-4610-8B2A-65F5AF5E4D4D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J$17:$CJ$146</c:f>
              <c:numCache>
                <c:formatCode>0.00</c:formatCode>
                <c:ptCount val="130"/>
                <c:pt idx="0">
                  <c:v>86.025759999999991</c:v>
                </c:pt>
                <c:pt idx="1">
                  <c:v>83.232159999999993</c:v>
                </c:pt>
                <c:pt idx="2">
                  <c:v>76.285019999999989</c:v>
                </c:pt>
                <c:pt idx="3">
                  <c:v>70.254840000000002</c:v>
                </c:pt>
                <c:pt idx="4">
                  <c:v>65.609219999999993</c:v>
                </c:pt>
                <c:pt idx="5">
                  <c:v>61.175980000000003</c:v>
                </c:pt>
                <c:pt idx="6">
                  <c:v>55.230880000000006</c:v>
                </c:pt>
                <c:pt idx="7">
                  <c:v>49.63176</c:v>
                </c:pt>
                <c:pt idx="8">
                  <c:v>44.130839999999999</c:v>
                </c:pt>
                <c:pt idx="9">
                  <c:v>40.046720000000001</c:v>
                </c:pt>
                <c:pt idx="10">
                  <c:v>38.986719999999998</c:v>
                </c:pt>
                <c:pt idx="11">
                  <c:v>42.052700000000002</c:v>
                </c:pt>
                <c:pt idx="12">
                  <c:v>49.480420000000002</c:v>
                </c:pt>
                <c:pt idx="13">
                  <c:v>60.869780000000006</c:v>
                </c:pt>
                <c:pt idx="14">
                  <c:v>72.53716</c:v>
                </c:pt>
                <c:pt idx="15">
                  <c:v>90.946359999999999</c:v>
                </c:pt>
                <c:pt idx="16">
                  <c:v>112.39388000000001</c:v>
                </c:pt>
                <c:pt idx="17">
                  <c:v>133.24593999999999</c:v>
                </c:pt>
                <c:pt idx="18">
                  <c:v>157.65208000000001</c:v>
                </c:pt>
                <c:pt idx="19">
                  <c:v>178.29026000000002</c:v>
                </c:pt>
                <c:pt idx="20">
                  <c:v>183.78862000000001</c:v>
                </c:pt>
                <c:pt idx="21">
                  <c:v>179.95743999999999</c:v>
                </c:pt>
                <c:pt idx="22">
                  <c:v>167.20223999999999</c:v>
                </c:pt>
                <c:pt idx="23">
                  <c:v>152.53446</c:v>
                </c:pt>
                <c:pt idx="24">
                  <c:v>137.8013</c:v>
                </c:pt>
                <c:pt idx="25">
                  <c:v>127.69372</c:v>
                </c:pt>
                <c:pt idx="26">
                  <c:v>120.79661999999999</c:v>
                </c:pt>
                <c:pt idx="27">
                  <c:v>115.74386000000001</c:v>
                </c:pt>
                <c:pt idx="28">
                  <c:v>111.39731999999999</c:v>
                </c:pt>
                <c:pt idx="29">
                  <c:v>104.69926</c:v>
                </c:pt>
                <c:pt idx="30">
                  <c:v>92.867959999999997</c:v>
                </c:pt>
                <c:pt idx="31">
                  <c:v>82.431060000000002</c:v>
                </c:pt>
                <c:pt idx="32">
                  <c:v>72.358800000000002</c:v>
                </c:pt>
                <c:pt idx="33">
                  <c:v>66.550419999999988</c:v>
                </c:pt>
                <c:pt idx="34">
                  <c:v>61.043300000000002</c:v>
                </c:pt>
                <c:pt idx="35">
                  <c:v>57.137500000000003</c:v>
                </c:pt>
                <c:pt idx="36">
                  <c:v>56.372540000000001</c:v>
                </c:pt>
                <c:pt idx="37">
                  <c:v>58.189280000000004</c:v>
                </c:pt>
                <c:pt idx="38">
                  <c:v>63.542259999999999</c:v>
                </c:pt>
                <c:pt idx="39">
                  <c:v>74.414140000000003</c:v>
                </c:pt>
                <c:pt idx="40">
                  <c:v>85.484259999999992</c:v>
                </c:pt>
                <c:pt idx="41">
                  <c:v>95.978659999999991</c:v>
                </c:pt>
                <c:pt idx="42">
                  <c:v>103.28962</c:v>
                </c:pt>
                <c:pt idx="43">
                  <c:v>104.39865999999999</c:v>
                </c:pt>
                <c:pt idx="44">
                  <c:v>98.675219999999996</c:v>
                </c:pt>
                <c:pt idx="45">
                  <c:v>89.526840000000007</c:v>
                </c:pt>
                <c:pt idx="46">
                  <c:v>79.479140000000001</c:v>
                </c:pt>
                <c:pt idx="47">
                  <c:v>70.603440000000006</c:v>
                </c:pt>
                <c:pt idx="48">
                  <c:v>65.053919999999991</c:v>
                </c:pt>
                <c:pt idx="49">
                  <c:v>62.394799999999996</c:v>
                </c:pt>
                <c:pt idx="50">
                  <c:v>61.175139999999999</c:v>
                </c:pt>
                <c:pt idx="51">
                  <c:v>59.951500000000003</c:v>
                </c:pt>
                <c:pt idx="52">
                  <c:v>59.227600000000002</c:v>
                </c:pt>
                <c:pt idx="53">
                  <c:v>58.019539999999999</c:v>
                </c:pt>
                <c:pt idx="54">
                  <c:v>56.071580000000004</c:v>
                </c:pt>
                <c:pt idx="55">
                  <c:v>54.633280000000006</c:v>
                </c:pt>
                <c:pt idx="56">
                  <c:v>53.193159999999999</c:v>
                </c:pt>
                <c:pt idx="57">
                  <c:v>52.39114</c:v>
                </c:pt>
                <c:pt idx="58">
                  <c:v>52.559800000000003</c:v>
                </c:pt>
                <c:pt idx="59">
                  <c:v>54.639959999999995</c:v>
                </c:pt>
                <c:pt idx="60">
                  <c:v>58.693399999999997</c:v>
                </c:pt>
                <c:pt idx="61">
                  <c:v>64.108360000000005</c:v>
                </c:pt>
                <c:pt idx="62">
                  <c:v>69.085419999999999</c:v>
                </c:pt>
                <c:pt idx="63">
                  <c:v>72.886780000000002</c:v>
                </c:pt>
                <c:pt idx="64">
                  <c:v>75.030439999999999</c:v>
                </c:pt>
                <c:pt idx="65">
                  <c:v>74.426419999999993</c:v>
                </c:pt>
                <c:pt idx="66">
                  <c:v>71.991259999999997</c:v>
                </c:pt>
                <c:pt idx="67">
                  <c:v>67.238119999999995</c:v>
                </c:pt>
                <c:pt idx="68">
                  <c:v>61.954300000000003</c:v>
                </c:pt>
                <c:pt idx="69">
                  <c:v>56.943880000000007</c:v>
                </c:pt>
                <c:pt idx="70">
                  <c:v>52.348179999999999</c:v>
                </c:pt>
                <c:pt idx="71">
                  <c:v>49.024140000000003</c:v>
                </c:pt>
                <c:pt idx="72">
                  <c:v>47.628679999999996</c:v>
                </c:pt>
                <c:pt idx="73">
                  <c:v>47.197620000000001</c:v>
                </c:pt>
                <c:pt idx="74">
                  <c:v>46.885420000000003</c:v>
                </c:pt>
                <c:pt idx="75">
                  <c:v>47.15578</c:v>
                </c:pt>
                <c:pt idx="76">
                  <c:v>46.834859999999999</c:v>
                </c:pt>
                <c:pt idx="77">
                  <c:v>47.060679999999998</c:v>
                </c:pt>
                <c:pt idx="78">
                  <c:v>46.118859999999998</c:v>
                </c:pt>
                <c:pt idx="79">
                  <c:v>45.847799999999999</c:v>
                </c:pt>
                <c:pt idx="80">
                  <c:v>45.547719999999998</c:v>
                </c:pt>
                <c:pt idx="81">
                  <c:v>45.487580000000001</c:v>
                </c:pt>
                <c:pt idx="82">
                  <c:v>45.954180000000001</c:v>
                </c:pt>
                <c:pt idx="83">
                  <c:v>46.657379999999996</c:v>
                </c:pt>
                <c:pt idx="84">
                  <c:v>47.77008</c:v>
                </c:pt>
                <c:pt idx="85">
                  <c:v>48.740559999999995</c:v>
                </c:pt>
                <c:pt idx="86">
                  <c:v>49.437240000000003</c:v>
                </c:pt>
                <c:pt idx="87">
                  <c:v>49.815300000000001</c:v>
                </c:pt>
                <c:pt idx="88">
                  <c:v>49.009900000000002</c:v>
                </c:pt>
                <c:pt idx="89">
                  <c:v>47.200559999999996</c:v>
                </c:pt>
                <c:pt idx="90">
                  <c:v>44.783140000000003</c:v>
                </c:pt>
                <c:pt idx="91">
                  <c:v>41.853020000000001</c:v>
                </c:pt>
                <c:pt idx="92">
                  <c:v>38.747840000000004</c:v>
                </c:pt>
                <c:pt idx="93">
                  <c:v>35.871940000000002</c:v>
                </c:pt>
                <c:pt idx="94">
                  <c:v>33.356079999999999</c:v>
                </c:pt>
                <c:pt idx="95">
                  <c:v>31.34122</c:v>
                </c:pt>
                <c:pt idx="96">
                  <c:v>30.113759999999999</c:v>
                </c:pt>
                <c:pt idx="97">
                  <c:v>29.729840000000003</c:v>
                </c:pt>
                <c:pt idx="98">
                  <c:v>29.994220000000002</c:v>
                </c:pt>
                <c:pt idx="99">
                  <c:v>30.93038</c:v>
                </c:pt>
                <c:pt idx="100">
                  <c:v>32.127800000000001</c:v>
                </c:pt>
                <c:pt idx="101">
                  <c:v>33.317840000000004</c:v>
                </c:pt>
                <c:pt idx="102">
                  <c:v>34.328159999999997</c:v>
                </c:pt>
                <c:pt idx="103">
                  <c:v>35.486319999999999</c:v>
                </c:pt>
                <c:pt idx="104">
                  <c:v>36.368699999999997</c:v>
                </c:pt>
                <c:pt idx="105">
                  <c:v>37.251159999999999</c:v>
                </c:pt>
                <c:pt idx="106">
                  <c:v>37.526220000000002</c:v>
                </c:pt>
                <c:pt idx="107">
                  <c:v>37.089379999999998</c:v>
                </c:pt>
                <c:pt idx="108">
                  <c:v>36.534739999999999</c:v>
                </c:pt>
                <c:pt idx="109">
                  <c:v>35.078959999999995</c:v>
                </c:pt>
                <c:pt idx="110">
                  <c:v>34.687339999999999</c:v>
                </c:pt>
                <c:pt idx="111">
                  <c:v>32.68168</c:v>
                </c:pt>
                <c:pt idx="112">
                  <c:v>31.157359999999997</c:v>
                </c:pt>
                <c:pt idx="113">
                  <c:v>29.67792</c:v>
                </c:pt>
                <c:pt idx="114">
                  <c:v>28.002359999999996</c:v>
                </c:pt>
                <c:pt idx="115">
                  <c:v>26.490759999999998</c:v>
                </c:pt>
                <c:pt idx="116">
                  <c:v>25.433900000000001</c:v>
                </c:pt>
                <c:pt idx="117">
                  <c:v>24.614840000000001</c:v>
                </c:pt>
                <c:pt idx="118">
                  <c:v>24.015979999999999</c:v>
                </c:pt>
                <c:pt idx="119">
                  <c:v>23.6325</c:v>
                </c:pt>
                <c:pt idx="120">
                  <c:v>23.139700000000001</c:v>
                </c:pt>
                <c:pt idx="121">
                  <c:v>22.684759999999997</c:v>
                </c:pt>
                <c:pt idx="122">
                  <c:v>22.733879999999999</c:v>
                </c:pt>
                <c:pt idx="123">
                  <c:v>23.131599999999999</c:v>
                </c:pt>
                <c:pt idx="124">
                  <c:v>21.934040000000003</c:v>
                </c:pt>
                <c:pt idx="125">
                  <c:v>24.566700000000001</c:v>
                </c:pt>
                <c:pt idx="126">
                  <c:v>25.515820000000001</c:v>
                </c:pt>
                <c:pt idx="127">
                  <c:v>26.5411</c:v>
                </c:pt>
                <c:pt idx="128">
                  <c:v>27.0288</c:v>
                </c:pt>
                <c:pt idx="129">
                  <c:v>27.05264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B6-4610-8B2A-65F5AF5E4D4D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K$17:$CK$146</c:f>
              <c:numCache>
                <c:formatCode>0.00</c:formatCode>
                <c:ptCount val="130"/>
                <c:pt idx="0">
                  <c:v>80.217959999999991</c:v>
                </c:pt>
                <c:pt idx="1">
                  <c:v>69.736660000000001</c:v>
                </c:pt>
                <c:pt idx="2">
                  <c:v>61.163719999999998</c:v>
                </c:pt>
                <c:pt idx="3">
                  <c:v>57.361740000000005</c:v>
                </c:pt>
                <c:pt idx="4">
                  <c:v>54.109719999999996</c:v>
                </c:pt>
                <c:pt idx="5">
                  <c:v>51.67868</c:v>
                </c:pt>
                <c:pt idx="6">
                  <c:v>48.003079999999997</c:v>
                </c:pt>
                <c:pt idx="7">
                  <c:v>44.076859999999996</c:v>
                </c:pt>
                <c:pt idx="8">
                  <c:v>41.061240000000005</c:v>
                </c:pt>
                <c:pt idx="9">
                  <c:v>40.281620000000004</c:v>
                </c:pt>
                <c:pt idx="10">
                  <c:v>43.686619999999998</c:v>
                </c:pt>
                <c:pt idx="11">
                  <c:v>50.732100000000003</c:v>
                </c:pt>
                <c:pt idx="12">
                  <c:v>59.538519999999998</c:v>
                </c:pt>
                <c:pt idx="13">
                  <c:v>69.878080000000011</c:v>
                </c:pt>
                <c:pt idx="14">
                  <c:v>89.403260000000003</c:v>
                </c:pt>
                <c:pt idx="15">
                  <c:v>119.23096000000001</c:v>
                </c:pt>
                <c:pt idx="16">
                  <c:v>154.97208000000001</c:v>
                </c:pt>
                <c:pt idx="17">
                  <c:v>190.27444</c:v>
                </c:pt>
                <c:pt idx="18">
                  <c:v>225.85377999999997</c:v>
                </c:pt>
                <c:pt idx="19">
                  <c:v>247.89156</c:v>
                </c:pt>
                <c:pt idx="20">
                  <c:v>251.50542000000002</c:v>
                </c:pt>
                <c:pt idx="21">
                  <c:v>235.38083999999998</c:v>
                </c:pt>
                <c:pt idx="22">
                  <c:v>216.30503999999999</c:v>
                </c:pt>
                <c:pt idx="23">
                  <c:v>199.82226</c:v>
                </c:pt>
                <c:pt idx="24">
                  <c:v>185.2704</c:v>
                </c:pt>
                <c:pt idx="25">
                  <c:v>174.45112</c:v>
                </c:pt>
                <c:pt idx="26">
                  <c:v>162.80062000000001</c:v>
                </c:pt>
                <c:pt idx="27">
                  <c:v>152.29826</c:v>
                </c:pt>
                <c:pt idx="28">
                  <c:v>140.84662</c:v>
                </c:pt>
                <c:pt idx="29">
                  <c:v>126.44246000000001</c:v>
                </c:pt>
                <c:pt idx="30">
                  <c:v>112.41336000000001</c:v>
                </c:pt>
                <c:pt idx="31">
                  <c:v>100.92636</c:v>
                </c:pt>
                <c:pt idx="32">
                  <c:v>91.286600000000007</c:v>
                </c:pt>
                <c:pt idx="33">
                  <c:v>87.46772</c:v>
                </c:pt>
                <c:pt idx="34">
                  <c:v>86.981200000000001</c:v>
                </c:pt>
                <c:pt idx="35">
                  <c:v>91.189700000000002</c:v>
                </c:pt>
                <c:pt idx="36">
                  <c:v>99.27364</c:v>
                </c:pt>
                <c:pt idx="37">
                  <c:v>110.65298</c:v>
                </c:pt>
                <c:pt idx="38">
                  <c:v>122.89046</c:v>
                </c:pt>
                <c:pt idx="39">
                  <c:v>135.78873999999999</c:v>
                </c:pt>
                <c:pt idx="40">
                  <c:v>146.37486000000001</c:v>
                </c:pt>
                <c:pt idx="41">
                  <c:v>150.92786000000001</c:v>
                </c:pt>
                <c:pt idx="42">
                  <c:v>150.31631999999999</c:v>
                </c:pt>
                <c:pt idx="43">
                  <c:v>144.67836</c:v>
                </c:pt>
                <c:pt idx="44">
                  <c:v>135.72191999999998</c:v>
                </c:pt>
                <c:pt idx="45">
                  <c:v>123.31233999999999</c:v>
                </c:pt>
                <c:pt idx="46">
                  <c:v>112.35073999999999</c:v>
                </c:pt>
                <c:pt idx="47">
                  <c:v>103.63894000000001</c:v>
                </c:pt>
                <c:pt idx="48">
                  <c:v>97.526420000000002</c:v>
                </c:pt>
                <c:pt idx="49">
                  <c:v>92.597899999999996</c:v>
                </c:pt>
                <c:pt idx="50">
                  <c:v>87.670240000000007</c:v>
                </c:pt>
                <c:pt idx="51">
                  <c:v>83.436000000000007</c:v>
                </c:pt>
                <c:pt idx="52">
                  <c:v>79.008600000000001</c:v>
                </c:pt>
                <c:pt idx="53">
                  <c:v>74.67174</c:v>
                </c:pt>
                <c:pt idx="54">
                  <c:v>72.03258000000001</c:v>
                </c:pt>
                <c:pt idx="55">
                  <c:v>70.63488000000001</c:v>
                </c:pt>
                <c:pt idx="56">
                  <c:v>71.754059999999996</c:v>
                </c:pt>
                <c:pt idx="57">
                  <c:v>75.538640000000001</c:v>
                </c:pt>
                <c:pt idx="58">
                  <c:v>79.618899999999996</c:v>
                </c:pt>
                <c:pt idx="59">
                  <c:v>85.038659999999993</c:v>
                </c:pt>
                <c:pt idx="60">
                  <c:v>90.603999999999999</c:v>
                </c:pt>
                <c:pt idx="61">
                  <c:v>95.074759999999998</c:v>
                </c:pt>
                <c:pt idx="62">
                  <c:v>96.659120000000001</c:v>
                </c:pt>
                <c:pt idx="63">
                  <c:v>96.13288</c:v>
                </c:pt>
                <c:pt idx="64">
                  <c:v>93.748339999999999</c:v>
                </c:pt>
                <c:pt idx="65">
                  <c:v>91.141619999999989</c:v>
                </c:pt>
                <c:pt idx="66">
                  <c:v>87.27046</c:v>
                </c:pt>
                <c:pt idx="67">
                  <c:v>82.86681999999999</c:v>
                </c:pt>
                <c:pt idx="68">
                  <c:v>79.007800000000003</c:v>
                </c:pt>
                <c:pt idx="69">
                  <c:v>75.439779999999999</c:v>
                </c:pt>
                <c:pt idx="70">
                  <c:v>72.009680000000003</c:v>
                </c:pt>
                <c:pt idx="71">
                  <c:v>68.527740000000009</c:v>
                </c:pt>
                <c:pt idx="72">
                  <c:v>66.498680000000007</c:v>
                </c:pt>
                <c:pt idx="73">
                  <c:v>64.101219999999998</c:v>
                </c:pt>
                <c:pt idx="74">
                  <c:v>61.952019999999997</c:v>
                </c:pt>
                <c:pt idx="75">
                  <c:v>61.007280000000002</c:v>
                </c:pt>
                <c:pt idx="76">
                  <c:v>57.924859999999995</c:v>
                </c:pt>
                <c:pt idx="77">
                  <c:v>57.555780000000006</c:v>
                </c:pt>
                <c:pt idx="78">
                  <c:v>57.81176</c:v>
                </c:pt>
                <c:pt idx="79">
                  <c:v>60.507100000000001</c:v>
                </c:pt>
                <c:pt idx="80">
                  <c:v>60.979519999999994</c:v>
                </c:pt>
                <c:pt idx="81">
                  <c:v>64.057079999999999</c:v>
                </c:pt>
                <c:pt idx="82">
                  <c:v>66.821380000000005</c:v>
                </c:pt>
                <c:pt idx="83">
                  <c:v>68.728680000000011</c:v>
                </c:pt>
                <c:pt idx="84">
                  <c:v>69.882080000000002</c:v>
                </c:pt>
                <c:pt idx="85">
                  <c:v>68.937860000000001</c:v>
                </c:pt>
                <c:pt idx="86">
                  <c:v>67.621639999999999</c:v>
                </c:pt>
                <c:pt idx="87">
                  <c:v>65.372900000000001</c:v>
                </c:pt>
                <c:pt idx="88">
                  <c:v>62.898000000000003</c:v>
                </c:pt>
                <c:pt idx="89">
                  <c:v>59.232859999999995</c:v>
                </c:pt>
                <c:pt idx="90">
                  <c:v>55.250840000000004</c:v>
                </c:pt>
                <c:pt idx="91">
                  <c:v>51.848820000000003</c:v>
                </c:pt>
                <c:pt idx="92">
                  <c:v>48.758540000000004</c:v>
                </c:pt>
                <c:pt idx="93">
                  <c:v>46.943540000000006</c:v>
                </c:pt>
                <c:pt idx="94">
                  <c:v>45.155479999999997</c:v>
                </c:pt>
                <c:pt idx="95">
                  <c:v>44.334720000000004</c:v>
                </c:pt>
                <c:pt idx="96">
                  <c:v>44.158760000000001</c:v>
                </c:pt>
                <c:pt idx="97">
                  <c:v>43.742240000000002</c:v>
                </c:pt>
                <c:pt idx="98">
                  <c:v>44.157719999999998</c:v>
                </c:pt>
                <c:pt idx="99">
                  <c:v>44.707279999999997</c:v>
                </c:pt>
                <c:pt idx="100">
                  <c:v>45.459899999999998</c:v>
                </c:pt>
                <c:pt idx="101">
                  <c:v>46.001040000000003</c:v>
                </c:pt>
                <c:pt idx="102">
                  <c:v>46.58896</c:v>
                </c:pt>
                <c:pt idx="103">
                  <c:v>47.388820000000003</c:v>
                </c:pt>
                <c:pt idx="104">
                  <c:v>47.375999999999998</c:v>
                </c:pt>
                <c:pt idx="105">
                  <c:v>47.031759999999998</c:v>
                </c:pt>
                <c:pt idx="106">
                  <c:v>46.345420000000004</c:v>
                </c:pt>
                <c:pt idx="107">
                  <c:v>45.277079999999998</c:v>
                </c:pt>
                <c:pt idx="108">
                  <c:v>43.852740000000004</c:v>
                </c:pt>
                <c:pt idx="109">
                  <c:v>42.341059999999999</c:v>
                </c:pt>
                <c:pt idx="110">
                  <c:v>40.25864</c:v>
                </c:pt>
                <c:pt idx="111">
                  <c:v>38.38158</c:v>
                </c:pt>
                <c:pt idx="112">
                  <c:v>36.388359999999999</c:v>
                </c:pt>
                <c:pt idx="113">
                  <c:v>34.89752</c:v>
                </c:pt>
                <c:pt idx="114">
                  <c:v>34.18206</c:v>
                </c:pt>
                <c:pt idx="115">
                  <c:v>33.953759999999996</c:v>
                </c:pt>
                <c:pt idx="116">
                  <c:v>33.886400000000002</c:v>
                </c:pt>
                <c:pt idx="117">
                  <c:v>33.72634</c:v>
                </c:pt>
                <c:pt idx="118">
                  <c:v>33.419080000000001</c:v>
                </c:pt>
                <c:pt idx="119">
                  <c:v>33.112000000000002</c:v>
                </c:pt>
                <c:pt idx="120">
                  <c:v>32.352899999999998</c:v>
                </c:pt>
                <c:pt idx="121">
                  <c:v>31.733359999999998</c:v>
                </c:pt>
                <c:pt idx="122">
                  <c:v>31.237279999999998</c:v>
                </c:pt>
                <c:pt idx="123">
                  <c:v>31.2913</c:v>
                </c:pt>
                <c:pt idx="124">
                  <c:v>29.752140000000001</c:v>
                </c:pt>
                <c:pt idx="125">
                  <c:v>32.111699999999999</c:v>
                </c:pt>
                <c:pt idx="126">
                  <c:v>32.433920000000001</c:v>
                </c:pt>
                <c:pt idx="127">
                  <c:v>32.247999999999998</c:v>
                </c:pt>
                <c:pt idx="128">
                  <c:v>31.482600000000001</c:v>
                </c:pt>
                <c:pt idx="129">
                  <c:v>30.47094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9B6-4610-8B2A-65F5AF5E4D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5338880"/>
        <c:axId val="75340800"/>
      </c:lineChart>
      <c:catAx>
        <c:axId val="75338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5340800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75340800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753388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F$17:$CF$146</c:f>
              <c:numCache>
                <c:formatCode>0.00</c:formatCode>
                <c:ptCount val="130"/>
                <c:pt idx="0">
                  <c:v>316.71786000000003</c:v>
                </c:pt>
                <c:pt idx="1">
                  <c:v>304.88816000000003</c:v>
                </c:pt>
                <c:pt idx="2">
                  <c:v>302.48012</c:v>
                </c:pt>
                <c:pt idx="3">
                  <c:v>280.17133999999999</c:v>
                </c:pt>
                <c:pt idx="4">
                  <c:v>247.26892000000001</c:v>
                </c:pt>
                <c:pt idx="5">
                  <c:v>211.79377999999997</c:v>
                </c:pt>
                <c:pt idx="6">
                  <c:v>182.65378000000001</c:v>
                </c:pt>
                <c:pt idx="7">
                  <c:v>162.81656000000001</c:v>
                </c:pt>
                <c:pt idx="8">
                  <c:v>145.92553999999998</c:v>
                </c:pt>
                <c:pt idx="9">
                  <c:v>136.26512</c:v>
                </c:pt>
                <c:pt idx="10">
                  <c:v>125.25152</c:v>
                </c:pt>
                <c:pt idx="11">
                  <c:v>114.4881</c:v>
                </c:pt>
                <c:pt idx="12">
                  <c:v>106.17662</c:v>
                </c:pt>
                <c:pt idx="13">
                  <c:v>101.94998000000001</c:v>
                </c:pt>
                <c:pt idx="14">
                  <c:v>101.56036</c:v>
                </c:pt>
                <c:pt idx="15">
                  <c:v>99.823059999999998</c:v>
                </c:pt>
                <c:pt idx="16">
                  <c:v>95.853880000000004</c:v>
                </c:pt>
                <c:pt idx="17">
                  <c:v>90.643640000000005</c:v>
                </c:pt>
                <c:pt idx="18">
                  <c:v>84.557780000000008</c:v>
                </c:pt>
                <c:pt idx="19">
                  <c:v>80.740359999999995</c:v>
                </c:pt>
                <c:pt idx="20">
                  <c:v>80.181119999999993</c:v>
                </c:pt>
                <c:pt idx="21">
                  <c:v>80.617140000000006</c:v>
                </c:pt>
                <c:pt idx="22">
                  <c:v>83.918540000000007</c:v>
                </c:pt>
                <c:pt idx="23">
                  <c:v>89.528359999999992</c:v>
                </c:pt>
                <c:pt idx="24">
                  <c:v>94.949399999999997</c:v>
                </c:pt>
                <c:pt idx="25">
                  <c:v>98.303219999999996</c:v>
                </c:pt>
                <c:pt idx="26">
                  <c:v>101.89712</c:v>
                </c:pt>
                <c:pt idx="27">
                  <c:v>102.68406</c:v>
                </c:pt>
                <c:pt idx="28">
                  <c:v>99.93432</c:v>
                </c:pt>
                <c:pt idx="29">
                  <c:v>97.626859999999994</c:v>
                </c:pt>
                <c:pt idx="30">
                  <c:v>96.512259999999998</c:v>
                </c:pt>
                <c:pt idx="31">
                  <c:v>98.440759999999997</c:v>
                </c:pt>
                <c:pt idx="32">
                  <c:v>100.2833</c:v>
                </c:pt>
                <c:pt idx="33">
                  <c:v>105.55852</c:v>
                </c:pt>
                <c:pt idx="34">
                  <c:v>110.34229999999999</c:v>
                </c:pt>
                <c:pt idx="35">
                  <c:v>113.6658</c:v>
                </c:pt>
                <c:pt idx="36">
                  <c:v>117.40163999999999</c:v>
                </c:pt>
                <c:pt idx="37">
                  <c:v>118.75018</c:v>
                </c:pt>
                <c:pt idx="38">
                  <c:v>116.69346000000002</c:v>
                </c:pt>
                <c:pt idx="39">
                  <c:v>112.74503999999999</c:v>
                </c:pt>
                <c:pt idx="40">
                  <c:v>108.66856000000001</c:v>
                </c:pt>
                <c:pt idx="41">
                  <c:v>104.42135999999999</c:v>
                </c:pt>
                <c:pt idx="42">
                  <c:v>101.16552</c:v>
                </c:pt>
                <c:pt idx="43">
                  <c:v>99.658959999999993</c:v>
                </c:pt>
                <c:pt idx="44">
                  <c:v>100.12921999999999</c:v>
                </c:pt>
                <c:pt idx="45">
                  <c:v>99.984840000000005</c:v>
                </c:pt>
                <c:pt idx="46">
                  <c:v>101.11224</c:v>
                </c:pt>
                <c:pt idx="47">
                  <c:v>102.99764</c:v>
                </c:pt>
                <c:pt idx="48">
                  <c:v>102.82791999999999</c:v>
                </c:pt>
                <c:pt idx="49">
                  <c:v>99.773600000000002</c:v>
                </c:pt>
                <c:pt idx="50">
                  <c:v>94.350040000000007</c:v>
                </c:pt>
                <c:pt idx="51">
                  <c:v>87.334500000000006</c:v>
                </c:pt>
                <c:pt idx="52">
                  <c:v>80.115399999999994</c:v>
                </c:pt>
                <c:pt idx="53">
                  <c:v>74.998739999999998</c:v>
                </c:pt>
                <c:pt idx="54">
                  <c:v>72.523679999999999</c:v>
                </c:pt>
                <c:pt idx="55">
                  <c:v>71.765979999999999</c:v>
                </c:pt>
                <c:pt idx="56">
                  <c:v>71.051559999999995</c:v>
                </c:pt>
                <c:pt idx="57">
                  <c:v>70.18844</c:v>
                </c:pt>
                <c:pt idx="58">
                  <c:v>69.788899999999998</c:v>
                </c:pt>
                <c:pt idx="59">
                  <c:v>69.547560000000004</c:v>
                </c:pt>
                <c:pt idx="60">
                  <c:v>66.639099999999999</c:v>
                </c:pt>
                <c:pt idx="61">
                  <c:v>61.36656</c:v>
                </c:pt>
                <c:pt idx="62">
                  <c:v>56.477619999999995</c:v>
                </c:pt>
                <c:pt idx="63">
                  <c:v>52.298879999999997</c:v>
                </c:pt>
                <c:pt idx="64">
                  <c:v>50.039740000000002</c:v>
                </c:pt>
                <c:pt idx="65">
                  <c:v>49.22972</c:v>
                </c:pt>
                <c:pt idx="66">
                  <c:v>49.124559999999995</c:v>
                </c:pt>
                <c:pt idx="67">
                  <c:v>49.19332</c:v>
                </c:pt>
                <c:pt idx="68">
                  <c:v>48.354599999999998</c:v>
                </c:pt>
                <c:pt idx="69">
                  <c:v>47.85848</c:v>
                </c:pt>
                <c:pt idx="70">
                  <c:v>46.633379999999995</c:v>
                </c:pt>
                <c:pt idx="71">
                  <c:v>44.677140000000001</c:v>
                </c:pt>
                <c:pt idx="72">
                  <c:v>42.445479999999996</c:v>
                </c:pt>
                <c:pt idx="73">
                  <c:v>40.636420000000001</c:v>
                </c:pt>
                <c:pt idx="74">
                  <c:v>39.116320000000002</c:v>
                </c:pt>
                <c:pt idx="75">
                  <c:v>38.221879999999999</c:v>
                </c:pt>
                <c:pt idx="76">
                  <c:v>37.74606</c:v>
                </c:pt>
                <c:pt idx="77">
                  <c:v>37.89678</c:v>
                </c:pt>
                <c:pt idx="78">
                  <c:v>37.825359999999996</c:v>
                </c:pt>
                <c:pt idx="79">
                  <c:v>37.8459</c:v>
                </c:pt>
                <c:pt idx="80">
                  <c:v>37.69012</c:v>
                </c:pt>
                <c:pt idx="81">
                  <c:v>37.158380000000001</c:v>
                </c:pt>
                <c:pt idx="82">
                  <c:v>35.730179999999997</c:v>
                </c:pt>
                <c:pt idx="83">
                  <c:v>34.348979999999997</c:v>
                </c:pt>
                <c:pt idx="84">
                  <c:v>32.98068</c:v>
                </c:pt>
                <c:pt idx="85">
                  <c:v>32.178159999999998</c:v>
                </c:pt>
                <c:pt idx="86">
                  <c:v>31.667240000000003</c:v>
                </c:pt>
                <c:pt idx="87">
                  <c:v>31.678000000000001</c:v>
                </c:pt>
                <c:pt idx="88">
                  <c:v>32.079300000000003</c:v>
                </c:pt>
                <c:pt idx="89">
                  <c:v>32.411559999999994</c:v>
                </c:pt>
                <c:pt idx="90">
                  <c:v>32.955539999999999</c:v>
                </c:pt>
                <c:pt idx="91">
                  <c:v>33.046520000000001</c:v>
                </c:pt>
                <c:pt idx="92">
                  <c:v>32.262340000000002</c:v>
                </c:pt>
                <c:pt idx="93">
                  <c:v>31.374340000000004</c:v>
                </c:pt>
                <c:pt idx="94">
                  <c:v>30.213480000000001</c:v>
                </c:pt>
                <c:pt idx="95">
                  <c:v>29.349820000000001</c:v>
                </c:pt>
                <c:pt idx="96">
                  <c:v>28.897259999999999</c:v>
                </c:pt>
                <c:pt idx="97">
                  <c:v>28.485540000000004</c:v>
                </c:pt>
                <c:pt idx="98">
                  <c:v>28.26962</c:v>
                </c:pt>
                <c:pt idx="99">
                  <c:v>28.12978</c:v>
                </c:pt>
                <c:pt idx="100">
                  <c:v>28.019100000000002</c:v>
                </c:pt>
                <c:pt idx="101">
                  <c:v>27.850940000000001</c:v>
                </c:pt>
                <c:pt idx="102">
                  <c:v>27.437059999999999</c:v>
                </c:pt>
                <c:pt idx="103">
                  <c:v>27.04982</c:v>
                </c:pt>
                <c:pt idx="104">
                  <c:v>26.513999999999999</c:v>
                </c:pt>
                <c:pt idx="105">
                  <c:v>25.615259999999999</c:v>
                </c:pt>
                <c:pt idx="106">
                  <c:v>25.026720000000001</c:v>
                </c:pt>
                <c:pt idx="107">
                  <c:v>24.83258</c:v>
                </c:pt>
                <c:pt idx="108">
                  <c:v>24.524740000000001</c:v>
                </c:pt>
                <c:pt idx="109">
                  <c:v>24.472359999999998</c:v>
                </c:pt>
                <c:pt idx="110">
                  <c:v>24.504340000000003</c:v>
                </c:pt>
                <c:pt idx="111">
                  <c:v>24.51268</c:v>
                </c:pt>
                <c:pt idx="112">
                  <c:v>24.030759999999997</c:v>
                </c:pt>
                <c:pt idx="113">
                  <c:v>23.238320000000002</c:v>
                </c:pt>
                <c:pt idx="114">
                  <c:v>22.526959999999999</c:v>
                </c:pt>
                <c:pt idx="115">
                  <c:v>21.534659999999999</c:v>
                </c:pt>
                <c:pt idx="116">
                  <c:v>20.493300000000001</c:v>
                </c:pt>
                <c:pt idx="117">
                  <c:v>19.834140000000001</c:v>
                </c:pt>
                <c:pt idx="118">
                  <c:v>19.38758</c:v>
                </c:pt>
                <c:pt idx="119">
                  <c:v>19.460100000000001</c:v>
                </c:pt>
                <c:pt idx="120">
                  <c:v>19.542100000000001</c:v>
                </c:pt>
                <c:pt idx="121">
                  <c:v>19.516759999999998</c:v>
                </c:pt>
                <c:pt idx="122">
                  <c:v>19.48028</c:v>
                </c:pt>
                <c:pt idx="123">
                  <c:v>19.305199999999999</c:v>
                </c:pt>
                <c:pt idx="124">
                  <c:v>17.241340000000001</c:v>
                </c:pt>
                <c:pt idx="125">
                  <c:v>19.216899999999999</c:v>
                </c:pt>
                <c:pt idx="126">
                  <c:v>18.405520000000003</c:v>
                </c:pt>
                <c:pt idx="127">
                  <c:v>17.867000000000001</c:v>
                </c:pt>
                <c:pt idx="128">
                  <c:v>17.117000000000001</c:v>
                </c:pt>
                <c:pt idx="129">
                  <c:v>16.64764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BBD-419D-9AA2-E0A7BCCCE637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G$17:$CG$146</c:f>
              <c:numCache>
                <c:formatCode>0.00</c:formatCode>
                <c:ptCount val="130"/>
                <c:pt idx="0">
                  <c:v>306.04596000000004</c:v>
                </c:pt>
                <c:pt idx="1">
                  <c:v>290.37675999999999</c:v>
                </c:pt>
                <c:pt idx="2">
                  <c:v>280.85382000000004</c:v>
                </c:pt>
                <c:pt idx="3">
                  <c:v>259.43583999999998</c:v>
                </c:pt>
                <c:pt idx="4">
                  <c:v>225.99672000000001</c:v>
                </c:pt>
                <c:pt idx="5">
                  <c:v>187.87588</c:v>
                </c:pt>
                <c:pt idx="6">
                  <c:v>156.61807999999999</c:v>
                </c:pt>
                <c:pt idx="7">
                  <c:v>139.53656000000001</c:v>
                </c:pt>
                <c:pt idx="8">
                  <c:v>130.71003999999999</c:v>
                </c:pt>
                <c:pt idx="9">
                  <c:v>125.90482</c:v>
                </c:pt>
                <c:pt idx="10">
                  <c:v>121.82642</c:v>
                </c:pt>
                <c:pt idx="11">
                  <c:v>119.85299999999999</c:v>
                </c:pt>
                <c:pt idx="12">
                  <c:v>116.31371999999999</c:v>
                </c:pt>
                <c:pt idx="13">
                  <c:v>108.09598000000001</c:v>
                </c:pt>
                <c:pt idx="14">
                  <c:v>99.357860000000002</c:v>
                </c:pt>
                <c:pt idx="15">
                  <c:v>96.268259999999998</c:v>
                </c:pt>
                <c:pt idx="16">
                  <c:v>98.747080000000011</c:v>
                </c:pt>
                <c:pt idx="17">
                  <c:v>101.46024</c:v>
                </c:pt>
                <c:pt idx="18">
                  <c:v>106.34338000000001</c:v>
                </c:pt>
                <c:pt idx="19">
                  <c:v>107.84256000000001</c:v>
                </c:pt>
                <c:pt idx="20">
                  <c:v>106.09732</c:v>
                </c:pt>
                <c:pt idx="21">
                  <c:v>110.69933999999999</c:v>
                </c:pt>
                <c:pt idx="22">
                  <c:v>114.14703999999999</c:v>
                </c:pt>
                <c:pt idx="23">
                  <c:v>113.44036000000001</c:v>
                </c:pt>
                <c:pt idx="24">
                  <c:v>113.7705</c:v>
                </c:pt>
                <c:pt idx="25">
                  <c:v>113.90241999999999</c:v>
                </c:pt>
                <c:pt idx="26">
                  <c:v>112.89851999999999</c:v>
                </c:pt>
                <c:pt idx="27">
                  <c:v>114.78456000000001</c:v>
                </c:pt>
                <c:pt idx="28">
                  <c:v>117.28081999999999</c:v>
                </c:pt>
                <c:pt idx="29">
                  <c:v>119.70026000000001</c:v>
                </c:pt>
                <c:pt idx="30">
                  <c:v>123.14866000000001</c:v>
                </c:pt>
                <c:pt idx="31">
                  <c:v>126.78636000000002</c:v>
                </c:pt>
                <c:pt idx="32">
                  <c:v>127.9</c:v>
                </c:pt>
                <c:pt idx="33">
                  <c:v>130.51552000000001</c:v>
                </c:pt>
                <c:pt idx="34">
                  <c:v>132.04580000000001</c:v>
                </c:pt>
                <c:pt idx="35">
                  <c:v>131.4496</c:v>
                </c:pt>
                <c:pt idx="36">
                  <c:v>129.47783999999999</c:v>
                </c:pt>
                <c:pt idx="37">
                  <c:v>128.01918000000001</c:v>
                </c:pt>
                <c:pt idx="38">
                  <c:v>126.53296</c:v>
                </c:pt>
                <c:pt idx="39">
                  <c:v>125.35484</c:v>
                </c:pt>
                <c:pt idx="40">
                  <c:v>123.86416000000001</c:v>
                </c:pt>
                <c:pt idx="41">
                  <c:v>123.40076000000001</c:v>
                </c:pt>
                <c:pt idx="42">
                  <c:v>122.53872</c:v>
                </c:pt>
                <c:pt idx="43">
                  <c:v>120.75466000000002</c:v>
                </c:pt>
                <c:pt idx="44">
                  <c:v>118.52942</c:v>
                </c:pt>
                <c:pt idx="45">
                  <c:v>113.73844</c:v>
                </c:pt>
                <c:pt idx="46">
                  <c:v>108.75393999999999</c:v>
                </c:pt>
                <c:pt idx="47">
                  <c:v>103.78224</c:v>
                </c:pt>
                <c:pt idx="48">
                  <c:v>99.828419999999994</c:v>
                </c:pt>
                <c:pt idx="49">
                  <c:v>96.230500000000006</c:v>
                </c:pt>
                <c:pt idx="50">
                  <c:v>94.483040000000003</c:v>
                </c:pt>
                <c:pt idx="51">
                  <c:v>92.3613</c:v>
                </c:pt>
                <c:pt idx="52">
                  <c:v>90.005300000000005</c:v>
                </c:pt>
                <c:pt idx="53">
                  <c:v>87.006039999999999</c:v>
                </c:pt>
                <c:pt idx="54">
                  <c:v>82.773180000000011</c:v>
                </c:pt>
                <c:pt idx="55">
                  <c:v>78.190280000000001</c:v>
                </c:pt>
                <c:pt idx="56">
                  <c:v>73.975259999999992</c:v>
                </c:pt>
                <c:pt idx="57">
                  <c:v>70.47054</c:v>
                </c:pt>
                <c:pt idx="58">
                  <c:v>67.191800000000001</c:v>
                </c:pt>
                <c:pt idx="59">
                  <c:v>64.490659999999991</c:v>
                </c:pt>
                <c:pt idx="60">
                  <c:v>62.474899999999998</c:v>
                </c:pt>
                <c:pt idx="61">
                  <c:v>60.979759999999999</c:v>
                </c:pt>
                <c:pt idx="62">
                  <c:v>59.659719999999993</c:v>
                </c:pt>
                <c:pt idx="63">
                  <c:v>57.812280000000001</c:v>
                </c:pt>
                <c:pt idx="64">
                  <c:v>55.46264</c:v>
                </c:pt>
                <c:pt idx="65">
                  <c:v>53.009419999999999</c:v>
                </c:pt>
                <c:pt idx="66">
                  <c:v>50.908559999999994</c:v>
                </c:pt>
                <c:pt idx="67">
                  <c:v>48.457320000000003</c:v>
                </c:pt>
                <c:pt idx="68">
                  <c:v>46.581600000000002</c:v>
                </c:pt>
                <c:pt idx="69">
                  <c:v>44.769480000000001</c:v>
                </c:pt>
                <c:pt idx="70">
                  <c:v>43.217579999999998</c:v>
                </c:pt>
                <c:pt idx="71">
                  <c:v>42.064140000000002</c:v>
                </c:pt>
                <c:pt idx="72">
                  <c:v>41.06438</c:v>
                </c:pt>
                <c:pt idx="73">
                  <c:v>40.534320000000001</c:v>
                </c:pt>
                <c:pt idx="74">
                  <c:v>40.482019999999999</c:v>
                </c:pt>
                <c:pt idx="75">
                  <c:v>40.68168</c:v>
                </c:pt>
                <c:pt idx="76">
                  <c:v>40.37556</c:v>
                </c:pt>
                <c:pt idx="77">
                  <c:v>40.106479999999998</c:v>
                </c:pt>
                <c:pt idx="78">
                  <c:v>39.468859999999999</c:v>
                </c:pt>
                <c:pt idx="79">
                  <c:v>38.890700000000002</c:v>
                </c:pt>
                <c:pt idx="80">
                  <c:v>37.73742</c:v>
                </c:pt>
                <c:pt idx="81">
                  <c:v>36.788679999999999</c:v>
                </c:pt>
                <c:pt idx="82">
                  <c:v>35.555779999999999</c:v>
                </c:pt>
                <c:pt idx="83">
                  <c:v>34.664279999999998</c:v>
                </c:pt>
                <c:pt idx="84">
                  <c:v>34.03848</c:v>
                </c:pt>
                <c:pt idx="85">
                  <c:v>33.965260000000001</c:v>
                </c:pt>
                <c:pt idx="86">
                  <c:v>33.95964</c:v>
                </c:pt>
                <c:pt idx="87">
                  <c:v>34.362299999999998</c:v>
                </c:pt>
                <c:pt idx="88">
                  <c:v>34.909799999999997</c:v>
                </c:pt>
                <c:pt idx="89">
                  <c:v>34.650259999999996</c:v>
                </c:pt>
                <c:pt idx="90">
                  <c:v>33.89884</c:v>
                </c:pt>
                <c:pt idx="91">
                  <c:v>32.780120000000004</c:v>
                </c:pt>
                <c:pt idx="92">
                  <c:v>31.764040000000001</c:v>
                </c:pt>
                <c:pt idx="93">
                  <c:v>30.802840000000003</c:v>
                </c:pt>
                <c:pt idx="94">
                  <c:v>29.926579999999998</c:v>
                </c:pt>
                <c:pt idx="95">
                  <c:v>29.737719999999999</c:v>
                </c:pt>
                <c:pt idx="96">
                  <c:v>29.587559999999996</c:v>
                </c:pt>
                <c:pt idx="97">
                  <c:v>29.358740000000001</c:v>
                </c:pt>
                <c:pt idx="98">
                  <c:v>29.124220000000001</c:v>
                </c:pt>
                <c:pt idx="99">
                  <c:v>29.075879999999998</c:v>
                </c:pt>
                <c:pt idx="100">
                  <c:v>28.973299999999998</c:v>
                </c:pt>
                <c:pt idx="101">
                  <c:v>28.412640000000003</c:v>
                </c:pt>
                <c:pt idx="102">
                  <c:v>27.790959999999998</c:v>
                </c:pt>
                <c:pt idx="103">
                  <c:v>26.889520000000001</c:v>
                </c:pt>
                <c:pt idx="104">
                  <c:v>26.162500000000001</c:v>
                </c:pt>
                <c:pt idx="105">
                  <c:v>25.672359999999998</c:v>
                </c:pt>
                <c:pt idx="106">
                  <c:v>25.103720000000003</c:v>
                </c:pt>
                <c:pt idx="107">
                  <c:v>24.57818</c:v>
                </c:pt>
                <c:pt idx="108">
                  <c:v>24.041240000000002</c:v>
                </c:pt>
                <c:pt idx="109">
                  <c:v>23.834559999999996</c:v>
                </c:pt>
                <c:pt idx="110">
                  <c:v>23.624640000000003</c:v>
                </c:pt>
                <c:pt idx="111">
                  <c:v>23.515079999999998</c:v>
                </c:pt>
                <c:pt idx="112">
                  <c:v>23.261459999999996</c:v>
                </c:pt>
                <c:pt idx="113">
                  <c:v>22.733620000000002</c:v>
                </c:pt>
                <c:pt idx="114">
                  <c:v>22.178659999999997</c:v>
                </c:pt>
                <c:pt idx="115">
                  <c:v>21.862159999999999</c:v>
                </c:pt>
                <c:pt idx="116">
                  <c:v>21.335899999999999</c:v>
                </c:pt>
                <c:pt idx="117">
                  <c:v>20.846140000000002</c:v>
                </c:pt>
                <c:pt idx="118">
                  <c:v>20.563179999999999</c:v>
                </c:pt>
                <c:pt idx="119">
                  <c:v>20.3598</c:v>
                </c:pt>
                <c:pt idx="120">
                  <c:v>19.874099999999999</c:v>
                </c:pt>
                <c:pt idx="121">
                  <c:v>19.435259999999996</c:v>
                </c:pt>
                <c:pt idx="122">
                  <c:v>19.270579999999999</c:v>
                </c:pt>
                <c:pt idx="123">
                  <c:v>19.0609</c:v>
                </c:pt>
                <c:pt idx="124">
                  <c:v>16.771240000000002</c:v>
                </c:pt>
                <c:pt idx="125">
                  <c:v>18.527100000000001</c:v>
                </c:pt>
                <c:pt idx="126">
                  <c:v>18.423220000000001</c:v>
                </c:pt>
                <c:pt idx="127">
                  <c:v>18.029699999999998</c:v>
                </c:pt>
                <c:pt idx="128">
                  <c:v>17.726199999999999</c:v>
                </c:pt>
                <c:pt idx="129">
                  <c:v>17.41534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BBD-419D-9AA2-E0A7BCCCE637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H$17:$CH$146</c:f>
              <c:numCache>
                <c:formatCode>0.00</c:formatCode>
                <c:ptCount val="130"/>
                <c:pt idx="0">
                  <c:v>294.48916000000003</c:v>
                </c:pt>
                <c:pt idx="1">
                  <c:v>274.28126000000003</c:v>
                </c:pt>
                <c:pt idx="2">
                  <c:v>265.58452</c:v>
                </c:pt>
                <c:pt idx="3">
                  <c:v>245.86854</c:v>
                </c:pt>
                <c:pt idx="4">
                  <c:v>216.87752000000003</c:v>
                </c:pt>
                <c:pt idx="5">
                  <c:v>184.13578000000001</c:v>
                </c:pt>
                <c:pt idx="6">
                  <c:v>155.08948000000001</c:v>
                </c:pt>
                <c:pt idx="7">
                  <c:v>130.53706</c:v>
                </c:pt>
                <c:pt idx="8">
                  <c:v>111.05193999999999</c:v>
                </c:pt>
                <c:pt idx="9">
                  <c:v>97.173220000000001</c:v>
                </c:pt>
                <c:pt idx="10">
                  <c:v>89.229320000000001</c:v>
                </c:pt>
                <c:pt idx="11">
                  <c:v>85.179599999999994</c:v>
                </c:pt>
                <c:pt idx="12">
                  <c:v>82.886619999999994</c:v>
                </c:pt>
                <c:pt idx="13">
                  <c:v>82.087180000000004</c:v>
                </c:pt>
                <c:pt idx="14">
                  <c:v>84.599059999999994</c:v>
                </c:pt>
                <c:pt idx="15">
                  <c:v>88.093260000000001</c:v>
                </c:pt>
                <c:pt idx="16">
                  <c:v>88.691479999999999</c:v>
                </c:pt>
                <c:pt idx="17">
                  <c:v>86.798439999999999</c:v>
                </c:pt>
                <c:pt idx="18">
                  <c:v>81.405380000000008</c:v>
                </c:pt>
                <c:pt idx="19">
                  <c:v>78.259360000000001</c:v>
                </c:pt>
                <c:pt idx="20">
                  <c:v>78.085319999999996</c:v>
                </c:pt>
                <c:pt idx="21">
                  <c:v>79.033140000000003</c:v>
                </c:pt>
                <c:pt idx="22">
                  <c:v>81.998040000000003</c:v>
                </c:pt>
                <c:pt idx="23">
                  <c:v>86.399059999999992</c:v>
                </c:pt>
                <c:pt idx="24">
                  <c:v>90.523300000000006</c:v>
                </c:pt>
                <c:pt idx="25">
                  <c:v>94.28792</c:v>
                </c:pt>
                <c:pt idx="26">
                  <c:v>97.950419999999994</c:v>
                </c:pt>
                <c:pt idx="27">
                  <c:v>100.28695999999999</c:v>
                </c:pt>
                <c:pt idx="28">
                  <c:v>100.01251999999999</c:v>
                </c:pt>
                <c:pt idx="29">
                  <c:v>97.094459999999998</c:v>
                </c:pt>
                <c:pt idx="30">
                  <c:v>95.46996</c:v>
                </c:pt>
                <c:pt idx="31">
                  <c:v>95.422759999999997</c:v>
                </c:pt>
                <c:pt idx="32">
                  <c:v>97.083200000000005</c:v>
                </c:pt>
                <c:pt idx="33">
                  <c:v>102.23081999999999</c:v>
                </c:pt>
                <c:pt idx="34">
                  <c:v>108.3897</c:v>
                </c:pt>
                <c:pt idx="35">
                  <c:v>113.0778</c:v>
                </c:pt>
                <c:pt idx="36">
                  <c:v>119.25743999999999</c:v>
                </c:pt>
                <c:pt idx="37">
                  <c:v>123.79368000000001</c:v>
                </c:pt>
                <c:pt idx="38">
                  <c:v>122.97766000000001</c:v>
                </c:pt>
                <c:pt idx="39">
                  <c:v>120.05883999999999</c:v>
                </c:pt>
                <c:pt idx="40">
                  <c:v>116.17236000000001</c:v>
                </c:pt>
                <c:pt idx="41">
                  <c:v>112.62526000000001</c:v>
                </c:pt>
                <c:pt idx="42">
                  <c:v>109.91022</c:v>
                </c:pt>
                <c:pt idx="43">
                  <c:v>108.53696000000001</c:v>
                </c:pt>
                <c:pt idx="44">
                  <c:v>107.79312</c:v>
                </c:pt>
                <c:pt idx="45">
                  <c:v>108.09873999999999</c:v>
                </c:pt>
                <c:pt idx="46">
                  <c:v>109.64433999999999</c:v>
                </c:pt>
                <c:pt idx="47">
                  <c:v>111.62733999999999</c:v>
                </c:pt>
                <c:pt idx="48">
                  <c:v>110.13911999999999</c:v>
                </c:pt>
                <c:pt idx="49">
                  <c:v>106.7484</c:v>
                </c:pt>
                <c:pt idx="50">
                  <c:v>101.26194</c:v>
                </c:pt>
                <c:pt idx="51">
                  <c:v>96.176699999999997</c:v>
                </c:pt>
                <c:pt idx="52">
                  <c:v>91.702699999999993</c:v>
                </c:pt>
                <c:pt idx="53">
                  <c:v>87.984040000000007</c:v>
                </c:pt>
                <c:pt idx="54">
                  <c:v>85.188079999999999</c:v>
                </c:pt>
                <c:pt idx="55">
                  <c:v>82.871080000000006</c:v>
                </c:pt>
                <c:pt idx="56">
                  <c:v>80.676459999999992</c:v>
                </c:pt>
                <c:pt idx="57">
                  <c:v>79.977440000000001</c:v>
                </c:pt>
                <c:pt idx="58">
                  <c:v>80.081000000000003</c:v>
                </c:pt>
                <c:pt idx="59">
                  <c:v>78.917259999999999</c:v>
                </c:pt>
                <c:pt idx="60">
                  <c:v>76.053899999999999</c:v>
                </c:pt>
                <c:pt idx="61">
                  <c:v>72.235460000000003</c:v>
                </c:pt>
                <c:pt idx="62">
                  <c:v>67.72941999999999</c:v>
                </c:pt>
                <c:pt idx="63">
                  <c:v>63.837280000000007</c:v>
                </c:pt>
                <c:pt idx="64">
                  <c:v>60.124140000000004</c:v>
                </c:pt>
                <c:pt idx="65">
                  <c:v>57.206519999999998</c:v>
                </c:pt>
                <c:pt idx="66">
                  <c:v>55.05836</c:v>
                </c:pt>
                <c:pt idx="67">
                  <c:v>53.696819999999995</c:v>
                </c:pt>
                <c:pt idx="68">
                  <c:v>52.983199999999997</c:v>
                </c:pt>
                <c:pt idx="69">
                  <c:v>52.981580000000008</c:v>
                </c:pt>
                <c:pt idx="70">
                  <c:v>52.542180000000002</c:v>
                </c:pt>
                <c:pt idx="71">
                  <c:v>51.314540000000001</c:v>
                </c:pt>
                <c:pt idx="72">
                  <c:v>50.07488</c:v>
                </c:pt>
                <c:pt idx="73">
                  <c:v>47.963320000000003</c:v>
                </c:pt>
                <c:pt idx="74">
                  <c:v>46.492820000000002</c:v>
                </c:pt>
                <c:pt idx="75">
                  <c:v>45.171479999999995</c:v>
                </c:pt>
                <c:pt idx="76">
                  <c:v>44.364759999999997</c:v>
                </c:pt>
                <c:pt idx="77">
                  <c:v>44.039679999999997</c:v>
                </c:pt>
                <c:pt idx="78">
                  <c:v>43.84646</c:v>
                </c:pt>
                <c:pt idx="79">
                  <c:v>43.817500000000003</c:v>
                </c:pt>
                <c:pt idx="80">
                  <c:v>43.432220000000001</c:v>
                </c:pt>
                <c:pt idx="81">
                  <c:v>42.984679999999997</c:v>
                </c:pt>
                <c:pt idx="82">
                  <c:v>42.312280000000001</c:v>
                </c:pt>
                <c:pt idx="83">
                  <c:v>41.742179999999998</c:v>
                </c:pt>
                <c:pt idx="84">
                  <c:v>40.927079999999997</c:v>
                </c:pt>
                <c:pt idx="85">
                  <c:v>40.168259999999997</c:v>
                </c:pt>
                <c:pt idx="86">
                  <c:v>40.014140000000005</c:v>
                </c:pt>
                <c:pt idx="87">
                  <c:v>40.283799999999999</c:v>
                </c:pt>
                <c:pt idx="88">
                  <c:v>40.619399999999999</c:v>
                </c:pt>
                <c:pt idx="89">
                  <c:v>40.748359999999998</c:v>
                </c:pt>
                <c:pt idx="90">
                  <c:v>40.204940000000001</c:v>
                </c:pt>
                <c:pt idx="91">
                  <c:v>39.635020000000004</c:v>
                </c:pt>
                <c:pt idx="92">
                  <c:v>38.493140000000004</c:v>
                </c:pt>
                <c:pt idx="93">
                  <c:v>36.914439999999999</c:v>
                </c:pt>
                <c:pt idx="94">
                  <c:v>35.596980000000002</c:v>
                </c:pt>
                <c:pt idx="95">
                  <c:v>34.412820000000004</c:v>
                </c:pt>
                <c:pt idx="96">
                  <c:v>33.78396</c:v>
                </c:pt>
                <c:pt idx="97">
                  <c:v>33.583739999999999</c:v>
                </c:pt>
                <c:pt idx="98">
                  <c:v>34.003820000000005</c:v>
                </c:pt>
                <c:pt idx="99">
                  <c:v>34.546379999999999</c:v>
                </c:pt>
                <c:pt idx="100">
                  <c:v>35.078099999999999</c:v>
                </c:pt>
                <c:pt idx="101">
                  <c:v>35.108340000000005</c:v>
                </c:pt>
                <c:pt idx="102">
                  <c:v>34.885059999999996</c:v>
                </c:pt>
                <c:pt idx="103">
                  <c:v>34.035119999999999</c:v>
                </c:pt>
                <c:pt idx="104">
                  <c:v>32.842700000000001</c:v>
                </c:pt>
                <c:pt idx="105">
                  <c:v>31.688759999999998</c:v>
                </c:pt>
                <c:pt idx="106">
                  <c:v>30.366220000000002</c:v>
                </c:pt>
                <c:pt idx="107">
                  <c:v>29.307679999999998</c:v>
                </c:pt>
                <c:pt idx="108">
                  <c:v>28.559640000000002</c:v>
                </c:pt>
                <c:pt idx="109">
                  <c:v>28.089759999999998</c:v>
                </c:pt>
                <c:pt idx="110">
                  <c:v>27.993440000000003</c:v>
                </c:pt>
                <c:pt idx="111">
                  <c:v>27.933879999999998</c:v>
                </c:pt>
                <c:pt idx="112">
                  <c:v>27.752359999999996</c:v>
                </c:pt>
                <c:pt idx="113">
                  <c:v>27.37332</c:v>
                </c:pt>
                <c:pt idx="114">
                  <c:v>26.916859999999996</c:v>
                </c:pt>
                <c:pt idx="115">
                  <c:v>26.807459999999999</c:v>
                </c:pt>
                <c:pt idx="116">
                  <c:v>26.2197</c:v>
                </c:pt>
                <c:pt idx="117">
                  <c:v>25.494840000000003</c:v>
                </c:pt>
                <c:pt idx="118">
                  <c:v>24.95768</c:v>
                </c:pt>
                <c:pt idx="119">
                  <c:v>24.1388</c:v>
                </c:pt>
                <c:pt idx="120">
                  <c:v>23.849599999999999</c:v>
                </c:pt>
                <c:pt idx="121">
                  <c:v>23.288659999999997</c:v>
                </c:pt>
                <c:pt idx="122">
                  <c:v>22.612679999999997</c:v>
                </c:pt>
                <c:pt idx="123">
                  <c:v>21.9543</c:v>
                </c:pt>
                <c:pt idx="124">
                  <c:v>19.333340000000003</c:v>
                </c:pt>
                <c:pt idx="125">
                  <c:v>21.477799999999998</c:v>
                </c:pt>
                <c:pt idx="126">
                  <c:v>21.37322</c:v>
                </c:pt>
                <c:pt idx="127">
                  <c:v>20.970300000000002</c:v>
                </c:pt>
                <c:pt idx="128">
                  <c:v>20.157</c:v>
                </c:pt>
                <c:pt idx="129">
                  <c:v>19.40284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BBD-419D-9AA2-E0A7BCCCE6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9024512"/>
        <c:axId val="39026048"/>
      </c:lineChart>
      <c:catAx>
        <c:axId val="39024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9026048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9026048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90245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W$17:$BW$146</c:f>
              <c:numCache>
                <c:formatCode>0.00</c:formatCode>
                <c:ptCount val="130"/>
                <c:pt idx="0">
                  <c:v>77.025559999999999</c:v>
                </c:pt>
                <c:pt idx="1">
                  <c:v>84.090180000000004</c:v>
                </c:pt>
                <c:pt idx="2">
                  <c:v>86.001519999999999</c:v>
                </c:pt>
                <c:pt idx="3">
                  <c:v>85.352080000000001</c:v>
                </c:pt>
                <c:pt idx="4">
                  <c:v>81.585480000000004</c:v>
                </c:pt>
                <c:pt idx="5">
                  <c:v>77.090620000000001</c:v>
                </c:pt>
                <c:pt idx="6">
                  <c:v>72.620980000000003</c:v>
                </c:pt>
                <c:pt idx="7">
                  <c:v>68.478580000000008</c:v>
                </c:pt>
                <c:pt idx="8">
                  <c:v>64.550200000000004</c:v>
                </c:pt>
                <c:pt idx="9">
                  <c:v>61.732780000000005</c:v>
                </c:pt>
                <c:pt idx="10">
                  <c:v>59.155859999999997</c:v>
                </c:pt>
                <c:pt idx="11">
                  <c:v>56.818719999999992</c:v>
                </c:pt>
                <c:pt idx="12">
                  <c:v>55.422699999999999</c:v>
                </c:pt>
                <c:pt idx="13">
                  <c:v>53.989219999999996</c:v>
                </c:pt>
                <c:pt idx="14">
                  <c:v>52.867139999999999</c:v>
                </c:pt>
                <c:pt idx="15">
                  <c:v>51.21508</c:v>
                </c:pt>
                <c:pt idx="16">
                  <c:v>50.026600000000002</c:v>
                </c:pt>
                <c:pt idx="17">
                  <c:v>48.877679999999998</c:v>
                </c:pt>
                <c:pt idx="18">
                  <c:v>48.179520000000004</c:v>
                </c:pt>
                <c:pt idx="19">
                  <c:v>47.894280000000002</c:v>
                </c:pt>
                <c:pt idx="20">
                  <c:v>47.804819999999999</c:v>
                </c:pt>
                <c:pt idx="21">
                  <c:v>48.352540000000005</c:v>
                </c:pt>
                <c:pt idx="22">
                  <c:v>49.121879999999997</c:v>
                </c:pt>
                <c:pt idx="23">
                  <c:v>51.435499999999998</c:v>
                </c:pt>
                <c:pt idx="24">
                  <c:v>53.835540000000002</c:v>
                </c:pt>
                <c:pt idx="25">
                  <c:v>56.597919999999995</c:v>
                </c:pt>
                <c:pt idx="26">
                  <c:v>59.682899999999997</c:v>
                </c:pt>
                <c:pt idx="27">
                  <c:v>61.773859999999999</c:v>
                </c:pt>
                <c:pt idx="28">
                  <c:v>63.464280000000002</c:v>
                </c:pt>
                <c:pt idx="29">
                  <c:v>64.757719999999992</c:v>
                </c:pt>
                <c:pt idx="30">
                  <c:v>65.089060000000003</c:v>
                </c:pt>
                <c:pt idx="31">
                  <c:v>64.574359999999999</c:v>
                </c:pt>
                <c:pt idx="32">
                  <c:v>63.661859999999997</c:v>
                </c:pt>
                <c:pt idx="33">
                  <c:v>63.456380000000003</c:v>
                </c:pt>
                <c:pt idx="34">
                  <c:v>65.028000000000006</c:v>
                </c:pt>
                <c:pt idx="35">
                  <c:v>66.851039999999998</c:v>
                </c:pt>
                <c:pt idx="36">
                  <c:v>67.730380000000011</c:v>
                </c:pt>
                <c:pt idx="37">
                  <c:v>68.58614</c:v>
                </c:pt>
                <c:pt idx="38">
                  <c:v>68.401240000000001</c:v>
                </c:pt>
                <c:pt idx="39">
                  <c:v>68.914280000000005</c:v>
                </c:pt>
                <c:pt idx="40">
                  <c:v>68.13821999999999</c:v>
                </c:pt>
                <c:pt idx="41">
                  <c:v>67.779780000000002</c:v>
                </c:pt>
                <c:pt idx="42">
                  <c:v>66.655000000000001</c:v>
                </c:pt>
                <c:pt idx="43">
                  <c:v>65.479200000000006</c:v>
                </c:pt>
                <c:pt idx="44">
                  <c:v>64.905760000000001</c:v>
                </c:pt>
                <c:pt idx="45">
                  <c:v>64.728999999999999</c:v>
                </c:pt>
                <c:pt idx="46">
                  <c:v>65.115040000000008</c:v>
                </c:pt>
                <c:pt idx="47">
                  <c:v>64.592200000000005</c:v>
                </c:pt>
                <c:pt idx="48">
                  <c:v>64.510040000000004</c:v>
                </c:pt>
                <c:pt idx="49">
                  <c:v>63.992919999999998</c:v>
                </c:pt>
                <c:pt idx="50">
                  <c:v>63.592399999999998</c:v>
                </c:pt>
                <c:pt idx="51">
                  <c:v>63.104300000000002</c:v>
                </c:pt>
                <c:pt idx="52">
                  <c:v>62.443180000000005</c:v>
                </c:pt>
                <c:pt idx="53">
                  <c:v>61.499899999999997</c:v>
                </c:pt>
                <c:pt idx="54">
                  <c:v>59.877200000000002</c:v>
                </c:pt>
                <c:pt idx="55">
                  <c:v>57.941959999999995</c:v>
                </c:pt>
                <c:pt idx="56">
                  <c:v>56.289819999999999</c:v>
                </c:pt>
                <c:pt idx="57">
                  <c:v>54.836259999999996</c:v>
                </c:pt>
                <c:pt idx="58">
                  <c:v>53.699580000000005</c:v>
                </c:pt>
                <c:pt idx="59">
                  <c:v>52.781599999999997</c:v>
                </c:pt>
                <c:pt idx="60">
                  <c:v>51.744859999999996</c:v>
                </c:pt>
                <c:pt idx="61">
                  <c:v>50.86712</c:v>
                </c:pt>
                <c:pt idx="62">
                  <c:v>49.706060000000001</c:v>
                </c:pt>
                <c:pt idx="63">
                  <c:v>48.876940000000005</c:v>
                </c:pt>
                <c:pt idx="64">
                  <c:v>48.410699999999999</c:v>
                </c:pt>
                <c:pt idx="65">
                  <c:v>47.757640000000002</c:v>
                </c:pt>
                <c:pt idx="66">
                  <c:v>47.241419999999998</c:v>
                </c:pt>
                <c:pt idx="67">
                  <c:v>46.963999999999999</c:v>
                </c:pt>
                <c:pt idx="68">
                  <c:v>45.975459999999998</c:v>
                </c:pt>
                <c:pt idx="69">
                  <c:v>45.186459999999997</c:v>
                </c:pt>
                <c:pt idx="70">
                  <c:v>44.735520000000001</c:v>
                </c:pt>
                <c:pt idx="71">
                  <c:v>43.81438</c:v>
                </c:pt>
                <c:pt idx="72">
                  <c:v>42.772959999999998</c:v>
                </c:pt>
                <c:pt idx="73">
                  <c:v>41.842179999999999</c:v>
                </c:pt>
                <c:pt idx="74">
                  <c:v>41.147179999999999</c:v>
                </c:pt>
                <c:pt idx="75">
                  <c:v>40.655120000000004</c:v>
                </c:pt>
                <c:pt idx="76">
                  <c:v>39.491840000000003</c:v>
                </c:pt>
                <c:pt idx="77">
                  <c:v>38.679320000000004</c:v>
                </c:pt>
                <c:pt idx="78">
                  <c:v>37.840499999999999</c:v>
                </c:pt>
                <c:pt idx="79">
                  <c:v>37.565600000000003</c:v>
                </c:pt>
                <c:pt idx="80">
                  <c:v>37.475840000000005</c:v>
                </c:pt>
                <c:pt idx="81">
                  <c:v>37.266100000000002</c:v>
                </c:pt>
                <c:pt idx="82">
                  <c:v>37.079340000000002</c:v>
                </c:pt>
                <c:pt idx="83">
                  <c:v>37.075319999999998</c:v>
                </c:pt>
                <c:pt idx="84">
                  <c:v>36.928919999999998</c:v>
                </c:pt>
                <c:pt idx="85">
                  <c:v>36.385059999999996</c:v>
                </c:pt>
                <c:pt idx="86">
                  <c:v>36.065979999999996</c:v>
                </c:pt>
                <c:pt idx="87">
                  <c:v>35.463760000000001</c:v>
                </c:pt>
                <c:pt idx="88">
                  <c:v>34.77984</c:v>
                </c:pt>
                <c:pt idx="89">
                  <c:v>34.544579999999996</c:v>
                </c:pt>
                <c:pt idx="90">
                  <c:v>34.000900000000001</c:v>
                </c:pt>
                <c:pt idx="91">
                  <c:v>33.13946</c:v>
                </c:pt>
                <c:pt idx="92">
                  <c:v>32.376860000000001</c:v>
                </c:pt>
                <c:pt idx="93">
                  <c:v>32.061440000000005</c:v>
                </c:pt>
                <c:pt idx="94">
                  <c:v>31.468779999999999</c:v>
                </c:pt>
                <c:pt idx="95">
                  <c:v>31.281279999999999</c:v>
                </c:pt>
                <c:pt idx="96">
                  <c:v>30.446059999999999</c:v>
                </c:pt>
                <c:pt idx="97">
                  <c:v>30.4849</c:v>
                </c:pt>
                <c:pt idx="98">
                  <c:v>30.16582</c:v>
                </c:pt>
                <c:pt idx="99">
                  <c:v>30.431459999999998</c:v>
                </c:pt>
                <c:pt idx="100">
                  <c:v>30.065440000000002</c:v>
                </c:pt>
                <c:pt idx="101">
                  <c:v>30.010619999999999</c:v>
                </c:pt>
                <c:pt idx="102">
                  <c:v>29.641719999999999</c:v>
                </c:pt>
                <c:pt idx="103">
                  <c:v>29.067599999999999</c:v>
                </c:pt>
                <c:pt idx="104">
                  <c:v>28.751899999999999</c:v>
                </c:pt>
                <c:pt idx="105">
                  <c:v>28.07508</c:v>
                </c:pt>
                <c:pt idx="106">
                  <c:v>27.485759999999999</c:v>
                </c:pt>
                <c:pt idx="107">
                  <c:v>27.257279999999998</c:v>
                </c:pt>
                <c:pt idx="108">
                  <c:v>26.47728</c:v>
                </c:pt>
                <c:pt idx="109">
                  <c:v>26.00722</c:v>
                </c:pt>
                <c:pt idx="110">
                  <c:v>25.64282</c:v>
                </c:pt>
                <c:pt idx="111">
                  <c:v>25.141400000000001</c:v>
                </c:pt>
                <c:pt idx="112">
                  <c:v>24.868159999999996</c:v>
                </c:pt>
                <c:pt idx="113">
                  <c:v>24.653340000000004</c:v>
                </c:pt>
                <c:pt idx="114">
                  <c:v>24.555520000000001</c:v>
                </c:pt>
                <c:pt idx="115">
                  <c:v>24.360340000000001</c:v>
                </c:pt>
                <c:pt idx="116">
                  <c:v>24.263040000000004</c:v>
                </c:pt>
                <c:pt idx="117">
                  <c:v>24.083679999999998</c:v>
                </c:pt>
                <c:pt idx="118">
                  <c:v>23.96442</c:v>
                </c:pt>
                <c:pt idx="119">
                  <c:v>23.719479999999997</c:v>
                </c:pt>
                <c:pt idx="120">
                  <c:v>23.302979999999998</c:v>
                </c:pt>
                <c:pt idx="121">
                  <c:v>23.2715</c:v>
                </c:pt>
                <c:pt idx="122">
                  <c:v>23.155659999999997</c:v>
                </c:pt>
                <c:pt idx="123">
                  <c:v>22.961179999999999</c:v>
                </c:pt>
                <c:pt idx="124">
                  <c:v>22.514640000000004</c:v>
                </c:pt>
                <c:pt idx="125">
                  <c:v>22.337259999999997</c:v>
                </c:pt>
                <c:pt idx="126">
                  <c:v>22.073899999999998</c:v>
                </c:pt>
                <c:pt idx="127">
                  <c:v>21.646559999999997</c:v>
                </c:pt>
                <c:pt idx="128">
                  <c:v>21.326659999999997</c:v>
                </c:pt>
                <c:pt idx="129">
                  <c:v>20.99312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669-4512-8354-41A441E4E4D4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X$17:$BX$146</c:f>
              <c:numCache>
                <c:formatCode>0.00</c:formatCode>
                <c:ptCount val="130"/>
                <c:pt idx="0">
                  <c:v>76.291259999999994</c:v>
                </c:pt>
                <c:pt idx="1">
                  <c:v>82.61318</c:v>
                </c:pt>
                <c:pt idx="2">
                  <c:v>83.375720000000001</c:v>
                </c:pt>
                <c:pt idx="3">
                  <c:v>82.30538</c:v>
                </c:pt>
                <c:pt idx="4">
                  <c:v>79.813580000000002</c:v>
                </c:pt>
                <c:pt idx="5">
                  <c:v>75.073319999999995</c:v>
                </c:pt>
                <c:pt idx="6">
                  <c:v>70.443880000000007</c:v>
                </c:pt>
                <c:pt idx="7">
                  <c:v>65.98518</c:v>
                </c:pt>
                <c:pt idx="8">
                  <c:v>61.428800000000003</c:v>
                </c:pt>
                <c:pt idx="9">
                  <c:v>56.785080000000008</c:v>
                </c:pt>
                <c:pt idx="10">
                  <c:v>53.015059999999998</c:v>
                </c:pt>
                <c:pt idx="11">
                  <c:v>49.539120000000004</c:v>
                </c:pt>
                <c:pt idx="12">
                  <c:v>46.500399999999999</c:v>
                </c:pt>
                <c:pt idx="13">
                  <c:v>44.025220000000004</c:v>
                </c:pt>
                <c:pt idx="14">
                  <c:v>41.94314</c:v>
                </c:pt>
                <c:pt idx="15">
                  <c:v>40.328379999999996</c:v>
                </c:pt>
                <c:pt idx="16">
                  <c:v>39.095300000000002</c:v>
                </c:pt>
                <c:pt idx="17">
                  <c:v>38.340879999999999</c:v>
                </c:pt>
                <c:pt idx="18">
                  <c:v>38.097619999999999</c:v>
                </c:pt>
                <c:pt idx="19">
                  <c:v>38.343179999999997</c:v>
                </c:pt>
                <c:pt idx="20">
                  <c:v>38.600520000000003</c:v>
                </c:pt>
                <c:pt idx="21">
                  <c:v>39.380540000000003</c:v>
                </c:pt>
                <c:pt idx="22">
                  <c:v>39.994479999999996</c:v>
                </c:pt>
                <c:pt idx="23">
                  <c:v>41.453400000000002</c:v>
                </c:pt>
                <c:pt idx="24">
                  <c:v>43.19314</c:v>
                </c:pt>
                <c:pt idx="25">
                  <c:v>45.291719999999998</c:v>
                </c:pt>
                <c:pt idx="26">
                  <c:v>47.6096</c:v>
                </c:pt>
                <c:pt idx="27">
                  <c:v>50.16816</c:v>
                </c:pt>
                <c:pt idx="28">
                  <c:v>52.538580000000003</c:v>
                </c:pt>
                <c:pt idx="29">
                  <c:v>55.110219999999998</c:v>
                </c:pt>
                <c:pt idx="30">
                  <c:v>57.143259999999998</c:v>
                </c:pt>
                <c:pt idx="31">
                  <c:v>58.774859999999997</c:v>
                </c:pt>
                <c:pt idx="32">
                  <c:v>59.582459999999998</c:v>
                </c:pt>
                <c:pt idx="33">
                  <c:v>59.096180000000004</c:v>
                </c:pt>
                <c:pt idx="34">
                  <c:v>58.635599999999997</c:v>
                </c:pt>
                <c:pt idx="35">
                  <c:v>57.840340000000005</c:v>
                </c:pt>
                <c:pt idx="36">
                  <c:v>57.502480000000006</c:v>
                </c:pt>
                <c:pt idx="37">
                  <c:v>57.144040000000004</c:v>
                </c:pt>
                <c:pt idx="38">
                  <c:v>57.627940000000002</c:v>
                </c:pt>
                <c:pt idx="39">
                  <c:v>56.897580000000005</c:v>
                </c:pt>
                <c:pt idx="40">
                  <c:v>56.299619999999997</c:v>
                </c:pt>
                <c:pt idx="41">
                  <c:v>55.942980000000006</c:v>
                </c:pt>
                <c:pt idx="42">
                  <c:v>55.226599999999998</c:v>
                </c:pt>
                <c:pt idx="43">
                  <c:v>54.307400000000001</c:v>
                </c:pt>
                <c:pt idx="44">
                  <c:v>53.086859999999994</c:v>
                </c:pt>
                <c:pt idx="45">
                  <c:v>51.594900000000003</c:v>
                </c:pt>
                <c:pt idx="46">
                  <c:v>51.830740000000006</c:v>
                </c:pt>
                <c:pt idx="47">
                  <c:v>51.937800000000003</c:v>
                </c:pt>
                <c:pt idx="48">
                  <c:v>51.39864</c:v>
                </c:pt>
                <c:pt idx="49">
                  <c:v>50.82602</c:v>
                </c:pt>
                <c:pt idx="50">
                  <c:v>50.217199999999998</c:v>
                </c:pt>
                <c:pt idx="51">
                  <c:v>49.002499999999998</c:v>
                </c:pt>
                <c:pt idx="52">
                  <c:v>48.385579999999997</c:v>
                </c:pt>
                <c:pt idx="53">
                  <c:v>47.395899999999997</c:v>
                </c:pt>
                <c:pt idx="54">
                  <c:v>46.679400000000001</c:v>
                </c:pt>
                <c:pt idx="55">
                  <c:v>45.935859999999998</c:v>
                </c:pt>
                <c:pt idx="56">
                  <c:v>44.951320000000003</c:v>
                </c:pt>
                <c:pt idx="57">
                  <c:v>44.768459999999997</c:v>
                </c:pt>
                <c:pt idx="58">
                  <c:v>44.22878</c:v>
                </c:pt>
                <c:pt idx="59">
                  <c:v>44.3155</c:v>
                </c:pt>
                <c:pt idx="60">
                  <c:v>44.177959999999999</c:v>
                </c:pt>
                <c:pt idx="61">
                  <c:v>44.251519999999999</c:v>
                </c:pt>
                <c:pt idx="62">
                  <c:v>44.202259999999995</c:v>
                </c:pt>
                <c:pt idx="63">
                  <c:v>44.164439999999999</c:v>
                </c:pt>
                <c:pt idx="64">
                  <c:v>44.344799999999999</c:v>
                </c:pt>
                <c:pt idx="65">
                  <c:v>43.868639999999999</c:v>
                </c:pt>
                <c:pt idx="66">
                  <c:v>43.215519999999998</c:v>
                </c:pt>
                <c:pt idx="67">
                  <c:v>42.808700000000002</c:v>
                </c:pt>
                <c:pt idx="68">
                  <c:v>42.476859999999995</c:v>
                </c:pt>
                <c:pt idx="69">
                  <c:v>42.076560000000001</c:v>
                </c:pt>
                <c:pt idx="70">
                  <c:v>42.026519999999998</c:v>
                </c:pt>
                <c:pt idx="71">
                  <c:v>41.290179999999999</c:v>
                </c:pt>
                <c:pt idx="72">
                  <c:v>40.91686</c:v>
                </c:pt>
                <c:pt idx="73">
                  <c:v>40.32508</c:v>
                </c:pt>
                <c:pt idx="74">
                  <c:v>39.935179999999995</c:v>
                </c:pt>
                <c:pt idx="75">
                  <c:v>39.637819999999998</c:v>
                </c:pt>
                <c:pt idx="76">
                  <c:v>39.189040000000006</c:v>
                </c:pt>
                <c:pt idx="77">
                  <c:v>38.80462</c:v>
                </c:pt>
                <c:pt idx="78">
                  <c:v>38.3294</c:v>
                </c:pt>
                <c:pt idx="79">
                  <c:v>37.807299999999998</c:v>
                </c:pt>
                <c:pt idx="80">
                  <c:v>37.566540000000003</c:v>
                </c:pt>
                <c:pt idx="81">
                  <c:v>36.8825</c:v>
                </c:pt>
                <c:pt idx="82">
                  <c:v>36.517740000000003</c:v>
                </c:pt>
                <c:pt idx="83">
                  <c:v>35.988120000000002</c:v>
                </c:pt>
                <c:pt idx="84">
                  <c:v>35.599820000000001</c:v>
                </c:pt>
                <c:pt idx="85">
                  <c:v>35.534659999999995</c:v>
                </c:pt>
                <c:pt idx="86">
                  <c:v>35.408380000000001</c:v>
                </c:pt>
                <c:pt idx="87">
                  <c:v>34.812259999999995</c:v>
                </c:pt>
                <c:pt idx="88">
                  <c:v>34.358840000000001</c:v>
                </c:pt>
                <c:pt idx="89">
                  <c:v>33.92398</c:v>
                </c:pt>
                <c:pt idx="90">
                  <c:v>33.4878</c:v>
                </c:pt>
                <c:pt idx="91">
                  <c:v>33.303759999999997</c:v>
                </c:pt>
                <c:pt idx="92">
                  <c:v>32.971559999999997</c:v>
                </c:pt>
                <c:pt idx="93">
                  <c:v>32.324339999999999</c:v>
                </c:pt>
                <c:pt idx="94">
                  <c:v>31.78078</c:v>
                </c:pt>
                <c:pt idx="95">
                  <c:v>31.14368</c:v>
                </c:pt>
                <c:pt idx="96">
                  <c:v>30.266059999999996</c:v>
                </c:pt>
                <c:pt idx="97">
                  <c:v>29.8614</c:v>
                </c:pt>
                <c:pt idx="98">
                  <c:v>29.389120000000002</c:v>
                </c:pt>
                <c:pt idx="99">
                  <c:v>29.253859999999996</c:v>
                </c:pt>
                <c:pt idx="100">
                  <c:v>28.690440000000002</c:v>
                </c:pt>
                <c:pt idx="101">
                  <c:v>28.34402</c:v>
                </c:pt>
                <c:pt idx="102">
                  <c:v>28.041520000000002</c:v>
                </c:pt>
                <c:pt idx="103">
                  <c:v>27.485900000000001</c:v>
                </c:pt>
                <c:pt idx="104">
                  <c:v>27.476299999999998</c:v>
                </c:pt>
                <c:pt idx="105">
                  <c:v>26.98338</c:v>
                </c:pt>
                <c:pt idx="106">
                  <c:v>26.592559999999999</c:v>
                </c:pt>
                <c:pt idx="107">
                  <c:v>26.15418</c:v>
                </c:pt>
                <c:pt idx="108">
                  <c:v>25.901679999999999</c:v>
                </c:pt>
                <c:pt idx="109">
                  <c:v>25.63222</c:v>
                </c:pt>
                <c:pt idx="110">
                  <c:v>25.494320000000002</c:v>
                </c:pt>
                <c:pt idx="111">
                  <c:v>25.074100000000001</c:v>
                </c:pt>
                <c:pt idx="112">
                  <c:v>24.763259999999999</c:v>
                </c:pt>
                <c:pt idx="113">
                  <c:v>24.632140000000003</c:v>
                </c:pt>
                <c:pt idx="114">
                  <c:v>24.44022</c:v>
                </c:pt>
                <c:pt idx="115">
                  <c:v>24.359640000000002</c:v>
                </c:pt>
                <c:pt idx="116">
                  <c:v>24.308640000000004</c:v>
                </c:pt>
                <c:pt idx="117">
                  <c:v>24.176079999999999</c:v>
                </c:pt>
                <c:pt idx="118">
                  <c:v>24.052220000000002</c:v>
                </c:pt>
                <c:pt idx="119">
                  <c:v>24.680979999999998</c:v>
                </c:pt>
                <c:pt idx="120">
                  <c:v>23.595979999999997</c:v>
                </c:pt>
                <c:pt idx="121">
                  <c:v>23.282699999999998</c:v>
                </c:pt>
                <c:pt idx="122">
                  <c:v>23.330159999999999</c:v>
                </c:pt>
                <c:pt idx="123">
                  <c:v>23.088279999999997</c:v>
                </c:pt>
                <c:pt idx="124">
                  <c:v>22.803540000000002</c:v>
                </c:pt>
                <c:pt idx="125">
                  <c:v>22.796059999999997</c:v>
                </c:pt>
                <c:pt idx="126">
                  <c:v>22.656400000000001</c:v>
                </c:pt>
                <c:pt idx="127">
                  <c:v>22.362359999999999</c:v>
                </c:pt>
                <c:pt idx="128">
                  <c:v>22.230859999999996</c:v>
                </c:pt>
                <c:pt idx="129">
                  <c:v>22.03062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669-4512-8354-41A441E4E4D4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Y$17:$BY$146</c:f>
              <c:numCache>
                <c:formatCode>0.00</c:formatCode>
                <c:ptCount val="130"/>
                <c:pt idx="0">
                  <c:v>69.30086</c:v>
                </c:pt>
                <c:pt idx="1">
                  <c:v>77.88188000000001</c:v>
                </c:pt>
                <c:pt idx="2">
                  <c:v>77.320419999999999</c:v>
                </c:pt>
                <c:pt idx="3">
                  <c:v>74.502279999999999</c:v>
                </c:pt>
                <c:pt idx="4">
                  <c:v>71.707280000000011</c:v>
                </c:pt>
                <c:pt idx="5">
                  <c:v>68.161319999999989</c:v>
                </c:pt>
                <c:pt idx="6">
                  <c:v>63.289680000000004</c:v>
                </c:pt>
                <c:pt idx="7">
                  <c:v>58.828980000000001</c:v>
                </c:pt>
                <c:pt idx="8">
                  <c:v>54.8185</c:v>
                </c:pt>
                <c:pt idx="9">
                  <c:v>50.931179999999998</c:v>
                </c:pt>
                <c:pt idx="10">
                  <c:v>47.998959999999997</c:v>
                </c:pt>
                <c:pt idx="11">
                  <c:v>45.202820000000003</c:v>
                </c:pt>
                <c:pt idx="12">
                  <c:v>42.783900000000003</c:v>
                </c:pt>
                <c:pt idx="13">
                  <c:v>40.57152</c:v>
                </c:pt>
                <c:pt idx="14">
                  <c:v>39.169140000000006</c:v>
                </c:pt>
                <c:pt idx="15">
                  <c:v>38.565579999999997</c:v>
                </c:pt>
                <c:pt idx="16">
                  <c:v>37.0867</c:v>
                </c:pt>
                <c:pt idx="17">
                  <c:v>36.240780000000001</c:v>
                </c:pt>
                <c:pt idx="18">
                  <c:v>35.400019999999998</c:v>
                </c:pt>
                <c:pt idx="19">
                  <c:v>35.074179999999998</c:v>
                </c:pt>
                <c:pt idx="20">
                  <c:v>35.127520000000004</c:v>
                </c:pt>
                <c:pt idx="21">
                  <c:v>35.933540000000001</c:v>
                </c:pt>
                <c:pt idx="22">
                  <c:v>36.740180000000002</c:v>
                </c:pt>
                <c:pt idx="23">
                  <c:v>38.487699999999997</c:v>
                </c:pt>
                <c:pt idx="24">
                  <c:v>40.840240000000001</c:v>
                </c:pt>
                <c:pt idx="25">
                  <c:v>43.765720000000002</c:v>
                </c:pt>
                <c:pt idx="26">
                  <c:v>46.623199999999997</c:v>
                </c:pt>
                <c:pt idx="27">
                  <c:v>49.809159999999999</c:v>
                </c:pt>
                <c:pt idx="28">
                  <c:v>52.994980000000005</c:v>
                </c:pt>
                <c:pt idx="29">
                  <c:v>55.894219999999997</c:v>
                </c:pt>
                <c:pt idx="30">
                  <c:v>58.948059999999998</c:v>
                </c:pt>
                <c:pt idx="31">
                  <c:v>62.057559999999995</c:v>
                </c:pt>
                <c:pt idx="32">
                  <c:v>64.335259999999991</c:v>
                </c:pt>
                <c:pt idx="33">
                  <c:v>66.528680000000008</c:v>
                </c:pt>
                <c:pt idx="34">
                  <c:v>66.273499999999999</c:v>
                </c:pt>
                <c:pt idx="35">
                  <c:v>66.163139999999999</c:v>
                </c:pt>
                <c:pt idx="36">
                  <c:v>66.621080000000006</c:v>
                </c:pt>
                <c:pt idx="37">
                  <c:v>65.630840000000006</c:v>
                </c:pt>
                <c:pt idx="38">
                  <c:v>65.233540000000005</c:v>
                </c:pt>
                <c:pt idx="39">
                  <c:v>63.948880000000003</c:v>
                </c:pt>
                <c:pt idx="40">
                  <c:v>62.181719999999999</c:v>
                </c:pt>
                <c:pt idx="41">
                  <c:v>60.814280000000004</c:v>
                </c:pt>
                <c:pt idx="42">
                  <c:v>60.378599999999999</c:v>
                </c:pt>
                <c:pt idx="43">
                  <c:v>60.289700000000003</c:v>
                </c:pt>
                <c:pt idx="44">
                  <c:v>59.412659999999995</c:v>
                </c:pt>
                <c:pt idx="45">
                  <c:v>58.358600000000003</c:v>
                </c:pt>
                <c:pt idx="46">
                  <c:v>57.456740000000003</c:v>
                </c:pt>
                <c:pt idx="47">
                  <c:v>56.671300000000002</c:v>
                </c:pt>
                <c:pt idx="48">
                  <c:v>55.856140000000003</c:v>
                </c:pt>
                <c:pt idx="49">
                  <c:v>54.692319999999995</c:v>
                </c:pt>
                <c:pt idx="50">
                  <c:v>54.561</c:v>
                </c:pt>
                <c:pt idx="51">
                  <c:v>52.8902</c:v>
                </c:pt>
                <c:pt idx="52">
                  <c:v>51.799880000000002</c:v>
                </c:pt>
                <c:pt idx="53">
                  <c:v>50.470799999999997</c:v>
                </c:pt>
                <c:pt idx="54">
                  <c:v>49.512999999999998</c:v>
                </c:pt>
                <c:pt idx="55">
                  <c:v>49.417859999999997</c:v>
                </c:pt>
                <c:pt idx="56">
                  <c:v>48.636920000000003</c:v>
                </c:pt>
                <c:pt idx="57">
                  <c:v>48.233759999999997</c:v>
                </c:pt>
                <c:pt idx="58">
                  <c:v>48.168779999999998</c:v>
                </c:pt>
                <c:pt idx="59">
                  <c:v>48.177300000000002</c:v>
                </c:pt>
                <c:pt idx="60">
                  <c:v>48.571959999999997</c:v>
                </c:pt>
                <c:pt idx="61">
                  <c:v>48.795320000000004</c:v>
                </c:pt>
                <c:pt idx="62">
                  <c:v>48.876059999999995</c:v>
                </c:pt>
                <c:pt idx="63">
                  <c:v>48.802340000000001</c:v>
                </c:pt>
                <c:pt idx="64">
                  <c:v>47.836799999999997</c:v>
                </c:pt>
                <c:pt idx="65">
                  <c:v>46.719940000000001</c:v>
                </c:pt>
                <c:pt idx="66">
                  <c:v>45.534520000000001</c:v>
                </c:pt>
                <c:pt idx="67">
                  <c:v>44.373199999999997</c:v>
                </c:pt>
                <c:pt idx="68">
                  <c:v>43.181259999999995</c:v>
                </c:pt>
                <c:pt idx="69">
                  <c:v>41.901859999999999</c:v>
                </c:pt>
                <c:pt idx="70">
                  <c:v>41.32602</c:v>
                </c:pt>
                <c:pt idx="71">
                  <c:v>40.477879999999999</c:v>
                </c:pt>
                <c:pt idx="72">
                  <c:v>39.884859999999996</c:v>
                </c:pt>
                <c:pt idx="73">
                  <c:v>39.037880000000001</c:v>
                </c:pt>
                <c:pt idx="74">
                  <c:v>38.55068</c:v>
                </c:pt>
                <c:pt idx="75">
                  <c:v>38.59252</c:v>
                </c:pt>
                <c:pt idx="76">
                  <c:v>37.995740000000005</c:v>
                </c:pt>
                <c:pt idx="77">
                  <c:v>37.203020000000002</c:v>
                </c:pt>
                <c:pt idx="78">
                  <c:v>36.703600000000002</c:v>
                </c:pt>
                <c:pt idx="79">
                  <c:v>36.049999999999997</c:v>
                </c:pt>
                <c:pt idx="80">
                  <c:v>35.998440000000002</c:v>
                </c:pt>
                <c:pt idx="81">
                  <c:v>35.882300000000001</c:v>
                </c:pt>
                <c:pt idx="82">
                  <c:v>35.744340000000001</c:v>
                </c:pt>
                <c:pt idx="83">
                  <c:v>35.370420000000003</c:v>
                </c:pt>
                <c:pt idx="84">
                  <c:v>34.582320000000003</c:v>
                </c:pt>
                <c:pt idx="85">
                  <c:v>34.287259999999996</c:v>
                </c:pt>
                <c:pt idx="86">
                  <c:v>33.49718</c:v>
                </c:pt>
                <c:pt idx="87">
                  <c:v>32.82676</c:v>
                </c:pt>
                <c:pt idx="88">
                  <c:v>31.972940000000001</c:v>
                </c:pt>
                <c:pt idx="89">
                  <c:v>31.397579999999998</c:v>
                </c:pt>
                <c:pt idx="90">
                  <c:v>31.013400000000001</c:v>
                </c:pt>
                <c:pt idx="91">
                  <c:v>30.583759999999998</c:v>
                </c:pt>
                <c:pt idx="92">
                  <c:v>30.106759999999998</c:v>
                </c:pt>
                <c:pt idx="93">
                  <c:v>29.980740000000001</c:v>
                </c:pt>
                <c:pt idx="94">
                  <c:v>29.743279999999999</c:v>
                </c:pt>
                <c:pt idx="95">
                  <c:v>30.022179999999999</c:v>
                </c:pt>
                <c:pt idx="96">
                  <c:v>29.620659999999997</c:v>
                </c:pt>
                <c:pt idx="97">
                  <c:v>29.933900000000001</c:v>
                </c:pt>
                <c:pt idx="98">
                  <c:v>30.086020000000001</c:v>
                </c:pt>
                <c:pt idx="99">
                  <c:v>30.142359999999996</c:v>
                </c:pt>
                <c:pt idx="100">
                  <c:v>29.656340000000004</c:v>
                </c:pt>
                <c:pt idx="101">
                  <c:v>29.38692</c:v>
                </c:pt>
                <c:pt idx="102">
                  <c:v>28.90222</c:v>
                </c:pt>
                <c:pt idx="103">
                  <c:v>28.173500000000001</c:v>
                </c:pt>
                <c:pt idx="104">
                  <c:v>27.8935</c:v>
                </c:pt>
                <c:pt idx="105">
                  <c:v>27.260679999999997</c:v>
                </c:pt>
                <c:pt idx="106">
                  <c:v>26.890759999999997</c:v>
                </c:pt>
                <c:pt idx="107">
                  <c:v>26.529579999999999</c:v>
                </c:pt>
                <c:pt idx="108">
                  <c:v>26.005779999999998</c:v>
                </c:pt>
                <c:pt idx="109">
                  <c:v>25.567320000000002</c:v>
                </c:pt>
                <c:pt idx="110">
                  <c:v>25.33642</c:v>
                </c:pt>
                <c:pt idx="111">
                  <c:v>24.945900000000002</c:v>
                </c:pt>
                <c:pt idx="112">
                  <c:v>24.380859999999998</c:v>
                </c:pt>
                <c:pt idx="113">
                  <c:v>24.237140000000004</c:v>
                </c:pt>
                <c:pt idx="114">
                  <c:v>24.119820000000001</c:v>
                </c:pt>
                <c:pt idx="115">
                  <c:v>23.940640000000002</c:v>
                </c:pt>
                <c:pt idx="116">
                  <c:v>23.972640000000002</c:v>
                </c:pt>
                <c:pt idx="117">
                  <c:v>23.74438</c:v>
                </c:pt>
                <c:pt idx="118">
                  <c:v>23.399319999999999</c:v>
                </c:pt>
                <c:pt idx="119">
                  <c:v>23.342579999999998</c:v>
                </c:pt>
                <c:pt idx="120">
                  <c:v>23.14208</c:v>
                </c:pt>
                <c:pt idx="121">
                  <c:v>22.876999999999999</c:v>
                </c:pt>
                <c:pt idx="122">
                  <c:v>22.887159999999998</c:v>
                </c:pt>
                <c:pt idx="123">
                  <c:v>22.944579999999998</c:v>
                </c:pt>
                <c:pt idx="124">
                  <c:v>22.395040000000002</c:v>
                </c:pt>
                <c:pt idx="125">
                  <c:v>22.237559999999998</c:v>
                </c:pt>
                <c:pt idx="126">
                  <c:v>21.970700000000001</c:v>
                </c:pt>
                <c:pt idx="127">
                  <c:v>21.871159999999996</c:v>
                </c:pt>
                <c:pt idx="128">
                  <c:v>21.607159999999997</c:v>
                </c:pt>
                <c:pt idx="129">
                  <c:v>21.35102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669-4512-8354-41A441E4E4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345408"/>
        <c:axId val="63346944"/>
      </c:lineChart>
      <c:catAx>
        <c:axId val="63345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334694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334694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33454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T$17:$BT$146</c:f>
              <c:numCache>
                <c:formatCode>0.00</c:formatCode>
                <c:ptCount val="130"/>
                <c:pt idx="0">
                  <c:v>67.734160000000003</c:v>
                </c:pt>
                <c:pt idx="1">
                  <c:v>72.944479999999999</c:v>
                </c:pt>
                <c:pt idx="2">
                  <c:v>74.621919999999989</c:v>
                </c:pt>
                <c:pt idx="3">
                  <c:v>75.020180000000011</c:v>
                </c:pt>
                <c:pt idx="4">
                  <c:v>73.162779999999998</c:v>
                </c:pt>
                <c:pt idx="5">
                  <c:v>70.861719999999991</c:v>
                </c:pt>
                <c:pt idx="6">
                  <c:v>68.477080000000001</c:v>
                </c:pt>
                <c:pt idx="7">
                  <c:v>65.963480000000004</c:v>
                </c:pt>
                <c:pt idx="8">
                  <c:v>63.916499999999999</c:v>
                </c:pt>
                <c:pt idx="9">
                  <c:v>62.735880000000002</c:v>
                </c:pt>
                <c:pt idx="10">
                  <c:v>62.731259999999999</c:v>
                </c:pt>
                <c:pt idx="11">
                  <c:v>64.08471999999999</c:v>
                </c:pt>
                <c:pt idx="12">
                  <c:v>66.989000000000004</c:v>
                </c:pt>
                <c:pt idx="13">
                  <c:v>71.674819999999997</c:v>
                </c:pt>
                <c:pt idx="14">
                  <c:v>77.894940000000005</c:v>
                </c:pt>
                <c:pt idx="15">
                  <c:v>86.479680000000002</c:v>
                </c:pt>
                <c:pt idx="16">
                  <c:v>97.621600000000001</c:v>
                </c:pt>
                <c:pt idx="17">
                  <c:v>111.38328</c:v>
                </c:pt>
                <c:pt idx="18">
                  <c:v>125.12652</c:v>
                </c:pt>
                <c:pt idx="19">
                  <c:v>138.52137999999999</c:v>
                </c:pt>
                <c:pt idx="20">
                  <c:v>148.17831999999999</c:v>
                </c:pt>
                <c:pt idx="21">
                  <c:v>154.85893999999999</c:v>
                </c:pt>
                <c:pt idx="22">
                  <c:v>159.09788</c:v>
                </c:pt>
                <c:pt idx="23">
                  <c:v>162.5446</c:v>
                </c:pt>
                <c:pt idx="24">
                  <c:v>162.66793999999999</c:v>
                </c:pt>
                <c:pt idx="25">
                  <c:v>161.16752</c:v>
                </c:pt>
                <c:pt idx="26">
                  <c:v>158.19739999999999</c:v>
                </c:pt>
                <c:pt idx="27">
                  <c:v>154.31786</c:v>
                </c:pt>
                <c:pt idx="28">
                  <c:v>150.64168000000001</c:v>
                </c:pt>
                <c:pt idx="29">
                  <c:v>144.83212</c:v>
                </c:pt>
                <c:pt idx="30">
                  <c:v>138.80966000000001</c:v>
                </c:pt>
                <c:pt idx="31">
                  <c:v>133.63736</c:v>
                </c:pt>
                <c:pt idx="32">
                  <c:v>128.53516000000002</c:v>
                </c:pt>
                <c:pt idx="33">
                  <c:v>123.33328</c:v>
                </c:pt>
                <c:pt idx="34">
                  <c:v>118.1246</c:v>
                </c:pt>
                <c:pt idx="35">
                  <c:v>116.12813999999999</c:v>
                </c:pt>
                <c:pt idx="36">
                  <c:v>112.56448</c:v>
                </c:pt>
                <c:pt idx="37">
                  <c:v>107.47554</c:v>
                </c:pt>
                <c:pt idx="38">
                  <c:v>103.73194000000001</c:v>
                </c:pt>
                <c:pt idx="39">
                  <c:v>101.36698</c:v>
                </c:pt>
                <c:pt idx="40">
                  <c:v>100.42131999999999</c:v>
                </c:pt>
                <c:pt idx="41">
                  <c:v>100.52668</c:v>
                </c:pt>
                <c:pt idx="42">
                  <c:v>101.5909</c:v>
                </c:pt>
                <c:pt idx="43">
                  <c:v>103.351</c:v>
                </c:pt>
                <c:pt idx="44">
                  <c:v>104.81196</c:v>
                </c:pt>
                <c:pt idx="45">
                  <c:v>106.515</c:v>
                </c:pt>
                <c:pt idx="46">
                  <c:v>109.69293999999999</c:v>
                </c:pt>
                <c:pt idx="47">
                  <c:v>113.3853</c:v>
                </c:pt>
                <c:pt idx="48">
                  <c:v>115.78133999999999</c:v>
                </c:pt>
                <c:pt idx="49">
                  <c:v>117.60802</c:v>
                </c:pt>
                <c:pt idx="50">
                  <c:v>118.13120000000001</c:v>
                </c:pt>
                <c:pt idx="51">
                  <c:v>117.4759</c:v>
                </c:pt>
                <c:pt idx="52">
                  <c:v>117.17098</c:v>
                </c:pt>
                <c:pt idx="53">
                  <c:v>114.0823</c:v>
                </c:pt>
                <c:pt idx="54">
                  <c:v>111.5265</c:v>
                </c:pt>
                <c:pt idx="55">
                  <c:v>108.38006000000001</c:v>
                </c:pt>
                <c:pt idx="56">
                  <c:v>104.72861999999999</c:v>
                </c:pt>
                <c:pt idx="57">
                  <c:v>100.56596</c:v>
                </c:pt>
                <c:pt idx="58">
                  <c:v>97.244280000000003</c:v>
                </c:pt>
                <c:pt idx="59">
                  <c:v>93.694699999999997</c:v>
                </c:pt>
                <c:pt idx="60">
                  <c:v>89.624160000000003</c:v>
                </c:pt>
                <c:pt idx="61">
                  <c:v>86.109719999999996</c:v>
                </c:pt>
                <c:pt idx="62">
                  <c:v>82.185659999999999</c:v>
                </c:pt>
                <c:pt idx="63">
                  <c:v>78.234440000000006</c:v>
                </c:pt>
                <c:pt idx="64">
                  <c:v>76.053700000000006</c:v>
                </c:pt>
                <c:pt idx="65">
                  <c:v>74.319240000000008</c:v>
                </c:pt>
                <c:pt idx="66">
                  <c:v>73.01151999999999</c:v>
                </c:pt>
                <c:pt idx="67">
                  <c:v>71.902900000000002</c:v>
                </c:pt>
                <c:pt idx="68">
                  <c:v>71.327259999999995</c:v>
                </c:pt>
                <c:pt idx="69">
                  <c:v>70.729060000000004</c:v>
                </c:pt>
                <c:pt idx="70">
                  <c:v>70.663719999999998</c:v>
                </c:pt>
                <c:pt idx="71">
                  <c:v>70.401380000000003</c:v>
                </c:pt>
                <c:pt idx="72">
                  <c:v>70.853259999999992</c:v>
                </c:pt>
                <c:pt idx="73">
                  <c:v>71.019580000000005</c:v>
                </c:pt>
                <c:pt idx="74">
                  <c:v>71.476480000000009</c:v>
                </c:pt>
                <c:pt idx="75">
                  <c:v>71.470919999999992</c:v>
                </c:pt>
                <c:pt idx="76">
                  <c:v>71.338840000000005</c:v>
                </c:pt>
                <c:pt idx="77">
                  <c:v>70.393519999999995</c:v>
                </c:pt>
                <c:pt idx="78">
                  <c:v>69.890600000000006</c:v>
                </c:pt>
                <c:pt idx="79">
                  <c:v>68.553299999999993</c:v>
                </c:pt>
                <c:pt idx="80">
                  <c:v>67.58614</c:v>
                </c:pt>
                <c:pt idx="81">
                  <c:v>66.741</c:v>
                </c:pt>
                <c:pt idx="82">
                  <c:v>65.441339999999997</c:v>
                </c:pt>
                <c:pt idx="83">
                  <c:v>63.589219999999997</c:v>
                </c:pt>
                <c:pt idx="84">
                  <c:v>61.903319999999994</c:v>
                </c:pt>
                <c:pt idx="85">
                  <c:v>60.467259999999996</c:v>
                </c:pt>
                <c:pt idx="86">
                  <c:v>58.523680000000006</c:v>
                </c:pt>
                <c:pt idx="87">
                  <c:v>57.04806</c:v>
                </c:pt>
                <c:pt idx="88">
                  <c:v>55.852340000000005</c:v>
                </c:pt>
                <c:pt idx="89">
                  <c:v>54.692480000000003</c:v>
                </c:pt>
                <c:pt idx="90">
                  <c:v>53.3538</c:v>
                </c:pt>
                <c:pt idx="91">
                  <c:v>52.699559999999998</c:v>
                </c:pt>
                <c:pt idx="92">
                  <c:v>51.707560000000001</c:v>
                </c:pt>
                <c:pt idx="93">
                  <c:v>50.994640000000004</c:v>
                </c:pt>
                <c:pt idx="94">
                  <c:v>50.749980000000001</c:v>
                </c:pt>
                <c:pt idx="95">
                  <c:v>50.84028</c:v>
                </c:pt>
                <c:pt idx="96">
                  <c:v>50.42736</c:v>
                </c:pt>
                <c:pt idx="97">
                  <c:v>50.4619</c:v>
                </c:pt>
                <c:pt idx="98">
                  <c:v>50.289720000000003</c:v>
                </c:pt>
                <c:pt idx="99">
                  <c:v>50.530659999999997</c:v>
                </c:pt>
                <c:pt idx="100">
                  <c:v>50.314440000000005</c:v>
                </c:pt>
                <c:pt idx="101">
                  <c:v>50.291519999999998</c:v>
                </c:pt>
                <c:pt idx="102">
                  <c:v>50.091619999999999</c:v>
                </c:pt>
                <c:pt idx="103">
                  <c:v>49.267400000000002</c:v>
                </c:pt>
                <c:pt idx="104">
                  <c:v>49.045999999999999</c:v>
                </c:pt>
                <c:pt idx="105">
                  <c:v>48.325980000000001</c:v>
                </c:pt>
                <c:pt idx="106">
                  <c:v>47.897659999999995</c:v>
                </c:pt>
                <c:pt idx="107">
                  <c:v>47.207079999999998</c:v>
                </c:pt>
                <c:pt idx="108">
                  <c:v>46.290179999999999</c:v>
                </c:pt>
                <c:pt idx="109">
                  <c:v>45.96622</c:v>
                </c:pt>
                <c:pt idx="110">
                  <c:v>45.506920000000001</c:v>
                </c:pt>
                <c:pt idx="111">
                  <c:v>44.563099999999999</c:v>
                </c:pt>
                <c:pt idx="112">
                  <c:v>43.556159999999998</c:v>
                </c:pt>
                <c:pt idx="113">
                  <c:v>42.789640000000006</c:v>
                </c:pt>
                <c:pt idx="114">
                  <c:v>42.226019999999998</c:v>
                </c:pt>
                <c:pt idx="115">
                  <c:v>41.487740000000002</c:v>
                </c:pt>
                <c:pt idx="116">
                  <c:v>40.891040000000004</c:v>
                </c:pt>
                <c:pt idx="117">
                  <c:v>40.113680000000002</c:v>
                </c:pt>
                <c:pt idx="118">
                  <c:v>39.652619999999999</c:v>
                </c:pt>
                <c:pt idx="119">
                  <c:v>39.437579999999997</c:v>
                </c:pt>
                <c:pt idx="120">
                  <c:v>39.209379999999996</c:v>
                </c:pt>
                <c:pt idx="121">
                  <c:v>39.088000000000001</c:v>
                </c:pt>
                <c:pt idx="122">
                  <c:v>38.964259999999996</c:v>
                </c:pt>
                <c:pt idx="123">
                  <c:v>38.916179999999997</c:v>
                </c:pt>
                <c:pt idx="124">
                  <c:v>38.459540000000004</c:v>
                </c:pt>
                <c:pt idx="125">
                  <c:v>38.272559999999999</c:v>
                </c:pt>
                <c:pt idx="126">
                  <c:v>37.945999999999998</c:v>
                </c:pt>
                <c:pt idx="127">
                  <c:v>37.49756</c:v>
                </c:pt>
                <c:pt idx="128">
                  <c:v>37.130159999999997</c:v>
                </c:pt>
                <c:pt idx="129">
                  <c:v>36.629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D25-47B8-B257-03F4AA42F46D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U$17:$BU$146</c:f>
              <c:numCache>
                <c:formatCode>0.00</c:formatCode>
                <c:ptCount val="130"/>
                <c:pt idx="0">
                  <c:v>52.378059999999998</c:v>
                </c:pt>
                <c:pt idx="1">
                  <c:v>54.972180000000002</c:v>
                </c:pt>
                <c:pt idx="2">
                  <c:v>54.568819999999995</c:v>
                </c:pt>
                <c:pt idx="3">
                  <c:v>53.531680000000001</c:v>
                </c:pt>
                <c:pt idx="4">
                  <c:v>51.637679999999996</c:v>
                </c:pt>
                <c:pt idx="5">
                  <c:v>50.347619999999999</c:v>
                </c:pt>
                <c:pt idx="6">
                  <c:v>49.037079999999996</c:v>
                </c:pt>
                <c:pt idx="7">
                  <c:v>47.968879999999999</c:v>
                </c:pt>
                <c:pt idx="8">
                  <c:v>48.212499999999999</c:v>
                </c:pt>
                <c:pt idx="9">
                  <c:v>48.878579999999999</c:v>
                </c:pt>
                <c:pt idx="10">
                  <c:v>50.946159999999999</c:v>
                </c:pt>
                <c:pt idx="11">
                  <c:v>54.376019999999997</c:v>
                </c:pt>
                <c:pt idx="12">
                  <c:v>59.747700000000002</c:v>
                </c:pt>
                <c:pt idx="13">
                  <c:v>67.23411999999999</c:v>
                </c:pt>
                <c:pt idx="14">
                  <c:v>76.62894</c:v>
                </c:pt>
                <c:pt idx="15">
                  <c:v>88.483980000000003</c:v>
                </c:pt>
                <c:pt idx="16">
                  <c:v>100.444</c:v>
                </c:pt>
                <c:pt idx="17">
                  <c:v>111.68078</c:v>
                </c:pt>
                <c:pt idx="18">
                  <c:v>120.18501999999999</c:v>
                </c:pt>
                <c:pt idx="19">
                  <c:v>127.15798000000001</c:v>
                </c:pt>
                <c:pt idx="20">
                  <c:v>131.58712</c:v>
                </c:pt>
                <c:pt idx="21">
                  <c:v>134.11123999999998</c:v>
                </c:pt>
                <c:pt idx="22">
                  <c:v>136.18648000000002</c:v>
                </c:pt>
                <c:pt idx="23">
                  <c:v>136.65459999999999</c:v>
                </c:pt>
                <c:pt idx="24">
                  <c:v>138.29643999999999</c:v>
                </c:pt>
                <c:pt idx="25">
                  <c:v>137.64661999999998</c:v>
                </c:pt>
                <c:pt idx="26">
                  <c:v>135.71039999999999</c:v>
                </c:pt>
                <c:pt idx="27">
                  <c:v>132.72206</c:v>
                </c:pt>
                <c:pt idx="28">
                  <c:v>128.28698</c:v>
                </c:pt>
                <c:pt idx="29">
                  <c:v>123.99122</c:v>
                </c:pt>
                <c:pt idx="30">
                  <c:v>119.99786</c:v>
                </c:pt>
                <c:pt idx="31">
                  <c:v>116.44236000000001</c:v>
                </c:pt>
                <c:pt idx="32">
                  <c:v>113.16276000000001</c:v>
                </c:pt>
                <c:pt idx="33">
                  <c:v>109.78318</c:v>
                </c:pt>
                <c:pt idx="34">
                  <c:v>107.4346</c:v>
                </c:pt>
                <c:pt idx="35">
                  <c:v>104.91824</c:v>
                </c:pt>
                <c:pt idx="36">
                  <c:v>102.09118000000001</c:v>
                </c:pt>
                <c:pt idx="37">
                  <c:v>100.42244000000001</c:v>
                </c:pt>
                <c:pt idx="38">
                  <c:v>101.13384000000001</c:v>
                </c:pt>
                <c:pt idx="39">
                  <c:v>102.84518</c:v>
                </c:pt>
                <c:pt idx="40">
                  <c:v>104.97951999999999</c:v>
                </c:pt>
                <c:pt idx="41">
                  <c:v>107.56608</c:v>
                </c:pt>
                <c:pt idx="42">
                  <c:v>109.83</c:v>
                </c:pt>
                <c:pt idx="43">
                  <c:v>109.4961</c:v>
                </c:pt>
                <c:pt idx="44">
                  <c:v>107.64576000000001</c:v>
                </c:pt>
                <c:pt idx="45">
                  <c:v>105.2602</c:v>
                </c:pt>
                <c:pt idx="46">
                  <c:v>102.75634000000001</c:v>
                </c:pt>
                <c:pt idx="47">
                  <c:v>100.7996</c:v>
                </c:pt>
                <c:pt idx="48">
                  <c:v>98.646540000000002</c:v>
                </c:pt>
                <c:pt idx="49">
                  <c:v>96.33771999999999</c:v>
                </c:pt>
                <c:pt idx="50">
                  <c:v>94.155600000000007</c:v>
                </c:pt>
                <c:pt idx="51">
                  <c:v>91.4666</c:v>
                </c:pt>
                <c:pt idx="52">
                  <c:v>88.627380000000002</c:v>
                </c:pt>
                <c:pt idx="53">
                  <c:v>84.923000000000002</c:v>
                </c:pt>
                <c:pt idx="54">
                  <c:v>82.476200000000006</c:v>
                </c:pt>
                <c:pt idx="55">
                  <c:v>79.580659999999995</c:v>
                </c:pt>
                <c:pt idx="56">
                  <c:v>76.683419999999998</c:v>
                </c:pt>
                <c:pt idx="57">
                  <c:v>74.14246</c:v>
                </c:pt>
                <c:pt idx="58">
                  <c:v>71.270880000000005</c:v>
                </c:pt>
                <c:pt idx="59">
                  <c:v>69.485900000000001</c:v>
                </c:pt>
                <c:pt idx="60">
                  <c:v>68.523259999999993</c:v>
                </c:pt>
                <c:pt idx="61">
                  <c:v>68.047619999999995</c:v>
                </c:pt>
                <c:pt idx="62">
                  <c:v>68.653260000000003</c:v>
                </c:pt>
                <c:pt idx="63">
                  <c:v>69.226740000000007</c:v>
                </c:pt>
                <c:pt idx="64">
                  <c:v>69.699399999999997</c:v>
                </c:pt>
                <c:pt idx="65">
                  <c:v>70.032139999999998</c:v>
                </c:pt>
                <c:pt idx="66">
                  <c:v>70.162520000000001</c:v>
                </c:pt>
                <c:pt idx="67">
                  <c:v>70.697100000000006</c:v>
                </c:pt>
                <c:pt idx="68">
                  <c:v>70.860759999999999</c:v>
                </c:pt>
                <c:pt idx="69">
                  <c:v>70.472259999999991</c:v>
                </c:pt>
                <c:pt idx="70">
                  <c:v>70.839219999999997</c:v>
                </c:pt>
                <c:pt idx="71">
                  <c:v>70.129379999999998</c:v>
                </c:pt>
                <c:pt idx="72">
                  <c:v>69.314059999999998</c:v>
                </c:pt>
                <c:pt idx="73">
                  <c:v>67.845579999999998</c:v>
                </c:pt>
                <c:pt idx="74">
                  <c:v>66.49148000000001</c:v>
                </c:pt>
                <c:pt idx="75">
                  <c:v>65.08202</c:v>
                </c:pt>
                <c:pt idx="76">
                  <c:v>62.885840000000002</c:v>
                </c:pt>
                <c:pt idx="77">
                  <c:v>61.195119999999996</c:v>
                </c:pt>
                <c:pt idx="78">
                  <c:v>59.499000000000002</c:v>
                </c:pt>
                <c:pt idx="79">
                  <c:v>58.185299999999998</c:v>
                </c:pt>
                <c:pt idx="80">
                  <c:v>57.379840000000002</c:v>
                </c:pt>
                <c:pt idx="81">
                  <c:v>56.807200000000002</c:v>
                </c:pt>
                <c:pt idx="82">
                  <c:v>56.712040000000002</c:v>
                </c:pt>
                <c:pt idx="83">
                  <c:v>56.127519999999997</c:v>
                </c:pt>
                <c:pt idx="84">
                  <c:v>55.610219999999998</c:v>
                </c:pt>
                <c:pt idx="85">
                  <c:v>55.637259999999998</c:v>
                </c:pt>
                <c:pt idx="86">
                  <c:v>55.443180000000005</c:v>
                </c:pt>
                <c:pt idx="87">
                  <c:v>54.529260000000001</c:v>
                </c:pt>
                <c:pt idx="88">
                  <c:v>54.376339999999999</c:v>
                </c:pt>
                <c:pt idx="89">
                  <c:v>54.083680000000008</c:v>
                </c:pt>
                <c:pt idx="90">
                  <c:v>53.7575</c:v>
                </c:pt>
                <c:pt idx="91">
                  <c:v>53.901759999999996</c:v>
                </c:pt>
                <c:pt idx="92">
                  <c:v>53.351859999999995</c:v>
                </c:pt>
                <c:pt idx="93">
                  <c:v>53.101939999999999</c:v>
                </c:pt>
                <c:pt idx="94">
                  <c:v>53.217180000000006</c:v>
                </c:pt>
                <c:pt idx="95">
                  <c:v>52.826380000000007</c:v>
                </c:pt>
                <c:pt idx="96">
                  <c:v>52.189459999999997</c:v>
                </c:pt>
                <c:pt idx="97">
                  <c:v>51.672400000000003</c:v>
                </c:pt>
                <c:pt idx="98">
                  <c:v>51.189520000000002</c:v>
                </c:pt>
                <c:pt idx="99">
                  <c:v>50.868259999999999</c:v>
                </c:pt>
                <c:pt idx="100">
                  <c:v>50.346740000000004</c:v>
                </c:pt>
                <c:pt idx="101">
                  <c:v>49.97092</c:v>
                </c:pt>
                <c:pt idx="102">
                  <c:v>49.171720000000001</c:v>
                </c:pt>
                <c:pt idx="103">
                  <c:v>48.413600000000002</c:v>
                </c:pt>
                <c:pt idx="104">
                  <c:v>47.8917</c:v>
                </c:pt>
                <c:pt idx="105">
                  <c:v>46.98518</c:v>
                </c:pt>
                <c:pt idx="106">
                  <c:v>46.380859999999998</c:v>
                </c:pt>
                <c:pt idx="107">
                  <c:v>45.969479999999997</c:v>
                </c:pt>
                <c:pt idx="108">
                  <c:v>44.98668</c:v>
                </c:pt>
                <c:pt idx="109">
                  <c:v>44.713720000000002</c:v>
                </c:pt>
                <c:pt idx="110">
                  <c:v>44.865920000000003</c:v>
                </c:pt>
                <c:pt idx="111">
                  <c:v>44.650599999999997</c:v>
                </c:pt>
                <c:pt idx="112">
                  <c:v>44.225760000000001</c:v>
                </c:pt>
                <c:pt idx="113">
                  <c:v>44.134240000000005</c:v>
                </c:pt>
                <c:pt idx="114">
                  <c:v>44.132919999999999</c:v>
                </c:pt>
                <c:pt idx="115">
                  <c:v>44.236640000000001</c:v>
                </c:pt>
                <c:pt idx="116">
                  <c:v>44.291840000000001</c:v>
                </c:pt>
                <c:pt idx="117">
                  <c:v>44.576180000000001</c:v>
                </c:pt>
                <c:pt idx="118">
                  <c:v>44.580420000000004</c:v>
                </c:pt>
                <c:pt idx="119">
                  <c:v>44.486779999999996</c:v>
                </c:pt>
                <c:pt idx="120">
                  <c:v>44.596980000000002</c:v>
                </c:pt>
                <c:pt idx="121">
                  <c:v>44.454999999999998</c:v>
                </c:pt>
                <c:pt idx="122">
                  <c:v>44.117459999999994</c:v>
                </c:pt>
                <c:pt idx="123">
                  <c:v>44.662079999999996</c:v>
                </c:pt>
                <c:pt idx="124">
                  <c:v>43.674640000000004</c:v>
                </c:pt>
                <c:pt idx="125">
                  <c:v>43.342959999999998</c:v>
                </c:pt>
                <c:pt idx="126">
                  <c:v>43.028500000000001</c:v>
                </c:pt>
                <c:pt idx="127">
                  <c:v>42.533059999999999</c:v>
                </c:pt>
                <c:pt idx="128">
                  <c:v>42.090859999999999</c:v>
                </c:pt>
                <c:pt idx="129">
                  <c:v>41.94122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D25-47B8-B257-03F4AA42F46D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V$17:$BV$146</c:f>
              <c:numCache>
                <c:formatCode>0.00</c:formatCode>
                <c:ptCount val="130"/>
                <c:pt idx="0">
                  <c:v>58.24906</c:v>
                </c:pt>
                <c:pt idx="1">
                  <c:v>66.048880000000011</c:v>
                </c:pt>
                <c:pt idx="2">
                  <c:v>68.692219999999992</c:v>
                </c:pt>
                <c:pt idx="3">
                  <c:v>71.024079999999998</c:v>
                </c:pt>
                <c:pt idx="4">
                  <c:v>71.705179999999999</c:v>
                </c:pt>
                <c:pt idx="5">
                  <c:v>71.642919999999989</c:v>
                </c:pt>
                <c:pt idx="6">
                  <c:v>70.798880000000011</c:v>
                </c:pt>
                <c:pt idx="7">
                  <c:v>69.766379999999998</c:v>
                </c:pt>
                <c:pt idx="8">
                  <c:v>68.350399999999993</c:v>
                </c:pt>
                <c:pt idx="9">
                  <c:v>66.972080000000005</c:v>
                </c:pt>
                <c:pt idx="10">
                  <c:v>65.818259999999995</c:v>
                </c:pt>
                <c:pt idx="11">
                  <c:v>66.082920000000001</c:v>
                </c:pt>
                <c:pt idx="12">
                  <c:v>68.030699999999996</c:v>
                </c:pt>
                <c:pt idx="13">
                  <c:v>71.885319999999993</c:v>
                </c:pt>
                <c:pt idx="14">
                  <c:v>78.257339999999999</c:v>
                </c:pt>
                <c:pt idx="15">
                  <c:v>86.154080000000008</c:v>
                </c:pt>
                <c:pt idx="16">
                  <c:v>96.095799999999997</c:v>
                </c:pt>
                <c:pt idx="17">
                  <c:v>106.75578</c:v>
                </c:pt>
                <c:pt idx="18">
                  <c:v>118.05632</c:v>
                </c:pt>
                <c:pt idx="19">
                  <c:v>127.35958000000001</c:v>
                </c:pt>
                <c:pt idx="20">
                  <c:v>133.97821999999999</c:v>
                </c:pt>
                <c:pt idx="21">
                  <c:v>138.53263999999999</c:v>
                </c:pt>
                <c:pt idx="22">
                  <c:v>141.74838</c:v>
                </c:pt>
                <c:pt idx="23">
                  <c:v>143.46190000000001</c:v>
                </c:pt>
                <c:pt idx="24">
                  <c:v>142.56533999999999</c:v>
                </c:pt>
                <c:pt idx="25">
                  <c:v>140.50002000000001</c:v>
                </c:pt>
                <c:pt idx="26">
                  <c:v>137.25630000000001</c:v>
                </c:pt>
                <c:pt idx="27">
                  <c:v>133.48096000000001</c:v>
                </c:pt>
                <c:pt idx="28">
                  <c:v>127.87578000000001</c:v>
                </c:pt>
                <c:pt idx="29">
                  <c:v>121.10751999999999</c:v>
                </c:pt>
                <c:pt idx="30">
                  <c:v>111.93766000000001</c:v>
                </c:pt>
                <c:pt idx="31">
                  <c:v>102.50766</c:v>
                </c:pt>
                <c:pt idx="32">
                  <c:v>95.220060000000004</c:v>
                </c:pt>
                <c:pt idx="33">
                  <c:v>90.029980000000009</c:v>
                </c:pt>
                <c:pt idx="34">
                  <c:v>86.853700000000003</c:v>
                </c:pt>
                <c:pt idx="35">
                  <c:v>83.935640000000006</c:v>
                </c:pt>
                <c:pt idx="36">
                  <c:v>82.12688</c:v>
                </c:pt>
                <c:pt idx="37">
                  <c:v>80.590440000000001</c:v>
                </c:pt>
                <c:pt idx="38">
                  <c:v>80.935640000000006</c:v>
                </c:pt>
                <c:pt idx="39">
                  <c:v>82.223280000000003</c:v>
                </c:pt>
                <c:pt idx="40">
                  <c:v>83.095320000000001</c:v>
                </c:pt>
                <c:pt idx="41">
                  <c:v>84.320980000000006</c:v>
                </c:pt>
                <c:pt idx="42">
                  <c:v>85.650599999999997</c:v>
                </c:pt>
                <c:pt idx="43">
                  <c:v>87.794700000000006</c:v>
                </c:pt>
                <c:pt idx="44">
                  <c:v>89.622460000000004</c:v>
                </c:pt>
                <c:pt idx="45">
                  <c:v>91.337199999999996</c:v>
                </c:pt>
                <c:pt idx="46">
                  <c:v>92.842839999999995</c:v>
                </c:pt>
                <c:pt idx="47">
                  <c:v>93.636099999999999</c:v>
                </c:pt>
                <c:pt idx="48">
                  <c:v>94.189840000000004</c:v>
                </c:pt>
                <c:pt idx="49">
                  <c:v>94.727719999999991</c:v>
                </c:pt>
                <c:pt idx="50">
                  <c:v>93.732500000000002</c:v>
                </c:pt>
                <c:pt idx="51">
                  <c:v>93.330299999999994</c:v>
                </c:pt>
                <c:pt idx="52">
                  <c:v>91.749780000000001</c:v>
                </c:pt>
                <c:pt idx="53">
                  <c:v>89.567700000000002</c:v>
                </c:pt>
                <c:pt idx="54">
                  <c:v>87.595399999999998</c:v>
                </c:pt>
                <c:pt idx="55">
                  <c:v>84.292459999999991</c:v>
                </c:pt>
                <c:pt idx="56">
                  <c:v>81.291219999999996</c:v>
                </c:pt>
                <c:pt idx="57">
                  <c:v>79.156359999999992</c:v>
                </c:pt>
                <c:pt idx="58">
                  <c:v>77.788180000000011</c:v>
                </c:pt>
                <c:pt idx="59">
                  <c:v>76.125399999999999</c:v>
                </c:pt>
                <c:pt idx="60">
                  <c:v>75.122159999999994</c:v>
                </c:pt>
                <c:pt idx="61">
                  <c:v>73.306820000000002</c:v>
                </c:pt>
                <c:pt idx="62">
                  <c:v>71.606259999999992</c:v>
                </c:pt>
                <c:pt idx="63">
                  <c:v>69.980140000000006</c:v>
                </c:pt>
                <c:pt idx="64">
                  <c:v>68.283600000000007</c:v>
                </c:pt>
                <c:pt idx="65">
                  <c:v>66.482340000000008</c:v>
                </c:pt>
                <c:pt idx="66">
                  <c:v>65.347719999999995</c:v>
                </c:pt>
                <c:pt idx="67">
                  <c:v>64.802700000000002</c:v>
                </c:pt>
                <c:pt idx="68">
                  <c:v>64.604959999999991</c:v>
                </c:pt>
                <c:pt idx="69">
                  <c:v>63.897759999999998</c:v>
                </c:pt>
                <c:pt idx="70">
                  <c:v>63.984619999999993</c:v>
                </c:pt>
                <c:pt idx="71">
                  <c:v>63.477780000000003</c:v>
                </c:pt>
                <c:pt idx="72">
                  <c:v>63.467359999999999</c:v>
                </c:pt>
                <c:pt idx="73">
                  <c:v>63.275680000000001</c:v>
                </c:pt>
                <c:pt idx="74">
                  <c:v>63.188080000000006</c:v>
                </c:pt>
                <c:pt idx="75">
                  <c:v>62.975719999999995</c:v>
                </c:pt>
                <c:pt idx="76">
                  <c:v>61.966940000000001</c:v>
                </c:pt>
                <c:pt idx="77">
                  <c:v>60.758819999999993</c:v>
                </c:pt>
                <c:pt idx="78">
                  <c:v>59.414000000000001</c:v>
                </c:pt>
                <c:pt idx="79">
                  <c:v>57.977400000000003</c:v>
                </c:pt>
                <c:pt idx="80">
                  <c:v>57.053340000000006</c:v>
                </c:pt>
                <c:pt idx="81">
                  <c:v>55.289499999999997</c:v>
                </c:pt>
                <c:pt idx="82">
                  <c:v>54.045740000000002</c:v>
                </c:pt>
                <c:pt idx="83">
                  <c:v>52.967219999999998</c:v>
                </c:pt>
                <c:pt idx="84">
                  <c:v>51.925319999999999</c:v>
                </c:pt>
                <c:pt idx="85">
                  <c:v>51.440359999999998</c:v>
                </c:pt>
                <c:pt idx="86">
                  <c:v>50.580379999999998</c:v>
                </c:pt>
                <c:pt idx="87">
                  <c:v>49.78566</c:v>
                </c:pt>
                <c:pt idx="88">
                  <c:v>48.713140000000003</c:v>
                </c:pt>
                <c:pt idx="89">
                  <c:v>48.190080000000002</c:v>
                </c:pt>
                <c:pt idx="90">
                  <c:v>47.749899999999997</c:v>
                </c:pt>
                <c:pt idx="91">
                  <c:v>47.486759999999997</c:v>
                </c:pt>
                <c:pt idx="92">
                  <c:v>46.935759999999995</c:v>
                </c:pt>
                <c:pt idx="93">
                  <c:v>46.328240000000001</c:v>
                </c:pt>
                <c:pt idx="94">
                  <c:v>46.391280000000002</c:v>
                </c:pt>
                <c:pt idx="95">
                  <c:v>45.831879999999998</c:v>
                </c:pt>
                <c:pt idx="96">
                  <c:v>45.638059999999996</c:v>
                </c:pt>
                <c:pt idx="97">
                  <c:v>45.4724</c:v>
                </c:pt>
                <c:pt idx="98">
                  <c:v>45.200220000000002</c:v>
                </c:pt>
                <c:pt idx="99">
                  <c:v>44.857559999999999</c:v>
                </c:pt>
                <c:pt idx="100">
                  <c:v>44.05444</c:v>
                </c:pt>
                <c:pt idx="101">
                  <c:v>43.865020000000001</c:v>
                </c:pt>
                <c:pt idx="102">
                  <c:v>43.53192</c:v>
                </c:pt>
                <c:pt idx="103">
                  <c:v>42.758000000000003</c:v>
                </c:pt>
                <c:pt idx="104">
                  <c:v>42.3964</c:v>
                </c:pt>
                <c:pt idx="105">
                  <c:v>41.743580000000001</c:v>
                </c:pt>
                <c:pt idx="106">
                  <c:v>40.92736</c:v>
                </c:pt>
                <c:pt idx="107">
                  <c:v>40.444679999999998</c:v>
                </c:pt>
                <c:pt idx="108">
                  <c:v>39.714779999999998</c:v>
                </c:pt>
                <c:pt idx="109">
                  <c:v>39.330919999999999</c:v>
                </c:pt>
                <c:pt idx="110">
                  <c:v>38.885220000000004</c:v>
                </c:pt>
                <c:pt idx="111">
                  <c:v>38.284599999999998</c:v>
                </c:pt>
                <c:pt idx="112">
                  <c:v>37.666559999999997</c:v>
                </c:pt>
                <c:pt idx="113">
                  <c:v>37.053139999999999</c:v>
                </c:pt>
                <c:pt idx="114">
                  <c:v>36.807320000000004</c:v>
                </c:pt>
                <c:pt idx="115">
                  <c:v>36.539439999999999</c:v>
                </c:pt>
                <c:pt idx="116">
                  <c:v>36.209140000000005</c:v>
                </c:pt>
                <c:pt idx="117">
                  <c:v>36.024180000000001</c:v>
                </c:pt>
                <c:pt idx="118">
                  <c:v>35.913519999999998</c:v>
                </c:pt>
                <c:pt idx="119">
                  <c:v>35.877679999999998</c:v>
                </c:pt>
                <c:pt idx="120">
                  <c:v>35.817679999999996</c:v>
                </c:pt>
                <c:pt idx="121">
                  <c:v>35.788699999999999</c:v>
                </c:pt>
                <c:pt idx="122">
                  <c:v>35.927959999999999</c:v>
                </c:pt>
                <c:pt idx="123">
                  <c:v>36.182580000000002</c:v>
                </c:pt>
                <c:pt idx="124">
                  <c:v>36.437040000000003</c:v>
                </c:pt>
                <c:pt idx="125">
                  <c:v>37.01596</c:v>
                </c:pt>
                <c:pt idx="126">
                  <c:v>37.138199999999998</c:v>
                </c:pt>
                <c:pt idx="127">
                  <c:v>37.324259999999995</c:v>
                </c:pt>
                <c:pt idx="128">
                  <c:v>37.345659999999995</c:v>
                </c:pt>
                <c:pt idx="129">
                  <c:v>37.93762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D25-47B8-B257-03F4AA42F4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360000"/>
        <c:axId val="64422656"/>
      </c:lineChart>
      <c:catAx>
        <c:axId val="6336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42265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42265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3360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C$17:$CC$146</c:f>
              <c:numCache>
                <c:formatCode>0.00</c:formatCode>
                <c:ptCount val="130"/>
                <c:pt idx="0">
                  <c:v>33.971539999999997</c:v>
                </c:pt>
                <c:pt idx="1">
                  <c:v>33.765260000000005</c:v>
                </c:pt>
                <c:pt idx="2">
                  <c:v>27.862774999999999</c:v>
                </c:pt>
                <c:pt idx="3">
                  <c:v>25.606539999999995</c:v>
                </c:pt>
                <c:pt idx="4">
                  <c:v>22.126485000000002</c:v>
                </c:pt>
                <c:pt idx="5">
                  <c:v>18.9437</c:v>
                </c:pt>
                <c:pt idx="6">
                  <c:v>16.932664999999997</c:v>
                </c:pt>
                <c:pt idx="7">
                  <c:v>17.141024999999999</c:v>
                </c:pt>
                <c:pt idx="8">
                  <c:v>16.664639999999995</c:v>
                </c:pt>
                <c:pt idx="9">
                  <c:v>17.524360000000005</c:v>
                </c:pt>
                <c:pt idx="10">
                  <c:v>17.929989999999997</c:v>
                </c:pt>
                <c:pt idx="11">
                  <c:v>18.161954999999999</c:v>
                </c:pt>
                <c:pt idx="12">
                  <c:v>17.050889999999995</c:v>
                </c:pt>
                <c:pt idx="13">
                  <c:v>16.788404999999997</c:v>
                </c:pt>
                <c:pt idx="14">
                  <c:v>17.006510000000002</c:v>
                </c:pt>
                <c:pt idx="15">
                  <c:v>18.311454999999999</c:v>
                </c:pt>
                <c:pt idx="16">
                  <c:v>20.787960000000002</c:v>
                </c:pt>
                <c:pt idx="17">
                  <c:v>26.739460000000005</c:v>
                </c:pt>
                <c:pt idx="18">
                  <c:v>31.759610000000002</c:v>
                </c:pt>
                <c:pt idx="19">
                  <c:v>36.846260000000001</c:v>
                </c:pt>
                <c:pt idx="20">
                  <c:v>41.629170000000002</c:v>
                </c:pt>
                <c:pt idx="21">
                  <c:v>44.545929999999998</c:v>
                </c:pt>
                <c:pt idx="22">
                  <c:v>45.587885</c:v>
                </c:pt>
                <c:pt idx="23">
                  <c:v>46.475304999999999</c:v>
                </c:pt>
                <c:pt idx="24">
                  <c:v>48.259695000000001</c:v>
                </c:pt>
                <c:pt idx="25">
                  <c:v>50.452554999999997</c:v>
                </c:pt>
                <c:pt idx="26">
                  <c:v>49.87921</c:v>
                </c:pt>
                <c:pt idx="27">
                  <c:v>47.26323</c:v>
                </c:pt>
                <c:pt idx="28">
                  <c:v>43.280794999999998</c:v>
                </c:pt>
                <c:pt idx="29">
                  <c:v>38.587519999999998</c:v>
                </c:pt>
                <c:pt idx="30">
                  <c:v>33.970269999999999</c:v>
                </c:pt>
                <c:pt idx="31">
                  <c:v>30.029835000000002</c:v>
                </c:pt>
                <c:pt idx="32">
                  <c:v>27.273460000000004</c:v>
                </c:pt>
                <c:pt idx="33">
                  <c:v>24.898814999999995</c:v>
                </c:pt>
                <c:pt idx="34">
                  <c:v>23.084399999999999</c:v>
                </c:pt>
                <c:pt idx="35">
                  <c:v>21.432114999999996</c:v>
                </c:pt>
                <c:pt idx="36">
                  <c:v>19.38045</c:v>
                </c:pt>
                <c:pt idx="37">
                  <c:v>17.823899999999998</c:v>
                </c:pt>
                <c:pt idx="38">
                  <c:v>16.921695</c:v>
                </c:pt>
                <c:pt idx="39">
                  <c:v>16.218695</c:v>
                </c:pt>
                <c:pt idx="40">
                  <c:v>16.347285000000003</c:v>
                </c:pt>
                <c:pt idx="41">
                  <c:v>16.172739999999997</c:v>
                </c:pt>
                <c:pt idx="42">
                  <c:v>16.500699999999998</c:v>
                </c:pt>
                <c:pt idx="43">
                  <c:v>17.199679999999997</c:v>
                </c:pt>
                <c:pt idx="44">
                  <c:v>17.781595000000003</c:v>
                </c:pt>
                <c:pt idx="45">
                  <c:v>17.982624999999999</c:v>
                </c:pt>
                <c:pt idx="46">
                  <c:v>18.114860000000004</c:v>
                </c:pt>
                <c:pt idx="47">
                  <c:v>18.295764999999996</c:v>
                </c:pt>
                <c:pt idx="48">
                  <c:v>18.751829999999998</c:v>
                </c:pt>
                <c:pt idx="49">
                  <c:v>19.304479999999998</c:v>
                </c:pt>
                <c:pt idx="50">
                  <c:v>19.651429999999998</c:v>
                </c:pt>
                <c:pt idx="51">
                  <c:v>19.903835000000004</c:v>
                </c:pt>
                <c:pt idx="52">
                  <c:v>19.825099999999999</c:v>
                </c:pt>
                <c:pt idx="53">
                  <c:v>19.28397</c:v>
                </c:pt>
                <c:pt idx="54">
                  <c:v>18.322379999999999</c:v>
                </c:pt>
                <c:pt idx="55">
                  <c:v>17.214310000000005</c:v>
                </c:pt>
                <c:pt idx="56">
                  <c:v>16.238914999999995</c:v>
                </c:pt>
                <c:pt idx="57">
                  <c:v>15.392225</c:v>
                </c:pt>
                <c:pt idx="58">
                  <c:v>14.655589999999997</c:v>
                </c:pt>
                <c:pt idx="59">
                  <c:v>14.088125</c:v>
                </c:pt>
                <c:pt idx="60">
                  <c:v>13.664239999999996</c:v>
                </c:pt>
                <c:pt idx="61">
                  <c:v>13.384754999999998</c:v>
                </c:pt>
                <c:pt idx="62">
                  <c:v>13.0367</c:v>
                </c:pt>
                <c:pt idx="63">
                  <c:v>12.602964999999996</c:v>
                </c:pt>
                <c:pt idx="64">
                  <c:v>12.239020000000002</c:v>
                </c:pt>
                <c:pt idx="65">
                  <c:v>12.1944</c:v>
                </c:pt>
                <c:pt idx="66">
                  <c:v>12.2637</c:v>
                </c:pt>
                <c:pt idx="67">
                  <c:v>12.153179999999999</c:v>
                </c:pt>
                <c:pt idx="68">
                  <c:v>12.4216</c:v>
                </c:pt>
                <c:pt idx="69">
                  <c:v>12.854239999999997</c:v>
                </c:pt>
                <c:pt idx="70">
                  <c:v>13.373150000000001</c:v>
                </c:pt>
                <c:pt idx="71">
                  <c:v>13.652979999999999</c:v>
                </c:pt>
                <c:pt idx="72">
                  <c:v>13.895295000000001</c:v>
                </c:pt>
                <c:pt idx="73">
                  <c:v>13.753639999999997</c:v>
                </c:pt>
                <c:pt idx="74">
                  <c:v>13.522704999999998</c:v>
                </c:pt>
                <c:pt idx="75">
                  <c:v>13.348895000000001</c:v>
                </c:pt>
                <c:pt idx="76">
                  <c:v>13.083860000000003</c:v>
                </c:pt>
                <c:pt idx="77">
                  <c:v>13.025695000000001</c:v>
                </c:pt>
                <c:pt idx="78">
                  <c:v>13.329075</c:v>
                </c:pt>
                <c:pt idx="79">
                  <c:v>13.185939999999997</c:v>
                </c:pt>
                <c:pt idx="80">
                  <c:v>12.863589999999997</c:v>
                </c:pt>
                <c:pt idx="81">
                  <c:v>12.182910000000003</c:v>
                </c:pt>
                <c:pt idx="82">
                  <c:v>11.510164999999997</c:v>
                </c:pt>
                <c:pt idx="83">
                  <c:v>10.982250000000001</c:v>
                </c:pt>
                <c:pt idx="84">
                  <c:v>10.204660000000004</c:v>
                </c:pt>
                <c:pt idx="85">
                  <c:v>9.8557950000000005</c:v>
                </c:pt>
                <c:pt idx="86">
                  <c:v>9.6777600000000028</c:v>
                </c:pt>
                <c:pt idx="87">
                  <c:v>9.4671749999999992</c:v>
                </c:pt>
                <c:pt idx="88">
                  <c:v>9.356639999999997</c:v>
                </c:pt>
                <c:pt idx="89">
                  <c:v>9.2521749999999994</c:v>
                </c:pt>
                <c:pt idx="90">
                  <c:v>9.1965600000000034</c:v>
                </c:pt>
                <c:pt idx="91">
                  <c:v>8.9060000000000006</c:v>
                </c:pt>
                <c:pt idx="92">
                  <c:v>8.7383649999999964</c:v>
                </c:pt>
                <c:pt idx="93">
                  <c:v>8.4625249999999994</c:v>
                </c:pt>
                <c:pt idx="94">
                  <c:v>8.3081250000000004</c:v>
                </c:pt>
                <c:pt idx="95">
                  <c:v>8.2230749999999997</c:v>
                </c:pt>
                <c:pt idx="96">
                  <c:v>8.2441450000000014</c:v>
                </c:pt>
                <c:pt idx="97">
                  <c:v>8.2563200000000005</c:v>
                </c:pt>
                <c:pt idx="98">
                  <c:v>8.3293450000000018</c:v>
                </c:pt>
                <c:pt idx="99">
                  <c:v>8.3579799999999995</c:v>
                </c:pt>
                <c:pt idx="100">
                  <c:v>8.1710799999999981</c:v>
                </c:pt>
                <c:pt idx="101">
                  <c:v>8.0708200000000012</c:v>
                </c:pt>
                <c:pt idx="102">
                  <c:v>7.4715549999999986</c:v>
                </c:pt>
                <c:pt idx="103">
                  <c:v>7.0034600000000031</c:v>
                </c:pt>
                <c:pt idx="104">
                  <c:v>6.6152450000000016</c:v>
                </c:pt>
                <c:pt idx="105">
                  <c:v>6.3725399999999963</c:v>
                </c:pt>
                <c:pt idx="106">
                  <c:v>6.0633149999999967</c:v>
                </c:pt>
                <c:pt idx="107">
                  <c:v>5.972195000000001</c:v>
                </c:pt>
                <c:pt idx="108">
                  <c:v>5.9036</c:v>
                </c:pt>
                <c:pt idx="109">
                  <c:v>5.7239399999999963</c:v>
                </c:pt>
                <c:pt idx="110">
                  <c:v>5.4884149999999963</c:v>
                </c:pt>
                <c:pt idx="111">
                  <c:v>5.1715899999999966</c:v>
                </c:pt>
                <c:pt idx="112">
                  <c:v>4.8806950000000011</c:v>
                </c:pt>
                <c:pt idx="113">
                  <c:v>4.6726600000000031</c:v>
                </c:pt>
                <c:pt idx="114">
                  <c:v>4.5247700000000011</c:v>
                </c:pt>
                <c:pt idx="115">
                  <c:v>3.9946399999999964</c:v>
                </c:pt>
                <c:pt idx="116">
                  <c:v>3.922029999999999</c:v>
                </c:pt>
                <c:pt idx="117">
                  <c:v>3.8859600000000034</c:v>
                </c:pt>
                <c:pt idx="118">
                  <c:v>3.7335200000000013</c:v>
                </c:pt>
                <c:pt idx="119">
                  <c:v>3.586520000000001</c:v>
                </c:pt>
                <c:pt idx="120">
                  <c:v>3.4694049999999987</c:v>
                </c:pt>
                <c:pt idx="121">
                  <c:v>3.3189399999999964</c:v>
                </c:pt>
                <c:pt idx="122">
                  <c:v>3.2335100000000034</c:v>
                </c:pt>
                <c:pt idx="123">
                  <c:v>3.2762049999999987</c:v>
                </c:pt>
                <c:pt idx="124">
                  <c:v>3.213445000000001</c:v>
                </c:pt>
                <c:pt idx="125">
                  <c:v>3.2000500000000001</c:v>
                </c:pt>
                <c:pt idx="126">
                  <c:v>3.1081200000000013</c:v>
                </c:pt>
                <c:pt idx="127">
                  <c:v>2.9422850000000036</c:v>
                </c:pt>
                <c:pt idx="128">
                  <c:v>2.94</c:v>
                </c:pt>
                <c:pt idx="129">
                  <c:v>2.860204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58-4CCD-B22D-6EF18F81BF0C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D$17:$CD$146</c:f>
              <c:numCache>
                <c:formatCode>0.00</c:formatCode>
                <c:ptCount val="130"/>
                <c:pt idx="0">
                  <c:v>31.952339999999996</c:v>
                </c:pt>
                <c:pt idx="1">
                  <c:v>29.979360000000003</c:v>
                </c:pt>
                <c:pt idx="2">
                  <c:v>23.472375</c:v>
                </c:pt>
                <c:pt idx="3">
                  <c:v>21.464739999999995</c:v>
                </c:pt>
                <c:pt idx="4">
                  <c:v>19.274385000000002</c:v>
                </c:pt>
                <c:pt idx="5">
                  <c:v>16.9085</c:v>
                </c:pt>
                <c:pt idx="6">
                  <c:v>15.374864999999996</c:v>
                </c:pt>
                <c:pt idx="7">
                  <c:v>14.317225000000001</c:v>
                </c:pt>
                <c:pt idx="8">
                  <c:v>13.399539999999996</c:v>
                </c:pt>
                <c:pt idx="9">
                  <c:v>13.689160000000003</c:v>
                </c:pt>
                <c:pt idx="10">
                  <c:v>13.384789999999997</c:v>
                </c:pt>
                <c:pt idx="11">
                  <c:v>13.282754999999998</c:v>
                </c:pt>
                <c:pt idx="12">
                  <c:v>13.372789999999997</c:v>
                </c:pt>
                <c:pt idx="13">
                  <c:v>13.706804999999999</c:v>
                </c:pt>
                <c:pt idx="14">
                  <c:v>14.516810000000003</c:v>
                </c:pt>
                <c:pt idx="15">
                  <c:v>15.711354999999999</c:v>
                </c:pt>
                <c:pt idx="16">
                  <c:v>17.217260000000003</c:v>
                </c:pt>
                <c:pt idx="17">
                  <c:v>21.597160000000002</c:v>
                </c:pt>
                <c:pt idx="18">
                  <c:v>23.733210000000003</c:v>
                </c:pt>
                <c:pt idx="19">
                  <c:v>25.739360000000005</c:v>
                </c:pt>
                <c:pt idx="20">
                  <c:v>27.493370000000002</c:v>
                </c:pt>
                <c:pt idx="21">
                  <c:v>30.170030000000001</c:v>
                </c:pt>
                <c:pt idx="22">
                  <c:v>33.802785</c:v>
                </c:pt>
                <c:pt idx="23">
                  <c:v>38.202905000000001</c:v>
                </c:pt>
                <c:pt idx="24">
                  <c:v>42.106994999999998</c:v>
                </c:pt>
                <c:pt idx="25">
                  <c:v>43.965454999999999</c:v>
                </c:pt>
                <c:pt idx="26">
                  <c:v>45.111510000000003</c:v>
                </c:pt>
                <c:pt idx="27">
                  <c:v>43.229329999999997</c:v>
                </c:pt>
                <c:pt idx="28">
                  <c:v>39.612994999999998</c:v>
                </c:pt>
                <c:pt idx="29">
                  <c:v>35.964120000000001</c:v>
                </c:pt>
                <c:pt idx="30">
                  <c:v>31.894970000000001</c:v>
                </c:pt>
                <c:pt idx="31">
                  <c:v>28.078335000000003</c:v>
                </c:pt>
                <c:pt idx="32">
                  <c:v>24.668860000000002</c:v>
                </c:pt>
                <c:pt idx="33">
                  <c:v>22.294814999999996</c:v>
                </c:pt>
                <c:pt idx="34">
                  <c:v>20.7196</c:v>
                </c:pt>
                <c:pt idx="35">
                  <c:v>19.048414999999995</c:v>
                </c:pt>
                <c:pt idx="36">
                  <c:v>17.370349999999998</c:v>
                </c:pt>
                <c:pt idx="37">
                  <c:v>15.585599999999999</c:v>
                </c:pt>
                <c:pt idx="38">
                  <c:v>14.302195000000001</c:v>
                </c:pt>
                <c:pt idx="39">
                  <c:v>12.856795000000002</c:v>
                </c:pt>
                <c:pt idx="40">
                  <c:v>12.007985000000003</c:v>
                </c:pt>
                <c:pt idx="41">
                  <c:v>11.417539999999997</c:v>
                </c:pt>
                <c:pt idx="42">
                  <c:v>11.4693</c:v>
                </c:pt>
                <c:pt idx="43">
                  <c:v>12.074679999999999</c:v>
                </c:pt>
                <c:pt idx="44">
                  <c:v>12.619795000000002</c:v>
                </c:pt>
                <c:pt idx="45">
                  <c:v>13.083425</c:v>
                </c:pt>
                <c:pt idx="46">
                  <c:v>13.414960000000004</c:v>
                </c:pt>
                <c:pt idx="47">
                  <c:v>13.418464999999996</c:v>
                </c:pt>
                <c:pt idx="48">
                  <c:v>13.593129999999999</c:v>
                </c:pt>
                <c:pt idx="49">
                  <c:v>14.107279999999999</c:v>
                </c:pt>
                <c:pt idx="50">
                  <c:v>15.304129999999999</c:v>
                </c:pt>
                <c:pt idx="51">
                  <c:v>16.028735000000005</c:v>
                </c:pt>
                <c:pt idx="52">
                  <c:v>16.008199999999999</c:v>
                </c:pt>
                <c:pt idx="53">
                  <c:v>15.21297</c:v>
                </c:pt>
                <c:pt idx="54">
                  <c:v>13.910979999999999</c:v>
                </c:pt>
                <c:pt idx="55">
                  <c:v>12.896910000000004</c:v>
                </c:pt>
                <c:pt idx="56">
                  <c:v>11.858714999999997</c:v>
                </c:pt>
                <c:pt idx="57">
                  <c:v>10.953825</c:v>
                </c:pt>
                <c:pt idx="58">
                  <c:v>10.483789999999997</c:v>
                </c:pt>
                <c:pt idx="59">
                  <c:v>9.8972250000000006</c:v>
                </c:pt>
                <c:pt idx="60">
                  <c:v>9.6098399999999966</c:v>
                </c:pt>
                <c:pt idx="61">
                  <c:v>9.2001549999999988</c:v>
                </c:pt>
                <c:pt idx="62">
                  <c:v>8.8170999999999999</c:v>
                </c:pt>
                <c:pt idx="63">
                  <c:v>8.5869649999999957</c:v>
                </c:pt>
                <c:pt idx="64">
                  <c:v>8.3838200000000018</c:v>
                </c:pt>
                <c:pt idx="65">
                  <c:v>8.4390999999999998</c:v>
                </c:pt>
                <c:pt idx="66">
                  <c:v>8.4482999999999997</c:v>
                </c:pt>
                <c:pt idx="67">
                  <c:v>8.4215799999999987</c:v>
                </c:pt>
                <c:pt idx="68">
                  <c:v>8.7843999999999998</c:v>
                </c:pt>
                <c:pt idx="69">
                  <c:v>8.8087399999999967</c:v>
                </c:pt>
                <c:pt idx="70">
                  <c:v>8.8273499999999991</c:v>
                </c:pt>
                <c:pt idx="71">
                  <c:v>8.8216799999999989</c:v>
                </c:pt>
                <c:pt idx="72">
                  <c:v>8.6641950000000012</c:v>
                </c:pt>
                <c:pt idx="73">
                  <c:v>8.5927399999999974</c:v>
                </c:pt>
                <c:pt idx="74">
                  <c:v>8.4001049999999982</c:v>
                </c:pt>
                <c:pt idx="75">
                  <c:v>8.1087950000000006</c:v>
                </c:pt>
                <c:pt idx="76">
                  <c:v>7.7988600000000039</c:v>
                </c:pt>
                <c:pt idx="77">
                  <c:v>7.323195000000001</c:v>
                </c:pt>
                <c:pt idx="78">
                  <c:v>6.9959749999999996</c:v>
                </c:pt>
                <c:pt idx="79">
                  <c:v>6.8664399999999963</c:v>
                </c:pt>
                <c:pt idx="80">
                  <c:v>6.6068899999999964</c:v>
                </c:pt>
                <c:pt idx="81">
                  <c:v>6.4923100000000034</c:v>
                </c:pt>
                <c:pt idx="82">
                  <c:v>6.2473649999999967</c:v>
                </c:pt>
                <c:pt idx="83">
                  <c:v>6.1606500000000004</c:v>
                </c:pt>
                <c:pt idx="84">
                  <c:v>5.7812600000000032</c:v>
                </c:pt>
                <c:pt idx="85">
                  <c:v>5.7691950000000007</c:v>
                </c:pt>
                <c:pt idx="86">
                  <c:v>5.3537600000000038</c:v>
                </c:pt>
                <c:pt idx="87">
                  <c:v>5.3498749999999999</c:v>
                </c:pt>
                <c:pt idx="88">
                  <c:v>5.3362399999999965</c:v>
                </c:pt>
                <c:pt idx="89">
                  <c:v>5.0347749999999998</c:v>
                </c:pt>
                <c:pt idx="90">
                  <c:v>5.1223600000000031</c:v>
                </c:pt>
                <c:pt idx="91">
                  <c:v>5.0129000000000001</c:v>
                </c:pt>
                <c:pt idx="92">
                  <c:v>5.0511649999999966</c:v>
                </c:pt>
                <c:pt idx="93">
                  <c:v>4.9841249999999997</c:v>
                </c:pt>
                <c:pt idx="94">
                  <c:v>5.173025</c:v>
                </c:pt>
                <c:pt idx="95">
                  <c:v>5.0589750000000002</c:v>
                </c:pt>
                <c:pt idx="96">
                  <c:v>4.9589450000000008</c:v>
                </c:pt>
                <c:pt idx="97">
                  <c:v>4.9721200000000012</c:v>
                </c:pt>
                <c:pt idx="98">
                  <c:v>4.8953450000000007</c:v>
                </c:pt>
                <c:pt idx="99">
                  <c:v>4.8679799999999984</c:v>
                </c:pt>
                <c:pt idx="100">
                  <c:v>4.8084799999999985</c:v>
                </c:pt>
                <c:pt idx="101">
                  <c:v>4.7406200000000007</c:v>
                </c:pt>
                <c:pt idx="102">
                  <c:v>4.653554999999999</c:v>
                </c:pt>
                <c:pt idx="103">
                  <c:v>4.9140600000000036</c:v>
                </c:pt>
                <c:pt idx="104">
                  <c:v>4.539645000000001</c:v>
                </c:pt>
                <c:pt idx="105">
                  <c:v>4.5183399999999967</c:v>
                </c:pt>
                <c:pt idx="106">
                  <c:v>4.4073149999999961</c:v>
                </c:pt>
                <c:pt idx="107">
                  <c:v>4.4185950000000016</c:v>
                </c:pt>
                <c:pt idx="108">
                  <c:v>4.5065999999999997</c:v>
                </c:pt>
                <c:pt idx="109">
                  <c:v>4.5327399999999969</c:v>
                </c:pt>
                <c:pt idx="110">
                  <c:v>4.6915149999999963</c:v>
                </c:pt>
                <c:pt idx="111">
                  <c:v>4.7448899999999963</c:v>
                </c:pt>
                <c:pt idx="112">
                  <c:v>4.7153950000000009</c:v>
                </c:pt>
                <c:pt idx="113">
                  <c:v>4.6386600000000033</c:v>
                </c:pt>
                <c:pt idx="114">
                  <c:v>4.5282700000000009</c:v>
                </c:pt>
                <c:pt idx="115">
                  <c:v>3.6669399999999963</c:v>
                </c:pt>
                <c:pt idx="116">
                  <c:v>3.487029999999999</c:v>
                </c:pt>
                <c:pt idx="117">
                  <c:v>3.4794600000000036</c:v>
                </c:pt>
                <c:pt idx="118">
                  <c:v>3.3537200000000014</c:v>
                </c:pt>
                <c:pt idx="119">
                  <c:v>3.325120000000001</c:v>
                </c:pt>
                <c:pt idx="120">
                  <c:v>3.301404999999999</c:v>
                </c:pt>
                <c:pt idx="121">
                  <c:v>3.1846399999999964</c:v>
                </c:pt>
                <c:pt idx="122">
                  <c:v>3.1460100000000035</c:v>
                </c:pt>
                <c:pt idx="123">
                  <c:v>3.0895049999999991</c:v>
                </c:pt>
                <c:pt idx="124">
                  <c:v>2.9543450000000013</c:v>
                </c:pt>
                <c:pt idx="125">
                  <c:v>2.88855</c:v>
                </c:pt>
                <c:pt idx="126">
                  <c:v>2.7184200000000009</c:v>
                </c:pt>
                <c:pt idx="127">
                  <c:v>2.5486850000000034</c:v>
                </c:pt>
                <c:pt idx="128">
                  <c:v>2.484</c:v>
                </c:pt>
                <c:pt idx="129">
                  <c:v>2.43330499999999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858-4CCD-B22D-6EF18F81BF0C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E$17:$CE$146</c:f>
              <c:numCache>
                <c:formatCode>0.00</c:formatCode>
                <c:ptCount val="130"/>
                <c:pt idx="0">
                  <c:v>33.283139999999996</c:v>
                </c:pt>
                <c:pt idx="1">
                  <c:v>33.704660000000004</c:v>
                </c:pt>
                <c:pt idx="2">
                  <c:v>31.385075000000001</c:v>
                </c:pt>
                <c:pt idx="3">
                  <c:v>29.406439999999996</c:v>
                </c:pt>
                <c:pt idx="4">
                  <c:v>26.623285000000003</c:v>
                </c:pt>
                <c:pt idx="5">
                  <c:v>23.2775</c:v>
                </c:pt>
                <c:pt idx="6">
                  <c:v>20.768864999999998</c:v>
                </c:pt>
                <c:pt idx="7">
                  <c:v>19.640525</c:v>
                </c:pt>
                <c:pt idx="8">
                  <c:v>19.313939999999995</c:v>
                </c:pt>
                <c:pt idx="9">
                  <c:v>19.160660000000004</c:v>
                </c:pt>
                <c:pt idx="10">
                  <c:v>18.572489999999995</c:v>
                </c:pt>
                <c:pt idx="11">
                  <c:v>17.739055</c:v>
                </c:pt>
                <c:pt idx="12">
                  <c:v>17.139789999999998</c:v>
                </c:pt>
                <c:pt idx="13">
                  <c:v>17.456605</c:v>
                </c:pt>
                <c:pt idx="14">
                  <c:v>18.591210000000004</c:v>
                </c:pt>
                <c:pt idx="15">
                  <c:v>20.539755</c:v>
                </c:pt>
                <c:pt idx="16">
                  <c:v>23.606260000000002</c:v>
                </c:pt>
                <c:pt idx="17">
                  <c:v>30.346760000000003</c:v>
                </c:pt>
                <c:pt idx="18">
                  <c:v>37.111810000000006</c:v>
                </c:pt>
                <c:pt idx="19">
                  <c:v>42.893060000000006</c:v>
                </c:pt>
                <c:pt idx="20">
                  <c:v>45.828670000000002</c:v>
                </c:pt>
                <c:pt idx="21">
                  <c:v>47.856029999999997</c:v>
                </c:pt>
                <c:pt idx="22">
                  <c:v>50.298585000000003</c:v>
                </c:pt>
                <c:pt idx="23">
                  <c:v>53.735505000000003</c:v>
                </c:pt>
                <c:pt idx="24">
                  <c:v>57.984094999999996</c:v>
                </c:pt>
                <c:pt idx="25">
                  <c:v>61.520755000000001</c:v>
                </c:pt>
                <c:pt idx="26">
                  <c:v>61.666210000000007</c:v>
                </c:pt>
                <c:pt idx="27">
                  <c:v>58.531930000000003</c:v>
                </c:pt>
                <c:pt idx="28">
                  <c:v>53.205694999999999</c:v>
                </c:pt>
                <c:pt idx="29">
                  <c:v>46.520119999999999</c:v>
                </c:pt>
                <c:pt idx="30">
                  <c:v>40.204970000000003</c:v>
                </c:pt>
                <c:pt idx="31">
                  <c:v>35.873835000000007</c:v>
                </c:pt>
                <c:pt idx="32">
                  <c:v>31.645760000000003</c:v>
                </c:pt>
                <c:pt idx="33">
                  <c:v>28.404414999999997</c:v>
                </c:pt>
                <c:pt idx="34">
                  <c:v>26.001799999999999</c:v>
                </c:pt>
                <c:pt idx="35">
                  <c:v>23.983914999999996</c:v>
                </c:pt>
                <c:pt idx="36">
                  <c:v>22.311050000000002</c:v>
                </c:pt>
                <c:pt idx="37">
                  <c:v>21.138500000000001</c:v>
                </c:pt>
                <c:pt idx="38">
                  <c:v>20.544795000000001</c:v>
                </c:pt>
                <c:pt idx="39">
                  <c:v>20.141695000000002</c:v>
                </c:pt>
                <c:pt idx="40">
                  <c:v>20.269285000000004</c:v>
                </c:pt>
                <c:pt idx="41">
                  <c:v>19.921539999999997</c:v>
                </c:pt>
                <c:pt idx="42">
                  <c:v>20.336400000000001</c:v>
                </c:pt>
                <c:pt idx="43">
                  <c:v>21.33418</c:v>
                </c:pt>
                <c:pt idx="44">
                  <c:v>22.890095000000002</c:v>
                </c:pt>
                <c:pt idx="45">
                  <c:v>24.074925</c:v>
                </c:pt>
                <c:pt idx="46">
                  <c:v>25.254360000000002</c:v>
                </c:pt>
                <c:pt idx="47">
                  <c:v>25.825264999999998</c:v>
                </c:pt>
                <c:pt idx="48">
                  <c:v>25.75563</c:v>
                </c:pt>
                <c:pt idx="49">
                  <c:v>25.566779999999998</c:v>
                </c:pt>
                <c:pt idx="50">
                  <c:v>25.431229999999999</c:v>
                </c:pt>
                <c:pt idx="51">
                  <c:v>25.748935000000003</c:v>
                </c:pt>
                <c:pt idx="52">
                  <c:v>25.731200000000001</c:v>
                </c:pt>
                <c:pt idx="53">
                  <c:v>25.678070000000002</c:v>
                </c:pt>
                <c:pt idx="54">
                  <c:v>25.307679999999998</c:v>
                </c:pt>
                <c:pt idx="55">
                  <c:v>24.326710000000002</c:v>
                </c:pt>
                <c:pt idx="56">
                  <c:v>22.702014999999996</c:v>
                </c:pt>
                <c:pt idx="57">
                  <c:v>21.245925</c:v>
                </c:pt>
                <c:pt idx="58">
                  <c:v>19.772589999999997</c:v>
                </c:pt>
                <c:pt idx="59">
                  <c:v>18.660125000000001</c:v>
                </c:pt>
                <c:pt idx="60">
                  <c:v>17.908639999999995</c:v>
                </c:pt>
                <c:pt idx="61">
                  <c:v>17.633054999999999</c:v>
                </c:pt>
                <c:pt idx="62">
                  <c:v>17.523299999999999</c:v>
                </c:pt>
                <c:pt idx="63">
                  <c:v>17.477164999999996</c:v>
                </c:pt>
                <c:pt idx="64">
                  <c:v>17.180520000000001</c:v>
                </c:pt>
                <c:pt idx="65">
                  <c:v>16.9955</c:v>
                </c:pt>
                <c:pt idx="66">
                  <c:v>16.786000000000001</c:v>
                </c:pt>
                <c:pt idx="67">
                  <c:v>16.534579999999998</c:v>
                </c:pt>
                <c:pt idx="68">
                  <c:v>16.738399999999999</c:v>
                </c:pt>
                <c:pt idx="69">
                  <c:v>16.993539999999996</c:v>
                </c:pt>
                <c:pt idx="70">
                  <c:v>17.539149999999999</c:v>
                </c:pt>
                <c:pt idx="71">
                  <c:v>18.15868</c:v>
                </c:pt>
                <c:pt idx="72">
                  <c:v>18.507595000000002</c:v>
                </c:pt>
                <c:pt idx="73">
                  <c:v>18.985239999999997</c:v>
                </c:pt>
                <c:pt idx="74">
                  <c:v>19.040704999999999</c:v>
                </c:pt>
                <c:pt idx="75">
                  <c:v>18.955495000000003</c:v>
                </c:pt>
                <c:pt idx="76">
                  <c:v>18.319760000000002</c:v>
                </c:pt>
                <c:pt idx="77">
                  <c:v>17.436195000000001</c:v>
                </c:pt>
                <c:pt idx="78">
                  <c:v>16.351775</c:v>
                </c:pt>
                <c:pt idx="79">
                  <c:v>16.332239999999995</c:v>
                </c:pt>
                <c:pt idx="80">
                  <c:v>15.402589999999996</c:v>
                </c:pt>
                <c:pt idx="81">
                  <c:v>15.205910000000003</c:v>
                </c:pt>
                <c:pt idx="82">
                  <c:v>14.900064999999996</c:v>
                </c:pt>
                <c:pt idx="83">
                  <c:v>14.16785</c:v>
                </c:pt>
                <c:pt idx="84">
                  <c:v>13.013760000000003</c:v>
                </c:pt>
                <c:pt idx="85">
                  <c:v>12.267095000000001</c:v>
                </c:pt>
                <c:pt idx="86">
                  <c:v>11.598360000000003</c:v>
                </c:pt>
                <c:pt idx="87">
                  <c:v>11.342375000000001</c:v>
                </c:pt>
                <c:pt idx="88">
                  <c:v>11.403339999999996</c:v>
                </c:pt>
                <c:pt idx="89">
                  <c:v>11.315675000000001</c:v>
                </c:pt>
                <c:pt idx="90">
                  <c:v>11.315360000000004</c:v>
                </c:pt>
                <c:pt idx="91">
                  <c:v>11.029199999999999</c:v>
                </c:pt>
                <c:pt idx="92">
                  <c:v>10.959564999999996</c:v>
                </c:pt>
                <c:pt idx="93">
                  <c:v>11.046925</c:v>
                </c:pt>
                <c:pt idx="94">
                  <c:v>11.256525</c:v>
                </c:pt>
                <c:pt idx="95">
                  <c:v>11.115575</c:v>
                </c:pt>
                <c:pt idx="96">
                  <c:v>10.940545000000002</c:v>
                </c:pt>
                <c:pt idx="97">
                  <c:v>10.63062</c:v>
                </c:pt>
                <c:pt idx="98">
                  <c:v>10.481545000000001</c:v>
                </c:pt>
                <c:pt idx="99">
                  <c:v>10.429879999999999</c:v>
                </c:pt>
                <c:pt idx="100">
                  <c:v>10.250779999999999</c:v>
                </c:pt>
                <c:pt idx="101">
                  <c:v>9.9731200000000015</c:v>
                </c:pt>
                <c:pt idx="102">
                  <c:v>9.6805549999999982</c:v>
                </c:pt>
                <c:pt idx="103">
                  <c:v>9.3902600000000032</c:v>
                </c:pt>
                <c:pt idx="104">
                  <c:v>9.1620450000000009</c:v>
                </c:pt>
                <c:pt idx="105">
                  <c:v>9.0229399999999966</c:v>
                </c:pt>
                <c:pt idx="106">
                  <c:v>8.6941149999999965</c:v>
                </c:pt>
                <c:pt idx="107">
                  <c:v>8.534295000000002</c:v>
                </c:pt>
                <c:pt idx="108">
                  <c:v>8.2718000000000007</c:v>
                </c:pt>
                <c:pt idx="109">
                  <c:v>8.0521399999999961</c:v>
                </c:pt>
                <c:pt idx="110">
                  <c:v>8.169914999999996</c:v>
                </c:pt>
                <c:pt idx="111">
                  <c:v>7.5512899999999963</c:v>
                </c:pt>
                <c:pt idx="112">
                  <c:v>7.329695000000001</c:v>
                </c:pt>
                <c:pt idx="113">
                  <c:v>7.3372600000000032</c:v>
                </c:pt>
                <c:pt idx="114">
                  <c:v>7.3119700000000014</c:v>
                </c:pt>
                <c:pt idx="115">
                  <c:v>7.1093399999999969</c:v>
                </c:pt>
                <c:pt idx="116">
                  <c:v>6.9068299999999985</c:v>
                </c:pt>
                <c:pt idx="117">
                  <c:v>6.6741600000000032</c:v>
                </c:pt>
                <c:pt idx="118">
                  <c:v>6.3168200000000008</c:v>
                </c:pt>
                <c:pt idx="119">
                  <c:v>6.1419200000000016</c:v>
                </c:pt>
                <c:pt idx="120">
                  <c:v>5.9728049999999993</c:v>
                </c:pt>
                <c:pt idx="121">
                  <c:v>5.8503399999999965</c:v>
                </c:pt>
                <c:pt idx="122">
                  <c:v>5.6805100000000035</c:v>
                </c:pt>
                <c:pt idx="123">
                  <c:v>5.733204999999999</c:v>
                </c:pt>
                <c:pt idx="124">
                  <c:v>5.6982450000000009</c:v>
                </c:pt>
                <c:pt idx="125">
                  <c:v>5.5368500000000003</c:v>
                </c:pt>
                <c:pt idx="126">
                  <c:v>5.234020000000001</c:v>
                </c:pt>
                <c:pt idx="127">
                  <c:v>4.8629850000000037</c:v>
                </c:pt>
                <c:pt idx="128">
                  <c:v>4.6178999999999997</c:v>
                </c:pt>
                <c:pt idx="129">
                  <c:v>4.318904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858-4CCD-B22D-6EF18F81BF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448000"/>
        <c:axId val="64449536"/>
      </c:lineChart>
      <c:catAx>
        <c:axId val="64448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44953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44953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448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Z$17:$BZ$146</c:f>
              <c:numCache>
                <c:formatCode>0.00</c:formatCode>
                <c:ptCount val="130"/>
                <c:pt idx="0">
                  <c:v>65.632439999999988</c:v>
                </c:pt>
                <c:pt idx="1">
                  <c:v>57.243960000000008</c:v>
                </c:pt>
                <c:pt idx="2">
                  <c:v>42.245274999999999</c:v>
                </c:pt>
                <c:pt idx="3">
                  <c:v>34.151939999999996</c:v>
                </c:pt>
                <c:pt idx="4">
                  <c:v>28.791885000000004</c:v>
                </c:pt>
                <c:pt idx="5">
                  <c:v>24.818300000000001</c:v>
                </c:pt>
                <c:pt idx="6">
                  <c:v>21.842864999999996</c:v>
                </c:pt>
                <c:pt idx="7">
                  <c:v>19.441925000000001</c:v>
                </c:pt>
                <c:pt idx="8">
                  <c:v>17.585139999999996</c:v>
                </c:pt>
                <c:pt idx="9">
                  <c:v>16.234460000000002</c:v>
                </c:pt>
                <c:pt idx="10">
                  <c:v>23.706689999999998</c:v>
                </c:pt>
                <c:pt idx="11">
                  <c:v>23.333454999999997</c:v>
                </c:pt>
                <c:pt idx="12">
                  <c:v>27.087089999999996</c:v>
                </c:pt>
                <c:pt idx="13">
                  <c:v>28.367304999999998</c:v>
                </c:pt>
                <c:pt idx="14">
                  <c:v>31.722710000000003</c:v>
                </c:pt>
                <c:pt idx="15">
                  <c:v>28.659354999999998</c:v>
                </c:pt>
                <c:pt idx="16">
                  <c:v>32.783660000000005</c:v>
                </c:pt>
                <c:pt idx="17">
                  <c:v>28.618860000000005</c:v>
                </c:pt>
                <c:pt idx="18">
                  <c:v>34.280010000000004</c:v>
                </c:pt>
                <c:pt idx="19">
                  <c:v>24.958060000000003</c:v>
                </c:pt>
                <c:pt idx="20">
                  <c:v>21.162470000000003</c:v>
                </c:pt>
                <c:pt idx="21">
                  <c:v>26.20233</c:v>
                </c:pt>
                <c:pt idx="22">
                  <c:v>18.528885000000002</c:v>
                </c:pt>
                <c:pt idx="23">
                  <c:v>14.791404999999999</c:v>
                </c:pt>
                <c:pt idx="24">
                  <c:v>34.603095000000003</c:v>
                </c:pt>
                <c:pt idx="25">
                  <c:v>28.456054999999999</c:v>
                </c:pt>
                <c:pt idx="26">
                  <c:v>23.984610000000004</c:v>
                </c:pt>
                <c:pt idx="27">
                  <c:v>21.760729999999999</c:v>
                </c:pt>
                <c:pt idx="28">
                  <c:v>40.053195000000002</c:v>
                </c:pt>
                <c:pt idx="29">
                  <c:v>32.838720000000002</c:v>
                </c:pt>
                <c:pt idx="30">
                  <c:v>22.934370000000001</c:v>
                </c:pt>
                <c:pt idx="31">
                  <c:v>16.005435000000002</c:v>
                </c:pt>
                <c:pt idx="32">
                  <c:v>12.035860000000003</c:v>
                </c:pt>
                <c:pt idx="33">
                  <c:v>28.560514999999995</c:v>
                </c:pt>
                <c:pt idx="34">
                  <c:v>24.975300000000001</c:v>
                </c:pt>
                <c:pt idx="35">
                  <c:v>18.730014999999998</c:v>
                </c:pt>
                <c:pt idx="36">
                  <c:v>15.747450000000001</c:v>
                </c:pt>
                <c:pt idx="37">
                  <c:v>14.729100000000001</c:v>
                </c:pt>
                <c:pt idx="38">
                  <c:v>14.796695000000001</c:v>
                </c:pt>
                <c:pt idx="39">
                  <c:v>57.249594999999992</c:v>
                </c:pt>
                <c:pt idx="40">
                  <c:v>75.987685000000013</c:v>
                </c:pt>
                <c:pt idx="41">
                  <c:v>97.127939999999995</c:v>
                </c:pt>
                <c:pt idx="42">
                  <c:v>105.6913</c:v>
                </c:pt>
                <c:pt idx="43">
                  <c:v>108.14138</c:v>
                </c:pt>
                <c:pt idx="44">
                  <c:v>99.508394999999993</c:v>
                </c:pt>
                <c:pt idx="45">
                  <c:v>85.828924999999998</c:v>
                </c:pt>
                <c:pt idx="46">
                  <c:v>70.449660000000009</c:v>
                </c:pt>
                <c:pt idx="47">
                  <c:v>57.680764999999994</c:v>
                </c:pt>
                <c:pt idx="48">
                  <c:v>47.689830000000001</c:v>
                </c:pt>
                <c:pt idx="49">
                  <c:v>40.429679999999998</c:v>
                </c:pt>
                <c:pt idx="50">
                  <c:v>34.650230000000001</c:v>
                </c:pt>
                <c:pt idx="51">
                  <c:v>30.452435000000005</c:v>
                </c:pt>
                <c:pt idx="52">
                  <c:v>27.028199999999998</c:v>
                </c:pt>
                <c:pt idx="53">
                  <c:v>24.472270000000002</c:v>
                </c:pt>
                <c:pt idx="54">
                  <c:v>22.662679999999998</c:v>
                </c:pt>
                <c:pt idx="55">
                  <c:v>21.844510000000003</c:v>
                </c:pt>
                <c:pt idx="56">
                  <c:v>20.809114999999995</c:v>
                </c:pt>
                <c:pt idx="57">
                  <c:v>20.034324999999999</c:v>
                </c:pt>
                <c:pt idx="58">
                  <c:v>19.660489999999996</c:v>
                </c:pt>
                <c:pt idx="59">
                  <c:v>19.326924999999999</c:v>
                </c:pt>
                <c:pt idx="60">
                  <c:v>19.216939999999997</c:v>
                </c:pt>
                <c:pt idx="61">
                  <c:v>19.320255</c:v>
                </c:pt>
                <c:pt idx="62">
                  <c:v>19.540099999999999</c:v>
                </c:pt>
                <c:pt idx="63">
                  <c:v>19.928564999999995</c:v>
                </c:pt>
                <c:pt idx="64">
                  <c:v>20.222720000000002</c:v>
                </c:pt>
                <c:pt idx="65">
                  <c:v>21.280100000000001</c:v>
                </c:pt>
                <c:pt idx="66">
                  <c:v>22.840800000000002</c:v>
                </c:pt>
                <c:pt idx="67">
                  <c:v>24.252479999999998</c:v>
                </c:pt>
                <c:pt idx="68">
                  <c:v>24.334199999999999</c:v>
                </c:pt>
                <c:pt idx="69">
                  <c:v>23.464939999999995</c:v>
                </c:pt>
                <c:pt idx="70">
                  <c:v>21.834150000000001</c:v>
                </c:pt>
                <c:pt idx="71">
                  <c:v>20.092579999999998</c:v>
                </c:pt>
                <c:pt idx="72">
                  <c:v>18.392795</c:v>
                </c:pt>
                <c:pt idx="73">
                  <c:v>16.681439999999995</c:v>
                </c:pt>
                <c:pt idx="74">
                  <c:v>14.896504999999999</c:v>
                </c:pt>
                <c:pt idx="75">
                  <c:v>13.722095000000001</c:v>
                </c:pt>
                <c:pt idx="76">
                  <c:v>13.084260000000004</c:v>
                </c:pt>
                <c:pt idx="77">
                  <c:v>12.397595000000001</c:v>
                </c:pt>
                <c:pt idx="78">
                  <c:v>12.614775</c:v>
                </c:pt>
                <c:pt idx="79">
                  <c:v>12.816339999999997</c:v>
                </c:pt>
                <c:pt idx="80">
                  <c:v>12.686089999999997</c:v>
                </c:pt>
                <c:pt idx="81">
                  <c:v>12.537410000000003</c:v>
                </c:pt>
                <c:pt idx="82">
                  <c:v>12.114064999999997</c:v>
                </c:pt>
                <c:pt idx="83">
                  <c:v>11.86575</c:v>
                </c:pt>
                <c:pt idx="84">
                  <c:v>11.574760000000003</c:v>
                </c:pt>
                <c:pt idx="85">
                  <c:v>11.555995000000001</c:v>
                </c:pt>
                <c:pt idx="86">
                  <c:v>11.769560000000004</c:v>
                </c:pt>
                <c:pt idx="87">
                  <c:v>12.027675</c:v>
                </c:pt>
                <c:pt idx="88">
                  <c:v>12.526339999999996</c:v>
                </c:pt>
                <c:pt idx="89">
                  <c:v>13.305275</c:v>
                </c:pt>
                <c:pt idx="90">
                  <c:v>13.915660000000004</c:v>
                </c:pt>
                <c:pt idx="91">
                  <c:v>13.946300000000001</c:v>
                </c:pt>
                <c:pt idx="92">
                  <c:v>14.239064999999997</c:v>
                </c:pt>
                <c:pt idx="93">
                  <c:v>14.167825000000001</c:v>
                </c:pt>
                <c:pt idx="94">
                  <c:v>13.633324999999999</c:v>
                </c:pt>
                <c:pt idx="95">
                  <c:v>12.895675000000001</c:v>
                </c:pt>
                <c:pt idx="96">
                  <c:v>12.133845000000001</c:v>
                </c:pt>
                <c:pt idx="97">
                  <c:v>11.503920000000001</c:v>
                </c:pt>
                <c:pt idx="98">
                  <c:v>11.241245000000001</c:v>
                </c:pt>
                <c:pt idx="99">
                  <c:v>11.203479999999999</c:v>
                </c:pt>
                <c:pt idx="100">
                  <c:v>11.272479999999998</c:v>
                </c:pt>
                <c:pt idx="101">
                  <c:v>11.001520000000001</c:v>
                </c:pt>
                <c:pt idx="102">
                  <c:v>10.623154999999999</c:v>
                </c:pt>
                <c:pt idx="103">
                  <c:v>10.093160000000003</c:v>
                </c:pt>
                <c:pt idx="104">
                  <c:v>9.578145000000001</c:v>
                </c:pt>
                <c:pt idx="105">
                  <c:v>8.962239999999996</c:v>
                </c:pt>
                <c:pt idx="106">
                  <c:v>8.6439149999999962</c:v>
                </c:pt>
                <c:pt idx="107">
                  <c:v>8.3881950000000014</c:v>
                </c:pt>
                <c:pt idx="108">
                  <c:v>8.4957999999999991</c:v>
                </c:pt>
                <c:pt idx="109">
                  <c:v>8.8287399999999963</c:v>
                </c:pt>
                <c:pt idx="110">
                  <c:v>9.4243149999999964</c:v>
                </c:pt>
                <c:pt idx="111">
                  <c:v>9.7715899999999962</c:v>
                </c:pt>
                <c:pt idx="112">
                  <c:v>9.9807950000000005</c:v>
                </c:pt>
                <c:pt idx="113">
                  <c:v>10.024560000000003</c:v>
                </c:pt>
                <c:pt idx="114">
                  <c:v>9.8856700000000011</c:v>
                </c:pt>
                <c:pt idx="115">
                  <c:v>8.6289399999999965</c:v>
                </c:pt>
                <c:pt idx="116">
                  <c:v>8.1626299999999983</c:v>
                </c:pt>
                <c:pt idx="117">
                  <c:v>7.9553600000000033</c:v>
                </c:pt>
                <c:pt idx="118">
                  <c:v>7.5228200000000012</c:v>
                </c:pt>
                <c:pt idx="119">
                  <c:v>7.2234200000000008</c:v>
                </c:pt>
                <c:pt idx="120">
                  <c:v>6.9055049999999989</c:v>
                </c:pt>
                <c:pt idx="121">
                  <c:v>6.4373399999999963</c:v>
                </c:pt>
                <c:pt idx="122">
                  <c:v>5.9645100000000033</c:v>
                </c:pt>
                <c:pt idx="123">
                  <c:v>5.6450049999999985</c:v>
                </c:pt>
                <c:pt idx="124">
                  <c:v>5.2733450000000008</c:v>
                </c:pt>
                <c:pt idx="125">
                  <c:v>5.0713499999999998</c:v>
                </c:pt>
                <c:pt idx="126">
                  <c:v>4.8120200000000013</c:v>
                </c:pt>
                <c:pt idx="127">
                  <c:v>4.5066850000000036</c:v>
                </c:pt>
                <c:pt idx="128">
                  <c:v>4.3601999999999999</c:v>
                </c:pt>
                <c:pt idx="129">
                  <c:v>4.2650049999999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4B1-4EB1-A936-395844623404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A$17:$CA$146</c:f>
              <c:numCache>
                <c:formatCode>0.00</c:formatCode>
                <c:ptCount val="130"/>
                <c:pt idx="0">
                  <c:v>40.069539999999996</c:v>
                </c:pt>
                <c:pt idx="1">
                  <c:v>37.504960000000004</c:v>
                </c:pt>
                <c:pt idx="2">
                  <c:v>29.432874999999999</c:v>
                </c:pt>
                <c:pt idx="3">
                  <c:v>26.152939999999997</c:v>
                </c:pt>
                <c:pt idx="4">
                  <c:v>23.370085000000003</c:v>
                </c:pt>
                <c:pt idx="5">
                  <c:v>21.088200000000001</c:v>
                </c:pt>
                <c:pt idx="6">
                  <c:v>19.417064999999997</c:v>
                </c:pt>
                <c:pt idx="7">
                  <c:v>18.459225</c:v>
                </c:pt>
                <c:pt idx="8">
                  <c:v>18.196839999999998</c:v>
                </c:pt>
                <c:pt idx="9">
                  <c:v>19.135660000000005</c:v>
                </c:pt>
                <c:pt idx="10">
                  <c:v>20.972789999999996</c:v>
                </c:pt>
                <c:pt idx="11">
                  <c:v>25.821755</c:v>
                </c:pt>
                <c:pt idx="12">
                  <c:v>32.981189999999998</c:v>
                </c:pt>
                <c:pt idx="13">
                  <c:v>42.873204999999999</c:v>
                </c:pt>
                <c:pt idx="14">
                  <c:v>52.039910000000006</c:v>
                </c:pt>
                <c:pt idx="15">
                  <c:v>58.612255000000005</c:v>
                </c:pt>
                <c:pt idx="16">
                  <c:v>65.887060000000005</c:v>
                </c:pt>
                <c:pt idx="17">
                  <c:v>74.516960000000012</c:v>
                </c:pt>
                <c:pt idx="18">
                  <c:v>78.320710000000005</c:v>
                </c:pt>
                <c:pt idx="19">
                  <c:v>81.943260000000009</c:v>
                </c:pt>
                <c:pt idx="20">
                  <c:v>84.418569999999988</c:v>
                </c:pt>
                <c:pt idx="21">
                  <c:v>83.464330000000004</c:v>
                </c:pt>
                <c:pt idx="22">
                  <c:v>81.581485000000015</c:v>
                </c:pt>
                <c:pt idx="23">
                  <c:v>76.895405000000011</c:v>
                </c:pt>
                <c:pt idx="24">
                  <c:v>69.375394999999997</c:v>
                </c:pt>
                <c:pt idx="25">
                  <c:v>60.359755000000007</c:v>
                </c:pt>
                <c:pt idx="26">
                  <c:v>52.499310000000008</c:v>
                </c:pt>
                <c:pt idx="27">
                  <c:v>45.180129999999998</c:v>
                </c:pt>
                <c:pt idx="28">
                  <c:v>39.645695000000003</c:v>
                </c:pt>
                <c:pt idx="29">
                  <c:v>35.36712</c:v>
                </c:pt>
                <c:pt idx="30">
                  <c:v>32.668669999999999</c:v>
                </c:pt>
                <c:pt idx="31">
                  <c:v>31.395935000000005</c:v>
                </c:pt>
                <c:pt idx="32">
                  <c:v>30.648360000000004</c:v>
                </c:pt>
                <c:pt idx="33">
                  <c:v>30.412814999999995</c:v>
                </c:pt>
                <c:pt idx="34">
                  <c:v>30.753299999999999</c:v>
                </c:pt>
                <c:pt idx="35">
                  <c:v>31.796014999999997</c:v>
                </c:pt>
                <c:pt idx="36">
                  <c:v>33.645249999999997</c:v>
                </c:pt>
                <c:pt idx="37">
                  <c:v>36.137</c:v>
                </c:pt>
                <c:pt idx="38">
                  <c:v>39.536495000000002</c:v>
                </c:pt>
                <c:pt idx="39">
                  <c:v>42.664095000000003</c:v>
                </c:pt>
                <c:pt idx="40">
                  <c:v>45.757885000000002</c:v>
                </c:pt>
                <c:pt idx="41">
                  <c:v>46.832639999999998</c:v>
                </c:pt>
                <c:pt idx="42">
                  <c:v>47.415700000000001</c:v>
                </c:pt>
                <c:pt idx="43">
                  <c:v>48.615580000000001</c:v>
                </c:pt>
                <c:pt idx="44">
                  <c:v>47.666195000000002</c:v>
                </c:pt>
                <c:pt idx="45">
                  <c:v>45.780425000000001</c:v>
                </c:pt>
                <c:pt idx="46">
                  <c:v>42.578060000000001</c:v>
                </c:pt>
                <c:pt idx="47">
                  <c:v>38.804964999999996</c:v>
                </c:pt>
                <c:pt idx="48">
                  <c:v>35.29083</c:v>
                </c:pt>
                <c:pt idx="49">
                  <c:v>32.058679999999995</c:v>
                </c:pt>
                <c:pt idx="50">
                  <c:v>29.35923</c:v>
                </c:pt>
                <c:pt idx="51">
                  <c:v>26.991735000000002</c:v>
                </c:pt>
                <c:pt idx="52">
                  <c:v>24.996400000000001</c:v>
                </c:pt>
                <c:pt idx="53">
                  <c:v>23.647970000000001</c:v>
                </c:pt>
                <c:pt idx="54">
                  <c:v>22.838480000000001</c:v>
                </c:pt>
                <c:pt idx="55">
                  <c:v>22.208210000000005</c:v>
                </c:pt>
                <c:pt idx="56">
                  <c:v>21.965714999999996</c:v>
                </c:pt>
                <c:pt idx="57">
                  <c:v>21.889225</c:v>
                </c:pt>
                <c:pt idx="58">
                  <c:v>22.391489999999997</c:v>
                </c:pt>
                <c:pt idx="59">
                  <c:v>23.792825000000001</c:v>
                </c:pt>
                <c:pt idx="60">
                  <c:v>25.018739999999998</c:v>
                </c:pt>
                <c:pt idx="61">
                  <c:v>26.807054999999998</c:v>
                </c:pt>
                <c:pt idx="62">
                  <c:v>28.397500000000001</c:v>
                </c:pt>
                <c:pt idx="63">
                  <c:v>29.724364999999995</c:v>
                </c:pt>
                <c:pt idx="64">
                  <c:v>30.37032</c:v>
                </c:pt>
                <c:pt idx="65">
                  <c:v>31.058299999999999</c:v>
                </c:pt>
                <c:pt idx="66">
                  <c:v>31.124500000000001</c:v>
                </c:pt>
                <c:pt idx="67">
                  <c:v>29.765879999999999</c:v>
                </c:pt>
                <c:pt idx="68">
                  <c:v>28.015499999999999</c:v>
                </c:pt>
                <c:pt idx="69">
                  <c:v>26.349839999999997</c:v>
                </c:pt>
                <c:pt idx="70">
                  <c:v>24.496949999999998</c:v>
                </c:pt>
                <c:pt idx="71">
                  <c:v>22.661279999999998</c:v>
                </c:pt>
                <c:pt idx="72">
                  <c:v>21.110195000000001</c:v>
                </c:pt>
                <c:pt idx="73">
                  <c:v>19.689039999999995</c:v>
                </c:pt>
                <c:pt idx="74">
                  <c:v>18.066804999999999</c:v>
                </c:pt>
                <c:pt idx="75">
                  <c:v>16.606295000000003</c:v>
                </c:pt>
                <c:pt idx="76">
                  <c:v>15.454560000000004</c:v>
                </c:pt>
                <c:pt idx="77">
                  <c:v>14.437095000000001</c:v>
                </c:pt>
                <c:pt idx="78">
                  <c:v>13.713475000000001</c:v>
                </c:pt>
                <c:pt idx="79">
                  <c:v>13.378839999999997</c:v>
                </c:pt>
                <c:pt idx="80">
                  <c:v>13.519489999999996</c:v>
                </c:pt>
                <c:pt idx="81">
                  <c:v>14.221810000000003</c:v>
                </c:pt>
                <c:pt idx="82">
                  <c:v>15.355864999999996</c:v>
                </c:pt>
                <c:pt idx="83">
                  <c:v>16.643550000000001</c:v>
                </c:pt>
                <c:pt idx="84">
                  <c:v>17.580960000000005</c:v>
                </c:pt>
                <c:pt idx="85">
                  <c:v>18.347795000000001</c:v>
                </c:pt>
                <c:pt idx="86">
                  <c:v>18.306260000000002</c:v>
                </c:pt>
                <c:pt idx="87">
                  <c:v>18.109874999999999</c:v>
                </c:pt>
                <c:pt idx="88">
                  <c:v>17.717339999999997</c:v>
                </c:pt>
                <c:pt idx="89">
                  <c:v>17.026575000000001</c:v>
                </c:pt>
                <c:pt idx="90">
                  <c:v>16.202960000000004</c:v>
                </c:pt>
                <c:pt idx="91">
                  <c:v>14.7858</c:v>
                </c:pt>
                <c:pt idx="92">
                  <c:v>13.636264999999996</c:v>
                </c:pt>
                <c:pt idx="93">
                  <c:v>12.683225</c:v>
                </c:pt>
                <c:pt idx="94">
                  <c:v>11.794025</c:v>
                </c:pt>
                <c:pt idx="95">
                  <c:v>10.769575</c:v>
                </c:pt>
                <c:pt idx="96">
                  <c:v>9.9861450000000005</c:v>
                </c:pt>
                <c:pt idx="97">
                  <c:v>9.4384200000000007</c:v>
                </c:pt>
                <c:pt idx="98">
                  <c:v>8.8697450000000018</c:v>
                </c:pt>
                <c:pt idx="99">
                  <c:v>8.5593799999999991</c:v>
                </c:pt>
                <c:pt idx="100">
                  <c:v>8.2532799999999984</c:v>
                </c:pt>
                <c:pt idx="101">
                  <c:v>8.1282200000000007</c:v>
                </c:pt>
                <c:pt idx="102">
                  <c:v>7.9334549999999986</c:v>
                </c:pt>
                <c:pt idx="103">
                  <c:v>8.0566600000000044</c:v>
                </c:pt>
                <c:pt idx="104">
                  <c:v>8.4236450000000005</c:v>
                </c:pt>
                <c:pt idx="105">
                  <c:v>9.0016399999999965</c:v>
                </c:pt>
                <c:pt idx="106">
                  <c:v>9.6485149999999962</c:v>
                </c:pt>
                <c:pt idx="107">
                  <c:v>10.127695000000001</c:v>
                </c:pt>
                <c:pt idx="108">
                  <c:v>10.3775</c:v>
                </c:pt>
                <c:pt idx="109">
                  <c:v>10.358939999999997</c:v>
                </c:pt>
                <c:pt idx="110">
                  <c:v>10.175314999999996</c:v>
                </c:pt>
                <c:pt idx="111">
                  <c:v>9.7000899999999959</c:v>
                </c:pt>
                <c:pt idx="112">
                  <c:v>8.9955950000000016</c:v>
                </c:pt>
                <c:pt idx="113">
                  <c:v>8.0738600000000034</c:v>
                </c:pt>
                <c:pt idx="114">
                  <c:v>7.3276700000000012</c:v>
                </c:pt>
                <c:pt idx="115">
                  <c:v>6.0045399999999969</c:v>
                </c:pt>
                <c:pt idx="116">
                  <c:v>5.4297299999999993</c:v>
                </c:pt>
                <c:pt idx="117">
                  <c:v>4.9892600000000034</c:v>
                </c:pt>
                <c:pt idx="118">
                  <c:v>4.5371200000000016</c:v>
                </c:pt>
                <c:pt idx="119">
                  <c:v>4.2617200000000013</c:v>
                </c:pt>
                <c:pt idx="120">
                  <c:v>3.9948049999999991</c:v>
                </c:pt>
                <c:pt idx="121">
                  <c:v>3.6916399999999965</c:v>
                </c:pt>
                <c:pt idx="122">
                  <c:v>3.4993100000000035</c:v>
                </c:pt>
                <c:pt idx="123">
                  <c:v>3.3389049999999987</c:v>
                </c:pt>
                <c:pt idx="124">
                  <c:v>3.2567450000000013</c:v>
                </c:pt>
                <c:pt idx="125">
                  <c:v>3.29895</c:v>
                </c:pt>
                <c:pt idx="126">
                  <c:v>3.3300200000000011</c:v>
                </c:pt>
                <c:pt idx="127">
                  <c:v>3.4904850000000036</c:v>
                </c:pt>
                <c:pt idx="128">
                  <c:v>3.7498</c:v>
                </c:pt>
                <c:pt idx="129">
                  <c:v>3.877704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4B1-4EB1-A936-395844623404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B$17:$CB$146</c:f>
              <c:numCache>
                <c:formatCode>0.00</c:formatCode>
                <c:ptCount val="130"/>
                <c:pt idx="0">
                  <c:v>48.137039999999999</c:v>
                </c:pt>
                <c:pt idx="1">
                  <c:v>48.320960000000007</c:v>
                </c:pt>
                <c:pt idx="2">
                  <c:v>40.588675000000002</c:v>
                </c:pt>
                <c:pt idx="3">
                  <c:v>37.049639999999997</c:v>
                </c:pt>
                <c:pt idx="4">
                  <c:v>32.025885000000002</c:v>
                </c:pt>
                <c:pt idx="5">
                  <c:v>27.529</c:v>
                </c:pt>
                <c:pt idx="6">
                  <c:v>24.775064999999998</c:v>
                </c:pt>
                <c:pt idx="7">
                  <c:v>23.408625000000001</c:v>
                </c:pt>
                <c:pt idx="8">
                  <c:v>23.252939999999995</c:v>
                </c:pt>
                <c:pt idx="9">
                  <c:v>24.631160000000005</c:v>
                </c:pt>
                <c:pt idx="10">
                  <c:v>27.211189999999995</c:v>
                </c:pt>
                <c:pt idx="11">
                  <c:v>32.411254999999997</c:v>
                </c:pt>
                <c:pt idx="12">
                  <c:v>39.706389999999999</c:v>
                </c:pt>
                <c:pt idx="13">
                  <c:v>50.220705000000002</c:v>
                </c:pt>
                <c:pt idx="14">
                  <c:v>63.23801000000001</c:v>
                </c:pt>
                <c:pt idx="15">
                  <c:v>76.562854999999999</c:v>
                </c:pt>
                <c:pt idx="16">
                  <c:v>87.244960000000006</c:v>
                </c:pt>
                <c:pt idx="17">
                  <c:v>98.418160000000015</c:v>
                </c:pt>
                <c:pt idx="18">
                  <c:v>101.65731000000001</c:v>
                </c:pt>
                <c:pt idx="19">
                  <c:v>103.21946000000001</c:v>
                </c:pt>
                <c:pt idx="20">
                  <c:v>104.00806999999999</c:v>
                </c:pt>
                <c:pt idx="21">
                  <c:v>102.27693000000001</c:v>
                </c:pt>
                <c:pt idx="22">
                  <c:v>95.914585000000002</c:v>
                </c:pt>
                <c:pt idx="23">
                  <c:v>83.996205000000003</c:v>
                </c:pt>
                <c:pt idx="24">
                  <c:v>69.357994999999988</c:v>
                </c:pt>
                <c:pt idx="25">
                  <c:v>55.516355000000004</c:v>
                </c:pt>
                <c:pt idx="26">
                  <c:v>44.287910000000004</c:v>
                </c:pt>
                <c:pt idx="27">
                  <c:v>36.841029999999996</c:v>
                </c:pt>
                <c:pt idx="28">
                  <c:v>32.826895</c:v>
                </c:pt>
                <c:pt idx="29">
                  <c:v>30.09862</c:v>
                </c:pt>
                <c:pt idx="30">
                  <c:v>28.37847</c:v>
                </c:pt>
                <c:pt idx="31">
                  <c:v>27.066935000000004</c:v>
                </c:pt>
                <c:pt idx="32">
                  <c:v>25.988660000000003</c:v>
                </c:pt>
                <c:pt idx="33">
                  <c:v>25.321614999999998</c:v>
                </c:pt>
                <c:pt idx="34">
                  <c:v>25.437000000000001</c:v>
                </c:pt>
                <c:pt idx="35">
                  <c:v>26.963014999999995</c:v>
                </c:pt>
                <c:pt idx="36">
                  <c:v>30.349450000000001</c:v>
                </c:pt>
                <c:pt idx="37">
                  <c:v>35.959299999999999</c:v>
                </c:pt>
                <c:pt idx="38">
                  <c:v>42.610195000000004</c:v>
                </c:pt>
                <c:pt idx="39">
                  <c:v>48.571494999999999</c:v>
                </c:pt>
                <c:pt idx="40">
                  <c:v>52.050185000000006</c:v>
                </c:pt>
                <c:pt idx="41">
                  <c:v>50.85774</c:v>
                </c:pt>
                <c:pt idx="42">
                  <c:v>48.627800000000001</c:v>
                </c:pt>
                <c:pt idx="43">
                  <c:v>48.412579999999998</c:v>
                </c:pt>
                <c:pt idx="44">
                  <c:v>47.615295000000003</c:v>
                </c:pt>
                <c:pt idx="45">
                  <c:v>46.467624999999998</c:v>
                </c:pt>
                <c:pt idx="46">
                  <c:v>43.820760000000007</c:v>
                </c:pt>
                <c:pt idx="47">
                  <c:v>39.741664999999998</c:v>
                </c:pt>
                <c:pt idx="48">
                  <c:v>34.451729999999998</c:v>
                </c:pt>
                <c:pt idx="49">
                  <c:v>29.291879999999999</c:v>
                </c:pt>
                <c:pt idx="50">
                  <c:v>25.02553</c:v>
                </c:pt>
                <c:pt idx="51">
                  <c:v>21.834835000000002</c:v>
                </c:pt>
                <c:pt idx="52">
                  <c:v>19.439</c:v>
                </c:pt>
                <c:pt idx="53">
                  <c:v>18.191470000000002</c:v>
                </c:pt>
                <c:pt idx="54">
                  <c:v>17.870079999999998</c:v>
                </c:pt>
                <c:pt idx="55">
                  <c:v>18.263910000000003</c:v>
                </c:pt>
                <c:pt idx="56">
                  <c:v>19.257714999999997</c:v>
                </c:pt>
                <c:pt idx="57">
                  <c:v>20.610325</c:v>
                </c:pt>
                <c:pt idx="58">
                  <c:v>21.872289999999996</c:v>
                </c:pt>
                <c:pt idx="59">
                  <c:v>23.351925000000001</c:v>
                </c:pt>
                <c:pt idx="60">
                  <c:v>24.544839999999997</c:v>
                </c:pt>
                <c:pt idx="61">
                  <c:v>25.961454999999997</c:v>
                </c:pt>
                <c:pt idx="62">
                  <c:v>26.962499999999999</c:v>
                </c:pt>
                <c:pt idx="63">
                  <c:v>28.332864999999998</c:v>
                </c:pt>
                <c:pt idx="64">
                  <c:v>29.913320000000002</c:v>
                </c:pt>
                <c:pt idx="65">
                  <c:v>31.928799999999999</c:v>
                </c:pt>
                <c:pt idx="66">
                  <c:v>34.031999999999996</c:v>
                </c:pt>
                <c:pt idx="67">
                  <c:v>34.604979999999998</c:v>
                </c:pt>
                <c:pt idx="68">
                  <c:v>33.641100000000002</c:v>
                </c:pt>
                <c:pt idx="69">
                  <c:v>30.662339999999997</c:v>
                </c:pt>
                <c:pt idx="70">
                  <c:v>27.360749999999999</c:v>
                </c:pt>
                <c:pt idx="71">
                  <c:v>24.273879999999998</c:v>
                </c:pt>
                <c:pt idx="72">
                  <c:v>21.543995000000002</c:v>
                </c:pt>
                <c:pt idx="73">
                  <c:v>19.390739999999997</c:v>
                </c:pt>
                <c:pt idx="74">
                  <c:v>17.893704999999997</c:v>
                </c:pt>
                <c:pt idx="75">
                  <c:v>17.065195000000003</c:v>
                </c:pt>
                <c:pt idx="76">
                  <c:v>16.161960000000004</c:v>
                </c:pt>
                <c:pt idx="77">
                  <c:v>15.616595000000002</c:v>
                </c:pt>
                <c:pt idx="78">
                  <c:v>15.328474999999999</c:v>
                </c:pt>
                <c:pt idx="79">
                  <c:v>15.490039999999997</c:v>
                </c:pt>
                <c:pt idx="80">
                  <c:v>15.615289999999996</c:v>
                </c:pt>
                <c:pt idx="81">
                  <c:v>15.878110000000003</c:v>
                </c:pt>
                <c:pt idx="82">
                  <c:v>16.529164999999995</c:v>
                </c:pt>
                <c:pt idx="83">
                  <c:v>17.927050000000001</c:v>
                </c:pt>
                <c:pt idx="84">
                  <c:v>19.758360000000003</c:v>
                </c:pt>
                <c:pt idx="85">
                  <c:v>21.348395</c:v>
                </c:pt>
                <c:pt idx="86">
                  <c:v>22.925060000000002</c:v>
                </c:pt>
                <c:pt idx="87">
                  <c:v>23.785475000000002</c:v>
                </c:pt>
                <c:pt idx="88">
                  <c:v>23.859839999999995</c:v>
                </c:pt>
                <c:pt idx="89">
                  <c:v>22.751574999999999</c:v>
                </c:pt>
                <c:pt idx="90">
                  <c:v>21.148360000000004</c:v>
                </c:pt>
                <c:pt idx="91">
                  <c:v>18.8935</c:v>
                </c:pt>
                <c:pt idx="92">
                  <c:v>17.991564999999998</c:v>
                </c:pt>
                <c:pt idx="93">
                  <c:v>17.384425</c:v>
                </c:pt>
                <c:pt idx="94">
                  <c:v>16.572825000000002</c:v>
                </c:pt>
                <c:pt idx="95">
                  <c:v>15.447875</c:v>
                </c:pt>
                <c:pt idx="96">
                  <c:v>14.720045000000001</c:v>
                </c:pt>
                <c:pt idx="97">
                  <c:v>13.31892</c:v>
                </c:pt>
                <c:pt idx="98">
                  <c:v>12.359845000000002</c:v>
                </c:pt>
                <c:pt idx="99">
                  <c:v>11.638279999999998</c:v>
                </c:pt>
                <c:pt idx="100">
                  <c:v>11.18878</c:v>
                </c:pt>
                <c:pt idx="101">
                  <c:v>11.464120000000001</c:v>
                </c:pt>
                <c:pt idx="102">
                  <c:v>12.065655</c:v>
                </c:pt>
                <c:pt idx="103">
                  <c:v>12.954060000000004</c:v>
                </c:pt>
                <c:pt idx="104">
                  <c:v>13.891345000000001</c:v>
                </c:pt>
                <c:pt idx="105">
                  <c:v>14.748939999999996</c:v>
                </c:pt>
                <c:pt idx="106">
                  <c:v>15.514314999999996</c:v>
                </c:pt>
                <c:pt idx="107">
                  <c:v>16.351694999999999</c:v>
                </c:pt>
                <c:pt idx="108">
                  <c:v>16.925000000000001</c:v>
                </c:pt>
                <c:pt idx="109">
                  <c:v>17.268039999999996</c:v>
                </c:pt>
                <c:pt idx="110">
                  <c:v>17.465914999999995</c:v>
                </c:pt>
                <c:pt idx="111">
                  <c:v>17.022589999999997</c:v>
                </c:pt>
                <c:pt idx="112">
                  <c:v>16.248795000000001</c:v>
                </c:pt>
                <c:pt idx="113">
                  <c:v>14.934260000000004</c:v>
                </c:pt>
                <c:pt idx="114">
                  <c:v>13.456770000000001</c:v>
                </c:pt>
                <c:pt idx="115">
                  <c:v>10.343339999999996</c:v>
                </c:pt>
                <c:pt idx="116">
                  <c:v>9.1007299999999987</c:v>
                </c:pt>
                <c:pt idx="117">
                  <c:v>8.2075600000000026</c:v>
                </c:pt>
                <c:pt idx="118">
                  <c:v>7.3812200000000008</c:v>
                </c:pt>
                <c:pt idx="119">
                  <c:v>6.9555200000000008</c:v>
                </c:pt>
                <c:pt idx="120">
                  <c:v>6.6427049999999985</c:v>
                </c:pt>
                <c:pt idx="121">
                  <c:v>6.3209399999999967</c:v>
                </c:pt>
                <c:pt idx="122">
                  <c:v>6.0706100000000038</c:v>
                </c:pt>
                <c:pt idx="123">
                  <c:v>5.9419049999999984</c:v>
                </c:pt>
                <c:pt idx="124">
                  <c:v>7.755745000000001</c:v>
                </c:pt>
                <c:pt idx="125">
                  <c:v>6.0604500000000003</c:v>
                </c:pt>
                <c:pt idx="126">
                  <c:v>6.1236200000000007</c:v>
                </c:pt>
                <c:pt idx="127">
                  <c:v>6.2586850000000034</c:v>
                </c:pt>
                <c:pt idx="128">
                  <c:v>6.6509</c:v>
                </c:pt>
                <c:pt idx="129">
                  <c:v>6.9197049999999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4B1-4EB1-A936-3958446234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471040"/>
        <c:axId val="64472576"/>
      </c:lineChart>
      <c:catAx>
        <c:axId val="64471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472576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472576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4710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W$17:$BW$146</c:f>
              <c:numCache>
                <c:formatCode>0.00</c:formatCode>
                <c:ptCount val="130"/>
                <c:pt idx="0">
                  <c:v>158.30223999999998</c:v>
                </c:pt>
                <c:pt idx="1">
                  <c:v>143.02136000000002</c:v>
                </c:pt>
                <c:pt idx="2">
                  <c:v>102.409875</c:v>
                </c:pt>
                <c:pt idx="3">
                  <c:v>88.921039999999991</c:v>
                </c:pt>
                <c:pt idx="4">
                  <c:v>75.346085000000016</c:v>
                </c:pt>
                <c:pt idx="5">
                  <c:v>63.688600000000001</c:v>
                </c:pt>
                <c:pt idx="6">
                  <c:v>56.905864999999991</c:v>
                </c:pt>
                <c:pt idx="7">
                  <c:v>53.482424999999999</c:v>
                </c:pt>
                <c:pt idx="8">
                  <c:v>53.007039999999989</c:v>
                </c:pt>
                <c:pt idx="9">
                  <c:v>54.360260000000011</c:v>
                </c:pt>
                <c:pt idx="10">
                  <c:v>55.666289999999989</c:v>
                </c:pt>
                <c:pt idx="11">
                  <c:v>56.875855000000001</c:v>
                </c:pt>
                <c:pt idx="12">
                  <c:v>57.24378999999999</c:v>
                </c:pt>
                <c:pt idx="13">
                  <c:v>58.543805000000006</c:v>
                </c:pt>
                <c:pt idx="14">
                  <c:v>59.971010000000007</c:v>
                </c:pt>
                <c:pt idx="15">
                  <c:v>60.244155000000006</c:v>
                </c:pt>
                <c:pt idx="16">
                  <c:v>61.239660000000008</c:v>
                </c:pt>
                <c:pt idx="17">
                  <c:v>69.170360000000002</c:v>
                </c:pt>
                <c:pt idx="18">
                  <c:v>73.35381000000001</c:v>
                </c:pt>
                <c:pt idx="19">
                  <c:v>77.315760000000012</c:v>
                </c:pt>
                <c:pt idx="20">
                  <c:v>79.934169999999995</c:v>
                </c:pt>
                <c:pt idx="21">
                  <c:v>80.703530000000001</c:v>
                </c:pt>
                <c:pt idx="22">
                  <c:v>80.912885000000003</c:v>
                </c:pt>
                <c:pt idx="23">
                  <c:v>81.890205000000009</c:v>
                </c:pt>
                <c:pt idx="24">
                  <c:v>83.930094999999994</c:v>
                </c:pt>
                <c:pt idx="25">
                  <c:v>86.287154999999998</c:v>
                </c:pt>
                <c:pt idx="26">
                  <c:v>87.427310000000006</c:v>
                </c:pt>
                <c:pt idx="27">
                  <c:v>87.979330000000004</c:v>
                </c:pt>
                <c:pt idx="28">
                  <c:v>87.188594999999992</c:v>
                </c:pt>
                <c:pt idx="29">
                  <c:v>86.078620000000001</c:v>
                </c:pt>
                <c:pt idx="30">
                  <c:v>84.08117</c:v>
                </c:pt>
                <c:pt idx="31">
                  <c:v>83.773935000000009</c:v>
                </c:pt>
                <c:pt idx="32">
                  <c:v>83.016360000000006</c:v>
                </c:pt>
                <c:pt idx="33">
                  <c:v>81.905114999999995</c:v>
                </c:pt>
                <c:pt idx="34">
                  <c:v>80.005700000000004</c:v>
                </c:pt>
                <c:pt idx="35">
                  <c:v>76.935514999999995</c:v>
                </c:pt>
                <c:pt idx="36">
                  <c:v>72.856250000000003</c:v>
                </c:pt>
                <c:pt idx="37">
                  <c:v>69.215100000000007</c:v>
                </c:pt>
                <c:pt idx="38">
                  <c:v>66.556294999999992</c:v>
                </c:pt>
                <c:pt idx="39">
                  <c:v>64.765394999999998</c:v>
                </c:pt>
                <c:pt idx="40">
                  <c:v>62.340485000000008</c:v>
                </c:pt>
                <c:pt idx="41">
                  <c:v>56.48543999999999</c:v>
                </c:pt>
                <c:pt idx="42">
                  <c:v>51.394199999999998</c:v>
                </c:pt>
                <c:pt idx="43">
                  <c:v>49.031779999999998</c:v>
                </c:pt>
                <c:pt idx="44">
                  <c:v>47.174195000000005</c:v>
                </c:pt>
                <c:pt idx="45">
                  <c:v>46.096924999999999</c:v>
                </c:pt>
                <c:pt idx="46">
                  <c:v>45.514960000000002</c:v>
                </c:pt>
                <c:pt idx="47">
                  <c:v>45.090564999999998</c:v>
                </c:pt>
                <c:pt idx="48">
                  <c:v>45.08643</c:v>
                </c:pt>
                <c:pt idx="49">
                  <c:v>44.54748</c:v>
                </c:pt>
                <c:pt idx="50">
                  <c:v>43.906129999999997</c:v>
                </c:pt>
                <c:pt idx="51">
                  <c:v>43.396735000000007</c:v>
                </c:pt>
                <c:pt idx="52">
                  <c:v>42.901200000000003</c:v>
                </c:pt>
                <c:pt idx="53">
                  <c:v>42.74747</c:v>
                </c:pt>
                <c:pt idx="54">
                  <c:v>42.537680000000002</c:v>
                </c:pt>
                <c:pt idx="55">
                  <c:v>42.451210000000003</c:v>
                </c:pt>
                <c:pt idx="56">
                  <c:v>42.178914999999996</c:v>
                </c:pt>
                <c:pt idx="57">
                  <c:v>41.562925</c:v>
                </c:pt>
                <c:pt idx="58">
                  <c:v>41.179289999999995</c:v>
                </c:pt>
                <c:pt idx="59">
                  <c:v>40.614924999999999</c:v>
                </c:pt>
                <c:pt idx="60">
                  <c:v>39.79054</c:v>
                </c:pt>
                <c:pt idx="61">
                  <c:v>39.106054999999998</c:v>
                </c:pt>
                <c:pt idx="62">
                  <c:v>38.044800000000002</c:v>
                </c:pt>
                <c:pt idx="63">
                  <c:v>37.300564999999999</c:v>
                </c:pt>
                <c:pt idx="64">
                  <c:v>35.931519999999999</c:v>
                </c:pt>
                <c:pt idx="65">
                  <c:v>35.814599999999999</c:v>
                </c:pt>
                <c:pt idx="66">
                  <c:v>35.955199999999998</c:v>
                </c:pt>
                <c:pt idx="67">
                  <c:v>35.490679999999998</c:v>
                </c:pt>
                <c:pt idx="68">
                  <c:v>35.1569</c:v>
                </c:pt>
                <c:pt idx="69">
                  <c:v>34.850839999999998</c:v>
                </c:pt>
                <c:pt idx="70">
                  <c:v>34.881149999999998</c:v>
                </c:pt>
                <c:pt idx="71">
                  <c:v>34.900379999999998</c:v>
                </c:pt>
                <c:pt idx="72">
                  <c:v>34.420895000000002</c:v>
                </c:pt>
                <c:pt idx="73">
                  <c:v>33.988639999999997</c:v>
                </c:pt>
                <c:pt idx="74">
                  <c:v>33.323605000000001</c:v>
                </c:pt>
                <c:pt idx="75">
                  <c:v>32.730895000000004</c:v>
                </c:pt>
                <c:pt idx="76">
                  <c:v>32.151360000000004</c:v>
                </c:pt>
                <c:pt idx="77">
                  <c:v>31.947795000000003</c:v>
                </c:pt>
                <c:pt idx="78">
                  <c:v>31.730975000000001</c:v>
                </c:pt>
                <c:pt idx="79">
                  <c:v>31.278339999999996</c:v>
                </c:pt>
                <c:pt idx="80">
                  <c:v>30.480689999999996</c:v>
                </c:pt>
                <c:pt idx="81">
                  <c:v>29.413710000000002</c:v>
                </c:pt>
                <c:pt idx="82">
                  <c:v>28.749464999999997</c:v>
                </c:pt>
                <c:pt idx="83">
                  <c:v>28.312850000000001</c:v>
                </c:pt>
                <c:pt idx="84">
                  <c:v>27.937960000000004</c:v>
                </c:pt>
                <c:pt idx="85">
                  <c:v>28.196194999999999</c:v>
                </c:pt>
                <c:pt idx="86">
                  <c:v>28.513960000000004</c:v>
                </c:pt>
                <c:pt idx="87">
                  <c:v>28.363275000000002</c:v>
                </c:pt>
                <c:pt idx="88">
                  <c:v>28.688939999999995</c:v>
                </c:pt>
                <c:pt idx="89">
                  <c:v>28.485575000000001</c:v>
                </c:pt>
                <c:pt idx="90">
                  <c:v>28.084460000000004</c:v>
                </c:pt>
                <c:pt idx="91">
                  <c:v>26.746700000000001</c:v>
                </c:pt>
                <c:pt idx="92">
                  <c:v>26.026664999999998</c:v>
                </c:pt>
                <c:pt idx="93">
                  <c:v>25.505925000000001</c:v>
                </c:pt>
                <c:pt idx="94">
                  <c:v>25.308225</c:v>
                </c:pt>
                <c:pt idx="95">
                  <c:v>25.218375000000002</c:v>
                </c:pt>
                <c:pt idx="96">
                  <c:v>24.726745000000001</c:v>
                </c:pt>
                <c:pt idx="97">
                  <c:v>24.510020000000001</c:v>
                </c:pt>
                <c:pt idx="98">
                  <c:v>24.350745</c:v>
                </c:pt>
                <c:pt idx="99">
                  <c:v>23.972579999999997</c:v>
                </c:pt>
                <c:pt idx="100">
                  <c:v>23.430879999999998</c:v>
                </c:pt>
                <c:pt idx="101">
                  <c:v>22.871220000000001</c:v>
                </c:pt>
                <c:pt idx="102">
                  <c:v>22.350655</c:v>
                </c:pt>
                <c:pt idx="103">
                  <c:v>21.787960000000002</c:v>
                </c:pt>
                <c:pt idx="104">
                  <c:v>21.336745000000001</c:v>
                </c:pt>
                <c:pt idx="105">
                  <c:v>20.879039999999996</c:v>
                </c:pt>
                <c:pt idx="106">
                  <c:v>20.078214999999997</c:v>
                </c:pt>
                <c:pt idx="107">
                  <c:v>19.522495000000003</c:v>
                </c:pt>
                <c:pt idx="108">
                  <c:v>19.000599999999999</c:v>
                </c:pt>
                <c:pt idx="109">
                  <c:v>18.367039999999996</c:v>
                </c:pt>
                <c:pt idx="110">
                  <c:v>17.897014999999996</c:v>
                </c:pt>
                <c:pt idx="111">
                  <c:v>17.684289999999997</c:v>
                </c:pt>
                <c:pt idx="112">
                  <c:v>17.164795000000002</c:v>
                </c:pt>
                <c:pt idx="113">
                  <c:v>16.648560000000003</c:v>
                </c:pt>
                <c:pt idx="114">
                  <c:v>15.973970000000001</c:v>
                </c:pt>
                <c:pt idx="115">
                  <c:v>13.429839999999997</c:v>
                </c:pt>
                <c:pt idx="116">
                  <c:v>12.963729999999998</c:v>
                </c:pt>
                <c:pt idx="117">
                  <c:v>12.707660000000004</c:v>
                </c:pt>
                <c:pt idx="118">
                  <c:v>12.475520000000001</c:v>
                </c:pt>
                <c:pt idx="119">
                  <c:v>12.408320000000002</c:v>
                </c:pt>
                <c:pt idx="120">
                  <c:v>12.122704999999998</c:v>
                </c:pt>
                <c:pt idx="121">
                  <c:v>11.601039999999996</c:v>
                </c:pt>
                <c:pt idx="122">
                  <c:v>11.175110000000004</c:v>
                </c:pt>
                <c:pt idx="123">
                  <c:v>10.947904999999999</c:v>
                </c:pt>
                <c:pt idx="124">
                  <c:v>10.737745</c:v>
                </c:pt>
                <c:pt idx="125">
                  <c:v>10.62825</c:v>
                </c:pt>
                <c:pt idx="126">
                  <c:v>10.46602</c:v>
                </c:pt>
                <c:pt idx="127">
                  <c:v>10.373185000000003</c:v>
                </c:pt>
                <c:pt idx="128">
                  <c:v>10.4642</c:v>
                </c:pt>
                <c:pt idx="129">
                  <c:v>10.290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A1-4CEE-BE54-24FCE4B0E50F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X$17:$BX$146</c:f>
              <c:numCache>
                <c:formatCode>0.00</c:formatCode>
                <c:ptCount val="130"/>
                <c:pt idx="0">
                  <c:v>129.03413999999998</c:v>
                </c:pt>
                <c:pt idx="1">
                  <c:v>105.98266000000001</c:v>
                </c:pt>
                <c:pt idx="2">
                  <c:v>74.031874999999999</c:v>
                </c:pt>
                <c:pt idx="3">
                  <c:v>65.564439999999991</c:v>
                </c:pt>
                <c:pt idx="4">
                  <c:v>58.218785000000011</c:v>
                </c:pt>
                <c:pt idx="5">
                  <c:v>51.677799999999998</c:v>
                </c:pt>
                <c:pt idx="6">
                  <c:v>46.560964999999996</c:v>
                </c:pt>
                <c:pt idx="7">
                  <c:v>42.538825000000003</c:v>
                </c:pt>
                <c:pt idx="8">
                  <c:v>39.205439999999996</c:v>
                </c:pt>
                <c:pt idx="9">
                  <c:v>37.365160000000003</c:v>
                </c:pt>
                <c:pt idx="10">
                  <c:v>36.190389999999994</c:v>
                </c:pt>
                <c:pt idx="11">
                  <c:v>36.497054999999996</c:v>
                </c:pt>
                <c:pt idx="12">
                  <c:v>36.810689999999994</c:v>
                </c:pt>
                <c:pt idx="13">
                  <c:v>38.541905</c:v>
                </c:pt>
                <c:pt idx="14">
                  <c:v>41.454810000000002</c:v>
                </c:pt>
                <c:pt idx="15">
                  <c:v>43.418054999999995</c:v>
                </c:pt>
                <c:pt idx="16">
                  <c:v>44.832560000000001</c:v>
                </c:pt>
                <c:pt idx="17">
                  <c:v>51.610660000000003</c:v>
                </c:pt>
                <c:pt idx="18">
                  <c:v>54.354010000000009</c:v>
                </c:pt>
                <c:pt idx="19">
                  <c:v>55.659760000000013</c:v>
                </c:pt>
                <c:pt idx="20">
                  <c:v>56.286769999999997</c:v>
                </c:pt>
                <c:pt idx="21">
                  <c:v>56.732530000000004</c:v>
                </c:pt>
                <c:pt idx="22">
                  <c:v>57.128285000000012</c:v>
                </c:pt>
                <c:pt idx="23">
                  <c:v>57.791805000000004</c:v>
                </c:pt>
                <c:pt idx="24">
                  <c:v>59.441194999999993</c:v>
                </c:pt>
                <c:pt idx="25">
                  <c:v>61.794855000000005</c:v>
                </c:pt>
                <c:pt idx="26">
                  <c:v>65.204210000000003</c:v>
                </c:pt>
                <c:pt idx="27">
                  <c:v>68.024430000000009</c:v>
                </c:pt>
                <c:pt idx="28">
                  <c:v>68.506495000000001</c:v>
                </c:pt>
                <c:pt idx="29">
                  <c:v>65.134919999999994</c:v>
                </c:pt>
                <c:pt idx="30">
                  <c:v>61.469569999999997</c:v>
                </c:pt>
                <c:pt idx="31">
                  <c:v>58.812735000000011</c:v>
                </c:pt>
                <c:pt idx="32">
                  <c:v>58.631960000000007</c:v>
                </c:pt>
                <c:pt idx="33">
                  <c:v>58.973114999999993</c:v>
                </c:pt>
                <c:pt idx="34">
                  <c:v>60.243299999999998</c:v>
                </c:pt>
                <c:pt idx="35">
                  <c:v>60.288614999999993</c:v>
                </c:pt>
                <c:pt idx="36">
                  <c:v>57.55545</c:v>
                </c:pt>
                <c:pt idx="37">
                  <c:v>53.487299999999998</c:v>
                </c:pt>
                <c:pt idx="38">
                  <c:v>48.660395000000001</c:v>
                </c:pt>
                <c:pt idx="39">
                  <c:v>45.678795000000001</c:v>
                </c:pt>
                <c:pt idx="40">
                  <c:v>44.059585000000006</c:v>
                </c:pt>
                <c:pt idx="41">
                  <c:v>41.160539999999997</c:v>
                </c:pt>
                <c:pt idx="42">
                  <c:v>39.701999999999998</c:v>
                </c:pt>
                <c:pt idx="43">
                  <c:v>38.87388</c:v>
                </c:pt>
                <c:pt idx="44">
                  <c:v>36.578095000000005</c:v>
                </c:pt>
                <c:pt idx="45">
                  <c:v>34.099924999999999</c:v>
                </c:pt>
                <c:pt idx="46">
                  <c:v>32.04466</c:v>
                </c:pt>
                <c:pt idx="47">
                  <c:v>30.999164999999998</c:v>
                </c:pt>
                <c:pt idx="48">
                  <c:v>30.64733</c:v>
                </c:pt>
                <c:pt idx="49">
                  <c:v>32.052479999999996</c:v>
                </c:pt>
                <c:pt idx="50">
                  <c:v>33.962029999999999</c:v>
                </c:pt>
                <c:pt idx="51">
                  <c:v>33.607635000000002</c:v>
                </c:pt>
                <c:pt idx="52">
                  <c:v>32.224800000000002</c:v>
                </c:pt>
                <c:pt idx="53">
                  <c:v>30.699870000000001</c:v>
                </c:pt>
                <c:pt idx="54">
                  <c:v>30.47128</c:v>
                </c:pt>
                <c:pt idx="55">
                  <c:v>31.449310000000004</c:v>
                </c:pt>
                <c:pt idx="56">
                  <c:v>32.714115</c:v>
                </c:pt>
                <c:pt idx="57">
                  <c:v>33.741025</c:v>
                </c:pt>
                <c:pt idx="58">
                  <c:v>33.789489999999994</c:v>
                </c:pt>
                <c:pt idx="59">
                  <c:v>32.399625</c:v>
                </c:pt>
                <c:pt idx="60">
                  <c:v>30.678839999999997</c:v>
                </c:pt>
                <c:pt idx="61">
                  <c:v>29.328154999999999</c:v>
                </c:pt>
                <c:pt idx="62">
                  <c:v>28.3764</c:v>
                </c:pt>
                <c:pt idx="63">
                  <c:v>28.097164999999997</c:v>
                </c:pt>
                <c:pt idx="64">
                  <c:v>28.532420000000002</c:v>
                </c:pt>
                <c:pt idx="65">
                  <c:v>30.075299999999999</c:v>
                </c:pt>
                <c:pt idx="66">
                  <c:v>30.832000000000001</c:v>
                </c:pt>
                <c:pt idx="67">
                  <c:v>29.539279999999998</c:v>
                </c:pt>
                <c:pt idx="68">
                  <c:v>27.998699999999999</c:v>
                </c:pt>
                <c:pt idx="69">
                  <c:v>26.526139999999998</c:v>
                </c:pt>
                <c:pt idx="70">
                  <c:v>26.01135</c:v>
                </c:pt>
                <c:pt idx="71">
                  <c:v>26.19698</c:v>
                </c:pt>
                <c:pt idx="72">
                  <c:v>27.886795000000003</c:v>
                </c:pt>
                <c:pt idx="73">
                  <c:v>29.600639999999995</c:v>
                </c:pt>
                <c:pt idx="74">
                  <c:v>30.008105</c:v>
                </c:pt>
                <c:pt idx="75">
                  <c:v>29.052894999999999</c:v>
                </c:pt>
                <c:pt idx="76">
                  <c:v>27.792960000000004</c:v>
                </c:pt>
                <c:pt idx="77">
                  <c:v>27.053495000000002</c:v>
                </c:pt>
                <c:pt idx="78">
                  <c:v>26.831375000000001</c:v>
                </c:pt>
                <c:pt idx="79">
                  <c:v>27.626839999999998</c:v>
                </c:pt>
                <c:pt idx="80">
                  <c:v>27.970189999999995</c:v>
                </c:pt>
                <c:pt idx="81">
                  <c:v>27.728110000000004</c:v>
                </c:pt>
                <c:pt idx="82">
                  <c:v>26.930664999999998</c:v>
                </c:pt>
                <c:pt idx="83">
                  <c:v>25.732749999999999</c:v>
                </c:pt>
                <c:pt idx="84">
                  <c:v>24.213760000000004</c:v>
                </c:pt>
                <c:pt idx="85">
                  <c:v>23.154295000000001</c:v>
                </c:pt>
                <c:pt idx="86">
                  <c:v>22.495360000000005</c:v>
                </c:pt>
                <c:pt idx="87">
                  <c:v>22.742975000000001</c:v>
                </c:pt>
                <c:pt idx="88">
                  <c:v>24.688639999999996</c:v>
                </c:pt>
                <c:pt idx="89">
                  <c:v>25.851775</c:v>
                </c:pt>
                <c:pt idx="90">
                  <c:v>25.869460000000004</c:v>
                </c:pt>
                <c:pt idx="91">
                  <c:v>24.357299999999999</c:v>
                </c:pt>
                <c:pt idx="92">
                  <c:v>23.599464999999995</c:v>
                </c:pt>
                <c:pt idx="93">
                  <c:v>23.045625000000001</c:v>
                </c:pt>
                <c:pt idx="94">
                  <c:v>22.718824999999999</c:v>
                </c:pt>
                <c:pt idx="95">
                  <c:v>22.838774999999998</c:v>
                </c:pt>
                <c:pt idx="96">
                  <c:v>23.150845</c:v>
                </c:pt>
                <c:pt idx="97">
                  <c:v>23.62172</c:v>
                </c:pt>
                <c:pt idx="98">
                  <c:v>23.656345000000002</c:v>
                </c:pt>
                <c:pt idx="99">
                  <c:v>23.102779999999999</c:v>
                </c:pt>
                <c:pt idx="100">
                  <c:v>22.213979999999999</c:v>
                </c:pt>
                <c:pt idx="101">
                  <c:v>21.33522</c:v>
                </c:pt>
                <c:pt idx="102">
                  <c:v>20.823454999999999</c:v>
                </c:pt>
                <c:pt idx="103">
                  <c:v>20.667460000000002</c:v>
                </c:pt>
                <c:pt idx="104">
                  <c:v>21.039845</c:v>
                </c:pt>
                <c:pt idx="105">
                  <c:v>21.740939999999995</c:v>
                </c:pt>
                <c:pt idx="106">
                  <c:v>21.879614999999998</c:v>
                </c:pt>
                <c:pt idx="107">
                  <c:v>21.625895</c:v>
                </c:pt>
                <c:pt idx="108">
                  <c:v>21.0349</c:v>
                </c:pt>
                <c:pt idx="109">
                  <c:v>20.502839999999996</c:v>
                </c:pt>
                <c:pt idx="110">
                  <c:v>20.167114999999995</c:v>
                </c:pt>
                <c:pt idx="111">
                  <c:v>20.136689999999998</c:v>
                </c:pt>
                <c:pt idx="112">
                  <c:v>20.148495</c:v>
                </c:pt>
                <c:pt idx="113">
                  <c:v>19.970360000000003</c:v>
                </c:pt>
                <c:pt idx="114">
                  <c:v>19.66657</c:v>
                </c:pt>
                <c:pt idx="115">
                  <c:v>15.416539999999996</c:v>
                </c:pt>
                <c:pt idx="116">
                  <c:v>14.574029999999999</c:v>
                </c:pt>
                <c:pt idx="117">
                  <c:v>13.796160000000004</c:v>
                </c:pt>
                <c:pt idx="118">
                  <c:v>12.962120000000001</c:v>
                </c:pt>
                <c:pt idx="119">
                  <c:v>12.269220000000001</c:v>
                </c:pt>
                <c:pt idx="120">
                  <c:v>11.675504999999999</c:v>
                </c:pt>
                <c:pt idx="121">
                  <c:v>10.882939999999996</c:v>
                </c:pt>
                <c:pt idx="122">
                  <c:v>10.266210000000003</c:v>
                </c:pt>
                <c:pt idx="123">
                  <c:v>9.9149049999999992</c:v>
                </c:pt>
                <c:pt idx="124">
                  <c:v>9.657745000000002</c:v>
                </c:pt>
                <c:pt idx="125">
                  <c:v>9.6053499999999996</c:v>
                </c:pt>
                <c:pt idx="126">
                  <c:v>9.6274200000000008</c:v>
                </c:pt>
                <c:pt idx="127">
                  <c:v>9.4940850000000037</c:v>
                </c:pt>
                <c:pt idx="128">
                  <c:v>9.6679999999999993</c:v>
                </c:pt>
                <c:pt idx="129">
                  <c:v>9.336304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BA1-4CEE-BE54-24FCE4B0E50F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Y$17:$BY$146</c:f>
              <c:numCache>
                <c:formatCode>0.00</c:formatCode>
                <c:ptCount val="130"/>
                <c:pt idx="0">
                  <c:v>171.28943999999998</c:v>
                </c:pt>
                <c:pt idx="1">
                  <c:v>147.18306000000001</c:v>
                </c:pt>
                <c:pt idx="2">
                  <c:v>100.990775</c:v>
                </c:pt>
                <c:pt idx="3">
                  <c:v>82.674239999999998</c:v>
                </c:pt>
                <c:pt idx="4">
                  <c:v>68.411985000000016</c:v>
                </c:pt>
                <c:pt idx="5">
                  <c:v>57.820900000000002</c:v>
                </c:pt>
                <c:pt idx="6">
                  <c:v>50.186064999999999</c:v>
                </c:pt>
                <c:pt idx="7">
                  <c:v>45.935025000000003</c:v>
                </c:pt>
                <c:pt idx="8">
                  <c:v>46.195039999999999</c:v>
                </c:pt>
                <c:pt idx="9">
                  <c:v>48.647560000000006</c:v>
                </c:pt>
                <c:pt idx="10">
                  <c:v>48.603189999999998</c:v>
                </c:pt>
                <c:pt idx="11">
                  <c:v>49.006754999999998</c:v>
                </c:pt>
                <c:pt idx="12">
                  <c:v>48.315989999999999</c:v>
                </c:pt>
                <c:pt idx="13">
                  <c:v>49.366205000000001</c:v>
                </c:pt>
                <c:pt idx="14">
                  <c:v>51.31221</c:v>
                </c:pt>
                <c:pt idx="15">
                  <c:v>53.302955000000004</c:v>
                </c:pt>
                <c:pt idx="16">
                  <c:v>56.497560000000007</c:v>
                </c:pt>
                <c:pt idx="17">
                  <c:v>67.769160000000014</c:v>
                </c:pt>
                <c:pt idx="18">
                  <c:v>69.717810000000014</c:v>
                </c:pt>
                <c:pt idx="19">
                  <c:v>70.413460000000015</c:v>
                </c:pt>
                <c:pt idx="20">
                  <c:v>70.871470000000002</c:v>
                </c:pt>
                <c:pt idx="21">
                  <c:v>72.988330000000005</c:v>
                </c:pt>
                <c:pt idx="22">
                  <c:v>75.221185000000006</c:v>
                </c:pt>
                <c:pt idx="23">
                  <c:v>78.746305000000007</c:v>
                </c:pt>
                <c:pt idx="24">
                  <c:v>80.201594999999998</c:v>
                </c:pt>
                <c:pt idx="25">
                  <c:v>79.202655000000007</c:v>
                </c:pt>
                <c:pt idx="26">
                  <c:v>77.134110000000007</c:v>
                </c:pt>
                <c:pt idx="27">
                  <c:v>76.096830000000011</c:v>
                </c:pt>
                <c:pt idx="28">
                  <c:v>78.853894999999994</c:v>
                </c:pt>
                <c:pt idx="29">
                  <c:v>84.006219999999999</c:v>
                </c:pt>
                <c:pt idx="30">
                  <c:v>88.206569999999999</c:v>
                </c:pt>
                <c:pt idx="31">
                  <c:v>85.417635000000004</c:v>
                </c:pt>
                <c:pt idx="32">
                  <c:v>78.617060000000009</c:v>
                </c:pt>
                <c:pt idx="33">
                  <c:v>71.720914999999991</c:v>
                </c:pt>
                <c:pt idx="34">
                  <c:v>66.434899999999999</c:v>
                </c:pt>
                <c:pt idx="35">
                  <c:v>63.79281499999999</c:v>
                </c:pt>
                <c:pt idx="36">
                  <c:v>62.28125</c:v>
                </c:pt>
                <c:pt idx="37">
                  <c:v>63.078899999999997</c:v>
                </c:pt>
                <c:pt idx="38">
                  <c:v>64.672294999999991</c:v>
                </c:pt>
                <c:pt idx="39">
                  <c:v>63.302394999999997</c:v>
                </c:pt>
                <c:pt idx="40">
                  <c:v>60.999685000000007</c:v>
                </c:pt>
                <c:pt idx="41">
                  <c:v>53.251939999999991</c:v>
                </c:pt>
                <c:pt idx="42">
                  <c:v>47.668300000000002</c:v>
                </c:pt>
                <c:pt idx="43">
                  <c:v>46.028779999999998</c:v>
                </c:pt>
                <c:pt idx="44">
                  <c:v>44.260795000000002</c:v>
                </c:pt>
                <c:pt idx="45">
                  <c:v>44.272125000000003</c:v>
                </c:pt>
                <c:pt idx="46">
                  <c:v>44.925060000000002</c:v>
                </c:pt>
                <c:pt idx="47">
                  <c:v>44.696164999999993</c:v>
                </c:pt>
                <c:pt idx="48">
                  <c:v>43.524630000000002</c:v>
                </c:pt>
                <c:pt idx="49">
                  <c:v>42.463279999999997</c:v>
                </c:pt>
                <c:pt idx="50">
                  <c:v>41.863329999999998</c:v>
                </c:pt>
                <c:pt idx="51">
                  <c:v>40.785835000000006</c:v>
                </c:pt>
                <c:pt idx="52">
                  <c:v>41.009500000000003</c:v>
                </c:pt>
                <c:pt idx="53">
                  <c:v>41.42277</c:v>
                </c:pt>
                <c:pt idx="54">
                  <c:v>42.504280000000001</c:v>
                </c:pt>
                <c:pt idx="55">
                  <c:v>43.077210000000001</c:v>
                </c:pt>
                <c:pt idx="56">
                  <c:v>42.640014999999998</c:v>
                </c:pt>
                <c:pt idx="57">
                  <c:v>40.953924999999998</c:v>
                </c:pt>
                <c:pt idx="58">
                  <c:v>39.994689999999999</c:v>
                </c:pt>
                <c:pt idx="59">
                  <c:v>38.975924999999997</c:v>
                </c:pt>
                <c:pt idx="60">
                  <c:v>38.434139999999999</c:v>
                </c:pt>
                <c:pt idx="61">
                  <c:v>38.415754999999997</c:v>
                </c:pt>
                <c:pt idx="62">
                  <c:v>38.8277</c:v>
                </c:pt>
                <c:pt idx="63">
                  <c:v>37.885764999999999</c:v>
                </c:pt>
                <c:pt idx="64">
                  <c:v>36.956020000000002</c:v>
                </c:pt>
                <c:pt idx="65">
                  <c:v>36.0747</c:v>
                </c:pt>
                <c:pt idx="66">
                  <c:v>35.431899999999999</c:v>
                </c:pt>
                <c:pt idx="67">
                  <c:v>33.306379999999997</c:v>
                </c:pt>
                <c:pt idx="68">
                  <c:v>32.072200000000002</c:v>
                </c:pt>
                <c:pt idx="69">
                  <c:v>31.651139999999998</c:v>
                </c:pt>
                <c:pt idx="70">
                  <c:v>32.737650000000002</c:v>
                </c:pt>
                <c:pt idx="71">
                  <c:v>33.68188</c:v>
                </c:pt>
                <c:pt idx="72">
                  <c:v>34.777795000000005</c:v>
                </c:pt>
                <c:pt idx="73">
                  <c:v>34.505539999999996</c:v>
                </c:pt>
                <c:pt idx="74">
                  <c:v>33.057704999999999</c:v>
                </c:pt>
                <c:pt idx="75">
                  <c:v>31.782195000000002</c:v>
                </c:pt>
                <c:pt idx="76">
                  <c:v>30.320660000000004</c:v>
                </c:pt>
                <c:pt idx="77">
                  <c:v>29.779395000000001</c:v>
                </c:pt>
                <c:pt idx="78">
                  <c:v>30.518075</c:v>
                </c:pt>
                <c:pt idx="79">
                  <c:v>31.573339999999998</c:v>
                </c:pt>
                <c:pt idx="80">
                  <c:v>32.264989999999997</c:v>
                </c:pt>
                <c:pt idx="81">
                  <c:v>31.936110000000003</c:v>
                </c:pt>
                <c:pt idx="82">
                  <c:v>30.666964999999998</c:v>
                </c:pt>
                <c:pt idx="83">
                  <c:v>29.095849999999999</c:v>
                </c:pt>
                <c:pt idx="84">
                  <c:v>27.351760000000002</c:v>
                </c:pt>
                <c:pt idx="85">
                  <c:v>26.266995000000001</c:v>
                </c:pt>
                <c:pt idx="86">
                  <c:v>25.949160000000003</c:v>
                </c:pt>
                <c:pt idx="87">
                  <c:v>26.228375</c:v>
                </c:pt>
                <c:pt idx="88">
                  <c:v>26.850739999999998</c:v>
                </c:pt>
                <c:pt idx="89">
                  <c:v>27.382375</c:v>
                </c:pt>
                <c:pt idx="90">
                  <c:v>26.689960000000003</c:v>
                </c:pt>
                <c:pt idx="91">
                  <c:v>24.7578</c:v>
                </c:pt>
                <c:pt idx="92">
                  <c:v>23.614864999999998</c:v>
                </c:pt>
                <c:pt idx="93">
                  <c:v>22.964524999999998</c:v>
                </c:pt>
                <c:pt idx="94">
                  <c:v>22.520325</c:v>
                </c:pt>
                <c:pt idx="95">
                  <c:v>22.085374999999999</c:v>
                </c:pt>
                <c:pt idx="96">
                  <c:v>21.931245000000001</c:v>
                </c:pt>
                <c:pt idx="97">
                  <c:v>21.931720000000002</c:v>
                </c:pt>
                <c:pt idx="98">
                  <c:v>21.588744999999999</c:v>
                </c:pt>
                <c:pt idx="99">
                  <c:v>20.906879999999997</c:v>
                </c:pt>
                <c:pt idx="100">
                  <c:v>20.726479999999999</c:v>
                </c:pt>
                <c:pt idx="101">
                  <c:v>20.80622</c:v>
                </c:pt>
                <c:pt idx="102">
                  <c:v>20.557154999999998</c:v>
                </c:pt>
                <c:pt idx="103">
                  <c:v>20.578360000000004</c:v>
                </c:pt>
                <c:pt idx="104">
                  <c:v>20.299045</c:v>
                </c:pt>
                <c:pt idx="105">
                  <c:v>20.207939999999997</c:v>
                </c:pt>
                <c:pt idx="106">
                  <c:v>20.153114999999996</c:v>
                </c:pt>
                <c:pt idx="107">
                  <c:v>20.047695000000001</c:v>
                </c:pt>
                <c:pt idx="108">
                  <c:v>20.3691</c:v>
                </c:pt>
                <c:pt idx="109">
                  <c:v>20.350339999999996</c:v>
                </c:pt>
                <c:pt idx="110">
                  <c:v>20.239814999999997</c:v>
                </c:pt>
                <c:pt idx="111">
                  <c:v>19.587789999999998</c:v>
                </c:pt>
                <c:pt idx="112">
                  <c:v>19.067395000000001</c:v>
                </c:pt>
                <c:pt idx="113">
                  <c:v>18.067960000000003</c:v>
                </c:pt>
                <c:pt idx="114">
                  <c:v>17.315370000000001</c:v>
                </c:pt>
                <c:pt idx="115">
                  <c:v>13.308339999999996</c:v>
                </c:pt>
                <c:pt idx="116">
                  <c:v>12.279129999999999</c:v>
                </c:pt>
                <c:pt idx="117">
                  <c:v>11.676360000000004</c:v>
                </c:pt>
                <c:pt idx="118">
                  <c:v>10.752320000000001</c:v>
                </c:pt>
                <c:pt idx="119">
                  <c:v>10.347220000000002</c:v>
                </c:pt>
                <c:pt idx="120">
                  <c:v>9.9827049999999993</c:v>
                </c:pt>
                <c:pt idx="121">
                  <c:v>9.5720399999999959</c:v>
                </c:pt>
                <c:pt idx="122">
                  <c:v>9.0075100000000035</c:v>
                </c:pt>
                <c:pt idx="123">
                  <c:v>8.6712049999999987</c:v>
                </c:pt>
                <c:pt idx="124">
                  <c:v>8.3963450000000019</c:v>
                </c:pt>
                <c:pt idx="125">
                  <c:v>8.0317500000000006</c:v>
                </c:pt>
                <c:pt idx="126">
                  <c:v>7.8014200000000011</c:v>
                </c:pt>
                <c:pt idx="127">
                  <c:v>7.6352850000000032</c:v>
                </c:pt>
                <c:pt idx="128">
                  <c:v>7.9055999999999997</c:v>
                </c:pt>
                <c:pt idx="129">
                  <c:v>8.2207049999999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BA1-4CEE-BE54-24FCE4B0E5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559360"/>
        <c:axId val="64569344"/>
      </c:lineChart>
      <c:catAx>
        <c:axId val="64559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56934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56934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5593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BT$17:$BT$146</c:f>
              <c:numCache>
                <c:formatCode>0.00</c:formatCode>
                <c:ptCount val="130"/>
                <c:pt idx="0">
                  <c:v>107.67533999999999</c:v>
                </c:pt>
                <c:pt idx="1">
                  <c:v>93.484960000000015</c:v>
                </c:pt>
                <c:pt idx="2">
                  <c:v>64.663174999999995</c:v>
                </c:pt>
                <c:pt idx="3">
                  <c:v>55.705539999999992</c:v>
                </c:pt>
                <c:pt idx="4">
                  <c:v>49.810985000000002</c:v>
                </c:pt>
                <c:pt idx="5">
                  <c:v>45.1753</c:v>
                </c:pt>
                <c:pt idx="6">
                  <c:v>42.420964999999995</c:v>
                </c:pt>
                <c:pt idx="7">
                  <c:v>41.220925000000001</c:v>
                </c:pt>
                <c:pt idx="8">
                  <c:v>40.209739999999996</c:v>
                </c:pt>
                <c:pt idx="9">
                  <c:v>41.623860000000001</c:v>
                </c:pt>
                <c:pt idx="10">
                  <c:v>46.262289999999993</c:v>
                </c:pt>
                <c:pt idx="11">
                  <c:v>56.081155000000003</c:v>
                </c:pt>
                <c:pt idx="12">
                  <c:v>70.674289999999985</c:v>
                </c:pt>
                <c:pt idx="13">
                  <c:v>92.06960500000001</c:v>
                </c:pt>
                <c:pt idx="14">
                  <c:v>120.54051000000001</c:v>
                </c:pt>
                <c:pt idx="15">
                  <c:v>153.27955500000002</c:v>
                </c:pt>
                <c:pt idx="16">
                  <c:v>179.65386000000001</c:v>
                </c:pt>
                <c:pt idx="17">
                  <c:v>217.34646000000001</c:v>
                </c:pt>
                <c:pt idx="18">
                  <c:v>228.64641</c:v>
                </c:pt>
                <c:pt idx="19">
                  <c:v>230.48156</c:v>
                </c:pt>
                <c:pt idx="20">
                  <c:v>230.69247000000001</c:v>
                </c:pt>
                <c:pt idx="21">
                  <c:v>230.29702999999998</c:v>
                </c:pt>
                <c:pt idx="22">
                  <c:v>222.562985</c:v>
                </c:pt>
                <c:pt idx="23">
                  <c:v>202.589505</c:v>
                </c:pt>
                <c:pt idx="24">
                  <c:v>175.47359499999999</c:v>
                </c:pt>
                <c:pt idx="25">
                  <c:v>146.95405500000001</c:v>
                </c:pt>
                <c:pt idx="26">
                  <c:v>121.26061000000001</c:v>
                </c:pt>
                <c:pt idx="27">
                  <c:v>101.07643</c:v>
                </c:pt>
                <c:pt idx="28">
                  <c:v>87.077794999999995</c:v>
                </c:pt>
                <c:pt idx="29">
                  <c:v>77.089119999999994</c:v>
                </c:pt>
                <c:pt idx="30">
                  <c:v>68.964569999999995</c:v>
                </c:pt>
                <c:pt idx="31">
                  <c:v>62.073935000000006</c:v>
                </c:pt>
                <c:pt idx="32">
                  <c:v>57.008960000000009</c:v>
                </c:pt>
                <c:pt idx="33">
                  <c:v>53.659114999999993</c:v>
                </c:pt>
                <c:pt idx="34">
                  <c:v>50.210500000000003</c:v>
                </c:pt>
                <c:pt idx="35">
                  <c:v>48.743614999999998</c:v>
                </c:pt>
                <c:pt idx="36">
                  <c:v>48.612450000000003</c:v>
                </c:pt>
                <c:pt idx="37">
                  <c:v>50.650399999999998</c:v>
                </c:pt>
                <c:pt idx="38">
                  <c:v>54.247094999999995</c:v>
                </c:pt>
                <c:pt idx="39">
                  <c:v>59.952494999999992</c:v>
                </c:pt>
                <c:pt idx="40">
                  <c:v>67.376085000000003</c:v>
                </c:pt>
                <c:pt idx="41">
                  <c:v>72.069939999999988</c:v>
                </c:pt>
                <c:pt idx="42">
                  <c:v>76.587500000000006</c:v>
                </c:pt>
                <c:pt idx="43">
                  <c:v>83.925280000000001</c:v>
                </c:pt>
                <c:pt idx="44">
                  <c:v>92.055295000000001</c:v>
                </c:pt>
                <c:pt idx="45">
                  <c:v>100.08302500000001</c:v>
                </c:pt>
                <c:pt idx="46">
                  <c:v>106.41656</c:v>
                </c:pt>
                <c:pt idx="47">
                  <c:v>106.36346499999999</c:v>
                </c:pt>
                <c:pt idx="48">
                  <c:v>100.52473000000001</c:v>
                </c:pt>
                <c:pt idx="49">
                  <c:v>93.666980000000009</c:v>
                </c:pt>
                <c:pt idx="50">
                  <c:v>87.275230000000008</c:v>
                </c:pt>
                <c:pt idx="51">
                  <c:v>80.346635000000006</c:v>
                </c:pt>
                <c:pt idx="52">
                  <c:v>73.719700000000003</c:v>
                </c:pt>
                <c:pt idx="53">
                  <c:v>66.26397</c:v>
                </c:pt>
                <c:pt idx="54">
                  <c:v>59.181780000000003</c:v>
                </c:pt>
                <c:pt idx="55">
                  <c:v>52.797610000000006</c:v>
                </c:pt>
                <c:pt idx="56">
                  <c:v>47.170314999999995</c:v>
                </c:pt>
                <c:pt idx="57">
                  <c:v>43.058824999999999</c:v>
                </c:pt>
                <c:pt idx="58">
                  <c:v>41.406689999999998</c:v>
                </c:pt>
                <c:pt idx="59">
                  <c:v>41.345224999999999</c:v>
                </c:pt>
                <c:pt idx="60">
                  <c:v>40.247239999999998</c:v>
                </c:pt>
                <c:pt idx="61">
                  <c:v>39.912554999999998</c:v>
                </c:pt>
                <c:pt idx="62">
                  <c:v>39.288699999999999</c:v>
                </c:pt>
                <c:pt idx="63">
                  <c:v>39.704864999999998</c:v>
                </c:pt>
                <c:pt idx="64">
                  <c:v>40.297420000000002</c:v>
                </c:pt>
                <c:pt idx="65">
                  <c:v>42.423900000000003</c:v>
                </c:pt>
                <c:pt idx="66">
                  <c:v>45.855800000000002</c:v>
                </c:pt>
                <c:pt idx="67">
                  <c:v>49.835979999999999</c:v>
                </c:pt>
                <c:pt idx="68">
                  <c:v>56.335599999999999</c:v>
                </c:pt>
                <c:pt idx="69">
                  <c:v>62.190539999999991</c:v>
                </c:pt>
                <c:pt idx="70">
                  <c:v>65.527950000000004</c:v>
                </c:pt>
                <c:pt idx="71">
                  <c:v>66.008279999999999</c:v>
                </c:pt>
                <c:pt idx="72">
                  <c:v>65.816194999999993</c:v>
                </c:pt>
                <c:pt idx="73">
                  <c:v>64.501039999999989</c:v>
                </c:pt>
                <c:pt idx="74">
                  <c:v>64.560005000000004</c:v>
                </c:pt>
                <c:pt idx="75">
                  <c:v>65.821694999999991</c:v>
                </c:pt>
                <c:pt idx="76">
                  <c:v>63.930960000000006</c:v>
                </c:pt>
                <c:pt idx="77">
                  <c:v>59.293894999999992</c:v>
                </c:pt>
                <c:pt idx="78">
                  <c:v>53.346074999999999</c:v>
                </c:pt>
                <c:pt idx="79">
                  <c:v>47.786539999999995</c:v>
                </c:pt>
                <c:pt idx="80">
                  <c:v>43.810589999999998</c:v>
                </c:pt>
                <c:pt idx="81">
                  <c:v>40.344710000000006</c:v>
                </c:pt>
                <c:pt idx="82">
                  <c:v>39.273464999999995</c:v>
                </c:pt>
                <c:pt idx="83">
                  <c:v>38.624450000000003</c:v>
                </c:pt>
                <c:pt idx="84">
                  <c:v>37.687860000000001</c:v>
                </c:pt>
                <c:pt idx="85">
                  <c:v>36.342995000000002</c:v>
                </c:pt>
                <c:pt idx="86">
                  <c:v>34.824260000000002</c:v>
                </c:pt>
                <c:pt idx="87">
                  <c:v>33.738174999999998</c:v>
                </c:pt>
                <c:pt idx="88">
                  <c:v>33.001239999999996</c:v>
                </c:pt>
                <c:pt idx="89">
                  <c:v>33.189374999999998</c:v>
                </c:pt>
                <c:pt idx="90">
                  <c:v>34.486260000000001</c:v>
                </c:pt>
                <c:pt idx="91">
                  <c:v>36.005899999999997</c:v>
                </c:pt>
                <c:pt idx="92">
                  <c:v>39.681264999999996</c:v>
                </c:pt>
                <c:pt idx="93">
                  <c:v>42.540325000000003</c:v>
                </c:pt>
                <c:pt idx="94">
                  <c:v>45.229824999999998</c:v>
                </c:pt>
                <c:pt idx="95">
                  <c:v>46.133474999999997</c:v>
                </c:pt>
                <c:pt idx="96">
                  <c:v>46.164045000000002</c:v>
                </c:pt>
                <c:pt idx="97">
                  <c:v>45.667920000000002</c:v>
                </c:pt>
                <c:pt idx="98">
                  <c:v>45.012844999999999</c:v>
                </c:pt>
                <c:pt idx="99">
                  <c:v>45.219180000000001</c:v>
                </c:pt>
                <c:pt idx="100">
                  <c:v>45.199579999999997</c:v>
                </c:pt>
                <c:pt idx="101">
                  <c:v>43.916519999999998</c:v>
                </c:pt>
                <c:pt idx="102">
                  <c:v>42.055554999999998</c:v>
                </c:pt>
                <c:pt idx="103">
                  <c:v>39.942160000000001</c:v>
                </c:pt>
                <c:pt idx="104">
                  <c:v>37.811145000000003</c:v>
                </c:pt>
                <c:pt idx="105">
                  <c:v>36.158839999999998</c:v>
                </c:pt>
                <c:pt idx="106">
                  <c:v>34.830414999999995</c:v>
                </c:pt>
                <c:pt idx="107">
                  <c:v>34.173095000000004</c:v>
                </c:pt>
                <c:pt idx="108">
                  <c:v>33.786799999999999</c:v>
                </c:pt>
                <c:pt idx="109">
                  <c:v>34.311339999999994</c:v>
                </c:pt>
                <c:pt idx="110">
                  <c:v>35.071414999999995</c:v>
                </c:pt>
                <c:pt idx="111">
                  <c:v>35.386189999999999</c:v>
                </c:pt>
                <c:pt idx="112">
                  <c:v>34.860195000000004</c:v>
                </c:pt>
                <c:pt idx="113">
                  <c:v>33.39526</c:v>
                </c:pt>
                <c:pt idx="114">
                  <c:v>32.375170000000004</c:v>
                </c:pt>
                <c:pt idx="115">
                  <c:v>27.036139999999996</c:v>
                </c:pt>
                <c:pt idx="116">
                  <c:v>26.750029999999999</c:v>
                </c:pt>
                <c:pt idx="117">
                  <c:v>26.924960000000002</c:v>
                </c:pt>
                <c:pt idx="118">
                  <c:v>27.072520000000001</c:v>
                </c:pt>
                <c:pt idx="119">
                  <c:v>27.180120000000002</c:v>
                </c:pt>
                <c:pt idx="120">
                  <c:v>27.241505</c:v>
                </c:pt>
                <c:pt idx="121">
                  <c:v>26.883839999999996</c:v>
                </c:pt>
                <c:pt idx="122">
                  <c:v>26.391110000000005</c:v>
                </c:pt>
                <c:pt idx="123">
                  <c:v>25.845105</c:v>
                </c:pt>
                <c:pt idx="124">
                  <c:v>25.582945000000002</c:v>
                </c:pt>
                <c:pt idx="125">
                  <c:v>25.071950000000001</c:v>
                </c:pt>
                <c:pt idx="126">
                  <c:v>24.44022</c:v>
                </c:pt>
                <c:pt idx="127">
                  <c:v>23.457485000000002</c:v>
                </c:pt>
                <c:pt idx="128">
                  <c:v>22.363099999999999</c:v>
                </c:pt>
                <c:pt idx="129">
                  <c:v>20.9813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8AD-4554-945C-5B3DEF88A576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BU$17:$BU$146</c:f>
              <c:numCache>
                <c:formatCode>0.00</c:formatCode>
                <c:ptCount val="130"/>
                <c:pt idx="0">
                  <c:v>111.40693999999999</c:v>
                </c:pt>
                <c:pt idx="1">
                  <c:v>98.423760000000016</c:v>
                </c:pt>
                <c:pt idx="2">
                  <c:v>74.492374999999996</c:v>
                </c:pt>
                <c:pt idx="3">
                  <c:v>66.318539999999985</c:v>
                </c:pt>
                <c:pt idx="4">
                  <c:v>59.17958500000001</c:v>
                </c:pt>
                <c:pt idx="5">
                  <c:v>52.600099999999998</c:v>
                </c:pt>
                <c:pt idx="6">
                  <c:v>47.448264999999999</c:v>
                </c:pt>
                <c:pt idx="7">
                  <c:v>44.093924999999999</c:v>
                </c:pt>
                <c:pt idx="8">
                  <c:v>44.049639999999997</c:v>
                </c:pt>
                <c:pt idx="9">
                  <c:v>46.137660000000004</c:v>
                </c:pt>
                <c:pt idx="10">
                  <c:v>51.493389999999998</c:v>
                </c:pt>
                <c:pt idx="11">
                  <c:v>62.434555000000003</c:v>
                </c:pt>
                <c:pt idx="12">
                  <c:v>79.367489999999989</c:v>
                </c:pt>
                <c:pt idx="13">
                  <c:v>99.766805000000005</c:v>
                </c:pt>
                <c:pt idx="14">
                  <c:v>126.27291000000001</c:v>
                </c:pt>
                <c:pt idx="15">
                  <c:v>156.16475500000001</c:v>
                </c:pt>
                <c:pt idx="16">
                  <c:v>183.16806</c:v>
                </c:pt>
                <c:pt idx="17">
                  <c:v>214.89066</c:v>
                </c:pt>
                <c:pt idx="18">
                  <c:v>224.47931</c:v>
                </c:pt>
                <c:pt idx="19">
                  <c:v>232.68886000000001</c:v>
                </c:pt>
                <c:pt idx="20">
                  <c:v>231.37027</c:v>
                </c:pt>
                <c:pt idx="21">
                  <c:v>231.54662999999999</c:v>
                </c:pt>
                <c:pt idx="22">
                  <c:v>226.97858500000001</c:v>
                </c:pt>
                <c:pt idx="23">
                  <c:v>211.65100499999997</c:v>
                </c:pt>
                <c:pt idx="24">
                  <c:v>186.35809499999999</c:v>
                </c:pt>
                <c:pt idx="25">
                  <c:v>156.26345499999999</c:v>
                </c:pt>
                <c:pt idx="26">
                  <c:v>128.03161</c:v>
                </c:pt>
                <c:pt idx="27">
                  <c:v>105.27383</c:v>
                </c:pt>
                <c:pt idx="28">
                  <c:v>89.162394999999989</c:v>
                </c:pt>
                <c:pt idx="29">
                  <c:v>77.413420000000002</c:v>
                </c:pt>
                <c:pt idx="30">
                  <c:v>69.701769999999996</c:v>
                </c:pt>
                <c:pt idx="31">
                  <c:v>63.636535000000009</c:v>
                </c:pt>
                <c:pt idx="32">
                  <c:v>58.36216000000001</c:v>
                </c:pt>
                <c:pt idx="33">
                  <c:v>55.277114999999988</c:v>
                </c:pt>
                <c:pt idx="34">
                  <c:v>53.405200000000001</c:v>
                </c:pt>
                <c:pt idx="35">
                  <c:v>52.705514999999991</c:v>
                </c:pt>
                <c:pt idx="36">
                  <c:v>52.317749999999997</c:v>
                </c:pt>
                <c:pt idx="37">
                  <c:v>52.956000000000003</c:v>
                </c:pt>
                <c:pt idx="38">
                  <c:v>56.775994999999995</c:v>
                </c:pt>
                <c:pt idx="39">
                  <c:v>63.047794999999994</c:v>
                </c:pt>
                <c:pt idx="40">
                  <c:v>72.198785000000015</c:v>
                </c:pt>
                <c:pt idx="41">
                  <c:v>77.570539999999994</c:v>
                </c:pt>
                <c:pt idx="42">
                  <c:v>82.770300000000006</c:v>
                </c:pt>
                <c:pt idx="43">
                  <c:v>89.832080000000005</c:v>
                </c:pt>
                <c:pt idx="44">
                  <c:v>96.911094999999989</c:v>
                </c:pt>
                <c:pt idx="45">
                  <c:v>103.83472500000001</c:v>
                </c:pt>
                <c:pt idx="46">
                  <c:v>109.23446000000001</c:v>
                </c:pt>
                <c:pt idx="47">
                  <c:v>110.764765</c:v>
                </c:pt>
                <c:pt idx="48">
                  <c:v>107.58793</c:v>
                </c:pt>
                <c:pt idx="49">
                  <c:v>101.44558000000001</c:v>
                </c:pt>
                <c:pt idx="50">
                  <c:v>93.261830000000003</c:v>
                </c:pt>
                <c:pt idx="51">
                  <c:v>84.512235000000004</c:v>
                </c:pt>
                <c:pt idx="52">
                  <c:v>76.771699999999996</c:v>
                </c:pt>
                <c:pt idx="53">
                  <c:v>69.563769999999991</c:v>
                </c:pt>
                <c:pt idx="54">
                  <c:v>64.17728000000001</c:v>
                </c:pt>
                <c:pt idx="55">
                  <c:v>58.452210000000008</c:v>
                </c:pt>
                <c:pt idx="56">
                  <c:v>53.188614999999992</c:v>
                </c:pt>
                <c:pt idx="57">
                  <c:v>48.490625000000001</c:v>
                </c:pt>
                <c:pt idx="58">
                  <c:v>45.252789999999997</c:v>
                </c:pt>
                <c:pt idx="59">
                  <c:v>42.294525</c:v>
                </c:pt>
                <c:pt idx="60">
                  <c:v>40.338939999999994</c:v>
                </c:pt>
                <c:pt idx="61">
                  <c:v>40.009754999999998</c:v>
                </c:pt>
                <c:pt idx="62">
                  <c:v>40.127899999999997</c:v>
                </c:pt>
                <c:pt idx="63">
                  <c:v>41.279164999999999</c:v>
                </c:pt>
                <c:pt idx="64">
                  <c:v>42.423720000000003</c:v>
                </c:pt>
                <c:pt idx="65">
                  <c:v>44.183399999999999</c:v>
                </c:pt>
                <c:pt idx="66">
                  <c:v>46.594900000000003</c:v>
                </c:pt>
                <c:pt idx="67">
                  <c:v>48.116880000000002</c:v>
                </c:pt>
                <c:pt idx="68">
                  <c:v>50.885599999999997</c:v>
                </c:pt>
                <c:pt idx="69">
                  <c:v>56.55843999999999</c:v>
                </c:pt>
                <c:pt idx="70">
                  <c:v>63.318049999999999</c:v>
                </c:pt>
                <c:pt idx="71">
                  <c:v>71.935380000000009</c:v>
                </c:pt>
                <c:pt idx="72">
                  <c:v>75.882494999999992</c:v>
                </c:pt>
                <c:pt idx="73">
                  <c:v>75.22923999999999</c:v>
                </c:pt>
                <c:pt idx="74">
                  <c:v>71.304704999999998</c:v>
                </c:pt>
                <c:pt idx="75">
                  <c:v>66.39099499999999</c:v>
                </c:pt>
                <c:pt idx="76">
                  <c:v>63.377460000000006</c:v>
                </c:pt>
                <c:pt idx="77">
                  <c:v>60.544194999999995</c:v>
                </c:pt>
                <c:pt idx="78">
                  <c:v>58.036175</c:v>
                </c:pt>
                <c:pt idx="79">
                  <c:v>55.313239999999993</c:v>
                </c:pt>
                <c:pt idx="80">
                  <c:v>51.527889999999999</c:v>
                </c:pt>
                <c:pt idx="81">
                  <c:v>47.046510000000005</c:v>
                </c:pt>
                <c:pt idx="82">
                  <c:v>43.295864999999999</c:v>
                </c:pt>
                <c:pt idx="83">
                  <c:v>40.105350000000001</c:v>
                </c:pt>
                <c:pt idx="84">
                  <c:v>38.406660000000002</c:v>
                </c:pt>
                <c:pt idx="85">
                  <c:v>37.546295000000001</c:v>
                </c:pt>
                <c:pt idx="86">
                  <c:v>37.636460000000007</c:v>
                </c:pt>
                <c:pt idx="87">
                  <c:v>37.828874999999996</c:v>
                </c:pt>
                <c:pt idx="88">
                  <c:v>37.681939999999997</c:v>
                </c:pt>
                <c:pt idx="89">
                  <c:v>37.545675000000003</c:v>
                </c:pt>
                <c:pt idx="90">
                  <c:v>37.952960000000004</c:v>
                </c:pt>
                <c:pt idx="91">
                  <c:v>38.020600000000002</c:v>
                </c:pt>
                <c:pt idx="92">
                  <c:v>40.059564999999999</c:v>
                </c:pt>
                <c:pt idx="93">
                  <c:v>42.497624999999999</c:v>
                </c:pt>
                <c:pt idx="94">
                  <c:v>45.091724999999997</c:v>
                </c:pt>
                <c:pt idx="95">
                  <c:v>46.849575000000002</c:v>
                </c:pt>
                <c:pt idx="96">
                  <c:v>47.517645000000002</c:v>
                </c:pt>
                <c:pt idx="97">
                  <c:v>47.873620000000003</c:v>
                </c:pt>
                <c:pt idx="98">
                  <c:v>48.600445000000001</c:v>
                </c:pt>
                <c:pt idx="99">
                  <c:v>49.46508</c:v>
                </c:pt>
                <c:pt idx="100">
                  <c:v>49.901679999999999</c:v>
                </c:pt>
                <c:pt idx="101">
                  <c:v>49.288020000000003</c:v>
                </c:pt>
                <c:pt idx="102">
                  <c:v>47.076155</c:v>
                </c:pt>
                <c:pt idx="103">
                  <c:v>43.725660000000005</c:v>
                </c:pt>
                <c:pt idx="104">
                  <c:v>40.446845000000003</c:v>
                </c:pt>
                <c:pt idx="105">
                  <c:v>37.377839999999999</c:v>
                </c:pt>
                <c:pt idx="106">
                  <c:v>35.967014999999996</c:v>
                </c:pt>
                <c:pt idx="107">
                  <c:v>35.738595000000004</c:v>
                </c:pt>
                <c:pt idx="108">
                  <c:v>35.674599999999998</c:v>
                </c:pt>
                <c:pt idx="109">
                  <c:v>35.401739999999997</c:v>
                </c:pt>
                <c:pt idx="110">
                  <c:v>34.310114999999996</c:v>
                </c:pt>
                <c:pt idx="111">
                  <c:v>33.748289999999997</c:v>
                </c:pt>
                <c:pt idx="112">
                  <c:v>32.691295000000004</c:v>
                </c:pt>
                <c:pt idx="113">
                  <c:v>32.076060000000005</c:v>
                </c:pt>
                <c:pt idx="114">
                  <c:v>32.617670000000004</c:v>
                </c:pt>
                <c:pt idx="115">
                  <c:v>28.960639999999998</c:v>
                </c:pt>
                <c:pt idx="116">
                  <c:v>30.75243</c:v>
                </c:pt>
                <c:pt idx="117">
                  <c:v>31.999460000000003</c:v>
                </c:pt>
                <c:pt idx="118">
                  <c:v>32.072520000000004</c:v>
                </c:pt>
                <c:pt idx="119">
                  <c:v>32.196220000000004</c:v>
                </c:pt>
                <c:pt idx="120">
                  <c:v>32.533704999999998</c:v>
                </c:pt>
                <c:pt idx="121">
                  <c:v>32.574539999999999</c:v>
                </c:pt>
                <c:pt idx="122">
                  <c:v>32.781710000000004</c:v>
                </c:pt>
                <c:pt idx="123">
                  <c:v>34.295405000000002</c:v>
                </c:pt>
                <c:pt idx="124">
                  <c:v>35.286445000000001</c:v>
                </c:pt>
                <c:pt idx="125">
                  <c:v>35.225450000000002</c:v>
                </c:pt>
                <c:pt idx="126">
                  <c:v>33.776020000000003</c:v>
                </c:pt>
                <c:pt idx="127">
                  <c:v>31.155785000000005</c:v>
                </c:pt>
                <c:pt idx="128">
                  <c:v>28.3995</c:v>
                </c:pt>
                <c:pt idx="129">
                  <c:v>25.72510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8AD-4554-945C-5B3DEF88A576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BV$17:$BV$146</c:f>
              <c:numCache>
                <c:formatCode>0.00</c:formatCode>
                <c:ptCount val="130"/>
                <c:pt idx="0">
                  <c:v>117.78943999999998</c:v>
                </c:pt>
                <c:pt idx="1">
                  <c:v>105.54306000000001</c:v>
                </c:pt>
                <c:pt idx="2">
                  <c:v>78.702174999999997</c:v>
                </c:pt>
                <c:pt idx="3">
                  <c:v>70.143939999999986</c:v>
                </c:pt>
                <c:pt idx="4">
                  <c:v>60.974685000000008</c:v>
                </c:pt>
                <c:pt idx="5">
                  <c:v>52.644500000000001</c:v>
                </c:pt>
                <c:pt idx="6">
                  <c:v>47.660464999999995</c:v>
                </c:pt>
                <c:pt idx="7">
                  <c:v>45.521925000000003</c:v>
                </c:pt>
                <c:pt idx="8">
                  <c:v>45.69914</c:v>
                </c:pt>
                <c:pt idx="9">
                  <c:v>50.172360000000005</c:v>
                </c:pt>
                <c:pt idx="10">
                  <c:v>59.200189999999992</c:v>
                </c:pt>
                <c:pt idx="11">
                  <c:v>74.874555000000001</c:v>
                </c:pt>
                <c:pt idx="12">
                  <c:v>91.632289999999998</c:v>
                </c:pt>
                <c:pt idx="13">
                  <c:v>115.196005</c:v>
                </c:pt>
                <c:pt idx="14">
                  <c:v>139.21431000000001</c:v>
                </c:pt>
                <c:pt idx="15">
                  <c:v>166.53305500000002</c:v>
                </c:pt>
                <c:pt idx="16">
                  <c:v>196.43786</c:v>
                </c:pt>
                <c:pt idx="17">
                  <c:v>240.74036000000001</c:v>
                </c:pt>
                <c:pt idx="18">
                  <c:v>255.32161000000002</c:v>
                </c:pt>
                <c:pt idx="19">
                  <c:v>255.83056000000002</c:v>
                </c:pt>
                <c:pt idx="20">
                  <c:v>249.85587000000001</c:v>
                </c:pt>
                <c:pt idx="21">
                  <c:v>240.32682999999997</c:v>
                </c:pt>
                <c:pt idx="22">
                  <c:v>225.84598500000001</c:v>
                </c:pt>
                <c:pt idx="23">
                  <c:v>204.38070500000001</c:v>
                </c:pt>
                <c:pt idx="24">
                  <c:v>177.67899499999999</c:v>
                </c:pt>
                <c:pt idx="25">
                  <c:v>150.105355</c:v>
                </c:pt>
                <c:pt idx="26">
                  <c:v>125.00751000000001</c:v>
                </c:pt>
                <c:pt idx="27">
                  <c:v>104.86923</c:v>
                </c:pt>
                <c:pt idx="28">
                  <c:v>89.368894999999995</c:v>
                </c:pt>
                <c:pt idx="29">
                  <c:v>78.238320000000002</c:v>
                </c:pt>
                <c:pt idx="30">
                  <c:v>70.230769999999993</c:v>
                </c:pt>
                <c:pt idx="31">
                  <c:v>63.582235000000011</c:v>
                </c:pt>
                <c:pt idx="32">
                  <c:v>59.056360000000012</c:v>
                </c:pt>
                <c:pt idx="33">
                  <c:v>56.211514999999991</c:v>
                </c:pt>
                <c:pt idx="34">
                  <c:v>54.040399999999998</c:v>
                </c:pt>
                <c:pt idx="35">
                  <c:v>53.169414999999994</c:v>
                </c:pt>
                <c:pt idx="36">
                  <c:v>54.295650000000002</c:v>
                </c:pt>
                <c:pt idx="37">
                  <c:v>57.527099999999997</c:v>
                </c:pt>
                <c:pt idx="38">
                  <c:v>62.700594999999993</c:v>
                </c:pt>
                <c:pt idx="39">
                  <c:v>70.054594999999992</c:v>
                </c:pt>
                <c:pt idx="40">
                  <c:v>79.303885000000008</c:v>
                </c:pt>
                <c:pt idx="41">
                  <c:v>82.405239999999992</c:v>
                </c:pt>
                <c:pt idx="42">
                  <c:v>84.5852</c:v>
                </c:pt>
                <c:pt idx="43">
                  <c:v>90.391180000000006</c:v>
                </c:pt>
                <c:pt idx="44">
                  <c:v>97.635694999999998</c:v>
                </c:pt>
                <c:pt idx="45">
                  <c:v>106.815425</c:v>
                </c:pt>
                <c:pt idx="46">
                  <c:v>113.47786000000001</c:v>
                </c:pt>
                <c:pt idx="47">
                  <c:v>111.52476499999999</c:v>
                </c:pt>
                <c:pt idx="48">
                  <c:v>104.09223</c:v>
                </c:pt>
                <c:pt idx="49">
                  <c:v>96.437080000000009</c:v>
                </c:pt>
                <c:pt idx="50">
                  <c:v>88.496930000000006</c:v>
                </c:pt>
                <c:pt idx="51">
                  <c:v>79.332735000000014</c:v>
                </c:pt>
                <c:pt idx="52">
                  <c:v>72.077600000000004</c:v>
                </c:pt>
                <c:pt idx="53">
                  <c:v>65.302269999999993</c:v>
                </c:pt>
                <c:pt idx="54">
                  <c:v>59.088680000000004</c:v>
                </c:pt>
                <c:pt idx="55">
                  <c:v>52.931410000000007</c:v>
                </c:pt>
                <c:pt idx="56">
                  <c:v>47.027114999999995</c:v>
                </c:pt>
                <c:pt idx="57">
                  <c:v>42.835825</c:v>
                </c:pt>
                <c:pt idx="58">
                  <c:v>39.859089999999995</c:v>
                </c:pt>
                <c:pt idx="59">
                  <c:v>37.779825000000002</c:v>
                </c:pt>
                <c:pt idx="60">
                  <c:v>37.123639999999995</c:v>
                </c:pt>
                <c:pt idx="61">
                  <c:v>37.423755</c:v>
                </c:pt>
                <c:pt idx="62">
                  <c:v>38.871899999999997</c:v>
                </c:pt>
                <c:pt idx="63">
                  <c:v>41.318864999999995</c:v>
                </c:pt>
                <c:pt idx="64">
                  <c:v>43.416420000000002</c:v>
                </c:pt>
                <c:pt idx="65">
                  <c:v>46.459499999999998</c:v>
                </c:pt>
                <c:pt idx="66">
                  <c:v>50.310899999999997</c:v>
                </c:pt>
                <c:pt idx="67">
                  <c:v>53.572880000000005</c:v>
                </c:pt>
                <c:pt idx="68">
                  <c:v>58.537300000000002</c:v>
                </c:pt>
                <c:pt idx="69">
                  <c:v>64.295639999999992</c:v>
                </c:pt>
                <c:pt idx="70">
                  <c:v>69.861750000000001</c:v>
                </c:pt>
                <c:pt idx="71">
                  <c:v>74.697180000000003</c:v>
                </c:pt>
                <c:pt idx="72">
                  <c:v>76.288595000000001</c:v>
                </c:pt>
                <c:pt idx="73">
                  <c:v>74.882339999999985</c:v>
                </c:pt>
                <c:pt idx="74">
                  <c:v>72.426905000000005</c:v>
                </c:pt>
                <c:pt idx="75">
                  <c:v>69.520595</c:v>
                </c:pt>
                <c:pt idx="76">
                  <c:v>65.144160000000014</c:v>
                </c:pt>
                <c:pt idx="77">
                  <c:v>61.244894999999993</c:v>
                </c:pt>
                <c:pt idx="78">
                  <c:v>57.471274999999999</c:v>
                </c:pt>
                <c:pt idx="79">
                  <c:v>54.033739999999987</c:v>
                </c:pt>
                <c:pt idx="80">
                  <c:v>50.554789999999997</c:v>
                </c:pt>
                <c:pt idx="81">
                  <c:v>47.481710000000007</c:v>
                </c:pt>
                <c:pt idx="82">
                  <c:v>44.541564999999999</c:v>
                </c:pt>
                <c:pt idx="83">
                  <c:v>42.30715</c:v>
                </c:pt>
                <c:pt idx="84">
                  <c:v>40.617360000000005</c:v>
                </c:pt>
                <c:pt idx="85">
                  <c:v>39.885195000000003</c:v>
                </c:pt>
                <c:pt idx="86">
                  <c:v>39.343660000000007</c:v>
                </c:pt>
                <c:pt idx="87">
                  <c:v>40.056975000000001</c:v>
                </c:pt>
                <c:pt idx="88">
                  <c:v>40.913039999999995</c:v>
                </c:pt>
                <c:pt idx="89">
                  <c:v>43.125275000000002</c:v>
                </c:pt>
                <c:pt idx="90">
                  <c:v>45.443060000000003</c:v>
                </c:pt>
                <c:pt idx="91">
                  <c:v>46.038699999999999</c:v>
                </c:pt>
                <c:pt idx="92">
                  <c:v>47.643764999999995</c:v>
                </c:pt>
                <c:pt idx="93">
                  <c:v>49.347124999999998</c:v>
                </c:pt>
                <c:pt idx="94">
                  <c:v>51.028224999999999</c:v>
                </c:pt>
                <c:pt idx="95">
                  <c:v>52.200074999999998</c:v>
                </c:pt>
                <c:pt idx="96">
                  <c:v>53.747444999999992</c:v>
                </c:pt>
                <c:pt idx="97">
                  <c:v>55.421619999999997</c:v>
                </c:pt>
                <c:pt idx="98">
                  <c:v>56.677344999999995</c:v>
                </c:pt>
                <c:pt idx="99">
                  <c:v>56.765780000000007</c:v>
                </c:pt>
                <c:pt idx="100">
                  <c:v>55.519280000000002</c:v>
                </c:pt>
                <c:pt idx="101">
                  <c:v>53.108019999999996</c:v>
                </c:pt>
                <c:pt idx="102">
                  <c:v>49.994354999999999</c:v>
                </c:pt>
                <c:pt idx="103">
                  <c:v>46.887960000000007</c:v>
                </c:pt>
                <c:pt idx="104">
                  <c:v>43.936644999999999</c:v>
                </c:pt>
                <c:pt idx="105">
                  <c:v>41.854939999999999</c:v>
                </c:pt>
                <c:pt idx="106">
                  <c:v>40.026814999999999</c:v>
                </c:pt>
                <c:pt idx="107">
                  <c:v>39.460095000000003</c:v>
                </c:pt>
                <c:pt idx="108">
                  <c:v>38.591299999999997</c:v>
                </c:pt>
                <c:pt idx="109">
                  <c:v>37.192039999999999</c:v>
                </c:pt>
                <c:pt idx="110">
                  <c:v>36.180214999999997</c:v>
                </c:pt>
                <c:pt idx="111">
                  <c:v>34.949789999999993</c:v>
                </c:pt>
                <c:pt idx="112">
                  <c:v>33.725394999999999</c:v>
                </c:pt>
                <c:pt idx="113">
                  <c:v>32.262660000000004</c:v>
                </c:pt>
                <c:pt idx="114">
                  <c:v>30.96407</c:v>
                </c:pt>
                <c:pt idx="115">
                  <c:v>25.315439999999995</c:v>
                </c:pt>
                <c:pt idx="116">
                  <c:v>25.24803</c:v>
                </c:pt>
                <c:pt idx="117">
                  <c:v>25.841860000000004</c:v>
                </c:pt>
                <c:pt idx="118">
                  <c:v>26.16882</c:v>
                </c:pt>
                <c:pt idx="119">
                  <c:v>26.228820000000002</c:v>
                </c:pt>
                <c:pt idx="120">
                  <c:v>26.433904999999999</c:v>
                </c:pt>
                <c:pt idx="121">
                  <c:v>25.897439999999996</c:v>
                </c:pt>
                <c:pt idx="122">
                  <c:v>24.874710000000004</c:v>
                </c:pt>
                <c:pt idx="123">
                  <c:v>24.903704999999999</c:v>
                </c:pt>
                <c:pt idx="124">
                  <c:v>25.355445</c:v>
                </c:pt>
                <c:pt idx="125">
                  <c:v>25.797450000000001</c:v>
                </c:pt>
                <c:pt idx="126">
                  <c:v>25.68102</c:v>
                </c:pt>
                <c:pt idx="127">
                  <c:v>24.609685000000002</c:v>
                </c:pt>
                <c:pt idx="128">
                  <c:v>23.5076</c:v>
                </c:pt>
                <c:pt idx="129">
                  <c:v>21.9246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8AD-4554-945C-5B3DEF88A5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594688"/>
        <c:axId val="64596224"/>
      </c:lineChart>
      <c:catAx>
        <c:axId val="6459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4596224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64596224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645946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none"/>
          </c:marker>
          <c:val>
            <c:numRef>
              <c:f>PlotData!$CC$17:$CC$146</c:f>
              <c:numCache>
                <c:formatCode>0.00</c:formatCode>
                <c:ptCount val="130"/>
                <c:pt idx="0">
                  <c:v>27.992759999999997</c:v>
                </c:pt>
                <c:pt idx="1">
                  <c:v>28.196259999999999</c:v>
                </c:pt>
                <c:pt idx="2">
                  <c:v>26.46002</c:v>
                </c:pt>
                <c:pt idx="3">
                  <c:v>25.091840000000001</c:v>
                </c:pt>
                <c:pt idx="4">
                  <c:v>23.367520000000003</c:v>
                </c:pt>
                <c:pt idx="5">
                  <c:v>21.33548</c:v>
                </c:pt>
                <c:pt idx="6">
                  <c:v>19.551880000000001</c:v>
                </c:pt>
                <c:pt idx="7">
                  <c:v>18.692359999999997</c:v>
                </c:pt>
                <c:pt idx="8">
                  <c:v>18.769640000000003</c:v>
                </c:pt>
                <c:pt idx="9">
                  <c:v>17.89622</c:v>
                </c:pt>
                <c:pt idx="10">
                  <c:v>16.982120000000002</c:v>
                </c:pt>
                <c:pt idx="11">
                  <c:v>16.846900000000002</c:v>
                </c:pt>
                <c:pt idx="12">
                  <c:v>17.43732</c:v>
                </c:pt>
                <c:pt idx="13">
                  <c:v>19.289479999999998</c:v>
                </c:pt>
                <c:pt idx="14">
                  <c:v>22.991559999999996</c:v>
                </c:pt>
                <c:pt idx="15">
                  <c:v>29.232259999999997</c:v>
                </c:pt>
                <c:pt idx="16">
                  <c:v>38.354979999999998</c:v>
                </c:pt>
                <c:pt idx="17">
                  <c:v>50.204540000000001</c:v>
                </c:pt>
                <c:pt idx="18">
                  <c:v>68.91058000000001</c:v>
                </c:pt>
                <c:pt idx="19">
                  <c:v>90.658860000000004</c:v>
                </c:pt>
                <c:pt idx="20">
                  <c:v>109.92641999999999</c:v>
                </c:pt>
                <c:pt idx="21">
                  <c:v>129.80094</c:v>
                </c:pt>
                <c:pt idx="22">
                  <c:v>142.80413999999999</c:v>
                </c:pt>
                <c:pt idx="23">
                  <c:v>145.93976000000001</c:v>
                </c:pt>
                <c:pt idx="24">
                  <c:v>144.32329999999999</c:v>
                </c:pt>
                <c:pt idx="25">
                  <c:v>136.72221999999999</c:v>
                </c:pt>
                <c:pt idx="26">
                  <c:v>125.38332</c:v>
                </c:pt>
                <c:pt idx="27">
                  <c:v>112.56026000000001</c:v>
                </c:pt>
                <c:pt idx="28">
                  <c:v>100.15342</c:v>
                </c:pt>
                <c:pt idx="29">
                  <c:v>90.60566</c:v>
                </c:pt>
                <c:pt idx="30">
                  <c:v>82.033559999999994</c:v>
                </c:pt>
                <c:pt idx="31">
                  <c:v>73.133160000000004</c:v>
                </c:pt>
                <c:pt idx="32">
                  <c:v>63.9831</c:v>
                </c:pt>
                <c:pt idx="33">
                  <c:v>56.361619999999995</c:v>
                </c:pt>
                <c:pt idx="34">
                  <c:v>48.258000000000003</c:v>
                </c:pt>
                <c:pt idx="35">
                  <c:v>41.1693</c:v>
                </c:pt>
                <c:pt idx="36">
                  <c:v>35.335540000000002</c:v>
                </c:pt>
                <c:pt idx="37">
                  <c:v>30.274179999999998</c:v>
                </c:pt>
                <c:pt idx="38">
                  <c:v>26.828659999999999</c:v>
                </c:pt>
                <c:pt idx="39">
                  <c:v>25.164340000000003</c:v>
                </c:pt>
                <c:pt idx="40">
                  <c:v>25.278859999999998</c:v>
                </c:pt>
                <c:pt idx="41">
                  <c:v>25.834659999999996</c:v>
                </c:pt>
                <c:pt idx="42">
                  <c:v>27.913019999999999</c:v>
                </c:pt>
                <c:pt idx="43">
                  <c:v>31.810559999999999</c:v>
                </c:pt>
                <c:pt idx="44">
                  <c:v>36.490819999999999</c:v>
                </c:pt>
                <c:pt idx="45">
                  <c:v>42.267040000000001</c:v>
                </c:pt>
                <c:pt idx="46">
                  <c:v>49.125140000000002</c:v>
                </c:pt>
                <c:pt idx="47">
                  <c:v>53.527340000000002</c:v>
                </c:pt>
                <c:pt idx="48">
                  <c:v>56.330419999999997</c:v>
                </c:pt>
                <c:pt idx="49">
                  <c:v>57.111899999999999</c:v>
                </c:pt>
                <c:pt idx="50">
                  <c:v>56.140340000000002</c:v>
                </c:pt>
                <c:pt idx="51">
                  <c:v>54.588500000000003</c:v>
                </c:pt>
                <c:pt idx="52">
                  <c:v>52.727600000000002</c:v>
                </c:pt>
                <c:pt idx="53">
                  <c:v>49.422540000000005</c:v>
                </c:pt>
                <c:pt idx="54">
                  <c:v>46.50658</c:v>
                </c:pt>
                <c:pt idx="55">
                  <c:v>42.931979999999996</c:v>
                </c:pt>
                <c:pt idx="56">
                  <c:v>38.953759999999996</c:v>
                </c:pt>
                <c:pt idx="57">
                  <c:v>35.204140000000002</c:v>
                </c:pt>
                <c:pt idx="58">
                  <c:v>32.199599999999997</c:v>
                </c:pt>
                <c:pt idx="59">
                  <c:v>29.509459999999997</c:v>
                </c:pt>
                <c:pt idx="60">
                  <c:v>27.408899999999999</c:v>
                </c:pt>
                <c:pt idx="61">
                  <c:v>25.199459999999998</c:v>
                </c:pt>
                <c:pt idx="62">
                  <c:v>23.42192</c:v>
                </c:pt>
                <c:pt idx="63">
                  <c:v>22.22268</c:v>
                </c:pt>
                <c:pt idx="64">
                  <c:v>20.982140000000001</c:v>
                </c:pt>
                <c:pt idx="65">
                  <c:v>20.527920000000002</c:v>
                </c:pt>
                <c:pt idx="66">
                  <c:v>20.148359999999997</c:v>
                </c:pt>
                <c:pt idx="67">
                  <c:v>19.872420000000002</c:v>
                </c:pt>
                <c:pt idx="68">
                  <c:v>20.064399999999999</c:v>
                </c:pt>
                <c:pt idx="69">
                  <c:v>20.91198</c:v>
                </c:pt>
                <c:pt idx="70">
                  <c:v>21.656279999999999</c:v>
                </c:pt>
                <c:pt idx="71">
                  <c:v>22.780940000000001</c:v>
                </c:pt>
                <c:pt idx="72">
                  <c:v>24.133479999999999</c:v>
                </c:pt>
                <c:pt idx="73">
                  <c:v>25.534020000000002</c:v>
                </c:pt>
                <c:pt idx="74">
                  <c:v>27.629720000000002</c:v>
                </c:pt>
                <c:pt idx="75">
                  <c:v>27.764479999999999</c:v>
                </c:pt>
                <c:pt idx="76">
                  <c:v>28.215359999999997</c:v>
                </c:pt>
                <c:pt idx="77">
                  <c:v>28.340679999999999</c:v>
                </c:pt>
                <c:pt idx="78">
                  <c:v>27.667959999999997</c:v>
                </c:pt>
                <c:pt idx="79">
                  <c:v>26.621600000000001</c:v>
                </c:pt>
                <c:pt idx="80">
                  <c:v>25.18892</c:v>
                </c:pt>
                <c:pt idx="81">
                  <c:v>23.90278</c:v>
                </c:pt>
                <c:pt idx="82">
                  <c:v>21.996879999999997</c:v>
                </c:pt>
                <c:pt idx="83">
                  <c:v>20.289179999999998</c:v>
                </c:pt>
                <c:pt idx="84">
                  <c:v>18.540779999999998</c:v>
                </c:pt>
                <c:pt idx="85">
                  <c:v>17.101459999999999</c:v>
                </c:pt>
                <c:pt idx="86">
                  <c:v>15.916340000000002</c:v>
                </c:pt>
                <c:pt idx="87">
                  <c:v>14.8268</c:v>
                </c:pt>
                <c:pt idx="88">
                  <c:v>14.125</c:v>
                </c:pt>
                <c:pt idx="89">
                  <c:v>13.516759999999998</c:v>
                </c:pt>
                <c:pt idx="90">
                  <c:v>13.214140000000002</c:v>
                </c:pt>
                <c:pt idx="91">
                  <c:v>13.129020000000001</c:v>
                </c:pt>
                <c:pt idx="92">
                  <c:v>13.328940000000003</c:v>
                </c:pt>
                <c:pt idx="93">
                  <c:v>13.506340000000002</c:v>
                </c:pt>
                <c:pt idx="94">
                  <c:v>13.847879999999998</c:v>
                </c:pt>
                <c:pt idx="95">
                  <c:v>14.226520000000001</c:v>
                </c:pt>
                <c:pt idx="96">
                  <c:v>14.842659999999997</c:v>
                </c:pt>
                <c:pt idx="97">
                  <c:v>15.427140000000003</c:v>
                </c:pt>
                <c:pt idx="98">
                  <c:v>16.179819999999999</c:v>
                </c:pt>
                <c:pt idx="99">
                  <c:v>17.022779999999997</c:v>
                </c:pt>
                <c:pt idx="100">
                  <c:v>17.772600000000001</c:v>
                </c:pt>
                <c:pt idx="101">
                  <c:v>18.087740000000004</c:v>
                </c:pt>
                <c:pt idx="102">
                  <c:v>17.814759999999996</c:v>
                </c:pt>
                <c:pt idx="103">
                  <c:v>17.41722</c:v>
                </c:pt>
                <c:pt idx="104">
                  <c:v>16.839300000000001</c:v>
                </c:pt>
                <c:pt idx="105">
                  <c:v>15.970459999999997</c:v>
                </c:pt>
                <c:pt idx="106">
                  <c:v>15.085520000000001</c:v>
                </c:pt>
                <c:pt idx="107">
                  <c:v>14.237779999999999</c:v>
                </c:pt>
                <c:pt idx="108">
                  <c:v>13.317440000000003</c:v>
                </c:pt>
                <c:pt idx="109">
                  <c:v>12.479359999999998</c:v>
                </c:pt>
                <c:pt idx="110">
                  <c:v>11.734540000000003</c:v>
                </c:pt>
                <c:pt idx="111">
                  <c:v>11.130179999999999</c:v>
                </c:pt>
                <c:pt idx="112">
                  <c:v>10.580759999999998</c:v>
                </c:pt>
                <c:pt idx="113">
                  <c:v>10.186420000000002</c:v>
                </c:pt>
                <c:pt idx="114">
                  <c:v>9.8998599999999985</c:v>
                </c:pt>
                <c:pt idx="115">
                  <c:v>9.802959999999997</c:v>
                </c:pt>
                <c:pt idx="116">
                  <c:v>9.7126999999999999</c:v>
                </c:pt>
                <c:pt idx="117">
                  <c:v>9.6105400000000021</c:v>
                </c:pt>
                <c:pt idx="118">
                  <c:v>9.668079999999998</c:v>
                </c:pt>
                <c:pt idx="119">
                  <c:v>9.9442000000000004</c:v>
                </c:pt>
                <c:pt idx="120">
                  <c:v>10.0943</c:v>
                </c:pt>
                <c:pt idx="121">
                  <c:v>10.386459999999998</c:v>
                </c:pt>
                <c:pt idx="122">
                  <c:v>10.727279999999999</c:v>
                </c:pt>
                <c:pt idx="123">
                  <c:v>10.9666</c:v>
                </c:pt>
                <c:pt idx="124">
                  <c:v>9.3900400000000026</c:v>
                </c:pt>
                <c:pt idx="125">
                  <c:v>11.5495</c:v>
                </c:pt>
                <c:pt idx="126">
                  <c:v>11.816020000000002</c:v>
                </c:pt>
                <c:pt idx="127">
                  <c:v>11.755599999999999</c:v>
                </c:pt>
                <c:pt idx="128">
                  <c:v>11.349299999999999</c:v>
                </c:pt>
                <c:pt idx="129">
                  <c:v>10.99264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7FE-4BFF-B444-B61046E226DC}"/>
            </c:ext>
          </c:extLst>
        </c:ser>
        <c:ser>
          <c:idx val="1"/>
          <c:order val="1"/>
          <c:marker>
            <c:symbol val="none"/>
          </c:marker>
          <c:val>
            <c:numRef>
              <c:f>PlotData!$CD$17:$CD$146</c:f>
              <c:numCache>
                <c:formatCode>0.00</c:formatCode>
                <c:ptCount val="130"/>
                <c:pt idx="0">
                  <c:v>19.429759999999998</c:v>
                </c:pt>
                <c:pt idx="1">
                  <c:v>22.511759999999999</c:v>
                </c:pt>
                <c:pt idx="2">
                  <c:v>21.74502</c:v>
                </c:pt>
                <c:pt idx="3">
                  <c:v>21.426140000000004</c:v>
                </c:pt>
                <c:pt idx="4">
                  <c:v>20.631520000000002</c:v>
                </c:pt>
                <c:pt idx="5">
                  <c:v>19.191479999999999</c:v>
                </c:pt>
                <c:pt idx="6">
                  <c:v>17.43038</c:v>
                </c:pt>
                <c:pt idx="7">
                  <c:v>15.500759999999998</c:v>
                </c:pt>
                <c:pt idx="8">
                  <c:v>14.010340000000003</c:v>
                </c:pt>
                <c:pt idx="9">
                  <c:v>12.669220000000001</c:v>
                </c:pt>
                <c:pt idx="10">
                  <c:v>11.861020000000002</c:v>
                </c:pt>
                <c:pt idx="11">
                  <c:v>11.4313</c:v>
                </c:pt>
                <c:pt idx="12">
                  <c:v>11.359220000000001</c:v>
                </c:pt>
                <c:pt idx="13">
                  <c:v>11.801979999999999</c:v>
                </c:pt>
                <c:pt idx="14">
                  <c:v>13.230859999999998</c:v>
                </c:pt>
                <c:pt idx="15">
                  <c:v>15.736159999999998</c:v>
                </c:pt>
                <c:pt idx="16">
                  <c:v>19.470179999999999</c:v>
                </c:pt>
                <c:pt idx="17">
                  <c:v>24.094040000000003</c:v>
                </c:pt>
                <c:pt idx="18">
                  <c:v>31.431480000000001</c:v>
                </c:pt>
                <c:pt idx="19">
                  <c:v>42.313159999999996</c:v>
                </c:pt>
                <c:pt idx="20">
                  <c:v>57.255919999999996</c:v>
                </c:pt>
                <c:pt idx="21">
                  <c:v>73.737340000000003</c:v>
                </c:pt>
                <c:pt idx="22">
                  <c:v>88.99494</c:v>
                </c:pt>
                <c:pt idx="23">
                  <c:v>97.786860000000004</c:v>
                </c:pt>
                <c:pt idx="24">
                  <c:v>98.611099999999993</c:v>
                </c:pt>
                <c:pt idx="25">
                  <c:v>91.318719999999999</c:v>
                </c:pt>
                <c:pt idx="26">
                  <c:v>79.715819999999994</c:v>
                </c:pt>
                <c:pt idx="27">
                  <c:v>72.054859999999991</c:v>
                </c:pt>
                <c:pt idx="28">
                  <c:v>68.936920000000001</c:v>
                </c:pt>
                <c:pt idx="29">
                  <c:v>68.060159999999996</c:v>
                </c:pt>
                <c:pt idx="30">
                  <c:v>66.990459999999999</c:v>
                </c:pt>
                <c:pt idx="31">
                  <c:v>63.484759999999994</c:v>
                </c:pt>
                <c:pt idx="32">
                  <c:v>56.713299999999997</c:v>
                </c:pt>
                <c:pt idx="33">
                  <c:v>50.115220000000001</c:v>
                </c:pt>
                <c:pt idx="34">
                  <c:v>42.7639</c:v>
                </c:pt>
                <c:pt idx="35">
                  <c:v>35.7639</c:v>
                </c:pt>
                <c:pt idx="36">
                  <c:v>29.777840000000001</c:v>
                </c:pt>
                <c:pt idx="37">
                  <c:v>24.912379999999999</c:v>
                </c:pt>
                <c:pt idx="38">
                  <c:v>22.169359999999998</c:v>
                </c:pt>
                <c:pt idx="39">
                  <c:v>21.409340000000004</c:v>
                </c:pt>
                <c:pt idx="40">
                  <c:v>21.492959999999997</c:v>
                </c:pt>
                <c:pt idx="41">
                  <c:v>22.492259999999998</c:v>
                </c:pt>
                <c:pt idx="42">
                  <c:v>24.74372</c:v>
                </c:pt>
                <c:pt idx="43">
                  <c:v>27.136559999999999</c:v>
                </c:pt>
                <c:pt idx="44">
                  <c:v>29.998820000000002</c:v>
                </c:pt>
                <c:pt idx="45">
                  <c:v>33.233640000000001</c:v>
                </c:pt>
                <c:pt idx="46">
                  <c:v>35.692240000000005</c:v>
                </c:pt>
                <c:pt idx="47">
                  <c:v>37.790939999999999</c:v>
                </c:pt>
                <c:pt idx="48">
                  <c:v>40.015320000000003</c:v>
                </c:pt>
                <c:pt idx="49">
                  <c:v>41.9846</c:v>
                </c:pt>
                <c:pt idx="50">
                  <c:v>43.04504</c:v>
                </c:pt>
                <c:pt idx="51">
                  <c:v>42.735199999999999</c:v>
                </c:pt>
                <c:pt idx="52">
                  <c:v>41.737900000000003</c:v>
                </c:pt>
                <c:pt idx="53">
                  <c:v>39.788740000000004</c:v>
                </c:pt>
                <c:pt idx="54">
                  <c:v>37.465179999999997</c:v>
                </c:pt>
                <c:pt idx="55">
                  <c:v>34.774879999999996</c:v>
                </c:pt>
                <c:pt idx="56">
                  <c:v>32.320659999999997</c:v>
                </c:pt>
                <c:pt idx="57">
                  <c:v>29.504840000000002</c:v>
                </c:pt>
                <c:pt idx="58">
                  <c:v>26.9712</c:v>
                </c:pt>
                <c:pt idx="59">
                  <c:v>24.877159999999996</c:v>
                </c:pt>
                <c:pt idx="60">
                  <c:v>23.062799999999999</c:v>
                </c:pt>
                <c:pt idx="61">
                  <c:v>21.219159999999999</c:v>
                </c:pt>
                <c:pt idx="62">
                  <c:v>19.788120000000003</c:v>
                </c:pt>
                <c:pt idx="63">
                  <c:v>18.48818</c:v>
                </c:pt>
                <c:pt idx="64">
                  <c:v>17.318040000000003</c:v>
                </c:pt>
                <c:pt idx="65">
                  <c:v>16.53642</c:v>
                </c:pt>
                <c:pt idx="66">
                  <c:v>16.121259999999996</c:v>
                </c:pt>
                <c:pt idx="67">
                  <c:v>15.95002</c:v>
                </c:pt>
                <c:pt idx="68">
                  <c:v>16.424299999999999</c:v>
                </c:pt>
                <c:pt idx="69">
                  <c:v>17.412879999999998</c:v>
                </c:pt>
                <c:pt idx="70">
                  <c:v>19.07348</c:v>
                </c:pt>
                <c:pt idx="71">
                  <c:v>20.836340000000003</c:v>
                </c:pt>
                <c:pt idx="72">
                  <c:v>22.514479999999999</c:v>
                </c:pt>
                <c:pt idx="73">
                  <c:v>24.15192</c:v>
                </c:pt>
                <c:pt idx="74">
                  <c:v>25.363220000000002</c:v>
                </c:pt>
                <c:pt idx="75">
                  <c:v>25.98208</c:v>
                </c:pt>
                <c:pt idx="76">
                  <c:v>26.087659999999996</c:v>
                </c:pt>
                <c:pt idx="77">
                  <c:v>26.22588</c:v>
                </c:pt>
                <c:pt idx="78">
                  <c:v>25.697759999999999</c:v>
                </c:pt>
                <c:pt idx="79">
                  <c:v>24.754999999999999</c:v>
                </c:pt>
                <c:pt idx="80">
                  <c:v>23.30932</c:v>
                </c:pt>
                <c:pt idx="81">
                  <c:v>21.779779999999999</c:v>
                </c:pt>
                <c:pt idx="82">
                  <c:v>19.962979999999998</c:v>
                </c:pt>
                <c:pt idx="83">
                  <c:v>18.412279999999999</c:v>
                </c:pt>
                <c:pt idx="84">
                  <c:v>16.710079999999998</c:v>
                </c:pt>
                <c:pt idx="85">
                  <c:v>15.472659999999998</c:v>
                </c:pt>
                <c:pt idx="86">
                  <c:v>14.353540000000002</c:v>
                </c:pt>
                <c:pt idx="87">
                  <c:v>13.4298</c:v>
                </c:pt>
                <c:pt idx="88">
                  <c:v>12.709899999999999</c:v>
                </c:pt>
                <c:pt idx="89">
                  <c:v>12.075559999999998</c:v>
                </c:pt>
                <c:pt idx="90">
                  <c:v>11.596240000000002</c:v>
                </c:pt>
                <c:pt idx="91">
                  <c:v>11.367420000000001</c:v>
                </c:pt>
                <c:pt idx="92">
                  <c:v>11.253040000000002</c:v>
                </c:pt>
                <c:pt idx="93">
                  <c:v>11.325140000000003</c:v>
                </c:pt>
                <c:pt idx="94">
                  <c:v>11.52868</c:v>
                </c:pt>
                <c:pt idx="95">
                  <c:v>11.959320000000002</c:v>
                </c:pt>
                <c:pt idx="96">
                  <c:v>12.867359999999998</c:v>
                </c:pt>
                <c:pt idx="97">
                  <c:v>13.599740000000002</c:v>
                </c:pt>
                <c:pt idx="98">
                  <c:v>14.502820000000002</c:v>
                </c:pt>
                <c:pt idx="99">
                  <c:v>15.305979999999998</c:v>
                </c:pt>
                <c:pt idx="100">
                  <c:v>15.929399999999999</c:v>
                </c:pt>
                <c:pt idx="101">
                  <c:v>16.344840000000001</c:v>
                </c:pt>
                <c:pt idx="102">
                  <c:v>16.413459999999997</c:v>
                </c:pt>
                <c:pt idx="103">
                  <c:v>16.073119999999999</c:v>
                </c:pt>
                <c:pt idx="104">
                  <c:v>15.4566</c:v>
                </c:pt>
                <c:pt idx="105">
                  <c:v>14.545159999999997</c:v>
                </c:pt>
                <c:pt idx="106">
                  <c:v>13.625020000000001</c:v>
                </c:pt>
                <c:pt idx="107">
                  <c:v>12.770679999999999</c:v>
                </c:pt>
                <c:pt idx="108">
                  <c:v>11.755940000000002</c:v>
                </c:pt>
                <c:pt idx="109">
                  <c:v>10.852859999999998</c:v>
                </c:pt>
                <c:pt idx="110">
                  <c:v>10.037940000000003</c:v>
                </c:pt>
                <c:pt idx="111">
                  <c:v>9.328479999999999</c:v>
                </c:pt>
                <c:pt idx="112">
                  <c:v>8.6877599999999973</c:v>
                </c:pt>
                <c:pt idx="113">
                  <c:v>8.2434200000000004</c:v>
                </c:pt>
                <c:pt idx="114">
                  <c:v>7.971359999999998</c:v>
                </c:pt>
                <c:pt idx="115">
                  <c:v>7.8197599999999978</c:v>
                </c:pt>
                <c:pt idx="116">
                  <c:v>7.7135999999999996</c:v>
                </c:pt>
                <c:pt idx="117">
                  <c:v>7.716140000000002</c:v>
                </c:pt>
                <c:pt idx="118">
                  <c:v>7.9296799999999985</c:v>
                </c:pt>
                <c:pt idx="119">
                  <c:v>8.2263999999999999</c:v>
                </c:pt>
                <c:pt idx="120">
                  <c:v>8.5062999999999995</c:v>
                </c:pt>
                <c:pt idx="121">
                  <c:v>8.8952599999999968</c:v>
                </c:pt>
                <c:pt idx="122">
                  <c:v>9.3958799999999982</c:v>
                </c:pt>
                <c:pt idx="123">
                  <c:v>9.7431000000000001</c:v>
                </c:pt>
                <c:pt idx="124">
                  <c:v>8.1884400000000017</c:v>
                </c:pt>
                <c:pt idx="125">
                  <c:v>10.2834</c:v>
                </c:pt>
                <c:pt idx="126">
                  <c:v>10.064920000000001</c:v>
                </c:pt>
                <c:pt idx="127">
                  <c:v>10.171200000000001</c:v>
                </c:pt>
                <c:pt idx="128">
                  <c:v>9.5109999999999992</c:v>
                </c:pt>
                <c:pt idx="129">
                  <c:v>9.59414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7FE-4BFF-B444-B61046E226DC}"/>
            </c:ext>
          </c:extLst>
        </c:ser>
        <c:ser>
          <c:idx val="2"/>
          <c:order val="2"/>
          <c:marker>
            <c:symbol val="none"/>
          </c:marker>
          <c:val>
            <c:numRef>
              <c:f>PlotData!$CE$17:$CE$146</c:f>
              <c:numCache>
                <c:formatCode>0.00</c:formatCode>
                <c:ptCount val="130"/>
                <c:pt idx="0">
                  <c:v>26.336259999999999</c:v>
                </c:pt>
                <c:pt idx="1">
                  <c:v>28.959359999999997</c:v>
                </c:pt>
                <c:pt idx="2">
                  <c:v>29.28922</c:v>
                </c:pt>
                <c:pt idx="3">
                  <c:v>28.069440000000004</c:v>
                </c:pt>
                <c:pt idx="4">
                  <c:v>26.631520000000002</c:v>
                </c:pt>
                <c:pt idx="5">
                  <c:v>24.110379999999999</c:v>
                </c:pt>
                <c:pt idx="6">
                  <c:v>22.34308</c:v>
                </c:pt>
                <c:pt idx="7">
                  <c:v>21.521759999999997</c:v>
                </c:pt>
                <c:pt idx="8">
                  <c:v>19.955540000000003</c:v>
                </c:pt>
                <c:pt idx="9">
                  <c:v>17.686820000000001</c:v>
                </c:pt>
                <c:pt idx="10">
                  <c:v>15.797220000000001</c:v>
                </c:pt>
                <c:pt idx="11">
                  <c:v>14.392799999999999</c:v>
                </c:pt>
                <c:pt idx="12">
                  <c:v>14.596920000000001</c:v>
                </c:pt>
                <c:pt idx="13">
                  <c:v>16.409179999999999</c:v>
                </c:pt>
                <c:pt idx="14">
                  <c:v>19.907559999999997</c:v>
                </c:pt>
                <c:pt idx="15">
                  <c:v>24.474059999999998</c:v>
                </c:pt>
                <c:pt idx="16">
                  <c:v>30.214979999999997</c:v>
                </c:pt>
                <c:pt idx="17">
                  <c:v>37.40014</c:v>
                </c:pt>
                <c:pt idx="18">
                  <c:v>48.235779999999998</c:v>
                </c:pt>
                <c:pt idx="19">
                  <c:v>66.572859999999991</c:v>
                </c:pt>
                <c:pt idx="20">
                  <c:v>89.56031999999999</c:v>
                </c:pt>
                <c:pt idx="21">
                  <c:v>112.82203999999999</c:v>
                </c:pt>
                <c:pt idx="22">
                  <c:v>136.74003999999999</c:v>
                </c:pt>
                <c:pt idx="23">
                  <c:v>153.65546000000001</c:v>
                </c:pt>
                <c:pt idx="24">
                  <c:v>157.90170000000001</c:v>
                </c:pt>
                <c:pt idx="25">
                  <c:v>147.74112</c:v>
                </c:pt>
                <c:pt idx="26">
                  <c:v>131.26972000000001</c:v>
                </c:pt>
                <c:pt idx="27">
                  <c:v>116.69226</c:v>
                </c:pt>
                <c:pt idx="28">
                  <c:v>106.17291999999999</c:v>
                </c:pt>
                <c:pt idx="29">
                  <c:v>97.963759999999994</c:v>
                </c:pt>
                <c:pt idx="30">
                  <c:v>90.403260000000003</c:v>
                </c:pt>
                <c:pt idx="31">
                  <c:v>82.566459999999992</c:v>
                </c:pt>
                <c:pt idx="32">
                  <c:v>72.917599999999993</c:v>
                </c:pt>
                <c:pt idx="33">
                  <c:v>64.239519999999999</c:v>
                </c:pt>
                <c:pt idx="34">
                  <c:v>54.588700000000003</c:v>
                </c:pt>
                <c:pt idx="35">
                  <c:v>45.718699999999998</c:v>
                </c:pt>
                <c:pt idx="36">
                  <c:v>38.680840000000003</c:v>
                </c:pt>
                <c:pt idx="37">
                  <c:v>32.600279999999998</c:v>
                </c:pt>
                <c:pt idx="38">
                  <c:v>28.589659999999999</c:v>
                </c:pt>
                <c:pt idx="39">
                  <c:v>26.553540000000002</c:v>
                </c:pt>
                <c:pt idx="40">
                  <c:v>24.949859999999997</c:v>
                </c:pt>
                <c:pt idx="41">
                  <c:v>24.892459999999996</c:v>
                </c:pt>
                <c:pt idx="42">
                  <c:v>26.052420000000001</c:v>
                </c:pt>
                <c:pt idx="43">
                  <c:v>28.736459999999997</c:v>
                </c:pt>
                <c:pt idx="44">
                  <c:v>32.549419999999998</c:v>
                </c:pt>
                <c:pt idx="45">
                  <c:v>37.347640000000006</c:v>
                </c:pt>
                <c:pt idx="46">
                  <c:v>41.934240000000003</c:v>
                </c:pt>
                <c:pt idx="47">
                  <c:v>45.923439999999999</c:v>
                </c:pt>
                <c:pt idx="48">
                  <c:v>48.887219999999999</c:v>
                </c:pt>
                <c:pt idx="49">
                  <c:v>51.147500000000001</c:v>
                </c:pt>
                <c:pt idx="50">
                  <c:v>51.819540000000003</c:v>
                </c:pt>
                <c:pt idx="51">
                  <c:v>51.710999999999999</c:v>
                </c:pt>
                <c:pt idx="52">
                  <c:v>50.9512</c:v>
                </c:pt>
                <c:pt idx="53">
                  <c:v>48.837040000000002</c:v>
                </c:pt>
                <c:pt idx="54">
                  <c:v>45.874479999999998</c:v>
                </c:pt>
                <c:pt idx="55">
                  <c:v>42.92418</c:v>
                </c:pt>
                <c:pt idx="56">
                  <c:v>40.177759999999999</c:v>
                </c:pt>
                <c:pt idx="57">
                  <c:v>36.744140000000002</c:v>
                </c:pt>
                <c:pt idx="58">
                  <c:v>33.764899999999997</c:v>
                </c:pt>
                <c:pt idx="59">
                  <c:v>30.878359999999997</c:v>
                </c:pt>
                <c:pt idx="60">
                  <c:v>28.452300000000001</c:v>
                </c:pt>
                <c:pt idx="61">
                  <c:v>25.972459999999998</c:v>
                </c:pt>
                <c:pt idx="62">
                  <c:v>24.291920000000001</c:v>
                </c:pt>
                <c:pt idx="63">
                  <c:v>22.743279999999999</c:v>
                </c:pt>
                <c:pt idx="64">
                  <c:v>21.506740000000001</c:v>
                </c:pt>
                <c:pt idx="65">
                  <c:v>20.69332</c:v>
                </c:pt>
                <c:pt idx="66">
                  <c:v>20.150159999999996</c:v>
                </c:pt>
                <c:pt idx="67">
                  <c:v>19.694120000000002</c:v>
                </c:pt>
                <c:pt idx="68">
                  <c:v>19.808399999999999</c:v>
                </c:pt>
                <c:pt idx="69">
                  <c:v>20.129179999999998</c:v>
                </c:pt>
                <c:pt idx="70">
                  <c:v>21.17558</c:v>
                </c:pt>
                <c:pt idx="71">
                  <c:v>22.271940000000001</c:v>
                </c:pt>
                <c:pt idx="72">
                  <c:v>23.827479999999998</c:v>
                </c:pt>
                <c:pt idx="73">
                  <c:v>25.14892</c:v>
                </c:pt>
                <c:pt idx="74">
                  <c:v>26.384720000000002</c:v>
                </c:pt>
                <c:pt idx="75">
                  <c:v>29.118279999999999</c:v>
                </c:pt>
                <c:pt idx="76">
                  <c:v>28.229459999999996</c:v>
                </c:pt>
                <c:pt idx="77">
                  <c:v>28.96508</c:v>
                </c:pt>
                <c:pt idx="78">
                  <c:v>29.034259999999996</c:v>
                </c:pt>
                <c:pt idx="79">
                  <c:v>28.417100000000001</c:v>
                </c:pt>
                <c:pt idx="80">
                  <c:v>27.19162</c:v>
                </c:pt>
                <c:pt idx="81">
                  <c:v>25.96818</c:v>
                </c:pt>
                <c:pt idx="82">
                  <c:v>24.35998</c:v>
                </c:pt>
                <c:pt idx="83">
                  <c:v>22.845679999999998</c:v>
                </c:pt>
                <c:pt idx="84">
                  <c:v>21.326879999999999</c:v>
                </c:pt>
                <c:pt idx="85">
                  <c:v>19.817759999999996</c:v>
                </c:pt>
                <c:pt idx="86">
                  <c:v>18.452640000000002</c:v>
                </c:pt>
                <c:pt idx="87">
                  <c:v>17.244800000000001</c:v>
                </c:pt>
                <c:pt idx="88">
                  <c:v>16.305099999999999</c:v>
                </c:pt>
                <c:pt idx="89">
                  <c:v>15.451259999999998</c:v>
                </c:pt>
                <c:pt idx="90">
                  <c:v>14.689240000000002</c:v>
                </c:pt>
                <c:pt idx="91">
                  <c:v>14.346220000000001</c:v>
                </c:pt>
                <c:pt idx="92">
                  <c:v>13.982240000000003</c:v>
                </c:pt>
                <c:pt idx="93">
                  <c:v>13.847140000000003</c:v>
                </c:pt>
                <c:pt idx="94">
                  <c:v>14.08658</c:v>
                </c:pt>
                <c:pt idx="95">
                  <c:v>14.186520000000002</c:v>
                </c:pt>
                <c:pt idx="96">
                  <c:v>14.866859999999997</c:v>
                </c:pt>
                <c:pt idx="97">
                  <c:v>15.394040000000002</c:v>
                </c:pt>
                <c:pt idx="98">
                  <c:v>16.239920000000001</c:v>
                </c:pt>
                <c:pt idx="99">
                  <c:v>17.133579999999998</c:v>
                </c:pt>
                <c:pt idx="100">
                  <c:v>18.1294</c:v>
                </c:pt>
                <c:pt idx="101">
                  <c:v>18.814140000000002</c:v>
                </c:pt>
                <c:pt idx="102">
                  <c:v>19.309159999999999</c:v>
                </c:pt>
                <c:pt idx="103">
                  <c:v>19.445420000000002</c:v>
                </c:pt>
                <c:pt idx="104">
                  <c:v>19.2441</c:v>
                </c:pt>
                <c:pt idx="105">
                  <c:v>18.641559999999998</c:v>
                </c:pt>
                <c:pt idx="106">
                  <c:v>17.98132</c:v>
                </c:pt>
                <c:pt idx="107">
                  <c:v>17.114079999999998</c:v>
                </c:pt>
                <c:pt idx="108">
                  <c:v>16.130140000000001</c:v>
                </c:pt>
                <c:pt idx="109">
                  <c:v>14.984559999999998</c:v>
                </c:pt>
                <c:pt idx="110">
                  <c:v>14.159640000000003</c:v>
                </c:pt>
                <c:pt idx="111">
                  <c:v>13.255579999999998</c:v>
                </c:pt>
                <c:pt idx="112">
                  <c:v>12.590559999999998</c:v>
                </c:pt>
                <c:pt idx="113">
                  <c:v>11.90802</c:v>
                </c:pt>
                <c:pt idx="114">
                  <c:v>11.486859999999998</c:v>
                </c:pt>
                <c:pt idx="115">
                  <c:v>11.110459999999998</c:v>
                </c:pt>
                <c:pt idx="116">
                  <c:v>10.956899999999999</c:v>
                </c:pt>
                <c:pt idx="117">
                  <c:v>10.764940000000003</c:v>
                </c:pt>
                <c:pt idx="118">
                  <c:v>10.795179999999998</c:v>
                </c:pt>
                <c:pt idx="119">
                  <c:v>11.027699999999999</c:v>
                </c:pt>
                <c:pt idx="120">
                  <c:v>11.2644</c:v>
                </c:pt>
                <c:pt idx="121">
                  <c:v>11.513159999999997</c:v>
                </c:pt>
                <c:pt idx="122">
                  <c:v>11.833879999999999</c:v>
                </c:pt>
                <c:pt idx="123">
                  <c:v>12.283300000000001</c:v>
                </c:pt>
                <c:pt idx="124">
                  <c:v>10.629540000000002</c:v>
                </c:pt>
                <c:pt idx="125">
                  <c:v>12.8271</c:v>
                </c:pt>
                <c:pt idx="126">
                  <c:v>13.025520000000002</c:v>
                </c:pt>
                <c:pt idx="127">
                  <c:v>13.0854</c:v>
                </c:pt>
                <c:pt idx="128">
                  <c:v>13.1599</c:v>
                </c:pt>
                <c:pt idx="129">
                  <c:v>12.89744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7FE-4BFF-B444-B61046E226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5507200"/>
        <c:axId val="38851328"/>
      </c:lineChart>
      <c:catAx>
        <c:axId val="35507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8851328"/>
        <c:crosses val="autoZero"/>
        <c:auto val="1"/>
        <c:lblAlgn val="ctr"/>
        <c:lblOffset val="100"/>
        <c:tickLblSkip val="24"/>
        <c:tickMarkSkip val="24"/>
        <c:noMultiLvlLbl val="0"/>
      </c:catAx>
      <c:valAx>
        <c:axId val="38851328"/>
        <c:scaling>
          <c:orientation val="minMax"/>
        </c:scaling>
        <c:delete val="0"/>
        <c:axPos val="l"/>
        <c:majorGridlines/>
        <c:numFmt formatCode="#,##0_);[Red]\(#,##0\)" sourceLinked="0"/>
        <c:majorTickMark val="out"/>
        <c:minorTickMark val="none"/>
        <c:tickLblPos val="nextTo"/>
        <c:crossAx val="355072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053363-8410-4D02-BD9A-2BAF05E471F2}" type="datetimeFigureOut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28775" y="1143000"/>
            <a:ext cx="360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7827E3-1715-4A59-B4A4-AA295E1981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18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883861"/>
            <a:ext cx="5355670" cy="1880235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2836605"/>
            <a:ext cx="4725591" cy="1303913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91C4-C34E-4DC1-A579-1A3B6C413C5E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5850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F3E09-8DE8-4C25-ACA0-EF165F461BEE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706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287536"/>
            <a:ext cx="1358607" cy="4576822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287536"/>
            <a:ext cx="3997062" cy="4576822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FBBBE-6061-47AC-BC8D-FB976DAD2225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9656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FD866-B2AC-42EC-98D7-F3029271575F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9671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1346420"/>
            <a:ext cx="5434430" cy="2246530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3614203"/>
            <a:ext cx="5434430" cy="1181397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AB35E-470D-4405-8088-6E802CBA0FD9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7669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1437680"/>
            <a:ext cx="2677835" cy="3426679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1437680"/>
            <a:ext cx="2677835" cy="3426679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5A4FD-2A70-458C-A7E7-4A11B8D3A84C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401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287537"/>
            <a:ext cx="5434430" cy="1043881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1323916"/>
            <a:ext cx="2665528" cy="648831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1972747"/>
            <a:ext cx="2665528" cy="290161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1323916"/>
            <a:ext cx="2678656" cy="648831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1972747"/>
            <a:ext cx="2678656" cy="290161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E5130-7CF3-42FA-96D2-2B19FB85DBB0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237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F39D-150C-41C5-A787-EC0F3295FABC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882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7934A-A47E-475F-AFB6-99AA513907E7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144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360045"/>
            <a:ext cx="2032168" cy="1260158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777598"/>
            <a:ext cx="3189774" cy="3837980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620202"/>
            <a:ext cx="2032168" cy="3001626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600C-F5E7-4FFA-965C-54332A9323DE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9695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360045"/>
            <a:ext cx="2032168" cy="1260158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777598"/>
            <a:ext cx="3189774" cy="3837980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620202"/>
            <a:ext cx="2032168" cy="3001626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5C292-207A-45FD-BFAC-B33C9EFADD1D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40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287537"/>
            <a:ext cx="5434430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1437680"/>
            <a:ext cx="5434430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5005627"/>
            <a:ext cx="141767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B4636-A480-4E55-BD66-666B9BA26760}" type="datetime1">
              <a:rPr lang="zh-CN" altLang="en-US" smtClean="0"/>
              <a:t>2022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5005627"/>
            <a:ext cx="212651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5005627"/>
            <a:ext cx="141767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55BAD-AD76-49C3-A950-3C0BD48F29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7115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1.wdp"/><Relationship Id="rId18" Type="http://schemas.openxmlformats.org/officeDocument/2006/relationships/image" Target="../media/image14.png"/><Relationship Id="rId26" Type="http://schemas.openxmlformats.org/officeDocument/2006/relationships/image" Target="../media/image18.png"/><Relationship Id="rId3" Type="http://schemas.openxmlformats.org/officeDocument/2006/relationships/image" Target="../media/image2.png"/><Relationship Id="rId21" Type="http://schemas.microsoft.com/office/2007/relationships/hdphoto" Target="../media/hdphoto5.wdp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microsoft.com/office/2007/relationships/hdphoto" Target="../media/hdphoto3.wdp"/><Relationship Id="rId25" Type="http://schemas.microsoft.com/office/2007/relationships/hdphoto" Target="../media/hdphoto7.wdp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17.png"/><Relationship Id="rId5" Type="http://schemas.openxmlformats.org/officeDocument/2006/relationships/image" Target="../media/image4.png"/><Relationship Id="rId15" Type="http://schemas.microsoft.com/office/2007/relationships/hdphoto" Target="../media/hdphoto2.wdp"/><Relationship Id="rId23" Type="http://schemas.microsoft.com/office/2007/relationships/hdphoto" Target="../media/hdphoto6.wdp"/><Relationship Id="rId10" Type="http://schemas.openxmlformats.org/officeDocument/2006/relationships/image" Target="../media/image9.png"/><Relationship Id="rId19" Type="http://schemas.microsoft.com/office/2007/relationships/hdphoto" Target="../media/hdphoto4.wdp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2.png"/><Relationship Id="rId22" Type="http://schemas.openxmlformats.org/officeDocument/2006/relationships/image" Target="../media/image16.png"/><Relationship Id="rId27" Type="http://schemas.microsoft.com/office/2007/relationships/hdphoto" Target="../media/hdphoto8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2.xml"/><Relationship Id="rId13" Type="http://schemas.openxmlformats.org/officeDocument/2006/relationships/chart" Target="../charts/chart27.xml"/><Relationship Id="rId3" Type="http://schemas.openxmlformats.org/officeDocument/2006/relationships/chart" Target="../charts/chart17.xml"/><Relationship Id="rId7" Type="http://schemas.openxmlformats.org/officeDocument/2006/relationships/chart" Target="../charts/chart21.xml"/><Relationship Id="rId12" Type="http://schemas.openxmlformats.org/officeDocument/2006/relationships/chart" Target="../charts/chart26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0.xml"/><Relationship Id="rId11" Type="http://schemas.openxmlformats.org/officeDocument/2006/relationships/chart" Target="../charts/chart25.xml"/><Relationship Id="rId5" Type="http://schemas.openxmlformats.org/officeDocument/2006/relationships/chart" Target="../charts/chart19.xml"/><Relationship Id="rId10" Type="http://schemas.openxmlformats.org/officeDocument/2006/relationships/chart" Target="../charts/chart24.xml"/><Relationship Id="rId4" Type="http://schemas.openxmlformats.org/officeDocument/2006/relationships/chart" Target="../charts/chart18.xml"/><Relationship Id="rId9" Type="http://schemas.openxmlformats.org/officeDocument/2006/relationships/chart" Target="../charts/chart23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openxmlformats.org/officeDocument/2006/relationships/image" Target="../media/image54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12" Type="http://schemas.openxmlformats.org/officeDocument/2006/relationships/image" Target="../media/image53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46.pn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10" Type="http://schemas.openxmlformats.org/officeDocument/2006/relationships/image" Target="../media/image63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66F9124-7B62-4443-934B-CA5634B786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0188" y="4272650"/>
            <a:ext cx="2736850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6">
            <a:extLst>
              <a:ext uri="{FF2B5EF4-FFF2-40B4-BE49-F238E27FC236}">
                <a16:creationId xmlns:a16="http://schemas.microsoft.com/office/drawing/2014/main" id="{4CDFAC69-95A3-4876-A17D-8EB30AD980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425" y="3642413"/>
            <a:ext cx="2736850" cy="312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30">
            <a:extLst>
              <a:ext uri="{FF2B5EF4-FFF2-40B4-BE49-F238E27FC236}">
                <a16:creationId xmlns:a16="http://schemas.microsoft.com/office/drawing/2014/main" id="{E5887EB7-3CC9-4885-BA8E-9762E7CACB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425" y="4015475"/>
            <a:ext cx="2736850" cy="20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3">
            <a:extLst>
              <a:ext uri="{FF2B5EF4-FFF2-40B4-BE49-F238E27FC236}">
                <a16:creationId xmlns:a16="http://schemas.microsoft.com/office/drawing/2014/main" id="{CE8AFBD7-CD4C-4F7D-B13C-349145D154A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425" y="3345550"/>
            <a:ext cx="2736850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0">
            <a:extLst>
              <a:ext uri="{FF2B5EF4-FFF2-40B4-BE49-F238E27FC236}">
                <a16:creationId xmlns:a16="http://schemas.microsoft.com/office/drawing/2014/main" id="{D8466A87-911F-4930-A488-758B71EF112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425" y="1848538"/>
            <a:ext cx="2736850" cy="428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1">
            <a:extLst>
              <a:ext uri="{FF2B5EF4-FFF2-40B4-BE49-F238E27FC236}">
                <a16:creationId xmlns:a16="http://schemas.microsoft.com/office/drawing/2014/main" id="{85DE62E6-6431-498B-9A7B-386871D15BC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425" y="2323200"/>
            <a:ext cx="2736850" cy="49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53">
            <a:extLst>
              <a:ext uri="{FF2B5EF4-FFF2-40B4-BE49-F238E27FC236}">
                <a16:creationId xmlns:a16="http://schemas.microsoft.com/office/drawing/2014/main" id="{2720A751-8189-4488-9C59-DA744CA3797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6100" y="1848538"/>
            <a:ext cx="1547813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63">
            <a:extLst>
              <a:ext uri="{FF2B5EF4-FFF2-40B4-BE49-F238E27FC236}">
                <a16:creationId xmlns:a16="http://schemas.microsoft.com/office/drawing/2014/main" id="{730454D6-1A38-44D3-9027-CA65FFD9CFA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6100" y="2323200"/>
            <a:ext cx="1547813" cy="484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7">
            <a:extLst>
              <a:ext uri="{FF2B5EF4-FFF2-40B4-BE49-F238E27FC236}">
                <a16:creationId xmlns:a16="http://schemas.microsoft.com/office/drawing/2014/main" id="{46590FB5-6119-4C50-A01D-2E90E73998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682" y="1957563"/>
            <a:ext cx="11785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V5 (FRQ)</a:t>
            </a: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94C2EE92-50AB-480B-976D-F95617E1BB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682" y="2409463"/>
            <a:ext cx="10937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FRQ </a:t>
            </a:r>
            <a:r>
              <a:rPr lang="en-US" altLang="zh-CN" sz="1200" dirty="0" err="1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l.e</a:t>
            </a: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</a:t>
            </a:r>
          </a:p>
        </p:txBody>
      </p:sp>
      <p:sp>
        <p:nvSpPr>
          <p:cNvPr id="19" name="TextBox 24">
            <a:extLst>
              <a:ext uri="{FF2B5EF4-FFF2-40B4-BE49-F238E27FC236}">
                <a16:creationId xmlns:a16="http://schemas.microsoft.com/office/drawing/2014/main" id="{22F2A20A-20E7-44E2-9192-D56D041529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682" y="3335500"/>
            <a:ext cx="9128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WC-1</a:t>
            </a:r>
          </a:p>
        </p:txBody>
      </p:sp>
      <p:sp>
        <p:nvSpPr>
          <p:cNvPr id="20" name="TextBox 30">
            <a:extLst>
              <a:ext uri="{FF2B5EF4-FFF2-40B4-BE49-F238E27FC236}">
                <a16:creationId xmlns:a16="http://schemas.microsoft.com/office/drawing/2014/main" id="{7F707DCE-7D48-4DC5-9AF7-04E22AFA30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682" y="3978963"/>
            <a:ext cx="9128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WC-2</a:t>
            </a:r>
          </a:p>
        </p:txBody>
      </p:sp>
      <p:sp>
        <p:nvSpPr>
          <p:cNvPr id="21" name="TextBox 31">
            <a:extLst>
              <a:ext uri="{FF2B5EF4-FFF2-40B4-BE49-F238E27FC236}">
                <a16:creationId xmlns:a16="http://schemas.microsoft.com/office/drawing/2014/main" id="{7485125E-9872-434E-9FF4-C65D4909C4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457" y="4252550"/>
            <a:ext cx="11604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WC-2 </a:t>
            </a:r>
            <a:r>
              <a:rPr lang="en-US" altLang="zh-CN" sz="1200" dirty="0" err="1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l.e</a:t>
            </a: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</a:t>
            </a:r>
          </a:p>
        </p:txBody>
      </p:sp>
      <p:sp>
        <p:nvSpPr>
          <p:cNvPr id="22" name="TextBox 40">
            <a:extLst>
              <a:ext uri="{FF2B5EF4-FFF2-40B4-BE49-F238E27FC236}">
                <a16:creationId xmlns:a16="http://schemas.microsoft.com/office/drawing/2014/main" id="{5568E2AA-F66B-463C-86C0-7D30BEC20C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682" y="3657250"/>
            <a:ext cx="11604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WC-1 l.e.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E4A841A-E64C-45BB-AD8B-152B68106227}"/>
              </a:ext>
            </a:extLst>
          </p:cNvPr>
          <p:cNvCxnSpPr/>
          <p:nvPr/>
        </p:nvCxnSpPr>
        <p:spPr>
          <a:xfrm>
            <a:off x="1520311" y="768538"/>
            <a:ext cx="1295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33CAC24-EF75-419A-A2D2-8CE2512DCD4D}"/>
              </a:ext>
            </a:extLst>
          </p:cNvPr>
          <p:cNvCxnSpPr/>
          <p:nvPr/>
        </p:nvCxnSpPr>
        <p:spPr>
          <a:xfrm>
            <a:off x="2873249" y="768538"/>
            <a:ext cx="1295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DE99B86-FA59-462C-863B-56EF02D459C2}"/>
              </a:ext>
            </a:extLst>
          </p:cNvPr>
          <p:cNvCxnSpPr/>
          <p:nvPr/>
        </p:nvCxnSpPr>
        <p:spPr>
          <a:xfrm>
            <a:off x="4360409" y="764512"/>
            <a:ext cx="7191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F26CD82-1F00-4AE0-93C2-7962EE5DEC15}"/>
              </a:ext>
            </a:extLst>
          </p:cNvPr>
          <p:cNvCxnSpPr/>
          <p:nvPr/>
        </p:nvCxnSpPr>
        <p:spPr>
          <a:xfrm>
            <a:off x="5127636" y="771110"/>
            <a:ext cx="7191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31">
            <a:extLst>
              <a:ext uri="{FF2B5EF4-FFF2-40B4-BE49-F238E27FC236}">
                <a16:creationId xmlns:a16="http://schemas.microsoft.com/office/drawing/2014/main" id="{F3B3ED65-7AD3-49D4-8C45-AD1B74ED2F5D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869918" y="404475"/>
            <a:ext cx="12255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Helvetica" panose="020B0604020202020204" pitchFamily="34" charset="0"/>
                <a:cs typeface="Helvetica" panose="020B0604020202020204" pitchFamily="34" charset="0"/>
              </a:rPr>
              <a:t>Input </a:t>
            </a:r>
            <a:endParaRPr lang="zh-CN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" name="TextBox 36">
            <a:extLst>
              <a:ext uri="{FF2B5EF4-FFF2-40B4-BE49-F238E27FC236}">
                <a16:creationId xmlns:a16="http://schemas.microsoft.com/office/drawing/2014/main" id="{54741217-C1B4-4AC4-AC00-CC6436ABA10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173304" y="415588"/>
            <a:ext cx="1260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Helvetica" panose="020B0604020202020204" pitchFamily="34" charset="0"/>
                <a:cs typeface="Helvetica" panose="020B0604020202020204" pitchFamily="34" charset="0"/>
              </a:rPr>
              <a:t>V5 IP</a:t>
            </a:r>
            <a:endParaRPr lang="zh-CN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TextBox 31">
            <a:extLst>
              <a:ext uri="{FF2B5EF4-FFF2-40B4-BE49-F238E27FC236}">
                <a16:creationId xmlns:a16="http://schemas.microsoft.com/office/drawing/2014/main" id="{7E6EC974-3E02-4804-862D-012C7470BBE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438424" y="401300"/>
            <a:ext cx="1263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  <a:endParaRPr lang="zh-CN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TextBox 36">
            <a:extLst>
              <a:ext uri="{FF2B5EF4-FFF2-40B4-BE49-F238E27FC236}">
                <a16:creationId xmlns:a16="http://schemas.microsoft.com/office/drawing/2014/main" id="{F9C4A0CF-301E-4681-8F8A-717DDBCE08E8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5148263" y="401903"/>
            <a:ext cx="1260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Helvetica" panose="020B0604020202020204" pitchFamily="34" charset="0"/>
                <a:cs typeface="Helvetica" panose="020B0604020202020204" pitchFamily="34" charset="0"/>
              </a:rPr>
              <a:t>V5 IP</a:t>
            </a:r>
            <a:endParaRPr lang="zh-CN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TextBox 1">
            <a:extLst>
              <a:ext uri="{FF2B5EF4-FFF2-40B4-BE49-F238E27FC236}">
                <a16:creationId xmlns:a16="http://schemas.microsoft.com/office/drawing/2014/main" id="{5A5CCCBD-D04D-4226-86F0-313256DB60F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21152" y="1341419"/>
            <a:ext cx="8935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-114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18">
            <a:extLst>
              <a:ext uri="{FF2B5EF4-FFF2-40B4-BE49-F238E27FC236}">
                <a16:creationId xmlns:a16="http://schemas.microsoft.com/office/drawing/2014/main" id="{56AC7363-F2A1-4A86-8A2F-FA2E6D9FE3C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72469" y="1283454"/>
            <a:ext cx="1008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15-25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TextBox 19">
            <a:extLst>
              <a:ext uri="{FF2B5EF4-FFF2-40B4-BE49-F238E27FC236}">
                <a16:creationId xmlns:a16="http://schemas.microsoft.com/office/drawing/2014/main" id="{89867F8B-09E4-4CBE-9DE9-50DC8B1D5D2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46732" y="1282123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60-383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20">
            <a:extLst>
              <a:ext uri="{FF2B5EF4-FFF2-40B4-BE49-F238E27FC236}">
                <a16:creationId xmlns:a16="http://schemas.microsoft.com/office/drawing/2014/main" id="{553EB7CB-8174-43C7-B4B7-6E8F8983AC2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48884" y="1282123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84-471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TextBox 15">
            <a:extLst>
              <a:ext uri="{FF2B5EF4-FFF2-40B4-BE49-F238E27FC236}">
                <a16:creationId xmlns:a16="http://schemas.microsoft.com/office/drawing/2014/main" id="{9C794915-71A3-4924-98B8-080C41BBE42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44158" y="1282123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472-61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19">
            <a:extLst>
              <a:ext uri="{FF2B5EF4-FFF2-40B4-BE49-F238E27FC236}">
                <a16:creationId xmlns:a16="http://schemas.microsoft.com/office/drawing/2014/main" id="{9084C0B8-4DD0-4F1F-9D27-68957FBF60A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131150" y="1277895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616-708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TextBox 20">
            <a:extLst>
              <a:ext uri="{FF2B5EF4-FFF2-40B4-BE49-F238E27FC236}">
                <a16:creationId xmlns:a16="http://schemas.microsoft.com/office/drawing/2014/main" id="{9239FFC6-DF4F-41AA-A3D8-C38B3264625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319522" y="1282120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709-86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TextBox 21">
            <a:extLst>
              <a:ext uri="{FF2B5EF4-FFF2-40B4-BE49-F238E27FC236}">
                <a16:creationId xmlns:a16="http://schemas.microsoft.com/office/drawing/2014/main" id="{3BD86F25-DFAB-4A5C-9816-685CFFC37D6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15865" y="1282120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866-98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0" name="TextBox 1">
            <a:extLst>
              <a:ext uri="{FF2B5EF4-FFF2-40B4-BE49-F238E27FC236}">
                <a16:creationId xmlns:a16="http://schemas.microsoft.com/office/drawing/2014/main" id="{B7EF944C-4CF6-442D-83A6-F14A97221D8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94703" y="1403638"/>
            <a:ext cx="7681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V5H6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1" name="TextBox 1">
            <a:extLst>
              <a:ext uri="{FF2B5EF4-FFF2-40B4-BE49-F238E27FC236}">
                <a16:creationId xmlns:a16="http://schemas.microsoft.com/office/drawing/2014/main" id="{5AB5134F-4381-403A-91F5-40A371A48BE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84632" y="1194650"/>
            <a:ext cx="12062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WT (untagged)</a:t>
            </a:r>
            <a:endParaRPr lang="zh-CN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TextBox 1">
            <a:extLst>
              <a:ext uri="{FF2B5EF4-FFF2-40B4-BE49-F238E27FC236}">
                <a16:creationId xmlns:a16="http://schemas.microsoft.com/office/drawing/2014/main" id="{D317D87D-C31B-44A2-AEBC-AE1FAA3A749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92216" y="1341423"/>
            <a:ext cx="8935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-114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TextBox 18">
            <a:extLst>
              <a:ext uri="{FF2B5EF4-FFF2-40B4-BE49-F238E27FC236}">
                <a16:creationId xmlns:a16="http://schemas.microsoft.com/office/drawing/2014/main" id="{8C690DDD-66BC-4419-8005-91983BA7EF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29784" y="1283452"/>
            <a:ext cx="1008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15-25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TextBox 19">
            <a:extLst>
              <a:ext uri="{FF2B5EF4-FFF2-40B4-BE49-F238E27FC236}">
                <a16:creationId xmlns:a16="http://schemas.microsoft.com/office/drawing/2014/main" id="{E16E94C2-4060-4501-9099-4AAC9566AC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04051" y="1282121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60-383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TextBox 20">
            <a:extLst>
              <a:ext uri="{FF2B5EF4-FFF2-40B4-BE49-F238E27FC236}">
                <a16:creationId xmlns:a16="http://schemas.microsoft.com/office/drawing/2014/main" id="{598FD165-58B6-4BEB-A402-89AD9931452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13078" y="1282121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84-471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15">
            <a:extLst>
              <a:ext uri="{FF2B5EF4-FFF2-40B4-BE49-F238E27FC236}">
                <a16:creationId xmlns:a16="http://schemas.microsoft.com/office/drawing/2014/main" id="{4B9EEB53-9ED9-4EE6-B55B-8748A113697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15225" y="1282121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472-61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TextBox 19">
            <a:extLst>
              <a:ext uri="{FF2B5EF4-FFF2-40B4-BE49-F238E27FC236}">
                <a16:creationId xmlns:a16="http://schemas.microsoft.com/office/drawing/2014/main" id="{4E766477-7465-46B3-9BB9-F9D7B4A752E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900043" y="1281071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616-708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20">
            <a:extLst>
              <a:ext uri="{FF2B5EF4-FFF2-40B4-BE49-F238E27FC236}">
                <a16:creationId xmlns:a16="http://schemas.microsoft.com/office/drawing/2014/main" id="{55061CDA-1EA8-463E-8623-FF2B3CC03E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095298" y="1285296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709-86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TextBox 21">
            <a:extLst>
              <a:ext uri="{FF2B5EF4-FFF2-40B4-BE49-F238E27FC236}">
                <a16:creationId xmlns:a16="http://schemas.microsoft.com/office/drawing/2014/main" id="{92CC4496-3FD8-45DB-B34B-5162ED02171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300085" y="1285296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866-98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4" name="TextBox 8">
            <a:extLst>
              <a:ext uri="{FF2B5EF4-FFF2-40B4-BE49-F238E27FC236}">
                <a16:creationId xmlns:a16="http://schemas.microsoft.com/office/drawing/2014/main" id="{05A78439-1B4A-4204-844A-B1A45E1558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920" y="2955501"/>
            <a:ext cx="8350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WB: FRH</a:t>
            </a:r>
          </a:p>
        </p:txBody>
      </p:sp>
      <p:pic>
        <p:nvPicPr>
          <p:cNvPr id="63" name="Picture 25">
            <a:extLst>
              <a:ext uri="{FF2B5EF4-FFF2-40B4-BE49-F238E27FC236}">
                <a16:creationId xmlns:a16="http://schemas.microsoft.com/office/drawing/2014/main" id="{C249F173-B88A-444A-B28F-61A100B9FFD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9075" y="2886763"/>
            <a:ext cx="2735263" cy="390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4" name="Picture 26">
            <a:extLst>
              <a:ext uri="{FF2B5EF4-FFF2-40B4-BE49-F238E27FC236}">
                <a16:creationId xmlns:a16="http://schemas.microsoft.com/office/drawing/2014/main" id="{F34EC6B7-9C24-4D22-AE13-0219395481C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6100" y="2866125"/>
            <a:ext cx="1547813" cy="403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7F626F3D-BE15-4C2D-A8AE-C26115B5E70B}"/>
              </a:ext>
            </a:extLst>
          </p:cNvPr>
          <p:cNvSpPr txBox="1"/>
          <p:nvPr/>
        </p:nvSpPr>
        <p:spPr>
          <a:xfrm>
            <a:off x="-4002" y="3854"/>
            <a:ext cx="2401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1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5" name="TextBox 1">
            <a:extLst>
              <a:ext uri="{FF2B5EF4-FFF2-40B4-BE49-F238E27FC236}">
                <a16:creationId xmlns:a16="http://schemas.microsoft.com/office/drawing/2014/main" id="{6CD948D3-99C4-4397-9ABA-2000A2088D6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57140" y="1404783"/>
            <a:ext cx="7681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V5H6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TextBox 1">
            <a:extLst>
              <a:ext uri="{FF2B5EF4-FFF2-40B4-BE49-F238E27FC236}">
                <a16:creationId xmlns:a16="http://schemas.microsoft.com/office/drawing/2014/main" id="{0B2A0E3E-5025-4E6B-8063-59BD9E742E1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53944" y="1195795"/>
            <a:ext cx="12062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WT (untagged)</a:t>
            </a:r>
            <a:endParaRPr lang="zh-CN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TextBox 1">
            <a:extLst>
              <a:ext uri="{FF2B5EF4-FFF2-40B4-BE49-F238E27FC236}">
                <a16:creationId xmlns:a16="http://schemas.microsoft.com/office/drawing/2014/main" id="{191611C8-AB45-4D35-91B5-769FC081294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71678" y="1407004"/>
            <a:ext cx="7681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V5H6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8" name="TextBox 1">
            <a:extLst>
              <a:ext uri="{FF2B5EF4-FFF2-40B4-BE49-F238E27FC236}">
                <a16:creationId xmlns:a16="http://schemas.microsoft.com/office/drawing/2014/main" id="{8ADC111F-4C92-4D49-9340-A19E93C6717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836790" y="1407542"/>
            <a:ext cx="7681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V5H6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80D1E524-A6DE-4654-A05D-C37D0574FA1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6027" y="3331647"/>
            <a:ext cx="765612" cy="269628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32EA5A4A-E41F-4360-87D6-8D001B80FE4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0332" y="3332019"/>
            <a:ext cx="766665" cy="270000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402911BA-E8D4-417D-BB17-F65305C95B7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9594" y="4004099"/>
            <a:ext cx="755429" cy="198626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0D4FA4C7-8E3F-406E-8B21-3D07F835F30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7754" y="4004099"/>
            <a:ext cx="755082" cy="198534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713B1FA2-E29D-4C71-93D6-E2E97AC321BF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8069" y="3642899"/>
            <a:ext cx="763569" cy="265447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C163F751-5F97-4687-A04E-7AC67BC004A5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6255" y="3642899"/>
            <a:ext cx="763200" cy="265319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53E60A0C-0AC9-40B9-A66A-93BF977A55F2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71636" y="4259013"/>
            <a:ext cx="760001" cy="203745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67CE437E-BF02-485C-B266-A33BD9B67AD6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0332" y="4259013"/>
            <a:ext cx="760001" cy="203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77456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8BBA6B3-A4CB-427D-AD8A-173B1C2E6E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0756832"/>
              </p:ext>
            </p:extLst>
          </p:nvPr>
        </p:nvGraphicFramePr>
        <p:xfrm>
          <a:off x="1057062" y="4324938"/>
          <a:ext cx="1941280" cy="10552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F70B5E7-F28D-4C1F-B6B0-FBB77D31EE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0361521"/>
              </p:ext>
            </p:extLst>
          </p:nvPr>
        </p:nvGraphicFramePr>
        <p:xfrm>
          <a:off x="1045896" y="3341706"/>
          <a:ext cx="1952446" cy="1025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3821DB3-1AD1-457F-B7F5-320E777FD2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6355303"/>
              </p:ext>
            </p:extLst>
          </p:nvPr>
        </p:nvGraphicFramePr>
        <p:xfrm>
          <a:off x="1048327" y="2392437"/>
          <a:ext cx="1929466" cy="1011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86886736-F87E-4A16-A074-80774A18F1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916981"/>
              </p:ext>
            </p:extLst>
          </p:nvPr>
        </p:nvGraphicFramePr>
        <p:xfrm>
          <a:off x="1044550" y="1468787"/>
          <a:ext cx="1953792" cy="10206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5196632-12D0-4B4B-8588-45026819F6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8840421"/>
              </p:ext>
            </p:extLst>
          </p:nvPr>
        </p:nvGraphicFramePr>
        <p:xfrm>
          <a:off x="4527600" y="4305855"/>
          <a:ext cx="1899141" cy="10743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BC2A88E2-86E7-42AE-BD96-A3B393BEB2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1887498"/>
              </p:ext>
            </p:extLst>
          </p:nvPr>
        </p:nvGraphicFramePr>
        <p:xfrm>
          <a:off x="4484397" y="3330626"/>
          <a:ext cx="1942344" cy="1025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37A7486-32D1-4C3E-89E3-FD42393DBF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2360822"/>
              </p:ext>
            </p:extLst>
          </p:nvPr>
        </p:nvGraphicFramePr>
        <p:xfrm>
          <a:off x="4509327" y="2365040"/>
          <a:ext cx="1956650" cy="1017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CF13C4F3-1487-4CA9-957D-31901D3B99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2184186"/>
              </p:ext>
            </p:extLst>
          </p:nvPr>
        </p:nvGraphicFramePr>
        <p:xfrm>
          <a:off x="4511553" y="1450385"/>
          <a:ext cx="1944149" cy="1017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0BDCF2E4-C453-465A-A630-EDBC94673B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2547967"/>
              </p:ext>
            </p:extLst>
          </p:nvPr>
        </p:nvGraphicFramePr>
        <p:xfrm>
          <a:off x="2745569" y="4306900"/>
          <a:ext cx="1964935" cy="10743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97F89436-CD67-486D-8CDC-4856EA2880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7896809"/>
              </p:ext>
            </p:extLst>
          </p:nvPr>
        </p:nvGraphicFramePr>
        <p:xfrm>
          <a:off x="2758484" y="3320964"/>
          <a:ext cx="1950612" cy="1025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4B15C11A-B3F7-4588-BD64-6B2C74D4E5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6689629"/>
              </p:ext>
            </p:extLst>
          </p:nvPr>
        </p:nvGraphicFramePr>
        <p:xfrm>
          <a:off x="2768159" y="2374979"/>
          <a:ext cx="1940937" cy="1017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667C9D22-547F-423A-8F90-33EADD0554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5402022"/>
              </p:ext>
            </p:extLst>
          </p:nvPr>
        </p:nvGraphicFramePr>
        <p:xfrm>
          <a:off x="2775115" y="1471091"/>
          <a:ext cx="1954529" cy="10271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9710" name="TextBox 1">
            <a:extLst>
              <a:ext uri="{FF2B5EF4-FFF2-40B4-BE49-F238E27FC236}">
                <a16:creationId xmlns:a16="http://schemas.microsoft.com/office/drawing/2014/main" id="{E9789E8B-1C46-40F9-91E4-F99F817032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27" y="1754644"/>
            <a:ext cx="915764" cy="283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-114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711" name="TextBox 18">
            <a:extLst>
              <a:ext uri="{FF2B5EF4-FFF2-40B4-BE49-F238E27FC236}">
                <a16:creationId xmlns:a16="http://schemas.microsoft.com/office/drawing/2014/main" id="{2CB09A69-8708-4611-84CC-B6206EEEA8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4002" y="2773933"/>
            <a:ext cx="1008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115-25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712" name="TextBox 19">
            <a:extLst>
              <a:ext uri="{FF2B5EF4-FFF2-40B4-BE49-F238E27FC236}">
                <a16:creationId xmlns:a16="http://schemas.microsoft.com/office/drawing/2014/main" id="{DC9B85C9-C95F-4A53-A549-C3BA488B3A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889" y="3692417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60-383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713" name="TextBox 20">
            <a:extLst>
              <a:ext uri="{FF2B5EF4-FFF2-40B4-BE49-F238E27FC236}">
                <a16:creationId xmlns:a16="http://schemas.microsoft.com/office/drawing/2014/main" id="{7E680BE5-EFE5-4E83-AAD7-DBD06AAE42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2" y="4686480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84-471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714" name="Title 1">
            <a:extLst>
              <a:ext uri="{FF2B5EF4-FFF2-40B4-BE49-F238E27FC236}">
                <a16:creationId xmlns:a16="http://schemas.microsoft.com/office/drawing/2014/main" id="{050AA405-5D25-47E3-AB2A-BE61E38AB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98115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1259F9CD-CCF7-46B0-B744-E50FA17401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3427218"/>
              </p:ext>
            </p:extLst>
          </p:nvPr>
        </p:nvGraphicFramePr>
        <p:xfrm>
          <a:off x="1097919" y="494541"/>
          <a:ext cx="1900423" cy="10691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67DDE8C0-2F2F-45C0-A0BA-771FDBCC55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7892183"/>
              </p:ext>
            </p:extLst>
          </p:nvPr>
        </p:nvGraphicFramePr>
        <p:xfrm>
          <a:off x="4511553" y="472052"/>
          <a:ext cx="1954424" cy="1072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id="{E1D4FE1E-1517-4481-ADB7-1F93D5F2D6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6662088"/>
              </p:ext>
            </p:extLst>
          </p:nvPr>
        </p:nvGraphicFramePr>
        <p:xfrm>
          <a:off x="2770959" y="499156"/>
          <a:ext cx="1942345" cy="1055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41" name="TextBox 17">
            <a:extLst>
              <a:ext uri="{FF2B5EF4-FFF2-40B4-BE49-F238E27FC236}">
                <a16:creationId xmlns:a16="http://schemas.microsoft.com/office/drawing/2014/main" id="{35242741-854C-41A2-BACA-97DFA54D2A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2" y="817056"/>
            <a:ext cx="1074653" cy="283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WT (661-4a)</a:t>
            </a:r>
            <a:endParaRPr lang="zh-CN" alt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8346A7B-65F9-4103-8406-3B45FF77AE96}"/>
              </a:ext>
            </a:extLst>
          </p:cNvPr>
          <p:cNvSpPr txBox="1"/>
          <p:nvPr/>
        </p:nvSpPr>
        <p:spPr>
          <a:xfrm>
            <a:off x="-4002" y="3854"/>
            <a:ext cx="2316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2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Title 1">
            <a:extLst>
              <a:ext uri="{FF2B5EF4-FFF2-40B4-BE49-F238E27FC236}">
                <a16:creationId xmlns:a16="http://schemas.microsoft.com/office/drawing/2014/main" id="{7E684B0F-E0E5-4C3A-82BC-E505F99FF774}"/>
              </a:ext>
            </a:extLst>
          </p:cNvPr>
          <p:cNvSpPr txBox="1">
            <a:spLocks/>
          </p:cNvSpPr>
          <p:nvPr/>
        </p:nvSpPr>
        <p:spPr>
          <a:xfrm>
            <a:off x="3506291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7" name="Title 1">
            <a:extLst>
              <a:ext uri="{FF2B5EF4-FFF2-40B4-BE49-F238E27FC236}">
                <a16:creationId xmlns:a16="http://schemas.microsoft.com/office/drawing/2014/main" id="{89B8451E-7D2D-485B-9641-73C8CA100C62}"/>
              </a:ext>
            </a:extLst>
          </p:cNvPr>
          <p:cNvSpPr txBox="1">
            <a:spLocks/>
          </p:cNvSpPr>
          <p:nvPr/>
        </p:nvSpPr>
        <p:spPr>
          <a:xfrm>
            <a:off x="5205613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93C39D2-804D-4D70-953A-CD17C692E086}"/>
              </a:ext>
            </a:extLst>
          </p:cNvPr>
          <p:cNvSpPr txBox="1"/>
          <p:nvPr/>
        </p:nvSpPr>
        <p:spPr>
          <a:xfrm>
            <a:off x="1814469" y="142844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9477041-184A-4944-8AEF-73518601A68E}"/>
              </a:ext>
            </a:extLst>
          </p:cNvPr>
          <p:cNvSpPr txBox="1"/>
          <p:nvPr/>
        </p:nvSpPr>
        <p:spPr>
          <a:xfrm>
            <a:off x="3659537" y="1416471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7D54020-F2B8-4A7C-804F-920A99F50F59}"/>
              </a:ext>
            </a:extLst>
          </p:cNvPr>
          <p:cNvSpPr txBox="1"/>
          <p:nvPr/>
        </p:nvSpPr>
        <p:spPr>
          <a:xfrm>
            <a:off x="5245150" y="1416401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94B56EB-F329-4862-AB5D-77476D7756A7}"/>
              </a:ext>
            </a:extLst>
          </p:cNvPr>
          <p:cNvSpPr txBox="1"/>
          <p:nvPr/>
        </p:nvSpPr>
        <p:spPr>
          <a:xfrm>
            <a:off x="1812949" y="235668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944AF8-BFFE-4AF3-B5C9-048801368AAE}"/>
              </a:ext>
            </a:extLst>
          </p:cNvPr>
          <p:cNvSpPr txBox="1"/>
          <p:nvPr/>
        </p:nvSpPr>
        <p:spPr>
          <a:xfrm>
            <a:off x="3658017" y="2354237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EF33326-465F-45AF-A47A-79FE52EB7AE7}"/>
              </a:ext>
            </a:extLst>
          </p:cNvPr>
          <p:cNvSpPr txBox="1"/>
          <p:nvPr/>
        </p:nvSpPr>
        <p:spPr>
          <a:xfrm>
            <a:off x="5243630" y="2335117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2FA1CB5-5F2C-4ED5-8367-21C114E1CEC8}"/>
              </a:ext>
            </a:extLst>
          </p:cNvPr>
          <p:cNvSpPr txBox="1"/>
          <p:nvPr/>
        </p:nvSpPr>
        <p:spPr>
          <a:xfrm>
            <a:off x="1823708" y="326266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F405662-AC08-4019-B1A8-94A36766EBDB}"/>
              </a:ext>
            </a:extLst>
          </p:cNvPr>
          <p:cNvSpPr txBox="1"/>
          <p:nvPr/>
        </p:nvSpPr>
        <p:spPr>
          <a:xfrm>
            <a:off x="3668776" y="3260216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C0DB7A2-BF9C-457C-958C-82DE4FF4850C}"/>
              </a:ext>
            </a:extLst>
          </p:cNvPr>
          <p:cNvSpPr txBox="1"/>
          <p:nvPr/>
        </p:nvSpPr>
        <p:spPr>
          <a:xfrm>
            <a:off x="5254389" y="3260146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1C494F6-74C3-43B7-B7B0-D779DE18D76F}"/>
              </a:ext>
            </a:extLst>
          </p:cNvPr>
          <p:cNvSpPr txBox="1"/>
          <p:nvPr/>
        </p:nvSpPr>
        <p:spPr>
          <a:xfrm>
            <a:off x="1823708" y="4225072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4FE8941-81B2-44AD-A4FB-45BBC12DDB0D}"/>
              </a:ext>
            </a:extLst>
          </p:cNvPr>
          <p:cNvSpPr txBox="1"/>
          <p:nvPr/>
        </p:nvSpPr>
        <p:spPr>
          <a:xfrm>
            <a:off x="3668776" y="422262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88BDE7E-411B-4D4D-AF8A-0D657D55D563}"/>
              </a:ext>
            </a:extLst>
          </p:cNvPr>
          <p:cNvSpPr txBox="1"/>
          <p:nvPr/>
        </p:nvSpPr>
        <p:spPr>
          <a:xfrm>
            <a:off x="5254389" y="422255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BCF3757-A221-4F2A-80C1-1079D6EC33F4}"/>
              </a:ext>
            </a:extLst>
          </p:cNvPr>
          <p:cNvSpPr txBox="1"/>
          <p:nvPr/>
        </p:nvSpPr>
        <p:spPr>
          <a:xfrm>
            <a:off x="1820397" y="5239733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59069D5-0C68-4E71-927E-03B971EB4635}"/>
              </a:ext>
            </a:extLst>
          </p:cNvPr>
          <p:cNvSpPr txBox="1"/>
          <p:nvPr/>
        </p:nvSpPr>
        <p:spPr>
          <a:xfrm>
            <a:off x="3665465" y="523728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6A633FA-FCBF-4539-AFD7-C60D048759F5}"/>
              </a:ext>
            </a:extLst>
          </p:cNvPr>
          <p:cNvSpPr txBox="1"/>
          <p:nvPr/>
        </p:nvSpPr>
        <p:spPr>
          <a:xfrm>
            <a:off x="5251078" y="523721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AA19D90-D98D-40C1-9747-2497E71349EB}"/>
              </a:ext>
            </a:extLst>
          </p:cNvPr>
          <p:cNvSpPr txBox="1"/>
          <p:nvPr/>
        </p:nvSpPr>
        <p:spPr>
          <a:xfrm rot="16200000">
            <a:off x="488297" y="870657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FE2124E-499A-4EE5-BD44-54F6AC07EFFF}"/>
              </a:ext>
            </a:extLst>
          </p:cNvPr>
          <p:cNvSpPr txBox="1"/>
          <p:nvPr/>
        </p:nvSpPr>
        <p:spPr>
          <a:xfrm rot="16200000">
            <a:off x="488296" y="1853334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C8F3F7C-5A5F-4E54-9BB1-4AAC3ADB639A}"/>
              </a:ext>
            </a:extLst>
          </p:cNvPr>
          <p:cNvSpPr txBox="1"/>
          <p:nvPr/>
        </p:nvSpPr>
        <p:spPr>
          <a:xfrm rot="16200000">
            <a:off x="486789" y="2788299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7B3FFFE-58E6-4602-B3DF-2CA30A80EDBA}"/>
              </a:ext>
            </a:extLst>
          </p:cNvPr>
          <p:cNvSpPr txBox="1"/>
          <p:nvPr/>
        </p:nvSpPr>
        <p:spPr>
          <a:xfrm rot="16200000">
            <a:off x="486789" y="3758334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5E5F277-41CB-4E83-91B7-4781A0B2E21B}"/>
              </a:ext>
            </a:extLst>
          </p:cNvPr>
          <p:cNvSpPr txBox="1"/>
          <p:nvPr/>
        </p:nvSpPr>
        <p:spPr>
          <a:xfrm rot="16200000">
            <a:off x="485282" y="4740924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1A4C855B-E655-4A16-B23D-3703A17274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6738177"/>
              </p:ext>
            </p:extLst>
          </p:nvPr>
        </p:nvGraphicFramePr>
        <p:xfrm>
          <a:off x="1045516" y="3675119"/>
          <a:ext cx="1944186" cy="1119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7A55AEF5-78FA-421A-BBB1-23C3377914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8290056"/>
              </p:ext>
            </p:extLst>
          </p:nvPr>
        </p:nvGraphicFramePr>
        <p:xfrm>
          <a:off x="1033097" y="2640581"/>
          <a:ext cx="1952179" cy="11141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850CC14F-76E8-4487-9E30-E2F73C6227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9875511"/>
              </p:ext>
            </p:extLst>
          </p:nvPr>
        </p:nvGraphicFramePr>
        <p:xfrm>
          <a:off x="1033096" y="1616073"/>
          <a:ext cx="1952180" cy="1124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5BC24DB3-29BD-4699-8629-669C62E64A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0238349"/>
              </p:ext>
            </p:extLst>
          </p:nvPr>
        </p:nvGraphicFramePr>
        <p:xfrm>
          <a:off x="1024910" y="582843"/>
          <a:ext cx="1944186" cy="1116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ADCE4AB3-DF5C-4BFF-A91E-7E46135C81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3606169"/>
              </p:ext>
            </p:extLst>
          </p:nvPr>
        </p:nvGraphicFramePr>
        <p:xfrm>
          <a:off x="4506163" y="3666573"/>
          <a:ext cx="1954747" cy="1119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FD787BE9-CC50-409C-8FB8-9914FE1350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1114138"/>
              </p:ext>
            </p:extLst>
          </p:nvPr>
        </p:nvGraphicFramePr>
        <p:xfrm>
          <a:off x="4516725" y="2620033"/>
          <a:ext cx="1944186" cy="11141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1C0478C3-9FE8-46FF-AA16-9F3C59273D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4724498"/>
              </p:ext>
            </p:extLst>
          </p:nvPr>
        </p:nvGraphicFramePr>
        <p:xfrm>
          <a:off x="4506163" y="1615876"/>
          <a:ext cx="1954747" cy="11167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2DCFB5A0-E295-4D43-87FD-9BA1292C12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6652166"/>
              </p:ext>
            </p:extLst>
          </p:nvPr>
        </p:nvGraphicFramePr>
        <p:xfrm>
          <a:off x="4511444" y="582546"/>
          <a:ext cx="1954747" cy="11168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1559B045-EEC4-47AC-9F09-86F42A3893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3138629"/>
              </p:ext>
            </p:extLst>
          </p:nvPr>
        </p:nvGraphicFramePr>
        <p:xfrm>
          <a:off x="2755835" y="3666573"/>
          <a:ext cx="1954747" cy="1119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221B1A12-2540-4366-A84A-0AB1379B24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0687173"/>
              </p:ext>
            </p:extLst>
          </p:nvPr>
        </p:nvGraphicFramePr>
        <p:xfrm>
          <a:off x="2790995" y="2632033"/>
          <a:ext cx="1944186" cy="1122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3AD91B5F-19F0-4D72-8148-E9564FCA1D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8706626"/>
              </p:ext>
            </p:extLst>
          </p:nvPr>
        </p:nvGraphicFramePr>
        <p:xfrm>
          <a:off x="2790995" y="1616073"/>
          <a:ext cx="1944186" cy="1124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8D2671A4-8088-491B-96CD-3CD5A99EF1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4731098"/>
              </p:ext>
            </p:extLst>
          </p:nvPr>
        </p:nvGraphicFramePr>
        <p:xfrm>
          <a:off x="2790995" y="582545"/>
          <a:ext cx="1944186" cy="1127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34" name="TextBox 15">
            <a:extLst>
              <a:ext uri="{FF2B5EF4-FFF2-40B4-BE49-F238E27FC236}">
                <a16:creationId xmlns:a16="http://schemas.microsoft.com/office/drawing/2014/main" id="{B3F42B97-3103-476D-94E1-604105549A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8894" y="975104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472-61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19">
            <a:extLst>
              <a:ext uri="{FF2B5EF4-FFF2-40B4-BE49-F238E27FC236}">
                <a16:creationId xmlns:a16="http://schemas.microsoft.com/office/drawing/2014/main" id="{E7D4650D-4408-4D37-8A8C-1F1E2DBE10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8893" y="2029673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616-708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TextBox 20">
            <a:extLst>
              <a:ext uri="{FF2B5EF4-FFF2-40B4-BE49-F238E27FC236}">
                <a16:creationId xmlns:a16="http://schemas.microsoft.com/office/drawing/2014/main" id="{818EF986-13A0-442F-A532-9E347A1665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8893" y="3056718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709-865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21">
            <a:extLst>
              <a:ext uri="{FF2B5EF4-FFF2-40B4-BE49-F238E27FC236}">
                <a16:creationId xmlns:a16="http://schemas.microsoft.com/office/drawing/2014/main" id="{93445D83-2AF6-4640-93CA-DEBA5B0399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8893" y="3994551"/>
            <a:ext cx="10166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altLang="zh-CN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866-989pA</a:t>
            </a:r>
            <a:endParaRPr lang="zh-CN" altLang="en-US" sz="1200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48953FD-E980-4529-BBB2-FEB24DF93924}"/>
              </a:ext>
            </a:extLst>
          </p:cNvPr>
          <p:cNvSpPr txBox="1"/>
          <p:nvPr/>
        </p:nvSpPr>
        <p:spPr>
          <a:xfrm>
            <a:off x="-4003" y="3854"/>
            <a:ext cx="3407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2 continued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Title 1">
            <a:extLst>
              <a:ext uri="{FF2B5EF4-FFF2-40B4-BE49-F238E27FC236}">
                <a16:creationId xmlns:a16="http://schemas.microsoft.com/office/drawing/2014/main" id="{B0B27E88-E8DB-4F01-AA1E-B9EF294561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79065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40" name="Title 1">
            <a:extLst>
              <a:ext uri="{FF2B5EF4-FFF2-40B4-BE49-F238E27FC236}">
                <a16:creationId xmlns:a16="http://schemas.microsoft.com/office/drawing/2014/main" id="{5565F26B-4E80-406F-9543-B496B43E511D}"/>
              </a:ext>
            </a:extLst>
          </p:cNvPr>
          <p:cNvSpPr txBox="1">
            <a:spLocks/>
          </p:cNvSpPr>
          <p:nvPr/>
        </p:nvSpPr>
        <p:spPr>
          <a:xfrm>
            <a:off x="3487241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41" name="Title 1">
            <a:extLst>
              <a:ext uri="{FF2B5EF4-FFF2-40B4-BE49-F238E27FC236}">
                <a16:creationId xmlns:a16="http://schemas.microsoft.com/office/drawing/2014/main" id="{A3CAFCB6-0010-4F3C-B3B8-C3238EAACA14}"/>
              </a:ext>
            </a:extLst>
          </p:cNvPr>
          <p:cNvSpPr txBox="1">
            <a:spLocks/>
          </p:cNvSpPr>
          <p:nvPr/>
        </p:nvSpPr>
        <p:spPr>
          <a:xfrm>
            <a:off x="5186563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E53456E-F402-4E18-B1CC-432A8BA7B203}"/>
              </a:ext>
            </a:extLst>
          </p:cNvPr>
          <p:cNvSpPr txBox="1"/>
          <p:nvPr/>
        </p:nvSpPr>
        <p:spPr>
          <a:xfrm>
            <a:off x="1795419" y="1564633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A03C5B-70C5-4D90-B8C1-47C6C5D44D56}"/>
              </a:ext>
            </a:extLst>
          </p:cNvPr>
          <p:cNvSpPr txBox="1"/>
          <p:nvPr/>
        </p:nvSpPr>
        <p:spPr>
          <a:xfrm>
            <a:off x="3640487" y="156218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E2C91E4-02F1-4734-BEDE-A9FD745F81E5}"/>
              </a:ext>
            </a:extLst>
          </p:cNvPr>
          <p:cNvSpPr txBox="1"/>
          <p:nvPr/>
        </p:nvSpPr>
        <p:spPr>
          <a:xfrm>
            <a:off x="5226100" y="156211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5F8B250-94F3-4E67-96F9-C33EAF995210}"/>
              </a:ext>
            </a:extLst>
          </p:cNvPr>
          <p:cNvSpPr txBox="1"/>
          <p:nvPr/>
        </p:nvSpPr>
        <p:spPr>
          <a:xfrm>
            <a:off x="1792174" y="2582792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DF158AD-62AD-4F22-B964-97BDE718EE28}"/>
              </a:ext>
            </a:extLst>
          </p:cNvPr>
          <p:cNvSpPr txBox="1"/>
          <p:nvPr/>
        </p:nvSpPr>
        <p:spPr>
          <a:xfrm>
            <a:off x="3637242" y="258034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9862270-CD5D-4C30-8EF9-C2BD24B0119A}"/>
              </a:ext>
            </a:extLst>
          </p:cNvPr>
          <p:cNvSpPr txBox="1"/>
          <p:nvPr/>
        </p:nvSpPr>
        <p:spPr>
          <a:xfrm>
            <a:off x="5222855" y="258027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AE4D11B-76E0-404D-8CD9-47ECF3AE9F78}"/>
              </a:ext>
            </a:extLst>
          </p:cNvPr>
          <p:cNvSpPr txBox="1"/>
          <p:nvPr/>
        </p:nvSpPr>
        <p:spPr>
          <a:xfrm>
            <a:off x="1788931" y="361007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5F18FC7-1D1C-4C2A-92CD-0334DF256306}"/>
              </a:ext>
            </a:extLst>
          </p:cNvPr>
          <p:cNvSpPr txBox="1"/>
          <p:nvPr/>
        </p:nvSpPr>
        <p:spPr>
          <a:xfrm>
            <a:off x="3633999" y="3607626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CAFD793-852C-4867-9935-A5C2E1BD84DC}"/>
              </a:ext>
            </a:extLst>
          </p:cNvPr>
          <p:cNvSpPr txBox="1"/>
          <p:nvPr/>
        </p:nvSpPr>
        <p:spPr>
          <a:xfrm>
            <a:off x="5219612" y="3607556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41967D8-6CAC-45F4-B31F-0D3BA7E9ECB6}"/>
              </a:ext>
            </a:extLst>
          </p:cNvPr>
          <p:cNvSpPr txBox="1"/>
          <p:nvPr/>
        </p:nvSpPr>
        <p:spPr>
          <a:xfrm>
            <a:off x="1785690" y="4647893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E6B6374-0FDF-4626-AF0B-8339100200D3}"/>
              </a:ext>
            </a:extLst>
          </p:cNvPr>
          <p:cNvSpPr txBox="1"/>
          <p:nvPr/>
        </p:nvSpPr>
        <p:spPr>
          <a:xfrm>
            <a:off x="3630758" y="464544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5EAF2F2-FEEB-4AF3-816E-FF9ADAF885CE}"/>
              </a:ext>
            </a:extLst>
          </p:cNvPr>
          <p:cNvSpPr txBox="1"/>
          <p:nvPr/>
        </p:nvSpPr>
        <p:spPr>
          <a:xfrm>
            <a:off x="5216371" y="4645375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DD (hr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871ABE2-63A3-486E-B375-621D853B31D0}"/>
              </a:ext>
            </a:extLst>
          </p:cNvPr>
          <p:cNvSpPr txBox="1"/>
          <p:nvPr/>
        </p:nvSpPr>
        <p:spPr>
          <a:xfrm rot="16200000">
            <a:off x="488297" y="1032582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9DD63A7-3D69-4E21-A532-9BB9576A97DA}"/>
              </a:ext>
            </a:extLst>
          </p:cNvPr>
          <p:cNvSpPr txBox="1"/>
          <p:nvPr/>
        </p:nvSpPr>
        <p:spPr>
          <a:xfrm rot="16200000">
            <a:off x="488296" y="2034309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E3AD1DE-50A6-4668-BE89-FAD790D58499}"/>
              </a:ext>
            </a:extLst>
          </p:cNvPr>
          <p:cNvSpPr txBox="1"/>
          <p:nvPr/>
        </p:nvSpPr>
        <p:spPr>
          <a:xfrm rot="16200000">
            <a:off x="486789" y="3074049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8ACFDA9-9688-4871-97AF-DC6621A6A8DB}"/>
              </a:ext>
            </a:extLst>
          </p:cNvPr>
          <p:cNvSpPr txBox="1"/>
          <p:nvPr/>
        </p:nvSpPr>
        <p:spPr>
          <a:xfrm rot="16200000">
            <a:off x="486789" y="4139334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34" charset="0"/>
                <a:cs typeface="Helvetica" panose="020B0604020202020204" pitchFamily="34" charset="0"/>
              </a:rPr>
              <a:t>Luminescence (AU)</a:t>
            </a:r>
            <a:endParaRPr lang="zh-CN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854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1">
            <a:extLst>
              <a:ext uri="{FF2B5EF4-FFF2-40B4-BE49-F238E27FC236}">
                <a16:creationId xmlns:a16="http://schemas.microsoft.com/office/drawing/2014/main" id="{B8346A7B-65F9-4103-8406-3B45FF77AE96}"/>
              </a:ext>
            </a:extLst>
          </p:cNvPr>
          <p:cNvSpPr txBox="1"/>
          <p:nvPr/>
        </p:nvSpPr>
        <p:spPr>
          <a:xfrm>
            <a:off x="0" y="-3391"/>
            <a:ext cx="2316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3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BD5E5F2-2BC7-016C-A5E1-B00CBDF439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1878" y="744547"/>
            <a:ext cx="1728000" cy="10386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49A1ECE-8359-6EAD-6668-35FE16AF92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1878" y="1906907"/>
            <a:ext cx="1728000" cy="103863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A4E34F7-5455-7CAA-E03C-F09FEBCFF3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5869" y="738439"/>
            <a:ext cx="1728000" cy="10386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1B31437-9D30-BD73-C399-C1E6A90548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9985" y="1906907"/>
            <a:ext cx="1728000" cy="103863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29B3A98-4896-C47E-A63B-C22C435EA8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0235" y="738439"/>
            <a:ext cx="1728000" cy="103863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4589307-A769-59DC-DA63-5E33979940A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66119" y="1906906"/>
            <a:ext cx="1728000" cy="1038639"/>
          </a:xfrm>
          <a:prstGeom prst="rect">
            <a:avLst/>
          </a:prstGeom>
        </p:spPr>
      </p:pic>
      <p:sp>
        <p:nvSpPr>
          <p:cNvPr id="14" name="TextBox 14">
            <a:extLst>
              <a:ext uri="{FF2B5EF4-FFF2-40B4-BE49-F238E27FC236}">
                <a16:creationId xmlns:a16="http://schemas.microsoft.com/office/drawing/2014/main" id="{A29AB6B8-D94B-00DB-DFFA-55CE302C6459}"/>
              </a:ext>
            </a:extLst>
          </p:cNvPr>
          <p:cNvSpPr txBox="1"/>
          <p:nvPr/>
        </p:nvSpPr>
        <p:spPr>
          <a:xfrm>
            <a:off x="322" y="912476"/>
            <a:ext cx="11671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13A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Strain 1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D75083FC-EAA3-B2D8-5D1D-19FE4BFCE043}"/>
              </a:ext>
            </a:extLst>
          </p:cNvPr>
          <p:cNvSpPr txBox="1"/>
          <p:nvPr/>
        </p:nvSpPr>
        <p:spPr>
          <a:xfrm>
            <a:off x="322" y="2025662"/>
            <a:ext cx="1066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13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 Strain 2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B07BB9B5-32E6-4590-5B0C-FD8A8EA1627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31878" y="3069267"/>
            <a:ext cx="1728000" cy="103863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E65FBED-AADB-ADB3-65AB-777C00154E8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59985" y="3069264"/>
            <a:ext cx="1728000" cy="103863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4210AAA-BB53-B722-3F7B-58718043F99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66119" y="3075375"/>
            <a:ext cx="1728000" cy="1038638"/>
          </a:xfrm>
          <a:prstGeom prst="rect">
            <a:avLst/>
          </a:prstGeom>
        </p:spPr>
      </p:pic>
      <p:sp>
        <p:nvSpPr>
          <p:cNvPr id="19" name="TextBox 21">
            <a:extLst>
              <a:ext uri="{FF2B5EF4-FFF2-40B4-BE49-F238E27FC236}">
                <a16:creationId xmlns:a16="http://schemas.microsoft.com/office/drawing/2014/main" id="{E9447017-4E9C-973B-B41B-EF98240E5311}"/>
              </a:ext>
            </a:extLst>
          </p:cNvPr>
          <p:cNvSpPr txBox="1"/>
          <p:nvPr/>
        </p:nvSpPr>
        <p:spPr>
          <a:xfrm>
            <a:off x="322" y="3203910"/>
            <a:ext cx="140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38A, S540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1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BB1A2D4-09FC-4EA7-8B50-B30B8989E31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31878" y="4243843"/>
            <a:ext cx="1728000" cy="103863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81ED265-5B26-413B-9D07-E1D739F484B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55869" y="4225514"/>
            <a:ext cx="1728000" cy="103863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906C12D2-32F9-464B-ADBD-6780941ADC8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64061" y="4225514"/>
            <a:ext cx="1728000" cy="103863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A38A6E04-3CEE-4D35-BEF3-93FBB4E1AF08}"/>
              </a:ext>
            </a:extLst>
          </p:cNvPr>
          <p:cNvSpPr txBox="1"/>
          <p:nvPr/>
        </p:nvSpPr>
        <p:spPr>
          <a:xfrm>
            <a:off x="0" y="4479567"/>
            <a:ext cx="140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38A, S540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2</a:t>
            </a:r>
          </a:p>
        </p:txBody>
      </p:sp>
      <p:sp>
        <p:nvSpPr>
          <p:cNvPr id="24" name="Title 1">
            <a:extLst>
              <a:ext uri="{FF2B5EF4-FFF2-40B4-BE49-F238E27FC236}">
                <a16:creationId xmlns:a16="http://schemas.microsoft.com/office/drawing/2014/main" id="{2A6E7D14-0745-4276-A7B6-4CC5CDCB4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12390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5" name="Title 1">
            <a:extLst>
              <a:ext uri="{FF2B5EF4-FFF2-40B4-BE49-F238E27FC236}">
                <a16:creationId xmlns:a16="http://schemas.microsoft.com/office/drawing/2014/main" id="{6FE07513-536C-4F6C-AE39-C114CC74C7DD}"/>
              </a:ext>
            </a:extLst>
          </p:cNvPr>
          <p:cNvSpPr txBox="1">
            <a:spLocks/>
          </p:cNvSpPr>
          <p:nvPr/>
        </p:nvSpPr>
        <p:spPr>
          <a:xfrm>
            <a:off x="3420566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6" name="Title 1">
            <a:extLst>
              <a:ext uri="{FF2B5EF4-FFF2-40B4-BE49-F238E27FC236}">
                <a16:creationId xmlns:a16="http://schemas.microsoft.com/office/drawing/2014/main" id="{2DF5F942-C4CD-4DFC-98E5-18F000DE2234}"/>
              </a:ext>
            </a:extLst>
          </p:cNvPr>
          <p:cNvSpPr txBox="1">
            <a:spLocks/>
          </p:cNvSpPr>
          <p:nvPr/>
        </p:nvSpPr>
        <p:spPr>
          <a:xfrm>
            <a:off x="5119888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938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058AC29-34E4-4660-B2B7-C1C751F520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860" y="726730"/>
            <a:ext cx="1692000" cy="1017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A836F26-9394-4D2B-B22F-6259958FDC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3860" y="1752398"/>
            <a:ext cx="1692000" cy="1017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07686A-EE0C-40CB-A6C4-3398FA7156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5860" y="726730"/>
            <a:ext cx="1692000" cy="1017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1523F0F-D41A-479C-8785-C335B533A8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64776" y="1750525"/>
            <a:ext cx="1692000" cy="1017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5DE0590-4DE0-452C-B0AD-2C17DA56D1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58508" y="726730"/>
            <a:ext cx="1692000" cy="1017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A8894E8-2D01-47EA-B7D5-A4E029ADB18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7642" y="1743730"/>
            <a:ext cx="1692000" cy="1017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3E7A788-66DC-446A-9F9F-8F4A9100234B}"/>
              </a:ext>
            </a:extLst>
          </p:cNvPr>
          <p:cNvSpPr txBox="1"/>
          <p:nvPr/>
        </p:nvSpPr>
        <p:spPr>
          <a:xfrm>
            <a:off x="0" y="1983711"/>
            <a:ext cx="140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73A, S574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7E9267-5427-4274-A2E5-0E1DA6029531}"/>
              </a:ext>
            </a:extLst>
          </p:cNvPr>
          <p:cNvSpPr txBox="1"/>
          <p:nvPr/>
        </p:nvSpPr>
        <p:spPr>
          <a:xfrm>
            <a:off x="0" y="1004398"/>
            <a:ext cx="140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73A, S574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43063CC-6183-43DA-851E-F9F147D522C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73643" y="2765652"/>
            <a:ext cx="1692000" cy="1017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BC99DBB-12BD-4ADB-AFC0-5501E521DF6A}"/>
              </a:ext>
            </a:extLst>
          </p:cNvPr>
          <p:cNvSpPr txBox="1"/>
          <p:nvPr/>
        </p:nvSpPr>
        <p:spPr>
          <a:xfrm>
            <a:off x="-13066" y="3128953"/>
            <a:ext cx="13111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41A, S545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96F7DE9-7DB2-4E76-86CD-ABA8033BA8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73641" y="3778906"/>
            <a:ext cx="1692000" cy="1017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0AA48BF-B218-4335-A64B-1059FD573FB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65642" y="2769398"/>
            <a:ext cx="1692000" cy="1017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C4B261C-C7FB-491E-B1B7-562CAA759F3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865642" y="3782652"/>
            <a:ext cx="1692000" cy="1017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3B32394-FB39-4F30-A6DA-541A8F8923E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57642" y="2774320"/>
            <a:ext cx="1692000" cy="1017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0CC7A03-60AA-4856-8368-B049A9DD95A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57642" y="3787574"/>
            <a:ext cx="1692000" cy="1017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853DD0D-C6E8-432B-B212-7CF56F863EBC}"/>
              </a:ext>
            </a:extLst>
          </p:cNvPr>
          <p:cNvSpPr txBox="1"/>
          <p:nvPr/>
        </p:nvSpPr>
        <p:spPr>
          <a:xfrm>
            <a:off x="0" y="4108266"/>
            <a:ext cx="140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41A, S545A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2</a:t>
            </a: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id="{9B24118D-AC40-4BF9-82BC-1FA69A8C7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67390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8B9FEAF1-97F9-44D2-9AAC-3C033211816B}"/>
              </a:ext>
            </a:extLst>
          </p:cNvPr>
          <p:cNvSpPr txBox="1">
            <a:spLocks/>
          </p:cNvSpPr>
          <p:nvPr/>
        </p:nvSpPr>
        <p:spPr>
          <a:xfrm>
            <a:off x="3420566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2" name="Title 1">
            <a:extLst>
              <a:ext uri="{FF2B5EF4-FFF2-40B4-BE49-F238E27FC236}">
                <a16:creationId xmlns:a16="http://schemas.microsoft.com/office/drawing/2014/main" id="{8B44D82D-48C2-4C9E-9866-EF4E0173E593}"/>
              </a:ext>
            </a:extLst>
          </p:cNvPr>
          <p:cNvSpPr txBox="1">
            <a:spLocks/>
          </p:cNvSpPr>
          <p:nvPr/>
        </p:nvSpPr>
        <p:spPr>
          <a:xfrm>
            <a:off x="5119888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435288-9786-4C57-976C-F94456861F7F}"/>
              </a:ext>
            </a:extLst>
          </p:cNvPr>
          <p:cNvSpPr txBox="1"/>
          <p:nvPr/>
        </p:nvSpPr>
        <p:spPr>
          <a:xfrm>
            <a:off x="-4003" y="3854"/>
            <a:ext cx="3407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3 continued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63403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39222382-2D27-4DB1-A590-821309092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67390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0483757D-44EA-4493-9418-0079C141D5E8}"/>
              </a:ext>
            </a:extLst>
          </p:cNvPr>
          <p:cNvSpPr txBox="1">
            <a:spLocks/>
          </p:cNvSpPr>
          <p:nvPr/>
        </p:nvSpPr>
        <p:spPr>
          <a:xfrm>
            <a:off x="3420566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60B4CC19-1DF5-4FE4-8841-4723CB5A5E67}"/>
              </a:ext>
            </a:extLst>
          </p:cNvPr>
          <p:cNvSpPr txBox="1">
            <a:spLocks/>
          </p:cNvSpPr>
          <p:nvPr/>
        </p:nvSpPr>
        <p:spPr>
          <a:xfrm>
            <a:off x="5119888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351BAF0-FD93-4B59-8A6B-96CE58D53640}"/>
              </a:ext>
            </a:extLst>
          </p:cNvPr>
          <p:cNvSpPr txBox="1"/>
          <p:nvPr/>
        </p:nvSpPr>
        <p:spPr>
          <a:xfrm>
            <a:off x="-4003" y="3854"/>
            <a:ext cx="3407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3 continued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D7029A1-BAAF-4B7B-95A6-049DE6BAA5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1245" y="729256"/>
            <a:ext cx="1692000" cy="1017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EE394C1-8545-41A8-AF22-11C611980E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3245" y="733346"/>
            <a:ext cx="1692000" cy="1017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79ECEEA-D32E-4E4C-8ADC-26D0051413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5245" y="729256"/>
            <a:ext cx="1692000" cy="1017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D66B743-5D0E-481E-BB89-29AD96D57E36}"/>
              </a:ext>
            </a:extLst>
          </p:cNvPr>
          <p:cNvSpPr txBox="1"/>
          <p:nvPr/>
        </p:nvSpPr>
        <p:spPr>
          <a:xfrm>
            <a:off x="-4003" y="904967"/>
            <a:ext cx="10067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900D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61C4CF9-5304-457C-8304-67E4F03666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1245" y="1740939"/>
            <a:ext cx="1692000" cy="1017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3656C9F-9BE5-4D81-973A-6A6125DF0C18}"/>
              </a:ext>
            </a:extLst>
          </p:cNvPr>
          <p:cNvSpPr txBox="1"/>
          <p:nvPr/>
        </p:nvSpPr>
        <p:spPr>
          <a:xfrm>
            <a:off x="-4003" y="1809260"/>
            <a:ext cx="16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900D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2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D723285-DDCD-4F5A-AF9C-816E8D2143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73242" y="1748675"/>
            <a:ext cx="1692000" cy="1017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461A087-8092-4FF2-849E-BAA0493B7F0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65242" y="1757315"/>
            <a:ext cx="1692000" cy="1017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63FA9CD-9331-4E39-8765-671C000CC43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81243" y="3750061"/>
            <a:ext cx="1692000" cy="1017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71F04A5-447D-422C-8959-09CD468683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81243" y="2748532"/>
            <a:ext cx="1692000" cy="1017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C54E321-DA2C-409C-B3EC-19A091C2FC0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73239" y="2756268"/>
            <a:ext cx="1692000" cy="1017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6093685-FD15-4183-96A9-78156979F41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873239" y="3757796"/>
            <a:ext cx="1692000" cy="1017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9265AC3-51F0-4EFC-A43F-3C0BEEF7F02C}"/>
              </a:ext>
            </a:extLst>
          </p:cNvPr>
          <p:cNvSpPr txBox="1"/>
          <p:nvPr/>
        </p:nvSpPr>
        <p:spPr>
          <a:xfrm>
            <a:off x="-4003" y="2908179"/>
            <a:ext cx="12942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38A, S540A, S548A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7D068AB-E300-4340-83E5-2FFAAD80025D}"/>
              </a:ext>
            </a:extLst>
          </p:cNvPr>
          <p:cNvSpPr txBox="1"/>
          <p:nvPr/>
        </p:nvSpPr>
        <p:spPr>
          <a:xfrm>
            <a:off x="-4003" y="3811689"/>
            <a:ext cx="14143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Q</a:t>
            </a:r>
            <a:r>
              <a:rPr lang="en-US" sz="12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S538A, S540A, S548A 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Strain 2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EF793A61-169E-4565-A4DE-1F28CF4652F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65239" y="2764907"/>
            <a:ext cx="1692000" cy="1017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75B5C86-2B98-4F66-87DB-D2F96F5A398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65240" y="3766436"/>
            <a:ext cx="1692000" cy="1017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7147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1582DA1-C39A-410B-99F4-93489608404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20202" y="784427"/>
            <a:ext cx="1692000" cy="101710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CB49843-D767-43EA-9A3B-C270494E6F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9878" y="1801427"/>
            <a:ext cx="1692000" cy="1017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2E3AB4B-8A87-42D7-9195-206831CA90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1878" y="784427"/>
            <a:ext cx="1692000" cy="1017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42987E3-6A9C-4B91-8B3B-0A58A1E391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11878" y="1801427"/>
            <a:ext cx="1692000" cy="1017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EDF64C5-5594-49B6-A7E3-EFCED24292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8788" y="784427"/>
            <a:ext cx="1692000" cy="1017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B1F5CE8-896C-47F0-A8DD-1C8A1190790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08788" y="1801234"/>
            <a:ext cx="1692000" cy="1017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3F334E9-9468-485C-9DE6-E7EDFB3F8AED}"/>
              </a:ext>
            </a:extLst>
          </p:cNvPr>
          <p:cNvSpPr txBox="1"/>
          <p:nvPr/>
        </p:nvSpPr>
        <p:spPr>
          <a:xfrm>
            <a:off x="-4003" y="987956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WT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82CF135-D5A4-4552-AD29-D929202DAF56}"/>
              </a:ext>
            </a:extLst>
          </p:cNvPr>
          <p:cNvSpPr txBox="1"/>
          <p:nvPr/>
        </p:nvSpPr>
        <p:spPr>
          <a:xfrm>
            <a:off x="7539" y="1994297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ras-1</a:t>
            </a:r>
            <a:r>
              <a:rPr lang="en-US" sz="1200" i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bd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5AA015E-2AF1-4DF6-AF6C-E20C2E5C752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9878" y="2818234"/>
            <a:ext cx="1692000" cy="1017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81DFE70-E136-4C19-9791-3B38536E294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07458" y="2809452"/>
            <a:ext cx="1692000" cy="1017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50BFAC7-057F-49C9-AD00-4E27DEF62D6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99458" y="2818234"/>
            <a:ext cx="1692000" cy="1017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4C50186-C174-4C24-B1BC-D0A226026AFE}"/>
              </a:ext>
            </a:extLst>
          </p:cNvPr>
          <p:cNvSpPr txBox="1"/>
          <p:nvPr/>
        </p:nvSpPr>
        <p:spPr>
          <a:xfrm>
            <a:off x="0" y="3170918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ras-1</a:t>
            </a:r>
            <a:r>
              <a:rPr lang="en-US" sz="1200" i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bd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,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  prd-3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D76A31D-7B28-499C-827F-868D1DCE4500}"/>
              </a:ext>
            </a:extLst>
          </p:cNvPr>
          <p:cNvSpPr txBox="1"/>
          <p:nvPr/>
        </p:nvSpPr>
        <p:spPr>
          <a:xfrm>
            <a:off x="-4003" y="3854"/>
            <a:ext cx="3407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20204" pitchFamily="34" charset="0"/>
                <a:cs typeface="Helvetica" panose="020B0604020202020204" pitchFamily="34" charset="0"/>
              </a:rPr>
              <a:t>Supporting Figure 3 continued</a:t>
            </a:r>
            <a:endParaRPr lang="zh-CN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4739431C-D23D-4E75-9EDB-C506109728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67390" y="359923"/>
            <a:ext cx="839011" cy="344575"/>
          </a:xfrm>
        </p:spPr>
        <p:txBody>
          <a:bodyPr>
            <a:normAutofit/>
          </a:bodyPr>
          <a:lstStyle/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5928AA0A-ADA1-4626-A627-FA8D1EBDC025}"/>
              </a:ext>
            </a:extLst>
          </p:cNvPr>
          <p:cNvSpPr txBox="1">
            <a:spLocks/>
          </p:cNvSpPr>
          <p:nvPr/>
        </p:nvSpPr>
        <p:spPr>
          <a:xfrm>
            <a:off x="3420566" y="354228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5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19" name="Title 1">
            <a:extLst>
              <a:ext uri="{FF2B5EF4-FFF2-40B4-BE49-F238E27FC236}">
                <a16:creationId xmlns:a16="http://schemas.microsoft.com/office/drawing/2014/main" id="{3B845CD5-F16F-424B-BBF6-A6815F917F81}"/>
              </a:ext>
            </a:extLst>
          </p:cNvPr>
          <p:cNvSpPr txBox="1">
            <a:spLocks/>
          </p:cNvSpPr>
          <p:nvPr/>
        </p:nvSpPr>
        <p:spPr>
          <a:xfrm>
            <a:off x="5119888" y="355374"/>
            <a:ext cx="839011" cy="344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301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032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dirty="0">
                <a:latin typeface="Helvetica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30 </a:t>
            </a:r>
            <a:r>
              <a:rPr lang="en-US" altLang="zh-CN" sz="1600" dirty="0">
                <a:latin typeface="Helvetica" panose="020B0604020202020204" pitchFamily="34" charset="0"/>
                <a:cs typeface="Helvetica" panose="020B0604020202020204" pitchFamily="34" charset="0"/>
              </a:rPr>
              <a:t>°C</a:t>
            </a:r>
            <a:endParaRPr lang="en-US" altLang="zh-CN" sz="1600" dirty="0">
              <a:latin typeface="Helvetica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974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3</TotalTime>
  <Words>366</Words>
  <Application>Microsoft Office PowerPoint</Application>
  <PresentationFormat>Custom</PresentationFormat>
  <Paragraphs>12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Helvetica</vt:lpstr>
      <vt:lpstr>Office Theme</vt:lpstr>
      <vt:lpstr>PowerPoint Presentation</vt:lpstr>
      <vt:lpstr>20 °C</vt:lpstr>
      <vt:lpstr>20 °C</vt:lpstr>
      <vt:lpstr>20 °C</vt:lpstr>
      <vt:lpstr>20 °C</vt:lpstr>
      <vt:lpstr>20 °C</vt:lpstr>
      <vt:lpstr>20 °C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n Wang</dc:creator>
  <cp:lastModifiedBy>Bin Wang</cp:lastModifiedBy>
  <cp:revision>191</cp:revision>
  <dcterms:created xsi:type="dcterms:W3CDTF">2022-07-02T11:40:10Z</dcterms:created>
  <dcterms:modified xsi:type="dcterms:W3CDTF">2022-12-14T17:08:07Z</dcterms:modified>
</cp:coreProperties>
</file>